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4"/>
  </p:notesMasterIdLst>
  <p:sldIdLst>
    <p:sldId id="429" r:id="rId2"/>
    <p:sldId id="418" r:id="rId3"/>
    <p:sldId id="386" r:id="rId4"/>
    <p:sldId id="428" r:id="rId5"/>
    <p:sldId id="408" r:id="rId6"/>
    <p:sldId id="409" r:id="rId7"/>
    <p:sldId id="432" r:id="rId8"/>
    <p:sldId id="422" r:id="rId9"/>
    <p:sldId id="419" r:id="rId10"/>
    <p:sldId id="420" r:id="rId11"/>
    <p:sldId id="430" r:id="rId12"/>
    <p:sldId id="431"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AF794E2-4A92-77CE-6C2E-DE5D6FA0B518}" name="Gao, Haoran" initials="GH" userId="S::gaohaora@msu.edu::e591f824-f9a3-4fe7-9076-4cd8b18a87e8"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126C9CE-60D4-4D94-B0E1-02E45659FE05}" v="37" dt="2023-09-08T20:36:50.54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276"/>
    <p:restoredTop sz="95238"/>
  </p:normalViewPr>
  <p:slideViewPr>
    <p:cSldViewPr snapToGrid="0" snapToObjects="1">
      <p:cViewPr varScale="1">
        <p:scale>
          <a:sx n="122" d="100"/>
          <a:sy n="122" d="100"/>
        </p:scale>
        <p:origin x="568"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21" Type="http://schemas.microsoft.com/office/2018/10/relationships/authors" Targe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20"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orgensen, Rick" userId="22b7bd11-eb0f-413f-9bcb-9ce21ec7b0a8" providerId="ADAL" clId="{9126C9CE-60D4-4D94-B0E1-02E45659FE05}"/>
    <pc:docChg chg="undo custSel addSld modSld">
      <pc:chgData name="Jorgensen, Rick" userId="22b7bd11-eb0f-413f-9bcb-9ce21ec7b0a8" providerId="ADAL" clId="{9126C9CE-60D4-4D94-B0E1-02E45659FE05}" dt="2023-09-08T20:36:49.367" v="720" actId="27918"/>
      <pc:docMkLst>
        <pc:docMk/>
      </pc:docMkLst>
      <pc:sldChg chg="modSp mod">
        <pc:chgData name="Jorgensen, Rick" userId="22b7bd11-eb0f-413f-9bcb-9ce21ec7b0a8" providerId="ADAL" clId="{9126C9CE-60D4-4D94-B0E1-02E45659FE05}" dt="2023-09-08T20:04:42.260" v="680" actId="20577"/>
        <pc:sldMkLst>
          <pc:docMk/>
          <pc:sldMk cId="4043107919" sldId="418"/>
        </pc:sldMkLst>
        <pc:spChg chg="mod">
          <ac:chgData name="Jorgensen, Rick" userId="22b7bd11-eb0f-413f-9bcb-9ce21ec7b0a8" providerId="ADAL" clId="{9126C9CE-60D4-4D94-B0E1-02E45659FE05}" dt="2023-09-08T20:04:42.260" v="680" actId="20577"/>
          <ac:spMkLst>
            <pc:docMk/>
            <pc:sldMk cId="4043107919" sldId="418"/>
            <ac:spMk id="3" creationId="{00000000-0000-0000-0000-000000000000}"/>
          </ac:spMkLst>
        </pc:spChg>
      </pc:sldChg>
      <pc:sldChg chg="modSp mod">
        <pc:chgData name="Jorgensen, Rick" userId="22b7bd11-eb0f-413f-9bcb-9ce21ec7b0a8" providerId="ADAL" clId="{9126C9CE-60D4-4D94-B0E1-02E45659FE05}" dt="2023-09-08T19:41:01.878" v="42" actId="27918"/>
        <pc:sldMkLst>
          <pc:docMk/>
          <pc:sldMk cId="1551454966" sldId="419"/>
        </pc:sldMkLst>
        <pc:graphicFrameChg chg="mod">
          <ac:chgData name="Jorgensen, Rick" userId="22b7bd11-eb0f-413f-9bcb-9ce21ec7b0a8" providerId="ADAL" clId="{9126C9CE-60D4-4D94-B0E1-02E45659FE05}" dt="2023-09-08T19:41:00.818" v="41"/>
          <ac:graphicFrameMkLst>
            <pc:docMk/>
            <pc:sldMk cId="1551454966" sldId="419"/>
            <ac:graphicFrameMk id="9" creationId="{4936B1E3-6CC8-4944-870F-DC784E261689}"/>
          </ac:graphicFrameMkLst>
        </pc:graphicFrameChg>
      </pc:sldChg>
      <pc:sldChg chg="addSp delSp modSp mod">
        <pc:chgData name="Jorgensen, Rick" userId="22b7bd11-eb0f-413f-9bcb-9ce21ec7b0a8" providerId="ADAL" clId="{9126C9CE-60D4-4D94-B0E1-02E45659FE05}" dt="2023-09-08T20:36:04.976" v="718" actId="1076"/>
        <pc:sldMkLst>
          <pc:docMk/>
          <pc:sldMk cId="2552959805" sldId="429"/>
        </pc:sldMkLst>
        <pc:spChg chg="add del mod">
          <ac:chgData name="Jorgensen, Rick" userId="22b7bd11-eb0f-413f-9bcb-9ce21ec7b0a8" providerId="ADAL" clId="{9126C9CE-60D4-4D94-B0E1-02E45659FE05}" dt="2023-09-08T20:35:34.918" v="712"/>
          <ac:spMkLst>
            <pc:docMk/>
            <pc:sldMk cId="2552959805" sldId="429"/>
            <ac:spMk id="2" creationId="{E7FCF340-4061-9708-1AD2-2BE27A15CAC0}"/>
          </ac:spMkLst>
        </pc:spChg>
        <pc:spChg chg="add mod">
          <ac:chgData name="Jorgensen, Rick" userId="22b7bd11-eb0f-413f-9bcb-9ce21ec7b0a8" providerId="ADAL" clId="{9126C9CE-60D4-4D94-B0E1-02E45659FE05}" dt="2023-09-08T20:33:33.731" v="698" actId="1076"/>
          <ac:spMkLst>
            <pc:docMk/>
            <pc:sldMk cId="2552959805" sldId="429"/>
            <ac:spMk id="4" creationId="{8723B67C-EAAD-8AC1-4144-6DB5487D4127}"/>
          </ac:spMkLst>
        </pc:spChg>
        <pc:spChg chg="add mod">
          <ac:chgData name="Jorgensen, Rick" userId="22b7bd11-eb0f-413f-9bcb-9ce21ec7b0a8" providerId="ADAL" clId="{9126C9CE-60D4-4D94-B0E1-02E45659FE05}" dt="2023-09-08T20:34:30.203" v="703" actId="1076"/>
          <ac:spMkLst>
            <pc:docMk/>
            <pc:sldMk cId="2552959805" sldId="429"/>
            <ac:spMk id="5" creationId="{6045110D-145D-AB29-3651-4C82DCEF642C}"/>
          </ac:spMkLst>
        </pc:spChg>
        <pc:spChg chg="mod ord">
          <ac:chgData name="Jorgensen, Rick" userId="22b7bd11-eb0f-413f-9bcb-9ce21ec7b0a8" providerId="ADAL" clId="{9126C9CE-60D4-4D94-B0E1-02E45659FE05}" dt="2023-09-08T20:32:13.002" v="693" actId="166"/>
          <ac:spMkLst>
            <pc:docMk/>
            <pc:sldMk cId="2552959805" sldId="429"/>
            <ac:spMk id="7" creationId="{07E4C538-E00E-3525-DA62-3F5FD0968DED}"/>
          </ac:spMkLst>
        </pc:spChg>
        <pc:spChg chg="add mod">
          <ac:chgData name="Jorgensen, Rick" userId="22b7bd11-eb0f-413f-9bcb-9ce21ec7b0a8" providerId="ADAL" clId="{9126C9CE-60D4-4D94-B0E1-02E45659FE05}" dt="2023-09-08T20:35:09.104" v="706" actId="1076"/>
          <ac:spMkLst>
            <pc:docMk/>
            <pc:sldMk cId="2552959805" sldId="429"/>
            <ac:spMk id="8" creationId="{42D1D179-0786-9FCD-DBCF-F419D3D87573}"/>
          </ac:spMkLst>
        </pc:spChg>
        <pc:spChg chg="ord">
          <ac:chgData name="Jorgensen, Rick" userId="22b7bd11-eb0f-413f-9bcb-9ce21ec7b0a8" providerId="ADAL" clId="{9126C9CE-60D4-4D94-B0E1-02E45659FE05}" dt="2023-09-08T20:32:13.002" v="693" actId="166"/>
          <ac:spMkLst>
            <pc:docMk/>
            <pc:sldMk cId="2552959805" sldId="429"/>
            <ac:spMk id="9" creationId="{7389AAA5-3E58-6445-D200-A1EBDB88A436}"/>
          </ac:spMkLst>
        </pc:spChg>
        <pc:spChg chg="ord">
          <ac:chgData name="Jorgensen, Rick" userId="22b7bd11-eb0f-413f-9bcb-9ce21ec7b0a8" providerId="ADAL" clId="{9126C9CE-60D4-4D94-B0E1-02E45659FE05}" dt="2023-09-08T20:32:13.002" v="693" actId="166"/>
          <ac:spMkLst>
            <pc:docMk/>
            <pc:sldMk cId="2552959805" sldId="429"/>
            <ac:spMk id="10" creationId="{3E37CC4E-B5FE-402F-FED6-F3C1B221D7B7}"/>
          </ac:spMkLst>
        </pc:spChg>
        <pc:spChg chg="mod">
          <ac:chgData name="Jorgensen, Rick" userId="22b7bd11-eb0f-413f-9bcb-9ce21ec7b0a8" providerId="ADAL" clId="{9126C9CE-60D4-4D94-B0E1-02E45659FE05}" dt="2023-09-08T20:36:04.976" v="718" actId="1076"/>
          <ac:spMkLst>
            <pc:docMk/>
            <pc:sldMk cId="2552959805" sldId="429"/>
            <ac:spMk id="17" creationId="{C0217B56-E66C-515D-7E75-EAA96F430CE8}"/>
          </ac:spMkLst>
        </pc:spChg>
        <pc:spChg chg="del mod">
          <ac:chgData name="Jorgensen, Rick" userId="22b7bd11-eb0f-413f-9bcb-9ce21ec7b0a8" providerId="ADAL" clId="{9126C9CE-60D4-4D94-B0E1-02E45659FE05}" dt="2023-09-08T20:31:53.941" v="687" actId="478"/>
          <ac:spMkLst>
            <pc:docMk/>
            <pc:sldMk cId="2552959805" sldId="429"/>
            <ac:spMk id="18" creationId="{450E6268-86E5-4738-1B8D-11CCE562E840}"/>
          </ac:spMkLst>
        </pc:spChg>
        <pc:spChg chg="mod">
          <ac:chgData name="Jorgensen, Rick" userId="22b7bd11-eb0f-413f-9bcb-9ce21ec7b0a8" providerId="ADAL" clId="{9126C9CE-60D4-4D94-B0E1-02E45659FE05}" dt="2023-09-08T20:35:53.067" v="715" actId="1076"/>
          <ac:spMkLst>
            <pc:docMk/>
            <pc:sldMk cId="2552959805" sldId="429"/>
            <ac:spMk id="19" creationId="{997093FD-A6D6-C2E0-0084-8DB95C7B1B3B}"/>
          </ac:spMkLst>
        </pc:spChg>
        <pc:graphicFrameChg chg="add mod ord">
          <ac:chgData name="Jorgensen, Rick" userId="22b7bd11-eb0f-413f-9bcb-9ce21ec7b0a8" providerId="ADAL" clId="{9126C9CE-60D4-4D94-B0E1-02E45659FE05}" dt="2023-09-08T20:35:59.788" v="716"/>
          <ac:graphicFrameMkLst>
            <pc:docMk/>
            <pc:sldMk cId="2552959805" sldId="429"/>
            <ac:graphicFrameMk id="3" creationId="{631A0593-D48F-4A59-9FB2-8E82BC5FCC8B}"/>
          </ac:graphicFrameMkLst>
        </pc:graphicFrameChg>
        <pc:graphicFrameChg chg="del mod">
          <ac:chgData name="Jorgensen, Rick" userId="22b7bd11-eb0f-413f-9bcb-9ce21ec7b0a8" providerId="ADAL" clId="{9126C9CE-60D4-4D94-B0E1-02E45659FE05}" dt="2023-09-08T20:31:51.024" v="686" actId="478"/>
          <ac:graphicFrameMkLst>
            <pc:docMk/>
            <pc:sldMk cId="2552959805" sldId="429"/>
            <ac:graphicFrameMk id="6" creationId="{D4CCACB4-4E67-4B42-B1F7-EB2D9C2F572E}"/>
          </ac:graphicFrameMkLst>
        </pc:graphicFrameChg>
      </pc:sldChg>
      <pc:sldChg chg="addSp delSp modSp add mod">
        <pc:chgData name="Jorgensen, Rick" userId="22b7bd11-eb0f-413f-9bcb-9ce21ec7b0a8" providerId="ADAL" clId="{9126C9CE-60D4-4D94-B0E1-02E45659FE05}" dt="2023-09-08T20:36:49.367" v="720" actId="27918"/>
        <pc:sldMkLst>
          <pc:docMk/>
          <pc:sldMk cId="4031669943" sldId="430"/>
        </pc:sldMkLst>
        <pc:spChg chg="add mod">
          <ac:chgData name="Jorgensen, Rick" userId="22b7bd11-eb0f-413f-9bcb-9ce21ec7b0a8" providerId="ADAL" clId="{9126C9CE-60D4-4D94-B0E1-02E45659FE05}" dt="2023-09-08T19:36:21.962" v="37" actId="1076"/>
          <ac:spMkLst>
            <pc:docMk/>
            <pc:sldMk cId="4031669943" sldId="430"/>
            <ac:spMk id="2" creationId="{638B8333-ABA7-9388-D941-A92EF4F4AB71}"/>
          </ac:spMkLst>
        </pc:spChg>
        <pc:spChg chg="del">
          <ac:chgData name="Jorgensen, Rick" userId="22b7bd11-eb0f-413f-9bcb-9ce21ec7b0a8" providerId="ADAL" clId="{9126C9CE-60D4-4D94-B0E1-02E45659FE05}" dt="2023-09-08T19:27:50.647" v="13" actId="478"/>
          <ac:spMkLst>
            <pc:docMk/>
            <pc:sldMk cId="4031669943" sldId="430"/>
            <ac:spMk id="3" creationId="{A9911829-125C-2AF7-3570-AF5B472CF4F9}"/>
          </ac:spMkLst>
        </pc:spChg>
        <pc:spChg chg="del">
          <ac:chgData name="Jorgensen, Rick" userId="22b7bd11-eb0f-413f-9bcb-9ce21ec7b0a8" providerId="ADAL" clId="{9126C9CE-60D4-4D94-B0E1-02E45659FE05}" dt="2023-09-08T19:27:50.647" v="13" actId="478"/>
          <ac:spMkLst>
            <pc:docMk/>
            <pc:sldMk cId="4031669943" sldId="430"/>
            <ac:spMk id="4" creationId="{CA8E73CD-369F-0B3A-47A4-727DC48EE995}"/>
          </ac:spMkLst>
        </pc:spChg>
        <pc:spChg chg="del">
          <ac:chgData name="Jorgensen, Rick" userId="22b7bd11-eb0f-413f-9bcb-9ce21ec7b0a8" providerId="ADAL" clId="{9126C9CE-60D4-4D94-B0E1-02E45659FE05}" dt="2023-09-08T19:27:50.647" v="13" actId="478"/>
          <ac:spMkLst>
            <pc:docMk/>
            <pc:sldMk cId="4031669943" sldId="430"/>
            <ac:spMk id="5" creationId="{937AEC2F-1FFC-9213-F3B3-CB64E79EF898}"/>
          </ac:spMkLst>
        </pc:spChg>
        <pc:spChg chg="add mod">
          <ac:chgData name="Jorgensen, Rick" userId="22b7bd11-eb0f-413f-9bcb-9ce21ec7b0a8" providerId="ADAL" clId="{9126C9CE-60D4-4D94-B0E1-02E45659FE05}" dt="2023-09-08T19:36:40.021" v="40" actId="1076"/>
          <ac:spMkLst>
            <pc:docMk/>
            <pc:sldMk cId="4031669943" sldId="430"/>
            <ac:spMk id="7" creationId="{172AD0FF-44A0-7EE4-5143-1275FE26035B}"/>
          </ac:spMkLst>
        </pc:spChg>
        <pc:spChg chg="add del mod">
          <ac:chgData name="Jorgensen, Rick" userId="22b7bd11-eb0f-413f-9bcb-9ce21ec7b0a8" providerId="ADAL" clId="{9126C9CE-60D4-4D94-B0E1-02E45659FE05}" dt="2023-09-08T19:44:14.302" v="65" actId="478"/>
          <ac:spMkLst>
            <pc:docMk/>
            <pc:sldMk cId="4031669943" sldId="430"/>
            <ac:spMk id="13" creationId="{4F3826E1-3AC3-606A-F3C4-F1AABB7F4676}"/>
          </ac:spMkLst>
        </pc:spChg>
        <pc:spChg chg="add del mod">
          <ac:chgData name="Jorgensen, Rick" userId="22b7bd11-eb0f-413f-9bcb-9ce21ec7b0a8" providerId="ADAL" clId="{9126C9CE-60D4-4D94-B0E1-02E45659FE05}" dt="2023-09-08T19:44:12.537" v="64" actId="478"/>
          <ac:spMkLst>
            <pc:docMk/>
            <pc:sldMk cId="4031669943" sldId="430"/>
            <ac:spMk id="14" creationId="{9757D68F-099E-54DF-2DDF-28BB94D30BB1}"/>
          </ac:spMkLst>
        </pc:spChg>
        <pc:spChg chg="add del mod">
          <ac:chgData name="Jorgensen, Rick" userId="22b7bd11-eb0f-413f-9bcb-9ce21ec7b0a8" providerId="ADAL" clId="{9126C9CE-60D4-4D94-B0E1-02E45659FE05}" dt="2023-09-08T19:42:06.125" v="54" actId="478"/>
          <ac:spMkLst>
            <pc:docMk/>
            <pc:sldMk cId="4031669943" sldId="430"/>
            <ac:spMk id="15" creationId="{26E98004-7C72-425F-D988-8895D280FA8B}"/>
          </ac:spMkLst>
        </pc:spChg>
        <pc:spChg chg="del">
          <ac:chgData name="Jorgensen, Rick" userId="22b7bd11-eb0f-413f-9bcb-9ce21ec7b0a8" providerId="ADAL" clId="{9126C9CE-60D4-4D94-B0E1-02E45659FE05}" dt="2023-09-08T19:27:50.647" v="13" actId="478"/>
          <ac:spMkLst>
            <pc:docMk/>
            <pc:sldMk cId="4031669943" sldId="430"/>
            <ac:spMk id="17" creationId="{055AFFF1-7D90-FBB9-1959-2C2BBDB4E1ED}"/>
          </ac:spMkLst>
        </pc:spChg>
        <pc:spChg chg="del">
          <ac:chgData name="Jorgensen, Rick" userId="22b7bd11-eb0f-413f-9bcb-9ce21ec7b0a8" providerId="ADAL" clId="{9126C9CE-60D4-4D94-B0E1-02E45659FE05}" dt="2023-09-08T19:27:50.647" v="13" actId="478"/>
          <ac:spMkLst>
            <pc:docMk/>
            <pc:sldMk cId="4031669943" sldId="430"/>
            <ac:spMk id="19" creationId="{672A4FC3-3D56-829F-2976-0E0C208F8297}"/>
          </ac:spMkLst>
        </pc:spChg>
        <pc:spChg chg="mod">
          <ac:chgData name="Jorgensen, Rick" userId="22b7bd11-eb0f-413f-9bcb-9ce21ec7b0a8" providerId="ADAL" clId="{9126C9CE-60D4-4D94-B0E1-02E45659FE05}" dt="2023-09-08T19:27:46.921" v="11" actId="1076"/>
          <ac:spMkLst>
            <pc:docMk/>
            <pc:sldMk cId="4031669943" sldId="430"/>
            <ac:spMk id="25" creationId="{43DF711F-4684-B34D-9236-D3A26D348F11}"/>
          </ac:spMkLst>
        </pc:spChg>
        <pc:spChg chg="del">
          <ac:chgData name="Jorgensen, Rick" userId="22b7bd11-eb0f-413f-9bcb-9ce21ec7b0a8" providerId="ADAL" clId="{9126C9CE-60D4-4D94-B0E1-02E45659FE05}" dt="2023-09-08T19:27:48.533" v="12" actId="478"/>
          <ac:spMkLst>
            <pc:docMk/>
            <pc:sldMk cId="4031669943" sldId="430"/>
            <ac:spMk id="53" creationId="{6396E680-00D0-8F82-1816-555E623E2E69}"/>
          </ac:spMkLst>
        </pc:spChg>
        <pc:spChg chg="del">
          <ac:chgData name="Jorgensen, Rick" userId="22b7bd11-eb0f-413f-9bcb-9ce21ec7b0a8" providerId="ADAL" clId="{9126C9CE-60D4-4D94-B0E1-02E45659FE05}" dt="2023-09-08T19:27:48.533" v="12" actId="478"/>
          <ac:spMkLst>
            <pc:docMk/>
            <pc:sldMk cId="4031669943" sldId="430"/>
            <ac:spMk id="54" creationId="{AF1A4DE1-431E-F8D2-F34E-B86711B93E41}"/>
          </ac:spMkLst>
        </pc:spChg>
        <pc:spChg chg="del">
          <ac:chgData name="Jorgensen, Rick" userId="22b7bd11-eb0f-413f-9bcb-9ce21ec7b0a8" providerId="ADAL" clId="{9126C9CE-60D4-4D94-B0E1-02E45659FE05}" dt="2023-09-08T19:27:48.533" v="12" actId="478"/>
          <ac:spMkLst>
            <pc:docMk/>
            <pc:sldMk cId="4031669943" sldId="430"/>
            <ac:spMk id="55" creationId="{62636936-5942-8106-460E-CC1AC237CC3A}"/>
          </ac:spMkLst>
        </pc:spChg>
        <pc:graphicFrameChg chg="add del mod">
          <ac:chgData name="Jorgensen, Rick" userId="22b7bd11-eb0f-413f-9bcb-9ce21ec7b0a8" providerId="ADAL" clId="{9126C9CE-60D4-4D94-B0E1-02E45659FE05}" dt="2023-09-08T19:50:27.550" v="67" actId="478"/>
          <ac:graphicFrameMkLst>
            <pc:docMk/>
            <pc:sldMk cId="4031669943" sldId="430"/>
            <ac:graphicFrameMk id="6" creationId="{356CDF2D-2D4E-4705-B3F5-40BBBB402459}"/>
          </ac:graphicFrameMkLst>
        </pc:graphicFrameChg>
        <pc:graphicFrameChg chg="add mod">
          <ac:chgData name="Jorgensen, Rick" userId="22b7bd11-eb0f-413f-9bcb-9ce21ec7b0a8" providerId="ADAL" clId="{9126C9CE-60D4-4D94-B0E1-02E45659FE05}" dt="2023-09-08T19:58:19.417" v="276"/>
          <ac:graphicFrameMkLst>
            <pc:docMk/>
            <pc:sldMk cId="4031669943" sldId="430"/>
            <ac:graphicFrameMk id="8" creationId="{9FC82532-2841-4B26-9F8F-5E2647E5AEDC}"/>
          </ac:graphicFrameMkLst>
        </pc:graphicFrameChg>
        <pc:graphicFrameChg chg="del">
          <ac:chgData name="Jorgensen, Rick" userId="22b7bd11-eb0f-413f-9bcb-9ce21ec7b0a8" providerId="ADAL" clId="{9126C9CE-60D4-4D94-B0E1-02E45659FE05}" dt="2023-09-08T19:27:43.410" v="9" actId="478"/>
          <ac:graphicFrameMkLst>
            <pc:docMk/>
            <pc:sldMk cId="4031669943" sldId="430"/>
            <ac:graphicFrameMk id="9" creationId="{4936B1E3-6CC8-4944-870F-DC784E261689}"/>
          </ac:graphicFrameMkLst>
        </pc:graphicFrameChg>
        <pc:graphicFrameChg chg="add mod">
          <ac:chgData name="Jorgensen, Rick" userId="22b7bd11-eb0f-413f-9bcb-9ce21ec7b0a8" providerId="ADAL" clId="{9126C9CE-60D4-4D94-B0E1-02E45659FE05}" dt="2023-09-08T19:58:15.772" v="275"/>
          <ac:graphicFrameMkLst>
            <pc:docMk/>
            <pc:sldMk cId="4031669943" sldId="430"/>
            <ac:graphicFrameMk id="31" creationId="{356CDF2D-2D4E-4705-B3F5-40BBBB402459}"/>
          </ac:graphicFrameMkLst>
        </pc:graphicFrameChg>
        <pc:cxnChg chg="add del mod">
          <ac:chgData name="Jorgensen, Rick" userId="22b7bd11-eb0f-413f-9bcb-9ce21ec7b0a8" providerId="ADAL" clId="{9126C9CE-60D4-4D94-B0E1-02E45659FE05}" dt="2023-09-08T19:44:14.927" v="66" actId="478"/>
          <ac:cxnSpMkLst>
            <pc:docMk/>
            <pc:sldMk cId="4031669943" sldId="430"/>
            <ac:cxnSpMk id="10" creationId="{C6784848-CF2B-7009-72A8-A64117C3744B}"/>
          </ac:cxnSpMkLst>
        </pc:cxnChg>
        <pc:cxnChg chg="add del mod">
          <ac:chgData name="Jorgensen, Rick" userId="22b7bd11-eb0f-413f-9bcb-9ce21ec7b0a8" providerId="ADAL" clId="{9126C9CE-60D4-4D94-B0E1-02E45659FE05}" dt="2023-09-08T19:44:11.424" v="63" actId="478"/>
          <ac:cxnSpMkLst>
            <pc:docMk/>
            <pc:sldMk cId="4031669943" sldId="430"/>
            <ac:cxnSpMk id="11" creationId="{63E7D5C4-3423-81BE-993A-0CBD1C08B594}"/>
          </ac:cxnSpMkLst>
        </pc:cxnChg>
        <pc:cxnChg chg="add del mod">
          <ac:chgData name="Jorgensen, Rick" userId="22b7bd11-eb0f-413f-9bcb-9ce21ec7b0a8" providerId="ADAL" clId="{9126C9CE-60D4-4D94-B0E1-02E45659FE05}" dt="2023-09-08T19:42:04.901" v="53" actId="478"/>
          <ac:cxnSpMkLst>
            <pc:docMk/>
            <pc:sldMk cId="4031669943" sldId="430"/>
            <ac:cxnSpMk id="12" creationId="{1111F9E6-0337-893B-2CE4-FA22507617D8}"/>
          </ac:cxnSpMkLst>
        </pc:cxnChg>
        <pc:cxnChg chg="del">
          <ac:chgData name="Jorgensen, Rick" userId="22b7bd11-eb0f-413f-9bcb-9ce21ec7b0a8" providerId="ADAL" clId="{9126C9CE-60D4-4D94-B0E1-02E45659FE05}" dt="2023-09-08T19:27:48.533" v="12" actId="478"/>
          <ac:cxnSpMkLst>
            <pc:docMk/>
            <pc:sldMk cId="4031669943" sldId="430"/>
            <ac:cxnSpMk id="47" creationId="{41CF870C-618E-C86D-36B2-57490FC42E41}"/>
          </ac:cxnSpMkLst>
        </pc:cxnChg>
        <pc:cxnChg chg="del">
          <ac:chgData name="Jorgensen, Rick" userId="22b7bd11-eb0f-413f-9bcb-9ce21ec7b0a8" providerId="ADAL" clId="{9126C9CE-60D4-4D94-B0E1-02E45659FE05}" dt="2023-09-08T19:27:48.533" v="12" actId="478"/>
          <ac:cxnSpMkLst>
            <pc:docMk/>
            <pc:sldMk cId="4031669943" sldId="430"/>
            <ac:cxnSpMk id="49" creationId="{2EC63D4A-D56C-05F2-F952-D9466476B9B9}"/>
          </ac:cxnSpMkLst>
        </pc:cxnChg>
        <pc:cxnChg chg="del">
          <ac:chgData name="Jorgensen, Rick" userId="22b7bd11-eb0f-413f-9bcb-9ce21ec7b0a8" providerId="ADAL" clId="{9126C9CE-60D4-4D94-B0E1-02E45659FE05}" dt="2023-09-08T19:27:48.533" v="12" actId="478"/>
          <ac:cxnSpMkLst>
            <pc:docMk/>
            <pc:sldMk cId="4031669943" sldId="430"/>
            <ac:cxnSpMk id="51" creationId="{F32A2DA8-3CEB-1B7B-3F28-CFCCEE994F48}"/>
          </ac:cxnSpMkLst>
        </pc:cxnChg>
      </pc:sldChg>
      <pc:sldChg chg="modSp add mod">
        <pc:chgData name="Jorgensen, Rick" userId="22b7bd11-eb0f-413f-9bcb-9ce21ec7b0a8" providerId="ADAL" clId="{9126C9CE-60D4-4D94-B0E1-02E45659FE05}" dt="2023-09-08T20:05:47.555" v="685" actId="20577"/>
        <pc:sldMkLst>
          <pc:docMk/>
          <pc:sldMk cId="1075045119" sldId="431"/>
        </pc:sldMkLst>
        <pc:spChg chg="mod">
          <ac:chgData name="Jorgensen, Rick" userId="22b7bd11-eb0f-413f-9bcb-9ce21ec7b0a8" providerId="ADAL" clId="{9126C9CE-60D4-4D94-B0E1-02E45659FE05}" dt="2023-09-08T20:02:33.600" v="576" actId="207"/>
          <ac:spMkLst>
            <pc:docMk/>
            <pc:sldMk cId="1075045119" sldId="431"/>
            <ac:spMk id="2" creationId="{00000000-0000-0000-0000-000000000000}"/>
          </ac:spMkLst>
        </pc:spChg>
        <pc:spChg chg="mod">
          <ac:chgData name="Jorgensen, Rick" userId="22b7bd11-eb0f-413f-9bcb-9ce21ec7b0a8" providerId="ADAL" clId="{9126C9CE-60D4-4D94-B0E1-02E45659FE05}" dt="2023-09-08T20:05:47.555" v="685" actId="20577"/>
          <ac:spMkLst>
            <pc:docMk/>
            <pc:sldMk cId="1075045119" sldId="431"/>
            <ac:spMk id="3" creationId="{00000000-0000-0000-0000-000000000000}"/>
          </ac:spMkLst>
        </pc:spChg>
      </pc:sldChg>
    </pc:docChg>
  </pc:docChgLst>
  <pc:docChgLst>
    <pc:chgData name="Jorgensen, Rick" userId="22b7bd11-eb0f-413f-9bcb-9ce21ec7b0a8" providerId="ADAL" clId="{63C519A2-C2B2-47AC-828F-E429CD2FEDB2}"/>
    <pc:docChg chg="undo redo custSel addSld delSld modSld sldOrd">
      <pc:chgData name="Jorgensen, Rick" userId="22b7bd11-eb0f-413f-9bcb-9ce21ec7b0a8" providerId="ADAL" clId="{63C519A2-C2B2-47AC-828F-E429CD2FEDB2}" dt="2023-08-01T17:18:07.355" v="12591" actId="1076"/>
      <pc:docMkLst>
        <pc:docMk/>
      </pc:docMkLst>
      <pc:sldChg chg="del">
        <pc:chgData name="Jorgensen, Rick" userId="22b7bd11-eb0f-413f-9bcb-9ce21ec7b0a8" providerId="ADAL" clId="{63C519A2-C2B2-47AC-828F-E429CD2FEDB2}" dt="2023-04-25T19:40:16.339" v="0" actId="47"/>
        <pc:sldMkLst>
          <pc:docMk/>
          <pc:sldMk cId="482761308" sldId="280"/>
        </pc:sldMkLst>
      </pc:sldChg>
      <pc:sldChg chg="addSp delSp modSp mod ord">
        <pc:chgData name="Jorgensen, Rick" userId="22b7bd11-eb0f-413f-9bcb-9ce21ec7b0a8" providerId="ADAL" clId="{63C519A2-C2B2-47AC-828F-E429CD2FEDB2}" dt="2023-08-01T14:33:59.289" v="10268"/>
        <pc:sldMkLst>
          <pc:docMk/>
          <pc:sldMk cId="3228758306" sldId="313"/>
        </pc:sldMkLst>
        <pc:spChg chg="add mod">
          <ac:chgData name="Jorgensen, Rick" userId="22b7bd11-eb0f-413f-9bcb-9ce21ec7b0a8" providerId="ADAL" clId="{63C519A2-C2B2-47AC-828F-E429CD2FEDB2}" dt="2023-06-28T16:25:27.434" v="6398" actId="1076"/>
          <ac:spMkLst>
            <pc:docMk/>
            <pc:sldMk cId="3228758306" sldId="313"/>
            <ac:spMk id="2" creationId="{4F4F5B3D-8585-3287-1E6F-5052E6029EA4}"/>
          </ac:spMkLst>
        </pc:spChg>
        <pc:spChg chg="del">
          <ac:chgData name="Jorgensen, Rick" userId="22b7bd11-eb0f-413f-9bcb-9ce21ec7b0a8" providerId="ADAL" clId="{63C519A2-C2B2-47AC-828F-E429CD2FEDB2}" dt="2023-06-23T16:49:39.433" v="5411" actId="478"/>
          <ac:spMkLst>
            <pc:docMk/>
            <pc:sldMk cId="3228758306" sldId="313"/>
            <ac:spMk id="7" creationId="{9AE13EE7-2016-0C8A-7A41-F6C6FFC8FE44}"/>
          </ac:spMkLst>
        </pc:spChg>
        <pc:spChg chg="del">
          <ac:chgData name="Jorgensen, Rick" userId="22b7bd11-eb0f-413f-9bcb-9ce21ec7b0a8" providerId="ADAL" clId="{63C519A2-C2B2-47AC-828F-E429CD2FEDB2}" dt="2023-06-23T16:49:38.271" v="5410" actId="478"/>
          <ac:spMkLst>
            <pc:docMk/>
            <pc:sldMk cId="3228758306" sldId="313"/>
            <ac:spMk id="10" creationId="{4A48EF9A-57C3-18D6-1C90-CDB2EBAF4EFF}"/>
          </ac:spMkLst>
        </pc:spChg>
        <pc:spChg chg="del">
          <ac:chgData name="Jorgensen, Rick" userId="22b7bd11-eb0f-413f-9bcb-9ce21ec7b0a8" providerId="ADAL" clId="{63C519A2-C2B2-47AC-828F-E429CD2FEDB2}" dt="2023-06-23T16:49:37.367" v="5409" actId="478"/>
          <ac:spMkLst>
            <pc:docMk/>
            <pc:sldMk cId="3228758306" sldId="313"/>
            <ac:spMk id="17" creationId="{51693D77-CF3A-F9E8-228D-7C569241AF68}"/>
          </ac:spMkLst>
        </pc:spChg>
        <pc:graphicFrameChg chg="mod">
          <ac:chgData name="Jorgensen, Rick" userId="22b7bd11-eb0f-413f-9bcb-9ce21ec7b0a8" providerId="ADAL" clId="{63C519A2-C2B2-47AC-828F-E429CD2FEDB2}" dt="2023-07-27T14:18:40.407" v="8778" actId="692"/>
          <ac:graphicFrameMkLst>
            <pc:docMk/>
            <pc:sldMk cId="3228758306" sldId="313"/>
            <ac:graphicFrameMk id="6" creationId="{682D5B92-24D4-4A94-B11C-57A26A85F288}"/>
          </ac:graphicFrameMkLst>
        </pc:graphicFrameChg>
        <pc:graphicFrameChg chg="mod">
          <ac:chgData name="Jorgensen, Rick" userId="22b7bd11-eb0f-413f-9bcb-9ce21ec7b0a8" providerId="ADAL" clId="{63C519A2-C2B2-47AC-828F-E429CD2FEDB2}" dt="2023-07-27T14:18:31.876" v="8775" actId="692"/>
          <ac:graphicFrameMkLst>
            <pc:docMk/>
            <pc:sldMk cId="3228758306" sldId="313"/>
            <ac:graphicFrameMk id="18" creationId="{D94D77FC-40F2-4C08-8577-7B5555805378}"/>
          </ac:graphicFrameMkLst>
        </pc:graphicFrameChg>
      </pc:sldChg>
      <pc:sldChg chg="modSp mod ord">
        <pc:chgData name="Jorgensen, Rick" userId="22b7bd11-eb0f-413f-9bcb-9ce21ec7b0a8" providerId="ADAL" clId="{63C519A2-C2B2-47AC-828F-E429CD2FEDB2}" dt="2023-08-01T14:55:13.304" v="10742"/>
        <pc:sldMkLst>
          <pc:docMk/>
          <pc:sldMk cId="2030081462" sldId="321"/>
        </pc:sldMkLst>
        <pc:spChg chg="mod">
          <ac:chgData name="Jorgensen, Rick" userId="22b7bd11-eb0f-413f-9bcb-9ce21ec7b0a8" providerId="ADAL" clId="{63C519A2-C2B2-47AC-828F-E429CD2FEDB2}" dt="2023-06-23T16:15:43.909" v="5400" actId="20577"/>
          <ac:spMkLst>
            <pc:docMk/>
            <pc:sldMk cId="2030081462" sldId="321"/>
            <ac:spMk id="3" creationId="{00000000-0000-0000-0000-000000000000}"/>
          </ac:spMkLst>
        </pc:spChg>
      </pc:sldChg>
      <pc:sldChg chg="addSp modSp mod">
        <pc:chgData name="Jorgensen, Rick" userId="22b7bd11-eb0f-413f-9bcb-9ce21ec7b0a8" providerId="ADAL" clId="{63C519A2-C2B2-47AC-828F-E429CD2FEDB2}" dt="2023-08-01T15:01:17.051" v="10852" actId="207"/>
        <pc:sldMkLst>
          <pc:docMk/>
          <pc:sldMk cId="1787906480" sldId="329"/>
        </pc:sldMkLst>
        <pc:spChg chg="add mod">
          <ac:chgData name="Jorgensen, Rick" userId="22b7bd11-eb0f-413f-9bcb-9ce21ec7b0a8" providerId="ADAL" clId="{63C519A2-C2B2-47AC-828F-E429CD2FEDB2}" dt="2023-08-01T15:00:23.007" v="10851" actId="20577"/>
          <ac:spMkLst>
            <pc:docMk/>
            <pc:sldMk cId="1787906480" sldId="329"/>
            <ac:spMk id="2" creationId="{C9880D3B-B374-2310-4B7A-8663C682C20E}"/>
          </ac:spMkLst>
        </pc:spChg>
        <pc:spChg chg="mod">
          <ac:chgData name="Jorgensen, Rick" userId="22b7bd11-eb0f-413f-9bcb-9ce21ec7b0a8" providerId="ADAL" clId="{63C519A2-C2B2-47AC-828F-E429CD2FEDB2}" dt="2023-07-27T15:43:46.895" v="8960" actId="692"/>
          <ac:spMkLst>
            <pc:docMk/>
            <pc:sldMk cId="1787906480" sldId="329"/>
            <ac:spMk id="11" creationId="{99578930-C130-A573-FBA3-1825193E1906}"/>
          </ac:spMkLst>
        </pc:spChg>
        <pc:spChg chg="mod">
          <ac:chgData name="Jorgensen, Rick" userId="22b7bd11-eb0f-413f-9bcb-9ce21ec7b0a8" providerId="ADAL" clId="{63C519A2-C2B2-47AC-828F-E429CD2FEDB2}" dt="2023-08-01T15:01:17.051" v="10852" actId="207"/>
          <ac:spMkLst>
            <pc:docMk/>
            <pc:sldMk cId="1787906480" sldId="329"/>
            <ac:spMk id="25" creationId="{43DF711F-4684-B34D-9236-D3A26D348F11}"/>
          </ac:spMkLst>
        </pc:spChg>
        <pc:graphicFrameChg chg="mod">
          <ac:chgData name="Jorgensen, Rick" userId="22b7bd11-eb0f-413f-9bcb-9ce21ec7b0a8" providerId="ADAL" clId="{63C519A2-C2B2-47AC-828F-E429CD2FEDB2}" dt="2023-07-27T15:43:50.124" v="8961" actId="692"/>
          <ac:graphicFrameMkLst>
            <pc:docMk/>
            <pc:sldMk cId="1787906480" sldId="329"/>
            <ac:graphicFrameMk id="3" creationId="{00000000-0008-0000-0500-000038000000}"/>
          </ac:graphicFrameMkLst>
        </pc:graphicFrameChg>
      </pc:sldChg>
      <pc:sldChg chg="modSp mod">
        <pc:chgData name="Jorgensen, Rick" userId="22b7bd11-eb0f-413f-9bcb-9ce21ec7b0a8" providerId="ADAL" clId="{63C519A2-C2B2-47AC-828F-E429CD2FEDB2}" dt="2023-08-01T15:01:28.018" v="10857" actId="207"/>
        <pc:sldMkLst>
          <pc:docMk/>
          <pc:sldMk cId="913073503" sldId="330"/>
        </pc:sldMkLst>
        <pc:spChg chg="mod">
          <ac:chgData name="Jorgensen, Rick" userId="22b7bd11-eb0f-413f-9bcb-9ce21ec7b0a8" providerId="ADAL" clId="{63C519A2-C2B2-47AC-828F-E429CD2FEDB2}" dt="2023-08-01T15:01:28.018" v="10857" actId="207"/>
          <ac:spMkLst>
            <pc:docMk/>
            <pc:sldMk cId="913073503" sldId="330"/>
            <ac:spMk id="2" creationId="{00000000-0000-0000-0000-000000000000}"/>
          </ac:spMkLst>
        </pc:spChg>
      </pc:sldChg>
      <pc:sldChg chg="addSp modSp mod">
        <pc:chgData name="Jorgensen, Rick" userId="22b7bd11-eb0f-413f-9bcb-9ce21ec7b0a8" providerId="ADAL" clId="{63C519A2-C2B2-47AC-828F-E429CD2FEDB2}" dt="2023-08-01T15:11:30.036" v="11171" actId="207"/>
        <pc:sldMkLst>
          <pc:docMk/>
          <pc:sldMk cId="400082519" sldId="332"/>
        </pc:sldMkLst>
        <pc:spChg chg="add mod">
          <ac:chgData name="Jorgensen, Rick" userId="22b7bd11-eb0f-413f-9bcb-9ce21ec7b0a8" providerId="ADAL" clId="{63C519A2-C2B2-47AC-828F-E429CD2FEDB2}" dt="2023-08-01T15:10:20.377" v="11162" actId="20577"/>
          <ac:spMkLst>
            <pc:docMk/>
            <pc:sldMk cId="400082519" sldId="332"/>
            <ac:spMk id="4" creationId="{E113C254-E4A3-31B0-2CEC-29CF4C5E22F3}"/>
          </ac:spMkLst>
        </pc:spChg>
        <pc:spChg chg="mod">
          <ac:chgData name="Jorgensen, Rick" userId="22b7bd11-eb0f-413f-9bcb-9ce21ec7b0a8" providerId="ADAL" clId="{63C519A2-C2B2-47AC-828F-E429CD2FEDB2}" dt="2023-08-01T15:11:30.036" v="11171" actId="207"/>
          <ac:spMkLst>
            <pc:docMk/>
            <pc:sldMk cId="400082519" sldId="332"/>
            <ac:spMk id="9" creationId="{7D999125-4BFA-114C-85A1-52968C4B85C6}"/>
          </ac:spMkLst>
        </pc:spChg>
        <pc:graphicFrameChg chg="mod">
          <ac:chgData name="Jorgensen, Rick" userId="22b7bd11-eb0f-413f-9bcb-9ce21ec7b0a8" providerId="ADAL" clId="{63C519A2-C2B2-47AC-828F-E429CD2FEDB2}" dt="2023-07-27T17:11:57.507" v="9030" actId="692"/>
          <ac:graphicFrameMkLst>
            <pc:docMk/>
            <pc:sldMk cId="400082519" sldId="332"/>
            <ac:graphicFrameMk id="2" creationId="{7DA9CAFC-E22D-4235-9BCD-9629C3388F48}"/>
          </ac:graphicFrameMkLst>
        </pc:graphicFrameChg>
        <pc:graphicFrameChg chg="mod">
          <ac:chgData name="Jorgensen, Rick" userId="22b7bd11-eb0f-413f-9bcb-9ce21ec7b0a8" providerId="ADAL" clId="{63C519A2-C2B2-47AC-828F-E429CD2FEDB2}" dt="2023-07-27T17:11:43.497" v="9023" actId="20577"/>
          <ac:graphicFrameMkLst>
            <pc:docMk/>
            <pc:sldMk cId="400082519" sldId="332"/>
            <ac:graphicFrameMk id="3" creationId="{96047870-A663-6440-BE4E-10F8515D4591}"/>
          </ac:graphicFrameMkLst>
        </pc:graphicFrameChg>
      </pc:sldChg>
      <pc:sldChg chg="modSp mod">
        <pc:chgData name="Jorgensen, Rick" userId="22b7bd11-eb0f-413f-9bcb-9ce21ec7b0a8" providerId="ADAL" clId="{63C519A2-C2B2-47AC-828F-E429CD2FEDB2}" dt="2023-08-01T15:14:04.086" v="11186" actId="207"/>
        <pc:sldMkLst>
          <pc:docMk/>
          <pc:sldMk cId="1044495293" sldId="333"/>
        </pc:sldMkLst>
        <pc:spChg chg="mod">
          <ac:chgData name="Jorgensen, Rick" userId="22b7bd11-eb0f-413f-9bcb-9ce21ec7b0a8" providerId="ADAL" clId="{63C519A2-C2B2-47AC-828F-E429CD2FEDB2}" dt="2023-08-01T15:14:04.086" v="11186" actId="207"/>
          <ac:spMkLst>
            <pc:docMk/>
            <pc:sldMk cId="1044495293" sldId="333"/>
            <ac:spMk id="2" creationId="{00000000-0000-0000-0000-000000000000}"/>
          </ac:spMkLst>
        </pc:spChg>
        <pc:spChg chg="mod">
          <ac:chgData name="Jorgensen, Rick" userId="22b7bd11-eb0f-413f-9bcb-9ce21ec7b0a8" providerId="ADAL" clId="{63C519A2-C2B2-47AC-828F-E429CD2FEDB2}" dt="2023-08-01T15:12:10.222" v="11185" actId="20577"/>
          <ac:spMkLst>
            <pc:docMk/>
            <pc:sldMk cId="1044495293" sldId="333"/>
            <ac:spMk id="3" creationId="{00000000-0000-0000-0000-000000000000}"/>
          </ac:spMkLst>
        </pc:spChg>
      </pc:sldChg>
      <pc:sldChg chg="addSp delSp modSp mod">
        <pc:chgData name="Jorgensen, Rick" userId="22b7bd11-eb0f-413f-9bcb-9ce21ec7b0a8" providerId="ADAL" clId="{63C519A2-C2B2-47AC-828F-E429CD2FEDB2}" dt="2023-08-01T15:14:27.073" v="11194" actId="207"/>
        <pc:sldMkLst>
          <pc:docMk/>
          <pc:sldMk cId="2379362570" sldId="336"/>
        </pc:sldMkLst>
        <pc:spChg chg="del">
          <ac:chgData name="Jorgensen, Rick" userId="22b7bd11-eb0f-413f-9bcb-9ce21ec7b0a8" providerId="ADAL" clId="{63C519A2-C2B2-47AC-828F-E429CD2FEDB2}" dt="2023-06-23T16:49:14.839" v="5405" actId="478"/>
          <ac:spMkLst>
            <pc:docMk/>
            <pc:sldMk cId="2379362570" sldId="336"/>
            <ac:spMk id="2" creationId="{045D2E1B-40DF-21D3-04E7-9DE21F300561}"/>
          </ac:spMkLst>
        </pc:spChg>
        <pc:spChg chg="add mod">
          <ac:chgData name="Jorgensen, Rick" userId="22b7bd11-eb0f-413f-9bcb-9ce21ec7b0a8" providerId="ADAL" clId="{63C519A2-C2B2-47AC-828F-E429CD2FEDB2}" dt="2023-08-01T15:14:24.987" v="11193"/>
          <ac:spMkLst>
            <pc:docMk/>
            <pc:sldMk cId="2379362570" sldId="336"/>
            <ac:spMk id="2" creationId="{08A7B40D-026C-5D3D-02BE-8B4DDBDBF1D5}"/>
          </ac:spMkLst>
        </pc:spChg>
        <pc:spChg chg="mod">
          <ac:chgData name="Jorgensen, Rick" userId="22b7bd11-eb0f-413f-9bcb-9ce21ec7b0a8" providerId="ADAL" clId="{63C519A2-C2B2-47AC-828F-E429CD2FEDB2}" dt="2023-08-01T15:14:27.073" v="11194" actId="207"/>
          <ac:spMkLst>
            <pc:docMk/>
            <pc:sldMk cId="2379362570" sldId="336"/>
            <ac:spMk id="25" creationId="{43DF711F-4684-B34D-9236-D3A26D348F11}"/>
          </ac:spMkLst>
        </pc:spChg>
        <pc:graphicFrameChg chg="mod">
          <ac:chgData name="Jorgensen, Rick" userId="22b7bd11-eb0f-413f-9bcb-9ce21ec7b0a8" providerId="ADAL" clId="{63C519A2-C2B2-47AC-828F-E429CD2FEDB2}" dt="2023-07-27T17:12:58.873" v="9070" actId="692"/>
          <ac:graphicFrameMkLst>
            <pc:docMk/>
            <pc:sldMk cId="2379362570" sldId="336"/>
            <ac:graphicFrameMk id="4" creationId="{FD838422-8D1E-DB4E-BD54-3F097ACD7685}"/>
          </ac:graphicFrameMkLst>
        </pc:graphicFrameChg>
        <pc:graphicFrameChg chg="mod">
          <ac:chgData name="Jorgensen, Rick" userId="22b7bd11-eb0f-413f-9bcb-9ce21ec7b0a8" providerId="ADAL" clId="{63C519A2-C2B2-47AC-828F-E429CD2FEDB2}" dt="2023-07-27T17:12:45.416" v="9058" actId="692"/>
          <ac:graphicFrameMkLst>
            <pc:docMk/>
            <pc:sldMk cId="2379362570" sldId="336"/>
            <ac:graphicFrameMk id="5" creationId="{7736B398-AA26-FA4F-816A-B5494460DD23}"/>
          </ac:graphicFrameMkLst>
        </pc:graphicFrameChg>
      </pc:sldChg>
      <pc:sldChg chg="modSp mod">
        <pc:chgData name="Jorgensen, Rick" userId="22b7bd11-eb0f-413f-9bcb-9ce21ec7b0a8" providerId="ADAL" clId="{63C519A2-C2B2-47AC-828F-E429CD2FEDB2}" dt="2023-08-01T15:14:38.926" v="11201" actId="20577"/>
        <pc:sldMkLst>
          <pc:docMk/>
          <pc:sldMk cId="4068842680" sldId="337"/>
        </pc:sldMkLst>
        <pc:spChg chg="mod">
          <ac:chgData name="Jorgensen, Rick" userId="22b7bd11-eb0f-413f-9bcb-9ce21ec7b0a8" providerId="ADAL" clId="{63C519A2-C2B2-47AC-828F-E429CD2FEDB2}" dt="2023-08-01T15:14:32.878" v="11197" actId="207"/>
          <ac:spMkLst>
            <pc:docMk/>
            <pc:sldMk cId="4068842680" sldId="337"/>
            <ac:spMk id="2" creationId="{00000000-0000-0000-0000-000000000000}"/>
          </ac:spMkLst>
        </pc:spChg>
        <pc:spChg chg="mod">
          <ac:chgData name="Jorgensen, Rick" userId="22b7bd11-eb0f-413f-9bcb-9ce21ec7b0a8" providerId="ADAL" clId="{63C519A2-C2B2-47AC-828F-E429CD2FEDB2}" dt="2023-08-01T15:14:38.926" v="11201" actId="20577"/>
          <ac:spMkLst>
            <pc:docMk/>
            <pc:sldMk cId="4068842680" sldId="337"/>
            <ac:spMk id="3" creationId="{00000000-0000-0000-0000-000000000000}"/>
          </ac:spMkLst>
        </pc:spChg>
      </pc:sldChg>
      <pc:sldChg chg="addSp delSp modSp mod ord">
        <pc:chgData name="Jorgensen, Rick" userId="22b7bd11-eb0f-413f-9bcb-9ce21ec7b0a8" providerId="ADAL" clId="{63C519A2-C2B2-47AC-828F-E429CD2FEDB2}" dt="2023-08-01T14:55:13.304" v="10742"/>
        <pc:sldMkLst>
          <pc:docMk/>
          <pc:sldMk cId="1798676617" sldId="343"/>
        </pc:sldMkLst>
        <pc:spChg chg="add del mod">
          <ac:chgData name="Jorgensen, Rick" userId="22b7bd11-eb0f-413f-9bcb-9ce21ec7b0a8" providerId="ADAL" clId="{63C519A2-C2B2-47AC-828F-E429CD2FEDB2}" dt="2023-06-23T16:10:43.013" v="5345" actId="478"/>
          <ac:spMkLst>
            <pc:docMk/>
            <pc:sldMk cId="1798676617" sldId="343"/>
            <ac:spMk id="3" creationId="{C3E26FDF-2E30-0F6E-3E18-71488F7CF4CA}"/>
          </ac:spMkLst>
        </pc:spChg>
        <pc:spChg chg="add mod">
          <ac:chgData name="Jorgensen, Rick" userId="22b7bd11-eb0f-413f-9bcb-9ce21ec7b0a8" providerId="ADAL" clId="{63C519A2-C2B2-47AC-828F-E429CD2FEDB2}" dt="2023-06-23T16:09:33.629" v="5328" actId="1076"/>
          <ac:spMkLst>
            <pc:docMk/>
            <pc:sldMk cId="1798676617" sldId="343"/>
            <ac:spMk id="5" creationId="{F00554FB-01E5-5189-7B27-BA53E39CB641}"/>
          </ac:spMkLst>
        </pc:spChg>
        <pc:spChg chg="mod">
          <ac:chgData name="Jorgensen, Rick" userId="22b7bd11-eb0f-413f-9bcb-9ce21ec7b0a8" providerId="ADAL" clId="{63C519A2-C2B2-47AC-828F-E429CD2FEDB2}" dt="2023-07-27T14:30:00.908" v="8877" actId="692"/>
          <ac:spMkLst>
            <pc:docMk/>
            <pc:sldMk cId="1798676617" sldId="343"/>
            <ac:spMk id="11" creationId="{6EC777B4-DD9B-51E4-5EED-D6B898FCD4B9}"/>
          </ac:spMkLst>
        </pc:spChg>
        <pc:spChg chg="mod">
          <ac:chgData name="Jorgensen, Rick" userId="22b7bd11-eb0f-413f-9bcb-9ce21ec7b0a8" providerId="ADAL" clId="{63C519A2-C2B2-47AC-828F-E429CD2FEDB2}" dt="2023-07-27T14:30:19.869" v="8880" actId="1076"/>
          <ac:spMkLst>
            <pc:docMk/>
            <pc:sldMk cId="1798676617" sldId="343"/>
            <ac:spMk id="12" creationId="{D4DED1DD-2A27-F01E-C40C-98FDEB342AC6}"/>
          </ac:spMkLst>
        </pc:spChg>
        <pc:spChg chg="mod">
          <ac:chgData name="Jorgensen, Rick" userId="22b7bd11-eb0f-413f-9bcb-9ce21ec7b0a8" providerId="ADAL" clId="{63C519A2-C2B2-47AC-828F-E429CD2FEDB2}" dt="2023-07-27T14:30:11.705" v="8879" actId="1076"/>
          <ac:spMkLst>
            <pc:docMk/>
            <pc:sldMk cId="1798676617" sldId="343"/>
            <ac:spMk id="14" creationId="{69CF272C-2D89-C994-4640-91220AA8371B}"/>
          </ac:spMkLst>
        </pc:spChg>
        <pc:spChg chg="add mod">
          <ac:chgData name="Jorgensen, Rick" userId="22b7bd11-eb0f-413f-9bcb-9ce21ec7b0a8" providerId="ADAL" clId="{63C519A2-C2B2-47AC-828F-E429CD2FEDB2}" dt="2023-06-23T16:09:36.266" v="5330" actId="1076"/>
          <ac:spMkLst>
            <pc:docMk/>
            <pc:sldMk cId="1798676617" sldId="343"/>
            <ac:spMk id="16" creationId="{C8B8B8BA-7BDC-9F72-13F9-D93DD01E3FF4}"/>
          </ac:spMkLst>
        </pc:spChg>
        <pc:spChg chg="add mod">
          <ac:chgData name="Jorgensen, Rick" userId="22b7bd11-eb0f-413f-9bcb-9ce21ec7b0a8" providerId="ADAL" clId="{63C519A2-C2B2-47AC-828F-E429CD2FEDB2}" dt="2023-06-23T16:09:47.437" v="5332" actId="1076"/>
          <ac:spMkLst>
            <pc:docMk/>
            <pc:sldMk cId="1798676617" sldId="343"/>
            <ac:spMk id="17" creationId="{ABD3FCDE-4F55-12C5-3ED0-759725A969FF}"/>
          </ac:spMkLst>
        </pc:spChg>
        <pc:spChg chg="add mod">
          <ac:chgData name="Jorgensen, Rick" userId="22b7bd11-eb0f-413f-9bcb-9ce21ec7b0a8" providerId="ADAL" clId="{63C519A2-C2B2-47AC-828F-E429CD2FEDB2}" dt="2023-06-23T16:10:00.231" v="5337" actId="1076"/>
          <ac:spMkLst>
            <pc:docMk/>
            <pc:sldMk cId="1798676617" sldId="343"/>
            <ac:spMk id="18" creationId="{9C0CF2E8-B029-CB02-D340-C3940B7D5AC8}"/>
          </ac:spMkLst>
        </pc:spChg>
        <pc:spChg chg="add mod">
          <ac:chgData name="Jorgensen, Rick" userId="22b7bd11-eb0f-413f-9bcb-9ce21ec7b0a8" providerId="ADAL" clId="{63C519A2-C2B2-47AC-828F-E429CD2FEDB2}" dt="2023-06-23T16:10:10.628" v="5342" actId="1076"/>
          <ac:spMkLst>
            <pc:docMk/>
            <pc:sldMk cId="1798676617" sldId="343"/>
            <ac:spMk id="19" creationId="{9141F109-D077-F891-0395-DFBCC4DD22F0}"/>
          </ac:spMkLst>
        </pc:spChg>
        <pc:spChg chg="add mod">
          <ac:chgData name="Jorgensen, Rick" userId="22b7bd11-eb0f-413f-9bcb-9ce21ec7b0a8" providerId="ADAL" clId="{63C519A2-C2B2-47AC-828F-E429CD2FEDB2}" dt="2023-06-23T16:10:19.912" v="5344" actId="1076"/>
          <ac:spMkLst>
            <pc:docMk/>
            <pc:sldMk cId="1798676617" sldId="343"/>
            <ac:spMk id="20" creationId="{FF7F4E7C-6297-CCCC-BB1E-8F6057D8A633}"/>
          </ac:spMkLst>
        </pc:spChg>
        <pc:spChg chg="add mod">
          <ac:chgData name="Jorgensen, Rick" userId="22b7bd11-eb0f-413f-9bcb-9ce21ec7b0a8" providerId="ADAL" clId="{63C519A2-C2B2-47AC-828F-E429CD2FEDB2}" dt="2023-06-23T16:10:54.238" v="5347" actId="1076"/>
          <ac:spMkLst>
            <pc:docMk/>
            <pc:sldMk cId="1798676617" sldId="343"/>
            <ac:spMk id="21" creationId="{F7BB04A9-0072-F756-E5D3-E79311134169}"/>
          </ac:spMkLst>
        </pc:spChg>
        <pc:spChg chg="add mod">
          <ac:chgData name="Jorgensen, Rick" userId="22b7bd11-eb0f-413f-9bcb-9ce21ec7b0a8" providerId="ADAL" clId="{63C519A2-C2B2-47AC-828F-E429CD2FEDB2}" dt="2023-06-23T16:10:58.286" v="5349" actId="1076"/>
          <ac:spMkLst>
            <pc:docMk/>
            <pc:sldMk cId="1798676617" sldId="343"/>
            <ac:spMk id="22" creationId="{0FFFA28B-A02D-594B-A2B7-66E1B2477C61}"/>
          </ac:spMkLst>
        </pc:spChg>
        <pc:spChg chg="add mod">
          <ac:chgData name="Jorgensen, Rick" userId="22b7bd11-eb0f-413f-9bcb-9ce21ec7b0a8" providerId="ADAL" clId="{63C519A2-C2B2-47AC-828F-E429CD2FEDB2}" dt="2023-06-23T16:11:01.331" v="5351" actId="1076"/>
          <ac:spMkLst>
            <pc:docMk/>
            <pc:sldMk cId="1798676617" sldId="343"/>
            <ac:spMk id="23" creationId="{3AC7A3DA-6D6F-D636-8021-D23DA1B4C9FF}"/>
          </ac:spMkLst>
        </pc:spChg>
        <pc:spChg chg="add mod">
          <ac:chgData name="Jorgensen, Rick" userId="22b7bd11-eb0f-413f-9bcb-9ce21ec7b0a8" providerId="ADAL" clId="{63C519A2-C2B2-47AC-828F-E429CD2FEDB2}" dt="2023-06-23T16:11:05.518" v="5354" actId="1076"/>
          <ac:spMkLst>
            <pc:docMk/>
            <pc:sldMk cId="1798676617" sldId="343"/>
            <ac:spMk id="24" creationId="{62EFFA78-8B90-4BB8-4745-30AC2E070E03}"/>
          </ac:spMkLst>
        </pc:spChg>
        <pc:graphicFrameChg chg="mod">
          <ac:chgData name="Jorgensen, Rick" userId="22b7bd11-eb0f-413f-9bcb-9ce21ec7b0a8" providerId="ADAL" clId="{63C519A2-C2B2-47AC-828F-E429CD2FEDB2}" dt="2023-07-27T14:29:34.728" v="8865" actId="692"/>
          <ac:graphicFrameMkLst>
            <pc:docMk/>
            <pc:sldMk cId="1798676617" sldId="343"/>
            <ac:graphicFrameMk id="4" creationId="{0C0BD2FB-6516-44C3-A718-4E33F5A1BC6B}"/>
          </ac:graphicFrameMkLst>
        </pc:graphicFrameChg>
        <pc:graphicFrameChg chg="mod">
          <ac:chgData name="Jorgensen, Rick" userId="22b7bd11-eb0f-413f-9bcb-9ce21ec7b0a8" providerId="ADAL" clId="{63C519A2-C2B2-47AC-828F-E429CD2FEDB2}" dt="2023-07-27T14:29:51.964" v="8875" actId="692"/>
          <ac:graphicFrameMkLst>
            <pc:docMk/>
            <pc:sldMk cId="1798676617" sldId="343"/>
            <ac:graphicFrameMk id="7" creationId="{1F498BC0-BC61-4CF6-AB17-930ACBFDA2DD}"/>
          </ac:graphicFrameMkLst>
        </pc:graphicFrameChg>
      </pc:sldChg>
      <pc:sldChg chg="modSp mod ord">
        <pc:chgData name="Jorgensen, Rick" userId="22b7bd11-eb0f-413f-9bcb-9ce21ec7b0a8" providerId="ADAL" clId="{63C519A2-C2B2-47AC-828F-E429CD2FEDB2}" dt="2023-08-01T14:55:13.304" v="10742"/>
        <pc:sldMkLst>
          <pc:docMk/>
          <pc:sldMk cId="3719922809" sldId="344"/>
        </pc:sldMkLst>
        <pc:spChg chg="mod">
          <ac:chgData name="Jorgensen, Rick" userId="22b7bd11-eb0f-413f-9bcb-9ce21ec7b0a8" providerId="ADAL" clId="{63C519A2-C2B2-47AC-828F-E429CD2FEDB2}" dt="2023-07-27T14:28:51.467" v="8858" actId="692"/>
          <ac:spMkLst>
            <pc:docMk/>
            <pc:sldMk cId="3719922809" sldId="344"/>
            <ac:spMk id="14" creationId="{DAE00FD3-EDB7-0AA6-3EA5-7CE02633AE5B}"/>
          </ac:spMkLst>
        </pc:spChg>
        <pc:spChg chg="mod">
          <ac:chgData name="Jorgensen, Rick" userId="22b7bd11-eb0f-413f-9bcb-9ce21ec7b0a8" providerId="ADAL" clId="{63C519A2-C2B2-47AC-828F-E429CD2FEDB2}" dt="2023-07-27T14:29:06.580" v="8859" actId="692"/>
          <ac:spMkLst>
            <pc:docMk/>
            <pc:sldMk cId="3719922809" sldId="344"/>
            <ac:spMk id="29" creationId="{FF30619C-4267-300B-69AD-4C3DD433F248}"/>
          </ac:spMkLst>
        </pc:spChg>
        <pc:graphicFrameChg chg="mod">
          <ac:chgData name="Jorgensen, Rick" userId="22b7bd11-eb0f-413f-9bcb-9ce21ec7b0a8" providerId="ADAL" clId="{63C519A2-C2B2-47AC-828F-E429CD2FEDB2}" dt="2023-07-27T14:26:39.546" v="8853" actId="692"/>
          <ac:graphicFrameMkLst>
            <pc:docMk/>
            <pc:sldMk cId="3719922809" sldId="344"/>
            <ac:graphicFrameMk id="2" creationId="{4C1A20E4-5A7D-4ACB-B676-18D71F0183DE}"/>
          </ac:graphicFrameMkLst>
        </pc:graphicFrameChg>
        <pc:graphicFrameChg chg="mod">
          <ac:chgData name="Jorgensen, Rick" userId="22b7bd11-eb0f-413f-9bcb-9ce21ec7b0a8" providerId="ADAL" clId="{63C519A2-C2B2-47AC-828F-E429CD2FEDB2}" dt="2023-07-27T14:26:49.827" v="8857" actId="692"/>
          <ac:graphicFrameMkLst>
            <pc:docMk/>
            <pc:sldMk cId="3719922809" sldId="344"/>
            <ac:graphicFrameMk id="3" creationId="{26DDEA2D-0E9D-4FB9-973D-16DEFDB90893}"/>
          </ac:graphicFrameMkLst>
        </pc:graphicFrameChg>
      </pc:sldChg>
      <pc:sldChg chg="modSp mod ord">
        <pc:chgData name="Jorgensen, Rick" userId="22b7bd11-eb0f-413f-9bcb-9ce21ec7b0a8" providerId="ADAL" clId="{63C519A2-C2B2-47AC-828F-E429CD2FEDB2}" dt="2023-08-01T15:01:49.444" v="10859"/>
        <pc:sldMkLst>
          <pc:docMk/>
          <pc:sldMk cId="3247327489" sldId="350"/>
        </pc:sldMkLst>
        <pc:spChg chg="mod">
          <ac:chgData name="Jorgensen, Rick" userId="22b7bd11-eb0f-413f-9bcb-9ce21ec7b0a8" providerId="ADAL" clId="{63C519A2-C2B2-47AC-828F-E429CD2FEDB2}" dt="2023-07-24T16:56:45.353" v="7549" actId="1076"/>
          <ac:spMkLst>
            <pc:docMk/>
            <pc:sldMk cId="3247327489" sldId="350"/>
            <ac:spMk id="14" creationId="{23478ECB-C0DB-7751-2BDB-0AC0625EFB69}"/>
          </ac:spMkLst>
        </pc:spChg>
        <pc:graphicFrameChg chg="mod">
          <ac:chgData name="Jorgensen, Rick" userId="22b7bd11-eb0f-413f-9bcb-9ce21ec7b0a8" providerId="ADAL" clId="{63C519A2-C2B2-47AC-828F-E429CD2FEDB2}" dt="2023-06-23T21:21:49.976" v="5850" actId="692"/>
          <ac:graphicFrameMkLst>
            <pc:docMk/>
            <pc:sldMk cId="3247327489" sldId="350"/>
            <ac:graphicFrameMk id="2" creationId="{49BDDCB0-92CF-4CFD-99A2-8A19467FEA82}"/>
          </ac:graphicFrameMkLst>
        </pc:graphicFrameChg>
      </pc:sldChg>
      <pc:sldChg chg="addSp modSp mod ord">
        <pc:chgData name="Jorgensen, Rick" userId="22b7bd11-eb0f-413f-9bcb-9ce21ec7b0a8" providerId="ADAL" clId="{63C519A2-C2B2-47AC-828F-E429CD2FEDB2}" dt="2023-08-01T15:01:49.444" v="10859"/>
        <pc:sldMkLst>
          <pc:docMk/>
          <pc:sldMk cId="908059905" sldId="352"/>
        </pc:sldMkLst>
        <pc:spChg chg="mod">
          <ac:chgData name="Jorgensen, Rick" userId="22b7bd11-eb0f-413f-9bcb-9ce21ec7b0a8" providerId="ADAL" clId="{63C519A2-C2B2-47AC-828F-E429CD2FEDB2}" dt="2023-06-27T16:25:23.770" v="6123" actId="1076"/>
          <ac:spMkLst>
            <pc:docMk/>
            <pc:sldMk cId="908059905" sldId="352"/>
            <ac:spMk id="4" creationId="{A97E7F01-98B7-43A1-8851-FFD015082EDD}"/>
          </ac:spMkLst>
        </pc:spChg>
        <pc:spChg chg="mod">
          <ac:chgData name="Jorgensen, Rick" userId="22b7bd11-eb0f-413f-9bcb-9ce21ec7b0a8" providerId="ADAL" clId="{63C519A2-C2B2-47AC-828F-E429CD2FEDB2}" dt="2023-06-27T16:24:30.234" v="6073" actId="20577"/>
          <ac:spMkLst>
            <pc:docMk/>
            <pc:sldMk cId="908059905" sldId="352"/>
            <ac:spMk id="5" creationId="{D4ACEC80-D129-38DD-1A6F-FD08BCD6D14A}"/>
          </ac:spMkLst>
        </pc:spChg>
        <pc:spChg chg="mod">
          <ac:chgData name="Jorgensen, Rick" userId="22b7bd11-eb0f-413f-9bcb-9ce21ec7b0a8" providerId="ADAL" clId="{63C519A2-C2B2-47AC-828F-E429CD2FEDB2}" dt="2023-06-27T16:25:01.033" v="6086" actId="1076"/>
          <ac:spMkLst>
            <pc:docMk/>
            <pc:sldMk cId="908059905" sldId="352"/>
            <ac:spMk id="10" creationId="{2FC9C943-E7A2-254A-C199-16A008EB25A2}"/>
          </ac:spMkLst>
        </pc:spChg>
        <pc:spChg chg="mod">
          <ac:chgData name="Jorgensen, Rick" userId="22b7bd11-eb0f-413f-9bcb-9ce21ec7b0a8" providerId="ADAL" clId="{63C519A2-C2B2-47AC-828F-E429CD2FEDB2}" dt="2023-07-27T15:46:46.075" v="8991"/>
          <ac:spMkLst>
            <pc:docMk/>
            <pc:sldMk cId="908059905" sldId="352"/>
            <ac:spMk id="11" creationId="{A301A7AC-BCCF-7431-D387-0437EACF1FE3}"/>
          </ac:spMkLst>
        </pc:spChg>
        <pc:spChg chg="add mod">
          <ac:chgData name="Jorgensen, Rick" userId="22b7bd11-eb0f-413f-9bcb-9ce21ec7b0a8" providerId="ADAL" clId="{63C519A2-C2B2-47AC-828F-E429CD2FEDB2}" dt="2023-06-27T16:24:55.472" v="6085" actId="1076"/>
          <ac:spMkLst>
            <pc:docMk/>
            <pc:sldMk cId="908059905" sldId="352"/>
            <ac:spMk id="12" creationId="{91412B21-5699-76A4-638D-F5C88BDD452E}"/>
          </ac:spMkLst>
        </pc:spChg>
        <pc:spChg chg="add mod">
          <ac:chgData name="Jorgensen, Rick" userId="22b7bd11-eb0f-413f-9bcb-9ce21ec7b0a8" providerId="ADAL" clId="{63C519A2-C2B2-47AC-828F-E429CD2FEDB2}" dt="2023-06-27T16:25:37.614" v="6157" actId="113"/>
          <ac:spMkLst>
            <pc:docMk/>
            <pc:sldMk cId="908059905" sldId="352"/>
            <ac:spMk id="13" creationId="{246F5D56-8A99-5983-B14B-53DFA659B3F7}"/>
          </ac:spMkLst>
        </pc:spChg>
        <pc:spChg chg="add mod">
          <ac:chgData name="Jorgensen, Rick" userId="22b7bd11-eb0f-413f-9bcb-9ce21ec7b0a8" providerId="ADAL" clId="{63C519A2-C2B2-47AC-828F-E429CD2FEDB2}" dt="2023-07-27T15:46:40.794" v="8990" actId="20577"/>
          <ac:spMkLst>
            <pc:docMk/>
            <pc:sldMk cId="908059905" sldId="352"/>
            <ac:spMk id="15" creationId="{569A78EF-455C-E828-7C0D-E15312F2BEC2}"/>
          </ac:spMkLst>
        </pc:spChg>
        <pc:graphicFrameChg chg="mod">
          <ac:chgData name="Jorgensen, Rick" userId="22b7bd11-eb0f-413f-9bcb-9ce21ec7b0a8" providerId="ADAL" clId="{63C519A2-C2B2-47AC-828F-E429CD2FEDB2}" dt="2023-07-27T15:45:57.334" v="8969" actId="692"/>
          <ac:graphicFrameMkLst>
            <pc:docMk/>
            <pc:sldMk cId="908059905" sldId="352"/>
            <ac:graphicFrameMk id="2" creationId="{364BF032-DB2A-4F73-9CE2-82AE4C9042C6}"/>
          </ac:graphicFrameMkLst>
        </pc:graphicFrameChg>
        <pc:graphicFrameChg chg="mod">
          <ac:chgData name="Jorgensen, Rick" userId="22b7bd11-eb0f-413f-9bcb-9ce21ec7b0a8" providerId="ADAL" clId="{63C519A2-C2B2-47AC-828F-E429CD2FEDB2}" dt="2023-07-27T15:46:02.013" v="8975" actId="692"/>
          <ac:graphicFrameMkLst>
            <pc:docMk/>
            <pc:sldMk cId="908059905" sldId="352"/>
            <ac:graphicFrameMk id="7" creationId="{364BF032-DB2A-4F73-9CE2-82AE4C9042C6}"/>
          </ac:graphicFrameMkLst>
        </pc:graphicFrameChg>
        <pc:cxnChg chg="add mod">
          <ac:chgData name="Jorgensen, Rick" userId="22b7bd11-eb0f-413f-9bcb-9ce21ec7b0a8" providerId="ADAL" clId="{63C519A2-C2B2-47AC-828F-E429CD2FEDB2}" dt="2023-07-27T15:45:47.826" v="8963" actId="692"/>
          <ac:cxnSpMkLst>
            <pc:docMk/>
            <pc:sldMk cId="908059905" sldId="352"/>
            <ac:cxnSpMk id="9" creationId="{F053A922-3A73-2702-3250-B999540E4511}"/>
          </ac:cxnSpMkLst>
        </pc:cxnChg>
        <pc:cxnChg chg="add mod">
          <ac:chgData name="Jorgensen, Rick" userId="22b7bd11-eb0f-413f-9bcb-9ce21ec7b0a8" providerId="ADAL" clId="{63C519A2-C2B2-47AC-828F-E429CD2FEDB2}" dt="2023-07-27T15:46:24.459" v="8977" actId="1076"/>
          <ac:cxnSpMkLst>
            <pc:docMk/>
            <pc:sldMk cId="908059905" sldId="352"/>
            <ac:cxnSpMk id="14" creationId="{94A53DBF-D491-3F20-90E7-C96B5289B2CD}"/>
          </ac:cxnSpMkLst>
        </pc:cxnChg>
      </pc:sldChg>
      <pc:sldChg chg="delSp mod ord">
        <pc:chgData name="Jorgensen, Rick" userId="22b7bd11-eb0f-413f-9bcb-9ce21ec7b0a8" providerId="ADAL" clId="{63C519A2-C2B2-47AC-828F-E429CD2FEDB2}" dt="2023-08-01T15:01:49.444" v="10859"/>
        <pc:sldMkLst>
          <pc:docMk/>
          <pc:sldMk cId="1098282450" sldId="357"/>
        </pc:sldMkLst>
        <pc:spChg chg="del">
          <ac:chgData name="Jorgensen, Rick" userId="22b7bd11-eb0f-413f-9bcb-9ce21ec7b0a8" providerId="ADAL" clId="{63C519A2-C2B2-47AC-828F-E429CD2FEDB2}" dt="2023-06-23T16:49:26.616" v="5407" actId="478"/>
          <ac:spMkLst>
            <pc:docMk/>
            <pc:sldMk cId="1098282450" sldId="357"/>
            <ac:spMk id="4" creationId="{937ABA8F-B000-5D92-5319-42E410F90C23}"/>
          </ac:spMkLst>
        </pc:spChg>
      </pc:sldChg>
      <pc:sldChg chg="modSp mod ord">
        <pc:chgData name="Jorgensen, Rick" userId="22b7bd11-eb0f-413f-9bcb-9ce21ec7b0a8" providerId="ADAL" clId="{63C519A2-C2B2-47AC-828F-E429CD2FEDB2}" dt="2023-08-01T14:33:59.289" v="10268"/>
        <pc:sldMkLst>
          <pc:docMk/>
          <pc:sldMk cId="2562333133" sldId="364"/>
        </pc:sldMkLst>
        <pc:spChg chg="mod">
          <ac:chgData name="Jorgensen, Rick" userId="22b7bd11-eb0f-413f-9bcb-9ce21ec7b0a8" providerId="ADAL" clId="{63C519A2-C2B2-47AC-828F-E429CD2FEDB2}" dt="2023-06-27T16:10:15.815" v="5894" actId="20577"/>
          <ac:spMkLst>
            <pc:docMk/>
            <pc:sldMk cId="2562333133" sldId="364"/>
            <ac:spMk id="3" creationId="{00000000-0000-0000-0000-000000000000}"/>
          </ac:spMkLst>
        </pc:spChg>
      </pc:sldChg>
      <pc:sldChg chg="delSp modSp mod modNotesTx">
        <pc:chgData name="Jorgensen, Rick" userId="22b7bd11-eb0f-413f-9bcb-9ce21ec7b0a8" providerId="ADAL" clId="{63C519A2-C2B2-47AC-828F-E429CD2FEDB2}" dt="2023-08-01T15:01:19.456" v="10853" actId="207"/>
        <pc:sldMkLst>
          <pc:docMk/>
          <pc:sldMk cId="409862460" sldId="370"/>
        </pc:sldMkLst>
        <pc:spChg chg="del">
          <ac:chgData name="Jorgensen, Rick" userId="22b7bd11-eb0f-413f-9bcb-9ce21ec7b0a8" providerId="ADAL" clId="{63C519A2-C2B2-47AC-828F-E429CD2FEDB2}" dt="2023-06-23T17:29:40.683" v="5415" actId="478"/>
          <ac:spMkLst>
            <pc:docMk/>
            <pc:sldMk cId="409862460" sldId="370"/>
            <ac:spMk id="4" creationId="{CAC50F2A-3A83-86A5-B627-8DD3996DFAE3}"/>
          </ac:spMkLst>
        </pc:spChg>
        <pc:spChg chg="mod">
          <ac:chgData name="Jorgensen, Rick" userId="22b7bd11-eb0f-413f-9bcb-9ce21ec7b0a8" providerId="ADAL" clId="{63C519A2-C2B2-47AC-828F-E429CD2FEDB2}" dt="2023-08-01T15:01:19.456" v="10853" actId="207"/>
          <ac:spMkLst>
            <pc:docMk/>
            <pc:sldMk cId="409862460" sldId="370"/>
            <ac:spMk id="25" creationId="{43DF711F-4684-B34D-9236-D3A26D348F11}"/>
          </ac:spMkLst>
        </pc:spChg>
        <pc:graphicFrameChg chg="mod">
          <ac:chgData name="Jorgensen, Rick" userId="22b7bd11-eb0f-413f-9bcb-9ce21ec7b0a8" providerId="ADAL" clId="{63C519A2-C2B2-47AC-828F-E429CD2FEDB2}" dt="2023-07-27T15:36:39.213" v="8950" actId="692"/>
          <ac:graphicFrameMkLst>
            <pc:docMk/>
            <pc:sldMk cId="409862460" sldId="370"/>
            <ac:graphicFrameMk id="5" creationId="{2EC3F3E2-A4EF-4B48-86D0-23E339D1EC91}"/>
          </ac:graphicFrameMkLst>
        </pc:graphicFrameChg>
        <pc:graphicFrameChg chg="mod ord">
          <ac:chgData name="Jorgensen, Rick" userId="22b7bd11-eb0f-413f-9bcb-9ce21ec7b0a8" providerId="ADAL" clId="{63C519A2-C2B2-47AC-828F-E429CD2FEDB2}" dt="2023-07-27T15:36:44.223" v="8952" actId="692"/>
          <ac:graphicFrameMkLst>
            <pc:docMk/>
            <pc:sldMk cId="409862460" sldId="370"/>
            <ac:graphicFrameMk id="6" creationId="{A27E7A54-A97F-B041-A3E9-B13A645A6280}"/>
          </ac:graphicFrameMkLst>
        </pc:graphicFrameChg>
      </pc:sldChg>
      <pc:sldChg chg="addSp modSp mod ord">
        <pc:chgData name="Jorgensen, Rick" userId="22b7bd11-eb0f-413f-9bcb-9ce21ec7b0a8" providerId="ADAL" clId="{63C519A2-C2B2-47AC-828F-E429CD2FEDB2}" dt="2023-08-01T15:11:23.836" v="11170" actId="207"/>
        <pc:sldMkLst>
          <pc:docMk/>
          <pc:sldMk cId="4233420906" sldId="371"/>
        </pc:sldMkLst>
        <pc:spChg chg="add mod">
          <ac:chgData name="Jorgensen, Rick" userId="22b7bd11-eb0f-413f-9bcb-9ce21ec7b0a8" providerId="ADAL" clId="{63C519A2-C2B2-47AC-828F-E429CD2FEDB2}" dt="2023-08-01T14:42:53.173" v="10419" actId="20577"/>
          <ac:spMkLst>
            <pc:docMk/>
            <pc:sldMk cId="4233420906" sldId="371"/>
            <ac:spMk id="2" creationId="{D6C5BD8B-1213-63CE-A5EC-A6AD4B8F433D}"/>
          </ac:spMkLst>
        </pc:spChg>
        <pc:spChg chg="mod">
          <ac:chgData name="Jorgensen, Rick" userId="22b7bd11-eb0f-413f-9bcb-9ce21ec7b0a8" providerId="ADAL" clId="{63C519A2-C2B2-47AC-828F-E429CD2FEDB2}" dt="2023-08-01T15:11:23.836" v="11170" actId="207"/>
          <ac:spMkLst>
            <pc:docMk/>
            <pc:sldMk cId="4233420906" sldId="371"/>
            <ac:spMk id="4" creationId="{C1464C00-88D7-F8FC-7A22-D15A26949AB4}"/>
          </ac:spMkLst>
        </pc:spChg>
        <pc:spChg chg="add mod">
          <ac:chgData name="Jorgensen, Rick" userId="22b7bd11-eb0f-413f-9bcb-9ce21ec7b0a8" providerId="ADAL" clId="{63C519A2-C2B2-47AC-828F-E429CD2FEDB2}" dt="2023-08-01T15:11:21.332" v="11169"/>
          <ac:spMkLst>
            <pc:docMk/>
            <pc:sldMk cId="4233420906" sldId="371"/>
            <ac:spMk id="5" creationId="{3A53ACCA-D541-44AB-07A4-B6FE2AD4FD4D}"/>
          </ac:spMkLst>
        </pc:spChg>
        <pc:graphicFrameChg chg="mod">
          <ac:chgData name="Jorgensen, Rick" userId="22b7bd11-eb0f-413f-9bcb-9ce21ec7b0a8" providerId="ADAL" clId="{63C519A2-C2B2-47AC-828F-E429CD2FEDB2}" dt="2023-07-27T14:23:24.315" v="8820" actId="692"/>
          <ac:graphicFrameMkLst>
            <pc:docMk/>
            <pc:sldMk cId="4233420906" sldId="371"/>
            <ac:graphicFrameMk id="3" creationId="{1109EF19-42B5-1D41-9810-BAD609E3061D}"/>
          </ac:graphicFrameMkLst>
        </pc:graphicFrameChg>
      </pc:sldChg>
      <pc:sldChg chg="del">
        <pc:chgData name="Jorgensen, Rick" userId="22b7bd11-eb0f-413f-9bcb-9ce21ec7b0a8" providerId="ADAL" clId="{63C519A2-C2B2-47AC-828F-E429CD2FEDB2}" dt="2023-08-01T14:45:54.634" v="10468" actId="47"/>
        <pc:sldMkLst>
          <pc:docMk/>
          <pc:sldMk cId="2596119900" sldId="373"/>
        </pc:sldMkLst>
      </pc:sldChg>
      <pc:sldChg chg="modSp mod">
        <pc:chgData name="Jorgensen, Rick" userId="22b7bd11-eb0f-413f-9bcb-9ce21ec7b0a8" providerId="ADAL" clId="{63C519A2-C2B2-47AC-828F-E429CD2FEDB2}" dt="2023-08-01T15:01:22.059" v="10854" actId="207"/>
        <pc:sldMkLst>
          <pc:docMk/>
          <pc:sldMk cId="776687571" sldId="374"/>
        </pc:sldMkLst>
        <pc:spChg chg="mod">
          <ac:chgData name="Jorgensen, Rick" userId="22b7bd11-eb0f-413f-9bcb-9ce21ec7b0a8" providerId="ADAL" clId="{63C519A2-C2B2-47AC-828F-E429CD2FEDB2}" dt="2023-08-01T15:01:22.059" v="10854" actId="207"/>
          <ac:spMkLst>
            <pc:docMk/>
            <pc:sldMk cId="776687571" sldId="374"/>
            <ac:spMk id="3" creationId="{2F7E0F7C-03F2-1332-6114-CE4883465440}"/>
          </ac:spMkLst>
        </pc:spChg>
        <pc:graphicFrameChg chg="mod">
          <ac:chgData name="Jorgensen, Rick" userId="22b7bd11-eb0f-413f-9bcb-9ce21ec7b0a8" providerId="ADAL" clId="{63C519A2-C2B2-47AC-828F-E429CD2FEDB2}" dt="2023-07-27T15:43:26.958" v="8958" actId="692"/>
          <ac:graphicFrameMkLst>
            <pc:docMk/>
            <pc:sldMk cId="776687571" sldId="374"/>
            <ac:graphicFrameMk id="2" creationId="{3ECE29A9-59FA-8DD2-48F2-2CABF395C46F}"/>
          </ac:graphicFrameMkLst>
        </pc:graphicFrameChg>
      </pc:sldChg>
      <pc:sldChg chg="delSp modSp mod">
        <pc:chgData name="Jorgensen, Rick" userId="22b7bd11-eb0f-413f-9bcb-9ce21ec7b0a8" providerId="ADAL" clId="{63C519A2-C2B2-47AC-828F-E429CD2FEDB2}" dt="2023-08-01T15:11:32.455" v="11172" actId="207"/>
        <pc:sldMkLst>
          <pc:docMk/>
          <pc:sldMk cId="1502923220" sldId="375"/>
        </pc:sldMkLst>
        <pc:spChg chg="del">
          <ac:chgData name="Jorgensen, Rick" userId="22b7bd11-eb0f-413f-9bcb-9ce21ec7b0a8" providerId="ADAL" clId="{63C519A2-C2B2-47AC-828F-E429CD2FEDB2}" dt="2023-06-23T16:49:18.230" v="5406" actId="478"/>
          <ac:spMkLst>
            <pc:docMk/>
            <pc:sldMk cId="1502923220" sldId="375"/>
            <ac:spMk id="4" creationId="{1BBEF2BE-D16D-0E31-CD71-68C2254D46C5}"/>
          </ac:spMkLst>
        </pc:spChg>
        <pc:spChg chg="mod">
          <ac:chgData name="Jorgensen, Rick" userId="22b7bd11-eb0f-413f-9bcb-9ce21ec7b0a8" providerId="ADAL" clId="{63C519A2-C2B2-47AC-828F-E429CD2FEDB2}" dt="2023-08-01T15:11:32.455" v="11172" actId="207"/>
          <ac:spMkLst>
            <pc:docMk/>
            <pc:sldMk cId="1502923220" sldId="375"/>
            <ac:spMk id="9" creationId="{7D999125-4BFA-114C-85A1-52968C4B85C6}"/>
          </ac:spMkLst>
        </pc:spChg>
        <pc:graphicFrameChg chg="mod">
          <ac:chgData name="Jorgensen, Rick" userId="22b7bd11-eb0f-413f-9bcb-9ce21ec7b0a8" providerId="ADAL" clId="{63C519A2-C2B2-47AC-828F-E429CD2FEDB2}" dt="2023-07-27T17:12:26.272" v="9050" actId="692"/>
          <ac:graphicFrameMkLst>
            <pc:docMk/>
            <pc:sldMk cId="1502923220" sldId="375"/>
            <ac:graphicFrameMk id="5" creationId="{96047870-A663-6440-BE4E-10F8515D4591}"/>
          </ac:graphicFrameMkLst>
        </pc:graphicFrameChg>
        <pc:graphicFrameChg chg="mod">
          <ac:chgData name="Jorgensen, Rick" userId="22b7bd11-eb0f-413f-9bcb-9ce21ec7b0a8" providerId="ADAL" clId="{63C519A2-C2B2-47AC-828F-E429CD2FEDB2}" dt="2023-07-27T17:12:15.893" v="9040" actId="20577"/>
          <ac:graphicFrameMkLst>
            <pc:docMk/>
            <pc:sldMk cId="1502923220" sldId="375"/>
            <ac:graphicFrameMk id="6" creationId="{D7ED6DED-B81D-0542-9B85-22EBCF9BB5B6}"/>
          </ac:graphicFrameMkLst>
        </pc:graphicFrameChg>
      </pc:sldChg>
      <pc:sldChg chg="delSp modSp mod">
        <pc:chgData name="Jorgensen, Rick" userId="22b7bd11-eb0f-413f-9bcb-9ce21ec7b0a8" providerId="ADAL" clId="{63C519A2-C2B2-47AC-828F-E429CD2FEDB2}" dt="2023-08-01T14:52:44.690" v="10553" actId="1076"/>
        <pc:sldMkLst>
          <pc:docMk/>
          <pc:sldMk cId="4070891446" sldId="377"/>
        </pc:sldMkLst>
        <pc:spChg chg="mod">
          <ac:chgData name="Jorgensen, Rick" userId="22b7bd11-eb0f-413f-9bcb-9ce21ec7b0a8" providerId="ADAL" clId="{63C519A2-C2B2-47AC-828F-E429CD2FEDB2}" dt="2023-08-01T14:50:04.831" v="10525" actId="1076"/>
          <ac:spMkLst>
            <pc:docMk/>
            <pc:sldMk cId="4070891446" sldId="377"/>
            <ac:spMk id="3" creationId="{92ECD0F9-DADE-D190-B3DF-8F9EB3FF9D26}"/>
          </ac:spMkLst>
        </pc:spChg>
        <pc:spChg chg="del">
          <ac:chgData name="Jorgensen, Rick" userId="22b7bd11-eb0f-413f-9bcb-9ce21ec7b0a8" providerId="ADAL" clId="{63C519A2-C2B2-47AC-828F-E429CD2FEDB2}" dt="2023-06-23T16:49:32.096" v="5408" actId="478"/>
          <ac:spMkLst>
            <pc:docMk/>
            <pc:sldMk cId="4070891446" sldId="377"/>
            <ac:spMk id="4" creationId="{B97269DB-9802-4E8C-E3F7-870F0D1BB9A8}"/>
          </ac:spMkLst>
        </pc:spChg>
        <pc:spChg chg="mod">
          <ac:chgData name="Jorgensen, Rick" userId="22b7bd11-eb0f-413f-9bcb-9ce21ec7b0a8" providerId="ADAL" clId="{63C519A2-C2B2-47AC-828F-E429CD2FEDB2}" dt="2023-08-01T14:50:45.706" v="10534" actId="1076"/>
          <ac:spMkLst>
            <pc:docMk/>
            <pc:sldMk cId="4070891446" sldId="377"/>
            <ac:spMk id="7" creationId="{51D939F2-DC7C-39D9-ADF0-FE3169629BA5}"/>
          </ac:spMkLst>
        </pc:spChg>
        <pc:spChg chg="mod">
          <ac:chgData name="Jorgensen, Rick" userId="22b7bd11-eb0f-413f-9bcb-9ce21ec7b0a8" providerId="ADAL" clId="{63C519A2-C2B2-47AC-828F-E429CD2FEDB2}" dt="2023-08-01T14:50:47.430" v="10535" actId="1076"/>
          <ac:spMkLst>
            <pc:docMk/>
            <pc:sldMk cId="4070891446" sldId="377"/>
            <ac:spMk id="8" creationId="{247F22BB-F9FF-1402-E928-FB7603EDC4A3}"/>
          </ac:spMkLst>
        </pc:spChg>
        <pc:spChg chg="mod">
          <ac:chgData name="Jorgensen, Rick" userId="22b7bd11-eb0f-413f-9bcb-9ce21ec7b0a8" providerId="ADAL" clId="{63C519A2-C2B2-47AC-828F-E429CD2FEDB2}" dt="2023-08-01T14:50:02.793" v="10524" actId="1076"/>
          <ac:spMkLst>
            <pc:docMk/>
            <pc:sldMk cId="4070891446" sldId="377"/>
            <ac:spMk id="9" creationId="{63524C50-D6D0-0189-CE40-DC500E6857A7}"/>
          </ac:spMkLst>
        </pc:spChg>
        <pc:spChg chg="mod">
          <ac:chgData name="Jorgensen, Rick" userId="22b7bd11-eb0f-413f-9bcb-9ce21ec7b0a8" providerId="ADAL" clId="{63C519A2-C2B2-47AC-828F-E429CD2FEDB2}" dt="2023-08-01T14:52:44.690" v="10553" actId="1076"/>
          <ac:spMkLst>
            <pc:docMk/>
            <pc:sldMk cId="4070891446" sldId="377"/>
            <ac:spMk id="10" creationId="{DE9A23F4-1D6F-7D27-4B02-FD7334D78603}"/>
          </ac:spMkLst>
        </pc:spChg>
        <pc:spChg chg="mod">
          <ac:chgData name="Jorgensen, Rick" userId="22b7bd11-eb0f-413f-9bcb-9ce21ec7b0a8" providerId="ADAL" clId="{63C519A2-C2B2-47AC-828F-E429CD2FEDB2}" dt="2023-08-01T14:47:32.557" v="10519" actId="20577"/>
          <ac:spMkLst>
            <pc:docMk/>
            <pc:sldMk cId="4070891446" sldId="377"/>
            <ac:spMk id="11" creationId="{B4600D65-D8D9-0D52-AFE4-B43D2A483E7D}"/>
          </ac:spMkLst>
        </pc:spChg>
        <pc:grpChg chg="mod">
          <ac:chgData name="Jorgensen, Rick" userId="22b7bd11-eb0f-413f-9bcb-9ce21ec7b0a8" providerId="ADAL" clId="{63C519A2-C2B2-47AC-828F-E429CD2FEDB2}" dt="2023-08-01T14:50:41.437" v="10533" actId="1076"/>
          <ac:grpSpMkLst>
            <pc:docMk/>
            <pc:sldMk cId="4070891446" sldId="377"/>
            <ac:grpSpMk id="5" creationId="{EB75E518-91EB-7E19-49E9-FD98122F57F2}"/>
          </ac:grpSpMkLst>
        </pc:grpChg>
        <pc:graphicFrameChg chg="mod">
          <ac:chgData name="Jorgensen, Rick" userId="22b7bd11-eb0f-413f-9bcb-9ce21ec7b0a8" providerId="ADAL" clId="{63C519A2-C2B2-47AC-828F-E429CD2FEDB2}" dt="2023-07-27T14:24:14.890" v="8835" actId="20577"/>
          <ac:graphicFrameMkLst>
            <pc:docMk/>
            <pc:sldMk cId="4070891446" sldId="377"/>
            <ac:graphicFrameMk id="2" creationId="{BA3921CA-10C7-0AD8-3286-54DEF779C62B}"/>
          </ac:graphicFrameMkLst>
        </pc:graphicFrameChg>
      </pc:sldChg>
      <pc:sldChg chg="modSp mod">
        <pc:chgData name="Jorgensen, Rick" userId="22b7bd11-eb0f-413f-9bcb-9ce21ec7b0a8" providerId="ADAL" clId="{63C519A2-C2B2-47AC-828F-E429CD2FEDB2}" dt="2023-08-01T14:55:53.245" v="10760" actId="20577"/>
        <pc:sldMkLst>
          <pc:docMk/>
          <pc:sldMk cId="3740473727" sldId="378"/>
        </pc:sldMkLst>
        <pc:spChg chg="mod">
          <ac:chgData name="Jorgensen, Rick" userId="22b7bd11-eb0f-413f-9bcb-9ce21ec7b0a8" providerId="ADAL" clId="{63C519A2-C2B2-47AC-828F-E429CD2FEDB2}" dt="2023-08-01T14:47:35.730" v="10521" actId="20577"/>
          <ac:spMkLst>
            <pc:docMk/>
            <pc:sldMk cId="3740473727" sldId="378"/>
            <ac:spMk id="2" creationId="{00000000-0000-0000-0000-000000000000}"/>
          </ac:spMkLst>
        </pc:spChg>
        <pc:spChg chg="mod">
          <ac:chgData name="Jorgensen, Rick" userId="22b7bd11-eb0f-413f-9bcb-9ce21ec7b0a8" providerId="ADAL" clId="{63C519A2-C2B2-47AC-828F-E429CD2FEDB2}" dt="2023-08-01T14:55:53.245" v="10760" actId="20577"/>
          <ac:spMkLst>
            <pc:docMk/>
            <pc:sldMk cId="3740473727" sldId="378"/>
            <ac:spMk id="3" creationId="{00000000-0000-0000-0000-000000000000}"/>
          </ac:spMkLst>
        </pc:spChg>
      </pc:sldChg>
      <pc:sldChg chg="addSp delSp modSp mod ord">
        <pc:chgData name="Jorgensen, Rick" userId="22b7bd11-eb0f-413f-9bcb-9ce21ec7b0a8" providerId="ADAL" clId="{63C519A2-C2B2-47AC-828F-E429CD2FEDB2}" dt="2023-08-01T14:33:42.421" v="10266"/>
        <pc:sldMkLst>
          <pc:docMk/>
          <pc:sldMk cId="3976310766" sldId="379"/>
        </pc:sldMkLst>
        <pc:spChg chg="del">
          <ac:chgData name="Jorgensen, Rick" userId="22b7bd11-eb0f-413f-9bcb-9ce21ec7b0a8" providerId="ADAL" clId="{63C519A2-C2B2-47AC-828F-E429CD2FEDB2}" dt="2023-06-23T16:49:41.811" v="5412" actId="478"/>
          <ac:spMkLst>
            <pc:docMk/>
            <pc:sldMk cId="3976310766" sldId="379"/>
            <ac:spMk id="3" creationId="{64C5D5CE-FF7D-EED9-3512-B5135C7D9A5B}"/>
          </ac:spMkLst>
        </pc:spChg>
        <pc:spChg chg="del mod">
          <ac:chgData name="Jorgensen, Rick" userId="22b7bd11-eb0f-413f-9bcb-9ce21ec7b0a8" providerId="ADAL" clId="{63C519A2-C2B2-47AC-828F-E429CD2FEDB2}" dt="2023-06-27T16:13:09.711" v="5950" actId="478"/>
          <ac:spMkLst>
            <pc:docMk/>
            <pc:sldMk cId="3976310766" sldId="379"/>
            <ac:spMk id="6" creationId="{83BBB045-CB98-E08E-EA16-DFEADABF8380}"/>
          </ac:spMkLst>
        </pc:spChg>
        <pc:spChg chg="mod">
          <ac:chgData name="Jorgensen, Rick" userId="22b7bd11-eb0f-413f-9bcb-9ce21ec7b0a8" providerId="ADAL" clId="{63C519A2-C2B2-47AC-828F-E429CD2FEDB2}" dt="2023-07-24T14:39:08.953" v="7335" actId="1076"/>
          <ac:spMkLst>
            <pc:docMk/>
            <pc:sldMk cId="3976310766" sldId="379"/>
            <ac:spMk id="7" creationId="{D2E320E8-01EE-826A-37D7-9B726CD791F0}"/>
          </ac:spMkLst>
        </pc:spChg>
        <pc:spChg chg="mod">
          <ac:chgData name="Jorgensen, Rick" userId="22b7bd11-eb0f-413f-9bcb-9ce21ec7b0a8" providerId="ADAL" clId="{63C519A2-C2B2-47AC-828F-E429CD2FEDB2}" dt="2023-06-27T16:12:37.180" v="5925" actId="1076"/>
          <ac:spMkLst>
            <pc:docMk/>
            <pc:sldMk cId="3976310766" sldId="379"/>
            <ac:spMk id="10" creationId="{F1A3FC5D-620F-9258-8E5C-AC2FE122170C}"/>
          </ac:spMkLst>
        </pc:spChg>
        <pc:spChg chg="mod">
          <ac:chgData name="Jorgensen, Rick" userId="22b7bd11-eb0f-413f-9bcb-9ce21ec7b0a8" providerId="ADAL" clId="{63C519A2-C2B2-47AC-828F-E429CD2FEDB2}" dt="2023-07-05T15:18:34.829" v="6697" actId="20577"/>
          <ac:spMkLst>
            <pc:docMk/>
            <pc:sldMk cId="3976310766" sldId="379"/>
            <ac:spMk id="11" creationId="{622FA3CC-3D01-6213-A20F-73FE36504AAF}"/>
          </ac:spMkLst>
        </pc:spChg>
        <pc:spChg chg="del">
          <ac:chgData name="Jorgensen, Rick" userId="22b7bd11-eb0f-413f-9bcb-9ce21ec7b0a8" providerId="ADAL" clId="{63C519A2-C2B2-47AC-828F-E429CD2FEDB2}" dt="2023-06-23T16:49:43.139" v="5413" actId="478"/>
          <ac:spMkLst>
            <pc:docMk/>
            <pc:sldMk cId="3976310766" sldId="379"/>
            <ac:spMk id="14" creationId="{3D132538-435F-AB44-658A-60FA3AC8157A}"/>
          </ac:spMkLst>
        </pc:spChg>
        <pc:spChg chg="del">
          <ac:chgData name="Jorgensen, Rick" userId="22b7bd11-eb0f-413f-9bcb-9ce21ec7b0a8" providerId="ADAL" clId="{63C519A2-C2B2-47AC-828F-E429CD2FEDB2}" dt="2023-06-23T16:49:44.505" v="5414" actId="478"/>
          <ac:spMkLst>
            <pc:docMk/>
            <pc:sldMk cId="3976310766" sldId="379"/>
            <ac:spMk id="15" creationId="{5C50D81A-14F0-1E93-7B37-2A407C04A699}"/>
          </ac:spMkLst>
        </pc:spChg>
        <pc:spChg chg="add mod">
          <ac:chgData name="Jorgensen, Rick" userId="22b7bd11-eb0f-413f-9bcb-9ce21ec7b0a8" providerId="ADAL" clId="{63C519A2-C2B2-47AC-828F-E429CD2FEDB2}" dt="2023-06-27T16:12:44.145" v="5926" actId="1076"/>
          <ac:spMkLst>
            <pc:docMk/>
            <pc:sldMk cId="3976310766" sldId="379"/>
            <ac:spMk id="15" creationId="{7BFEFFF0-33AD-6D34-705E-87284BD8A145}"/>
          </ac:spMkLst>
        </pc:spChg>
        <pc:spChg chg="add del mod">
          <ac:chgData name="Jorgensen, Rick" userId="22b7bd11-eb0f-413f-9bcb-9ce21ec7b0a8" providerId="ADAL" clId="{63C519A2-C2B2-47AC-828F-E429CD2FEDB2}" dt="2023-06-27T16:08:18.041" v="5867" actId="478"/>
          <ac:spMkLst>
            <pc:docMk/>
            <pc:sldMk cId="3976310766" sldId="379"/>
            <ac:spMk id="16" creationId="{9F197E59-74A3-41A7-8A41-BBDCEFFB7BEF}"/>
          </ac:spMkLst>
        </pc:spChg>
        <pc:spChg chg="add mod">
          <ac:chgData name="Jorgensen, Rick" userId="22b7bd11-eb0f-413f-9bcb-9ce21ec7b0a8" providerId="ADAL" clId="{63C519A2-C2B2-47AC-828F-E429CD2FEDB2}" dt="2023-06-27T16:13:17.110" v="5952" actId="1076"/>
          <ac:spMkLst>
            <pc:docMk/>
            <pc:sldMk cId="3976310766" sldId="379"/>
            <ac:spMk id="19" creationId="{0FBD1CE3-EB2F-79AE-E529-09099C121916}"/>
          </ac:spMkLst>
        </pc:spChg>
        <pc:spChg chg="add mod">
          <ac:chgData name="Jorgensen, Rick" userId="22b7bd11-eb0f-413f-9bcb-9ce21ec7b0a8" providerId="ADAL" clId="{63C519A2-C2B2-47AC-828F-E429CD2FEDB2}" dt="2023-07-24T14:39:11.584" v="7336" actId="1076"/>
          <ac:spMkLst>
            <pc:docMk/>
            <pc:sldMk cId="3976310766" sldId="379"/>
            <ac:spMk id="22" creationId="{9FE5070A-D919-42C3-DF02-239E51E5D048}"/>
          </ac:spMkLst>
        </pc:spChg>
        <pc:spChg chg="add mod">
          <ac:chgData name="Jorgensen, Rick" userId="22b7bd11-eb0f-413f-9bcb-9ce21ec7b0a8" providerId="ADAL" clId="{63C519A2-C2B2-47AC-828F-E429CD2FEDB2}" dt="2023-06-27T16:14:11.094" v="6028" actId="20577"/>
          <ac:spMkLst>
            <pc:docMk/>
            <pc:sldMk cId="3976310766" sldId="379"/>
            <ac:spMk id="23" creationId="{441D0BB4-0F17-5120-0F19-9D70286B570A}"/>
          </ac:spMkLst>
        </pc:spChg>
        <pc:graphicFrameChg chg="mod">
          <ac:chgData name="Jorgensen, Rick" userId="22b7bd11-eb0f-413f-9bcb-9ce21ec7b0a8" providerId="ADAL" clId="{63C519A2-C2B2-47AC-828F-E429CD2FEDB2}" dt="2023-07-27T14:18:17.652" v="8766" actId="692"/>
          <ac:graphicFrameMkLst>
            <pc:docMk/>
            <pc:sldMk cId="3976310766" sldId="379"/>
            <ac:graphicFrameMk id="2" creationId="{592A93F4-298B-4ABA-9C61-D652FCE6EC05}"/>
          </ac:graphicFrameMkLst>
        </pc:graphicFrameChg>
        <pc:graphicFrameChg chg="mod">
          <ac:chgData name="Jorgensen, Rick" userId="22b7bd11-eb0f-413f-9bcb-9ce21ec7b0a8" providerId="ADAL" clId="{63C519A2-C2B2-47AC-828F-E429CD2FEDB2}" dt="2023-07-27T14:18:09.212" v="8760" actId="692"/>
          <ac:graphicFrameMkLst>
            <pc:docMk/>
            <pc:sldMk cId="3976310766" sldId="379"/>
            <ac:graphicFrameMk id="13" creationId="{B9927E7C-5754-4AEE-AAA8-51827D794FDD}"/>
          </ac:graphicFrameMkLst>
        </pc:graphicFrameChg>
        <pc:cxnChg chg="add mod">
          <ac:chgData name="Jorgensen, Rick" userId="22b7bd11-eb0f-413f-9bcb-9ce21ec7b0a8" providerId="ADAL" clId="{63C519A2-C2B2-47AC-828F-E429CD2FEDB2}" dt="2023-06-27T16:12:44.145" v="5926" actId="1076"/>
          <ac:cxnSpMkLst>
            <pc:docMk/>
            <pc:sldMk cId="3976310766" sldId="379"/>
            <ac:cxnSpMk id="14" creationId="{FBF004E4-FD20-BFC2-8831-D38BCBE42A8A}"/>
          </ac:cxnSpMkLst>
        </pc:cxnChg>
        <pc:cxnChg chg="add mod">
          <ac:chgData name="Jorgensen, Rick" userId="22b7bd11-eb0f-413f-9bcb-9ce21ec7b0a8" providerId="ADAL" clId="{63C519A2-C2B2-47AC-828F-E429CD2FEDB2}" dt="2023-06-27T16:13:17.110" v="5952" actId="1076"/>
          <ac:cxnSpMkLst>
            <pc:docMk/>
            <pc:sldMk cId="3976310766" sldId="379"/>
            <ac:cxnSpMk id="17" creationId="{E557CC94-2006-08F3-32BB-7F575F301643}"/>
          </ac:cxnSpMkLst>
        </pc:cxnChg>
      </pc:sldChg>
      <pc:sldChg chg="del">
        <pc:chgData name="Jorgensen, Rick" userId="22b7bd11-eb0f-413f-9bcb-9ce21ec7b0a8" providerId="ADAL" clId="{63C519A2-C2B2-47AC-828F-E429CD2FEDB2}" dt="2023-04-25T19:40:18.412" v="1" actId="47"/>
        <pc:sldMkLst>
          <pc:docMk/>
          <pc:sldMk cId="1270652540" sldId="380"/>
        </pc:sldMkLst>
      </pc:sldChg>
      <pc:sldChg chg="addSp delSp modSp mod">
        <pc:chgData name="Jorgensen, Rick" userId="22b7bd11-eb0f-413f-9bcb-9ce21ec7b0a8" providerId="ADAL" clId="{63C519A2-C2B2-47AC-828F-E429CD2FEDB2}" dt="2023-08-01T15:18:14.772" v="11231" actId="1076"/>
        <pc:sldMkLst>
          <pc:docMk/>
          <pc:sldMk cId="4180539983" sldId="381"/>
        </pc:sldMkLst>
        <pc:spChg chg="del mod">
          <ac:chgData name="Jorgensen, Rick" userId="22b7bd11-eb0f-413f-9bcb-9ce21ec7b0a8" providerId="ADAL" clId="{63C519A2-C2B2-47AC-828F-E429CD2FEDB2}" dt="2023-07-24T16:57:21.592" v="7558" actId="478"/>
          <ac:spMkLst>
            <pc:docMk/>
            <pc:sldMk cId="4180539983" sldId="381"/>
            <ac:spMk id="2" creationId="{81477866-D3AB-1E3F-46E7-E656EEFE1ADD}"/>
          </ac:spMkLst>
        </pc:spChg>
        <pc:spChg chg="add mod">
          <ac:chgData name="Jorgensen, Rick" userId="22b7bd11-eb0f-413f-9bcb-9ce21ec7b0a8" providerId="ADAL" clId="{63C519A2-C2B2-47AC-828F-E429CD2FEDB2}" dt="2023-07-27T17:17:51.862" v="9158" actId="1076"/>
          <ac:spMkLst>
            <pc:docMk/>
            <pc:sldMk cId="4180539983" sldId="381"/>
            <ac:spMk id="2" creationId="{8ACB899B-E198-35CE-27C6-280BF483F366}"/>
          </ac:spMkLst>
        </pc:spChg>
        <pc:spChg chg="add mod">
          <ac:chgData name="Jorgensen, Rick" userId="22b7bd11-eb0f-413f-9bcb-9ce21ec7b0a8" providerId="ADAL" clId="{63C519A2-C2B2-47AC-828F-E429CD2FEDB2}" dt="2023-07-27T17:17:41.059" v="9155" actId="1076"/>
          <ac:spMkLst>
            <pc:docMk/>
            <pc:sldMk cId="4180539983" sldId="381"/>
            <ac:spMk id="3" creationId="{00F047FB-581F-5398-E772-5E4FCD93816F}"/>
          </ac:spMkLst>
        </pc:spChg>
        <pc:spChg chg="add del mod">
          <ac:chgData name="Jorgensen, Rick" userId="22b7bd11-eb0f-413f-9bcb-9ce21ec7b0a8" providerId="ADAL" clId="{63C519A2-C2B2-47AC-828F-E429CD2FEDB2}" dt="2023-07-24T16:54:24.750" v="7479" actId="478"/>
          <ac:spMkLst>
            <pc:docMk/>
            <pc:sldMk cId="4180539983" sldId="381"/>
            <ac:spMk id="4" creationId="{573185A6-E68C-E1C8-379F-3B30B02D8C85}"/>
          </ac:spMkLst>
        </pc:spChg>
        <pc:spChg chg="del">
          <ac:chgData name="Jorgensen, Rick" userId="22b7bd11-eb0f-413f-9bcb-9ce21ec7b0a8" providerId="ADAL" clId="{63C519A2-C2B2-47AC-828F-E429CD2FEDB2}" dt="2023-06-23T16:49:10.574" v="5404" actId="478"/>
          <ac:spMkLst>
            <pc:docMk/>
            <pc:sldMk cId="4180539983" sldId="381"/>
            <ac:spMk id="4" creationId="{93D24B08-CC7D-C8B1-F600-18CF72F630A9}"/>
          </ac:spMkLst>
        </pc:spChg>
        <pc:spChg chg="add mod">
          <ac:chgData name="Jorgensen, Rick" userId="22b7bd11-eb0f-413f-9bcb-9ce21ec7b0a8" providerId="ADAL" clId="{63C519A2-C2B2-47AC-828F-E429CD2FEDB2}" dt="2023-07-24T17:15:33.168" v="7568" actId="1076"/>
          <ac:spMkLst>
            <pc:docMk/>
            <pc:sldMk cId="4180539983" sldId="381"/>
            <ac:spMk id="5" creationId="{D781EC2B-E649-9293-3A1C-83975708065C}"/>
          </ac:spMkLst>
        </pc:spChg>
        <pc:spChg chg="add mod ord">
          <ac:chgData name="Jorgensen, Rick" userId="22b7bd11-eb0f-413f-9bcb-9ce21ec7b0a8" providerId="ADAL" clId="{63C519A2-C2B2-47AC-828F-E429CD2FEDB2}" dt="2023-07-24T17:19:11.187" v="7590" actId="12788"/>
          <ac:spMkLst>
            <pc:docMk/>
            <pc:sldMk cId="4180539983" sldId="381"/>
            <ac:spMk id="6" creationId="{40B6CEB3-3A82-4E60-F188-FC045C4CBC79}"/>
          </ac:spMkLst>
        </pc:spChg>
        <pc:spChg chg="del">
          <ac:chgData name="Jorgensen, Rick" userId="22b7bd11-eb0f-413f-9bcb-9ce21ec7b0a8" providerId="ADAL" clId="{63C519A2-C2B2-47AC-828F-E429CD2FEDB2}" dt="2023-06-23T16:49:09.007" v="5403" actId="478"/>
          <ac:spMkLst>
            <pc:docMk/>
            <pc:sldMk cId="4180539983" sldId="381"/>
            <ac:spMk id="6" creationId="{8CE263FD-FACE-8532-2BFF-E542F0E600CC}"/>
          </ac:spMkLst>
        </pc:spChg>
        <pc:spChg chg="add mod ord">
          <ac:chgData name="Jorgensen, Rick" userId="22b7bd11-eb0f-413f-9bcb-9ce21ec7b0a8" providerId="ADAL" clId="{63C519A2-C2B2-47AC-828F-E429CD2FEDB2}" dt="2023-07-24T17:19:11.187" v="7590" actId="12788"/>
          <ac:spMkLst>
            <pc:docMk/>
            <pc:sldMk cId="4180539983" sldId="381"/>
            <ac:spMk id="7" creationId="{951535AA-70E5-4B16-E222-46AD8972F9CE}"/>
          </ac:spMkLst>
        </pc:spChg>
        <pc:spChg chg="del mod">
          <ac:chgData name="Jorgensen, Rick" userId="22b7bd11-eb0f-413f-9bcb-9ce21ec7b0a8" providerId="ADAL" clId="{63C519A2-C2B2-47AC-828F-E429CD2FEDB2}" dt="2023-08-01T15:15:25.429" v="11204" actId="478"/>
          <ac:spMkLst>
            <pc:docMk/>
            <pc:sldMk cId="4180539983" sldId="381"/>
            <ac:spMk id="8" creationId="{A85A1349-C6A4-F81E-2D7B-75FD5E4C4736}"/>
          </ac:spMkLst>
        </pc:spChg>
        <pc:spChg chg="add mod ord">
          <ac:chgData name="Jorgensen, Rick" userId="22b7bd11-eb0f-413f-9bcb-9ce21ec7b0a8" providerId="ADAL" clId="{63C519A2-C2B2-47AC-828F-E429CD2FEDB2}" dt="2023-07-24T17:19:11.187" v="7590" actId="12788"/>
          <ac:spMkLst>
            <pc:docMk/>
            <pc:sldMk cId="4180539983" sldId="381"/>
            <ac:spMk id="10" creationId="{7522894A-B4AC-36B0-5629-F20EC9F4B9FC}"/>
          </ac:spMkLst>
        </pc:spChg>
        <pc:spChg chg="add mod ord">
          <ac:chgData name="Jorgensen, Rick" userId="22b7bd11-eb0f-413f-9bcb-9ce21ec7b0a8" providerId="ADAL" clId="{63C519A2-C2B2-47AC-828F-E429CD2FEDB2}" dt="2023-07-24T17:19:11.187" v="7590" actId="12788"/>
          <ac:spMkLst>
            <pc:docMk/>
            <pc:sldMk cId="4180539983" sldId="381"/>
            <ac:spMk id="11" creationId="{EF4D9831-160A-4CD3-10DC-6541144E8A9A}"/>
          </ac:spMkLst>
        </pc:spChg>
        <pc:spChg chg="add mod ord">
          <ac:chgData name="Jorgensen, Rick" userId="22b7bd11-eb0f-413f-9bcb-9ce21ec7b0a8" providerId="ADAL" clId="{63C519A2-C2B2-47AC-828F-E429CD2FEDB2}" dt="2023-07-24T17:19:11.187" v="7590" actId="12788"/>
          <ac:spMkLst>
            <pc:docMk/>
            <pc:sldMk cId="4180539983" sldId="381"/>
            <ac:spMk id="12" creationId="{CF6FBB5F-FA38-2245-30C4-D451AF10E3FB}"/>
          </ac:spMkLst>
        </pc:spChg>
        <pc:spChg chg="add mod">
          <ac:chgData name="Jorgensen, Rick" userId="22b7bd11-eb0f-413f-9bcb-9ce21ec7b0a8" providerId="ADAL" clId="{63C519A2-C2B2-47AC-828F-E429CD2FEDB2}" dt="2023-07-24T17:15:28.325" v="7567" actId="1076"/>
          <ac:spMkLst>
            <pc:docMk/>
            <pc:sldMk cId="4180539983" sldId="381"/>
            <ac:spMk id="13" creationId="{911BA559-AAEB-1D23-6B7F-319764FA4494}"/>
          </ac:spMkLst>
        </pc:spChg>
        <pc:spChg chg="del mod">
          <ac:chgData name="Jorgensen, Rick" userId="22b7bd11-eb0f-413f-9bcb-9ce21ec7b0a8" providerId="ADAL" clId="{63C519A2-C2B2-47AC-828F-E429CD2FEDB2}" dt="2023-08-01T15:16:03.503" v="11209" actId="478"/>
          <ac:spMkLst>
            <pc:docMk/>
            <pc:sldMk cId="4180539983" sldId="381"/>
            <ac:spMk id="14" creationId="{AA92C4F3-BF02-3BBC-8A8E-B130F6238713}"/>
          </ac:spMkLst>
        </pc:spChg>
        <pc:spChg chg="mod">
          <ac:chgData name="Jorgensen, Rick" userId="22b7bd11-eb0f-413f-9bcb-9ce21ec7b0a8" providerId="ADAL" clId="{63C519A2-C2B2-47AC-828F-E429CD2FEDB2}" dt="2023-07-17T16:55:54.139" v="6998" actId="1076"/>
          <ac:spMkLst>
            <pc:docMk/>
            <pc:sldMk cId="4180539983" sldId="381"/>
            <ac:spMk id="15" creationId="{1BA55689-1E02-D64A-AEF5-1140E4E5B817}"/>
          </ac:spMkLst>
        </pc:spChg>
        <pc:spChg chg="mod">
          <ac:chgData name="Jorgensen, Rick" userId="22b7bd11-eb0f-413f-9bcb-9ce21ec7b0a8" providerId="ADAL" clId="{63C519A2-C2B2-47AC-828F-E429CD2FEDB2}" dt="2023-07-17T17:23:21.558" v="7090" actId="1076"/>
          <ac:spMkLst>
            <pc:docMk/>
            <pc:sldMk cId="4180539983" sldId="381"/>
            <ac:spMk id="16" creationId="{BE744FE4-2EF0-B94D-B621-3533220D4D03}"/>
          </ac:spMkLst>
        </pc:spChg>
        <pc:spChg chg="add mod">
          <ac:chgData name="Jorgensen, Rick" userId="22b7bd11-eb0f-413f-9bcb-9ce21ec7b0a8" providerId="ADAL" clId="{63C519A2-C2B2-47AC-828F-E429CD2FEDB2}" dt="2023-07-17T17:02:09.913" v="7084" actId="164"/>
          <ac:spMkLst>
            <pc:docMk/>
            <pc:sldMk cId="4180539983" sldId="381"/>
            <ac:spMk id="17" creationId="{4FDBAC02-F47A-CCDD-1CA9-7D7F1CA4CAE2}"/>
          </ac:spMkLst>
        </pc:spChg>
        <pc:spChg chg="add mod">
          <ac:chgData name="Jorgensen, Rick" userId="22b7bd11-eb0f-413f-9bcb-9ce21ec7b0a8" providerId="ADAL" clId="{63C519A2-C2B2-47AC-828F-E429CD2FEDB2}" dt="2023-07-17T17:02:09.913" v="7084" actId="164"/>
          <ac:spMkLst>
            <pc:docMk/>
            <pc:sldMk cId="4180539983" sldId="381"/>
            <ac:spMk id="18" creationId="{41D6832F-C24E-8402-4FDB-885E446D4490}"/>
          </ac:spMkLst>
        </pc:spChg>
        <pc:spChg chg="add mod">
          <ac:chgData name="Jorgensen, Rick" userId="22b7bd11-eb0f-413f-9bcb-9ce21ec7b0a8" providerId="ADAL" clId="{63C519A2-C2B2-47AC-828F-E429CD2FEDB2}" dt="2023-07-24T16:55:45.035" v="7502" actId="14100"/>
          <ac:spMkLst>
            <pc:docMk/>
            <pc:sldMk cId="4180539983" sldId="381"/>
            <ac:spMk id="19" creationId="{AD90372F-F9D2-4C89-A416-34884E2601F0}"/>
          </ac:spMkLst>
        </pc:spChg>
        <pc:spChg chg="add mod">
          <ac:chgData name="Jorgensen, Rick" userId="22b7bd11-eb0f-413f-9bcb-9ce21ec7b0a8" providerId="ADAL" clId="{63C519A2-C2B2-47AC-828F-E429CD2FEDB2}" dt="2023-07-17T17:02:09.913" v="7084" actId="164"/>
          <ac:spMkLst>
            <pc:docMk/>
            <pc:sldMk cId="4180539983" sldId="381"/>
            <ac:spMk id="20" creationId="{297A722A-851D-B645-E82F-E2D285AAB0BD}"/>
          </ac:spMkLst>
        </pc:spChg>
        <pc:spChg chg="mod">
          <ac:chgData name="Jorgensen, Rick" userId="22b7bd11-eb0f-413f-9bcb-9ce21ec7b0a8" providerId="ADAL" clId="{63C519A2-C2B2-47AC-828F-E429CD2FEDB2}" dt="2023-07-17T17:23:42.464" v="7093"/>
          <ac:spMkLst>
            <pc:docMk/>
            <pc:sldMk cId="4180539983" sldId="381"/>
            <ac:spMk id="24" creationId="{3E09912C-646F-BB02-8AB2-B6BDB5208659}"/>
          </ac:spMkLst>
        </pc:spChg>
        <pc:spChg chg="mod">
          <ac:chgData name="Jorgensen, Rick" userId="22b7bd11-eb0f-413f-9bcb-9ce21ec7b0a8" providerId="ADAL" clId="{63C519A2-C2B2-47AC-828F-E429CD2FEDB2}" dt="2023-08-01T15:15:21.359" v="11203" actId="20577"/>
          <ac:spMkLst>
            <pc:docMk/>
            <pc:sldMk cId="4180539983" sldId="381"/>
            <ac:spMk id="25" creationId="{43DF711F-4684-B34D-9236-D3A26D348F11}"/>
          </ac:spMkLst>
        </pc:spChg>
        <pc:spChg chg="mod">
          <ac:chgData name="Jorgensen, Rick" userId="22b7bd11-eb0f-413f-9bcb-9ce21ec7b0a8" providerId="ADAL" clId="{63C519A2-C2B2-47AC-828F-E429CD2FEDB2}" dt="2023-07-17T17:23:42.464" v="7093"/>
          <ac:spMkLst>
            <pc:docMk/>
            <pc:sldMk cId="4180539983" sldId="381"/>
            <ac:spMk id="26" creationId="{C878745E-C2F4-935B-1AE5-6A0DC31B6114}"/>
          </ac:spMkLst>
        </pc:spChg>
        <pc:spChg chg="mod">
          <ac:chgData name="Jorgensen, Rick" userId="22b7bd11-eb0f-413f-9bcb-9ce21ec7b0a8" providerId="ADAL" clId="{63C519A2-C2B2-47AC-828F-E429CD2FEDB2}" dt="2023-07-17T17:23:42.464" v="7093"/>
          <ac:spMkLst>
            <pc:docMk/>
            <pc:sldMk cId="4180539983" sldId="381"/>
            <ac:spMk id="27" creationId="{6B66F347-0644-2BFF-80F3-10BDDFD53E2C}"/>
          </ac:spMkLst>
        </pc:spChg>
        <pc:spChg chg="mod">
          <ac:chgData name="Jorgensen, Rick" userId="22b7bd11-eb0f-413f-9bcb-9ce21ec7b0a8" providerId="ADAL" clId="{63C519A2-C2B2-47AC-828F-E429CD2FEDB2}" dt="2023-07-17T17:23:42.464" v="7093"/>
          <ac:spMkLst>
            <pc:docMk/>
            <pc:sldMk cId="4180539983" sldId="381"/>
            <ac:spMk id="28" creationId="{CCF1757F-2565-80D7-B399-18E95B618985}"/>
          </ac:spMkLst>
        </pc:spChg>
        <pc:spChg chg="add del mod">
          <ac:chgData name="Jorgensen, Rick" userId="22b7bd11-eb0f-413f-9bcb-9ce21ec7b0a8" providerId="ADAL" clId="{63C519A2-C2B2-47AC-828F-E429CD2FEDB2}" dt="2023-07-24T16:57:08.920" v="7551" actId="478"/>
          <ac:spMkLst>
            <pc:docMk/>
            <pc:sldMk cId="4180539983" sldId="381"/>
            <ac:spMk id="29" creationId="{DBAD79D3-979C-9A49-1E60-3B7FC65768E4}"/>
          </ac:spMkLst>
        </pc:spChg>
        <pc:spChg chg="add del mod">
          <ac:chgData name="Jorgensen, Rick" userId="22b7bd11-eb0f-413f-9bcb-9ce21ec7b0a8" providerId="ADAL" clId="{63C519A2-C2B2-47AC-828F-E429CD2FEDB2}" dt="2023-07-24T16:57:10.846" v="7552" actId="478"/>
          <ac:spMkLst>
            <pc:docMk/>
            <pc:sldMk cId="4180539983" sldId="381"/>
            <ac:spMk id="30" creationId="{01E0D4CD-F5CE-855B-1191-00897F9742AC}"/>
          </ac:spMkLst>
        </pc:spChg>
        <pc:spChg chg="add del mod">
          <ac:chgData name="Jorgensen, Rick" userId="22b7bd11-eb0f-413f-9bcb-9ce21ec7b0a8" providerId="ADAL" clId="{63C519A2-C2B2-47AC-828F-E429CD2FEDB2}" dt="2023-07-24T16:57:12.005" v="7553" actId="478"/>
          <ac:spMkLst>
            <pc:docMk/>
            <pc:sldMk cId="4180539983" sldId="381"/>
            <ac:spMk id="31" creationId="{7D155A62-4D2B-6281-2E45-4C916E379C6F}"/>
          </ac:spMkLst>
        </pc:spChg>
        <pc:spChg chg="add del mod">
          <ac:chgData name="Jorgensen, Rick" userId="22b7bd11-eb0f-413f-9bcb-9ce21ec7b0a8" providerId="ADAL" clId="{63C519A2-C2B2-47AC-828F-E429CD2FEDB2}" dt="2023-07-24T16:57:13.567" v="7554" actId="478"/>
          <ac:spMkLst>
            <pc:docMk/>
            <pc:sldMk cId="4180539983" sldId="381"/>
            <ac:spMk id="32" creationId="{280C7EDC-EE27-2337-CD7D-9D7A7DAB03CF}"/>
          </ac:spMkLst>
        </pc:spChg>
        <pc:spChg chg="mod">
          <ac:chgData name="Jorgensen, Rick" userId="22b7bd11-eb0f-413f-9bcb-9ce21ec7b0a8" providerId="ADAL" clId="{63C519A2-C2B2-47AC-828F-E429CD2FEDB2}" dt="2023-07-24T16:57:16.252" v="7555"/>
          <ac:spMkLst>
            <pc:docMk/>
            <pc:sldMk cId="4180539983" sldId="381"/>
            <ac:spMk id="34" creationId="{328DDFAD-AD78-B2FD-69C2-55A1373E6552}"/>
          </ac:spMkLst>
        </pc:spChg>
        <pc:spChg chg="mod">
          <ac:chgData name="Jorgensen, Rick" userId="22b7bd11-eb0f-413f-9bcb-9ce21ec7b0a8" providerId="ADAL" clId="{63C519A2-C2B2-47AC-828F-E429CD2FEDB2}" dt="2023-07-24T16:57:16.252" v="7555"/>
          <ac:spMkLst>
            <pc:docMk/>
            <pc:sldMk cId="4180539983" sldId="381"/>
            <ac:spMk id="35" creationId="{0B5BBC4A-E4F2-B689-89E7-2264924F4D98}"/>
          </ac:spMkLst>
        </pc:spChg>
        <pc:spChg chg="mod">
          <ac:chgData name="Jorgensen, Rick" userId="22b7bd11-eb0f-413f-9bcb-9ce21ec7b0a8" providerId="ADAL" clId="{63C519A2-C2B2-47AC-828F-E429CD2FEDB2}" dt="2023-07-24T16:57:16.252" v="7555"/>
          <ac:spMkLst>
            <pc:docMk/>
            <pc:sldMk cId="4180539983" sldId="381"/>
            <ac:spMk id="36" creationId="{3A525E64-6CAA-3EE1-8BEB-DF3DD0FA5962}"/>
          </ac:spMkLst>
        </pc:spChg>
        <pc:spChg chg="mod">
          <ac:chgData name="Jorgensen, Rick" userId="22b7bd11-eb0f-413f-9bcb-9ce21ec7b0a8" providerId="ADAL" clId="{63C519A2-C2B2-47AC-828F-E429CD2FEDB2}" dt="2023-07-24T16:57:16.252" v="7555"/>
          <ac:spMkLst>
            <pc:docMk/>
            <pc:sldMk cId="4180539983" sldId="381"/>
            <ac:spMk id="37" creationId="{F1A07120-933B-E51F-C851-84C9B0A553D4}"/>
          </ac:spMkLst>
        </pc:spChg>
        <pc:spChg chg="add del mod">
          <ac:chgData name="Jorgensen, Rick" userId="22b7bd11-eb0f-413f-9bcb-9ce21ec7b0a8" providerId="ADAL" clId="{63C519A2-C2B2-47AC-828F-E429CD2FEDB2}" dt="2023-08-01T15:16:13.103" v="11211" actId="478"/>
          <ac:spMkLst>
            <pc:docMk/>
            <pc:sldMk cId="4180539983" sldId="381"/>
            <ac:spMk id="38" creationId="{70029A47-2B66-0DA1-2049-5A43CA27F7A6}"/>
          </ac:spMkLst>
        </pc:spChg>
        <pc:spChg chg="add mod">
          <ac:chgData name="Jorgensen, Rick" userId="22b7bd11-eb0f-413f-9bcb-9ce21ec7b0a8" providerId="ADAL" clId="{63C519A2-C2B2-47AC-828F-E429CD2FEDB2}" dt="2023-07-27T17:13:38.682" v="9089" actId="692"/>
          <ac:spMkLst>
            <pc:docMk/>
            <pc:sldMk cId="4180539983" sldId="381"/>
            <ac:spMk id="40" creationId="{DDDF0E5A-3974-79DF-0FE1-B6DF8F6D1D64}"/>
          </ac:spMkLst>
        </pc:spChg>
        <pc:spChg chg="add mod">
          <ac:chgData name="Jorgensen, Rick" userId="22b7bd11-eb0f-413f-9bcb-9ce21ec7b0a8" providerId="ADAL" clId="{63C519A2-C2B2-47AC-828F-E429CD2FEDB2}" dt="2023-07-24T17:23:02.457" v="7592" actId="1076"/>
          <ac:spMkLst>
            <pc:docMk/>
            <pc:sldMk cId="4180539983" sldId="381"/>
            <ac:spMk id="41" creationId="{66DA6F02-7D4C-D65E-6836-19D0B5646E8F}"/>
          </ac:spMkLst>
        </pc:spChg>
        <pc:spChg chg="add mod">
          <ac:chgData name="Jorgensen, Rick" userId="22b7bd11-eb0f-413f-9bcb-9ce21ec7b0a8" providerId="ADAL" clId="{63C519A2-C2B2-47AC-828F-E429CD2FEDB2}" dt="2023-08-01T15:18:11.445" v="11230" actId="1076"/>
          <ac:spMkLst>
            <pc:docMk/>
            <pc:sldMk cId="4180539983" sldId="381"/>
            <ac:spMk id="42" creationId="{2D84763A-F38F-0D7E-646F-FC534BCD1E4B}"/>
          </ac:spMkLst>
        </pc:spChg>
        <pc:spChg chg="add mod">
          <ac:chgData name="Jorgensen, Rick" userId="22b7bd11-eb0f-413f-9bcb-9ce21ec7b0a8" providerId="ADAL" clId="{63C519A2-C2B2-47AC-828F-E429CD2FEDB2}" dt="2023-08-01T15:18:14.772" v="11231" actId="1076"/>
          <ac:spMkLst>
            <pc:docMk/>
            <pc:sldMk cId="4180539983" sldId="381"/>
            <ac:spMk id="43" creationId="{4E395039-7876-8176-160C-B3C5E23BB480}"/>
          </ac:spMkLst>
        </pc:spChg>
        <pc:spChg chg="add mod">
          <ac:chgData name="Jorgensen, Rick" userId="22b7bd11-eb0f-413f-9bcb-9ce21ec7b0a8" providerId="ADAL" clId="{63C519A2-C2B2-47AC-828F-E429CD2FEDB2}" dt="2023-08-01T15:18:08.323" v="11229" actId="1076"/>
          <ac:spMkLst>
            <pc:docMk/>
            <pc:sldMk cId="4180539983" sldId="381"/>
            <ac:spMk id="44" creationId="{1099F439-2C72-613A-9FFB-A4EEC230954D}"/>
          </ac:spMkLst>
        </pc:spChg>
        <pc:grpChg chg="add mod ord">
          <ac:chgData name="Jorgensen, Rick" userId="22b7bd11-eb0f-413f-9bcb-9ce21ec7b0a8" providerId="ADAL" clId="{63C519A2-C2B2-47AC-828F-E429CD2FEDB2}" dt="2023-08-01T15:16:29.534" v="11212" actId="1076"/>
          <ac:grpSpMkLst>
            <pc:docMk/>
            <pc:sldMk cId="4180539983" sldId="381"/>
            <ac:grpSpMk id="21" creationId="{CC56C904-0BDB-5A14-493D-83F762479834}"/>
          </ac:grpSpMkLst>
        </pc:grpChg>
        <pc:grpChg chg="add del mod">
          <ac:chgData name="Jorgensen, Rick" userId="22b7bd11-eb0f-413f-9bcb-9ce21ec7b0a8" providerId="ADAL" clId="{63C519A2-C2B2-47AC-828F-E429CD2FEDB2}" dt="2023-07-24T16:57:20.174" v="7557" actId="478"/>
          <ac:grpSpMkLst>
            <pc:docMk/>
            <pc:sldMk cId="4180539983" sldId="381"/>
            <ac:grpSpMk id="23" creationId="{308CDCE0-D64C-5139-526A-D35B9DE07201}"/>
          </ac:grpSpMkLst>
        </pc:grpChg>
        <pc:grpChg chg="add mod">
          <ac:chgData name="Jorgensen, Rick" userId="22b7bd11-eb0f-413f-9bcb-9ce21ec7b0a8" providerId="ADAL" clId="{63C519A2-C2B2-47AC-828F-E429CD2FEDB2}" dt="2023-08-01T15:16:32.311" v="11213" actId="1076"/>
          <ac:grpSpMkLst>
            <pc:docMk/>
            <pc:sldMk cId="4180539983" sldId="381"/>
            <ac:grpSpMk id="33" creationId="{B7B8DA1C-6608-F3AC-6499-78EA4121866B}"/>
          </ac:grpSpMkLst>
        </pc:grpChg>
        <pc:graphicFrameChg chg="add del mod ord">
          <ac:chgData name="Jorgensen, Rick" userId="22b7bd11-eb0f-413f-9bcb-9ce21ec7b0a8" providerId="ADAL" clId="{63C519A2-C2B2-47AC-828F-E429CD2FEDB2}" dt="2023-07-24T15:23:43.275" v="7473" actId="478"/>
          <ac:graphicFrameMkLst>
            <pc:docMk/>
            <pc:sldMk cId="4180539983" sldId="381"/>
            <ac:graphicFrameMk id="3" creationId="{DE951F37-77FB-4F5A-B764-8CE1F8B42F66}"/>
          </ac:graphicFrameMkLst>
        </pc:graphicFrameChg>
        <pc:graphicFrameChg chg="del">
          <ac:chgData name="Jorgensen, Rick" userId="22b7bd11-eb0f-413f-9bcb-9ce21ec7b0a8" providerId="ADAL" clId="{63C519A2-C2B2-47AC-828F-E429CD2FEDB2}" dt="2023-07-17T16:55:36.708" v="6994" actId="478"/>
          <ac:graphicFrameMkLst>
            <pc:docMk/>
            <pc:sldMk cId="4180539983" sldId="381"/>
            <ac:graphicFrameMk id="8" creationId="{0B2F4E1B-51B6-BE03-924D-34F828619F2F}"/>
          </ac:graphicFrameMkLst>
        </pc:graphicFrameChg>
        <pc:graphicFrameChg chg="add mod ord">
          <ac:chgData name="Jorgensen, Rick" userId="22b7bd11-eb0f-413f-9bcb-9ce21ec7b0a8" providerId="ADAL" clId="{63C519A2-C2B2-47AC-828F-E429CD2FEDB2}" dt="2023-08-01T15:16:59.128" v="11217" actId="692"/>
          <ac:graphicFrameMkLst>
            <pc:docMk/>
            <pc:sldMk cId="4180539983" sldId="381"/>
            <ac:graphicFrameMk id="9" creationId="{3570F2B5-DAE4-4ED3-8040-377E7BDD6F78}"/>
          </ac:graphicFrameMkLst>
        </pc:graphicFrameChg>
        <pc:graphicFrameChg chg="del">
          <ac:chgData name="Jorgensen, Rick" userId="22b7bd11-eb0f-413f-9bcb-9ce21ec7b0a8" providerId="ADAL" clId="{63C519A2-C2B2-47AC-828F-E429CD2FEDB2}" dt="2023-07-17T16:55:39.720" v="6995" actId="478"/>
          <ac:graphicFrameMkLst>
            <pc:docMk/>
            <pc:sldMk cId="4180539983" sldId="381"/>
            <ac:graphicFrameMk id="9" creationId="{F42BCC8E-E501-4377-A492-6E144F040F82}"/>
          </ac:graphicFrameMkLst>
        </pc:graphicFrameChg>
        <pc:graphicFrameChg chg="add del mod">
          <ac:chgData name="Jorgensen, Rick" userId="22b7bd11-eb0f-413f-9bcb-9ce21ec7b0a8" providerId="ADAL" clId="{63C519A2-C2B2-47AC-828F-E429CD2FEDB2}" dt="2023-07-17T16:59:39.591" v="7047" actId="478"/>
          <ac:graphicFrameMkLst>
            <pc:docMk/>
            <pc:sldMk cId="4180539983" sldId="381"/>
            <ac:graphicFrameMk id="13" creationId="{DE951F37-77FB-4F5A-B764-8CE1F8B42F66}"/>
          </ac:graphicFrameMkLst>
        </pc:graphicFrameChg>
        <pc:graphicFrameChg chg="add del mod">
          <ac:chgData name="Jorgensen, Rick" userId="22b7bd11-eb0f-413f-9bcb-9ce21ec7b0a8" providerId="ADAL" clId="{63C519A2-C2B2-47AC-828F-E429CD2FEDB2}" dt="2023-07-24T16:57:06.443" v="7550" actId="478"/>
          <ac:graphicFrameMkLst>
            <pc:docMk/>
            <pc:sldMk cId="4180539983" sldId="381"/>
            <ac:graphicFrameMk id="22" creationId="{AC9F4369-0AF6-4638-815C-AF8ECFADC914}"/>
          </ac:graphicFrameMkLst>
        </pc:graphicFrameChg>
        <pc:graphicFrameChg chg="add mod ord">
          <ac:chgData name="Jorgensen, Rick" userId="22b7bd11-eb0f-413f-9bcb-9ce21ec7b0a8" providerId="ADAL" clId="{63C519A2-C2B2-47AC-828F-E429CD2FEDB2}" dt="2023-08-01T15:17:01.623" v="11218" actId="692"/>
          <ac:graphicFrameMkLst>
            <pc:docMk/>
            <pc:sldMk cId="4180539983" sldId="381"/>
            <ac:graphicFrameMk id="39" creationId="{DE951F37-77FB-4F5A-B764-8CE1F8B42F66}"/>
          </ac:graphicFrameMkLst>
        </pc:graphicFrameChg>
      </pc:sldChg>
      <pc:sldChg chg="delSp mod ord">
        <pc:chgData name="Jorgensen, Rick" userId="22b7bd11-eb0f-413f-9bcb-9ce21ec7b0a8" providerId="ADAL" clId="{63C519A2-C2B2-47AC-828F-E429CD2FEDB2}" dt="2023-08-01T15:25:29.290" v="11625"/>
        <pc:sldMkLst>
          <pc:docMk/>
          <pc:sldMk cId="603868055" sldId="382"/>
        </pc:sldMkLst>
        <pc:spChg chg="del">
          <ac:chgData name="Jorgensen, Rick" userId="22b7bd11-eb0f-413f-9bcb-9ce21ec7b0a8" providerId="ADAL" clId="{63C519A2-C2B2-47AC-828F-E429CD2FEDB2}" dt="2023-06-23T16:46:51.846" v="5401" actId="478"/>
          <ac:spMkLst>
            <pc:docMk/>
            <pc:sldMk cId="603868055" sldId="382"/>
            <ac:spMk id="2" creationId="{834A38AD-1286-1743-BE33-040D86E33228}"/>
          </ac:spMkLst>
        </pc:spChg>
        <pc:spChg chg="del">
          <ac:chgData name="Jorgensen, Rick" userId="22b7bd11-eb0f-413f-9bcb-9ce21ec7b0a8" providerId="ADAL" clId="{63C519A2-C2B2-47AC-828F-E429CD2FEDB2}" dt="2023-06-23T16:49:05.944" v="5402" actId="478"/>
          <ac:spMkLst>
            <pc:docMk/>
            <pc:sldMk cId="603868055" sldId="382"/>
            <ac:spMk id="3" creationId="{F102D2C9-5A9D-834E-0C72-13EED9136009}"/>
          </ac:spMkLst>
        </pc:spChg>
      </pc:sldChg>
      <pc:sldChg chg="ord">
        <pc:chgData name="Jorgensen, Rick" userId="22b7bd11-eb0f-413f-9bcb-9ce21ec7b0a8" providerId="ADAL" clId="{63C519A2-C2B2-47AC-828F-E429CD2FEDB2}" dt="2023-08-01T15:25:29.290" v="11625"/>
        <pc:sldMkLst>
          <pc:docMk/>
          <pc:sldMk cId="1539833663" sldId="383"/>
        </pc:sldMkLst>
      </pc:sldChg>
      <pc:sldChg chg="new del">
        <pc:chgData name="Jorgensen, Rick" userId="22b7bd11-eb0f-413f-9bcb-9ce21ec7b0a8" providerId="ADAL" clId="{63C519A2-C2B2-47AC-828F-E429CD2FEDB2}" dt="2023-05-31T18:16:18.537" v="4" actId="2696"/>
        <pc:sldMkLst>
          <pc:docMk/>
          <pc:sldMk cId="3721491159" sldId="384"/>
        </pc:sldMkLst>
      </pc:sldChg>
      <pc:sldChg chg="addSp delSp modSp add mod ord">
        <pc:chgData name="Jorgensen, Rick" userId="22b7bd11-eb0f-413f-9bcb-9ce21ec7b0a8" providerId="ADAL" clId="{63C519A2-C2B2-47AC-828F-E429CD2FEDB2}" dt="2023-08-01T15:41:23.932" v="11998"/>
        <pc:sldMkLst>
          <pc:docMk/>
          <pc:sldMk cId="3869918126" sldId="385"/>
        </pc:sldMkLst>
        <pc:spChg chg="add mod">
          <ac:chgData name="Jorgensen, Rick" userId="22b7bd11-eb0f-413f-9bcb-9ce21ec7b0a8" providerId="ADAL" clId="{63C519A2-C2B2-47AC-828F-E429CD2FEDB2}" dt="2023-07-05T15:18:55.904" v="6701" actId="1076"/>
          <ac:spMkLst>
            <pc:docMk/>
            <pc:sldMk cId="3869918126" sldId="385"/>
            <ac:spMk id="2" creationId="{1E66CF56-52EB-3365-90B6-AAC062ECFB8D}"/>
          </ac:spMkLst>
        </pc:spChg>
        <pc:spChg chg="add mod">
          <ac:chgData name="Jorgensen, Rick" userId="22b7bd11-eb0f-413f-9bcb-9ce21ec7b0a8" providerId="ADAL" clId="{63C519A2-C2B2-47AC-828F-E429CD2FEDB2}" dt="2023-07-05T15:18:55.904" v="6701" actId="1076"/>
          <ac:spMkLst>
            <pc:docMk/>
            <pc:sldMk cId="3869918126" sldId="385"/>
            <ac:spMk id="3" creationId="{60B581A2-7CF8-9EE6-063B-4A5A9A033092}"/>
          </ac:spMkLst>
        </pc:spChg>
        <pc:spChg chg="del">
          <ac:chgData name="Jorgensen, Rick" userId="22b7bd11-eb0f-413f-9bcb-9ce21ec7b0a8" providerId="ADAL" clId="{63C519A2-C2B2-47AC-828F-E429CD2FEDB2}" dt="2023-05-31T18:18:11.626" v="53" actId="478"/>
          <ac:spMkLst>
            <pc:docMk/>
            <pc:sldMk cId="3869918126" sldId="385"/>
            <ac:spMk id="3" creationId="{64C5D5CE-FF7D-EED9-3512-B5135C7D9A5B}"/>
          </ac:spMkLst>
        </pc:spChg>
        <pc:spChg chg="del">
          <ac:chgData name="Jorgensen, Rick" userId="22b7bd11-eb0f-413f-9bcb-9ce21ec7b0a8" providerId="ADAL" clId="{63C519A2-C2B2-47AC-828F-E429CD2FEDB2}" dt="2023-05-31T18:19:15.684" v="82" actId="478"/>
          <ac:spMkLst>
            <pc:docMk/>
            <pc:sldMk cId="3869918126" sldId="385"/>
            <ac:spMk id="4" creationId="{495B3960-9843-4808-4E62-B7FC00D5322C}"/>
          </ac:spMkLst>
        </pc:spChg>
        <pc:spChg chg="add mod">
          <ac:chgData name="Jorgensen, Rick" userId="22b7bd11-eb0f-413f-9bcb-9ce21ec7b0a8" providerId="ADAL" clId="{63C519A2-C2B2-47AC-828F-E429CD2FEDB2}" dt="2023-07-05T15:19:43.802" v="6732" actId="1076"/>
          <ac:spMkLst>
            <pc:docMk/>
            <pc:sldMk cId="3869918126" sldId="385"/>
            <ac:spMk id="5" creationId="{71FF7E0E-3035-EE19-8331-950447F5E05B}"/>
          </ac:spMkLst>
        </pc:spChg>
        <pc:spChg chg="del">
          <ac:chgData name="Jorgensen, Rick" userId="22b7bd11-eb0f-413f-9bcb-9ce21ec7b0a8" providerId="ADAL" clId="{63C519A2-C2B2-47AC-828F-E429CD2FEDB2}" dt="2023-05-31T18:18:44.617" v="57" actId="478"/>
          <ac:spMkLst>
            <pc:docMk/>
            <pc:sldMk cId="3869918126" sldId="385"/>
            <ac:spMk id="5" creationId="{99CF073D-EC7F-22EF-1F2B-B06549DEF5C8}"/>
          </ac:spMkLst>
        </pc:spChg>
        <pc:spChg chg="del mod ord">
          <ac:chgData name="Jorgensen, Rick" userId="22b7bd11-eb0f-413f-9bcb-9ce21ec7b0a8" providerId="ADAL" clId="{63C519A2-C2B2-47AC-828F-E429CD2FEDB2}" dt="2023-07-05T15:18:48.060" v="6698" actId="478"/>
          <ac:spMkLst>
            <pc:docMk/>
            <pc:sldMk cId="3869918126" sldId="385"/>
            <ac:spMk id="6" creationId="{83BBB045-CB98-E08E-EA16-DFEADABF8380}"/>
          </ac:spMkLst>
        </pc:spChg>
        <pc:spChg chg="del mod ord">
          <ac:chgData name="Jorgensen, Rick" userId="22b7bd11-eb0f-413f-9bcb-9ce21ec7b0a8" providerId="ADAL" clId="{63C519A2-C2B2-47AC-828F-E429CD2FEDB2}" dt="2023-07-05T15:18:49.110" v="6699" actId="478"/>
          <ac:spMkLst>
            <pc:docMk/>
            <pc:sldMk cId="3869918126" sldId="385"/>
            <ac:spMk id="7" creationId="{D2E320E8-01EE-826A-37D7-9B726CD791F0}"/>
          </ac:spMkLst>
        </pc:spChg>
        <pc:spChg chg="mod">
          <ac:chgData name="Jorgensen, Rick" userId="22b7bd11-eb0f-413f-9bcb-9ce21ec7b0a8" providerId="ADAL" clId="{63C519A2-C2B2-47AC-828F-E429CD2FEDB2}" dt="2023-05-31T18:17:45.939" v="46" actId="1076"/>
          <ac:spMkLst>
            <pc:docMk/>
            <pc:sldMk cId="3869918126" sldId="385"/>
            <ac:spMk id="8" creationId="{FA488ED6-3516-01A8-484D-512D85B1D866}"/>
          </ac:spMkLst>
        </pc:spChg>
        <pc:spChg chg="mod">
          <ac:chgData name="Jorgensen, Rick" userId="22b7bd11-eb0f-413f-9bcb-9ce21ec7b0a8" providerId="ADAL" clId="{63C519A2-C2B2-47AC-828F-E429CD2FEDB2}" dt="2023-08-01T15:39:51.845" v="11996" actId="20577"/>
          <ac:spMkLst>
            <pc:docMk/>
            <pc:sldMk cId="3869918126" sldId="385"/>
            <ac:spMk id="9" creationId="{090E3AC6-72C7-E48F-824F-47B306FEB8B6}"/>
          </ac:spMkLst>
        </pc:spChg>
        <pc:spChg chg="del">
          <ac:chgData name="Jorgensen, Rick" userId="22b7bd11-eb0f-413f-9bcb-9ce21ec7b0a8" providerId="ADAL" clId="{63C519A2-C2B2-47AC-828F-E429CD2FEDB2}" dt="2023-05-31T18:17:36.778" v="43" actId="478"/>
          <ac:spMkLst>
            <pc:docMk/>
            <pc:sldMk cId="3869918126" sldId="385"/>
            <ac:spMk id="10" creationId="{F1A3FC5D-620F-9258-8E5C-AC2FE122170C}"/>
          </ac:spMkLst>
        </pc:spChg>
        <pc:spChg chg="del">
          <ac:chgData name="Jorgensen, Rick" userId="22b7bd11-eb0f-413f-9bcb-9ce21ec7b0a8" providerId="ADAL" clId="{63C519A2-C2B2-47AC-828F-E429CD2FEDB2}" dt="2023-05-31T18:17:37.573" v="44" actId="478"/>
          <ac:spMkLst>
            <pc:docMk/>
            <pc:sldMk cId="3869918126" sldId="385"/>
            <ac:spMk id="11" creationId="{622FA3CC-3D01-6213-A20F-73FE36504AAF}"/>
          </ac:spMkLst>
        </pc:spChg>
        <pc:spChg chg="mod">
          <ac:chgData name="Jorgensen, Rick" userId="22b7bd11-eb0f-413f-9bcb-9ce21ec7b0a8" providerId="ADAL" clId="{63C519A2-C2B2-47AC-828F-E429CD2FEDB2}" dt="2023-05-31T18:18:51.306" v="58" actId="1076"/>
          <ac:spMkLst>
            <pc:docMk/>
            <pc:sldMk cId="3869918126" sldId="385"/>
            <ac:spMk id="12" creationId="{CDC53B9C-8D5D-AD16-E044-2DF3881169E5}"/>
          </ac:spMkLst>
        </pc:spChg>
        <pc:spChg chg="del">
          <ac:chgData name="Jorgensen, Rick" userId="22b7bd11-eb0f-413f-9bcb-9ce21ec7b0a8" providerId="ADAL" clId="{63C519A2-C2B2-47AC-828F-E429CD2FEDB2}" dt="2023-05-31T18:18:13.698" v="54" actId="478"/>
          <ac:spMkLst>
            <pc:docMk/>
            <pc:sldMk cId="3869918126" sldId="385"/>
            <ac:spMk id="14" creationId="{3D132538-435F-AB44-658A-60FA3AC8157A}"/>
          </ac:spMkLst>
        </pc:spChg>
        <pc:spChg chg="del">
          <ac:chgData name="Jorgensen, Rick" userId="22b7bd11-eb0f-413f-9bcb-9ce21ec7b0a8" providerId="ADAL" clId="{63C519A2-C2B2-47AC-828F-E429CD2FEDB2}" dt="2023-05-31T18:18:15.094" v="55" actId="478"/>
          <ac:spMkLst>
            <pc:docMk/>
            <pc:sldMk cId="3869918126" sldId="385"/>
            <ac:spMk id="15" creationId="{5C50D81A-14F0-1E93-7B37-2A407C04A699}"/>
          </ac:spMkLst>
        </pc:spChg>
        <pc:spChg chg="add del mod">
          <ac:chgData name="Jorgensen, Rick" userId="22b7bd11-eb0f-413f-9bcb-9ce21ec7b0a8" providerId="ADAL" clId="{63C519A2-C2B2-47AC-828F-E429CD2FEDB2}" dt="2023-07-05T15:18:57.638" v="6702" actId="478"/>
          <ac:spMkLst>
            <pc:docMk/>
            <pc:sldMk cId="3869918126" sldId="385"/>
            <ac:spMk id="17" creationId="{F593A653-28A6-B693-2CC5-B1070D9DC8F3}"/>
          </ac:spMkLst>
        </pc:spChg>
        <pc:spChg chg="add del mod">
          <ac:chgData name="Jorgensen, Rick" userId="22b7bd11-eb0f-413f-9bcb-9ce21ec7b0a8" providerId="ADAL" clId="{63C519A2-C2B2-47AC-828F-E429CD2FEDB2}" dt="2023-07-05T15:19:14.740" v="6703" actId="478"/>
          <ac:spMkLst>
            <pc:docMk/>
            <pc:sldMk cId="3869918126" sldId="385"/>
            <ac:spMk id="19" creationId="{0A76B24B-BE33-8900-1DF0-41848893B924}"/>
          </ac:spMkLst>
        </pc:spChg>
        <pc:grpChg chg="mod">
          <ac:chgData name="Jorgensen, Rick" userId="22b7bd11-eb0f-413f-9bcb-9ce21ec7b0a8" providerId="ADAL" clId="{63C519A2-C2B2-47AC-828F-E429CD2FEDB2}" dt="2023-05-31T18:18:42.645" v="56" actId="1076"/>
          <ac:grpSpMkLst>
            <pc:docMk/>
            <pc:sldMk cId="3869918126" sldId="385"/>
            <ac:grpSpMk id="21" creationId="{D4C63643-32D5-AD70-A424-F738A1382502}"/>
          </ac:grpSpMkLst>
        </pc:grpChg>
        <pc:graphicFrameChg chg="del">
          <ac:chgData name="Jorgensen, Rick" userId="22b7bd11-eb0f-413f-9bcb-9ce21ec7b0a8" providerId="ADAL" clId="{63C519A2-C2B2-47AC-828F-E429CD2FEDB2}" dt="2023-05-31T18:16:43.144" v="37" actId="478"/>
          <ac:graphicFrameMkLst>
            <pc:docMk/>
            <pc:sldMk cId="3869918126" sldId="385"/>
            <ac:graphicFrameMk id="2" creationId="{592A93F4-298B-4ABA-9C61-D652FCE6EC05}"/>
          </ac:graphicFrameMkLst>
        </pc:graphicFrameChg>
        <pc:graphicFrameChg chg="del">
          <ac:chgData name="Jorgensen, Rick" userId="22b7bd11-eb0f-413f-9bcb-9ce21ec7b0a8" providerId="ADAL" clId="{63C519A2-C2B2-47AC-828F-E429CD2FEDB2}" dt="2023-05-31T18:16:39.268" v="36" actId="478"/>
          <ac:graphicFrameMkLst>
            <pc:docMk/>
            <pc:sldMk cId="3869918126" sldId="385"/>
            <ac:graphicFrameMk id="13" creationId="{B9927E7C-5754-4AEE-AAA8-51827D794FDD}"/>
          </ac:graphicFrameMkLst>
        </pc:graphicFrameChg>
        <pc:graphicFrameChg chg="add mod ord">
          <ac:chgData name="Jorgensen, Rick" userId="22b7bd11-eb0f-413f-9bcb-9ce21ec7b0a8" providerId="ADAL" clId="{63C519A2-C2B2-47AC-828F-E429CD2FEDB2}" dt="2023-07-27T17:19:41.885" v="9179" actId="692"/>
          <ac:graphicFrameMkLst>
            <pc:docMk/>
            <pc:sldMk cId="3869918126" sldId="385"/>
            <ac:graphicFrameMk id="16" creationId="{A190DDF6-648A-486A-BC49-29B9BF702BB9}"/>
          </ac:graphicFrameMkLst>
        </pc:graphicFrameChg>
        <pc:cxnChg chg="add mod">
          <ac:chgData name="Jorgensen, Rick" userId="22b7bd11-eb0f-413f-9bcb-9ce21ec7b0a8" providerId="ADAL" clId="{63C519A2-C2B2-47AC-828F-E429CD2FEDB2}" dt="2023-07-27T17:19:30.200" v="9175" actId="692"/>
          <ac:cxnSpMkLst>
            <pc:docMk/>
            <pc:sldMk cId="3869918126" sldId="385"/>
            <ac:cxnSpMk id="4" creationId="{7375FB5C-346A-379C-F7A8-DE876A5BE58D}"/>
          </ac:cxnSpMkLst>
        </pc:cxnChg>
        <pc:cxnChg chg="mod">
          <ac:chgData name="Jorgensen, Rick" userId="22b7bd11-eb0f-413f-9bcb-9ce21ec7b0a8" providerId="ADAL" clId="{63C519A2-C2B2-47AC-828F-E429CD2FEDB2}" dt="2023-07-27T17:20:21.360" v="9195" actId="692"/>
          <ac:cxnSpMkLst>
            <pc:docMk/>
            <pc:sldMk cId="3869918126" sldId="385"/>
            <ac:cxnSpMk id="18" creationId="{4360E467-0D4F-6D3C-C1F0-603651439336}"/>
          </ac:cxnSpMkLst>
        </pc:cxnChg>
      </pc:sldChg>
      <pc:sldChg chg="addSp delSp modSp add mod ord">
        <pc:chgData name="Jorgensen, Rick" userId="22b7bd11-eb0f-413f-9bcb-9ce21ec7b0a8" providerId="ADAL" clId="{63C519A2-C2B2-47AC-828F-E429CD2FEDB2}" dt="2023-08-01T15:56:21.131" v="12239" actId="20577"/>
        <pc:sldMkLst>
          <pc:docMk/>
          <pc:sldMk cId="1930347573" sldId="386"/>
        </pc:sldMkLst>
        <pc:spChg chg="add mod">
          <ac:chgData name="Jorgensen, Rick" userId="22b7bd11-eb0f-413f-9bcb-9ce21ec7b0a8" providerId="ADAL" clId="{63C519A2-C2B2-47AC-828F-E429CD2FEDB2}" dt="2023-08-01T15:42:12.945" v="12006" actId="1076"/>
          <ac:spMkLst>
            <pc:docMk/>
            <pc:sldMk cId="1930347573" sldId="386"/>
            <ac:spMk id="2" creationId="{7FE5B6EF-7FEE-E6F6-B1FB-04BEC9D64FBA}"/>
          </ac:spMkLst>
        </pc:spChg>
        <pc:spChg chg="del">
          <ac:chgData name="Jorgensen, Rick" userId="22b7bd11-eb0f-413f-9bcb-9ce21ec7b0a8" providerId="ADAL" clId="{63C519A2-C2B2-47AC-828F-E429CD2FEDB2}" dt="2023-05-31T18:51:25.010" v="219" actId="478"/>
          <ac:spMkLst>
            <pc:docMk/>
            <pc:sldMk cId="1930347573" sldId="386"/>
            <ac:spMk id="3" creationId="{1242B38E-6782-C861-E8D6-D1E98C0E5ED4}"/>
          </ac:spMkLst>
        </pc:spChg>
        <pc:spChg chg="add mod">
          <ac:chgData name="Jorgensen, Rick" userId="22b7bd11-eb0f-413f-9bcb-9ce21ec7b0a8" providerId="ADAL" clId="{63C519A2-C2B2-47AC-828F-E429CD2FEDB2}" dt="2023-08-01T15:42:12.945" v="12006" actId="1076"/>
          <ac:spMkLst>
            <pc:docMk/>
            <pc:sldMk cId="1930347573" sldId="386"/>
            <ac:spMk id="3" creationId="{4738819F-EC27-2C00-D45B-69BFDB7E3FC4}"/>
          </ac:spMkLst>
        </pc:spChg>
        <pc:spChg chg="del">
          <ac:chgData name="Jorgensen, Rick" userId="22b7bd11-eb0f-413f-9bcb-9ce21ec7b0a8" providerId="ADAL" clId="{63C519A2-C2B2-47AC-828F-E429CD2FEDB2}" dt="2023-05-31T18:52:22.634" v="241" actId="478"/>
          <ac:spMkLst>
            <pc:docMk/>
            <pc:sldMk cId="1930347573" sldId="386"/>
            <ac:spMk id="4" creationId="{09DBCA02-D125-8AB6-BC27-4A1677DEE8D3}"/>
          </ac:spMkLst>
        </pc:spChg>
        <pc:spChg chg="add mod">
          <ac:chgData name="Jorgensen, Rick" userId="22b7bd11-eb0f-413f-9bcb-9ce21ec7b0a8" providerId="ADAL" clId="{63C519A2-C2B2-47AC-828F-E429CD2FEDB2}" dt="2023-08-01T15:42:12.945" v="12006" actId="1076"/>
          <ac:spMkLst>
            <pc:docMk/>
            <pc:sldMk cId="1930347573" sldId="386"/>
            <ac:spMk id="5" creationId="{8D31E811-9219-17E9-A74B-55B29D9B3BC7}"/>
          </ac:spMkLst>
        </pc:spChg>
        <pc:spChg chg="del">
          <ac:chgData name="Jorgensen, Rick" userId="22b7bd11-eb0f-413f-9bcb-9ce21ec7b0a8" providerId="ADAL" clId="{63C519A2-C2B2-47AC-828F-E429CD2FEDB2}" dt="2023-05-31T18:51:26.330" v="220" actId="478"/>
          <ac:spMkLst>
            <pc:docMk/>
            <pc:sldMk cId="1930347573" sldId="386"/>
            <ac:spMk id="5" creationId="{E50A960F-E28D-4D60-4874-8E57F0A21381}"/>
          </ac:spMkLst>
        </pc:spChg>
        <pc:spChg chg="mod ord">
          <ac:chgData name="Jorgensen, Rick" userId="22b7bd11-eb0f-413f-9bcb-9ce21ec7b0a8" providerId="ADAL" clId="{63C519A2-C2B2-47AC-828F-E429CD2FEDB2}" dt="2023-08-01T15:42:28.062" v="12009" actId="1076"/>
          <ac:spMkLst>
            <pc:docMk/>
            <pc:sldMk cId="1930347573" sldId="386"/>
            <ac:spMk id="7" creationId="{3C3BE146-B654-24C5-1312-6B07E139E8DA}"/>
          </ac:spMkLst>
        </pc:spChg>
        <pc:spChg chg="del mod ord">
          <ac:chgData name="Jorgensen, Rick" userId="22b7bd11-eb0f-413f-9bcb-9ce21ec7b0a8" providerId="ADAL" clId="{63C519A2-C2B2-47AC-828F-E429CD2FEDB2}" dt="2023-07-05T15:19:50.643" v="6733" actId="478"/>
          <ac:spMkLst>
            <pc:docMk/>
            <pc:sldMk cId="1930347573" sldId="386"/>
            <ac:spMk id="8" creationId="{6DBB4D36-7671-FA4C-D50C-E943B2F05018}"/>
          </ac:spMkLst>
        </pc:spChg>
        <pc:spChg chg="del mod ord">
          <ac:chgData name="Jorgensen, Rick" userId="22b7bd11-eb0f-413f-9bcb-9ce21ec7b0a8" providerId="ADAL" clId="{63C519A2-C2B2-47AC-828F-E429CD2FEDB2}" dt="2023-07-05T15:19:52.565" v="6734" actId="478"/>
          <ac:spMkLst>
            <pc:docMk/>
            <pc:sldMk cId="1930347573" sldId="386"/>
            <ac:spMk id="9" creationId="{A3759962-9366-5CD1-C35C-ED0B0855C7E2}"/>
          </ac:spMkLst>
        </pc:spChg>
        <pc:spChg chg="add del mod">
          <ac:chgData name="Jorgensen, Rick" userId="22b7bd11-eb0f-413f-9bcb-9ce21ec7b0a8" providerId="ADAL" clId="{63C519A2-C2B2-47AC-828F-E429CD2FEDB2}" dt="2023-05-31T18:56:09.887" v="254" actId="478"/>
          <ac:spMkLst>
            <pc:docMk/>
            <pc:sldMk cId="1930347573" sldId="386"/>
            <ac:spMk id="11" creationId="{04165BF4-118E-BD50-6EA9-7C9846A10A25}"/>
          </ac:spMkLst>
        </pc:spChg>
        <pc:spChg chg="mod">
          <ac:chgData name="Jorgensen, Rick" userId="22b7bd11-eb0f-413f-9bcb-9ce21ec7b0a8" providerId="ADAL" clId="{63C519A2-C2B2-47AC-828F-E429CD2FEDB2}" dt="2023-08-01T15:41:57.003" v="12003"/>
          <ac:spMkLst>
            <pc:docMk/>
            <pc:sldMk cId="1930347573" sldId="386"/>
            <ac:spMk id="11" creationId="{918192D5-6F5C-0935-FB63-6AF2FADAC45F}"/>
          </ac:spMkLst>
        </pc:spChg>
        <pc:spChg chg="add del mod">
          <ac:chgData name="Jorgensen, Rick" userId="22b7bd11-eb0f-413f-9bcb-9ce21ec7b0a8" providerId="ADAL" clId="{63C519A2-C2B2-47AC-828F-E429CD2FEDB2}" dt="2023-07-27T17:20:31.651" v="9196" actId="478"/>
          <ac:spMkLst>
            <pc:docMk/>
            <pc:sldMk cId="1930347573" sldId="386"/>
            <ac:spMk id="15" creationId="{1AD59CB5-3811-2D86-D224-1B3F53E5FED9}"/>
          </ac:spMkLst>
        </pc:spChg>
        <pc:spChg chg="del">
          <ac:chgData name="Jorgensen, Rick" userId="22b7bd11-eb0f-413f-9bcb-9ce21ec7b0a8" providerId="ADAL" clId="{63C519A2-C2B2-47AC-828F-E429CD2FEDB2}" dt="2023-05-31T18:50:54.611" v="198" actId="478"/>
          <ac:spMkLst>
            <pc:docMk/>
            <pc:sldMk cId="1930347573" sldId="386"/>
            <ac:spMk id="16" creationId="{6593EDF3-5560-9A4E-B4EE-07FC91CE7602}"/>
          </ac:spMkLst>
        </pc:spChg>
        <pc:spChg chg="mod">
          <ac:chgData name="Jorgensen, Rick" userId="22b7bd11-eb0f-413f-9bcb-9ce21ec7b0a8" providerId="ADAL" clId="{63C519A2-C2B2-47AC-828F-E429CD2FEDB2}" dt="2023-08-01T15:42:22.947" v="12007" actId="1076"/>
          <ac:spMkLst>
            <pc:docMk/>
            <pc:sldMk cId="1930347573" sldId="386"/>
            <ac:spMk id="17" creationId="{D181E944-4B90-E74E-9153-2053FAE9DD47}"/>
          </ac:spMkLst>
        </pc:spChg>
        <pc:spChg chg="mod">
          <ac:chgData name="Jorgensen, Rick" userId="22b7bd11-eb0f-413f-9bcb-9ce21ec7b0a8" providerId="ADAL" clId="{63C519A2-C2B2-47AC-828F-E429CD2FEDB2}" dt="2023-08-01T15:41:57.003" v="12003"/>
          <ac:spMkLst>
            <pc:docMk/>
            <pc:sldMk cId="1930347573" sldId="386"/>
            <ac:spMk id="18" creationId="{2856FA08-4592-183F-E4B3-854AD0019A87}"/>
          </ac:spMkLst>
        </pc:spChg>
        <pc:spChg chg="mod">
          <ac:chgData name="Jorgensen, Rick" userId="22b7bd11-eb0f-413f-9bcb-9ce21ec7b0a8" providerId="ADAL" clId="{63C519A2-C2B2-47AC-828F-E429CD2FEDB2}" dt="2023-08-01T15:41:57.003" v="12003"/>
          <ac:spMkLst>
            <pc:docMk/>
            <pc:sldMk cId="1930347573" sldId="386"/>
            <ac:spMk id="19" creationId="{D07375C6-5A39-CC28-1C88-3E25F9949578}"/>
          </ac:spMkLst>
        </pc:spChg>
        <pc:spChg chg="mod">
          <ac:chgData name="Jorgensen, Rick" userId="22b7bd11-eb0f-413f-9bcb-9ce21ec7b0a8" providerId="ADAL" clId="{63C519A2-C2B2-47AC-828F-E429CD2FEDB2}" dt="2023-08-01T15:41:57.003" v="12003"/>
          <ac:spMkLst>
            <pc:docMk/>
            <pc:sldMk cId="1930347573" sldId="386"/>
            <ac:spMk id="21" creationId="{F20C939D-279D-1987-3323-543F2FDD569F}"/>
          </ac:spMkLst>
        </pc:spChg>
        <pc:spChg chg="add mod">
          <ac:chgData name="Jorgensen, Rick" userId="22b7bd11-eb0f-413f-9bcb-9ce21ec7b0a8" providerId="ADAL" clId="{63C519A2-C2B2-47AC-828F-E429CD2FEDB2}" dt="2023-08-01T15:45:35.328" v="12014" actId="20577"/>
          <ac:spMkLst>
            <pc:docMk/>
            <pc:sldMk cId="1930347573" sldId="386"/>
            <ac:spMk id="22" creationId="{09C0A976-1706-0DD0-3A28-3F125DD8EF1D}"/>
          </ac:spMkLst>
        </pc:spChg>
        <pc:spChg chg="add mod">
          <ac:chgData name="Jorgensen, Rick" userId="22b7bd11-eb0f-413f-9bcb-9ce21ec7b0a8" providerId="ADAL" clId="{63C519A2-C2B2-47AC-828F-E429CD2FEDB2}" dt="2023-08-01T15:46:15.466" v="12017" actId="1076"/>
          <ac:spMkLst>
            <pc:docMk/>
            <pc:sldMk cId="1930347573" sldId="386"/>
            <ac:spMk id="23" creationId="{753D7537-F164-CFEE-DDB8-D7FC97922DF8}"/>
          </ac:spMkLst>
        </pc:spChg>
        <pc:spChg chg="mod">
          <ac:chgData name="Jorgensen, Rick" userId="22b7bd11-eb0f-413f-9bcb-9ce21ec7b0a8" providerId="ADAL" clId="{63C519A2-C2B2-47AC-828F-E429CD2FEDB2}" dt="2023-08-01T15:56:21.131" v="12239" actId="20577"/>
          <ac:spMkLst>
            <pc:docMk/>
            <pc:sldMk cId="1930347573" sldId="386"/>
            <ac:spMk id="29" creationId="{2E51C695-DD93-3E46-975E-4AD32D674DE1}"/>
          </ac:spMkLst>
        </pc:spChg>
        <pc:grpChg chg="add mod">
          <ac:chgData name="Jorgensen, Rick" userId="22b7bd11-eb0f-413f-9bcb-9ce21ec7b0a8" providerId="ADAL" clId="{63C519A2-C2B2-47AC-828F-E429CD2FEDB2}" dt="2023-08-01T15:41:59.624" v="12004" actId="1076"/>
          <ac:grpSpMkLst>
            <pc:docMk/>
            <pc:sldMk cId="1930347573" sldId="386"/>
            <ac:grpSpMk id="8" creationId="{3F0A3545-1777-341E-3333-34A87D41DE63}"/>
          </ac:grpSpMkLst>
        </pc:grpChg>
        <pc:grpChg chg="mod">
          <ac:chgData name="Jorgensen, Rick" userId="22b7bd11-eb0f-413f-9bcb-9ce21ec7b0a8" providerId="ADAL" clId="{63C519A2-C2B2-47AC-828F-E429CD2FEDB2}" dt="2023-08-01T15:41:57.003" v="12003"/>
          <ac:grpSpMkLst>
            <pc:docMk/>
            <pc:sldMk cId="1930347573" sldId="386"/>
            <ac:grpSpMk id="9" creationId="{350527BC-A0A4-F134-33DF-884DBE1FBEE8}"/>
          </ac:grpSpMkLst>
        </pc:grpChg>
        <pc:grpChg chg="mod">
          <ac:chgData name="Jorgensen, Rick" userId="22b7bd11-eb0f-413f-9bcb-9ce21ec7b0a8" providerId="ADAL" clId="{63C519A2-C2B2-47AC-828F-E429CD2FEDB2}" dt="2023-08-01T15:45:47.349" v="12015" actId="1076"/>
          <ac:grpSpMkLst>
            <pc:docMk/>
            <pc:sldMk cId="1930347573" sldId="386"/>
            <ac:grpSpMk id="12" creationId="{1B50585F-6C48-890F-D6BD-D343C918731A}"/>
          </ac:grpSpMkLst>
        </pc:grpChg>
        <pc:grpChg chg="mod">
          <ac:chgData name="Jorgensen, Rick" userId="22b7bd11-eb0f-413f-9bcb-9ce21ec7b0a8" providerId="ADAL" clId="{63C519A2-C2B2-47AC-828F-E429CD2FEDB2}" dt="2023-08-01T15:41:57.003" v="12003"/>
          <ac:grpSpMkLst>
            <pc:docMk/>
            <pc:sldMk cId="1930347573" sldId="386"/>
            <ac:grpSpMk id="16" creationId="{AEC33ED1-A1AD-9C0B-2876-10C2CA5A142A}"/>
          </ac:grpSpMkLst>
        </pc:grpChg>
        <pc:graphicFrameChg chg="del">
          <ac:chgData name="Jorgensen, Rick" userId="22b7bd11-eb0f-413f-9bcb-9ce21ec7b0a8" providerId="ADAL" clId="{63C519A2-C2B2-47AC-828F-E429CD2FEDB2}" dt="2023-05-31T18:51:12.851" v="213" actId="478"/>
          <ac:graphicFrameMkLst>
            <pc:docMk/>
            <pc:sldMk cId="1930347573" sldId="386"/>
            <ac:graphicFrameMk id="2" creationId="{49BDDCB0-92CF-4CFD-99A2-8A19467FEA82}"/>
          </ac:graphicFrameMkLst>
        </pc:graphicFrameChg>
        <pc:graphicFrameChg chg="del">
          <ac:chgData name="Jorgensen, Rick" userId="22b7bd11-eb0f-413f-9bcb-9ce21ec7b0a8" providerId="ADAL" clId="{63C519A2-C2B2-47AC-828F-E429CD2FEDB2}" dt="2023-05-31T18:50:52.902" v="197" actId="478"/>
          <ac:graphicFrameMkLst>
            <pc:docMk/>
            <pc:sldMk cId="1930347573" sldId="386"/>
            <ac:graphicFrameMk id="6" creationId="{182965B2-4788-498D-A731-4D6513F6FCC5}"/>
          </ac:graphicFrameMkLst>
        </pc:graphicFrameChg>
        <pc:graphicFrameChg chg="add mod">
          <ac:chgData name="Jorgensen, Rick" userId="22b7bd11-eb0f-413f-9bcb-9ce21ec7b0a8" providerId="ADAL" clId="{63C519A2-C2B2-47AC-828F-E429CD2FEDB2}" dt="2023-08-01T15:41:59.624" v="12004" actId="1076"/>
          <ac:graphicFrameMkLst>
            <pc:docMk/>
            <pc:sldMk cId="1930347573" sldId="386"/>
            <ac:graphicFrameMk id="6" creationId="{9A9B4E5A-BE93-E01F-F26A-ABE8CB9500C3}"/>
          </ac:graphicFrameMkLst>
        </pc:graphicFrameChg>
        <pc:graphicFrameChg chg="add mod ord">
          <ac:chgData name="Jorgensen, Rick" userId="22b7bd11-eb0f-413f-9bcb-9ce21ec7b0a8" providerId="ADAL" clId="{63C519A2-C2B2-47AC-828F-E429CD2FEDB2}" dt="2023-08-01T15:42:12.945" v="12006" actId="1076"/>
          <ac:graphicFrameMkLst>
            <pc:docMk/>
            <pc:sldMk cId="1930347573" sldId="386"/>
            <ac:graphicFrameMk id="10" creationId="{6A4EC095-5490-40BE-88AC-88E4EC7B03DE}"/>
          </ac:graphicFrameMkLst>
        </pc:graphicFrameChg>
        <pc:picChg chg="mod">
          <ac:chgData name="Jorgensen, Rick" userId="22b7bd11-eb0f-413f-9bcb-9ce21ec7b0a8" providerId="ADAL" clId="{63C519A2-C2B2-47AC-828F-E429CD2FEDB2}" dt="2023-08-01T15:41:57.003" v="12003"/>
          <ac:picMkLst>
            <pc:docMk/>
            <pc:sldMk cId="1930347573" sldId="386"/>
            <ac:picMk id="15" creationId="{1E2B2408-8CB3-1E38-E63A-2E6319212BE7}"/>
          </ac:picMkLst>
        </pc:picChg>
        <pc:picChg chg="mod">
          <ac:chgData name="Jorgensen, Rick" userId="22b7bd11-eb0f-413f-9bcb-9ce21ec7b0a8" providerId="ADAL" clId="{63C519A2-C2B2-47AC-828F-E429CD2FEDB2}" dt="2023-08-01T15:41:57.003" v="12003"/>
          <ac:picMkLst>
            <pc:docMk/>
            <pc:sldMk cId="1930347573" sldId="386"/>
            <ac:picMk id="20" creationId="{CD808FCB-AB7A-142A-4F64-76A3AE1AE2B7}"/>
          </ac:picMkLst>
        </pc:picChg>
        <pc:cxnChg chg="add mod">
          <ac:chgData name="Jorgensen, Rick" userId="22b7bd11-eb0f-413f-9bcb-9ce21ec7b0a8" providerId="ADAL" clId="{63C519A2-C2B2-47AC-828F-E429CD2FEDB2}" dt="2023-08-01T15:42:12.945" v="12006" actId="1076"/>
          <ac:cxnSpMkLst>
            <pc:docMk/>
            <pc:sldMk cId="1930347573" sldId="386"/>
            <ac:cxnSpMk id="4" creationId="{EC3D0536-8958-1C98-41DB-C0427AE32BBC}"/>
          </ac:cxnSpMkLst>
        </pc:cxnChg>
        <pc:cxnChg chg="mod">
          <ac:chgData name="Jorgensen, Rick" userId="22b7bd11-eb0f-413f-9bcb-9ce21ec7b0a8" providerId="ADAL" clId="{63C519A2-C2B2-47AC-828F-E429CD2FEDB2}" dt="2023-07-27T17:20:15.867" v="9193" actId="692"/>
          <ac:cxnSpMkLst>
            <pc:docMk/>
            <pc:sldMk cId="1930347573" sldId="386"/>
            <ac:cxnSpMk id="13" creationId="{3FBCFBE3-4735-5126-8902-B4CB06F7E632}"/>
          </ac:cxnSpMkLst>
        </pc:cxnChg>
      </pc:sldChg>
      <pc:sldChg chg="addSp delSp modSp add mod ord">
        <pc:chgData name="Jorgensen, Rick" userId="22b7bd11-eb0f-413f-9bcb-9ce21ec7b0a8" providerId="ADAL" clId="{63C519A2-C2B2-47AC-828F-E429CD2FEDB2}" dt="2023-08-01T15:56:08.937" v="12237"/>
        <pc:sldMkLst>
          <pc:docMk/>
          <pc:sldMk cId="361227352" sldId="387"/>
        </pc:sldMkLst>
        <pc:spChg chg="add mod">
          <ac:chgData name="Jorgensen, Rick" userId="22b7bd11-eb0f-413f-9bcb-9ce21ec7b0a8" providerId="ADAL" clId="{63C519A2-C2B2-47AC-828F-E429CD2FEDB2}" dt="2023-06-23T17:51:33.124" v="5514" actId="20577"/>
          <ac:spMkLst>
            <pc:docMk/>
            <pc:sldMk cId="361227352" sldId="387"/>
            <ac:spMk id="2" creationId="{86093107-869E-B9EB-05A0-DBBE64198E30}"/>
          </ac:spMkLst>
        </pc:spChg>
        <pc:spChg chg="add mod">
          <ac:chgData name="Jorgensen, Rick" userId="22b7bd11-eb0f-413f-9bcb-9ce21ec7b0a8" providerId="ADAL" clId="{63C519A2-C2B2-47AC-828F-E429CD2FEDB2}" dt="2023-06-23T17:46:39.744" v="5436" actId="164"/>
          <ac:spMkLst>
            <pc:docMk/>
            <pc:sldMk cId="361227352" sldId="387"/>
            <ac:spMk id="3" creationId="{45A6C5A0-516D-89A1-725C-76E5A0BDE3B6}"/>
          </ac:spMkLst>
        </pc:spChg>
        <pc:spChg chg="add mod">
          <ac:chgData name="Jorgensen, Rick" userId="22b7bd11-eb0f-413f-9bcb-9ce21ec7b0a8" providerId="ADAL" clId="{63C519A2-C2B2-47AC-828F-E429CD2FEDB2}" dt="2023-07-31T20:46:47.761" v="10240" actId="1076"/>
          <ac:spMkLst>
            <pc:docMk/>
            <pc:sldMk cId="361227352" sldId="387"/>
            <ac:spMk id="5" creationId="{825CC85B-2EE9-77AE-ECAC-EA89BD7ADE97}"/>
          </ac:spMkLst>
        </pc:spChg>
        <pc:spChg chg="mod">
          <ac:chgData name="Jorgensen, Rick" userId="22b7bd11-eb0f-413f-9bcb-9ce21ec7b0a8" providerId="ADAL" clId="{63C519A2-C2B2-47AC-828F-E429CD2FEDB2}" dt="2023-06-23T17:45:16.725" v="5420" actId="20577"/>
          <ac:spMkLst>
            <pc:docMk/>
            <pc:sldMk cId="361227352" sldId="387"/>
            <ac:spMk id="7" creationId="{8A8EC10B-0D30-01BF-78DE-823C54032375}"/>
          </ac:spMkLst>
        </pc:spChg>
        <pc:spChg chg="del">
          <ac:chgData name="Jorgensen, Rick" userId="22b7bd11-eb0f-413f-9bcb-9ce21ec7b0a8" providerId="ADAL" clId="{63C519A2-C2B2-47AC-828F-E429CD2FEDB2}" dt="2023-05-31T19:58:39.426" v="396" actId="478"/>
          <ac:spMkLst>
            <pc:docMk/>
            <pc:sldMk cId="361227352" sldId="387"/>
            <ac:spMk id="12" creationId="{9C653018-C4AE-725D-FC1F-4ABA856509C4}"/>
          </ac:spMkLst>
        </pc:spChg>
        <pc:spChg chg="mod">
          <ac:chgData name="Jorgensen, Rick" userId="22b7bd11-eb0f-413f-9bcb-9ce21ec7b0a8" providerId="ADAL" clId="{63C519A2-C2B2-47AC-828F-E429CD2FEDB2}" dt="2023-07-27T17:21:25.338" v="9218" actId="692"/>
          <ac:spMkLst>
            <pc:docMk/>
            <pc:sldMk cId="361227352" sldId="387"/>
            <ac:spMk id="13" creationId="{343B04CC-6DE5-9DB9-322C-CC47525C9CD1}"/>
          </ac:spMkLst>
        </pc:spChg>
        <pc:spChg chg="add mod">
          <ac:chgData name="Jorgensen, Rick" userId="22b7bd11-eb0f-413f-9bcb-9ce21ec7b0a8" providerId="ADAL" clId="{63C519A2-C2B2-47AC-828F-E429CD2FEDB2}" dt="2023-05-31T20:02:26.685" v="435" actId="164"/>
          <ac:spMkLst>
            <pc:docMk/>
            <pc:sldMk cId="361227352" sldId="387"/>
            <ac:spMk id="15" creationId="{1D5CEDBC-D99A-DED4-88E4-68B92D531651}"/>
          </ac:spMkLst>
        </pc:spChg>
        <pc:spChg chg="add mod">
          <ac:chgData name="Jorgensen, Rick" userId="22b7bd11-eb0f-413f-9bcb-9ce21ec7b0a8" providerId="ADAL" clId="{63C519A2-C2B2-47AC-828F-E429CD2FEDB2}" dt="2023-07-31T20:47:43.112" v="10257" actId="1076"/>
          <ac:spMkLst>
            <pc:docMk/>
            <pc:sldMk cId="361227352" sldId="387"/>
            <ac:spMk id="17" creationId="{B9C54977-DB05-D437-8AF5-9D204EF68063}"/>
          </ac:spMkLst>
        </pc:spChg>
        <pc:spChg chg="mod">
          <ac:chgData name="Jorgensen, Rick" userId="22b7bd11-eb0f-413f-9bcb-9ce21ec7b0a8" providerId="ADAL" clId="{63C519A2-C2B2-47AC-828F-E429CD2FEDB2}" dt="2023-05-31T20:03:21.110" v="446"/>
          <ac:spMkLst>
            <pc:docMk/>
            <pc:sldMk cId="361227352" sldId="387"/>
            <ac:spMk id="20" creationId="{F81C9874-D924-0B54-832A-49229CFFBB2F}"/>
          </ac:spMkLst>
        </pc:spChg>
        <pc:spChg chg="mod">
          <ac:chgData name="Jorgensen, Rick" userId="22b7bd11-eb0f-413f-9bcb-9ce21ec7b0a8" providerId="ADAL" clId="{63C519A2-C2B2-47AC-828F-E429CD2FEDB2}" dt="2023-05-31T20:03:21.110" v="446"/>
          <ac:spMkLst>
            <pc:docMk/>
            <pc:sldMk cId="361227352" sldId="387"/>
            <ac:spMk id="22" creationId="{D1397991-6C4C-C72A-04B2-FDC3A23B4775}"/>
          </ac:spMkLst>
        </pc:spChg>
        <pc:spChg chg="mod">
          <ac:chgData name="Jorgensen, Rick" userId="22b7bd11-eb0f-413f-9bcb-9ce21ec7b0a8" providerId="ADAL" clId="{63C519A2-C2B2-47AC-828F-E429CD2FEDB2}" dt="2023-06-23T17:47:45.197" v="5449"/>
          <ac:spMkLst>
            <pc:docMk/>
            <pc:sldMk cId="361227352" sldId="387"/>
            <ac:spMk id="23" creationId="{6689AFCB-DBDA-3347-A808-963438485873}"/>
          </ac:spMkLst>
        </pc:spChg>
        <pc:spChg chg="mod">
          <ac:chgData name="Jorgensen, Rick" userId="22b7bd11-eb0f-413f-9bcb-9ce21ec7b0a8" providerId="ADAL" clId="{63C519A2-C2B2-47AC-828F-E429CD2FEDB2}" dt="2023-07-17T14:58:06.776" v="6804" actId="20577"/>
          <ac:spMkLst>
            <pc:docMk/>
            <pc:sldMk cId="361227352" sldId="387"/>
            <ac:spMk id="25" creationId="{43DF711F-4684-B34D-9236-D3A26D348F11}"/>
          </ac:spMkLst>
        </pc:spChg>
        <pc:spChg chg="mod">
          <ac:chgData name="Jorgensen, Rick" userId="22b7bd11-eb0f-413f-9bcb-9ce21ec7b0a8" providerId="ADAL" clId="{63C519A2-C2B2-47AC-828F-E429CD2FEDB2}" dt="2023-06-23T17:47:45.197" v="5449"/>
          <ac:spMkLst>
            <pc:docMk/>
            <pc:sldMk cId="361227352" sldId="387"/>
            <ac:spMk id="27" creationId="{3250FBB8-FF61-51A7-0EAA-667057A9F81E}"/>
          </ac:spMkLst>
        </pc:spChg>
        <pc:spChg chg="mod">
          <ac:chgData name="Jorgensen, Rick" userId="22b7bd11-eb0f-413f-9bcb-9ce21ec7b0a8" providerId="ADAL" clId="{63C519A2-C2B2-47AC-828F-E429CD2FEDB2}" dt="2023-06-23T17:47:45.197" v="5449"/>
          <ac:spMkLst>
            <pc:docMk/>
            <pc:sldMk cId="361227352" sldId="387"/>
            <ac:spMk id="28" creationId="{FC1E2170-DE73-AB9D-1899-10F651766E6A}"/>
          </ac:spMkLst>
        </pc:spChg>
        <pc:spChg chg="mod">
          <ac:chgData name="Jorgensen, Rick" userId="22b7bd11-eb0f-413f-9bcb-9ce21ec7b0a8" providerId="ADAL" clId="{63C519A2-C2B2-47AC-828F-E429CD2FEDB2}" dt="2023-05-31T20:03:21.110" v="446"/>
          <ac:spMkLst>
            <pc:docMk/>
            <pc:sldMk cId="361227352" sldId="387"/>
            <ac:spMk id="31" creationId="{AA569F25-BA98-04D5-3178-FAE3B0B9A473}"/>
          </ac:spMkLst>
        </pc:spChg>
        <pc:spChg chg="mod">
          <ac:chgData name="Jorgensen, Rick" userId="22b7bd11-eb0f-413f-9bcb-9ce21ec7b0a8" providerId="ADAL" clId="{63C519A2-C2B2-47AC-828F-E429CD2FEDB2}" dt="2023-07-27T17:21:35.744" v="9220" actId="692"/>
          <ac:spMkLst>
            <pc:docMk/>
            <pc:sldMk cId="361227352" sldId="387"/>
            <ac:spMk id="32" creationId="{65341B23-19E3-577C-1CA1-47B7702F3BFF}"/>
          </ac:spMkLst>
        </pc:spChg>
        <pc:grpChg chg="add mod">
          <ac:chgData name="Jorgensen, Rick" userId="22b7bd11-eb0f-413f-9bcb-9ce21ec7b0a8" providerId="ADAL" clId="{63C519A2-C2B2-47AC-828F-E429CD2FEDB2}" dt="2023-05-31T20:02:26.685" v="435" actId="164"/>
          <ac:grpSpMkLst>
            <pc:docMk/>
            <pc:sldMk cId="361227352" sldId="387"/>
            <ac:grpSpMk id="6" creationId="{A85886BC-83B0-8A2C-AFE9-C72099D163C3}"/>
          </ac:grpSpMkLst>
        </pc:grpChg>
        <pc:grpChg chg="add mod">
          <ac:chgData name="Jorgensen, Rick" userId="22b7bd11-eb0f-413f-9bcb-9ce21ec7b0a8" providerId="ADAL" clId="{63C519A2-C2B2-47AC-828F-E429CD2FEDB2}" dt="2023-06-23T17:47:30.245" v="5446" actId="1076"/>
          <ac:grpSpMkLst>
            <pc:docMk/>
            <pc:sldMk cId="361227352" sldId="387"/>
            <ac:grpSpMk id="11" creationId="{ED8CF572-9196-C83F-0B7D-7754AC4AACEE}"/>
          </ac:grpSpMkLst>
        </pc:grpChg>
        <pc:grpChg chg="del">
          <ac:chgData name="Jorgensen, Rick" userId="22b7bd11-eb0f-413f-9bcb-9ce21ec7b0a8" providerId="ADAL" clId="{63C519A2-C2B2-47AC-828F-E429CD2FEDB2}" dt="2023-05-31T19:58:39.426" v="396" actId="478"/>
          <ac:grpSpMkLst>
            <pc:docMk/>
            <pc:sldMk cId="361227352" sldId="387"/>
            <ac:grpSpMk id="11" creationId="{EF40D498-E7FF-42F9-CE30-35EA2115D1E2}"/>
          </ac:grpSpMkLst>
        </pc:grpChg>
        <pc:grpChg chg="add mod">
          <ac:chgData name="Jorgensen, Rick" userId="22b7bd11-eb0f-413f-9bcb-9ce21ec7b0a8" providerId="ADAL" clId="{63C519A2-C2B2-47AC-828F-E429CD2FEDB2}" dt="2023-06-23T17:48:32.194" v="5456" actId="1076"/>
          <ac:grpSpMkLst>
            <pc:docMk/>
            <pc:sldMk cId="361227352" sldId="387"/>
            <ac:grpSpMk id="14" creationId="{A8E3776A-5242-7004-112E-A97F135505AD}"/>
          </ac:grpSpMkLst>
        </pc:grpChg>
        <pc:grpChg chg="add mod">
          <ac:chgData name="Jorgensen, Rick" userId="22b7bd11-eb0f-413f-9bcb-9ce21ec7b0a8" providerId="ADAL" clId="{63C519A2-C2B2-47AC-828F-E429CD2FEDB2}" dt="2023-06-23T17:46:39.744" v="5436" actId="164"/>
          <ac:grpSpMkLst>
            <pc:docMk/>
            <pc:sldMk cId="361227352" sldId="387"/>
            <ac:grpSpMk id="16" creationId="{63F365D8-0205-793D-706C-D33F1CECE77F}"/>
          </ac:grpSpMkLst>
        </pc:grpChg>
        <pc:grpChg chg="add del mod">
          <ac:chgData name="Jorgensen, Rick" userId="22b7bd11-eb0f-413f-9bcb-9ce21ec7b0a8" providerId="ADAL" clId="{63C519A2-C2B2-47AC-828F-E429CD2FEDB2}" dt="2023-06-23T17:47:48.720" v="5451" actId="478"/>
          <ac:grpSpMkLst>
            <pc:docMk/>
            <pc:sldMk cId="361227352" sldId="387"/>
            <ac:grpSpMk id="18" creationId="{AA8F8FDF-372B-4B2F-5318-140F11DAFB8C}"/>
          </ac:grpSpMkLst>
        </pc:grpChg>
        <pc:grpChg chg="mod">
          <ac:chgData name="Jorgensen, Rick" userId="22b7bd11-eb0f-413f-9bcb-9ce21ec7b0a8" providerId="ADAL" clId="{63C519A2-C2B2-47AC-828F-E429CD2FEDB2}" dt="2023-05-31T20:03:21.110" v="446"/>
          <ac:grpSpMkLst>
            <pc:docMk/>
            <pc:sldMk cId="361227352" sldId="387"/>
            <ac:grpSpMk id="19" creationId="{793A1B4C-32BF-8097-953C-2F0DC8F38A6C}"/>
          </ac:grpSpMkLst>
        </pc:grpChg>
        <pc:grpChg chg="mod">
          <ac:chgData name="Jorgensen, Rick" userId="22b7bd11-eb0f-413f-9bcb-9ce21ec7b0a8" providerId="ADAL" clId="{63C519A2-C2B2-47AC-828F-E429CD2FEDB2}" dt="2023-06-23T17:47:45.197" v="5449"/>
          <ac:grpSpMkLst>
            <pc:docMk/>
            <pc:sldMk cId="361227352" sldId="387"/>
            <ac:grpSpMk id="21" creationId="{BA8CAACC-77FA-230F-0ABE-3F5837982EB8}"/>
          </ac:grpSpMkLst>
        </pc:grpChg>
        <pc:grpChg chg="del">
          <ac:chgData name="Jorgensen, Rick" userId="22b7bd11-eb0f-413f-9bcb-9ce21ec7b0a8" providerId="ADAL" clId="{63C519A2-C2B2-47AC-828F-E429CD2FEDB2}" dt="2023-05-31T19:58:40.965" v="397" actId="478"/>
          <ac:grpSpMkLst>
            <pc:docMk/>
            <pc:sldMk cId="361227352" sldId="387"/>
            <ac:grpSpMk id="23" creationId="{D0DA05A6-B7B6-32E7-2840-F8E207CDE38B}"/>
          </ac:grpSpMkLst>
        </pc:grpChg>
        <pc:grpChg chg="del">
          <ac:chgData name="Jorgensen, Rick" userId="22b7bd11-eb0f-413f-9bcb-9ce21ec7b0a8" providerId="ADAL" clId="{63C519A2-C2B2-47AC-828F-E429CD2FEDB2}" dt="2023-05-31T20:03:02.419" v="441" actId="478"/>
          <ac:grpSpMkLst>
            <pc:docMk/>
            <pc:sldMk cId="361227352" sldId="387"/>
            <ac:grpSpMk id="24" creationId="{3B2524DA-3482-D029-913A-4ED060DA3398}"/>
          </ac:grpSpMkLst>
        </pc:grpChg>
        <pc:grpChg chg="mod">
          <ac:chgData name="Jorgensen, Rick" userId="22b7bd11-eb0f-413f-9bcb-9ce21ec7b0a8" providerId="ADAL" clId="{63C519A2-C2B2-47AC-828F-E429CD2FEDB2}" dt="2023-06-23T17:47:45.197" v="5449"/>
          <ac:grpSpMkLst>
            <pc:docMk/>
            <pc:sldMk cId="361227352" sldId="387"/>
            <ac:grpSpMk id="26" creationId="{B26E3168-DB02-3038-2C80-1075AB442A78}"/>
          </ac:grpSpMkLst>
        </pc:grpChg>
        <pc:graphicFrameChg chg="del">
          <ac:chgData name="Jorgensen, Rick" userId="22b7bd11-eb0f-413f-9bcb-9ce21ec7b0a8" providerId="ADAL" clId="{63C519A2-C2B2-47AC-828F-E429CD2FEDB2}" dt="2023-05-31T19:57:47.317" v="393" actId="478"/>
          <ac:graphicFrameMkLst>
            <pc:docMk/>
            <pc:sldMk cId="361227352" sldId="387"/>
            <ac:graphicFrameMk id="2" creationId="{4C1A20E4-5A7D-4ACB-B676-18D71F0183DE}"/>
          </ac:graphicFrameMkLst>
        </pc:graphicFrameChg>
        <pc:graphicFrameChg chg="del">
          <ac:chgData name="Jorgensen, Rick" userId="22b7bd11-eb0f-413f-9bcb-9ce21ec7b0a8" providerId="ADAL" clId="{63C519A2-C2B2-47AC-828F-E429CD2FEDB2}" dt="2023-05-31T20:02:43.149" v="440" actId="478"/>
          <ac:graphicFrameMkLst>
            <pc:docMk/>
            <pc:sldMk cId="361227352" sldId="387"/>
            <ac:graphicFrameMk id="3" creationId="{26DDEA2D-0E9D-4FB9-973D-16DEFDB90893}"/>
          </ac:graphicFrameMkLst>
        </pc:graphicFrameChg>
        <pc:graphicFrameChg chg="add del mod">
          <ac:chgData name="Jorgensen, Rick" userId="22b7bd11-eb0f-413f-9bcb-9ce21ec7b0a8" providerId="ADAL" clId="{63C519A2-C2B2-47AC-828F-E429CD2FEDB2}" dt="2023-05-31T19:58:52.600" v="399" actId="478"/>
          <ac:graphicFrameMkLst>
            <pc:docMk/>
            <pc:sldMk cId="361227352" sldId="387"/>
            <ac:graphicFrameMk id="4" creationId="{1A8EC719-D765-4ED2-911A-45F8286A6F59}"/>
          </ac:graphicFrameMkLst>
        </pc:graphicFrameChg>
        <pc:graphicFrameChg chg="add del mod">
          <ac:chgData name="Jorgensen, Rick" userId="22b7bd11-eb0f-413f-9bcb-9ce21ec7b0a8" providerId="ADAL" clId="{63C519A2-C2B2-47AC-828F-E429CD2FEDB2}" dt="2023-06-23T17:45:27.205" v="5424" actId="478"/>
          <ac:graphicFrameMkLst>
            <pc:docMk/>
            <pc:sldMk cId="361227352" sldId="387"/>
            <ac:graphicFrameMk id="5" creationId="{1A8EC719-D765-4ED2-911A-45F8286A6F59}"/>
          </ac:graphicFrameMkLst>
        </pc:graphicFrameChg>
        <pc:graphicFrameChg chg="add mod ord">
          <ac:chgData name="Jorgensen, Rick" userId="22b7bd11-eb0f-413f-9bcb-9ce21ec7b0a8" providerId="ADAL" clId="{63C519A2-C2B2-47AC-828F-E429CD2FEDB2}" dt="2023-07-27T17:21:13.332" v="9217" actId="692"/>
          <ac:graphicFrameMkLst>
            <pc:docMk/>
            <pc:sldMk cId="361227352" sldId="387"/>
            <ac:graphicFrameMk id="12" creationId="{52659E5C-59D3-44AA-93EA-00A3834A1AAD}"/>
          </ac:graphicFrameMkLst>
        </pc:graphicFrameChg>
        <pc:graphicFrameChg chg="add del mod">
          <ac:chgData name="Jorgensen, Rick" userId="22b7bd11-eb0f-413f-9bcb-9ce21ec7b0a8" providerId="ADAL" clId="{63C519A2-C2B2-47AC-828F-E429CD2FEDB2}" dt="2023-06-23T17:45:28.131" v="5425" actId="478"/>
          <ac:graphicFrameMkLst>
            <pc:docMk/>
            <pc:sldMk cId="361227352" sldId="387"/>
            <ac:graphicFrameMk id="17" creationId="{30D15B10-EAD8-4021-B50E-8139CF87AA4A}"/>
          </ac:graphicFrameMkLst>
        </pc:graphicFrameChg>
        <pc:graphicFrameChg chg="add del mod">
          <ac:chgData name="Jorgensen, Rick" userId="22b7bd11-eb0f-413f-9bcb-9ce21ec7b0a8" providerId="ADAL" clId="{63C519A2-C2B2-47AC-828F-E429CD2FEDB2}" dt="2023-06-23T17:50:23.362" v="5470" actId="478"/>
          <ac:graphicFrameMkLst>
            <pc:docMk/>
            <pc:sldMk cId="361227352" sldId="387"/>
            <ac:graphicFrameMk id="33" creationId="{2C46D776-ED2F-4957-B9BC-1A60F0DB73E6}"/>
          </ac:graphicFrameMkLst>
        </pc:graphicFrameChg>
        <pc:graphicFrameChg chg="add del mod">
          <ac:chgData name="Jorgensen, Rick" userId="22b7bd11-eb0f-413f-9bcb-9ce21ec7b0a8" providerId="ADAL" clId="{63C519A2-C2B2-47AC-828F-E429CD2FEDB2}" dt="2023-06-23T17:51:06.510" v="5475" actId="478"/>
          <ac:graphicFrameMkLst>
            <pc:docMk/>
            <pc:sldMk cId="361227352" sldId="387"/>
            <ac:graphicFrameMk id="34" creationId="{2C46D776-ED2F-4957-B9BC-1A60F0DB73E6}"/>
          </ac:graphicFrameMkLst>
        </pc:graphicFrameChg>
        <pc:graphicFrameChg chg="add mod ord">
          <ac:chgData name="Jorgensen, Rick" userId="22b7bd11-eb0f-413f-9bcb-9ce21ec7b0a8" providerId="ADAL" clId="{63C519A2-C2B2-47AC-828F-E429CD2FEDB2}" dt="2023-07-27T17:21:31.921" v="9219" actId="167"/>
          <ac:graphicFrameMkLst>
            <pc:docMk/>
            <pc:sldMk cId="361227352" sldId="387"/>
            <ac:graphicFrameMk id="35" creationId="{2C46D776-ED2F-4957-B9BC-1A60F0DB73E6}"/>
          </ac:graphicFrameMkLst>
        </pc:graphicFrameChg>
        <pc:picChg chg="add mod">
          <ac:chgData name="Jorgensen, Rick" userId="22b7bd11-eb0f-413f-9bcb-9ce21ec7b0a8" providerId="ADAL" clId="{63C519A2-C2B2-47AC-828F-E429CD2FEDB2}" dt="2023-06-23T17:46:50.685" v="5439" actId="1076"/>
          <ac:picMkLst>
            <pc:docMk/>
            <pc:sldMk cId="361227352" sldId="387"/>
            <ac:picMk id="4" creationId="{5C1B657B-43C2-F840-8AB6-2161BAC9CAC2}"/>
          </ac:picMkLst>
        </pc:picChg>
        <pc:picChg chg="mod modCrop">
          <ac:chgData name="Jorgensen, Rick" userId="22b7bd11-eb0f-413f-9bcb-9ce21ec7b0a8" providerId="ADAL" clId="{63C519A2-C2B2-47AC-828F-E429CD2FEDB2}" dt="2023-05-31T20:02:00.086" v="433" actId="1076"/>
          <ac:picMkLst>
            <pc:docMk/>
            <pc:sldMk cId="361227352" sldId="387"/>
            <ac:picMk id="8" creationId="{A2DB007B-8434-7EBD-66D7-F8E176105F4E}"/>
          </ac:picMkLst>
        </pc:picChg>
        <pc:picChg chg="mod">
          <ac:chgData name="Jorgensen, Rick" userId="22b7bd11-eb0f-413f-9bcb-9ce21ec7b0a8" providerId="ADAL" clId="{63C519A2-C2B2-47AC-828F-E429CD2FEDB2}" dt="2023-06-23T17:47:45.197" v="5449"/>
          <ac:picMkLst>
            <pc:docMk/>
            <pc:sldMk cId="361227352" sldId="387"/>
            <ac:picMk id="24" creationId="{CAA2D9A6-6AFA-ACA0-F60A-0B61AC62D069}"/>
          </ac:picMkLst>
        </pc:picChg>
        <pc:picChg chg="mod">
          <ac:chgData name="Jorgensen, Rick" userId="22b7bd11-eb0f-413f-9bcb-9ce21ec7b0a8" providerId="ADAL" clId="{63C519A2-C2B2-47AC-828F-E429CD2FEDB2}" dt="2023-06-23T17:47:45.197" v="5449"/>
          <ac:picMkLst>
            <pc:docMk/>
            <pc:sldMk cId="361227352" sldId="387"/>
            <ac:picMk id="29" creationId="{0C074788-CD0F-8715-DACE-9702EDF4C597}"/>
          </ac:picMkLst>
        </pc:picChg>
        <pc:picChg chg="mod">
          <ac:chgData name="Jorgensen, Rick" userId="22b7bd11-eb0f-413f-9bcb-9ce21ec7b0a8" providerId="ADAL" clId="{63C519A2-C2B2-47AC-828F-E429CD2FEDB2}" dt="2023-05-31T20:03:21.110" v="446"/>
          <ac:picMkLst>
            <pc:docMk/>
            <pc:sldMk cId="361227352" sldId="387"/>
            <ac:picMk id="30" creationId="{DB103EDA-CF95-2E50-4D06-F2896062C444}"/>
          </ac:picMkLst>
        </pc:picChg>
      </pc:sldChg>
      <pc:sldChg chg="addSp delSp modSp add del mod modNotesTx">
        <pc:chgData name="Jorgensen, Rick" userId="22b7bd11-eb0f-413f-9bcb-9ce21ec7b0a8" providerId="ADAL" clId="{63C519A2-C2B2-47AC-828F-E429CD2FEDB2}" dt="2023-06-23T17:46:55.914" v="5440" actId="47"/>
        <pc:sldMkLst>
          <pc:docMk/>
          <pc:sldMk cId="4062779282" sldId="388"/>
        </pc:sldMkLst>
        <pc:spChg chg="mod">
          <ac:chgData name="Jorgensen, Rick" userId="22b7bd11-eb0f-413f-9bcb-9ce21ec7b0a8" providerId="ADAL" clId="{63C519A2-C2B2-47AC-828F-E429CD2FEDB2}" dt="2023-05-31T20:19:30.616" v="612" actId="20577"/>
          <ac:spMkLst>
            <pc:docMk/>
            <pc:sldMk cId="4062779282" sldId="388"/>
            <ac:spMk id="9" creationId="{16C98FF7-C9E9-8046-A859-D9A599468A34}"/>
          </ac:spMkLst>
        </pc:spChg>
        <pc:spChg chg="mod">
          <ac:chgData name="Jorgensen, Rick" userId="22b7bd11-eb0f-413f-9bcb-9ce21ec7b0a8" providerId="ADAL" clId="{63C519A2-C2B2-47AC-828F-E429CD2FEDB2}" dt="2023-05-31T20:19:33.594" v="614" actId="20577"/>
          <ac:spMkLst>
            <pc:docMk/>
            <pc:sldMk cId="4062779282" sldId="388"/>
            <ac:spMk id="10" creationId="{9F84E2A2-11BF-6249-A2DF-0BE34D738A76}"/>
          </ac:spMkLst>
        </pc:spChg>
        <pc:spChg chg="mod">
          <ac:chgData name="Jorgensen, Rick" userId="22b7bd11-eb0f-413f-9bcb-9ce21ec7b0a8" providerId="ADAL" clId="{63C519A2-C2B2-47AC-828F-E429CD2FEDB2}" dt="2023-05-31T20:24:27.861" v="793" actId="1076"/>
          <ac:spMkLst>
            <pc:docMk/>
            <pc:sldMk cId="4062779282" sldId="388"/>
            <ac:spMk id="14" creationId="{BA4A3D44-CB1E-31F8-40DB-983C42780495}"/>
          </ac:spMkLst>
        </pc:spChg>
        <pc:spChg chg="mod">
          <ac:chgData name="Jorgensen, Rick" userId="22b7bd11-eb0f-413f-9bcb-9ce21ec7b0a8" providerId="ADAL" clId="{63C519A2-C2B2-47AC-828F-E429CD2FEDB2}" dt="2023-05-31T20:13:21.989" v="478" actId="14100"/>
          <ac:spMkLst>
            <pc:docMk/>
            <pc:sldMk cId="4062779282" sldId="388"/>
            <ac:spMk id="21" creationId="{1FEAA0BF-8295-DF43-12A9-167D156DA1E0}"/>
          </ac:spMkLst>
        </pc:spChg>
        <pc:spChg chg="mod">
          <ac:chgData name="Jorgensen, Rick" userId="22b7bd11-eb0f-413f-9bcb-9ce21ec7b0a8" providerId="ADAL" clId="{63C519A2-C2B2-47AC-828F-E429CD2FEDB2}" dt="2023-05-31T20:20:27.999" v="649" actId="20577"/>
          <ac:spMkLst>
            <pc:docMk/>
            <pc:sldMk cId="4062779282" sldId="388"/>
            <ac:spMk id="25" creationId="{43DF711F-4684-B34D-9236-D3A26D348F11}"/>
          </ac:spMkLst>
        </pc:spChg>
        <pc:spChg chg="mod">
          <ac:chgData name="Jorgensen, Rick" userId="22b7bd11-eb0f-413f-9bcb-9ce21ec7b0a8" providerId="ADAL" clId="{63C519A2-C2B2-47AC-828F-E429CD2FEDB2}" dt="2023-05-31T20:24:39.991" v="796" actId="1076"/>
          <ac:spMkLst>
            <pc:docMk/>
            <pc:sldMk cId="4062779282" sldId="388"/>
            <ac:spMk id="27" creationId="{ADE4A592-91FB-EC49-4BF3-E61E13A4240B}"/>
          </ac:spMkLst>
        </pc:spChg>
        <pc:spChg chg="mod">
          <ac:chgData name="Jorgensen, Rick" userId="22b7bd11-eb0f-413f-9bcb-9ce21ec7b0a8" providerId="ADAL" clId="{63C519A2-C2B2-47AC-828F-E429CD2FEDB2}" dt="2023-05-31T20:14:08.700" v="494"/>
          <ac:spMkLst>
            <pc:docMk/>
            <pc:sldMk cId="4062779282" sldId="388"/>
            <ac:spMk id="28" creationId="{BA0A6C9E-E597-8E16-09B9-36C3476748D7}"/>
          </ac:spMkLst>
        </pc:spChg>
        <pc:grpChg chg="add mod">
          <ac:chgData name="Jorgensen, Rick" userId="22b7bd11-eb0f-413f-9bcb-9ce21ec7b0a8" providerId="ADAL" clId="{63C519A2-C2B2-47AC-828F-E429CD2FEDB2}" dt="2023-05-31T20:12:59.895" v="471" actId="14100"/>
          <ac:grpSpMkLst>
            <pc:docMk/>
            <pc:sldMk cId="4062779282" sldId="388"/>
            <ac:grpSpMk id="4" creationId="{89654857-9093-6FF4-A799-9FA677057BCE}"/>
          </ac:grpSpMkLst>
        </pc:grpChg>
        <pc:grpChg chg="mod">
          <ac:chgData name="Jorgensen, Rick" userId="22b7bd11-eb0f-413f-9bcb-9ce21ec7b0a8" providerId="ADAL" clId="{63C519A2-C2B2-47AC-828F-E429CD2FEDB2}" dt="2023-05-31T20:12:36.293" v="465"/>
          <ac:grpSpMkLst>
            <pc:docMk/>
            <pc:sldMk cId="4062779282" sldId="388"/>
            <ac:grpSpMk id="11" creationId="{792C75F6-8D4F-6CBA-3784-856CD74B9041}"/>
          </ac:grpSpMkLst>
        </pc:grpChg>
        <pc:grpChg chg="del">
          <ac:chgData name="Jorgensen, Rick" userId="22b7bd11-eb0f-413f-9bcb-9ce21ec7b0a8" providerId="ADAL" clId="{63C519A2-C2B2-47AC-828F-E429CD2FEDB2}" dt="2023-05-31T20:10:46.604" v="451" actId="478"/>
          <ac:grpSpMkLst>
            <pc:docMk/>
            <pc:sldMk cId="4062779282" sldId="388"/>
            <ac:grpSpMk id="16" creationId="{63F365D8-0205-793D-706C-D33F1CECE77F}"/>
          </ac:grpSpMkLst>
        </pc:grpChg>
        <pc:grpChg chg="del">
          <ac:chgData name="Jorgensen, Rick" userId="22b7bd11-eb0f-413f-9bcb-9ce21ec7b0a8" providerId="ADAL" clId="{63C519A2-C2B2-47AC-828F-E429CD2FEDB2}" dt="2023-05-31T20:10:48.690" v="452" actId="478"/>
          <ac:grpSpMkLst>
            <pc:docMk/>
            <pc:sldMk cId="4062779282" sldId="388"/>
            <ac:grpSpMk id="18" creationId="{AA8F8FDF-372B-4B2F-5318-140F11DAFB8C}"/>
          </ac:grpSpMkLst>
        </pc:grpChg>
        <pc:grpChg chg="add mod">
          <ac:chgData name="Jorgensen, Rick" userId="22b7bd11-eb0f-413f-9bcb-9ce21ec7b0a8" providerId="ADAL" clId="{63C519A2-C2B2-47AC-828F-E429CD2FEDB2}" dt="2023-05-31T20:24:32.601" v="794" actId="1076"/>
          <ac:grpSpMkLst>
            <pc:docMk/>
            <pc:sldMk cId="4062779282" sldId="388"/>
            <ac:grpSpMk id="23" creationId="{A797A16D-B400-3AFE-582D-B3B07E0527FF}"/>
          </ac:grpSpMkLst>
        </pc:grpChg>
        <pc:grpChg chg="mod">
          <ac:chgData name="Jorgensen, Rick" userId="22b7bd11-eb0f-413f-9bcb-9ce21ec7b0a8" providerId="ADAL" clId="{63C519A2-C2B2-47AC-828F-E429CD2FEDB2}" dt="2023-05-31T20:14:08.700" v="494"/>
          <ac:grpSpMkLst>
            <pc:docMk/>
            <pc:sldMk cId="4062779282" sldId="388"/>
            <ac:grpSpMk id="24" creationId="{B11C2890-393C-504E-85EF-BF5246463C9C}"/>
          </ac:grpSpMkLst>
        </pc:grpChg>
        <pc:graphicFrameChg chg="add mod">
          <ac:chgData name="Jorgensen, Rick" userId="22b7bd11-eb0f-413f-9bcb-9ce21ec7b0a8" providerId="ADAL" clId="{63C519A2-C2B2-47AC-828F-E429CD2FEDB2}" dt="2023-05-31T20:12:03.996" v="463" actId="1076"/>
          <ac:graphicFrameMkLst>
            <pc:docMk/>
            <pc:sldMk cId="4062779282" sldId="388"/>
            <ac:graphicFrameMk id="2" creationId="{0260D794-FA24-4C5A-A475-CF5D3F36FABF}"/>
          </ac:graphicFrameMkLst>
        </pc:graphicFrameChg>
        <pc:graphicFrameChg chg="add mod">
          <ac:chgData name="Jorgensen, Rick" userId="22b7bd11-eb0f-413f-9bcb-9ce21ec7b0a8" providerId="ADAL" clId="{63C519A2-C2B2-47AC-828F-E429CD2FEDB2}" dt="2023-05-31T20:14:16.840" v="496"/>
          <ac:graphicFrameMkLst>
            <pc:docMk/>
            <pc:sldMk cId="4062779282" sldId="388"/>
            <ac:graphicFrameMk id="3" creationId="{2542508C-A729-43AB-8192-B88A73DEDB65}"/>
          </ac:graphicFrameMkLst>
        </pc:graphicFrameChg>
        <pc:graphicFrameChg chg="del">
          <ac:chgData name="Jorgensen, Rick" userId="22b7bd11-eb0f-413f-9bcb-9ce21ec7b0a8" providerId="ADAL" clId="{63C519A2-C2B2-47AC-828F-E429CD2FEDB2}" dt="2023-05-31T20:10:39.295" v="449" actId="478"/>
          <ac:graphicFrameMkLst>
            <pc:docMk/>
            <pc:sldMk cId="4062779282" sldId="388"/>
            <ac:graphicFrameMk id="5" creationId="{1A8EC719-D765-4ED2-911A-45F8286A6F59}"/>
          </ac:graphicFrameMkLst>
        </pc:graphicFrameChg>
        <pc:graphicFrameChg chg="del">
          <ac:chgData name="Jorgensen, Rick" userId="22b7bd11-eb0f-413f-9bcb-9ce21ec7b0a8" providerId="ADAL" clId="{63C519A2-C2B2-47AC-828F-E429CD2FEDB2}" dt="2023-05-31T20:10:43.043" v="450" actId="478"/>
          <ac:graphicFrameMkLst>
            <pc:docMk/>
            <pc:sldMk cId="4062779282" sldId="388"/>
            <ac:graphicFrameMk id="17" creationId="{30D15B10-EAD8-4021-B50E-8139CF87AA4A}"/>
          </ac:graphicFrameMkLst>
        </pc:graphicFrameChg>
        <pc:picChg chg="mod modCrop">
          <ac:chgData name="Jorgensen, Rick" userId="22b7bd11-eb0f-413f-9bcb-9ce21ec7b0a8" providerId="ADAL" clId="{63C519A2-C2B2-47AC-828F-E429CD2FEDB2}" dt="2023-05-31T20:24:22.377" v="792" actId="14100"/>
          <ac:picMkLst>
            <pc:docMk/>
            <pc:sldMk cId="4062779282" sldId="388"/>
            <ac:picMk id="12" creationId="{C86FE060-FAD6-9F74-32AC-D20A713D91F3}"/>
          </ac:picMkLst>
        </pc:picChg>
        <pc:picChg chg="mod">
          <ac:chgData name="Jorgensen, Rick" userId="22b7bd11-eb0f-413f-9bcb-9ce21ec7b0a8" providerId="ADAL" clId="{63C519A2-C2B2-47AC-828F-E429CD2FEDB2}" dt="2023-05-31T20:24:36.044" v="795" actId="1076"/>
          <ac:picMkLst>
            <pc:docMk/>
            <pc:sldMk cId="4062779282" sldId="388"/>
            <ac:picMk id="26" creationId="{4438DE1D-92E5-BD78-402D-3AEA4BCD3180}"/>
          </ac:picMkLst>
        </pc:picChg>
      </pc:sldChg>
      <pc:sldChg chg="modSp add mod ord">
        <pc:chgData name="Jorgensen, Rick" userId="22b7bd11-eb0f-413f-9bcb-9ce21ec7b0a8" providerId="ADAL" clId="{63C519A2-C2B2-47AC-828F-E429CD2FEDB2}" dt="2023-08-01T15:41:23.932" v="11998"/>
        <pc:sldMkLst>
          <pc:docMk/>
          <pc:sldMk cId="3056925330" sldId="389"/>
        </pc:sldMkLst>
        <pc:spChg chg="mod">
          <ac:chgData name="Jorgensen, Rick" userId="22b7bd11-eb0f-413f-9bcb-9ce21ec7b0a8" providerId="ADAL" clId="{63C519A2-C2B2-47AC-828F-E429CD2FEDB2}" dt="2023-07-17T14:57:56.058" v="6798" actId="20577"/>
          <ac:spMkLst>
            <pc:docMk/>
            <pc:sldMk cId="3056925330" sldId="389"/>
            <ac:spMk id="2" creationId="{00000000-0000-0000-0000-000000000000}"/>
          </ac:spMkLst>
        </pc:spChg>
        <pc:spChg chg="mod">
          <ac:chgData name="Jorgensen, Rick" userId="22b7bd11-eb0f-413f-9bcb-9ce21ec7b0a8" providerId="ADAL" clId="{63C519A2-C2B2-47AC-828F-E429CD2FEDB2}" dt="2023-07-31T20:40:56.856" v="10233" actId="20577"/>
          <ac:spMkLst>
            <pc:docMk/>
            <pc:sldMk cId="3056925330" sldId="389"/>
            <ac:spMk id="3" creationId="{00000000-0000-0000-0000-000000000000}"/>
          </ac:spMkLst>
        </pc:spChg>
      </pc:sldChg>
      <pc:sldChg chg="delSp modSp add mod ord">
        <pc:chgData name="Jorgensen, Rick" userId="22b7bd11-eb0f-413f-9bcb-9ce21ec7b0a8" providerId="ADAL" clId="{63C519A2-C2B2-47AC-828F-E429CD2FEDB2}" dt="2023-08-01T15:41:43.295" v="12002"/>
        <pc:sldMkLst>
          <pc:docMk/>
          <pc:sldMk cId="3756482471" sldId="390"/>
        </pc:sldMkLst>
        <pc:spChg chg="mod">
          <ac:chgData name="Jorgensen, Rick" userId="22b7bd11-eb0f-413f-9bcb-9ce21ec7b0a8" providerId="ADAL" clId="{63C519A2-C2B2-47AC-828F-E429CD2FEDB2}" dt="2023-07-17T14:58:04.245" v="6802" actId="20577"/>
          <ac:spMkLst>
            <pc:docMk/>
            <pc:sldMk cId="3756482471" sldId="390"/>
            <ac:spMk id="2" creationId="{00000000-0000-0000-0000-000000000000}"/>
          </ac:spMkLst>
        </pc:spChg>
        <pc:spChg chg="mod">
          <ac:chgData name="Jorgensen, Rick" userId="22b7bd11-eb0f-413f-9bcb-9ce21ec7b0a8" providerId="ADAL" clId="{63C519A2-C2B2-47AC-828F-E429CD2FEDB2}" dt="2023-05-31T20:23:23.937" v="784" actId="20577"/>
          <ac:spMkLst>
            <pc:docMk/>
            <pc:sldMk cId="3756482471" sldId="390"/>
            <ac:spMk id="3" creationId="{00000000-0000-0000-0000-000000000000}"/>
          </ac:spMkLst>
        </pc:spChg>
        <pc:spChg chg="del">
          <ac:chgData name="Jorgensen, Rick" userId="22b7bd11-eb0f-413f-9bcb-9ce21ec7b0a8" providerId="ADAL" clId="{63C519A2-C2B2-47AC-828F-E429CD2FEDB2}" dt="2023-05-31T20:18:29.216" v="558" actId="478"/>
          <ac:spMkLst>
            <pc:docMk/>
            <pc:sldMk cId="3756482471" sldId="390"/>
            <ac:spMk id="4" creationId="{937ABA8F-B000-5D92-5319-42E410F90C23}"/>
          </ac:spMkLst>
        </pc:spChg>
      </pc:sldChg>
      <pc:sldChg chg="modSp add mod">
        <pc:chgData name="Jorgensen, Rick" userId="22b7bd11-eb0f-413f-9bcb-9ce21ec7b0a8" providerId="ADAL" clId="{63C519A2-C2B2-47AC-828F-E429CD2FEDB2}" dt="2023-08-01T15:56:30.366" v="12243" actId="20577"/>
        <pc:sldMkLst>
          <pc:docMk/>
          <pc:sldMk cId="2295641252" sldId="391"/>
        </pc:sldMkLst>
        <pc:spChg chg="mod">
          <ac:chgData name="Jorgensen, Rick" userId="22b7bd11-eb0f-413f-9bcb-9ce21ec7b0a8" providerId="ADAL" clId="{63C519A2-C2B2-47AC-828F-E429CD2FEDB2}" dt="2023-08-01T15:56:30.366" v="12243" actId="20577"/>
          <ac:spMkLst>
            <pc:docMk/>
            <pc:sldMk cId="2295641252" sldId="391"/>
            <ac:spMk id="2" creationId="{00000000-0000-0000-0000-000000000000}"/>
          </ac:spMkLst>
        </pc:spChg>
        <pc:spChg chg="mod">
          <ac:chgData name="Jorgensen, Rick" userId="22b7bd11-eb0f-413f-9bcb-9ce21ec7b0a8" providerId="ADAL" clId="{63C519A2-C2B2-47AC-828F-E429CD2FEDB2}" dt="2023-07-31T20:47:12.004" v="10255" actId="20577"/>
          <ac:spMkLst>
            <pc:docMk/>
            <pc:sldMk cId="2295641252" sldId="391"/>
            <ac:spMk id="3" creationId="{00000000-0000-0000-0000-000000000000}"/>
          </ac:spMkLst>
        </pc:spChg>
      </pc:sldChg>
      <pc:sldChg chg="addSp delSp modSp add mod ord">
        <pc:chgData name="Jorgensen, Rick" userId="22b7bd11-eb0f-413f-9bcb-9ce21ec7b0a8" providerId="ADAL" clId="{63C519A2-C2B2-47AC-828F-E429CD2FEDB2}" dt="2023-08-01T15:55:36.166" v="12233"/>
        <pc:sldMkLst>
          <pc:docMk/>
          <pc:sldMk cId="230635334" sldId="392"/>
        </pc:sldMkLst>
        <pc:spChg chg="mod">
          <ac:chgData name="Jorgensen, Rick" userId="22b7bd11-eb0f-413f-9bcb-9ce21ec7b0a8" providerId="ADAL" clId="{63C519A2-C2B2-47AC-828F-E429CD2FEDB2}" dt="2023-06-05T15:26:14.322" v="969" actId="1076"/>
          <ac:spMkLst>
            <pc:docMk/>
            <pc:sldMk cId="230635334" sldId="392"/>
            <ac:spMk id="9" creationId="{16C98FF7-C9E9-8046-A859-D9A599468A34}"/>
          </ac:spMkLst>
        </pc:spChg>
        <pc:spChg chg="mod">
          <ac:chgData name="Jorgensen, Rick" userId="22b7bd11-eb0f-413f-9bcb-9ce21ec7b0a8" providerId="ADAL" clId="{63C519A2-C2B2-47AC-828F-E429CD2FEDB2}" dt="2023-06-05T15:26:14.322" v="969" actId="1076"/>
          <ac:spMkLst>
            <pc:docMk/>
            <pc:sldMk cId="230635334" sldId="392"/>
            <ac:spMk id="10" creationId="{9F84E2A2-11BF-6249-A2DF-0BE34D738A76}"/>
          </ac:spMkLst>
        </pc:spChg>
        <pc:spChg chg="add mod">
          <ac:chgData name="Jorgensen, Rick" userId="22b7bd11-eb0f-413f-9bcb-9ce21ec7b0a8" providerId="ADAL" clId="{63C519A2-C2B2-47AC-828F-E429CD2FEDB2}" dt="2023-06-05T15:26:14.322" v="969" actId="1076"/>
          <ac:spMkLst>
            <pc:docMk/>
            <pc:sldMk cId="230635334" sldId="392"/>
            <ac:spMk id="15" creationId="{D0BC4A18-9D32-73E9-AADD-E9497BF9BADD}"/>
          </ac:spMkLst>
        </pc:spChg>
        <pc:spChg chg="add mod">
          <ac:chgData name="Jorgensen, Rick" userId="22b7bd11-eb0f-413f-9bcb-9ce21ec7b0a8" providerId="ADAL" clId="{63C519A2-C2B2-47AC-828F-E429CD2FEDB2}" dt="2023-06-05T15:26:14.322" v="969" actId="1076"/>
          <ac:spMkLst>
            <pc:docMk/>
            <pc:sldMk cId="230635334" sldId="392"/>
            <ac:spMk id="17" creationId="{9DF35772-8786-2BDE-86C5-5759E33DDDEE}"/>
          </ac:spMkLst>
        </pc:spChg>
        <pc:spChg chg="add mod">
          <ac:chgData name="Jorgensen, Rick" userId="22b7bd11-eb0f-413f-9bcb-9ce21ec7b0a8" providerId="ADAL" clId="{63C519A2-C2B2-47AC-828F-E429CD2FEDB2}" dt="2023-06-05T15:27:08.614" v="981" actId="20577"/>
          <ac:spMkLst>
            <pc:docMk/>
            <pc:sldMk cId="230635334" sldId="392"/>
            <ac:spMk id="20" creationId="{1C2B0E8E-0479-101C-75EE-73E58A45CF00}"/>
          </ac:spMkLst>
        </pc:spChg>
        <pc:spChg chg="mod">
          <ac:chgData name="Jorgensen, Rick" userId="22b7bd11-eb0f-413f-9bcb-9ce21ec7b0a8" providerId="ADAL" clId="{63C519A2-C2B2-47AC-828F-E429CD2FEDB2}" dt="2023-07-17T14:58:12.180" v="6808" actId="20577"/>
          <ac:spMkLst>
            <pc:docMk/>
            <pc:sldMk cId="230635334" sldId="392"/>
            <ac:spMk id="25" creationId="{43DF711F-4684-B34D-9236-D3A26D348F11}"/>
          </ac:spMkLst>
        </pc:spChg>
        <pc:spChg chg="add mod">
          <ac:chgData name="Jorgensen, Rick" userId="22b7bd11-eb0f-413f-9bcb-9ce21ec7b0a8" providerId="ADAL" clId="{63C519A2-C2B2-47AC-828F-E429CD2FEDB2}" dt="2023-06-05T15:28:44.299" v="1003" actId="20577"/>
          <ac:spMkLst>
            <pc:docMk/>
            <pc:sldMk cId="230635334" sldId="392"/>
            <ac:spMk id="29" creationId="{DE561AC9-9051-7D8D-2414-DE52D32050CB}"/>
          </ac:spMkLst>
        </pc:spChg>
        <pc:spChg chg="add mod">
          <ac:chgData name="Jorgensen, Rick" userId="22b7bd11-eb0f-413f-9bcb-9ce21ec7b0a8" providerId="ADAL" clId="{63C519A2-C2B2-47AC-828F-E429CD2FEDB2}" dt="2023-06-05T15:28:46.768" v="1005" actId="20577"/>
          <ac:spMkLst>
            <pc:docMk/>
            <pc:sldMk cId="230635334" sldId="392"/>
            <ac:spMk id="31" creationId="{9A778661-5F19-F4DD-6752-4F8F6DE5D2B4}"/>
          </ac:spMkLst>
        </pc:spChg>
        <pc:spChg chg="add mod">
          <ac:chgData name="Jorgensen, Rick" userId="22b7bd11-eb0f-413f-9bcb-9ce21ec7b0a8" providerId="ADAL" clId="{63C519A2-C2B2-47AC-828F-E429CD2FEDB2}" dt="2023-06-05T15:29:17.036" v="1015" actId="20577"/>
          <ac:spMkLst>
            <pc:docMk/>
            <pc:sldMk cId="230635334" sldId="392"/>
            <ac:spMk id="33" creationId="{2ECD6DA8-6B79-76BD-7C86-B0AE7707311B}"/>
          </ac:spMkLst>
        </pc:spChg>
        <pc:spChg chg="add mod">
          <ac:chgData name="Jorgensen, Rick" userId="22b7bd11-eb0f-413f-9bcb-9ce21ec7b0a8" providerId="ADAL" clId="{63C519A2-C2B2-47AC-828F-E429CD2FEDB2}" dt="2023-06-05T15:34:56.449" v="1317" actId="1076"/>
          <ac:spMkLst>
            <pc:docMk/>
            <pc:sldMk cId="230635334" sldId="392"/>
            <ac:spMk id="34" creationId="{12504D40-533E-2535-74D3-B8A4BECC25DD}"/>
          </ac:spMkLst>
        </pc:spChg>
        <pc:grpChg chg="del">
          <ac:chgData name="Jorgensen, Rick" userId="22b7bd11-eb0f-413f-9bcb-9ce21ec7b0a8" providerId="ADAL" clId="{63C519A2-C2B2-47AC-828F-E429CD2FEDB2}" dt="2023-06-05T15:16:58.210" v="922" actId="478"/>
          <ac:grpSpMkLst>
            <pc:docMk/>
            <pc:sldMk cId="230635334" sldId="392"/>
            <ac:grpSpMk id="4" creationId="{89654857-9093-6FF4-A799-9FA677057BCE}"/>
          </ac:grpSpMkLst>
        </pc:grpChg>
        <pc:grpChg chg="del">
          <ac:chgData name="Jorgensen, Rick" userId="22b7bd11-eb0f-413f-9bcb-9ce21ec7b0a8" providerId="ADAL" clId="{63C519A2-C2B2-47AC-828F-E429CD2FEDB2}" dt="2023-06-05T15:16:57.218" v="921" actId="478"/>
          <ac:grpSpMkLst>
            <pc:docMk/>
            <pc:sldMk cId="230635334" sldId="392"/>
            <ac:grpSpMk id="23" creationId="{A797A16D-B400-3AFE-582D-B3B07E0527FF}"/>
          </ac:grpSpMkLst>
        </pc:grpChg>
        <pc:graphicFrameChg chg="del">
          <ac:chgData name="Jorgensen, Rick" userId="22b7bd11-eb0f-413f-9bcb-9ce21ec7b0a8" providerId="ADAL" clId="{63C519A2-C2B2-47AC-828F-E429CD2FEDB2}" dt="2023-06-05T15:16:54.203" v="919" actId="478"/>
          <ac:graphicFrameMkLst>
            <pc:docMk/>
            <pc:sldMk cId="230635334" sldId="392"/>
            <ac:graphicFrameMk id="2" creationId="{0260D794-FA24-4C5A-A475-CF5D3F36FABF}"/>
          </ac:graphicFrameMkLst>
        </pc:graphicFrameChg>
        <pc:graphicFrameChg chg="del">
          <ac:chgData name="Jorgensen, Rick" userId="22b7bd11-eb0f-413f-9bcb-9ce21ec7b0a8" providerId="ADAL" clId="{63C519A2-C2B2-47AC-828F-E429CD2FEDB2}" dt="2023-06-05T15:16:55.352" v="920" actId="478"/>
          <ac:graphicFrameMkLst>
            <pc:docMk/>
            <pc:sldMk cId="230635334" sldId="392"/>
            <ac:graphicFrameMk id="3" creationId="{2542508C-A729-43AB-8192-B88A73DEDB65}"/>
          </ac:graphicFrameMkLst>
        </pc:graphicFrameChg>
        <pc:picChg chg="add mod">
          <ac:chgData name="Jorgensen, Rick" userId="22b7bd11-eb0f-413f-9bcb-9ce21ec7b0a8" providerId="ADAL" clId="{63C519A2-C2B2-47AC-828F-E429CD2FEDB2}" dt="2023-06-05T15:26:14.322" v="969" actId="1076"/>
          <ac:picMkLst>
            <pc:docMk/>
            <pc:sldMk cId="230635334" sldId="392"/>
            <ac:picMk id="6" creationId="{5CCBC0C0-B353-606D-C2A5-14DEB2FDD88F}"/>
          </ac:picMkLst>
        </pc:picChg>
        <pc:picChg chg="add mod">
          <ac:chgData name="Jorgensen, Rick" userId="22b7bd11-eb0f-413f-9bcb-9ce21ec7b0a8" providerId="ADAL" clId="{63C519A2-C2B2-47AC-828F-E429CD2FEDB2}" dt="2023-06-05T15:26:14.322" v="969" actId="1076"/>
          <ac:picMkLst>
            <pc:docMk/>
            <pc:sldMk cId="230635334" sldId="392"/>
            <ac:picMk id="8" creationId="{4BCD7F75-4DEA-72D3-623D-FBA9466B798E}"/>
          </ac:picMkLst>
        </pc:picChg>
        <pc:picChg chg="add mod">
          <ac:chgData name="Jorgensen, Rick" userId="22b7bd11-eb0f-413f-9bcb-9ce21ec7b0a8" providerId="ADAL" clId="{63C519A2-C2B2-47AC-828F-E429CD2FEDB2}" dt="2023-06-05T15:26:14.322" v="969" actId="1076"/>
          <ac:picMkLst>
            <pc:docMk/>
            <pc:sldMk cId="230635334" sldId="392"/>
            <ac:picMk id="13" creationId="{130CDF64-1BA9-7830-72EA-EB77C091619A}"/>
          </ac:picMkLst>
        </pc:picChg>
        <pc:picChg chg="add mod">
          <ac:chgData name="Jorgensen, Rick" userId="22b7bd11-eb0f-413f-9bcb-9ce21ec7b0a8" providerId="ADAL" clId="{63C519A2-C2B2-47AC-828F-E429CD2FEDB2}" dt="2023-06-05T15:26:14.322" v="969" actId="1076"/>
          <ac:picMkLst>
            <pc:docMk/>
            <pc:sldMk cId="230635334" sldId="392"/>
            <ac:picMk id="16" creationId="{381542EA-FDC2-253C-2D47-68C208ECD4B7}"/>
          </ac:picMkLst>
        </pc:picChg>
        <pc:picChg chg="add mod">
          <ac:chgData name="Jorgensen, Rick" userId="22b7bd11-eb0f-413f-9bcb-9ce21ec7b0a8" providerId="ADAL" clId="{63C519A2-C2B2-47AC-828F-E429CD2FEDB2}" dt="2023-06-05T15:26:54.323" v="977" actId="688"/>
          <ac:picMkLst>
            <pc:docMk/>
            <pc:sldMk cId="230635334" sldId="392"/>
            <ac:picMk id="19" creationId="{2CE31D1C-7BCE-E665-97CF-DA509A4D8AB2}"/>
          </ac:picMkLst>
        </pc:picChg>
        <pc:picChg chg="add mod">
          <ac:chgData name="Jorgensen, Rick" userId="22b7bd11-eb0f-413f-9bcb-9ce21ec7b0a8" providerId="ADAL" clId="{63C519A2-C2B2-47AC-828F-E429CD2FEDB2}" dt="2023-06-05T15:27:29.422" v="987" actId="1076"/>
          <ac:picMkLst>
            <pc:docMk/>
            <pc:sldMk cId="230635334" sldId="392"/>
            <ac:picMk id="22" creationId="{541AC162-61A4-0E8E-9291-83E78511458B}"/>
          </ac:picMkLst>
        </pc:picChg>
        <pc:picChg chg="add mod">
          <ac:chgData name="Jorgensen, Rick" userId="22b7bd11-eb0f-413f-9bcb-9ce21ec7b0a8" providerId="ADAL" clId="{63C519A2-C2B2-47AC-828F-E429CD2FEDB2}" dt="2023-06-05T15:28:28.227" v="997" actId="1076"/>
          <ac:picMkLst>
            <pc:docMk/>
            <pc:sldMk cId="230635334" sldId="392"/>
            <ac:picMk id="30" creationId="{BBDBA7F6-D1CA-C3C3-D029-8667ED0244A8}"/>
          </ac:picMkLst>
        </pc:picChg>
        <pc:picChg chg="add mod">
          <ac:chgData name="Jorgensen, Rick" userId="22b7bd11-eb0f-413f-9bcb-9ce21ec7b0a8" providerId="ADAL" clId="{63C519A2-C2B2-47AC-828F-E429CD2FEDB2}" dt="2023-06-05T15:29:10.015" v="1011" actId="1076"/>
          <ac:picMkLst>
            <pc:docMk/>
            <pc:sldMk cId="230635334" sldId="392"/>
            <ac:picMk id="32" creationId="{F648B11E-F922-262D-5CC0-22225E15B07E}"/>
          </ac:picMkLst>
        </pc:picChg>
      </pc:sldChg>
      <pc:sldChg chg="modSp add del mod">
        <pc:chgData name="Jorgensen, Rick" userId="22b7bd11-eb0f-413f-9bcb-9ce21ec7b0a8" providerId="ADAL" clId="{63C519A2-C2B2-47AC-828F-E429CD2FEDB2}" dt="2023-06-05T15:16:45.196" v="915" actId="47"/>
        <pc:sldMkLst>
          <pc:docMk/>
          <pc:sldMk cId="3448690057" sldId="392"/>
        </pc:sldMkLst>
        <pc:spChg chg="mod">
          <ac:chgData name="Jorgensen, Rick" userId="22b7bd11-eb0f-413f-9bcb-9ce21ec7b0a8" providerId="ADAL" clId="{63C519A2-C2B2-47AC-828F-E429CD2FEDB2}" dt="2023-06-05T15:16:37.711" v="914" actId="20577"/>
          <ac:spMkLst>
            <pc:docMk/>
            <pc:sldMk cId="3448690057" sldId="392"/>
            <ac:spMk id="2" creationId="{00000000-0000-0000-0000-000000000000}"/>
          </ac:spMkLst>
        </pc:spChg>
      </pc:sldChg>
      <pc:sldChg chg="modSp add mod ord">
        <pc:chgData name="Jorgensen, Rick" userId="22b7bd11-eb0f-413f-9bcb-9ce21ec7b0a8" providerId="ADAL" clId="{63C519A2-C2B2-47AC-828F-E429CD2FEDB2}" dt="2023-08-01T15:55:36.166" v="12233"/>
        <pc:sldMkLst>
          <pc:docMk/>
          <pc:sldMk cId="836877954" sldId="393"/>
        </pc:sldMkLst>
        <pc:spChg chg="mod">
          <ac:chgData name="Jorgensen, Rick" userId="22b7bd11-eb0f-413f-9bcb-9ce21ec7b0a8" providerId="ADAL" clId="{63C519A2-C2B2-47AC-828F-E429CD2FEDB2}" dt="2023-07-17T14:58:14.862" v="6810" actId="20577"/>
          <ac:spMkLst>
            <pc:docMk/>
            <pc:sldMk cId="836877954" sldId="393"/>
            <ac:spMk id="2" creationId="{00000000-0000-0000-0000-000000000000}"/>
          </ac:spMkLst>
        </pc:spChg>
        <pc:spChg chg="mod">
          <ac:chgData name="Jorgensen, Rick" userId="22b7bd11-eb0f-413f-9bcb-9ce21ec7b0a8" providerId="ADAL" clId="{63C519A2-C2B2-47AC-828F-E429CD2FEDB2}" dt="2023-06-05T15:37:38.808" v="1492" actId="20577"/>
          <ac:spMkLst>
            <pc:docMk/>
            <pc:sldMk cId="836877954" sldId="393"/>
            <ac:spMk id="3" creationId="{00000000-0000-0000-0000-000000000000}"/>
          </ac:spMkLst>
        </pc:spChg>
      </pc:sldChg>
      <pc:sldChg chg="addSp delSp modSp add mod ord modNotesTx">
        <pc:chgData name="Jorgensen, Rick" userId="22b7bd11-eb0f-413f-9bcb-9ce21ec7b0a8" providerId="ADAL" clId="{63C519A2-C2B2-47AC-828F-E429CD2FEDB2}" dt="2023-08-01T15:32:39.036" v="11723"/>
        <pc:sldMkLst>
          <pc:docMk/>
          <pc:sldMk cId="3513125160" sldId="394"/>
        </pc:sldMkLst>
        <pc:spChg chg="add del mod">
          <ac:chgData name="Jorgensen, Rick" userId="22b7bd11-eb0f-413f-9bcb-9ce21ec7b0a8" providerId="ADAL" clId="{63C519A2-C2B2-47AC-828F-E429CD2FEDB2}" dt="2023-08-01T15:29:02.877" v="11645" actId="478"/>
          <ac:spMkLst>
            <pc:docMk/>
            <pc:sldMk cId="3513125160" sldId="394"/>
            <ac:spMk id="2" creationId="{0BC507F4-61D9-752F-A4DA-E6BD93E53638}"/>
          </ac:spMkLst>
        </pc:spChg>
        <pc:spChg chg="mod">
          <ac:chgData name="Jorgensen, Rick" userId="22b7bd11-eb0f-413f-9bcb-9ce21ec7b0a8" providerId="ADAL" clId="{63C519A2-C2B2-47AC-828F-E429CD2FEDB2}" dt="2023-06-08T20:42:00.465" v="2452" actId="1076"/>
          <ac:spMkLst>
            <pc:docMk/>
            <pc:sldMk cId="3513125160" sldId="394"/>
            <ac:spMk id="9" creationId="{16C98FF7-C9E9-8046-A859-D9A599468A34}"/>
          </ac:spMkLst>
        </pc:spChg>
        <pc:spChg chg="mod">
          <ac:chgData name="Jorgensen, Rick" userId="22b7bd11-eb0f-413f-9bcb-9ce21ec7b0a8" providerId="ADAL" clId="{63C519A2-C2B2-47AC-828F-E429CD2FEDB2}" dt="2023-06-08T20:42:00.465" v="2452" actId="1076"/>
          <ac:spMkLst>
            <pc:docMk/>
            <pc:sldMk cId="3513125160" sldId="394"/>
            <ac:spMk id="10" creationId="{9F84E2A2-11BF-6249-A2DF-0BE34D738A76}"/>
          </ac:spMkLst>
        </pc:spChg>
        <pc:spChg chg="mod">
          <ac:chgData name="Jorgensen, Rick" userId="22b7bd11-eb0f-413f-9bcb-9ce21ec7b0a8" providerId="ADAL" clId="{63C519A2-C2B2-47AC-828F-E429CD2FEDB2}" dt="2023-06-08T20:42:00.465" v="2452" actId="1076"/>
          <ac:spMkLst>
            <pc:docMk/>
            <pc:sldMk cId="3513125160" sldId="394"/>
            <ac:spMk id="15" creationId="{D0BC4A18-9D32-73E9-AADD-E9497BF9BADD}"/>
          </ac:spMkLst>
        </pc:spChg>
        <pc:spChg chg="mod">
          <ac:chgData name="Jorgensen, Rick" userId="22b7bd11-eb0f-413f-9bcb-9ce21ec7b0a8" providerId="ADAL" clId="{63C519A2-C2B2-47AC-828F-E429CD2FEDB2}" dt="2023-06-08T20:42:00.465" v="2452" actId="1076"/>
          <ac:spMkLst>
            <pc:docMk/>
            <pc:sldMk cId="3513125160" sldId="394"/>
            <ac:spMk id="17" creationId="{9DF35772-8786-2BDE-86C5-5759E33DDDEE}"/>
          </ac:spMkLst>
        </pc:spChg>
        <pc:spChg chg="del mod">
          <ac:chgData name="Jorgensen, Rick" userId="22b7bd11-eb0f-413f-9bcb-9ce21ec7b0a8" providerId="ADAL" clId="{63C519A2-C2B2-47AC-828F-E429CD2FEDB2}" dt="2023-06-08T20:41:49.609" v="2448" actId="478"/>
          <ac:spMkLst>
            <pc:docMk/>
            <pc:sldMk cId="3513125160" sldId="394"/>
            <ac:spMk id="20" creationId="{1C2B0E8E-0479-101C-75EE-73E58A45CF00}"/>
          </ac:spMkLst>
        </pc:spChg>
        <pc:spChg chg="mod">
          <ac:chgData name="Jorgensen, Rick" userId="22b7bd11-eb0f-413f-9bcb-9ce21ec7b0a8" providerId="ADAL" clId="{63C519A2-C2B2-47AC-828F-E429CD2FEDB2}" dt="2023-06-28T15:48:10.262" v="6167" actId="20577"/>
          <ac:spMkLst>
            <pc:docMk/>
            <pc:sldMk cId="3513125160" sldId="394"/>
            <ac:spMk id="25" creationId="{43DF711F-4684-B34D-9236-D3A26D348F11}"/>
          </ac:spMkLst>
        </pc:spChg>
        <pc:spChg chg="del mod">
          <ac:chgData name="Jorgensen, Rick" userId="22b7bd11-eb0f-413f-9bcb-9ce21ec7b0a8" providerId="ADAL" clId="{63C519A2-C2B2-47AC-828F-E429CD2FEDB2}" dt="2023-06-08T20:41:51.658" v="2449" actId="478"/>
          <ac:spMkLst>
            <pc:docMk/>
            <pc:sldMk cId="3513125160" sldId="394"/>
            <ac:spMk id="29" creationId="{DE561AC9-9051-7D8D-2414-DE52D32050CB}"/>
          </ac:spMkLst>
        </pc:spChg>
        <pc:spChg chg="add del mod">
          <ac:chgData name="Jorgensen, Rick" userId="22b7bd11-eb0f-413f-9bcb-9ce21ec7b0a8" providerId="ADAL" clId="{63C519A2-C2B2-47AC-828F-E429CD2FEDB2}" dt="2023-06-08T20:20:24.824" v="2165" actId="478"/>
          <ac:spMkLst>
            <pc:docMk/>
            <pc:sldMk cId="3513125160" sldId="394"/>
            <ac:spMk id="30" creationId="{9BDEEF25-1E47-1EAF-87BC-5BD1E9B40252}"/>
          </ac:spMkLst>
        </pc:spChg>
        <pc:spChg chg="del mod">
          <ac:chgData name="Jorgensen, Rick" userId="22b7bd11-eb0f-413f-9bcb-9ce21ec7b0a8" providerId="ADAL" clId="{63C519A2-C2B2-47AC-828F-E429CD2FEDB2}" dt="2023-06-08T19:57:00.004" v="2009" actId="478"/>
          <ac:spMkLst>
            <pc:docMk/>
            <pc:sldMk cId="3513125160" sldId="394"/>
            <ac:spMk id="31" creationId="{9A778661-5F19-F4DD-6752-4F8F6DE5D2B4}"/>
          </ac:spMkLst>
        </pc:spChg>
        <pc:spChg chg="add mod">
          <ac:chgData name="Jorgensen, Rick" userId="22b7bd11-eb0f-413f-9bcb-9ce21ec7b0a8" providerId="ADAL" clId="{63C519A2-C2B2-47AC-828F-E429CD2FEDB2}" dt="2023-06-08T20:42:00.465" v="2452" actId="1076"/>
          <ac:spMkLst>
            <pc:docMk/>
            <pc:sldMk cId="3513125160" sldId="394"/>
            <ac:spMk id="32" creationId="{4CF0541F-3412-06E7-0866-3D9F5502D1A2}"/>
          </ac:spMkLst>
        </pc:spChg>
        <pc:spChg chg="del">
          <ac:chgData name="Jorgensen, Rick" userId="22b7bd11-eb0f-413f-9bcb-9ce21ec7b0a8" providerId="ADAL" clId="{63C519A2-C2B2-47AC-828F-E429CD2FEDB2}" dt="2023-06-08T19:57:50.912" v="2022" actId="478"/>
          <ac:spMkLst>
            <pc:docMk/>
            <pc:sldMk cId="3513125160" sldId="394"/>
            <ac:spMk id="33" creationId="{2ECD6DA8-6B79-76BD-7C86-B0AE7707311B}"/>
          </ac:spMkLst>
        </pc:spChg>
        <pc:spChg chg="del mod">
          <ac:chgData name="Jorgensen, Rick" userId="22b7bd11-eb0f-413f-9bcb-9ce21ec7b0a8" providerId="ADAL" clId="{63C519A2-C2B2-47AC-828F-E429CD2FEDB2}" dt="2023-06-08T19:44:53.457" v="1836" actId="478"/>
          <ac:spMkLst>
            <pc:docMk/>
            <pc:sldMk cId="3513125160" sldId="394"/>
            <ac:spMk id="34" creationId="{12504D40-533E-2535-74D3-B8A4BECC25DD}"/>
          </ac:spMkLst>
        </pc:spChg>
        <pc:spChg chg="add mod">
          <ac:chgData name="Jorgensen, Rick" userId="22b7bd11-eb0f-413f-9bcb-9ce21ec7b0a8" providerId="ADAL" clId="{63C519A2-C2B2-47AC-828F-E429CD2FEDB2}" dt="2023-06-08T20:42:00.465" v="2452" actId="1076"/>
          <ac:spMkLst>
            <pc:docMk/>
            <pc:sldMk cId="3513125160" sldId="394"/>
            <ac:spMk id="35" creationId="{764319EC-7103-84E4-7E64-529EAD99F69B}"/>
          </ac:spMkLst>
        </pc:spChg>
        <pc:spChg chg="add mod">
          <ac:chgData name="Jorgensen, Rick" userId="22b7bd11-eb0f-413f-9bcb-9ce21ec7b0a8" providerId="ADAL" clId="{63C519A2-C2B2-47AC-828F-E429CD2FEDB2}" dt="2023-06-08T20:42:00.465" v="2452" actId="1076"/>
          <ac:spMkLst>
            <pc:docMk/>
            <pc:sldMk cId="3513125160" sldId="394"/>
            <ac:spMk id="36" creationId="{9698F0FB-4FA1-BFFF-3496-88B5DEAA214D}"/>
          </ac:spMkLst>
        </pc:spChg>
        <pc:spChg chg="add del mod">
          <ac:chgData name="Jorgensen, Rick" userId="22b7bd11-eb0f-413f-9bcb-9ce21ec7b0a8" providerId="ADAL" clId="{63C519A2-C2B2-47AC-828F-E429CD2FEDB2}" dt="2023-06-08T20:41:54.187" v="2451" actId="478"/>
          <ac:spMkLst>
            <pc:docMk/>
            <pc:sldMk cId="3513125160" sldId="394"/>
            <ac:spMk id="37" creationId="{19F0EEA5-55EE-DC86-5C44-FD3C0861138F}"/>
          </ac:spMkLst>
        </pc:spChg>
        <pc:spChg chg="add del mod">
          <ac:chgData name="Jorgensen, Rick" userId="22b7bd11-eb0f-413f-9bcb-9ce21ec7b0a8" providerId="ADAL" clId="{63C519A2-C2B2-47AC-828F-E429CD2FEDB2}" dt="2023-06-08T20:41:53.065" v="2450" actId="478"/>
          <ac:spMkLst>
            <pc:docMk/>
            <pc:sldMk cId="3513125160" sldId="394"/>
            <ac:spMk id="38" creationId="{D4FE6DCA-6A84-907A-7CEB-F9A2B7BB321C}"/>
          </ac:spMkLst>
        </pc:spChg>
        <pc:spChg chg="add del mod">
          <ac:chgData name="Jorgensen, Rick" userId="22b7bd11-eb0f-413f-9bcb-9ce21ec7b0a8" providerId="ADAL" clId="{63C519A2-C2B2-47AC-828F-E429CD2FEDB2}" dt="2023-06-08T20:01:14.550" v="2045"/>
          <ac:spMkLst>
            <pc:docMk/>
            <pc:sldMk cId="3513125160" sldId="394"/>
            <ac:spMk id="59" creationId="{D34BEF26-31D9-96B1-E8A8-33C32781D967}"/>
          </ac:spMkLst>
        </pc:spChg>
        <pc:spChg chg="add del mod">
          <ac:chgData name="Jorgensen, Rick" userId="22b7bd11-eb0f-413f-9bcb-9ce21ec7b0a8" providerId="ADAL" clId="{63C519A2-C2B2-47AC-828F-E429CD2FEDB2}" dt="2023-06-08T20:01:14.550" v="2045"/>
          <ac:spMkLst>
            <pc:docMk/>
            <pc:sldMk cId="3513125160" sldId="394"/>
            <ac:spMk id="60" creationId="{DF171A37-6A69-B479-E9F6-03B722E62A06}"/>
          </ac:spMkLst>
        </pc:spChg>
        <pc:spChg chg="add del mod">
          <ac:chgData name="Jorgensen, Rick" userId="22b7bd11-eb0f-413f-9bcb-9ce21ec7b0a8" providerId="ADAL" clId="{63C519A2-C2B2-47AC-828F-E429CD2FEDB2}" dt="2023-06-08T20:01:14.550" v="2045"/>
          <ac:spMkLst>
            <pc:docMk/>
            <pc:sldMk cId="3513125160" sldId="394"/>
            <ac:spMk id="61" creationId="{AD9EE47C-E997-DBAD-743C-F7FCD800BFB7}"/>
          </ac:spMkLst>
        </pc:spChg>
        <pc:spChg chg="add del mod">
          <ac:chgData name="Jorgensen, Rick" userId="22b7bd11-eb0f-413f-9bcb-9ce21ec7b0a8" providerId="ADAL" clId="{63C519A2-C2B2-47AC-828F-E429CD2FEDB2}" dt="2023-06-08T20:01:14.550" v="2045"/>
          <ac:spMkLst>
            <pc:docMk/>
            <pc:sldMk cId="3513125160" sldId="394"/>
            <ac:spMk id="62" creationId="{51955378-7CDA-51BB-C36D-27D2D327EC21}"/>
          </ac:spMkLst>
        </pc:spChg>
        <pc:spChg chg="add del mod">
          <ac:chgData name="Jorgensen, Rick" userId="22b7bd11-eb0f-413f-9bcb-9ce21ec7b0a8" providerId="ADAL" clId="{63C519A2-C2B2-47AC-828F-E429CD2FEDB2}" dt="2023-06-08T20:01:14.550" v="2045"/>
          <ac:spMkLst>
            <pc:docMk/>
            <pc:sldMk cId="3513125160" sldId="394"/>
            <ac:spMk id="63" creationId="{F7A7CDBE-C715-A2C7-7070-0612E9AEC873}"/>
          </ac:spMkLst>
        </pc:spChg>
        <pc:spChg chg="add del mod">
          <ac:chgData name="Jorgensen, Rick" userId="22b7bd11-eb0f-413f-9bcb-9ce21ec7b0a8" providerId="ADAL" clId="{63C519A2-C2B2-47AC-828F-E429CD2FEDB2}" dt="2023-06-08T20:01:14.550" v="2045"/>
          <ac:spMkLst>
            <pc:docMk/>
            <pc:sldMk cId="3513125160" sldId="394"/>
            <ac:spMk id="64" creationId="{7AB70765-7353-BB8D-B162-C88B71798A5B}"/>
          </ac:spMkLst>
        </pc:spChg>
        <pc:spChg chg="add del mod">
          <ac:chgData name="Jorgensen, Rick" userId="22b7bd11-eb0f-413f-9bcb-9ce21ec7b0a8" providerId="ADAL" clId="{63C519A2-C2B2-47AC-828F-E429CD2FEDB2}" dt="2023-06-08T20:01:35.521" v="2049" actId="478"/>
          <ac:spMkLst>
            <pc:docMk/>
            <pc:sldMk cId="3513125160" sldId="394"/>
            <ac:spMk id="71" creationId="{2273B229-FA0B-7832-BC3E-13B46F1E7E05}"/>
          </ac:spMkLst>
        </pc:spChg>
        <pc:spChg chg="add del mod">
          <ac:chgData name="Jorgensen, Rick" userId="22b7bd11-eb0f-413f-9bcb-9ce21ec7b0a8" providerId="ADAL" clId="{63C519A2-C2B2-47AC-828F-E429CD2FEDB2}" dt="2023-06-08T20:01:35.521" v="2049" actId="478"/>
          <ac:spMkLst>
            <pc:docMk/>
            <pc:sldMk cId="3513125160" sldId="394"/>
            <ac:spMk id="72" creationId="{20407092-DA2F-6BD6-89D2-969E80FDEB27}"/>
          </ac:spMkLst>
        </pc:spChg>
        <pc:spChg chg="add del mod">
          <ac:chgData name="Jorgensen, Rick" userId="22b7bd11-eb0f-413f-9bcb-9ce21ec7b0a8" providerId="ADAL" clId="{63C519A2-C2B2-47AC-828F-E429CD2FEDB2}" dt="2023-06-08T20:01:35.521" v="2049" actId="478"/>
          <ac:spMkLst>
            <pc:docMk/>
            <pc:sldMk cId="3513125160" sldId="394"/>
            <ac:spMk id="73" creationId="{B8363532-5284-EE85-9BC2-9095662A5987}"/>
          </ac:spMkLst>
        </pc:spChg>
        <pc:spChg chg="add del mod">
          <ac:chgData name="Jorgensen, Rick" userId="22b7bd11-eb0f-413f-9bcb-9ce21ec7b0a8" providerId="ADAL" clId="{63C519A2-C2B2-47AC-828F-E429CD2FEDB2}" dt="2023-06-08T20:01:35.521" v="2049" actId="478"/>
          <ac:spMkLst>
            <pc:docMk/>
            <pc:sldMk cId="3513125160" sldId="394"/>
            <ac:spMk id="74" creationId="{893BF81B-1CFB-FED0-AB9A-FFDDFC94F955}"/>
          </ac:spMkLst>
        </pc:spChg>
        <pc:spChg chg="add del mod">
          <ac:chgData name="Jorgensen, Rick" userId="22b7bd11-eb0f-413f-9bcb-9ce21ec7b0a8" providerId="ADAL" clId="{63C519A2-C2B2-47AC-828F-E429CD2FEDB2}" dt="2023-06-08T20:01:35.521" v="2049" actId="478"/>
          <ac:spMkLst>
            <pc:docMk/>
            <pc:sldMk cId="3513125160" sldId="394"/>
            <ac:spMk id="75" creationId="{FF17F11A-DBDC-B5B0-8BBD-6C656C63F3E3}"/>
          </ac:spMkLst>
        </pc:spChg>
        <pc:spChg chg="add del mod">
          <ac:chgData name="Jorgensen, Rick" userId="22b7bd11-eb0f-413f-9bcb-9ce21ec7b0a8" providerId="ADAL" clId="{63C519A2-C2B2-47AC-828F-E429CD2FEDB2}" dt="2023-06-08T20:01:35.521" v="2049" actId="478"/>
          <ac:spMkLst>
            <pc:docMk/>
            <pc:sldMk cId="3513125160" sldId="394"/>
            <ac:spMk id="76" creationId="{F21F2539-5799-177D-DCF9-3DCB6B58F087}"/>
          </ac:spMkLst>
        </pc:spChg>
        <pc:spChg chg="add mod">
          <ac:chgData name="Jorgensen, Rick" userId="22b7bd11-eb0f-413f-9bcb-9ce21ec7b0a8" providerId="ADAL" clId="{63C519A2-C2B2-47AC-828F-E429CD2FEDB2}" dt="2023-06-08T20:42:00.465" v="2452" actId="1076"/>
          <ac:spMkLst>
            <pc:docMk/>
            <pc:sldMk cId="3513125160" sldId="394"/>
            <ac:spMk id="105" creationId="{D441D6E1-A983-A53B-9ADF-4F9118D62180}"/>
          </ac:spMkLst>
        </pc:spChg>
        <pc:spChg chg="add mod">
          <ac:chgData name="Jorgensen, Rick" userId="22b7bd11-eb0f-413f-9bcb-9ce21ec7b0a8" providerId="ADAL" clId="{63C519A2-C2B2-47AC-828F-E429CD2FEDB2}" dt="2023-06-08T20:42:00.465" v="2452" actId="1076"/>
          <ac:spMkLst>
            <pc:docMk/>
            <pc:sldMk cId="3513125160" sldId="394"/>
            <ac:spMk id="108" creationId="{AB0B669A-4242-8BF1-2D3A-99138A13C0C4}"/>
          </ac:spMkLst>
        </pc:spChg>
        <pc:grpChg chg="add mod">
          <ac:chgData name="Jorgensen, Rick" userId="22b7bd11-eb0f-413f-9bcb-9ce21ec7b0a8" providerId="ADAL" clId="{63C519A2-C2B2-47AC-828F-E429CD2FEDB2}" dt="2023-06-08T19:43:42.701" v="1827" actId="164"/>
          <ac:grpSpMkLst>
            <pc:docMk/>
            <pc:sldMk cId="3513125160" sldId="394"/>
            <ac:grpSpMk id="28" creationId="{36E3BEC5-054B-834D-C3C6-DEAACC4CA27D}"/>
          </ac:grpSpMkLst>
        </pc:grpChg>
        <pc:picChg chg="add del mod">
          <ac:chgData name="Jorgensen, Rick" userId="22b7bd11-eb0f-413f-9bcb-9ce21ec7b0a8" providerId="ADAL" clId="{63C519A2-C2B2-47AC-828F-E429CD2FEDB2}" dt="2023-06-08T19:32:04.415" v="1691" actId="478"/>
          <ac:picMkLst>
            <pc:docMk/>
            <pc:sldMk cId="3513125160" sldId="394"/>
            <ac:picMk id="2" creationId="{0E3D2B62-86BA-0AB3-4AF6-B4C9A0341229}"/>
          </ac:picMkLst>
        </pc:picChg>
        <pc:picChg chg="add del mod">
          <ac:chgData name="Jorgensen, Rick" userId="22b7bd11-eb0f-413f-9bcb-9ce21ec7b0a8" providerId="ADAL" clId="{63C519A2-C2B2-47AC-828F-E429CD2FEDB2}" dt="2023-06-08T19:32:05.891" v="1694" actId="478"/>
          <ac:picMkLst>
            <pc:docMk/>
            <pc:sldMk cId="3513125160" sldId="394"/>
            <ac:picMk id="3" creationId="{CE4D6F04-3DB7-E4D2-E918-E891203AD82F}"/>
          </ac:picMkLst>
        </pc:picChg>
        <pc:picChg chg="add del mod">
          <ac:chgData name="Jorgensen, Rick" userId="22b7bd11-eb0f-413f-9bcb-9ce21ec7b0a8" providerId="ADAL" clId="{63C519A2-C2B2-47AC-828F-E429CD2FEDB2}" dt="2023-06-08T19:32:06.401" v="1695" actId="478"/>
          <ac:picMkLst>
            <pc:docMk/>
            <pc:sldMk cId="3513125160" sldId="394"/>
            <ac:picMk id="4" creationId="{BD2FB5E7-DCF2-56A9-01BD-F0DB334FEAF2}"/>
          </ac:picMkLst>
        </pc:picChg>
        <pc:picChg chg="add del mod">
          <ac:chgData name="Jorgensen, Rick" userId="22b7bd11-eb0f-413f-9bcb-9ce21ec7b0a8" providerId="ADAL" clId="{63C519A2-C2B2-47AC-828F-E429CD2FEDB2}" dt="2023-06-08T19:32:08.151" v="1698" actId="478"/>
          <ac:picMkLst>
            <pc:docMk/>
            <pc:sldMk cId="3513125160" sldId="394"/>
            <ac:picMk id="5" creationId="{BDD93B36-875C-C6ED-7EEA-CBCC5F561ED1}"/>
          </ac:picMkLst>
        </pc:picChg>
        <pc:picChg chg="del">
          <ac:chgData name="Jorgensen, Rick" userId="22b7bd11-eb0f-413f-9bcb-9ce21ec7b0a8" providerId="ADAL" clId="{63C519A2-C2B2-47AC-828F-E429CD2FEDB2}" dt="2023-06-05T15:49:05.176" v="1503" actId="478"/>
          <ac:picMkLst>
            <pc:docMk/>
            <pc:sldMk cId="3513125160" sldId="394"/>
            <ac:picMk id="6" creationId="{5CCBC0C0-B353-606D-C2A5-14DEB2FDD88F}"/>
          </ac:picMkLst>
        </pc:picChg>
        <pc:picChg chg="add del mod modCrop">
          <ac:chgData name="Jorgensen, Rick" userId="22b7bd11-eb0f-413f-9bcb-9ce21ec7b0a8" providerId="ADAL" clId="{63C519A2-C2B2-47AC-828F-E429CD2FEDB2}" dt="2023-06-08T20:14:27.652" v="2081" actId="478"/>
          <ac:picMkLst>
            <pc:docMk/>
            <pc:sldMk cId="3513125160" sldId="394"/>
            <ac:picMk id="7" creationId="{09FFA786-28A3-CF8A-2B45-0696623DFD61}"/>
          </ac:picMkLst>
        </pc:picChg>
        <pc:picChg chg="add del mod">
          <ac:chgData name="Jorgensen, Rick" userId="22b7bd11-eb0f-413f-9bcb-9ce21ec7b0a8" providerId="ADAL" clId="{63C519A2-C2B2-47AC-828F-E429CD2FEDB2}" dt="2023-06-05T15:51:58.885" v="1537" actId="478"/>
          <ac:picMkLst>
            <pc:docMk/>
            <pc:sldMk cId="3513125160" sldId="394"/>
            <ac:picMk id="7" creationId="{4E12A33B-88EB-5383-10EE-FF17102A78C9}"/>
          </ac:picMkLst>
        </pc:picChg>
        <pc:picChg chg="del">
          <ac:chgData name="Jorgensen, Rick" userId="22b7bd11-eb0f-413f-9bcb-9ce21ec7b0a8" providerId="ADAL" clId="{63C519A2-C2B2-47AC-828F-E429CD2FEDB2}" dt="2023-06-05T15:49:29.373" v="1510" actId="478"/>
          <ac:picMkLst>
            <pc:docMk/>
            <pc:sldMk cId="3513125160" sldId="394"/>
            <ac:picMk id="8" creationId="{4BCD7F75-4DEA-72D3-623D-FBA9466B798E}"/>
          </ac:picMkLst>
        </pc:picChg>
        <pc:picChg chg="add del mod">
          <ac:chgData name="Jorgensen, Rick" userId="22b7bd11-eb0f-413f-9bcb-9ce21ec7b0a8" providerId="ADAL" clId="{63C519A2-C2B2-47AC-828F-E429CD2FEDB2}" dt="2023-06-08T19:32:04.868" v="1692" actId="478"/>
          <ac:picMkLst>
            <pc:docMk/>
            <pc:sldMk cId="3513125160" sldId="394"/>
            <ac:picMk id="11" creationId="{332D7914-E1D9-687D-CC13-76885173B176}"/>
          </ac:picMkLst>
        </pc:picChg>
        <pc:picChg chg="add del mod">
          <ac:chgData name="Jorgensen, Rick" userId="22b7bd11-eb0f-413f-9bcb-9ce21ec7b0a8" providerId="ADAL" clId="{63C519A2-C2B2-47AC-828F-E429CD2FEDB2}" dt="2023-06-08T19:32:05.385" v="1693" actId="478"/>
          <ac:picMkLst>
            <pc:docMk/>
            <pc:sldMk cId="3513125160" sldId="394"/>
            <ac:picMk id="12" creationId="{9A72D7E7-3069-F10D-74B4-B0D073354418}"/>
          </ac:picMkLst>
        </pc:picChg>
        <pc:picChg chg="del">
          <ac:chgData name="Jorgensen, Rick" userId="22b7bd11-eb0f-413f-9bcb-9ce21ec7b0a8" providerId="ADAL" clId="{63C519A2-C2B2-47AC-828F-E429CD2FEDB2}" dt="2023-06-05T15:49:59.235" v="1517" actId="478"/>
          <ac:picMkLst>
            <pc:docMk/>
            <pc:sldMk cId="3513125160" sldId="394"/>
            <ac:picMk id="13" creationId="{130CDF64-1BA9-7830-72EA-EB77C091619A}"/>
          </ac:picMkLst>
        </pc:picChg>
        <pc:picChg chg="add del mod modCrop">
          <ac:chgData name="Jorgensen, Rick" userId="22b7bd11-eb0f-413f-9bcb-9ce21ec7b0a8" providerId="ADAL" clId="{63C519A2-C2B2-47AC-828F-E429CD2FEDB2}" dt="2023-06-08T20:14:28.207" v="2082" actId="478"/>
          <ac:picMkLst>
            <pc:docMk/>
            <pc:sldMk cId="3513125160" sldId="394"/>
            <ac:picMk id="13" creationId="{C0028344-6A5E-16F1-3689-DE5DC0EC7A90}"/>
          </ac:picMkLst>
        </pc:picChg>
        <pc:picChg chg="add del mod">
          <ac:chgData name="Jorgensen, Rick" userId="22b7bd11-eb0f-413f-9bcb-9ce21ec7b0a8" providerId="ADAL" clId="{63C519A2-C2B2-47AC-828F-E429CD2FEDB2}" dt="2023-06-08T19:32:06.984" v="1696" actId="478"/>
          <ac:picMkLst>
            <pc:docMk/>
            <pc:sldMk cId="3513125160" sldId="394"/>
            <ac:picMk id="14" creationId="{3AF5F5F2-A623-FB5B-35DD-384A0C5778B7}"/>
          </ac:picMkLst>
        </pc:picChg>
        <pc:picChg chg="del">
          <ac:chgData name="Jorgensen, Rick" userId="22b7bd11-eb0f-413f-9bcb-9ce21ec7b0a8" providerId="ADAL" clId="{63C519A2-C2B2-47AC-828F-E429CD2FEDB2}" dt="2023-06-05T15:50:28.426" v="1523" actId="478"/>
          <ac:picMkLst>
            <pc:docMk/>
            <pc:sldMk cId="3513125160" sldId="394"/>
            <ac:picMk id="16" creationId="{381542EA-FDC2-253C-2D47-68C208ECD4B7}"/>
          </ac:picMkLst>
        </pc:picChg>
        <pc:picChg chg="add del mod">
          <ac:chgData name="Jorgensen, Rick" userId="22b7bd11-eb0f-413f-9bcb-9ce21ec7b0a8" providerId="ADAL" clId="{63C519A2-C2B2-47AC-828F-E429CD2FEDB2}" dt="2023-06-08T19:32:07.547" v="1697" actId="478"/>
          <ac:picMkLst>
            <pc:docMk/>
            <pc:sldMk cId="3513125160" sldId="394"/>
            <ac:picMk id="18" creationId="{FFC0C59C-220F-52B4-E432-6A41D7CA7101}"/>
          </ac:picMkLst>
        </pc:picChg>
        <pc:picChg chg="del">
          <ac:chgData name="Jorgensen, Rick" userId="22b7bd11-eb0f-413f-9bcb-9ce21ec7b0a8" providerId="ADAL" clId="{63C519A2-C2B2-47AC-828F-E429CD2FEDB2}" dt="2023-06-05T15:51:16.831" v="1529" actId="478"/>
          <ac:picMkLst>
            <pc:docMk/>
            <pc:sldMk cId="3513125160" sldId="394"/>
            <ac:picMk id="19" creationId="{2CE31D1C-7BCE-E665-97CF-DA509A4D8AB2}"/>
          </ac:picMkLst>
        </pc:picChg>
        <pc:picChg chg="add del mod modCrop">
          <ac:chgData name="Jorgensen, Rick" userId="22b7bd11-eb0f-413f-9bcb-9ce21ec7b0a8" providerId="ADAL" clId="{63C519A2-C2B2-47AC-828F-E429CD2FEDB2}" dt="2023-06-08T20:14:28.664" v="2083" actId="478"/>
          <ac:picMkLst>
            <pc:docMk/>
            <pc:sldMk cId="3513125160" sldId="394"/>
            <ac:picMk id="19" creationId="{915B3557-B53B-F2FB-C460-E12387F1B177}"/>
          </ac:picMkLst>
        </pc:picChg>
        <pc:picChg chg="del">
          <ac:chgData name="Jorgensen, Rick" userId="22b7bd11-eb0f-413f-9bcb-9ce21ec7b0a8" providerId="ADAL" clId="{63C519A2-C2B2-47AC-828F-E429CD2FEDB2}" dt="2023-06-05T15:52:22.663" v="1544" actId="478"/>
          <ac:picMkLst>
            <pc:docMk/>
            <pc:sldMk cId="3513125160" sldId="394"/>
            <ac:picMk id="22" creationId="{541AC162-61A4-0E8E-9291-83E78511458B}"/>
          </ac:picMkLst>
        </pc:picChg>
        <pc:picChg chg="add del mod modCrop">
          <ac:chgData name="Jorgensen, Rick" userId="22b7bd11-eb0f-413f-9bcb-9ce21ec7b0a8" providerId="ADAL" clId="{63C519A2-C2B2-47AC-828F-E429CD2FEDB2}" dt="2023-06-08T20:14:29.287" v="2084" actId="478"/>
          <ac:picMkLst>
            <pc:docMk/>
            <pc:sldMk cId="3513125160" sldId="394"/>
            <ac:picMk id="22" creationId="{6CC61DC1-00A5-02BD-0D1C-E9EDAE6556E7}"/>
          </ac:picMkLst>
        </pc:picChg>
        <pc:picChg chg="add del mod modCrop">
          <ac:chgData name="Jorgensen, Rick" userId="22b7bd11-eb0f-413f-9bcb-9ce21ec7b0a8" providerId="ADAL" clId="{63C519A2-C2B2-47AC-828F-E429CD2FEDB2}" dt="2023-06-08T20:14:29.735" v="2085" actId="478"/>
          <ac:picMkLst>
            <pc:docMk/>
            <pc:sldMk cId="3513125160" sldId="394"/>
            <ac:picMk id="24" creationId="{A315108C-0BC1-4C27-5FEF-1BC94FC17CD1}"/>
          </ac:picMkLst>
        </pc:picChg>
        <pc:picChg chg="add del mod modCrop">
          <ac:chgData name="Jorgensen, Rick" userId="22b7bd11-eb0f-413f-9bcb-9ce21ec7b0a8" providerId="ADAL" clId="{63C519A2-C2B2-47AC-828F-E429CD2FEDB2}" dt="2023-06-08T20:14:30.472" v="2086" actId="478"/>
          <ac:picMkLst>
            <pc:docMk/>
            <pc:sldMk cId="3513125160" sldId="394"/>
            <ac:picMk id="27" creationId="{CDE1B1DD-CC91-CF49-8EEE-EC7C01DC9D2C}"/>
          </ac:picMkLst>
        </pc:picChg>
        <pc:picChg chg="del">
          <ac:chgData name="Jorgensen, Rick" userId="22b7bd11-eb0f-413f-9bcb-9ce21ec7b0a8" providerId="ADAL" clId="{63C519A2-C2B2-47AC-828F-E429CD2FEDB2}" dt="2023-06-05T15:52:44.867" v="1551" actId="478"/>
          <ac:picMkLst>
            <pc:docMk/>
            <pc:sldMk cId="3513125160" sldId="394"/>
            <ac:picMk id="30" creationId="{BBDBA7F6-D1CA-C3C3-D029-8667ED0244A8}"/>
          </ac:picMkLst>
        </pc:picChg>
        <pc:picChg chg="del">
          <ac:chgData name="Jorgensen, Rick" userId="22b7bd11-eb0f-413f-9bcb-9ce21ec7b0a8" providerId="ADAL" clId="{63C519A2-C2B2-47AC-828F-E429CD2FEDB2}" dt="2023-06-05T15:53:50.356" v="1558" actId="478"/>
          <ac:picMkLst>
            <pc:docMk/>
            <pc:sldMk cId="3513125160" sldId="394"/>
            <ac:picMk id="32" creationId="{F648B11E-F922-262D-5CC0-22225E15B07E}"/>
          </ac:picMkLst>
        </pc:picChg>
        <pc:picChg chg="add del mod">
          <ac:chgData name="Jorgensen, Rick" userId="22b7bd11-eb0f-413f-9bcb-9ce21ec7b0a8" providerId="ADAL" clId="{63C519A2-C2B2-47AC-828F-E429CD2FEDB2}" dt="2023-06-08T19:54:18.565" v="1970" actId="478"/>
          <ac:picMkLst>
            <pc:docMk/>
            <pc:sldMk cId="3513125160" sldId="394"/>
            <ac:picMk id="39" creationId="{4A9A6D9D-3BEC-029A-0DA9-0F07FBE28C68}"/>
          </ac:picMkLst>
        </pc:picChg>
        <pc:picChg chg="add del mod">
          <ac:chgData name="Jorgensen, Rick" userId="22b7bd11-eb0f-413f-9bcb-9ce21ec7b0a8" providerId="ADAL" clId="{63C519A2-C2B2-47AC-828F-E429CD2FEDB2}" dt="2023-06-08T19:54:48.425" v="1981" actId="478"/>
          <ac:picMkLst>
            <pc:docMk/>
            <pc:sldMk cId="3513125160" sldId="394"/>
            <ac:picMk id="40" creationId="{106A0EE9-4FEC-D986-C070-245D17AB898B}"/>
          </ac:picMkLst>
        </pc:picChg>
        <pc:picChg chg="add del mod">
          <ac:chgData name="Jorgensen, Rick" userId="22b7bd11-eb0f-413f-9bcb-9ce21ec7b0a8" providerId="ADAL" clId="{63C519A2-C2B2-47AC-828F-E429CD2FEDB2}" dt="2023-06-08T19:56:00.947" v="1996" actId="478"/>
          <ac:picMkLst>
            <pc:docMk/>
            <pc:sldMk cId="3513125160" sldId="394"/>
            <ac:picMk id="41" creationId="{FCA13F39-2614-2138-3FB3-0DD7DD7AA5BD}"/>
          </ac:picMkLst>
        </pc:picChg>
        <pc:picChg chg="add del mod">
          <ac:chgData name="Jorgensen, Rick" userId="22b7bd11-eb0f-413f-9bcb-9ce21ec7b0a8" providerId="ADAL" clId="{63C519A2-C2B2-47AC-828F-E429CD2FEDB2}" dt="2023-06-08T19:56:55.481" v="2007" actId="478"/>
          <ac:picMkLst>
            <pc:docMk/>
            <pc:sldMk cId="3513125160" sldId="394"/>
            <ac:picMk id="42" creationId="{AE691FEA-0BBC-4F03-44CD-1FED204F079A}"/>
          </ac:picMkLst>
        </pc:picChg>
        <pc:picChg chg="add del mod">
          <ac:chgData name="Jorgensen, Rick" userId="22b7bd11-eb0f-413f-9bcb-9ce21ec7b0a8" providerId="ADAL" clId="{63C519A2-C2B2-47AC-828F-E429CD2FEDB2}" dt="2023-06-08T19:57:48.027" v="2021" actId="478"/>
          <ac:picMkLst>
            <pc:docMk/>
            <pc:sldMk cId="3513125160" sldId="394"/>
            <ac:picMk id="43" creationId="{5D3C98DB-6244-482D-9510-244D5C13601A}"/>
          </ac:picMkLst>
        </pc:picChg>
        <pc:picChg chg="add del mod">
          <ac:chgData name="Jorgensen, Rick" userId="22b7bd11-eb0f-413f-9bcb-9ce21ec7b0a8" providerId="ADAL" clId="{63C519A2-C2B2-47AC-828F-E429CD2FEDB2}" dt="2023-06-08T19:58:22.996" v="2032" actId="478"/>
          <ac:picMkLst>
            <pc:docMk/>
            <pc:sldMk cId="3513125160" sldId="394"/>
            <ac:picMk id="44" creationId="{012A340E-E667-9341-045A-F790A38EA313}"/>
          </ac:picMkLst>
        </pc:picChg>
        <pc:picChg chg="add del mod modCrop">
          <ac:chgData name="Jorgensen, Rick" userId="22b7bd11-eb0f-413f-9bcb-9ce21ec7b0a8" providerId="ADAL" clId="{63C519A2-C2B2-47AC-828F-E429CD2FEDB2}" dt="2023-06-08T20:22:22.938" v="2178" actId="478"/>
          <ac:picMkLst>
            <pc:docMk/>
            <pc:sldMk cId="3513125160" sldId="394"/>
            <ac:picMk id="46" creationId="{F33C6329-D68A-F074-744A-C9C109305C23}"/>
          </ac:picMkLst>
        </pc:picChg>
        <pc:picChg chg="add del mod">
          <ac:chgData name="Jorgensen, Rick" userId="22b7bd11-eb0f-413f-9bcb-9ce21ec7b0a8" providerId="ADAL" clId="{63C519A2-C2B2-47AC-828F-E429CD2FEDB2}" dt="2023-06-08T19:55:38.464" v="1985"/>
          <ac:picMkLst>
            <pc:docMk/>
            <pc:sldMk cId="3513125160" sldId="394"/>
            <ac:picMk id="48" creationId="{4127FA0B-E1C9-4594-E3DC-43302D86DBB1}"/>
          </ac:picMkLst>
        </pc:picChg>
        <pc:picChg chg="add del mod modCrop">
          <ac:chgData name="Jorgensen, Rick" userId="22b7bd11-eb0f-413f-9bcb-9ce21ec7b0a8" providerId="ADAL" clId="{63C519A2-C2B2-47AC-828F-E429CD2FEDB2}" dt="2023-06-08T20:20:33.195" v="2167" actId="478"/>
          <ac:picMkLst>
            <pc:docMk/>
            <pc:sldMk cId="3513125160" sldId="394"/>
            <ac:picMk id="50" creationId="{F55E9FB4-B068-F99E-D4DD-54DD58641324}"/>
          </ac:picMkLst>
        </pc:picChg>
        <pc:picChg chg="add del mod modCrop">
          <ac:chgData name="Jorgensen, Rick" userId="22b7bd11-eb0f-413f-9bcb-9ce21ec7b0a8" providerId="ADAL" clId="{63C519A2-C2B2-47AC-828F-E429CD2FEDB2}" dt="2023-06-08T20:20:35.040" v="2168" actId="478"/>
          <ac:picMkLst>
            <pc:docMk/>
            <pc:sldMk cId="3513125160" sldId="394"/>
            <ac:picMk id="52" creationId="{74E168F7-B704-3695-DBAC-05DD5C682088}"/>
          </ac:picMkLst>
        </pc:picChg>
        <pc:picChg chg="add del mod modCrop">
          <ac:chgData name="Jorgensen, Rick" userId="22b7bd11-eb0f-413f-9bcb-9ce21ec7b0a8" providerId="ADAL" clId="{63C519A2-C2B2-47AC-828F-E429CD2FEDB2}" dt="2023-06-08T20:20:35.503" v="2169" actId="478"/>
          <ac:picMkLst>
            <pc:docMk/>
            <pc:sldMk cId="3513125160" sldId="394"/>
            <ac:picMk id="54" creationId="{0C94B3A2-D4FD-577C-AFFB-52F0E744FFA9}"/>
          </ac:picMkLst>
        </pc:picChg>
        <pc:picChg chg="add del mod modCrop">
          <ac:chgData name="Jorgensen, Rick" userId="22b7bd11-eb0f-413f-9bcb-9ce21ec7b0a8" providerId="ADAL" clId="{63C519A2-C2B2-47AC-828F-E429CD2FEDB2}" dt="2023-06-08T20:20:36.121" v="2170" actId="478"/>
          <ac:picMkLst>
            <pc:docMk/>
            <pc:sldMk cId="3513125160" sldId="394"/>
            <ac:picMk id="56" creationId="{15863B65-1190-169F-519D-CA0722DEA1B2}"/>
          </ac:picMkLst>
        </pc:picChg>
        <pc:picChg chg="add del mod modCrop">
          <ac:chgData name="Jorgensen, Rick" userId="22b7bd11-eb0f-413f-9bcb-9ce21ec7b0a8" providerId="ADAL" clId="{63C519A2-C2B2-47AC-828F-E429CD2FEDB2}" dt="2023-06-08T20:20:36.561" v="2171" actId="478"/>
          <ac:picMkLst>
            <pc:docMk/>
            <pc:sldMk cId="3513125160" sldId="394"/>
            <ac:picMk id="58" creationId="{8969B7B8-766C-F043-001E-15C44E4B78F3}"/>
          </ac:picMkLst>
        </pc:picChg>
        <pc:picChg chg="add del mod">
          <ac:chgData name="Jorgensen, Rick" userId="22b7bd11-eb0f-413f-9bcb-9ce21ec7b0a8" providerId="ADAL" clId="{63C519A2-C2B2-47AC-828F-E429CD2FEDB2}" dt="2023-06-08T20:01:14.550" v="2045"/>
          <ac:picMkLst>
            <pc:docMk/>
            <pc:sldMk cId="3513125160" sldId="394"/>
            <ac:picMk id="65" creationId="{701D206B-7752-C9B8-EC14-CC62E146AB1D}"/>
          </ac:picMkLst>
        </pc:picChg>
        <pc:picChg chg="add del mod">
          <ac:chgData name="Jorgensen, Rick" userId="22b7bd11-eb0f-413f-9bcb-9ce21ec7b0a8" providerId="ADAL" clId="{63C519A2-C2B2-47AC-828F-E429CD2FEDB2}" dt="2023-06-08T20:01:14.550" v="2045"/>
          <ac:picMkLst>
            <pc:docMk/>
            <pc:sldMk cId="3513125160" sldId="394"/>
            <ac:picMk id="66" creationId="{80C81E27-3C03-D6DD-C9AC-433E0C1B33CD}"/>
          </ac:picMkLst>
        </pc:picChg>
        <pc:picChg chg="add del mod">
          <ac:chgData name="Jorgensen, Rick" userId="22b7bd11-eb0f-413f-9bcb-9ce21ec7b0a8" providerId="ADAL" clId="{63C519A2-C2B2-47AC-828F-E429CD2FEDB2}" dt="2023-06-08T20:01:14.550" v="2045"/>
          <ac:picMkLst>
            <pc:docMk/>
            <pc:sldMk cId="3513125160" sldId="394"/>
            <ac:picMk id="67" creationId="{4674A195-0F8E-4D23-5B3B-8AC9CFF6C410}"/>
          </ac:picMkLst>
        </pc:picChg>
        <pc:picChg chg="add del mod">
          <ac:chgData name="Jorgensen, Rick" userId="22b7bd11-eb0f-413f-9bcb-9ce21ec7b0a8" providerId="ADAL" clId="{63C519A2-C2B2-47AC-828F-E429CD2FEDB2}" dt="2023-06-08T20:01:14.550" v="2045"/>
          <ac:picMkLst>
            <pc:docMk/>
            <pc:sldMk cId="3513125160" sldId="394"/>
            <ac:picMk id="68" creationId="{C0A59F3A-B760-3AEF-19E6-2237ABE084C7}"/>
          </ac:picMkLst>
        </pc:picChg>
        <pc:picChg chg="add del mod">
          <ac:chgData name="Jorgensen, Rick" userId="22b7bd11-eb0f-413f-9bcb-9ce21ec7b0a8" providerId="ADAL" clId="{63C519A2-C2B2-47AC-828F-E429CD2FEDB2}" dt="2023-06-08T20:01:14.550" v="2045"/>
          <ac:picMkLst>
            <pc:docMk/>
            <pc:sldMk cId="3513125160" sldId="394"/>
            <ac:picMk id="69" creationId="{BA5B0532-702D-52B5-2532-28FCB034EB90}"/>
          </ac:picMkLst>
        </pc:picChg>
        <pc:picChg chg="add del mod">
          <ac:chgData name="Jorgensen, Rick" userId="22b7bd11-eb0f-413f-9bcb-9ce21ec7b0a8" providerId="ADAL" clId="{63C519A2-C2B2-47AC-828F-E429CD2FEDB2}" dt="2023-06-08T20:01:14.550" v="2045"/>
          <ac:picMkLst>
            <pc:docMk/>
            <pc:sldMk cId="3513125160" sldId="394"/>
            <ac:picMk id="70" creationId="{CBFF1C6F-DA74-9B88-6A9C-A4096D430AEB}"/>
          </ac:picMkLst>
        </pc:picChg>
        <pc:picChg chg="add del mod">
          <ac:chgData name="Jorgensen, Rick" userId="22b7bd11-eb0f-413f-9bcb-9ce21ec7b0a8" providerId="ADAL" clId="{63C519A2-C2B2-47AC-828F-E429CD2FEDB2}" dt="2023-06-08T20:01:35.521" v="2049" actId="478"/>
          <ac:picMkLst>
            <pc:docMk/>
            <pc:sldMk cId="3513125160" sldId="394"/>
            <ac:picMk id="77" creationId="{0D2EDCF5-F170-993E-51BA-CDF623FD9A29}"/>
          </ac:picMkLst>
        </pc:picChg>
        <pc:picChg chg="add del mod">
          <ac:chgData name="Jorgensen, Rick" userId="22b7bd11-eb0f-413f-9bcb-9ce21ec7b0a8" providerId="ADAL" clId="{63C519A2-C2B2-47AC-828F-E429CD2FEDB2}" dt="2023-06-08T20:01:35.521" v="2049" actId="478"/>
          <ac:picMkLst>
            <pc:docMk/>
            <pc:sldMk cId="3513125160" sldId="394"/>
            <ac:picMk id="78" creationId="{68A9C037-B971-8288-366C-08D484751000}"/>
          </ac:picMkLst>
        </pc:picChg>
        <pc:picChg chg="add del mod">
          <ac:chgData name="Jorgensen, Rick" userId="22b7bd11-eb0f-413f-9bcb-9ce21ec7b0a8" providerId="ADAL" clId="{63C519A2-C2B2-47AC-828F-E429CD2FEDB2}" dt="2023-06-08T20:01:35.521" v="2049" actId="478"/>
          <ac:picMkLst>
            <pc:docMk/>
            <pc:sldMk cId="3513125160" sldId="394"/>
            <ac:picMk id="79" creationId="{5C80BD95-8197-60D7-F884-89B0629FD7E0}"/>
          </ac:picMkLst>
        </pc:picChg>
        <pc:picChg chg="add del mod">
          <ac:chgData name="Jorgensen, Rick" userId="22b7bd11-eb0f-413f-9bcb-9ce21ec7b0a8" providerId="ADAL" clId="{63C519A2-C2B2-47AC-828F-E429CD2FEDB2}" dt="2023-06-08T20:01:35.521" v="2049" actId="478"/>
          <ac:picMkLst>
            <pc:docMk/>
            <pc:sldMk cId="3513125160" sldId="394"/>
            <ac:picMk id="80" creationId="{720A096F-E385-6CFB-3DB3-7D8DCA60CED7}"/>
          </ac:picMkLst>
        </pc:picChg>
        <pc:picChg chg="add del mod">
          <ac:chgData name="Jorgensen, Rick" userId="22b7bd11-eb0f-413f-9bcb-9ce21ec7b0a8" providerId="ADAL" clId="{63C519A2-C2B2-47AC-828F-E429CD2FEDB2}" dt="2023-06-08T20:01:35.521" v="2049" actId="478"/>
          <ac:picMkLst>
            <pc:docMk/>
            <pc:sldMk cId="3513125160" sldId="394"/>
            <ac:picMk id="81" creationId="{6D8E047D-5A0F-B7EC-6289-94C8AB653D7F}"/>
          </ac:picMkLst>
        </pc:picChg>
        <pc:picChg chg="add del mod">
          <ac:chgData name="Jorgensen, Rick" userId="22b7bd11-eb0f-413f-9bcb-9ce21ec7b0a8" providerId="ADAL" clId="{63C519A2-C2B2-47AC-828F-E429CD2FEDB2}" dt="2023-06-08T20:01:35.521" v="2049" actId="478"/>
          <ac:picMkLst>
            <pc:docMk/>
            <pc:sldMk cId="3513125160" sldId="394"/>
            <ac:picMk id="82" creationId="{1594589E-8EB2-67B3-C366-18CD92AF6C9E}"/>
          </ac:picMkLst>
        </pc:picChg>
        <pc:picChg chg="add del mod modCrop">
          <ac:chgData name="Jorgensen, Rick" userId="22b7bd11-eb0f-413f-9bcb-9ce21ec7b0a8" providerId="ADAL" clId="{63C519A2-C2B2-47AC-828F-E429CD2FEDB2}" dt="2023-06-08T20:15:43.910" v="2102" actId="478"/>
          <ac:picMkLst>
            <pc:docMk/>
            <pc:sldMk cId="3513125160" sldId="394"/>
            <ac:picMk id="84" creationId="{1A4C665D-9029-CCB5-454E-46CCA13E11F5}"/>
          </ac:picMkLst>
        </pc:picChg>
        <pc:picChg chg="add del mod modCrop">
          <ac:chgData name="Jorgensen, Rick" userId="22b7bd11-eb0f-413f-9bcb-9ce21ec7b0a8" providerId="ADAL" clId="{63C519A2-C2B2-47AC-828F-E429CD2FEDB2}" dt="2023-06-08T20:17:48.947" v="2130" actId="478"/>
          <ac:picMkLst>
            <pc:docMk/>
            <pc:sldMk cId="3513125160" sldId="394"/>
            <ac:picMk id="86" creationId="{BE156FD9-2236-FBE3-95B5-C37AEC477974}"/>
          </ac:picMkLst>
        </pc:picChg>
        <pc:picChg chg="add mod modCrop">
          <ac:chgData name="Jorgensen, Rick" userId="22b7bd11-eb0f-413f-9bcb-9ce21ec7b0a8" providerId="ADAL" clId="{63C519A2-C2B2-47AC-828F-E429CD2FEDB2}" dt="2023-06-08T20:42:00.465" v="2452" actId="1076"/>
          <ac:picMkLst>
            <pc:docMk/>
            <pc:sldMk cId="3513125160" sldId="394"/>
            <ac:picMk id="88" creationId="{67262DE4-1CAF-B8F0-3DF8-656909E6E9C3}"/>
          </ac:picMkLst>
        </pc:picChg>
        <pc:picChg chg="add mod modCrop">
          <ac:chgData name="Jorgensen, Rick" userId="22b7bd11-eb0f-413f-9bcb-9ce21ec7b0a8" providerId="ADAL" clId="{63C519A2-C2B2-47AC-828F-E429CD2FEDB2}" dt="2023-08-01T15:28:45.300" v="11635" actId="1582"/>
          <ac:picMkLst>
            <pc:docMk/>
            <pc:sldMk cId="3513125160" sldId="394"/>
            <ac:picMk id="90" creationId="{4C5BBF87-2E7A-B6B7-553B-26F213832CAE}"/>
          </ac:picMkLst>
        </pc:picChg>
        <pc:picChg chg="add mod modCrop">
          <ac:chgData name="Jorgensen, Rick" userId="22b7bd11-eb0f-413f-9bcb-9ce21ec7b0a8" providerId="ADAL" clId="{63C519A2-C2B2-47AC-828F-E429CD2FEDB2}" dt="2023-06-08T20:42:00.465" v="2452" actId="1076"/>
          <ac:picMkLst>
            <pc:docMk/>
            <pc:sldMk cId="3513125160" sldId="394"/>
            <ac:picMk id="92" creationId="{0ECF3F55-E9CA-2D1D-A76F-BF0EA6422FA7}"/>
          </ac:picMkLst>
        </pc:picChg>
        <pc:picChg chg="add del mod modCrop">
          <ac:chgData name="Jorgensen, Rick" userId="22b7bd11-eb0f-413f-9bcb-9ce21ec7b0a8" providerId="ADAL" clId="{63C519A2-C2B2-47AC-828F-E429CD2FEDB2}" dt="2023-06-08T20:24:46.984" v="2203" actId="478"/>
          <ac:picMkLst>
            <pc:docMk/>
            <pc:sldMk cId="3513125160" sldId="394"/>
            <ac:picMk id="94" creationId="{D45C6C1F-4446-B7F2-4A93-35472BB0EC79}"/>
          </ac:picMkLst>
        </pc:picChg>
        <pc:picChg chg="add mod modCrop">
          <ac:chgData name="Jorgensen, Rick" userId="22b7bd11-eb0f-413f-9bcb-9ce21ec7b0a8" providerId="ADAL" clId="{63C519A2-C2B2-47AC-828F-E429CD2FEDB2}" dt="2023-06-08T20:42:00.465" v="2452" actId="1076"/>
          <ac:picMkLst>
            <pc:docMk/>
            <pc:sldMk cId="3513125160" sldId="394"/>
            <ac:picMk id="96" creationId="{0DF7A5C5-4221-18F9-BF8C-5F78BCF059AF}"/>
          </ac:picMkLst>
        </pc:picChg>
        <pc:picChg chg="add mod modCrop">
          <ac:chgData name="Jorgensen, Rick" userId="22b7bd11-eb0f-413f-9bcb-9ce21ec7b0a8" providerId="ADAL" clId="{63C519A2-C2B2-47AC-828F-E429CD2FEDB2}" dt="2023-06-08T20:42:00.465" v="2452" actId="1076"/>
          <ac:picMkLst>
            <pc:docMk/>
            <pc:sldMk cId="3513125160" sldId="394"/>
            <ac:picMk id="98" creationId="{BDF343AA-E9D4-AFFE-27C9-B79C39FDCB85}"/>
          </ac:picMkLst>
        </pc:picChg>
        <pc:picChg chg="add mod modCrop">
          <ac:chgData name="Jorgensen, Rick" userId="22b7bd11-eb0f-413f-9bcb-9ce21ec7b0a8" providerId="ADAL" clId="{63C519A2-C2B2-47AC-828F-E429CD2FEDB2}" dt="2023-06-08T20:42:00.465" v="2452" actId="1076"/>
          <ac:picMkLst>
            <pc:docMk/>
            <pc:sldMk cId="3513125160" sldId="394"/>
            <ac:picMk id="100" creationId="{662601E4-F6B4-44B7-63C4-5BFF23596B2A}"/>
          </ac:picMkLst>
        </pc:picChg>
        <pc:picChg chg="add mod modCrop">
          <ac:chgData name="Jorgensen, Rick" userId="22b7bd11-eb0f-413f-9bcb-9ce21ec7b0a8" providerId="ADAL" clId="{63C519A2-C2B2-47AC-828F-E429CD2FEDB2}" dt="2023-08-01T15:28:51.302" v="11637" actId="1582"/>
          <ac:picMkLst>
            <pc:docMk/>
            <pc:sldMk cId="3513125160" sldId="394"/>
            <ac:picMk id="102" creationId="{B23D2D46-5729-78AB-69A0-765DE47B96D4}"/>
          </ac:picMkLst>
        </pc:picChg>
        <pc:picChg chg="add mod modCrop">
          <ac:chgData name="Jorgensen, Rick" userId="22b7bd11-eb0f-413f-9bcb-9ce21ec7b0a8" providerId="ADAL" clId="{63C519A2-C2B2-47AC-828F-E429CD2FEDB2}" dt="2023-08-01T15:28:55.541" v="11638" actId="1582"/>
          <ac:picMkLst>
            <pc:docMk/>
            <pc:sldMk cId="3513125160" sldId="394"/>
            <ac:picMk id="104" creationId="{59E53313-CD33-C522-0C5A-C40772E2886E}"/>
          </ac:picMkLst>
        </pc:picChg>
        <pc:picChg chg="add mod modCrop">
          <ac:chgData name="Jorgensen, Rick" userId="22b7bd11-eb0f-413f-9bcb-9ce21ec7b0a8" providerId="ADAL" clId="{63C519A2-C2B2-47AC-828F-E429CD2FEDB2}" dt="2023-06-08T20:42:00.465" v="2452" actId="1076"/>
          <ac:picMkLst>
            <pc:docMk/>
            <pc:sldMk cId="3513125160" sldId="394"/>
            <ac:picMk id="107" creationId="{02C06F37-38B6-78A9-5CC2-5FCEC31D8BCD}"/>
          </ac:picMkLst>
        </pc:picChg>
      </pc:sldChg>
      <pc:sldChg chg="modSp add del mod ord">
        <pc:chgData name="Jorgensen, Rick" userId="22b7bd11-eb0f-413f-9bcb-9ce21ec7b0a8" providerId="ADAL" clId="{63C519A2-C2B2-47AC-828F-E429CD2FEDB2}" dt="2023-08-01T15:28:29.833" v="11632" actId="47"/>
        <pc:sldMkLst>
          <pc:docMk/>
          <pc:sldMk cId="2316913702" sldId="395"/>
        </pc:sldMkLst>
        <pc:spChg chg="mod">
          <ac:chgData name="Jorgensen, Rick" userId="22b7bd11-eb0f-413f-9bcb-9ce21ec7b0a8" providerId="ADAL" clId="{63C519A2-C2B2-47AC-828F-E429CD2FEDB2}" dt="2023-06-28T15:48:17.061" v="6171" actId="20577"/>
          <ac:spMkLst>
            <pc:docMk/>
            <pc:sldMk cId="2316913702" sldId="395"/>
            <ac:spMk id="2" creationId="{00000000-0000-0000-0000-000000000000}"/>
          </ac:spMkLst>
        </pc:spChg>
        <pc:spChg chg="mod">
          <ac:chgData name="Jorgensen, Rick" userId="22b7bd11-eb0f-413f-9bcb-9ce21ec7b0a8" providerId="ADAL" clId="{63C519A2-C2B2-47AC-828F-E429CD2FEDB2}" dt="2023-06-08T20:33:15.324" v="2323" actId="20577"/>
          <ac:spMkLst>
            <pc:docMk/>
            <pc:sldMk cId="2316913702" sldId="395"/>
            <ac:spMk id="3" creationId="{00000000-0000-0000-0000-000000000000}"/>
          </ac:spMkLst>
        </pc:spChg>
      </pc:sldChg>
      <pc:sldChg chg="addSp modSp new del mod">
        <pc:chgData name="Jorgensen, Rick" userId="22b7bd11-eb0f-413f-9bcb-9ce21ec7b0a8" providerId="ADAL" clId="{63C519A2-C2B2-47AC-828F-E429CD2FEDB2}" dt="2023-07-24T18:26:10.183" v="8198" actId="47"/>
        <pc:sldMkLst>
          <pc:docMk/>
          <pc:sldMk cId="4209602850" sldId="396"/>
        </pc:sldMkLst>
        <pc:picChg chg="add mod">
          <ac:chgData name="Jorgensen, Rick" userId="22b7bd11-eb0f-413f-9bcb-9ce21ec7b0a8" providerId="ADAL" clId="{63C519A2-C2B2-47AC-828F-E429CD2FEDB2}" dt="2023-06-07T20:02:39.330" v="1579" actId="1076"/>
          <ac:picMkLst>
            <pc:docMk/>
            <pc:sldMk cId="4209602850" sldId="396"/>
            <ac:picMk id="2" creationId="{66665BE8-61A2-69A8-B6DD-42F8750F3AA1}"/>
          </ac:picMkLst>
        </pc:picChg>
      </pc:sldChg>
      <pc:sldChg chg="addSp delSp modSp add del mod ord">
        <pc:chgData name="Jorgensen, Rick" userId="22b7bd11-eb0f-413f-9bcb-9ce21ec7b0a8" providerId="ADAL" clId="{63C519A2-C2B2-47AC-828F-E429CD2FEDB2}" dt="2023-08-01T15:28:32.818" v="11633" actId="47"/>
        <pc:sldMkLst>
          <pc:docMk/>
          <pc:sldMk cId="299100102" sldId="397"/>
        </pc:sldMkLst>
        <pc:spChg chg="mod">
          <ac:chgData name="Jorgensen, Rick" userId="22b7bd11-eb0f-413f-9bcb-9ce21ec7b0a8" providerId="ADAL" clId="{63C519A2-C2B2-47AC-828F-E429CD2FEDB2}" dt="2023-06-08T20:45:42.932" v="2495" actId="1076"/>
          <ac:spMkLst>
            <pc:docMk/>
            <pc:sldMk cId="299100102" sldId="397"/>
            <ac:spMk id="9" creationId="{16C98FF7-C9E9-8046-A859-D9A599468A34}"/>
          </ac:spMkLst>
        </pc:spChg>
        <pc:spChg chg="mod">
          <ac:chgData name="Jorgensen, Rick" userId="22b7bd11-eb0f-413f-9bcb-9ce21ec7b0a8" providerId="ADAL" clId="{63C519A2-C2B2-47AC-828F-E429CD2FEDB2}" dt="2023-06-08T20:45:42.932" v="2495" actId="1076"/>
          <ac:spMkLst>
            <pc:docMk/>
            <pc:sldMk cId="299100102" sldId="397"/>
            <ac:spMk id="10" creationId="{9F84E2A2-11BF-6249-A2DF-0BE34D738A76}"/>
          </ac:spMkLst>
        </pc:spChg>
        <pc:spChg chg="mod">
          <ac:chgData name="Jorgensen, Rick" userId="22b7bd11-eb0f-413f-9bcb-9ce21ec7b0a8" providerId="ADAL" clId="{63C519A2-C2B2-47AC-828F-E429CD2FEDB2}" dt="2023-06-08T20:45:42.932" v="2495" actId="1076"/>
          <ac:spMkLst>
            <pc:docMk/>
            <pc:sldMk cId="299100102" sldId="397"/>
            <ac:spMk id="15" creationId="{D0BC4A18-9D32-73E9-AADD-E9497BF9BADD}"/>
          </ac:spMkLst>
        </pc:spChg>
        <pc:spChg chg="mod">
          <ac:chgData name="Jorgensen, Rick" userId="22b7bd11-eb0f-413f-9bcb-9ce21ec7b0a8" providerId="ADAL" clId="{63C519A2-C2B2-47AC-828F-E429CD2FEDB2}" dt="2023-06-08T20:45:42.932" v="2495" actId="1076"/>
          <ac:spMkLst>
            <pc:docMk/>
            <pc:sldMk cId="299100102" sldId="397"/>
            <ac:spMk id="17" creationId="{9DF35772-8786-2BDE-86C5-5759E33DDDEE}"/>
          </ac:spMkLst>
        </pc:spChg>
        <pc:spChg chg="del">
          <ac:chgData name="Jorgensen, Rick" userId="22b7bd11-eb0f-413f-9bcb-9ce21ec7b0a8" providerId="ADAL" clId="{63C519A2-C2B2-47AC-828F-E429CD2FEDB2}" dt="2023-06-08T20:45:34.185" v="2494" actId="478"/>
          <ac:spMkLst>
            <pc:docMk/>
            <pc:sldMk cId="299100102" sldId="397"/>
            <ac:spMk id="20" creationId="{1C2B0E8E-0479-101C-75EE-73E58A45CF00}"/>
          </ac:spMkLst>
        </pc:spChg>
        <pc:spChg chg="mod">
          <ac:chgData name="Jorgensen, Rick" userId="22b7bd11-eb0f-413f-9bcb-9ce21ec7b0a8" providerId="ADAL" clId="{63C519A2-C2B2-47AC-828F-E429CD2FEDB2}" dt="2023-07-17T14:57:48.496" v="6792" actId="20577"/>
          <ac:spMkLst>
            <pc:docMk/>
            <pc:sldMk cId="299100102" sldId="397"/>
            <ac:spMk id="25" creationId="{43DF711F-4684-B34D-9236-D3A26D348F11}"/>
          </ac:spMkLst>
        </pc:spChg>
        <pc:spChg chg="del">
          <ac:chgData name="Jorgensen, Rick" userId="22b7bd11-eb0f-413f-9bcb-9ce21ec7b0a8" providerId="ADAL" clId="{63C519A2-C2B2-47AC-828F-E429CD2FEDB2}" dt="2023-06-08T20:45:34.185" v="2494" actId="478"/>
          <ac:spMkLst>
            <pc:docMk/>
            <pc:sldMk cId="299100102" sldId="397"/>
            <ac:spMk id="29" creationId="{DE561AC9-9051-7D8D-2414-DE52D32050CB}"/>
          </ac:spMkLst>
        </pc:spChg>
        <pc:spChg chg="mod">
          <ac:chgData name="Jorgensen, Rick" userId="22b7bd11-eb0f-413f-9bcb-9ce21ec7b0a8" providerId="ADAL" clId="{63C519A2-C2B2-47AC-828F-E429CD2FEDB2}" dt="2023-06-08T20:45:42.932" v="2495" actId="1076"/>
          <ac:spMkLst>
            <pc:docMk/>
            <pc:sldMk cId="299100102" sldId="397"/>
            <ac:spMk id="32" creationId="{4CF0541F-3412-06E7-0866-3D9F5502D1A2}"/>
          </ac:spMkLst>
        </pc:spChg>
        <pc:spChg chg="mod">
          <ac:chgData name="Jorgensen, Rick" userId="22b7bd11-eb0f-413f-9bcb-9ce21ec7b0a8" providerId="ADAL" clId="{63C519A2-C2B2-47AC-828F-E429CD2FEDB2}" dt="2023-06-08T20:45:42.932" v="2495" actId="1076"/>
          <ac:spMkLst>
            <pc:docMk/>
            <pc:sldMk cId="299100102" sldId="397"/>
            <ac:spMk id="35" creationId="{764319EC-7103-84E4-7E64-529EAD99F69B}"/>
          </ac:spMkLst>
        </pc:spChg>
        <pc:spChg chg="mod">
          <ac:chgData name="Jorgensen, Rick" userId="22b7bd11-eb0f-413f-9bcb-9ce21ec7b0a8" providerId="ADAL" clId="{63C519A2-C2B2-47AC-828F-E429CD2FEDB2}" dt="2023-06-08T20:45:42.932" v="2495" actId="1076"/>
          <ac:spMkLst>
            <pc:docMk/>
            <pc:sldMk cId="299100102" sldId="397"/>
            <ac:spMk id="36" creationId="{9698F0FB-4FA1-BFFF-3496-88B5DEAA214D}"/>
          </ac:spMkLst>
        </pc:spChg>
        <pc:spChg chg="del">
          <ac:chgData name="Jorgensen, Rick" userId="22b7bd11-eb0f-413f-9bcb-9ce21ec7b0a8" providerId="ADAL" clId="{63C519A2-C2B2-47AC-828F-E429CD2FEDB2}" dt="2023-06-08T20:45:33.260" v="2493" actId="478"/>
          <ac:spMkLst>
            <pc:docMk/>
            <pc:sldMk cId="299100102" sldId="397"/>
            <ac:spMk id="37" creationId="{19F0EEA5-55EE-DC86-5C44-FD3C0861138F}"/>
          </ac:spMkLst>
        </pc:spChg>
        <pc:spChg chg="del">
          <ac:chgData name="Jorgensen, Rick" userId="22b7bd11-eb0f-413f-9bcb-9ce21ec7b0a8" providerId="ADAL" clId="{63C519A2-C2B2-47AC-828F-E429CD2FEDB2}" dt="2023-06-08T20:45:34.185" v="2494" actId="478"/>
          <ac:spMkLst>
            <pc:docMk/>
            <pc:sldMk cId="299100102" sldId="397"/>
            <ac:spMk id="38" creationId="{D4FE6DCA-6A84-907A-7CEB-F9A2B7BB321C}"/>
          </ac:spMkLst>
        </pc:spChg>
        <pc:spChg chg="mod">
          <ac:chgData name="Jorgensen, Rick" userId="22b7bd11-eb0f-413f-9bcb-9ce21ec7b0a8" providerId="ADAL" clId="{63C519A2-C2B2-47AC-828F-E429CD2FEDB2}" dt="2023-06-08T20:45:42.932" v="2495" actId="1076"/>
          <ac:spMkLst>
            <pc:docMk/>
            <pc:sldMk cId="299100102" sldId="397"/>
            <ac:spMk id="105" creationId="{D441D6E1-A983-A53B-9ADF-4F9118D62180}"/>
          </ac:spMkLst>
        </pc:spChg>
        <pc:spChg chg="mod">
          <ac:chgData name="Jorgensen, Rick" userId="22b7bd11-eb0f-413f-9bcb-9ce21ec7b0a8" providerId="ADAL" clId="{63C519A2-C2B2-47AC-828F-E429CD2FEDB2}" dt="2023-06-08T20:45:42.932" v="2495" actId="1076"/>
          <ac:spMkLst>
            <pc:docMk/>
            <pc:sldMk cId="299100102" sldId="397"/>
            <ac:spMk id="108" creationId="{AB0B669A-4242-8BF1-2D3A-99138A13C0C4}"/>
          </ac:spMkLst>
        </pc:spChg>
        <pc:picChg chg="add mod modCrop">
          <ac:chgData name="Jorgensen, Rick" userId="22b7bd11-eb0f-413f-9bcb-9ce21ec7b0a8" providerId="ADAL" clId="{63C519A2-C2B2-47AC-828F-E429CD2FEDB2}" dt="2023-06-08T20:45:42.932" v="2495" actId="1076"/>
          <ac:picMkLst>
            <pc:docMk/>
            <pc:sldMk cId="299100102" sldId="397"/>
            <ac:picMk id="3" creationId="{12E58C05-3AF1-F43A-3711-E982A1F9928F}"/>
          </ac:picMkLst>
        </pc:picChg>
        <pc:picChg chg="add mod modCrop">
          <ac:chgData name="Jorgensen, Rick" userId="22b7bd11-eb0f-413f-9bcb-9ce21ec7b0a8" providerId="ADAL" clId="{63C519A2-C2B2-47AC-828F-E429CD2FEDB2}" dt="2023-06-08T20:45:42.932" v="2495" actId="1076"/>
          <ac:picMkLst>
            <pc:docMk/>
            <pc:sldMk cId="299100102" sldId="397"/>
            <ac:picMk id="5" creationId="{BCC49389-5791-6572-92B9-EBEE2D717F91}"/>
          </ac:picMkLst>
        </pc:picChg>
        <pc:picChg chg="add mod modCrop">
          <ac:chgData name="Jorgensen, Rick" userId="22b7bd11-eb0f-413f-9bcb-9ce21ec7b0a8" providerId="ADAL" clId="{63C519A2-C2B2-47AC-828F-E429CD2FEDB2}" dt="2023-06-08T20:45:42.932" v="2495" actId="1076"/>
          <ac:picMkLst>
            <pc:docMk/>
            <pc:sldMk cId="299100102" sldId="397"/>
            <ac:picMk id="7" creationId="{31D08072-D8D0-FB0F-E636-270CEA7CC335}"/>
          </ac:picMkLst>
        </pc:picChg>
        <pc:picChg chg="add del">
          <ac:chgData name="Jorgensen, Rick" userId="22b7bd11-eb0f-413f-9bcb-9ce21ec7b0a8" providerId="ADAL" clId="{63C519A2-C2B2-47AC-828F-E429CD2FEDB2}" dt="2023-06-08T20:39:28.203" v="2413" actId="478"/>
          <ac:picMkLst>
            <pc:docMk/>
            <pc:sldMk cId="299100102" sldId="397"/>
            <ac:picMk id="8" creationId="{A72CFD26-8067-9D1B-B95C-20278E447098}"/>
          </ac:picMkLst>
        </pc:picChg>
        <pc:picChg chg="add mod modCrop">
          <ac:chgData name="Jorgensen, Rick" userId="22b7bd11-eb0f-413f-9bcb-9ce21ec7b0a8" providerId="ADAL" clId="{63C519A2-C2B2-47AC-828F-E429CD2FEDB2}" dt="2023-06-08T20:45:42.932" v="2495" actId="1076"/>
          <ac:picMkLst>
            <pc:docMk/>
            <pc:sldMk cId="299100102" sldId="397"/>
            <ac:picMk id="12" creationId="{9AFA4186-28D1-1BE7-AD29-872BCBC6F61B}"/>
          </ac:picMkLst>
        </pc:picChg>
        <pc:picChg chg="add mod modCrop">
          <ac:chgData name="Jorgensen, Rick" userId="22b7bd11-eb0f-413f-9bcb-9ce21ec7b0a8" providerId="ADAL" clId="{63C519A2-C2B2-47AC-828F-E429CD2FEDB2}" dt="2023-06-08T20:45:42.932" v="2495" actId="1076"/>
          <ac:picMkLst>
            <pc:docMk/>
            <pc:sldMk cId="299100102" sldId="397"/>
            <ac:picMk id="14" creationId="{032269AD-5D1F-FFFA-EE0C-AC42FF03C7B6}"/>
          </ac:picMkLst>
        </pc:picChg>
        <pc:picChg chg="add mod modCrop">
          <ac:chgData name="Jorgensen, Rick" userId="22b7bd11-eb0f-413f-9bcb-9ce21ec7b0a8" providerId="ADAL" clId="{63C519A2-C2B2-47AC-828F-E429CD2FEDB2}" dt="2023-06-08T20:45:42.932" v="2495" actId="1076"/>
          <ac:picMkLst>
            <pc:docMk/>
            <pc:sldMk cId="299100102" sldId="397"/>
            <ac:picMk id="18" creationId="{D41F7070-D792-5867-A7E0-31F323357543}"/>
          </ac:picMkLst>
        </pc:picChg>
        <pc:picChg chg="add del mod modCrop">
          <ac:chgData name="Jorgensen, Rick" userId="22b7bd11-eb0f-413f-9bcb-9ce21ec7b0a8" providerId="ADAL" clId="{63C519A2-C2B2-47AC-828F-E429CD2FEDB2}" dt="2023-06-08T20:42:38.592" v="2459" actId="478"/>
          <ac:picMkLst>
            <pc:docMk/>
            <pc:sldMk cId="299100102" sldId="397"/>
            <ac:picMk id="21" creationId="{4D35936A-BBED-B218-BD1C-8935ADE06CC4}"/>
          </ac:picMkLst>
        </pc:picChg>
        <pc:picChg chg="add mod modCrop">
          <ac:chgData name="Jorgensen, Rick" userId="22b7bd11-eb0f-413f-9bcb-9ce21ec7b0a8" providerId="ADAL" clId="{63C519A2-C2B2-47AC-828F-E429CD2FEDB2}" dt="2023-06-08T20:45:42.932" v="2495" actId="1076"/>
          <ac:picMkLst>
            <pc:docMk/>
            <pc:sldMk cId="299100102" sldId="397"/>
            <ac:picMk id="23" creationId="{36418CC3-0C68-71AA-D843-C6A9EC37A89A}"/>
          </ac:picMkLst>
        </pc:picChg>
        <pc:picChg chg="add mod modCrop">
          <ac:chgData name="Jorgensen, Rick" userId="22b7bd11-eb0f-413f-9bcb-9ce21ec7b0a8" providerId="ADAL" clId="{63C519A2-C2B2-47AC-828F-E429CD2FEDB2}" dt="2023-06-08T20:45:42.932" v="2495" actId="1076"/>
          <ac:picMkLst>
            <pc:docMk/>
            <pc:sldMk cId="299100102" sldId="397"/>
            <ac:picMk id="26" creationId="{DA719DD5-FB78-ED87-7FE6-722E71E82EA2}"/>
          </ac:picMkLst>
        </pc:picChg>
        <pc:picChg chg="add mod modCrop">
          <ac:chgData name="Jorgensen, Rick" userId="22b7bd11-eb0f-413f-9bcb-9ce21ec7b0a8" providerId="ADAL" clId="{63C519A2-C2B2-47AC-828F-E429CD2FEDB2}" dt="2023-06-08T20:45:42.932" v="2495" actId="1076"/>
          <ac:picMkLst>
            <pc:docMk/>
            <pc:sldMk cId="299100102" sldId="397"/>
            <ac:picMk id="28" creationId="{563D0730-CA0B-95DA-FC1B-E0C1CAC055CB}"/>
          </ac:picMkLst>
        </pc:picChg>
        <pc:picChg chg="del mod">
          <ac:chgData name="Jorgensen, Rick" userId="22b7bd11-eb0f-413f-9bcb-9ce21ec7b0a8" providerId="ADAL" clId="{63C519A2-C2B2-47AC-828F-E429CD2FEDB2}" dt="2023-06-08T20:36:19.592" v="2373" actId="478"/>
          <ac:picMkLst>
            <pc:docMk/>
            <pc:sldMk cId="299100102" sldId="397"/>
            <ac:picMk id="88" creationId="{67262DE4-1CAF-B8F0-3DF8-656909E6E9C3}"/>
          </ac:picMkLst>
        </pc:picChg>
        <pc:picChg chg="del mod">
          <ac:chgData name="Jorgensen, Rick" userId="22b7bd11-eb0f-413f-9bcb-9ce21ec7b0a8" providerId="ADAL" clId="{63C519A2-C2B2-47AC-828F-E429CD2FEDB2}" dt="2023-06-08T20:36:22.010" v="2375" actId="478"/>
          <ac:picMkLst>
            <pc:docMk/>
            <pc:sldMk cId="299100102" sldId="397"/>
            <ac:picMk id="90" creationId="{4C5BBF87-2E7A-B6B7-553B-26F213832CAE}"/>
          </ac:picMkLst>
        </pc:picChg>
        <pc:picChg chg="del mod">
          <ac:chgData name="Jorgensen, Rick" userId="22b7bd11-eb0f-413f-9bcb-9ce21ec7b0a8" providerId="ADAL" clId="{63C519A2-C2B2-47AC-828F-E429CD2FEDB2}" dt="2023-06-08T20:36:20.292" v="2374" actId="478"/>
          <ac:picMkLst>
            <pc:docMk/>
            <pc:sldMk cId="299100102" sldId="397"/>
            <ac:picMk id="92" creationId="{0ECF3F55-E9CA-2D1D-A76F-BF0EA6422FA7}"/>
          </ac:picMkLst>
        </pc:picChg>
        <pc:picChg chg="del mod">
          <ac:chgData name="Jorgensen, Rick" userId="22b7bd11-eb0f-413f-9bcb-9ce21ec7b0a8" providerId="ADAL" clId="{63C519A2-C2B2-47AC-828F-E429CD2FEDB2}" dt="2023-06-08T20:36:16.796" v="2368" actId="478"/>
          <ac:picMkLst>
            <pc:docMk/>
            <pc:sldMk cId="299100102" sldId="397"/>
            <ac:picMk id="96" creationId="{0DF7A5C5-4221-18F9-BF8C-5F78BCF059AF}"/>
          </ac:picMkLst>
        </pc:picChg>
        <pc:picChg chg="del mod">
          <ac:chgData name="Jorgensen, Rick" userId="22b7bd11-eb0f-413f-9bcb-9ce21ec7b0a8" providerId="ADAL" clId="{63C519A2-C2B2-47AC-828F-E429CD2FEDB2}" dt="2023-06-08T20:36:16.383" v="2367" actId="478"/>
          <ac:picMkLst>
            <pc:docMk/>
            <pc:sldMk cId="299100102" sldId="397"/>
            <ac:picMk id="98" creationId="{BDF343AA-E9D4-AFFE-27C9-B79C39FDCB85}"/>
          </ac:picMkLst>
        </pc:picChg>
        <pc:picChg chg="del mod">
          <ac:chgData name="Jorgensen, Rick" userId="22b7bd11-eb0f-413f-9bcb-9ce21ec7b0a8" providerId="ADAL" clId="{63C519A2-C2B2-47AC-828F-E429CD2FEDB2}" dt="2023-06-08T20:36:17.294" v="2369" actId="478"/>
          <ac:picMkLst>
            <pc:docMk/>
            <pc:sldMk cId="299100102" sldId="397"/>
            <ac:picMk id="100" creationId="{662601E4-F6B4-44B7-63C4-5BFF23596B2A}"/>
          </ac:picMkLst>
        </pc:picChg>
        <pc:picChg chg="del mod">
          <ac:chgData name="Jorgensen, Rick" userId="22b7bd11-eb0f-413f-9bcb-9ce21ec7b0a8" providerId="ADAL" clId="{63C519A2-C2B2-47AC-828F-E429CD2FEDB2}" dt="2023-06-08T20:36:18.952" v="2372" actId="478"/>
          <ac:picMkLst>
            <pc:docMk/>
            <pc:sldMk cId="299100102" sldId="397"/>
            <ac:picMk id="102" creationId="{B23D2D46-5729-78AB-69A0-765DE47B96D4}"/>
          </ac:picMkLst>
        </pc:picChg>
        <pc:picChg chg="del mod">
          <ac:chgData name="Jorgensen, Rick" userId="22b7bd11-eb0f-413f-9bcb-9ce21ec7b0a8" providerId="ADAL" clId="{63C519A2-C2B2-47AC-828F-E429CD2FEDB2}" dt="2023-06-08T20:36:18.435" v="2371" actId="478"/>
          <ac:picMkLst>
            <pc:docMk/>
            <pc:sldMk cId="299100102" sldId="397"/>
            <ac:picMk id="104" creationId="{59E53313-CD33-C522-0C5A-C40772E2886E}"/>
          </ac:picMkLst>
        </pc:picChg>
        <pc:picChg chg="del mod">
          <ac:chgData name="Jorgensen, Rick" userId="22b7bd11-eb0f-413f-9bcb-9ce21ec7b0a8" providerId="ADAL" clId="{63C519A2-C2B2-47AC-828F-E429CD2FEDB2}" dt="2023-06-08T20:36:17.832" v="2370" actId="478"/>
          <ac:picMkLst>
            <pc:docMk/>
            <pc:sldMk cId="299100102" sldId="397"/>
            <ac:picMk id="107" creationId="{02C06F37-38B6-78A9-5CC2-5FCEC31D8BCD}"/>
          </ac:picMkLst>
        </pc:picChg>
      </pc:sldChg>
      <pc:sldChg chg="add del">
        <pc:chgData name="Jorgensen, Rick" userId="22b7bd11-eb0f-413f-9bcb-9ce21ec7b0a8" providerId="ADAL" clId="{63C519A2-C2B2-47AC-828F-E429CD2FEDB2}" dt="2023-06-08T19:51:41.268" v="1855" actId="47"/>
        <pc:sldMkLst>
          <pc:docMk/>
          <pc:sldMk cId="2148448697" sldId="397"/>
        </pc:sldMkLst>
      </pc:sldChg>
      <pc:sldChg chg="modSp add mod ord">
        <pc:chgData name="Jorgensen, Rick" userId="22b7bd11-eb0f-413f-9bcb-9ce21ec7b0a8" providerId="ADAL" clId="{63C519A2-C2B2-47AC-828F-E429CD2FEDB2}" dt="2023-08-01T15:32:39.036" v="11723"/>
        <pc:sldMkLst>
          <pc:docMk/>
          <pc:sldMk cId="4258801853" sldId="398"/>
        </pc:sldMkLst>
        <pc:spChg chg="mod">
          <ac:chgData name="Jorgensen, Rick" userId="22b7bd11-eb0f-413f-9bcb-9ce21ec7b0a8" providerId="ADAL" clId="{63C519A2-C2B2-47AC-828F-E429CD2FEDB2}" dt="2023-07-17T14:58:42.627" v="6816" actId="20577"/>
          <ac:spMkLst>
            <pc:docMk/>
            <pc:sldMk cId="4258801853" sldId="398"/>
            <ac:spMk id="2" creationId="{00000000-0000-0000-0000-000000000000}"/>
          </ac:spMkLst>
        </pc:spChg>
        <pc:spChg chg="mod">
          <ac:chgData name="Jorgensen, Rick" userId="22b7bd11-eb0f-413f-9bcb-9ce21ec7b0a8" providerId="ADAL" clId="{63C519A2-C2B2-47AC-828F-E429CD2FEDB2}" dt="2023-06-08T20:33:50.412" v="2365" actId="20577"/>
          <ac:spMkLst>
            <pc:docMk/>
            <pc:sldMk cId="4258801853" sldId="398"/>
            <ac:spMk id="3" creationId="{00000000-0000-0000-0000-000000000000}"/>
          </ac:spMkLst>
        </pc:spChg>
      </pc:sldChg>
      <pc:sldChg chg="addSp delSp modSp new mod">
        <pc:chgData name="Jorgensen, Rick" userId="22b7bd11-eb0f-413f-9bcb-9ce21ec7b0a8" providerId="ADAL" clId="{63C519A2-C2B2-47AC-828F-E429CD2FEDB2}" dt="2023-06-28T15:37:53.094" v="6163" actId="1076"/>
        <pc:sldMkLst>
          <pc:docMk/>
          <pc:sldMk cId="2240995552" sldId="399"/>
        </pc:sldMkLst>
        <pc:spChg chg="add mod">
          <ac:chgData name="Jorgensen, Rick" userId="22b7bd11-eb0f-413f-9bcb-9ce21ec7b0a8" providerId="ADAL" clId="{63C519A2-C2B2-47AC-828F-E429CD2FEDB2}" dt="2023-06-14T18:56:20.405" v="3330" actId="1076"/>
          <ac:spMkLst>
            <pc:docMk/>
            <pc:sldMk cId="2240995552" sldId="399"/>
            <ac:spMk id="2" creationId="{52465DC4-63DB-B5C8-364D-A823D1989784}"/>
          </ac:spMkLst>
        </pc:spChg>
        <pc:spChg chg="add mod">
          <ac:chgData name="Jorgensen, Rick" userId="22b7bd11-eb0f-413f-9bcb-9ce21ec7b0a8" providerId="ADAL" clId="{63C519A2-C2B2-47AC-828F-E429CD2FEDB2}" dt="2023-06-23T18:42:22.978" v="5524" actId="14100"/>
          <ac:spMkLst>
            <pc:docMk/>
            <pc:sldMk cId="2240995552" sldId="399"/>
            <ac:spMk id="3" creationId="{12438F23-E3F3-0338-5192-7957B682E66B}"/>
          </ac:spMkLst>
        </pc:spChg>
        <pc:spChg chg="add del mod">
          <ac:chgData name="Jorgensen, Rick" userId="22b7bd11-eb0f-413f-9bcb-9ce21ec7b0a8" providerId="ADAL" clId="{63C519A2-C2B2-47AC-828F-E429CD2FEDB2}" dt="2023-06-23T18:26:41.201" v="5519" actId="478"/>
          <ac:spMkLst>
            <pc:docMk/>
            <pc:sldMk cId="2240995552" sldId="399"/>
            <ac:spMk id="7" creationId="{8E3E6909-4D00-56A5-3CDA-D09FCCAAD0E9}"/>
          </ac:spMkLst>
        </pc:spChg>
        <pc:spChg chg="add del mod">
          <ac:chgData name="Jorgensen, Rick" userId="22b7bd11-eb0f-413f-9bcb-9ce21ec7b0a8" providerId="ADAL" clId="{63C519A2-C2B2-47AC-828F-E429CD2FEDB2}" dt="2023-06-23T18:26:42.931" v="5521" actId="478"/>
          <ac:spMkLst>
            <pc:docMk/>
            <pc:sldMk cId="2240995552" sldId="399"/>
            <ac:spMk id="13" creationId="{08A973EE-E6AF-4CDA-2BCA-CE25D807E2A6}"/>
          </ac:spMkLst>
        </pc:spChg>
        <pc:spChg chg="add del mod">
          <ac:chgData name="Jorgensen, Rick" userId="22b7bd11-eb0f-413f-9bcb-9ce21ec7b0a8" providerId="ADAL" clId="{63C519A2-C2B2-47AC-828F-E429CD2FEDB2}" dt="2023-06-23T18:26:36.528" v="5516" actId="478"/>
          <ac:spMkLst>
            <pc:docMk/>
            <pc:sldMk cId="2240995552" sldId="399"/>
            <ac:spMk id="17" creationId="{1F5CD87B-7380-D481-9C1E-3604CC7CA78B}"/>
          </ac:spMkLst>
        </pc:spChg>
        <pc:picChg chg="add del mod">
          <ac:chgData name="Jorgensen, Rick" userId="22b7bd11-eb0f-413f-9bcb-9ce21ec7b0a8" providerId="ADAL" clId="{63C519A2-C2B2-47AC-828F-E429CD2FEDB2}" dt="2023-06-23T18:26:39.329" v="5518" actId="478"/>
          <ac:picMkLst>
            <pc:docMk/>
            <pc:sldMk cId="2240995552" sldId="399"/>
            <ac:picMk id="5" creationId="{315D2AF5-52CB-5675-AC0A-417E1EA85AD8}"/>
          </ac:picMkLst>
        </pc:picChg>
        <pc:picChg chg="add mod">
          <ac:chgData name="Jorgensen, Rick" userId="22b7bd11-eb0f-413f-9bcb-9ce21ec7b0a8" providerId="ADAL" clId="{63C519A2-C2B2-47AC-828F-E429CD2FEDB2}" dt="2023-06-23T18:26:46.505" v="5523" actId="1076"/>
          <ac:picMkLst>
            <pc:docMk/>
            <pc:sldMk cId="2240995552" sldId="399"/>
            <ac:picMk id="6" creationId="{7913A92E-CA2E-E6D1-FA56-0093CFBC7A9E}"/>
          </ac:picMkLst>
        </pc:picChg>
        <pc:picChg chg="add mod">
          <ac:chgData name="Jorgensen, Rick" userId="22b7bd11-eb0f-413f-9bcb-9ce21ec7b0a8" providerId="ADAL" clId="{63C519A2-C2B2-47AC-828F-E429CD2FEDB2}" dt="2023-06-28T15:37:53.094" v="6163" actId="1076"/>
          <ac:picMkLst>
            <pc:docMk/>
            <pc:sldMk cId="2240995552" sldId="399"/>
            <ac:picMk id="9" creationId="{64E58B52-3C93-C82B-D650-411B68E4358E}"/>
          </ac:picMkLst>
        </pc:picChg>
        <pc:picChg chg="add del mod">
          <ac:chgData name="Jorgensen, Rick" userId="22b7bd11-eb0f-413f-9bcb-9ce21ec7b0a8" providerId="ADAL" clId="{63C519A2-C2B2-47AC-828F-E429CD2FEDB2}" dt="2023-06-23T18:26:41.912" v="5520" actId="478"/>
          <ac:picMkLst>
            <pc:docMk/>
            <pc:sldMk cId="2240995552" sldId="399"/>
            <ac:picMk id="11" creationId="{6139CE36-DF3E-299A-0DFB-CDE8CD598B4A}"/>
          </ac:picMkLst>
        </pc:picChg>
        <pc:picChg chg="add del mod">
          <ac:chgData name="Jorgensen, Rick" userId="22b7bd11-eb0f-413f-9bcb-9ce21ec7b0a8" providerId="ADAL" clId="{63C519A2-C2B2-47AC-828F-E429CD2FEDB2}" dt="2023-06-23T18:26:35.343" v="5515" actId="478"/>
          <ac:picMkLst>
            <pc:docMk/>
            <pc:sldMk cId="2240995552" sldId="399"/>
            <ac:picMk id="15" creationId="{96362732-E72A-7E1A-9646-BDF22F5B457B}"/>
          </ac:picMkLst>
        </pc:picChg>
      </pc:sldChg>
      <pc:sldChg chg="addSp delSp modSp add mod">
        <pc:chgData name="Jorgensen, Rick" userId="22b7bd11-eb0f-413f-9bcb-9ce21ec7b0a8" providerId="ADAL" clId="{63C519A2-C2B2-47AC-828F-E429CD2FEDB2}" dt="2023-06-19T15:24:39.400" v="5293" actId="313"/>
        <pc:sldMkLst>
          <pc:docMk/>
          <pc:sldMk cId="2134229182" sldId="400"/>
        </pc:sldMkLst>
        <pc:spChg chg="mod">
          <ac:chgData name="Jorgensen, Rick" userId="22b7bd11-eb0f-413f-9bcb-9ce21ec7b0a8" providerId="ADAL" clId="{63C519A2-C2B2-47AC-828F-E429CD2FEDB2}" dt="2023-06-19T15:12:46.519" v="5290" actId="20577"/>
          <ac:spMkLst>
            <pc:docMk/>
            <pc:sldMk cId="2134229182" sldId="400"/>
            <ac:spMk id="2" creationId="{52465DC4-63DB-B5C8-364D-A823D1989784}"/>
          </ac:spMkLst>
        </pc:spChg>
        <pc:spChg chg="mod">
          <ac:chgData name="Jorgensen, Rick" userId="22b7bd11-eb0f-413f-9bcb-9ce21ec7b0a8" providerId="ADAL" clId="{63C519A2-C2B2-47AC-828F-E429CD2FEDB2}" dt="2023-06-19T15:24:39.400" v="5293" actId="313"/>
          <ac:spMkLst>
            <pc:docMk/>
            <pc:sldMk cId="2134229182" sldId="400"/>
            <ac:spMk id="3" creationId="{12438F23-E3F3-0338-5192-7957B682E66B}"/>
          </ac:spMkLst>
        </pc:spChg>
        <pc:spChg chg="del mod">
          <ac:chgData name="Jorgensen, Rick" userId="22b7bd11-eb0f-413f-9bcb-9ce21ec7b0a8" providerId="ADAL" clId="{63C519A2-C2B2-47AC-828F-E429CD2FEDB2}" dt="2023-06-14T19:20:09.123" v="4049" actId="478"/>
          <ac:spMkLst>
            <pc:docMk/>
            <pc:sldMk cId="2134229182" sldId="400"/>
            <ac:spMk id="7" creationId="{8E3E6909-4D00-56A5-3CDA-D09FCCAAD0E9}"/>
          </ac:spMkLst>
        </pc:spChg>
        <pc:spChg chg="del">
          <ac:chgData name="Jorgensen, Rick" userId="22b7bd11-eb0f-413f-9bcb-9ce21ec7b0a8" providerId="ADAL" clId="{63C519A2-C2B2-47AC-828F-E429CD2FEDB2}" dt="2023-06-14T19:20:05.819" v="4045" actId="478"/>
          <ac:spMkLst>
            <pc:docMk/>
            <pc:sldMk cId="2134229182" sldId="400"/>
            <ac:spMk id="13" creationId="{08A973EE-E6AF-4CDA-2BCA-CE25D807E2A6}"/>
          </ac:spMkLst>
        </pc:spChg>
        <pc:spChg chg="del">
          <ac:chgData name="Jorgensen, Rick" userId="22b7bd11-eb0f-413f-9bcb-9ce21ec7b0a8" providerId="ADAL" clId="{63C519A2-C2B2-47AC-828F-E429CD2FEDB2}" dt="2023-06-14T19:20:06.944" v="4046" actId="478"/>
          <ac:spMkLst>
            <pc:docMk/>
            <pc:sldMk cId="2134229182" sldId="400"/>
            <ac:spMk id="17" creationId="{1F5CD87B-7380-D481-9C1E-3604CC7CA78B}"/>
          </ac:spMkLst>
        </pc:spChg>
        <pc:picChg chg="del">
          <ac:chgData name="Jorgensen, Rick" userId="22b7bd11-eb0f-413f-9bcb-9ce21ec7b0a8" providerId="ADAL" clId="{63C519A2-C2B2-47AC-828F-E429CD2FEDB2}" dt="2023-06-14T19:20:09.650" v="4050" actId="478"/>
          <ac:picMkLst>
            <pc:docMk/>
            <pc:sldMk cId="2134229182" sldId="400"/>
            <ac:picMk id="5" creationId="{315D2AF5-52CB-5675-AC0A-417E1EA85AD8}"/>
          </ac:picMkLst>
        </pc:picChg>
        <pc:picChg chg="add mod">
          <ac:chgData name="Jorgensen, Rick" userId="22b7bd11-eb0f-413f-9bcb-9ce21ec7b0a8" providerId="ADAL" clId="{63C519A2-C2B2-47AC-828F-E429CD2FEDB2}" dt="2023-06-14T19:41:51.012" v="4962" actId="1076"/>
          <ac:picMkLst>
            <pc:docMk/>
            <pc:sldMk cId="2134229182" sldId="400"/>
            <ac:picMk id="6" creationId="{BCAF07B1-C24D-8D8A-91B6-30AF3C7DF5BE}"/>
          </ac:picMkLst>
        </pc:picChg>
        <pc:picChg chg="del">
          <ac:chgData name="Jorgensen, Rick" userId="22b7bd11-eb0f-413f-9bcb-9ce21ec7b0a8" providerId="ADAL" clId="{63C519A2-C2B2-47AC-828F-E429CD2FEDB2}" dt="2023-06-14T19:20:07.475" v="4047" actId="478"/>
          <ac:picMkLst>
            <pc:docMk/>
            <pc:sldMk cId="2134229182" sldId="400"/>
            <ac:picMk id="9" creationId="{64E58B52-3C93-C82B-D650-411B68E4358E}"/>
          </ac:picMkLst>
        </pc:picChg>
        <pc:picChg chg="add mod">
          <ac:chgData name="Jorgensen, Rick" userId="22b7bd11-eb0f-413f-9bcb-9ce21ec7b0a8" providerId="ADAL" clId="{63C519A2-C2B2-47AC-828F-E429CD2FEDB2}" dt="2023-06-14T19:42:17.461" v="4965" actId="1076"/>
          <ac:picMkLst>
            <pc:docMk/>
            <pc:sldMk cId="2134229182" sldId="400"/>
            <ac:picMk id="10" creationId="{4720E89C-C613-E89E-6371-AA9FE4374ABC}"/>
          </ac:picMkLst>
        </pc:picChg>
        <pc:picChg chg="del">
          <ac:chgData name="Jorgensen, Rick" userId="22b7bd11-eb0f-413f-9bcb-9ce21ec7b0a8" providerId="ADAL" clId="{63C519A2-C2B2-47AC-828F-E429CD2FEDB2}" dt="2023-06-14T19:20:04.719" v="4044" actId="478"/>
          <ac:picMkLst>
            <pc:docMk/>
            <pc:sldMk cId="2134229182" sldId="400"/>
            <ac:picMk id="11" creationId="{6139CE36-DF3E-299A-0DFB-CDE8CD598B4A}"/>
          </ac:picMkLst>
        </pc:picChg>
        <pc:picChg chg="del">
          <ac:chgData name="Jorgensen, Rick" userId="22b7bd11-eb0f-413f-9bcb-9ce21ec7b0a8" providerId="ADAL" clId="{63C519A2-C2B2-47AC-828F-E429CD2FEDB2}" dt="2023-06-14T19:20:06.944" v="4046" actId="478"/>
          <ac:picMkLst>
            <pc:docMk/>
            <pc:sldMk cId="2134229182" sldId="400"/>
            <ac:picMk id="15" creationId="{96362732-E72A-7E1A-9646-BDF22F5B457B}"/>
          </ac:picMkLst>
        </pc:picChg>
      </pc:sldChg>
      <pc:sldChg chg="addSp delSp modSp add mod ord modNotesTx">
        <pc:chgData name="Jorgensen, Rick" userId="22b7bd11-eb0f-413f-9bcb-9ce21ec7b0a8" providerId="ADAL" clId="{63C519A2-C2B2-47AC-828F-E429CD2FEDB2}" dt="2023-08-01T17:18:07.355" v="12591" actId="1076"/>
        <pc:sldMkLst>
          <pc:docMk/>
          <pc:sldMk cId="1669493757" sldId="401"/>
        </pc:sldMkLst>
        <pc:spChg chg="add del mod">
          <ac:chgData name="Jorgensen, Rick" userId="22b7bd11-eb0f-413f-9bcb-9ce21ec7b0a8" providerId="ADAL" clId="{63C519A2-C2B2-47AC-828F-E429CD2FEDB2}" dt="2023-07-05T14:18:28.734" v="6460" actId="478"/>
          <ac:spMkLst>
            <pc:docMk/>
            <pc:sldMk cId="1669493757" sldId="401"/>
            <ac:spMk id="2" creationId="{23DF294C-A100-E69F-9895-77109F4F8062}"/>
          </ac:spMkLst>
        </pc:spChg>
        <pc:spChg chg="add mod">
          <ac:chgData name="Jorgensen, Rick" userId="22b7bd11-eb0f-413f-9bcb-9ce21ec7b0a8" providerId="ADAL" clId="{63C519A2-C2B2-47AC-828F-E429CD2FEDB2}" dt="2023-08-01T17:17:47.548" v="12588" actId="1076"/>
          <ac:spMkLst>
            <pc:docMk/>
            <pc:sldMk cId="1669493757" sldId="401"/>
            <ac:spMk id="2" creationId="{A67035C2-4715-E15F-55F2-0611B5831114}"/>
          </ac:spMkLst>
        </pc:spChg>
        <pc:spChg chg="mod ord">
          <ac:chgData name="Jorgensen, Rick" userId="22b7bd11-eb0f-413f-9bcb-9ce21ec7b0a8" providerId="ADAL" clId="{63C519A2-C2B2-47AC-828F-E429CD2FEDB2}" dt="2023-07-31T18:27:33.951" v="10101" actId="1076"/>
          <ac:spMkLst>
            <pc:docMk/>
            <pc:sldMk cId="1669493757" sldId="401"/>
            <ac:spMk id="4" creationId="{495B3960-9843-4808-4E62-B7FC00D5322C}"/>
          </ac:spMkLst>
        </pc:spChg>
        <pc:spChg chg="del">
          <ac:chgData name="Jorgensen, Rick" userId="22b7bd11-eb0f-413f-9bcb-9ce21ec7b0a8" providerId="ADAL" clId="{63C519A2-C2B2-47AC-828F-E429CD2FEDB2}" dt="2023-06-23T20:09:13.038" v="5562" actId="478"/>
          <ac:spMkLst>
            <pc:docMk/>
            <pc:sldMk cId="1669493757" sldId="401"/>
            <ac:spMk id="5" creationId="{99CF073D-EC7F-22EF-1F2B-B06549DEF5C8}"/>
          </ac:spMkLst>
        </pc:spChg>
        <pc:spChg chg="add mod">
          <ac:chgData name="Jorgensen, Rick" userId="22b7bd11-eb0f-413f-9bcb-9ce21ec7b0a8" providerId="ADAL" clId="{63C519A2-C2B2-47AC-828F-E429CD2FEDB2}" dt="2023-07-31T18:27:57.847" v="10106" actId="14100"/>
          <ac:spMkLst>
            <pc:docMk/>
            <pc:sldMk cId="1669493757" sldId="401"/>
            <ac:spMk id="6" creationId="{53196C1B-981F-C47C-D616-E9D60C5EA985}"/>
          </ac:spMkLst>
        </pc:spChg>
        <pc:spChg chg="del mod ord">
          <ac:chgData name="Jorgensen, Rick" userId="22b7bd11-eb0f-413f-9bcb-9ce21ec7b0a8" providerId="ADAL" clId="{63C519A2-C2B2-47AC-828F-E429CD2FEDB2}" dt="2023-06-23T20:11:33.910" v="5610" actId="478"/>
          <ac:spMkLst>
            <pc:docMk/>
            <pc:sldMk cId="1669493757" sldId="401"/>
            <ac:spMk id="6" creationId="{83BBB045-CB98-E08E-EA16-DFEADABF8380}"/>
          </ac:spMkLst>
        </pc:spChg>
        <pc:spChg chg="add mod topLvl">
          <ac:chgData name="Jorgensen, Rick" userId="22b7bd11-eb0f-413f-9bcb-9ce21ec7b0a8" providerId="ADAL" clId="{63C519A2-C2B2-47AC-828F-E429CD2FEDB2}" dt="2023-08-01T14:36:33.826" v="10300" actId="1076"/>
          <ac:spMkLst>
            <pc:docMk/>
            <pc:sldMk cId="1669493757" sldId="401"/>
            <ac:spMk id="7" creationId="{4B6DDF8D-759C-B53C-1FB3-98DFE1E9AFBE}"/>
          </ac:spMkLst>
        </pc:spChg>
        <pc:spChg chg="del mod">
          <ac:chgData name="Jorgensen, Rick" userId="22b7bd11-eb0f-413f-9bcb-9ce21ec7b0a8" providerId="ADAL" clId="{63C519A2-C2B2-47AC-828F-E429CD2FEDB2}" dt="2023-06-23T20:11:34.968" v="5611" actId="478"/>
          <ac:spMkLst>
            <pc:docMk/>
            <pc:sldMk cId="1669493757" sldId="401"/>
            <ac:spMk id="7" creationId="{D2E320E8-01EE-826A-37D7-9B726CD791F0}"/>
          </ac:spMkLst>
        </pc:spChg>
        <pc:spChg chg="mod">
          <ac:chgData name="Jorgensen, Rick" userId="22b7bd11-eb0f-413f-9bcb-9ce21ec7b0a8" providerId="ADAL" clId="{63C519A2-C2B2-47AC-828F-E429CD2FEDB2}" dt="2023-08-01T14:33:34.079" v="10264" actId="1076"/>
          <ac:spMkLst>
            <pc:docMk/>
            <pc:sldMk cId="1669493757" sldId="401"/>
            <ac:spMk id="9" creationId="{090E3AC6-72C7-E48F-824F-47B306FEB8B6}"/>
          </ac:spMkLst>
        </pc:spChg>
        <pc:spChg chg="del mod ord">
          <ac:chgData name="Jorgensen, Rick" userId="22b7bd11-eb0f-413f-9bcb-9ce21ec7b0a8" providerId="ADAL" clId="{63C519A2-C2B2-47AC-828F-E429CD2FEDB2}" dt="2023-07-05T14:03:15.061" v="6414" actId="478"/>
          <ac:spMkLst>
            <pc:docMk/>
            <pc:sldMk cId="1669493757" sldId="401"/>
            <ac:spMk id="10" creationId="{F1A3FC5D-620F-9258-8E5C-AC2FE122170C}"/>
          </ac:spMkLst>
        </pc:spChg>
        <pc:spChg chg="del mod ord">
          <ac:chgData name="Jorgensen, Rick" userId="22b7bd11-eb0f-413f-9bcb-9ce21ec7b0a8" providerId="ADAL" clId="{63C519A2-C2B2-47AC-828F-E429CD2FEDB2}" dt="2023-07-05T14:03:15.991" v="6415" actId="478"/>
          <ac:spMkLst>
            <pc:docMk/>
            <pc:sldMk cId="1669493757" sldId="401"/>
            <ac:spMk id="11" creationId="{622FA3CC-3D01-6213-A20F-73FE36504AAF}"/>
          </ac:spMkLst>
        </pc:spChg>
        <pc:spChg chg="mod">
          <ac:chgData name="Jorgensen, Rick" userId="22b7bd11-eb0f-413f-9bcb-9ce21ec7b0a8" providerId="ADAL" clId="{63C519A2-C2B2-47AC-828F-E429CD2FEDB2}" dt="2023-08-01T14:39:35.803" v="10379"/>
          <ac:spMkLst>
            <pc:docMk/>
            <pc:sldMk cId="1669493757" sldId="401"/>
            <ac:spMk id="11" creationId="{C2475E3B-8F52-2702-DD36-4F7E7B86CB5A}"/>
          </ac:spMkLst>
        </pc:spChg>
        <pc:spChg chg="add mod topLvl">
          <ac:chgData name="Jorgensen, Rick" userId="22b7bd11-eb0f-413f-9bcb-9ce21ec7b0a8" providerId="ADAL" clId="{63C519A2-C2B2-47AC-828F-E429CD2FEDB2}" dt="2023-08-01T14:36:30.453" v="10299" actId="1076"/>
          <ac:spMkLst>
            <pc:docMk/>
            <pc:sldMk cId="1669493757" sldId="401"/>
            <ac:spMk id="12" creationId="{9C02250F-D86B-7969-63A2-9AD465F62767}"/>
          </ac:spMkLst>
        </pc:spChg>
        <pc:spChg chg="del">
          <ac:chgData name="Jorgensen, Rick" userId="22b7bd11-eb0f-413f-9bcb-9ce21ec7b0a8" providerId="ADAL" clId="{63C519A2-C2B2-47AC-828F-E429CD2FEDB2}" dt="2023-06-23T20:09:05.541" v="5560" actId="478"/>
          <ac:spMkLst>
            <pc:docMk/>
            <pc:sldMk cId="1669493757" sldId="401"/>
            <ac:spMk id="12" creationId="{CDC53B9C-8D5D-AD16-E044-2DF3881169E5}"/>
          </ac:spMkLst>
        </pc:spChg>
        <pc:spChg chg="add del mod">
          <ac:chgData name="Jorgensen, Rick" userId="22b7bd11-eb0f-413f-9bcb-9ce21ec7b0a8" providerId="ADAL" clId="{63C519A2-C2B2-47AC-828F-E429CD2FEDB2}" dt="2023-07-05T14:03:16.808" v="6416" actId="478"/>
          <ac:spMkLst>
            <pc:docMk/>
            <pc:sldMk cId="1669493757" sldId="401"/>
            <ac:spMk id="14" creationId="{3A8BACC0-374E-D830-6218-C37687C3BC2B}"/>
          </ac:spMkLst>
        </pc:spChg>
        <pc:spChg chg="add del mod">
          <ac:chgData name="Jorgensen, Rick" userId="22b7bd11-eb0f-413f-9bcb-9ce21ec7b0a8" providerId="ADAL" clId="{63C519A2-C2B2-47AC-828F-E429CD2FEDB2}" dt="2023-07-31T18:32:38.014" v="10151" actId="478"/>
          <ac:spMkLst>
            <pc:docMk/>
            <pc:sldMk cId="1669493757" sldId="401"/>
            <ac:spMk id="14" creationId="{DE330636-4DDE-1441-7462-DE6D0D32BDFF}"/>
          </ac:spMkLst>
        </pc:spChg>
        <pc:spChg chg="add del mod">
          <ac:chgData name="Jorgensen, Rick" userId="22b7bd11-eb0f-413f-9bcb-9ce21ec7b0a8" providerId="ADAL" clId="{63C519A2-C2B2-47AC-828F-E429CD2FEDB2}" dt="2023-07-05T14:03:17.539" v="6417" actId="478"/>
          <ac:spMkLst>
            <pc:docMk/>
            <pc:sldMk cId="1669493757" sldId="401"/>
            <ac:spMk id="15" creationId="{0BF8E532-DC19-2BC2-7F82-36CE087B7685}"/>
          </ac:spMkLst>
        </pc:spChg>
        <pc:spChg chg="add del mod">
          <ac:chgData name="Jorgensen, Rick" userId="22b7bd11-eb0f-413f-9bcb-9ce21ec7b0a8" providerId="ADAL" clId="{63C519A2-C2B2-47AC-828F-E429CD2FEDB2}" dt="2023-07-31T18:35:48.656" v="10181" actId="478"/>
          <ac:spMkLst>
            <pc:docMk/>
            <pc:sldMk cId="1669493757" sldId="401"/>
            <ac:spMk id="15" creationId="{8BE78D13-808E-254F-712F-8A3489825696}"/>
          </ac:spMkLst>
        </pc:spChg>
        <pc:spChg chg="add mod topLvl">
          <ac:chgData name="Jorgensen, Rick" userId="22b7bd11-eb0f-413f-9bcb-9ce21ec7b0a8" providerId="ADAL" clId="{63C519A2-C2B2-47AC-828F-E429CD2FEDB2}" dt="2023-08-01T14:36:38.080" v="10301" actId="1076"/>
          <ac:spMkLst>
            <pc:docMk/>
            <pc:sldMk cId="1669493757" sldId="401"/>
            <ac:spMk id="16" creationId="{4805E3FD-DCB2-0BB9-9058-3147DF8B4680}"/>
          </ac:spMkLst>
        </pc:spChg>
        <pc:spChg chg="mod">
          <ac:chgData name="Jorgensen, Rick" userId="22b7bd11-eb0f-413f-9bcb-9ce21ec7b0a8" providerId="ADAL" clId="{63C519A2-C2B2-47AC-828F-E429CD2FEDB2}" dt="2023-07-05T14:02:09.596" v="6405" actId="1076"/>
          <ac:spMkLst>
            <pc:docMk/>
            <pc:sldMk cId="1669493757" sldId="401"/>
            <ac:spMk id="20" creationId="{18ACA03B-AB41-D2CB-1F2A-94AE5B70AF66}"/>
          </ac:spMkLst>
        </pc:spChg>
        <pc:spChg chg="mod topLvl">
          <ac:chgData name="Jorgensen, Rick" userId="22b7bd11-eb0f-413f-9bcb-9ce21ec7b0a8" providerId="ADAL" clId="{63C519A2-C2B2-47AC-828F-E429CD2FEDB2}" dt="2023-08-01T16:59:11.709" v="12538" actId="1076"/>
          <ac:spMkLst>
            <pc:docMk/>
            <pc:sldMk cId="1669493757" sldId="401"/>
            <ac:spMk id="23" creationId="{284B7F6D-6FA7-F817-EC12-BB6E86CE5352}"/>
          </ac:spMkLst>
        </pc:spChg>
        <pc:spChg chg="mod topLvl">
          <ac:chgData name="Jorgensen, Rick" userId="22b7bd11-eb0f-413f-9bcb-9ce21ec7b0a8" providerId="ADAL" clId="{63C519A2-C2B2-47AC-828F-E429CD2FEDB2}" dt="2023-08-01T16:59:19.783" v="12540" actId="1076"/>
          <ac:spMkLst>
            <pc:docMk/>
            <pc:sldMk cId="1669493757" sldId="401"/>
            <ac:spMk id="24" creationId="{E45C231E-381E-D28E-6C98-31401C18275D}"/>
          </ac:spMkLst>
        </pc:spChg>
        <pc:spChg chg="mod topLvl">
          <ac:chgData name="Jorgensen, Rick" userId="22b7bd11-eb0f-413f-9bcb-9ce21ec7b0a8" providerId="ADAL" clId="{63C519A2-C2B2-47AC-828F-E429CD2FEDB2}" dt="2023-08-01T16:58:55.683" v="12535" actId="1076"/>
          <ac:spMkLst>
            <pc:docMk/>
            <pc:sldMk cId="1669493757" sldId="401"/>
            <ac:spMk id="26" creationId="{5FBA09B1-30DE-4414-5EC5-2AAF0FFFF145}"/>
          </ac:spMkLst>
        </pc:spChg>
        <pc:spChg chg="add mod">
          <ac:chgData name="Jorgensen, Rick" userId="22b7bd11-eb0f-413f-9bcb-9ce21ec7b0a8" providerId="ADAL" clId="{63C519A2-C2B2-47AC-828F-E429CD2FEDB2}" dt="2023-07-05T14:19:47.730" v="6464" actId="1076"/>
          <ac:spMkLst>
            <pc:docMk/>
            <pc:sldMk cId="1669493757" sldId="401"/>
            <ac:spMk id="27" creationId="{E2771ECE-5DCB-462F-06B7-764677C016C9}"/>
          </ac:spMkLst>
        </pc:spChg>
        <pc:spChg chg="mod">
          <ac:chgData name="Jorgensen, Rick" userId="22b7bd11-eb0f-413f-9bcb-9ce21ec7b0a8" providerId="ADAL" clId="{63C519A2-C2B2-47AC-828F-E429CD2FEDB2}" dt="2023-08-01T17:17:18.930" v="12546" actId="1076"/>
          <ac:spMkLst>
            <pc:docMk/>
            <pc:sldMk cId="1669493757" sldId="401"/>
            <ac:spMk id="30" creationId="{96EBF163-66BA-7175-EBCC-053C656F4BD8}"/>
          </ac:spMkLst>
        </pc:spChg>
        <pc:spChg chg="mod">
          <ac:chgData name="Jorgensen, Rick" userId="22b7bd11-eb0f-413f-9bcb-9ce21ec7b0a8" providerId="ADAL" clId="{63C519A2-C2B2-47AC-828F-E429CD2FEDB2}" dt="2023-08-01T17:17:27.798" v="12548" actId="1076"/>
          <ac:spMkLst>
            <pc:docMk/>
            <pc:sldMk cId="1669493757" sldId="401"/>
            <ac:spMk id="31" creationId="{91AAAAC7-6885-C8D8-FF68-B4CBC16AFB20}"/>
          </ac:spMkLst>
        </pc:spChg>
        <pc:spChg chg="mod">
          <ac:chgData name="Jorgensen, Rick" userId="22b7bd11-eb0f-413f-9bcb-9ce21ec7b0a8" providerId="ADAL" clId="{63C519A2-C2B2-47AC-828F-E429CD2FEDB2}" dt="2023-08-01T17:17:15.388" v="12545" actId="1076"/>
          <ac:spMkLst>
            <pc:docMk/>
            <pc:sldMk cId="1669493757" sldId="401"/>
            <ac:spMk id="33" creationId="{362A70EB-5AEC-BEE5-0349-1D347E21CA30}"/>
          </ac:spMkLst>
        </pc:spChg>
        <pc:spChg chg="mod">
          <ac:chgData name="Jorgensen, Rick" userId="22b7bd11-eb0f-413f-9bcb-9ce21ec7b0a8" providerId="ADAL" clId="{63C519A2-C2B2-47AC-828F-E429CD2FEDB2}" dt="2023-08-01T17:18:02.085" v="12590" actId="1076"/>
          <ac:spMkLst>
            <pc:docMk/>
            <pc:sldMk cId="1669493757" sldId="401"/>
            <ac:spMk id="35" creationId="{08E7F307-1C22-F738-20A0-ABFCBD252D95}"/>
          </ac:spMkLst>
        </pc:spChg>
        <pc:spChg chg="mod">
          <ac:chgData name="Jorgensen, Rick" userId="22b7bd11-eb0f-413f-9bcb-9ce21ec7b0a8" providerId="ADAL" clId="{63C519A2-C2B2-47AC-828F-E429CD2FEDB2}" dt="2023-08-01T17:18:07.355" v="12591" actId="1076"/>
          <ac:spMkLst>
            <pc:docMk/>
            <pc:sldMk cId="1669493757" sldId="401"/>
            <ac:spMk id="36" creationId="{A9DD38FB-1B9C-3D78-C8D0-53408BB3CB89}"/>
          </ac:spMkLst>
        </pc:spChg>
        <pc:spChg chg="mod">
          <ac:chgData name="Jorgensen, Rick" userId="22b7bd11-eb0f-413f-9bcb-9ce21ec7b0a8" providerId="ADAL" clId="{63C519A2-C2B2-47AC-828F-E429CD2FEDB2}" dt="2023-08-01T17:17:57.386" v="12589" actId="1076"/>
          <ac:spMkLst>
            <pc:docMk/>
            <pc:sldMk cId="1669493757" sldId="401"/>
            <ac:spMk id="38" creationId="{F676AF7C-47EB-665D-1E0A-FA5A7C9EF0CA}"/>
          </ac:spMkLst>
        </pc:spChg>
        <pc:spChg chg="add mod">
          <ac:chgData name="Jorgensen, Rick" userId="22b7bd11-eb0f-413f-9bcb-9ce21ec7b0a8" providerId="ADAL" clId="{63C519A2-C2B2-47AC-828F-E429CD2FEDB2}" dt="2023-07-31T18:28:42.225" v="10117" actId="1076"/>
          <ac:spMkLst>
            <pc:docMk/>
            <pc:sldMk cId="1669493757" sldId="401"/>
            <ac:spMk id="39" creationId="{677E063F-51CA-7574-462D-882B671FDC01}"/>
          </ac:spMkLst>
        </pc:spChg>
        <pc:spChg chg="add mod">
          <ac:chgData name="Jorgensen, Rick" userId="22b7bd11-eb0f-413f-9bcb-9ce21ec7b0a8" providerId="ADAL" clId="{63C519A2-C2B2-47AC-828F-E429CD2FEDB2}" dt="2023-07-05T14:37:39.816" v="6498" actId="20577"/>
          <ac:spMkLst>
            <pc:docMk/>
            <pc:sldMk cId="1669493757" sldId="401"/>
            <ac:spMk id="41" creationId="{0CE2C16E-EDE0-A6CB-450C-7CC9E92C73CE}"/>
          </ac:spMkLst>
        </pc:spChg>
        <pc:grpChg chg="add mod">
          <ac:chgData name="Jorgensen, Rick" userId="22b7bd11-eb0f-413f-9bcb-9ce21ec7b0a8" providerId="ADAL" clId="{63C519A2-C2B2-47AC-828F-E429CD2FEDB2}" dt="2023-08-01T14:39:42.670" v="10380" actId="1076"/>
          <ac:grpSpMkLst>
            <pc:docMk/>
            <pc:sldMk cId="1669493757" sldId="401"/>
            <ac:grpSpMk id="3" creationId="{7715983F-9F06-3651-A36E-8EC6F599D4EB}"/>
          </ac:grpSpMkLst>
        </pc:grpChg>
        <pc:grpChg chg="add del mod">
          <ac:chgData name="Jorgensen, Rick" userId="22b7bd11-eb0f-413f-9bcb-9ce21ec7b0a8" providerId="ADAL" clId="{63C519A2-C2B2-47AC-828F-E429CD2FEDB2}" dt="2023-07-31T18:30:35.780" v="10139" actId="165"/>
          <ac:grpSpMkLst>
            <pc:docMk/>
            <pc:sldMk cId="1669493757" sldId="401"/>
            <ac:grpSpMk id="19" creationId="{68B11417-71FE-8FD6-0490-DB23C6AD49F9}"/>
          </ac:grpSpMkLst>
        </pc:grpChg>
        <pc:grpChg chg="mod">
          <ac:chgData name="Jorgensen, Rick" userId="22b7bd11-eb0f-413f-9bcb-9ce21ec7b0a8" providerId="ADAL" clId="{63C519A2-C2B2-47AC-828F-E429CD2FEDB2}" dt="2023-07-31T18:36:27.617" v="10187" actId="14100"/>
          <ac:grpSpMkLst>
            <pc:docMk/>
            <pc:sldMk cId="1669493757" sldId="401"/>
            <ac:grpSpMk id="21" creationId="{D4C63643-32D5-AD70-A424-F738A1382502}"/>
          </ac:grpSpMkLst>
        </pc:grpChg>
        <pc:grpChg chg="add del mod">
          <ac:chgData name="Jorgensen, Rick" userId="22b7bd11-eb0f-413f-9bcb-9ce21ec7b0a8" providerId="ADAL" clId="{63C519A2-C2B2-47AC-828F-E429CD2FEDB2}" dt="2023-07-31T18:30:41.371" v="10140" actId="165"/>
          <ac:grpSpMkLst>
            <pc:docMk/>
            <pc:sldMk cId="1669493757" sldId="401"/>
            <ac:grpSpMk id="22" creationId="{FB5622C0-4E2B-9E16-C529-293A0A3D017A}"/>
          </ac:grpSpMkLst>
        </pc:grpChg>
        <pc:grpChg chg="add mod ord">
          <ac:chgData name="Jorgensen, Rick" userId="22b7bd11-eb0f-413f-9bcb-9ce21ec7b0a8" providerId="ADAL" clId="{63C519A2-C2B2-47AC-828F-E429CD2FEDB2}" dt="2023-07-05T14:37:21.994" v="6494" actId="164"/>
          <ac:grpSpMkLst>
            <pc:docMk/>
            <pc:sldMk cId="1669493757" sldId="401"/>
            <ac:grpSpMk id="29" creationId="{12EBB07B-1E4D-FB2C-0ABC-6896F8A2B382}"/>
          </ac:grpSpMkLst>
        </pc:grpChg>
        <pc:grpChg chg="add mod ord">
          <ac:chgData name="Jorgensen, Rick" userId="22b7bd11-eb0f-413f-9bcb-9ce21ec7b0a8" providerId="ADAL" clId="{63C519A2-C2B2-47AC-828F-E429CD2FEDB2}" dt="2023-07-05T14:37:21.994" v="6494" actId="164"/>
          <ac:grpSpMkLst>
            <pc:docMk/>
            <pc:sldMk cId="1669493757" sldId="401"/>
            <ac:grpSpMk id="34" creationId="{C1B0B2A5-E54C-B2F9-F37C-DE645E9B381B}"/>
          </ac:grpSpMkLst>
        </pc:grpChg>
        <pc:grpChg chg="add mod ord">
          <ac:chgData name="Jorgensen, Rick" userId="22b7bd11-eb0f-413f-9bcb-9ce21ec7b0a8" providerId="ADAL" clId="{63C519A2-C2B2-47AC-828F-E429CD2FEDB2}" dt="2023-07-31T18:32:21.017" v="10146" actId="1076"/>
          <ac:grpSpMkLst>
            <pc:docMk/>
            <pc:sldMk cId="1669493757" sldId="401"/>
            <ac:grpSpMk id="40" creationId="{04430BE8-1F8E-C9D4-9838-46B809DE0000}"/>
          </ac:grpSpMkLst>
        </pc:grpChg>
        <pc:graphicFrameChg chg="del">
          <ac:chgData name="Jorgensen, Rick" userId="22b7bd11-eb0f-413f-9bcb-9ce21ec7b0a8" providerId="ADAL" clId="{63C519A2-C2B2-47AC-828F-E429CD2FEDB2}" dt="2023-06-23T20:09:07.104" v="5561" actId="478"/>
          <ac:graphicFrameMkLst>
            <pc:docMk/>
            <pc:sldMk cId="1669493757" sldId="401"/>
            <ac:graphicFrameMk id="2" creationId="{592A93F4-298B-4ABA-9C61-D652FCE6EC05}"/>
          </ac:graphicFrameMkLst>
        </pc:graphicFrameChg>
        <pc:graphicFrameChg chg="add del mod">
          <ac:chgData name="Jorgensen, Rick" userId="22b7bd11-eb0f-413f-9bcb-9ce21ec7b0a8" providerId="ADAL" clId="{63C519A2-C2B2-47AC-828F-E429CD2FEDB2}" dt="2023-07-05T14:01:45.859" v="6399" actId="478"/>
          <ac:graphicFrameMkLst>
            <pc:docMk/>
            <pc:sldMk cId="1669493757" sldId="401"/>
            <ac:graphicFrameMk id="3" creationId="{4936B1E3-6CC8-4944-870F-DC784E261689}"/>
          </ac:graphicFrameMkLst>
        </pc:graphicFrameChg>
        <pc:graphicFrameChg chg="add mod ord">
          <ac:chgData name="Jorgensen, Rick" userId="22b7bd11-eb0f-413f-9bcb-9ce21ec7b0a8" providerId="ADAL" clId="{63C519A2-C2B2-47AC-828F-E429CD2FEDB2}" dt="2023-07-31T18:27:04.480" v="10095" actId="14100"/>
          <ac:graphicFrameMkLst>
            <pc:docMk/>
            <pc:sldMk cId="1669493757" sldId="401"/>
            <ac:graphicFrameMk id="5" creationId="{4936B1E3-6CC8-4944-870F-DC784E261689}"/>
          </ac:graphicFrameMkLst>
        </pc:graphicFrameChg>
        <pc:graphicFrameChg chg="del">
          <ac:chgData name="Jorgensen, Rick" userId="22b7bd11-eb0f-413f-9bcb-9ce21ec7b0a8" providerId="ADAL" clId="{63C519A2-C2B2-47AC-828F-E429CD2FEDB2}" dt="2023-06-23T20:09:02.337" v="5559" actId="478"/>
          <ac:graphicFrameMkLst>
            <pc:docMk/>
            <pc:sldMk cId="1669493757" sldId="401"/>
            <ac:graphicFrameMk id="13" creationId="{B9927E7C-5754-4AEE-AAA8-51827D794FDD}"/>
          </ac:graphicFrameMkLst>
        </pc:graphicFrameChg>
        <pc:graphicFrameChg chg="add del mod">
          <ac:chgData name="Jorgensen, Rick" userId="22b7bd11-eb0f-413f-9bcb-9ce21ec7b0a8" providerId="ADAL" clId="{63C519A2-C2B2-47AC-828F-E429CD2FEDB2}" dt="2023-07-31T18:30:09.097" v="10130" actId="1076"/>
          <ac:graphicFrameMkLst>
            <pc:docMk/>
            <pc:sldMk cId="1669493757" sldId="401"/>
            <ac:graphicFrameMk id="28" creationId="{790296B3-2828-B0AD-A833-381165133C68}"/>
          </ac:graphicFrameMkLst>
        </pc:graphicFrameChg>
        <pc:cxnChg chg="mod">
          <ac:chgData name="Jorgensen, Rick" userId="22b7bd11-eb0f-413f-9bcb-9ce21ec7b0a8" providerId="ADAL" clId="{63C519A2-C2B2-47AC-828F-E429CD2FEDB2}" dt="2023-08-01T14:39:35.803" v="10379"/>
          <ac:cxnSpMkLst>
            <pc:docMk/>
            <pc:sldMk cId="1669493757" sldId="401"/>
            <ac:cxnSpMk id="10" creationId="{ED5B5DAB-DEC0-E247-8F35-11F5C96070D6}"/>
          </ac:cxnSpMkLst>
        </pc:cxnChg>
        <pc:cxnChg chg="add del">
          <ac:chgData name="Jorgensen, Rick" userId="22b7bd11-eb0f-413f-9bcb-9ce21ec7b0a8" providerId="ADAL" clId="{63C519A2-C2B2-47AC-828F-E429CD2FEDB2}" dt="2023-07-31T18:32:00.402" v="10143" actId="478"/>
          <ac:cxnSpMkLst>
            <pc:docMk/>
            <pc:sldMk cId="1669493757" sldId="401"/>
            <ac:cxnSpMk id="11" creationId="{78BCB988-AEDC-6D78-0C7C-2BF01FBC1AE3}"/>
          </ac:cxnSpMkLst>
        </pc:cxnChg>
        <pc:cxnChg chg="add mod topLvl">
          <ac:chgData name="Jorgensen, Rick" userId="22b7bd11-eb0f-413f-9bcb-9ce21ec7b0a8" providerId="ADAL" clId="{63C519A2-C2B2-47AC-828F-E429CD2FEDB2}" dt="2023-08-01T14:36:38.080" v="10301" actId="1076"/>
          <ac:cxnSpMkLst>
            <pc:docMk/>
            <pc:sldMk cId="1669493757" sldId="401"/>
            <ac:cxnSpMk id="13" creationId="{E0BA00E6-FAE7-7B67-8938-93278C0E000E}"/>
          </ac:cxnSpMkLst>
        </pc:cxnChg>
        <pc:cxnChg chg="mod">
          <ac:chgData name="Jorgensen, Rick" userId="22b7bd11-eb0f-413f-9bcb-9ce21ec7b0a8" providerId="ADAL" clId="{63C519A2-C2B2-47AC-828F-E429CD2FEDB2}" dt="2023-07-31T18:36:30.121" v="10188" actId="692"/>
          <ac:cxnSpMkLst>
            <pc:docMk/>
            <pc:sldMk cId="1669493757" sldId="401"/>
            <ac:cxnSpMk id="18" creationId="{4360E467-0D4F-6D3C-C1F0-603651439336}"/>
          </ac:cxnSpMkLst>
        </pc:cxnChg>
        <pc:cxnChg chg="mod topLvl">
          <ac:chgData name="Jorgensen, Rick" userId="22b7bd11-eb0f-413f-9bcb-9ce21ec7b0a8" providerId="ADAL" clId="{63C519A2-C2B2-47AC-828F-E429CD2FEDB2}" dt="2023-08-01T16:59:01.933" v="12536" actId="1076"/>
          <ac:cxnSpMkLst>
            <pc:docMk/>
            <pc:sldMk cId="1669493757" sldId="401"/>
            <ac:cxnSpMk id="25" creationId="{2F5207EF-12FB-6A7F-C330-C883B8F62BFF}"/>
          </ac:cxnSpMkLst>
        </pc:cxnChg>
        <pc:cxnChg chg="mod">
          <ac:chgData name="Jorgensen, Rick" userId="22b7bd11-eb0f-413f-9bcb-9ce21ec7b0a8" providerId="ADAL" clId="{63C519A2-C2B2-47AC-828F-E429CD2FEDB2}" dt="2023-08-01T17:17:15.388" v="12545" actId="1076"/>
          <ac:cxnSpMkLst>
            <pc:docMk/>
            <pc:sldMk cId="1669493757" sldId="401"/>
            <ac:cxnSpMk id="32" creationId="{6B536ABB-FD76-1E9D-9481-AD606780277E}"/>
          </ac:cxnSpMkLst>
        </pc:cxnChg>
        <pc:cxnChg chg="mod">
          <ac:chgData name="Jorgensen, Rick" userId="22b7bd11-eb0f-413f-9bcb-9ce21ec7b0a8" providerId="ADAL" clId="{63C519A2-C2B2-47AC-828F-E429CD2FEDB2}" dt="2023-08-01T17:17:57.386" v="12589" actId="1076"/>
          <ac:cxnSpMkLst>
            <pc:docMk/>
            <pc:sldMk cId="1669493757" sldId="401"/>
            <ac:cxnSpMk id="37" creationId="{A3C9F576-2758-3876-F615-20B6C366F399}"/>
          </ac:cxnSpMkLst>
        </pc:cxnChg>
      </pc:sldChg>
      <pc:sldChg chg="addSp delSp modSp add mod">
        <pc:chgData name="Jorgensen, Rick" userId="22b7bd11-eb0f-413f-9bcb-9ce21ec7b0a8" providerId="ADAL" clId="{63C519A2-C2B2-47AC-828F-E429CD2FEDB2}" dt="2023-08-01T14:57:33.076" v="10765" actId="207"/>
        <pc:sldMkLst>
          <pc:docMk/>
          <pc:sldMk cId="329471573" sldId="402"/>
        </pc:sldMkLst>
        <pc:spChg chg="mod">
          <ac:chgData name="Jorgensen, Rick" userId="22b7bd11-eb0f-413f-9bcb-9ce21ec7b0a8" providerId="ADAL" clId="{63C519A2-C2B2-47AC-828F-E429CD2FEDB2}" dt="2023-06-23T21:13:16.477" v="5820" actId="20577"/>
          <ac:spMkLst>
            <pc:docMk/>
            <pc:sldMk cId="329471573" sldId="402"/>
            <ac:spMk id="2" creationId="{78E4A034-1B39-A6C3-24D3-42C5497AD27F}"/>
          </ac:spMkLst>
        </pc:spChg>
        <pc:spChg chg="add mod">
          <ac:chgData name="Jorgensen, Rick" userId="22b7bd11-eb0f-413f-9bcb-9ce21ec7b0a8" providerId="ADAL" clId="{63C519A2-C2B2-47AC-828F-E429CD2FEDB2}" dt="2023-08-01T14:57:33.076" v="10765" actId="207"/>
          <ac:spMkLst>
            <pc:docMk/>
            <pc:sldMk cId="329471573" sldId="402"/>
            <ac:spMk id="3" creationId="{1CB3D359-0FEE-BF91-557F-4A5CF89E0729}"/>
          </ac:spMkLst>
        </pc:spChg>
        <pc:spChg chg="add del mod">
          <ac:chgData name="Jorgensen, Rick" userId="22b7bd11-eb0f-413f-9bcb-9ce21ec7b0a8" providerId="ADAL" clId="{63C519A2-C2B2-47AC-828F-E429CD2FEDB2}" dt="2023-06-23T21:06:14.229" v="5662" actId="1076"/>
          <ac:spMkLst>
            <pc:docMk/>
            <pc:sldMk cId="329471573" sldId="402"/>
            <ac:spMk id="5" creationId="{F00554FB-01E5-5189-7B27-BA53E39CB641}"/>
          </ac:spMkLst>
        </pc:spChg>
        <pc:spChg chg="mod">
          <ac:chgData name="Jorgensen, Rick" userId="22b7bd11-eb0f-413f-9bcb-9ce21ec7b0a8" providerId="ADAL" clId="{63C519A2-C2B2-47AC-828F-E429CD2FEDB2}" dt="2023-06-23T21:03:51.190" v="5633" actId="20577"/>
          <ac:spMkLst>
            <pc:docMk/>
            <pc:sldMk cId="329471573" sldId="402"/>
            <ac:spMk id="8" creationId="{453E9CC6-EBBE-094E-93B1-D1BB8A6202C9}"/>
          </ac:spMkLst>
        </pc:spChg>
        <pc:spChg chg="mod">
          <ac:chgData name="Jorgensen, Rick" userId="22b7bd11-eb0f-413f-9bcb-9ce21ec7b0a8" providerId="ADAL" clId="{63C519A2-C2B2-47AC-828F-E429CD2FEDB2}" dt="2023-06-23T21:17:45.046" v="5825" actId="20577"/>
          <ac:spMkLst>
            <pc:docMk/>
            <pc:sldMk cId="329471573" sldId="402"/>
            <ac:spMk id="9" creationId="{9EE04E13-9B71-5E4F-A7DF-4F7F5D741D4E}"/>
          </ac:spMkLst>
        </pc:spChg>
        <pc:spChg chg="mod">
          <ac:chgData name="Jorgensen, Rick" userId="22b7bd11-eb0f-413f-9bcb-9ce21ec7b0a8" providerId="ADAL" clId="{63C519A2-C2B2-47AC-828F-E429CD2FEDB2}" dt="2023-07-27T14:32:12.120" v="8906" actId="692"/>
          <ac:spMkLst>
            <pc:docMk/>
            <pc:sldMk cId="329471573" sldId="402"/>
            <ac:spMk id="11" creationId="{6EC777B4-DD9B-51E4-5EED-D6B898FCD4B9}"/>
          </ac:spMkLst>
        </pc:spChg>
        <pc:spChg chg="add del mod">
          <ac:chgData name="Jorgensen, Rick" userId="22b7bd11-eb0f-413f-9bcb-9ce21ec7b0a8" providerId="ADAL" clId="{63C519A2-C2B2-47AC-828F-E429CD2FEDB2}" dt="2023-06-23T21:06:14.229" v="5662" actId="1076"/>
          <ac:spMkLst>
            <pc:docMk/>
            <pc:sldMk cId="329471573" sldId="402"/>
            <ac:spMk id="16" creationId="{C8B8B8BA-7BDC-9F72-13F9-D93DD01E3FF4}"/>
          </ac:spMkLst>
        </pc:spChg>
        <pc:spChg chg="add del mod">
          <ac:chgData name="Jorgensen, Rick" userId="22b7bd11-eb0f-413f-9bcb-9ce21ec7b0a8" providerId="ADAL" clId="{63C519A2-C2B2-47AC-828F-E429CD2FEDB2}" dt="2023-06-23T21:06:16.540" v="5663" actId="1076"/>
          <ac:spMkLst>
            <pc:docMk/>
            <pc:sldMk cId="329471573" sldId="402"/>
            <ac:spMk id="17" creationId="{ABD3FCDE-4F55-12C5-3ED0-759725A969FF}"/>
          </ac:spMkLst>
        </pc:spChg>
        <pc:spChg chg="add del mod">
          <ac:chgData name="Jorgensen, Rick" userId="22b7bd11-eb0f-413f-9bcb-9ce21ec7b0a8" providerId="ADAL" clId="{63C519A2-C2B2-47AC-828F-E429CD2FEDB2}" dt="2023-06-23T21:06:18.360" v="5664" actId="1076"/>
          <ac:spMkLst>
            <pc:docMk/>
            <pc:sldMk cId="329471573" sldId="402"/>
            <ac:spMk id="18" creationId="{9C0CF2E8-B029-CB02-D340-C3940B7D5AC8}"/>
          </ac:spMkLst>
        </pc:spChg>
        <pc:spChg chg="add del mod">
          <ac:chgData name="Jorgensen, Rick" userId="22b7bd11-eb0f-413f-9bcb-9ce21ec7b0a8" providerId="ADAL" clId="{63C519A2-C2B2-47AC-828F-E429CD2FEDB2}" dt="2023-06-23T21:06:23.190" v="5665" actId="1076"/>
          <ac:spMkLst>
            <pc:docMk/>
            <pc:sldMk cId="329471573" sldId="402"/>
            <ac:spMk id="19" creationId="{9141F109-D077-F891-0395-DFBCC4DD22F0}"/>
          </ac:spMkLst>
        </pc:spChg>
        <pc:spChg chg="mod">
          <ac:chgData name="Jorgensen, Rick" userId="22b7bd11-eb0f-413f-9bcb-9ce21ec7b0a8" providerId="ADAL" clId="{63C519A2-C2B2-47AC-828F-E429CD2FEDB2}" dt="2023-06-23T21:18:11.401" v="5831" actId="1076"/>
          <ac:spMkLst>
            <pc:docMk/>
            <pc:sldMk cId="329471573" sldId="402"/>
            <ac:spMk id="20" creationId="{FF7F4E7C-6297-CCCC-BB1E-8F6057D8A633}"/>
          </ac:spMkLst>
        </pc:spChg>
        <pc:spChg chg="mod">
          <ac:chgData name="Jorgensen, Rick" userId="22b7bd11-eb0f-413f-9bcb-9ce21ec7b0a8" providerId="ADAL" clId="{63C519A2-C2B2-47AC-828F-E429CD2FEDB2}" dt="2023-06-23T21:18:14.396" v="5832" actId="1076"/>
          <ac:spMkLst>
            <pc:docMk/>
            <pc:sldMk cId="329471573" sldId="402"/>
            <ac:spMk id="21" creationId="{F7BB04A9-0072-F756-E5D3-E79311134169}"/>
          </ac:spMkLst>
        </pc:spChg>
        <pc:spChg chg="mod">
          <ac:chgData name="Jorgensen, Rick" userId="22b7bd11-eb0f-413f-9bcb-9ce21ec7b0a8" providerId="ADAL" clId="{63C519A2-C2B2-47AC-828F-E429CD2FEDB2}" dt="2023-06-23T21:18:17.346" v="5833" actId="1076"/>
          <ac:spMkLst>
            <pc:docMk/>
            <pc:sldMk cId="329471573" sldId="402"/>
            <ac:spMk id="22" creationId="{0FFFA28B-A02D-594B-A2B7-66E1B2477C61}"/>
          </ac:spMkLst>
        </pc:spChg>
        <pc:spChg chg="mod">
          <ac:chgData name="Jorgensen, Rick" userId="22b7bd11-eb0f-413f-9bcb-9ce21ec7b0a8" providerId="ADAL" clId="{63C519A2-C2B2-47AC-828F-E429CD2FEDB2}" dt="2023-06-23T21:18:19.448" v="5834" actId="1076"/>
          <ac:spMkLst>
            <pc:docMk/>
            <pc:sldMk cId="329471573" sldId="402"/>
            <ac:spMk id="23" creationId="{3AC7A3DA-6D6F-D636-8021-D23DA1B4C9FF}"/>
          </ac:spMkLst>
        </pc:spChg>
        <pc:spChg chg="mod">
          <ac:chgData name="Jorgensen, Rick" userId="22b7bd11-eb0f-413f-9bcb-9ce21ec7b0a8" providerId="ADAL" clId="{63C519A2-C2B2-47AC-828F-E429CD2FEDB2}" dt="2023-06-23T21:18:21.433" v="5835" actId="1076"/>
          <ac:spMkLst>
            <pc:docMk/>
            <pc:sldMk cId="329471573" sldId="402"/>
            <ac:spMk id="24" creationId="{62EFFA78-8B90-4BB8-4745-30AC2E070E03}"/>
          </ac:spMkLst>
        </pc:spChg>
        <pc:spChg chg="del">
          <ac:chgData name="Jorgensen, Rick" userId="22b7bd11-eb0f-413f-9bcb-9ce21ec7b0a8" providerId="ADAL" clId="{63C519A2-C2B2-47AC-828F-E429CD2FEDB2}" dt="2023-06-23T21:03:40.933" v="5626" actId="478"/>
          <ac:spMkLst>
            <pc:docMk/>
            <pc:sldMk cId="329471573" sldId="402"/>
            <ac:spMk id="25" creationId="{43DF711F-4684-B34D-9236-D3A26D348F11}"/>
          </ac:spMkLst>
        </pc:spChg>
        <pc:spChg chg="add mod">
          <ac:chgData name="Jorgensen, Rick" userId="22b7bd11-eb0f-413f-9bcb-9ce21ec7b0a8" providerId="ADAL" clId="{63C519A2-C2B2-47AC-828F-E429CD2FEDB2}" dt="2023-06-23T21:06:28.900" v="5667" actId="1076"/>
          <ac:spMkLst>
            <pc:docMk/>
            <pc:sldMk cId="329471573" sldId="402"/>
            <ac:spMk id="29" creationId="{A6969AE5-0CB6-03E8-2E68-774BD06AC829}"/>
          </ac:spMkLst>
        </pc:spChg>
        <pc:spChg chg="add del mod">
          <ac:chgData name="Jorgensen, Rick" userId="22b7bd11-eb0f-413f-9bcb-9ce21ec7b0a8" providerId="ADAL" clId="{63C519A2-C2B2-47AC-828F-E429CD2FEDB2}" dt="2023-06-23T21:08:23.441" v="5734"/>
          <ac:spMkLst>
            <pc:docMk/>
            <pc:sldMk cId="329471573" sldId="402"/>
            <ac:spMk id="30" creationId="{1940040E-1AE9-1BB3-86A5-2236B51C81A9}"/>
          </ac:spMkLst>
        </pc:spChg>
        <pc:spChg chg="mod">
          <ac:chgData name="Jorgensen, Rick" userId="22b7bd11-eb0f-413f-9bcb-9ce21ec7b0a8" providerId="ADAL" clId="{63C519A2-C2B2-47AC-828F-E429CD2FEDB2}" dt="2023-06-23T21:18:30.114" v="5837"/>
          <ac:spMkLst>
            <pc:docMk/>
            <pc:sldMk cId="329471573" sldId="402"/>
            <ac:spMk id="42" creationId="{D4E8B510-76D2-0AEF-529C-DE928461D24C}"/>
          </ac:spMkLst>
        </pc:spChg>
        <pc:spChg chg="mod">
          <ac:chgData name="Jorgensen, Rick" userId="22b7bd11-eb0f-413f-9bcb-9ce21ec7b0a8" providerId="ADAL" clId="{63C519A2-C2B2-47AC-828F-E429CD2FEDB2}" dt="2023-07-27T14:31:43.641" v="8902" actId="692"/>
          <ac:spMkLst>
            <pc:docMk/>
            <pc:sldMk cId="329471573" sldId="402"/>
            <ac:spMk id="43" creationId="{F4106A0F-78E2-F270-AC54-CEFD9006FEB4}"/>
          </ac:spMkLst>
        </pc:spChg>
        <pc:grpChg chg="mod">
          <ac:chgData name="Jorgensen, Rick" userId="22b7bd11-eb0f-413f-9bcb-9ce21ec7b0a8" providerId="ADAL" clId="{63C519A2-C2B2-47AC-828F-E429CD2FEDB2}" dt="2023-06-23T21:12:09.029" v="5787" actId="164"/>
          <ac:grpSpMkLst>
            <pc:docMk/>
            <pc:sldMk cId="329471573" sldId="402"/>
            <ac:grpSpMk id="6" creationId="{C9AE2A96-0BDB-E962-D778-4C9AD0D309A4}"/>
          </ac:grpSpMkLst>
        </pc:grpChg>
        <pc:grpChg chg="del mod">
          <ac:chgData name="Jorgensen, Rick" userId="22b7bd11-eb0f-413f-9bcb-9ce21ec7b0a8" providerId="ADAL" clId="{63C519A2-C2B2-47AC-828F-E429CD2FEDB2}" dt="2023-06-23T21:17:39.956" v="5823" actId="478"/>
          <ac:grpSpMkLst>
            <pc:docMk/>
            <pc:sldMk cId="329471573" sldId="402"/>
            <ac:grpSpMk id="15" creationId="{0748FABF-9B46-90D9-82B2-88E696A4CB78}"/>
          </ac:grpSpMkLst>
        </pc:grpChg>
        <pc:grpChg chg="add mod ord">
          <ac:chgData name="Jorgensen, Rick" userId="22b7bd11-eb0f-413f-9bcb-9ce21ec7b0a8" providerId="ADAL" clId="{63C519A2-C2B2-47AC-828F-E429CD2FEDB2}" dt="2023-07-27T14:32:15.878" v="8907" actId="167"/>
          <ac:grpSpMkLst>
            <pc:docMk/>
            <pc:sldMk cId="329471573" sldId="402"/>
            <ac:grpSpMk id="37" creationId="{A9E62DCA-9D96-1F1B-73CA-CEC0694B71AF}"/>
          </ac:grpSpMkLst>
        </pc:grpChg>
        <pc:grpChg chg="add mod ord">
          <ac:chgData name="Jorgensen, Rick" userId="22b7bd11-eb0f-413f-9bcb-9ce21ec7b0a8" providerId="ADAL" clId="{63C519A2-C2B2-47AC-828F-E429CD2FEDB2}" dt="2023-07-27T14:31:47.472" v="8903" actId="167"/>
          <ac:grpSpMkLst>
            <pc:docMk/>
            <pc:sldMk cId="329471573" sldId="402"/>
            <ac:grpSpMk id="39" creationId="{ED57C2C9-1EFB-1D77-9A39-95A632D280E6}"/>
          </ac:grpSpMkLst>
        </pc:grpChg>
        <pc:grpChg chg="mod">
          <ac:chgData name="Jorgensen, Rick" userId="22b7bd11-eb0f-413f-9bcb-9ce21ec7b0a8" providerId="ADAL" clId="{63C519A2-C2B2-47AC-828F-E429CD2FEDB2}" dt="2023-06-23T21:18:30.114" v="5837"/>
          <ac:grpSpMkLst>
            <pc:docMk/>
            <pc:sldMk cId="329471573" sldId="402"/>
            <ac:grpSpMk id="41" creationId="{9399CEDD-DCF4-E47E-FC77-C67EBD1D17FB}"/>
          </ac:grpSpMkLst>
        </pc:grpChg>
        <pc:graphicFrameChg chg="del">
          <ac:chgData name="Jorgensen, Rick" userId="22b7bd11-eb0f-413f-9bcb-9ce21ec7b0a8" providerId="ADAL" clId="{63C519A2-C2B2-47AC-828F-E429CD2FEDB2}" dt="2023-06-23T21:03:55.185" v="5634" actId="478"/>
          <ac:graphicFrameMkLst>
            <pc:docMk/>
            <pc:sldMk cId="329471573" sldId="402"/>
            <ac:graphicFrameMk id="4" creationId="{0C0BD2FB-6516-44C3-A718-4E33F5A1BC6B}"/>
          </ac:graphicFrameMkLst>
        </pc:graphicFrameChg>
        <pc:graphicFrameChg chg="add del mod">
          <ac:chgData name="Jorgensen, Rick" userId="22b7bd11-eb0f-413f-9bcb-9ce21ec7b0a8" providerId="ADAL" clId="{63C519A2-C2B2-47AC-828F-E429CD2FEDB2}" dt="2023-06-23T21:16:38.100" v="5822" actId="478"/>
          <ac:graphicFrameMkLst>
            <pc:docMk/>
            <pc:sldMk cId="329471573" sldId="402"/>
            <ac:graphicFrameMk id="7" creationId="{1F498BC0-BC61-4CF6-AB17-930ACBFDA2DD}"/>
          </ac:graphicFrameMkLst>
        </pc:graphicFrameChg>
        <pc:graphicFrameChg chg="add mod">
          <ac:chgData name="Jorgensen, Rick" userId="22b7bd11-eb0f-413f-9bcb-9ce21ec7b0a8" providerId="ADAL" clId="{63C519A2-C2B2-47AC-828F-E429CD2FEDB2}" dt="2023-06-23T21:04:26.341" v="5646"/>
          <ac:graphicFrameMkLst>
            <pc:docMk/>
            <pc:sldMk cId="329471573" sldId="402"/>
            <ac:graphicFrameMk id="26" creationId="{FA8308DA-1544-4162-AE2D-0B5E503D47D9}"/>
          </ac:graphicFrameMkLst>
        </pc:graphicFrameChg>
        <pc:graphicFrameChg chg="add del mod">
          <ac:chgData name="Jorgensen, Rick" userId="22b7bd11-eb0f-413f-9bcb-9ce21ec7b0a8" providerId="ADAL" clId="{63C519A2-C2B2-47AC-828F-E429CD2FEDB2}" dt="2023-06-23T21:05:02.025" v="5656" actId="478"/>
          <ac:graphicFrameMkLst>
            <pc:docMk/>
            <pc:sldMk cId="329471573" sldId="402"/>
            <ac:graphicFrameMk id="27" creationId="{FA8308DA-1544-4162-AE2D-0B5E503D47D9}"/>
          </ac:graphicFrameMkLst>
        </pc:graphicFrameChg>
        <pc:graphicFrameChg chg="add del mod ord">
          <ac:chgData name="Jorgensen, Rick" userId="22b7bd11-eb0f-413f-9bcb-9ce21ec7b0a8" providerId="ADAL" clId="{63C519A2-C2B2-47AC-828F-E429CD2FEDB2}" dt="2023-06-23T21:10:51.936" v="5771" actId="478"/>
          <ac:graphicFrameMkLst>
            <pc:docMk/>
            <pc:sldMk cId="329471573" sldId="402"/>
            <ac:graphicFrameMk id="28" creationId="{FA8308DA-1544-4162-AE2D-0B5E503D47D9}"/>
          </ac:graphicFrameMkLst>
        </pc:graphicFrameChg>
        <pc:graphicFrameChg chg="add del mod">
          <ac:chgData name="Jorgensen, Rick" userId="22b7bd11-eb0f-413f-9bcb-9ce21ec7b0a8" providerId="ADAL" clId="{63C519A2-C2B2-47AC-828F-E429CD2FEDB2}" dt="2023-06-23T21:10:26.212" v="5762" actId="478"/>
          <ac:graphicFrameMkLst>
            <pc:docMk/>
            <pc:sldMk cId="329471573" sldId="402"/>
            <ac:graphicFrameMk id="32" creationId="{FA8308DA-1544-4162-AE2D-0B5E503D47D9}"/>
          </ac:graphicFrameMkLst>
        </pc:graphicFrameChg>
        <pc:graphicFrameChg chg="add mod ord">
          <ac:chgData name="Jorgensen, Rick" userId="22b7bd11-eb0f-413f-9bcb-9ce21ec7b0a8" providerId="ADAL" clId="{63C519A2-C2B2-47AC-828F-E429CD2FEDB2}" dt="2023-07-31T18:37:12.299" v="10195" actId="692"/>
          <ac:graphicFrameMkLst>
            <pc:docMk/>
            <pc:sldMk cId="329471573" sldId="402"/>
            <ac:graphicFrameMk id="33" creationId="{FA8308DA-1544-4162-AE2D-0B5E503D47D9}"/>
          </ac:graphicFrameMkLst>
        </pc:graphicFrameChg>
        <pc:graphicFrameChg chg="add del mod">
          <ac:chgData name="Jorgensen, Rick" userId="22b7bd11-eb0f-413f-9bcb-9ce21ec7b0a8" providerId="ADAL" clId="{63C519A2-C2B2-47AC-828F-E429CD2FEDB2}" dt="2023-06-23T21:10:39.527" v="5768" actId="478"/>
          <ac:graphicFrameMkLst>
            <pc:docMk/>
            <pc:sldMk cId="329471573" sldId="402"/>
            <ac:graphicFrameMk id="34" creationId="{13E884C9-74A4-D60B-2A79-774A90024885}"/>
          </ac:graphicFrameMkLst>
        </pc:graphicFrameChg>
        <pc:graphicFrameChg chg="add mod ord">
          <ac:chgData name="Jorgensen, Rick" userId="22b7bd11-eb0f-413f-9bcb-9ce21ec7b0a8" providerId="ADAL" clId="{63C519A2-C2B2-47AC-828F-E429CD2FEDB2}" dt="2023-07-27T14:31:37.580" v="8901" actId="167"/>
          <ac:graphicFrameMkLst>
            <pc:docMk/>
            <pc:sldMk cId="329471573" sldId="402"/>
            <ac:graphicFrameMk id="38" creationId="{862B7BE0-8234-4F24-B8C5-0802CF7477C9}"/>
          </ac:graphicFrameMkLst>
        </pc:graphicFrameChg>
        <pc:picChg chg="del mod">
          <ac:chgData name="Jorgensen, Rick" userId="22b7bd11-eb0f-413f-9bcb-9ce21ec7b0a8" providerId="ADAL" clId="{63C519A2-C2B2-47AC-828F-E429CD2FEDB2}" dt="2023-06-23T21:10:20.308" v="5759" actId="478"/>
          <ac:picMkLst>
            <pc:docMk/>
            <pc:sldMk cId="329471573" sldId="402"/>
            <ac:picMk id="10" creationId="{7E29BC5D-1340-3318-A786-37F26A528532}"/>
          </ac:picMkLst>
        </pc:picChg>
        <pc:picChg chg="add del mod">
          <ac:chgData name="Jorgensen, Rick" userId="22b7bd11-eb0f-413f-9bcb-9ce21ec7b0a8" providerId="ADAL" clId="{63C519A2-C2B2-47AC-828F-E429CD2FEDB2}" dt="2023-06-23T21:10:21.126" v="5760" actId="478"/>
          <ac:picMkLst>
            <pc:docMk/>
            <pc:sldMk cId="329471573" sldId="402"/>
            <ac:picMk id="31" creationId="{63A4C303-303D-6D11-D4EE-0EAC1FEF511A}"/>
          </ac:picMkLst>
        </pc:picChg>
        <pc:picChg chg="add mod ord modCrop">
          <ac:chgData name="Jorgensen, Rick" userId="22b7bd11-eb0f-413f-9bcb-9ce21ec7b0a8" providerId="ADAL" clId="{63C519A2-C2B2-47AC-828F-E429CD2FEDB2}" dt="2023-06-23T21:12:09.029" v="5787" actId="164"/>
          <ac:picMkLst>
            <pc:docMk/>
            <pc:sldMk cId="329471573" sldId="402"/>
            <ac:picMk id="36" creationId="{04000FC3-078F-23A1-C29D-7E2BF3970EA4}"/>
          </ac:picMkLst>
        </pc:picChg>
        <pc:picChg chg="mod">
          <ac:chgData name="Jorgensen, Rick" userId="22b7bd11-eb0f-413f-9bcb-9ce21ec7b0a8" providerId="ADAL" clId="{63C519A2-C2B2-47AC-828F-E429CD2FEDB2}" dt="2023-06-23T21:18:30.114" v="5837"/>
          <ac:picMkLst>
            <pc:docMk/>
            <pc:sldMk cId="329471573" sldId="402"/>
            <ac:picMk id="40" creationId="{FCD946C8-48E7-7FC1-E8A6-C987B6CD481C}"/>
          </ac:picMkLst>
        </pc:picChg>
      </pc:sldChg>
      <pc:sldChg chg="add del">
        <pc:chgData name="Jorgensen, Rick" userId="22b7bd11-eb0f-413f-9bcb-9ce21ec7b0a8" providerId="ADAL" clId="{63C519A2-C2B2-47AC-828F-E429CD2FEDB2}" dt="2023-06-23T20:09:16.993" v="5564"/>
        <pc:sldMkLst>
          <pc:docMk/>
          <pc:sldMk cId="2824248810" sldId="402"/>
        </pc:sldMkLst>
      </pc:sldChg>
      <pc:sldChg chg="addSp delSp modSp add mod">
        <pc:chgData name="Jorgensen, Rick" userId="22b7bd11-eb0f-413f-9bcb-9ce21ec7b0a8" providerId="ADAL" clId="{63C519A2-C2B2-47AC-828F-E429CD2FEDB2}" dt="2023-08-01T15:07:48.986" v="11090" actId="207"/>
        <pc:sldMkLst>
          <pc:docMk/>
          <pc:sldMk cId="1498640041" sldId="403"/>
        </pc:sldMkLst>
        <pc:spChg chg="add mod">
          <ac:chgData name="Jorgensen, Rick" userId="22b7bd11-eb0f-413f-9bcb-9ce21ec7b0a8" providerId="ADAL" clId="{63C519A2-C2B2-47AC-828F-E429CD2FEDB2}" dt="2023-08-01T15:07:22.355" v="11089" actId="14100"/>
          <ac:spMkLst>
            <pc:docMk/>
            <pc:sldMk cId="1498640041" sldId="403"/>
            <ac:spMk id="2" creationId="{17D1D561-2F59-5C4F-5DEB-D61C87E9EF15}"/>
          </ac:spMkLst>
        </pc:spChg>
        <pc:spChg chg="del">
          <ac:chgData name="Jorgensen, Rick" userId="22b7bd11-eb0f-413f-9bcb-9ce21ec7b0a8" providerId="ADAL" clId="{63C519A2-C2B2-47AC-828F-E429CD2FEDB2}" dt="2023-07-05T15:09:42.708" v="6537" actId="478"/>
          <ac:spMkLst>
            <pc:docMk/>
            <pc:sldMk cId="1498640041" sldId="403"/>
            <ac:spMk id="3" creationId="{1242B38E-6782-C861-E8D6-D1E98C0E5ED4}"/>
          </ac:spMkLst>
        </pc:spChg>
        <pc:spChg chg="del">
          <ac:chgData name="Jorgensen, Rick" userId="22b7bd11-eb0f-413f-9bcb-9ce21ec7b0a8" providerId="ADAL" clId="{63C519A2-C2B2-47AC-828F-E429CD2FEDB2}" dt="2023-07-05T15:09:42.708" v="6537" actId="478"/>
          <ac:spMkLst>
            <pc:docMk/>
            <pc:sldMk cId="1498640041" sldId="403"/>
            <ac:spMk id="4" creationId="{09DBCA02-D125-8AB6-BC27-4A1677DEE8D3}"/>
          </ac:spMkLst>
        </pc:spChg>
        <pc:spChg chg="del">
          <ac:chgData name="Jorgensen, Rick" userId="22b7bd11-eb0f-413f-9bcb-9ce21ec7b0a8" providerId="ADAL" clId="{63C519A2-C2B2-47AC-828F-E429CD2FEDB2}" dt="2023-07-05T15:09:42.708" v="6537" actId="478"/>
          <ac:spMkLst>
            <pc:docMk/>
            <pc:sldMk cId="1498640041" sldId="403"/>
            <ac:spMk id="5" creationId="{E50A960F-E28D-4D60-4874-8E57F0A21381}"/>
          </ac:spMkLst>
        </pc:spChg>
        <pc:spChg chg="del">
          <ac:chgData name="Jorgensen, Rick" userId="22b7bd11-eb0f-413f-9bcb-9ce21ec7b0a8" providerId="ADAL" clId="{63C519A2-C2B2-47AC-828F-E429CD2FEDB2}" dt="2023-07-05T15:09:42.708" v="6537" actId="478"/>
          <ac:spMkLst>
            <pc:docMk/>
            <pc:sldMk cId="1498640041" sldId="403"/>
            <ac:spMk id="7" creationId="{3C3BE146-B654-24C5-1312-6B07E139E8DA}"/>
          </ac:spMkLst>
        </pc:spChg>
        <pc:spChg chg="del">
          <ac:chgData name="Jorgensen, Rick" userId="22b7bd11-eb0f-413f-9bcb-9ce21ec7b0a8" providerId="ADAL" clId="{63C519A2-C2B2-47AC-828F-E429CD2FEDB2}" dt="2023-07-05T15:09:42.708" v="6537" actId="478"/>
          <ac:spMkLst>
            <pc:docMk/>
            <pc:sldMk cId="1498640041" sldId="403"/>
            <ac:spMk id="8" creationId="{6DBB4D36-7671-FA4C-D50C-E943B2F05018}"/>
          </ac:spMkLst>
        </pc:spChg>
        <pc:spChg chg="del">
          <ac:chgData name="Jorgensen, Rick" userId="22b7bd11-eb0f-413f-9bcb-9ce21ec7b0a8" providerId="ADAL" clId="{63C519A2-C2B2-47AC-828F-E429CD2FEDB2}" dt="2023-07-05T15:09:42.708" v="6537" actId="478"/>
          <ac:spMkLst>
            <pc:docMk/>
            <pc:sldMk cId="1498640041" sldId="403"/>
            <ac:spMk id="9" creationId="{A3759962-9366-5CD1-C35C-ED0B0855C7E2}"/>
          </ac:spMkLst>
        </pc:spChg>
        <pc:spChg chg="mod">
          <ac:chgData name="Jorgensen, Rick" userId="22b7bd11-eb0f-413f-9bcb-9ce21ec7b0a8" providerId="ADAL" clId="{63C519A2-C2B2-47AC-828F-E429CD2FEDB2}" dt="2023-07-31T18:37:58.595" v="10198" actId="1076"/>
          <ac:spMkLst>
            <pc:docMk/>
            <pc:sldMk cId="1498640041" sldId="403"/>
            <ac:spMk id="14" creationId="{23478ECB-C0DB-7751-2BDB-0AC0625EFB69}"/>
          </ac:spMkLst>
        </pc:spChg>
        <pc:spChg chg="mod">
          <ac:chgData name="Jorgensen, Rick" userId="22b7bd11-eb0f-413f-9bcb-9ce21ec7b0a8" providerId="ADAL" clId="{63C519A2-C2B2-47AC-828F-E429CD2FEDB2}" dt="2023-07-05T15:13:23.628" v="6639" actId="1076"/>
          <ac:spMkLst>
            <pc:docMk/>
            <pc:sldMk cId="1498640041" sldId="403"/>
            <ac:spMk id="15" creationId="{F46E22AC-35F2-C5A4-9561-04D1ED4E983B}"/>
          </ac:spMkLst>
        </pc:spChg>
        <pc:spChg chg="del">
          <ac:chgData name="Jorgensen, Rick" userId="22b7bd11-eb0f-413f-9bcb-9ce21ec7b0a8" providerId="ADAL" clId="{63C519A2-C2B2-47AC-828F-E429CD2FEDB2}" dt="2023-07-05T15:09:48.149" v="6540" actId="478"/>
          <ac:spMkLst>
            <pc:docMk/>
            <pc:sldMk cId="1498640041" sldId="403"/>
            <ac:spMk id="16" creationId="{6593EDF3-5560-9A4E-B4EE-07FC91CE7602}"/>
          </ac:spMkLst>
        </pc:spChg>
        <pc:spChg chg="del">
          <ac:chgData name="Jorgensen, Rick" userId="22b7bd11-eb0f-413f-9bcb-9ce21ec7b0a8" providerId="ADAL" clId="{63C519A2-C2B2-47AC-828F-E429CD2FEDB2}" dt="2023-07-05T15:09:47.015" v="6539" actId="478"/>
          <ac:spMkLst>
            <pc:docMk/>
            <pc:sldMk cId="1498640041" sldId="403"/>
            <ac:spMk id="17" creationId="{D181E944-4B90-E74E-9153-2053FAE9DD47}"/>
          </ac:spMkLst>
        </pc:spChg>
        <pc:spChg chg="mod">
          <ac:chgData name="Jorgensen, Rick" userId="22b7bd11-eb0f-413f-9bcb-9ce21ec7b0a8" providerId="ADAL" clId="{63C519A2-C2B2-47AC-828F-E429CD2FEDB2}" dt="2023-07-05T15:13:43.214" v="6640" actId="14100"/>
          <ac:spMkLst>
            <pc:docMk/>
            <pc:sldMk cId="1498640041" sldId="403"/>
            <ac:spMk id="18" creationId="{CBA17ECE-F503-ED50-45C9-0F86876BA70B}"/>
          </ac:spMkLst>
        </pc:spChg>
        <pc:spChg chg="mod">
          <ac:chgData name="Jorgensen, Rick" userId="22b7bd11-eb0f-413f-9bcb-9ce21ec7b0a8" providerId="ADAL" clId="{63C519A2-C2B2-47AC-828F-E429CD2FEDB2}" dt="2023-07-05T15:14:00.954" v="6651" actId="14100"/>
          <ac:spMkLst>
            <pc:docMk/>
            <pc:sldMk cId="1498640041" sldId="403"/>
            <ac:spMk id="20" creationId="{E321A8C0-780A-230B-E1BE-73253C936EB8}"/>
          </ac:spMkLst>
        </pc:spChg>
        <pc:spChg chg="add mod">
          <ac:chgData name="Jorgensen, Rick" userId="22b7bd11-eb0f-413f-9bcb-9ce21ec7b0a8" providerId="ADAL" clId="{63C519A2-C2B2-47AC-828F-E429CD2FEDB2}" dt="2023-07-05T15:12:25.476" v="6607" actId="14100"/>
          <ac:spMkLst>
            <pc:docMk/>
            <pc:sldMk cId="1498640041" sldId="403"/>
            <ac:spMk id="21" creationId="{9FDBA3B0-FD20-33B9-A077-68B7F8EDDB76}"/>
          </ac:spMkLst>
        </pc:spChg>
        <pc:spChg chg="mod">
          <ac:chgData name="Jorgensen, Rick" userId="22b7bd11-eb0f-413f-9bcb-9ce21ec7b0a8" providerId="ADAL" clId="{63C519A2-C2B2-47AC-828F-E429CD2FEDB2}" dt="2023-07-05T15:13:48.230" v="6641"/>
          <ac:spMkLst>
            <pc:docMk/>
            <pc:sldMk cId="1498640041" sldId="403"/>
            <ac:spMk id="23" creationId="{6AE75A8A-A855-CE94-0E4E-5CFDCE18BEEF}"/>
          </ac:spMkLst>
        </pc:spChg>
        <pc:spChg chg="mod">
          <ac:chgData name="Jorgensen, Rick" userId="22b7bd11-eb0f-413f-9bcb-9ce21ec7b0a8" providerId="ADAL" clId="{63C519A2-C2B2-47AC-828F-E429CD2FEDB2}" dt="2023-07-05T15:13:48.230" v="6641"/>
          <ac:spMkLst>
            <pc:docMk/>
            <pc:sldMk cId="1498640041" sldId="403"/>
            <ac:spMk id="24" creationId="{55F6CE40-8FA5-A2E4-E2BD-E3EBE1460204}"/>
          </ac:spMkLst>
        </pc:spChg>
        <pc:spChg chg="mod">
          <ac:chgData name="Jorgensen, Rick" userId="22b7bd11-eb0f-413f-9bcb-9ce21ec7b0a8" providerId="ADAL" clId="{63C519A2-C2B2-47AC-828F-E429CD2FEDB2}" dt="2023-07-05T15:14:45.939" v="6658" actId="1076"/>
          <ac:spMkLst>
            <pc:docMk/>
            <pc:sldMk cId="1498640041" sldId="403"/>
            <ac:spMk id="26" creationId="{9BB2D566-0547-3452-5F9C-87A93D5883F1}"/>
          </ac:spMkLst>
        </pc:spChg>
        <pc:spChg chg="mod">
          <ac:chgData name="Jorgensen, Rick" userId="22b7bd11-eb0f-413f-9bcb-9ce21ec7b0a8" providerId="ADAL" clId="{63C519A2-C2B2-47AC-828F-E429CD2FEDB2}" dt="2023-07-05T15:14:48.396" v="6659"/>
          <ac:spMkLst>
            <pc:docMk/>
            <pc:sldMk cId="1498640041" sldId="403"/>
            <ac:spMk id="28" creationId="{A00B6EA7-50E2-8CBA-A617-D18D574DE746}"/>
          </ac:spMkLst>
        </pc:spChg>
        <pc:spChg chg="mod">
          <ac:chgData name="Jorgensen, Rick" userId="22b7bd11-eb0f-413f-9bcb-9ce21ec7b0a8" providerId="ADAL" clId="{63C519A2-C2B2-47AC-828F-E429CD2FEDB2}" dt="2023-08-01T15:07:48.986" v="11090" actId="207"/>
          <ac:spMkLst>
            <pc:docMk/>
            <pc:sldMk cId="1498640041" sldId="403"/>
            <ac:spMk id="29" creationId="{2E51C695-DD93-3E46-975E-4AD32D674DE1}"/>
          </ac:spMkLst>
        </pc:spChg>
        <pc:spChg chg="mod">
          <ac:chgData name="Jorgensen, Rick" userId="22b7bd11-eb0f-413f-9bcb-9ce21ec7b0a8" providerId="ADAL" clId="{63C519A2-C2B2-47AC-828F-E429CD2FEDB2}" dt="2023-07-05T15:14:48.396" v="6659"/>
          <ac:spMkLst>
            <pc:docMk/>
            <pc:sldMk cId="1498640041" sldId="403"/>
            <ac:spMk id="30" creationId="{0B1B3293-0D88-D22C-B6C4-0E2B3FF49FC9}"/>
          </ac:spMkLst>
        </pc:spChg>
        <pc:spChg chg="mod">
          <ac:chgData name="Jorgensen, Rick" userId="22b7bd11-eb0f-413f-9bcb-9ce21ec7b0a8" providerId="ADAL" clId="{63C519A2-C2B2-47AC-828F-E429CD2FEDB2}" dt="2023-07-05T15:15:21.479" v="6680" actId="20577"/>
          <ac:spMkLst>
            <pc:docMk/>
            <pc:sldMk cId="1498640041" sldId="403"/>
            <ac:spMk id="32" creationId="{08D5B429-645F-8553-9BE6-1B35AAA32F56}"/>
          </ac:spMkLst>
        </pc:spChg>
        <pc:spChg chg="mod">
          <ac:chgData name="Jorgensen, Rick" userId="22b7bd11-eb0f-413f-9bcb-9ce21ec7b0a8" providerId="ADAL" clId="{63C519A2-C2B2-47AC-828F-E429CD2FEDB2}" dt="2023-07-05T15:15:26.096" v="6681"/>
          <ac:spMkLst>
            <pc:docMk/>
            <pc:sldMk cId="1498640041" sldId="403"/>
            <ac:spMk id="34" creationId="{E24A0E48-2B42-A0DB-5E6D-71D8944092D8}"/>
          </ac:spMkLst>
        </pc:spChg>
        <pc:spChg chg="mod">
          <ac:chgData name="Jorgensen, Rick" userId="22b7bd11-eb0f-413f-9bcb-9ce21ec7b0a8" providerId="ADAL" clId="{63C519A2-C2B2-47AC-828F-E429CD2FEDB2}" dt="2023-07-05T15:15:26.096" v="6681"/>
          <ac:spMkLst>
            <pc:docMk/>
            <pc:sldMk cId="1498640041" sldId="403"/>
            <ac:spMk id="35" creationId="{27DC41BF-AB67-3D24-926A-10BE4522D0E5}"/>
          </ac:spMkLst>
        </pc:spChg>
        <pc:spChg chg="mod">
          <ac:chgData name="Jorgensen, Rick" userId="22b7bd11-eb0f-413f-9bcb-9ce21ec7b0a8" providerId="ADAL" clId="{63C519A2-C2B2-47AC-828F-E429CD2FEDB2}" dt="2023-07-05T15:15:45.489" v="6686" actId="20577"/>
          <ac:spMkLst>
            <pc:docMk/>
            <pc:sldMk cId="1498640041" sldId="403"/>
            <ac:spMk id="37" creationId="{4A422687-EA3C-79E2-E2DD-C2FFEC42FDBC}"/>
          </ac:spMkLst>
        </pc:spChg>
        <pc:grpChg chg="add mod ord">
          <ac:chgData name="Jorgensen, Rick" userId="22b7bd11-eb0f-413f-9bcb-9ce21ec7b0a8" providerId="ADAL" clId="{63C519A2-C2B2-47AC-828F-E429CD2FEDB2}" dt="2023-07-05T15:15:58.977" v="6688" actId="1076"/>
          <ac:grpSpMkLst>
            <pc:docMk/>
            <pc:sldMk cId="1498640041" sldId="403"/>
            <ac:grpSpMk id="11" creationId="{660C241B-610F-C6C9-28DA-2F5C32967A67}"/>
          </ac:grpSpMkLst>
        </pc:grpChg>
        <pc:grpChg chg="mod">
          <ac:chgData name="Jorgensen, Rick" userId="22b7bd11-eb0f-413f-9bcb-9ce21ec7b0a8" providerId="ADAL" clId="{63C519A2-C2B2-47AC-828F-E429CD2FEDB2}" dt="2023-07-05T15:12:30.120" v="6608" actId="1076"/>
          <ac:grpSpMkLst>
            <pc:docMk/>
            <pc:sldMk cId="1498640041" sldId="403"/>
            <ac:grpSpMk id="12" creationId="{1B50585F-6C48-890F-D6BD-D343C918731A}"/>
          </ac:grpSpMkLst>
        </pc:grpChg>
        <pc:grpChg chg="add mod">
          <ac:chgData name="Jorgensen, Rick" userId="22b7bd11-eb0f-413f-9bcb-9ce21ec7b0a8" providerId="ADAL" clId="{63C519A2-C2B2-47AC-828F-E429CD2FEDB2}" dt="2023-07-05T15:15:54.469" v="6687" actId="1076"/>
          <ac:grpSpMkLst>
            <pc:docMk/>
            <pc:sldMk cId="1498640041" sldId="403"/>
            <ac:grpSpMk id="22" creationId="{DCF3D9BB-BA75-1C7F-5845-272BB6CB383B}"/>
          </ac:grpSpMkLst>
        </pc:grpChg>
        <pc:grpChg chg="add mod">
          <ac:chgData name="Jorgensen, Rick" userId="22b7bd11-eb0f-413f-9bcb-9ce21ec7b0a8" providerId="ADAL" clId="{63C519A2-C2B2-47AC-828F-E429CD2FEDB2}" dt="2023-07-05T15:15:12.130" v="6660" actId="1076"/>
          <ac:grpSpMkLst>
            <pc:docMk/>
            <pc:sldMk cId="1498640041" sldId="403"/>
            <ac:grpSpMk id="27" creationId="{60D2182B-1BF9-1058-1C88-A01FC67B8A11}"/>
          </ac:grpSpMkLst>
        </pc:grpChg>
        <pc:grpChg chg="add mod">
          <ac:chgData name="Jorgensen, Rick" userId="22b7bd11-eb0f-413f-9bcb-9ce21ec7b0a8" providerId="ADAL" clId="{63C519A2-C2B2-47AC-828F-E429CD2FEDB2}" dt="2023-07-05T15:15:42.260" v="6682" actId="1076"/>
          <ac:grpSpMkLst>
            <pc:docMk/>
            <pc:sldMk cId="1498640041" sldId="403"/>
            <ac:grpSpMk id="33" creationId="{72C80383-82F6-1E78-C7F7-39D1AFDB78D3}"/>
          </ac:grpSpMkLst>
        </pc:grpChg>
        <pc:graphicFrameChg chg="del">
          <ac:chgData name="Jorgensen, Rick" userId="22b7bd11-eb0f-413f-9bcb-9ce21ec7b0a8" providerId="ADAL" clId="{63C519A2-C2B2-47AC-828F-E429CD2FEDB2}" dt="2023-07-05T15:09:43.611" v="6538" actId="478"/>
          <ac:graphicFrameMkLst>
            <pc:docMk/>
            <pc:sldMk cId="1498640041" sldId="403"/>
            <ac:graphicFrameMk id="2" creationId="{49BDDCB0-92CF-4CFD-99A2-8A19467FEA82}"/>
          </ac:graphicFrameMkLst>
        </pc:graphicFrameChg>
        <pc:graphicFrameChg chg="del">
          <ac:chgData name="Jorgensen, Rick" userId="22b7bd11-eb0f-413f-9bcb-9ce21ec7b0a8" providerId="ADAL" clId="{63C519A2-C2B2-47AC-828F-E429CD2FEDB2}" dt="2023-07-05T15:09:40.821" v="6536" actId="478"/>
          <ac:graphicFrameMkLst>
            <pc:docMk/>
            <pc:sldMk cId="1498640041" sldId="403"/>
            <ac:graphicFrameMk id="6" creationId="{182965B2-4788-498D-A731-4D6513F6FCC5}"/>
          </ac:graphicFrameMkLst>
        </pc:graphicFrameChg>
        <pc:graphicFrameChg chg="add mod ord">
          <ac:chgData name="Jorgensen, Rick" userId="22b7bd11-eb0f-413f-9bcb-9ce21ec7b0a8" providerId="ADAL" clId="{63C519A2-C2B2-47AC-828F-E429CD2FEDB2}" dt="2023-08-01T15:07:17.402" v="11083"/>
          <ac:graphicFrameMkLst>
            <pc:docMk/>
            <pc:sldMk cId="1498640041" sldId="403"/>
            <ac:graphicFrameMk id="10" creationId="{AB6268C2-3B80-4C29-8854-0BF14EBD3279}"/>
          </ac:graphicFrameMkLst>
        </pc:graphicFrameChg>
        <pc:cxnChg chg="mod">
          <ac:chgData name="Jorgensen, Rick" userId="22b7bd11-eb0f-413f-9bcb-9ce21ec7b0a8" providerId="ADAL" clId="{63C519A2-C2B2-47AC-828F-E429CD2FEDB2}" dt="2023-07-31T18:37:53.689" v="10197" actId="692"/>
          <ac:cxnSpMkLst>
            <pc:docMk/>
            <pc:sldMk cId="1498640041" sldId="403"/>
            <ac:cxnSpMk id="13" creationId="{3FBCFBE3-4735-5126-8902-B4CB06F7E632}"/>
          </ac:cxnSpMkLst>
        </pc:cxnChg>
        <pc:cxnChg chg="mod">
          <ac:chgData name="Jorgensen, Rick" userId="22b7bd11-eb0f-413f-9bcb-9ce21ec7b0a8" providerId="ADAL" clId="{63C519A2-C2B2-47AC-828F-E429CD2FEDB2}" dt="2023-07-27T15:47:15.471" v="9001" actId="692"/>
          <ac:cxnSpMkLst>
            <pc:docMk/>
            <pc:sldMk cId="1498640041" sldId="403"/>
            <ac:cxnSpMk id="19" creationId="{047A6B62-65D4-12B3-5E3A-EC3C78B9D5AF}"/>
          </ac:cxnSpMkLst>
        </pc:cxnChg>
        <pc:cxnChg chg="mod">
          <ac:chgData name="Jorgensen, Rick" userId="22b7bd11-eb0f-413f-9bcb-9ce21ec7b0a8" providerId="ADAL" clId="{63C519A2-C2B2-47AC-828F-E429CD2FEDB2}" dt="2023-07-27T15:47:19.075" v="9003" actId="692"/>
          <ac:cxnSpMkLst>
            <pc:docMk/>
            <pc:sldMk cId="1498640041" sldId="403"/>
            <ac:cxnSpMk id="25" creationId="{A1A2D0B5-9007-8FE6-9992-8378C9261DCA}"/>
          </ac:cxnSpMkLst>
        </pc:cxnChg>
        <pc:cxnChg chg="mod">
          <ac:chgData name="Jorgensen, Rick" userId="22b7bd11-eb0f-413f-9bcb-9ce21ec7b0a8" providerId="ADAL" clId="{63C519A2-C2B2-47AC-828F-E429CD2FEDB2}" dt="2023-07-27T15:47:22.393" v="9005" actId="692"/>
          <ac:cxnSpMkLst>
            <pc:docMk/>
            <pc:sldMk cId="1498640041" sldId="403"/>
            <ac:cxnSpMk id="31" creationId="{4A596045-8F73-2934-6A26-6B13B196ED23}"/>
          </ac:cxnSpMkLst>
        </pc:cxnChg>
        <pc:cxnChg chg="mod">
          <ac:chgData name="Jorgensen, Rick" userId="22b7bd11-eb0f-413f-9bcb-9ce21ec7b0a8" providerId="ADAL" clId="{63C519A2-C2B2-47AC-828F-E429CD2FEDB2}" dt="2023-07-27T15:47:25.371" v="9007" actId="692"/>
          <ac:cxnSpMkLst>
            <pc:docMk/>
            <pc:sldMk cId="1498640041" sldId="403"/>
            <ac:cxnSpMk id="36" creationId="{93D700C4-EDD1-2337-7176-F96D008B1E2A}"/>
          </ac:cxnSpMkLst>
        </pc:cxnChg>
      </pc:sldChg>
      <pc:sldChg chg="addSp delSp modSp add del mod">
        <pc:chgData name="Jorgensen, Rick" userId="22b7bd11-eb0f-413f-9bcb-9ce21ec7b0a8" providerId="ADAL" clId="{63C519A2-C2B2-47AC-828F-E429CD2FEDB2}" dt="2023-07-05T14:37:48.729" v="6501" actId="47"/>
        <pc:sldMkLst>
          <pc:docMk/>
          <pc:sldMk cId="3674792571" sldId="403"/>
        </pc:sldMkLst>
        <pc:spChg chg="mod ord">
          <ac:chgData name="Jorgensen, Rick" userId="22b7bd11-eb0f-413f-9bcb-9ce21ec7b0a8" providerId="ADAL" clId="{63C519A2-C2B2-47AC-828F-E429CD2FEDB2}" dt="2023-07-05T14:35:02.412" v="6473" actId="166"/>
          <ac:spMkLst>
            <pc:docMk/>
            <pc:sldMk cId="3674792571" sldId="403"/>
            <ac:spMk id="4" creationId="{495B3960-9843-4808-4E62-B7FC00D5322C}"/>
          </ac:spMkLst>
        </pc:spChg>
        <pc:spChg chg="mod ord">
          <ac:chgData name="Jorgensen, Rick" userId="22b7bd11-eb0f-413f-9bcb-9ce21ec7b0a8" providerId="ADAL" clId="{63C519A2-C2B2-47AC-828F-E429CD2FEDB2}" dt="2023-07-05T14:35:29.295" v="6478" actId="1076"/>
          <ac:spMkLst>
            <pc:docMk/>
            <pc:sldMk cId="3674792571" sldId="403"/>
            <ac:spMk id="6" creationId="{53196C1B-981F-C47C-D616-E9D60C5EA985}"/>
          </ac:spMkLst>
        </pc:spChg>
        <pc:spChg chg="mod">
          <ac:chgData name="Jorgensen, Rick" userId="22b7bd11-eb0f-413f-9bcb-9ce21ec7b0a8" providerId="ADAL" clId="{63C519A2-C2B2-47AC-828F-E429CD2FEDB2}" dt="2023-07-05T14:20:08.707" v="6466" actId="1076"/>
          <ac:spMkLst>
            <pc:docMk/>
            <pc:sldMk cId="3674792571" sldId="403"/>
            <ac:spMk id="9" creationId="{090E3AC6-72C7-E48F-824F-47B306FEB8B6}"/>
          </ac:spMkLst>
        </pc:spChg>
        <pc:grpChg chg="mod ord">
          <ac:chgData name="Jorgensen, Rick" userId="22b7bd11-eb0f-413f-9bcb-9ce21ec7b0a8" providerId="ADAL" clId="{63C519A2-C2B2-47AC-828F-E429CD2FEDB2}" dt="2023-07-05T14:36:09.430" v="6482" actId="1076"/>
          <ac:grpSpMkLst>
            <pc:docMk/>
            <pc:sldMk cId="3674792571" sldId="403"/>
            <ac:grpSpMk id="19" creationId="{68B11417-71FE-8FD6-0490-DB23C6AD49F9}"/>
          </ac:grpSpMkLst>
        </pc:grpChg>
        <pc:grpChg chg="mod">
          <ac:chgData name="Jorgensen, Rick" userId="22b7bd11-eb0f-413f-9bcb-9ce21ec7b0a8" providerId="ADAL" clId="{63C519A2-C2B2-47AC-828F-E429CD2FEDB2}" dt="2023-07-05T14:20:15.825" v="6467" actId="1076"/>
          <ac:grpSpMkLst>
            <pc:docMk/>
            <pc:sldMk cId="3674792571" sldId="403"/>
            <ac:grpSpMk id="21" creationId="{D4C63643-32D5-AD70-A424-F738A1382502}"/>
          </ac:grpSpMkLst>
        </pc:grpChg>
        <pc:grpChg chg="mod ord">
          <ac:chgData name="Jorgensen, Rick" userId="22b7bd11-eb0f-413f-9bcb-9ce21ec7b0a8" providerId="ADAL" clId="{63C519A2-C2B2-47AC-828F-E429CD2FEDB2}" dt="2023-07-05T14:35:29.295" v="6478" actId="1076"/>
          <ac:grpSpMkLst>
            <pc:docMk/>
            <pc:sldMk cId="3674792571" sldId="403"/>
            <ac:grpSpMk id="22" creationId="{FB5622C0-4E2B-9E16-C529-293A0A3D017A}"/>
          </ac:grpSpMkLst>
        </pc:grpChg>
        <pc:graphicFrameChg chg="add mod">
          <ac:chgData name="Jorgensen, Rick" userId="22b7bd11-eb0f-413f-9bcb-9ce21ec7b0a8" providerId="ADAL" clId="{63C519A2-C2B2-47AC-828F-E429CD2FEDB2}" dt="2023-07-05T14:35:09.467" v="6474" actId="1076"/>
          <ac:graphicFrameMkLst>
            <pc:docMk/>
            <pc:sldMk cId="3674792571" sldId="403"/>
            <ac:graphicFrameMk id="2" creationId="{23DB8830-A66B-427E-A9F1-836694812AC4}"/>
          </ac:graphicFrameMkLst>
        </pc:graphicFrameChg>
        <pc:graphicFrameChg chg="del">
          <ac:chgData name="Jorgensen, Rick" userId="22b7bd11-eb0f-413f-9bcb-9ce21ec7b0a8" providerId="ADAL" clId="{63C519A2-C2B2-47AC-828F-E429CD2FEDB2}" dt="2023-07-05T14:20:01.850" v="6465" actId="478"/>
          <ac:graphicFrameMkLst>
            <pc:docMk/>
            <pc:sldMk cId="3674792571" sldId="403"/>
            <ac:graphicFrameMk id="5" creationId="{4936B1E3-6CC8-4944-870F-DC784E261689}"/>
          </ac:graphicFrameMkLst>
        </pc:graphicFrameChg>
      </pc:sldChg>
      <pc:sldChg chg="addSp delSp modSp add mod ord">
        <pc:chgData name="Jorgensen, Rick" userId="22b7bd11-eb0f-413f-9bcb-9ce21ec7b0a8" providerId="ADAL" clId="{63C519A2-C2B2-47AC-828F-E429CD2FEDB2}" dt="2023-08-01T15:55:47.501" v="12235"/>
        <pc:sldMkLst>
          <pc:docMk/>
          <pc:sldMk cId="3421980213" sldId="404"/>
        </pc:sldMkLst>
        <pc:spChg chg="del">
          <ac:chgData name="Jorgensen, Rick" userId="22b7bd11-eb0f-413f-9bcb-9ce21ec7b0a8" providerId="ADAL" clId="{63C519A2-C2B2-47AC-828F-E429CD2FEDB2}" dt="2023-07-17T14:59:34.450" v="6825" actId="478"/>
          <ac:spMkLst>
            <pc:docMk/>
            <pc:sldMk cId="3421980213" sldId="404"/>
            <ac:spMk id="2" creationId="{86093107-869E-B9EB-05A0-DBBE64198E30}"/>
          </ac:spMkLst>
        </pc:spChg>
        <pc:spChg chg="mod">
          <ac:chgData name="Jorgensen, Rick" userId="22b7bd11-eb0f-413f-9bcb-9ce21ec7b0a8" providerId="ADAL" clId="{63C519A2-C2B2-47AC-828F-E429CD2FEDB2}" dt="2023-07-17T15:05:41.860" v="6900" actId="1076"/>
          <ac:spMkLst>
            <pc:docMk/>
            <pc:sldMk cId="3421980213" sldId="404"/>
            <ac:spMk id="9" creationId="{16C98FF7-C9E9-8046-A859-D9A599468A34}"/>
          </ac:spMkLst>
        </pc:spChg>
        <pc:spChg chg="mod">
          <ac:chgData name="Jorgensen, Rick" userId="22b7bd11-eb0f-413f-9bcb-9ce21ec7b0a8" providerId="ADAL" clId="{63C519A2-C2B2-47AC-828F-E429CD2FEDB2}" dt="2023-07-17T15:05:47.265" v="6901" actId="1076"/>
          <ac:spMkLst>
            <pc:docMk/>
            <pc:sldMk cId="3421980213" sldId="404"/>
            <ac:spMk id="10" creationId="{9F84E2A2-11BF-6249-A2DF-0BE34D738A76}"/>
          </ac:spMkLst>
        </pc:spChg>
        <pc:spChg chg="add mod">
          <ac:chgData name="Jorgensen, Rick" userId="22b7bd11-eb0f-413f-9bcb-9ce21ec7b0a8" providerId="ADAL" clId="{63C519A2-C2B2-47AC-828F-E429CD2FEDB2}" dt="2023-07-17T15:04:59.581" v="6889" actId="164"/>
          <ac:spMkLst>
            <pc:docMk/>
            <pc:sldMk cId="3421980213" sldId="404"/>
            <ac:spMk id="17" creationId="{4026A052-860C-6F48-1DF2-B3E62E5BFD96}"/>
          </ac:spMkLst>
        </pc:spChg>
        <pc:spChg chg="add mod">
          <ac:chgData name="Jorgensen, Rick" userId="22b7bd11-eb0f-413f-9bcb-9ce21ec7b0a8" providerId="ADAL" clId="{63C519A2-C2B2-47AC-828F-E429CD2FEDB2}" dt="2023-07-17T15:04:59.581" v="6889" actId="164"/>
          <ac:spMkLst>
            <pc:docMk/>
            <pc:sldMk cId="3421980213" sldId="404"/>
            <ac:spMk id="18" creationId="{E726F654-F39E-2D14-15C6-042DD8938AB4}"/>
          </ac:spMkLst>
        </pc:spChg>
        <pc:spChg chg="add mod">
          <ac:chgData name="Jorgensen, Rick" userId="22b7bd11-eb0f-413f-9bcb-9ce21ec7b0a8" providerId="ADAL" clId="{63C519A2-C2B2-47AC-828F-E429CD2FEDB2}" dt="2023-07-17T15:04:59.581" v="6889" actId="164"/>
          <ac:spMkLst>
            <pc:docMk/>
            <pc:sldMk cId="3421980213" sldId="404"/>
            <ac:spMk id="19" creationId="{381D76AC-2CC2-B2BB-1DEC-B82875378185}"/>
          </ac:spMkLst>
        </pc:spChg>
        <pc:spChg chg="add del mod">
          <ac:chgData name="Jorgensen, Rick" userId="22b7bd11-eb0f-413f-9bcb-9ce21ec7b0a8" providerId="ADAL" clId="{63C519A2-C2B2-47AC-828F-E429CD2FEDB2}" dt="2023-07-24T18:25:58.378" v="8193" actId="20577"/>
          <ac:spMkLst>
            <pc:docMk/>
            <pc:sldMk cId="3421980213" sldId="404"/>
            <ac:spMk id="25" creationId="{43DF711F-4684-B34D-9236-D3A26D348F11}"/>
          </ac:spMkLst>
        </pc:spChg>
        <pc:spChg chg="add mod">
          <ac:chgData name="Jorgensen, Rick" userId="22b7bd11-eb0f-413f-9bcb-9ce21ec7b0a8" providerId="ADAL" clId="{63C519A2-C2B2-47AC-828F-E429CD2FEDB2}" dt="2023-07-17T15:06:39.335" v="6909" actId="207"/>
          <ac:spMkLst>
            <pc:docMk/>
            <pc:sldMk cId="3421980213" sldId="404"/>
            <ac:spMk id="30" creationId="{3D48DC1C-90A7-8867-CD77-A30256D274E3}"/>
          </ac:spMkLst>
        </pc:spChg>
        <pc:spChg chg="add mod">
          <ac:chgData name="Jorgensen, Rick" userId="22b7bd11-eb0f-413f-9bcb-9ce21ec7b0a8" providerId="ADAL" clId="{63C519A2-C2B2-47AC-828F-E429CD2FEDB2}" dt="2023-07-17T15:06:58.012" v="6917" actId="14100"/>
          <ac:spMkLst>
            <pc:docMk/>
            <pc:sldMk cId="3421980213" sldId="404"/>
            <ac:spMk id="31" creationId="{1780F414-B5FA-B5ED-4ECE-42C5CA3D7C74}"/>
          </ac:spMkLst>
        </pc:spChg>
        <pc:spChg chg="add mod">
          <ac:chgData name="Jorgensen, Rick" userId="22b7bd11-eb0f-413f-9bcb-9ce21ec7b0a8" providerId="ADAL" clId="{63C519A2-C2B2-47AC-828F-E429CD2FEDB2}" dt="2023-07-17T15:07:07.556" v="6924" actId="1076"/>
          <ac:spMkLst>
            <pc:docMk/>
            <pc:sldMk cId="3421980213" sldId="404"/>
            <ac:spMk id="33" creationId="{C0BEA176-77D8-CDD1-9079-4E9E8965D112}"/>
          </ac:spMkLst>
        </pc:spChg>
        <pc:grpChg chg="del">
          <ac:chgData name="Jorgensen, Rick" userId="22b7bd11-eb0f-413f-9bcb-9ce21ec7b0a8" providerId="ADAL" clId="{63C519A2-C2B2-47AC-828F-E429CD2FEDB2}" dt="2023-07-17T14:59:31.705" v="6823" actId="478"/>
          <ac:grpSpMkLst>
            <pc:docMk/>
            <pc:sldMk cId="3421980213" sldId="404"/>
            <ac:grpSpMk id="11" creationId="{ED8CF572-9196-C83F-0B7D-7754AC4AACEE}"/>
          </ac:grpSpMkLst>
        </pc:grpChg>
        <pc:grpChg chg="del">
          <ac:chgData name="Jorgensen, Rick" userId="22b7bd11-eb0f-413f-9bcb-9ce21ec7b0a8" providerId="ADAL" clId="{63C519A2-C2B2-47AC-828F-E429CD2FEDB2}" dt="2023-07-17T14:59:33.244" v="6824" actId="478"/>
          <ac:grpSpMkLst>
            <pc:docMk/>
            <pc:sldMk cId="3421980213" sldId="404"/>
            <ac:grpSpMk id="14" creationId="{A8E3776A-5242-7004-112E-A97F135505AD}"/>
          </ac:grpSpMkLst>
        </pc:grpChg>
        <pc:grpChg chg="add mod">
          <ac:chgData name="Jorgensen, Rick" userId="22b7bd11-eb0f-413f-9bcb-9ce21ec7b0a8" providerId="ADAL" clId="{63C519A2-C2B2-47AC-828F-E429CD2FEDB2}" dt="2023-07-17T15:05:39.274" v="6899" actId="1076"/>
          <ac:grpSpMkLst>
            <pc:docMk/>
            <pc:sldMk cId="3421980213" sldId="404"/>
            <ac:grpSpMk id="20" creationId="{0B2F194D-FED7-2B84-ED02-A1688A3FDA40}"/>
          </ac:grpSpMkLst>
        </pc:grpChg>
        <pc:graphicFrameChg chg="add mod">
          <ac:chgData name="Jorgensen, Rick" userId="22b7bd11-eb0f-413f-9bcb-9ce21ec7b0a8" providerId="ADAL" clId="{63C519A2-C2B2-47AC-828F-E429CD2FEDB2}" dt="2023-07-17T15:05:35.828" v="6898" actId="1076"/>
          <ac:graphicFrameMkLst>
            <pc:docMk/>
            <pc:sldMk cId="3421980213" sldId="404"/>
            <ac:graphicFrameMk id="5" creationId="{B1822635-3346-487C-87DA-AE621ADB84DC}"/>
          </ac:graphicFrameMkLst>
        </pc:graphicFrameChg>
        <pc:graphicFrameChg chg="add del">
          <ac:chgData name="Jorgensen, Rick" userId="22b7bd11-eb0f-413f-9bcb-9ce21ec7b0a8" providerId="ADAL" clId="{63C519A2-C2B2-47AC-828F-E429CD2FEDB2}" dt="2023-07-17T14:59:28.466" v="6821" actId="478"/>
          <ac:graphicFrameMkLst>
            <pc:docMk/>
            <pc:sldMk cId="3421980213" sldId="404"/>
            <ac:graphicFrameMk id="12" creationId="{52659E5C-59D3-44AA-93EA-00A3834A1AAD}"/>
          </ac:graphicFrameMkLst>
        </pc:graphicFrameChg>
        <pc:graphicFrameChg chg="add mod">
          <ac:chgData name="Jorgensen, Rick" userId="22b7bd11-eb0f-413f-9bcb-9ce21ec7b0a8" providerId="ADAL" clId="{63C519A2-C2B2-47AC-828F-E429CD2FEDB2}" dt="2023-07-17T15:06:10.406" v="6905" actId="14100"/>
          <ac:graphicFrameMkLst>
            <pc:docMk/>
            <pc:sldMk cId="3421980213" sldId="404"/>
            <ac:graphicFrameMk id="22" creationId="{871B0361-088F-4166-B51E-18DC5A5E21C1}"/>
          </ac:graphicFrameMkLst>
        </pc:graphicFrameChg>
        <pc:graphicFrameChg chg="del">
          <ac:chgData name="Jorgensen, Rick" userId="22b7bd11-eb0f-413f-9bcb-9ce21ec7b0a8" providerId="ADAL" clId="{63C519A2-C2B2-47AC-828F-E429CD2FEDB2}" dt="2023-07-17T14:59:29.591" v="6822" actId="478"/>
          <ac:graphicFrameMkLst>
            <pc:docMk/>
            <pc:sldMk cId="3421980213" sldId="404"/>
            <ac:graphicFrameMk id="35" creationId="{2C46D776-ED2F-4957-B9BC-1A60F0DB73E6}"/>
          </ac:graphicFrameMkLst>
        </pc:graphicFrameChg>
      </pc:sldChg>
      <pc:sldChg chg="addSp delSp modSp add mod ord">
        <pc:chgData name="Jorgensen, Rick" userId="22b7bd11-eb0f-413f-9bcb-9ce21ec7b0a8" providerId="ADAL" clId="{63C519A2-C2B2-47AC-828F-E429CD2FEDB2}" dt="2023-08-01T15:55:47.501" v="12235"/>
        <pc:sldMkLst>
          <pc:docMk/>
          <pc:sldMk cId="2185191487" sldId="405"/>
        </pc:sldMkLst>
        <pc:spChg chg="add del mod">
          <ac:chgData name="Jorgensen, Rick" userId="22b7bd11-eb0f-413f-9bcb-9ce21ec7b0a8" providerId="ADAL" clId="{63C519A2-C2B2-47AC-828F-E429CD2FEDB2}" dt="2023-07-17T15:09:20.230" v="6947" actId="478"/>
          <ac:spMkLst>
            <pc:docMk/>
            <pc:sldMk cId="2185191487" sldId="405"/>
            <ac:spMk id="3" creationId="{7CEBDE67-6171-A3F0-5BBE-9582EDA79DE0}"/>
          </ac:spMkLst>
        </pc:spChg>
        <pc:spChg chg="add mod">
          <ac:chgData name="Jorgensen, Rick" userId="22b7bd11-eb0f-413f-9bcb-9ce21ec7b0a8" providerId="ADAL" clId="{63C519A2-C2B2-47AC-828F-E429CD2FEDB2}" dt="2023-07-17T15:09:27.088" v="6949" actId="1076"/>
          <ac:spMkLst>
            <pc:docMk/>
            <pc:sldMk cId="2185191487" sldId="405"/>
            <ac:spMk id="4" creationId="{2E3E064F-A997-DB08-DBB4-25D73D3A9F06}"/>
          </ac:spMkLst>
        </pc:spChg>
        <pc:spChg chg="add mod">
          <ac:chgData name="Jorgensen, Rick" userId="22b7bd11-eb0f-413f-9bcb-9ce21ec7b0a8" providerId="ADAL" clId="{63C519A2-C2B2-47AC-828F-E429CD2FEDB2}" dt="2023-07-17T15:09:39.330" v="6955" actId="20577"/>
          <ac:spMkLst>
            <pc:docMk/>
            <pc:sldMk cId="2185191487" sldId="405"/>
            <ac:spMk id="6" creationId="{05B8A3F1-645B-8B64-B24E-2BD2B30AD81D}"/>
          </ac:spMkLst>
        </pc:spChg>
        <pc:spChg chg="add mod">
          <ac:chgData name="Jorgensen, Rick" userId="22b7bd11-eb0f-413f-9bcb-9ce21ec7b0a8" providerId="ADAL" clId="{63C519A2-C2B2-47AC-828F-E429CD2FEDB2}" dt="2023-07-17T15:09:43.264" v="6959" actId="20577"/>
          <ac:spMkLst>
            <pc:docMk/>
            <pc:sldMk cId="2185191487" sldId="405"/>
            <ac:spMk id="7" creationId="{40CEF3CF-DC5B-7AB3-0979-66FFF9D340F4}"/>
          </ac:spMkLst>
        </pc:spChg>
        <pc:spChg chg="mod">
          <ac:chgData name="Jorgensen, Rick" userId="22b7bd11-eb0f-413f-9bcb-9ce21ec7b0a8" providerId="ADAL" clId="{63C519A2-C2B2-47AC-828F-E429CD2FEDB2}" dt="2023-07-17T15:08:13.361" v="6927" actId="20577"/>
          <ac:spMkLst>
            <pc:docMk/>
            <pc:sldMk cId="2185191487" sldId="405"/>
            <ac:spMk id="9" creationId="{16C98FF7-C9E9-8046-A859-D9A599468A34}"/>
          </ac:spMkLst>
        </pc:spChg>
        <pc:spChg chg="mod">
          <ac:chgData name="Jorgensen, Rick" userId="22b7bd11-eb0f-413f-9bcb-9ce21ec7b0a8" providerId="ADAL" clId="{63C519A2-C2B2-47AC-828F-E429CD2FEDB2}" dt="2023-07-17T15:08:16.466" v="6929" actId="20577"/>
          <ac:spMkLst>
            <pc:docMk/>
            <pc:sldMk cId="2185191487" sldId="405"/>
            <ac:spMk id="10" creationId="{9F84E2A2-11BF-6249-A2DF-0BE34D738A76}"/>
          </ac:spMkLst>
        </pc:spChg>
        <pc:spChg chg="mod">
          <ac:chgData name="Jorgensen, Rick" userId="22b7bd11-eb0f-413f-9bcb-9ce21ec7b0a8" providerId="ADAL" clId="{63C519A2-C2B2-47AC-828F-E429CD2FEDB2}" dt="2023-07-24T18:26:01.868" v="8197" actId="20577"/>
          <ac:spMkLst>
            <pc:docMk/>
            <pc:sldMk cId="2185191487" sldId="405"/>
            <ac:spMk id="25" creationId="{43DF711F-4684-B34D-9236-D3A26D348F11}"/>
          </ac:spMkLst>
        </pc:spChg>
        <pc:spChg chg="mod">
          <ac:chgData name="Jorgensen, Rick" userId="22b7bd11-eb0f-413f-9bcb-9ce21ec7b0a8" providerId="ADAL" clId="{63C519A2-C2B2-47AC-828F-E429CD2FEDB2}" dt="2023-07-17T15:10:23.987" v="6968" actId="164"/>
          <ac:spMkLst>
            <pc:docMk/>
            <pc:sldMk cId="2185191487" sldId="405"/>
            <ac:spMk id="30" creationId="{3D48DC1C-90A7-8867-CD77-A30256D274E3}"/>
          </ac:spMkLst>
        </pc:spChg>
        <pc:spChg chg="mod">
          <ac:chgData name="Jorgensen, Rick" userId="22b7bd11-eb0f-413f-9bcb-9ce21ec7b0a8" providerId="ADAL" clId="{63C519A2-C2B2-47AC-828F-E429CD2FEDB2}" dt="2023-07-17T15:10:42.592" v="6981" actId="14100"/>
          <ac:spMkLst>
            <pc:docMk/>
            <pc:sldMk cId="2185191487" sldId="405"/>
            <ac:spMk id="31" creationId="{1780F414-B5FA-B5ED-4ECE-42C5CA3D7C74}"/>
          </ac:spMkLst>
        </pc:spChg>
        <pc:spChg chg="mod">
          <ac:chgData name="Jorgensen, Rick" userId="22b7bd11-eb0f-413f-9bcb-9ce21ec7b0a8" providerId="ADAL" clId="{63C519A2-C2B2-47AC-828F-E429CD2FEDB2}" dt="2023-07-17T15:10:52.838" v="6989" actId="14100"/>
          <ac:spMkLst>
            <pc:docMk/>
            <pc:sldMk cId="2185191487" sldId="405"/>
            <ac:spMk id="33" creationId="{C0BEA176-77D8-CDD1-9079-4E9E8965D112}"/>
          </ac:spMkLst>
        </pc:spChg>
        <pc:grpChg chg="add mod ord">
          <ac:chgData name="Jorgensen, Rick" userId="22b7bd11-eb0f-413f-9bcb-9ce21ec7b0a8" providerId="ADAL" clId="{63C519A2-C2B2-47AC-828F-E429CD2FEDB2}" dt="2023-07-17T15:10:57.516" v="6990" actId="1076"/>
          <ac:grpSpMkLst>
            <pc:docMk/>
            <pc:sldMk cId="2185191487" sldId="405"/>
            <ac:grpSpMk id="11" creationId="{DC73521D-86F1-D052-BDB0-06CC80324E76}"/>
          </ac:grpSpMkLst>
        </pc:grpChg>
        <pc:grpChg chg="del">
          <ac:chgData name="Jorgensen, Rick" userId="22b7bd11-eb0f-413f-9bcb-9ce21ec7b0a8" providerId="ADAL" clId="{63C519A2-C2B2-47AC-828F-E429CD2FEDB2}" dt="2023-07-17T15:08:18.310" v="6930" actId="478"/>
          <ac:grpSpMkLst>
            <pc:docMk/>
            <pc:sldMk cId="2185191487" sldId="405"/>
            <ac:grpSpMk id="20" creationId="{0B2F194D-FED7-2B84-ED02-A1688A3FDA40}"/>
          </ac:grpSpMkLst>
        </pc:grpChg>
        <pc:graphicFrameChg chg="add mod">
          <ac:chgData name="Jorgensen, Rick" userId="22b7bd11-eb0f-413f-9bcb-9ce21ec7b0a8" providerId="ADAL" clId="{63C519A2-C2B2-47AC-828F-E429CD2FEDB2}" dt="2023-07-17T15:08:39.981" v="6934" actId="1076"/>
          <ac:graphicFrameMkLst>
            <pc:docMk/>
            <pc:sldMk cId="2185191487" sldId="405"/>
            <ac:graphicFrameMk id="2" creationId="{6C0B429F-1A22-491B-86D8-46E474B48069}"/>
          </ac:graphicFrameMkLst>
        </pc:graphicFrameChg>
        <pc:graphicFrameChg chg="add mod">
          <ac:chgData name="Jorgensen, Rick" userId="22b7bd11-eb0f-413f-9bcb-9ce21ec7b0a8" providerId="ADAL" clId="{63C519A2-C2B2-47AC-828F-E429CD2FEDB2}" dt="2023-07-17T15:10:12.862" v="6965" actId="1076"/>
          <ac:graphicFrameMkLst>
            <pc:docMk/>
            <pc:sldMk cId="2185191487" sldId="405"/>
            <ac:graphicFrameMk id="8" creationId="{2A986585-C645-4785-87C9-DEF49D3527FF}"/>
          </ac:graphicFrameMkLst>
        </pc:graphicFrameChg>
        <pc:graphicFrameChg chg="del">
          <ac:chgData name="Jorgensen, Rick" userId="22b7bd11-eb0f-413f-9bcb-9ce21ec7b0a8" providerId="ADAL" clId="{63C519A2-C2B2-47AC-828F-E429CD2FEDB2}" dt="2023-07-17T15:08:41.928" v="6935" actId="478"/>
          <ac:graphicFrameMkLst>
            <pc:docMk/>
            <pc:sldMk cId="2185191487" sldId="405"/>
            <ac:graphicFrameMk id="22" creationId="{871B0361-088F-4166-B51E-18DC5A5E21C1}"/>
          </ac:graphicFrameMkLst>
        </pc:graphicFrameChg>
      </pc:sldChg>
      <pc:sldChg chg="add ord">
        <pc:chgData name="Jorgensen, Rick" userId="22b7bd11-eb0f-413f-9bcb-9ce21ec7b0a8" providerId="ADAL" clId="{63C519A2-C2B2-47AC-828F-E429CD2FEDB2}" dt="2023-08-01T15:25:29.290" v="11625"/>
        <pc:sldMkLst>
          <pc:docMk/>
          <pc:sldMk cId="3023127125" sldId="406"/>
        </pc:sldMkLst>
      </pc:sldChg>
      <pc:sldChg chg="addSp delSp modSp add del mod ord">
        <pc:chgData name="Jorgensen, Rick" userId="22b7bd11-eb0f-413f-9bcb-9ce21ec7b0a8" providerId="ADAL" clId="{63C519A2-C2B2-47AC-828F-E429CD2FEDB2}" dt="2023-07-31T18:39:23.643" v="10208" actId="47"/>
        <pc:sldMkLst>
          <pc:docMk/>
          <pc:sldMk cId="2194956609" sldId="407"/>
        </pc:sldMkLst>
        <pc:spChg chg="mod">
          <ac:chgData name="Jorgensen, Rick" userId="22b7bd11-eb0f-413f-9bcb-9ce21ec7b0a8" providerId="ADAL" clId="{63C519A2-C2B2-47AC-828F-E429CD2FEDB2}" dt="2023-07-17T17:37:36.816" v="7167" actId="1076"/>
          <ac:spMkLst>
            <pc:docMk/>
            <pc:sldMk cId="2194956609" sldId="407"/>
            <ac:spMk id="4" creationId="{D8FE5915-90A1-100D-9F27-2D16C32C673E}"/>
          </ac:spMkLst>
        </pc:spChg>
        <pc:spChg chg="mod">
          <ac:chgData name="Jorgensen, Rick" userId="22b7bd11-eb0f-413f-9bcb-9ce21ec7b0a8" providerId="ADAL" clId="{63C519A2-C2B2-47AC-828F-E429CD2FEDB2}" dt="2023-07-24T18:02:26.197" v="7747" actId="1076"/>
          <ac:spMkLst>
            <pc:docMk/>
            <pc:sldMk cId="2194956609" sldId="407"/>
            <ac:spMk id="5" creationId="{9FC6211B-39C1-955A-0B6C-E098D48468C7}"/>
          </ac:spMkLst>
        </pc:spChg>
        <pc:spChg chg="mod">
          <ac:chgData name="Jorgensen, Rick" userId="22b7bd11-eb0f-413f-9bcb-9ce21ec7b0a8" providerId="ADAL" clId="{63C519A2-C2B2-47AC-828F-E429CD2FEDB2}" dt="2023-07-17T17:37:47.204" v="7168"/>
          <ac:spMkLst>
            <pc:docMk/>
            <pc:sldMk cId="2194956609" sldId="407"/>
            <ac:spMk id="6" creationId="{D97C34D0-6030-BE16-25D6-70F369F72DD7}"/>
          </ac:spMkLst>
        </pc:spChg>
        <pc:spChg chg="mod">
          <ac:chgData name="Jorgensen, Rick" userId="22b7bd11-eb0f-413f-9bcb-9ce21ec7b0a8" providerId="ADAL" clId="{63C519A2-C2B2-47AC-828F-E429CD2FEDB2}" dt="2023-07-17T17:37:47.204" v="7168"/>
          <ac:spMkLst>
            <pc:docMk/>
            <pc:sldMk cId="2194956609" sldId="407"/>
            <ac:spMk id="7" creationId="{5C091984-9B78-4326-0B68-132B326FAC31}"/>
          </ac:spMkLst>
        </pc:spChg>
        <pc:spChg chg="mod">
          <ac:chgData name="Jorgensen, Rick" userId="22b7bd11-eb0f-413f-9bcb-9ce21ec7b0a8" providerId="ADAL" clId="{63C519A2-C2B2-47AC-828F-E429CD2FEDB2}" dt="2023-07-17T17:37:47.204" v="7168"/>
          <ac:spMkLst>
            <pc:docMk/>
            <pc:sldMk cId="2194956609" sldId="407"/>
            <ac:spMk id="8" creationId="{E093DCF8-E319-E622-6BE1-7CBE00E0614C}"/>
          </ac:spMkLst>
        </pc:spChg>
        <pc:spChg chg="mod">
          <ac:chgData name="Jorgensen, Rick" userId="22b7bd11-eb0f-413f-9bcb-9ce21ec7b0a8" providerId="ADAL" clId="{63C519A2-C2B2-47AC-828F-E429CD2FEDB2}" dt="2023-07-17T17:37:47.204" v="7168"/>
          <ac:spMkLst>
            <pc:docMk/>
            <pc:sldMk cId="2194956609" sldId="407"/>
            <ac:spMk id="9" creationId="{A331B860-21F4-E2D4-CA8A-DCE3B119230F}"/>
          </ac:spMkLst>
        </pc:spChg>
        <pc:spChg chg="add mod">
          <ac:chgData name="Jorgensen, Rick" userId="22b7bd11-eb0f-413f-9bcb-9ce21ec7b0a8" providerId="ADAL" clId="{63C519A2-C2B2-47AC-828F-E429CD2FEDB2}" dt="2023-07-17T17:41:23.285" v="7205" actId="207"/>
          <ac:spMkLst>
            <pc:docMk/>
            <pc:sldMk cId="2194956609" sldId="407"/>
            <ac:spMk id="10" creationId="{B4E0F80F-2E9B-C69E-A34B-C0FD0545C280}"/>
          </ac:spMkLst>
        </pc:spChg>
        <pc:spChg chg="add mod">
          <ac:chgData name="Jorgensen, Rick" userId="22b7bd11-eb0f-413f-9bcb-9ce21ec7b0a8" providerId="ADAL" clId="{63C519A2-C2B2-47AC-828F-E429CD2FEDB2}" dt="2023-07-17T17:43:04.163" v="7241" actId="553"/>
          <ac:spMkLst>
            <pc:docMk/>
            <pc:sldMk cId="2194956609" sldId="407"/>
            <ac:spMk id="11" creationId="{6B2F6E9C-55E9-50E1-DDBD-D33700BBDF5E}"/>
          </ac:spMkLst>
        </pc:spChg>
        <pc:spChg chg="add mod">
          <ac:chgData name="Jorgensen, Rick" userId="22b7bd11-eb0f-413f-9bcb-9ce21ec7b0a8" providerId="ADAL" clId="{63C519A2-C2B2-47AC-828F-E429CD2FEDB2}" dt="2023-07-17T17:43:04.163" v="7241" actId="553"/>
          <ac:spMkLst>
            <pc:docMk/>
            <pc:sldMk cId="2194956609" sldId="407"/>
            <ac:spMk id="12" creationId="{A839A502-4593-8544-0E13-6B336CDEA4C0}"/>
          </ac:spMkLst>
        </pc:spChg>
        <pc:spChg chg="add mod">
          <ac:chgData name="Jorgensen, Rick" userId="22b7bd11-eb0f-413f-9bcb-9ce21ec7b0a8" providerId="ADAL" clId="{63C519A2-C2B2-47AC-828F-E429CD2FEDB2}" dt="2023-07-17T17:43:04.163" v="7241" actId="553"/>
          <ac:spMkLst>
            <pc:docMk/>
            <pc:sldMk cId="2194956609" sldId="407"/>
            <ac:spMk id="13" creationId="{93B7C91F-C0C7-AC74-20FF-C5458875C38C}"/>
          </ac:spMkLst>
        </pc:spChg>
        <pc:spChg chg="add mod">
          <ac:chgData name="Jorgensen, Rick" userId="22b7bd11-eb0f-413f-9bcb-9ce21ec7b0a8" providerId="ADAL" clId="{63C519A2-C2B2-47AC-828F-E429CD2FEDB2}" dt="2023-07-17T17:43:04.163" v="7241" actId="553"/>
          <ac:spMkLst>
            <pc:docMk/>
            <pc:sldMk cId="2194956609" sldId="407"/>
            <ac:spMk id="14" creationId="{526245D3-295A-C05C-F40B-DEC75591E866}"/>
          </ac:spMkLst>
        </pc:spChg>
        <pc:spChg chg="mod">
          <ac:chgData name="Jorgensen, Rick" userId="22b7bd11-eb0f-413f-9bcb-9ce21ec7b0a8" providerId="ADAL" clId="{63C519A2-C2B2-47AC-828F-E429CD2FEDB2}" dt="2023-07-17T17:37:26.129" v="7166" actId="1076"/>
          <ac:spMkLst>
            <pc:docMk/>
            <pc:sldMk cId="2194956609" sldId="407"/>
            <ac:spMk id="15" creationId="{1BA55689-1E02-D64A-AEF5-1140E4E5B817}"/>
          </ac:spMkLst>
        </pc:spChg>
        <pc:spChg chg="add mod">
          <ac:chgData name="Jorgensen, Rick" userId="22b7bd11-eb0f-413f-9bcb-9ce21ec7b0a8" providerId="ADAL" clId="{63C519A2-C2B2-47AC-828F-E429CD2FEDB2}" dt="2023-07-17T17:43:04.163" v="7241" actId="553"/>
          <ac:spMkLst>
            <pc:docMk/>
            <pc:sldMk cId="2194956609" sldId="407"/>
            <ac:spMk id="16" creationId="{2D1DD050-20D7-BFE3-4560-C34C58ECBDB9}"/>
          </ac:spMkLst>
        </pc:spChg>
        <pc:spChg chg="mod">
          <ac:chgData name="Jorgensen, Rick" userId="22b7bd11-eb0f-413f-9bcb-9ce21ec7b0a8" providerId="ADAL" clId="{63C519A2-C2B2-47AC-828F-E429CD2FEDB2}" dt="2023-07-24T18:27:16.573" v="8251" actId="20577"/>
          <ac:spMkLst>
            <pc:docMk/>
            <pc:sldMk cId="2194956609" sldId="407"/>
            <ac:spMk id="25" creationId="{43DF711F-4684-B34D-9236-D3A26D348F11}"/>
          </ac:spMkLst>
        </pc:spChg>
        <pc:grpChg chg="add mod">
          <ac:chgData name="Jorgensen, Rick" userId="22b7bd11-eb0f-413f-9bcb-9ce21ec7b0a8" providerId="ADAL" clId="{63C519A2-C2B2-47AC-828F-E429CD2FEDB2}" dt="2023-07-17T17:37:52.812" v="7169" actId="1076"/>
          <ac:grpSpMkLst>
            <pc:docMk/>
            <pc:sldMk cId="2194956609" sldId="407"/>
            <ac:grpSpMk id="3" creationId="{20858C5F-90B2-91EB-9D9E-6AE193D5FFBB}"/>
          </ac:grpSpMkLst>
        </pc:grpChg>
        <pc:graphicFrameChg chg="add mod">
          <ac:chgData name="Jorgensen, Rick" userId="22b7bd11-eb0f-413f-9bcb-9ce21ec7b0a8" providerId="ADAL" clId="{63C519A2-C2B2-47AC-828F-E429CD2FEDB2}" dt="2023-07-17T17:37:21.179" v="7165"/>
          <ac:graphicFrameMkLst>
            <pc:docMk/>
            <pc:sldMk cId="2194956609" sldId="407"/>
            <ac:graphicFrameMk id="2" creationId="{BC0289C9-88C8-4E03-837C-113225E7B331}"/>
          </ac:graphicFrameMkLst>
        </pc:graphicFrameChg>
        <pc:graphicFrameChg chg="del">
          <ac:chgData name="Jorgensen, Rick" userId="22b7bd11-eb0f-413f-9bcb-9ce21ec7b0a8" providerId="ADAL" clId="{63C519A2-C2B2-47AC-828F-E429CD2FEDB2}" dt="2023-07-17T17:37:11.375" v="7160" actId="478"/>
          <ac:graphicFrameMkLst>
            <pc:docMk/>
            <pc:sldMk cId="2194956609" sldId="407"/>
            <ac:graphicFrameMk id="5" creationId="{CCC26A41-0417-4D74-81CF-4F4D435C57CC}"/>
          </ac:graphicFrameMkLst>
        </pc:graphicFrameChg>
      </pc:sldChg>
      <pc:sldChg chg="addSp delSp modSp add mod ord">
        <pc:chgData name="Jorgensen, Rick" userId="22b7bd11-eb0f-413f-9bcb-9ce21ec7b0a8" providerId="ADAL" clId="{63C519A2-C2B2-47AC-828F-E429CD2FEDB2}" dt="2023-08-01T15:56:34.243" v="12247" actId="20577"/>
        <pc:sldMkLst>
          <pc:docMk/>
          <pc:sldMk cId="2264319159" sldId="408"/>
        </pc:sldMkLst>
        <pc:spChg chg="del mod">
          <ac:chgData name="Jorgensen, Rick" userId="22b7bd11-eb0f-413f-9bcb-9ce21ec7b0a8" providerId="ADAL" clId="{63C519A2-C2B2-47AC-828F-E429CD2FEDB2}" dt="2023-07-27T17:33:56.895" v="9298" actId="478"/>
          <ac:spMkLst>
            <pc:docMk/>
            <pc:sldMk cId="2264319159" sldId="408"/>
            <ac:spMk id="2" creationId="{8EFEAB41-433B-43A8-ACF1-88DEF577F222}"/>
          </ac:spMkLst>
        </pc:spChg>
        <pc:spChg chg="add mod">
          <ac:chgData name="Jorgensen, Rick" userId="22b7bd11-eb0f-413f-9bcb-9ce21ec7b0a8" providerId="ADAL" clId="{63C519A2-C2B2-47AC-828F-E429CD2FEDB2}" dt="2023-08-01T15:53:29.044" v="12183" actId="1076"/>
          <ac:spMkLst>
            <pc:docMk/>
            <pc:sldMk cId="2264319159" sldId="408"/>
            <ac:spMk id="2" creationId="{C7BC4AC9-55F0-A34C-0E36-E0E54A5C4936}"/>
          </ac:spMkLst>
        </pc:spChg>
        <pc:spChg chg="add mod">
          <ac:chgData name="Jorgensen, Rick" userId="22b7bd11-eb0f-413f-9bcb-9ce21ec7b0a8" providerId="ADAL" clId="{63C519A2-C2B2-47AC-828F-E429CD2FEDB2}" dt="2023-08-01T15:53:32.813" v="12184" actId="1076"/>
          <ac:spMkLst>
            <pc:docMk/>
            <pc:sldMk cId="2264319159" sldId="408"/>
            <ac:spMk id="3" creationId="{2CBEE1F9-D739-120F-A3B4-7E6DE2B8A648}"/>
          </ac:spMkLst>
        </pc:spChg>
        <pc:spChg chg="add mod ord">
          <ac:chgData name="Jorgensen, Rick" userId="22b7bd11-eb0f-413f-9bcb-9ce21ec7b0a8" providerId="ADAL" clId="{63C519A2-C2B2-47AC-828F-E429CD2FEDB2}" dt="2023-07-27T17:41:21.389" v="9353" actId="1076"/>
          <ac:spMkLst>
            <pc:docMk/>
            <pc:sldMk cId="2264319159" sldId="408"/>
            <ac:spMk id="4" creationId="{BA8AFA7A-54C4-A2FE-02DA-3CD76CF0C5E3}"/>
          </ac:spMkLst>
        </pc:spChg>
        <pc:spChg chg="add mod">
          <ac:chgData name="Jorgensen, Rick" userId="22b7bd11-eb0f-413f-9bcb-9ce21ec7b0a8" providerId="ADAL" clId="{63C519A2-C2B2-47AC-828F-E429CD2FEDB2}" dt="2023-08-01T15:55:01.055" v="12228" actId="20577"/>
          <ac:spMkLst>
            <pc:docMk/>
            <pc:sldMk cId="2264319159" sldId="408"/>
            <ac:spMk id="7" creationId="{26939D55-B6EB-1805-9ACB-748C824D15DD}"/>
          </ac:spMkLst>
        </pc:spChg>
        <pc:spChg chg="add mod">
          <ac:chgData name="Jorgensen, Rick" userId="22b7bd11-eb0f-413f-9bcb-9ce21ec7b0a8" providerId="ADAL" clId="{63C519A2-C2B2-47AC-828F-E429CD2FEDB2}" dt="2023-08-01T15:51:45.775" v="12126" actId="1076"/>
          <ac:spMkLst>
            <pc:docMk/>
            <pc:sldMk cId="2264319159" sldId="408"/>
            <ac:spMk id="8" creationId="{627942DB-E913-E84F-DA5F-E3A249FA3908}"/>
          </ac:spMkLst>
        </pc:spChg>
        <pc:spChg chg="mod">
          <ac:chgData name="Jorgensen, Rick" userId="22b7bd11-eb0f-413f-9bcb-9ce21ec7b0a8" providerId="ADAL" clId="{63C519A2-C2B2-47AC-828F-E429CD2FEDB2}" dt="2023-08-01T15:53:41.336" v="12185" actId="1076"/>
          <ac:spMkLst>
            <pc:docMk/>
            <pc:sldMk cId="2264319159" sldId="408"/>
            <ac:spMk id="12" creationId="{FB9219B3-968D-FB2B-0B8E-B0F2C2B08910}"/>
          </ac:spMkLst>
        </pc:spChg>
        <pc:spChg chg="mod">
          <ac:chgData name="Jorgensen, Rick" userId="22b7bd11-eb0f-413f-9bcb-9ce21ec7b0a8" providerId="ADAL" clId="{63C519A2-C2B2-47AC-828F-E429CD2FEDB2}" dt="2023-08-01T15:52:37.594" v="12153" actId="1076"/>
          <ac:spMkLst>
            <pc:docMk/>
            <pc:sldMk cId="2264319159" sldId="408"/>
            <ac:spMk id="13" creationId="{17223BBD-BD68-A3C5-875F-E0DF77012F65}"/>
          </ac:spMkLst>
        </pc:spChg>
        <pc:spChg chg="add mod">
          <ac:chgData name="Jorgensen, Rick" userId="22b7bd11-eb0f-413f-9bcb-9ce21ec7b0a8" providerId="ADAL" clId="{63C519A2-C2B2-47AC-828F-E429CD2FEDB2}" dt="2023-07-24T14:52:44.871" v="7349" actId="14100"/>
          <ac:spMkLst>
            <pc:docMk/>
            <pc:sldMk cId="2264319159" sldId="408"/>
            <ac:spMk id="14" creationId="{156CE65C-A549-44C4-F8D6-ED4B92254675}"/>
          </ac:spMkLst>
        </pc:spChg>
        <pc:spChg chg="add del mod ord">
          <ac:chgData name="Jorgensen, Rick" userId="22b7bd11-eb0f-413f-9bcb-9ce21ec7b0a8" providerId="ADAL" clId="{63C519A2-C2B2-47AC-828F-E429CD2FEDB2}" dt="2023-07-27T17:33:49.807" v="9296" actId="478"/>
          <ac:spMkLst>
            <pc:docMk/>
            <pc:sldMk cId="2264319159" sldId="408"/>
            <ac:spMk id="15" creationId="{173B057F-B5A5-65B5-CC6F-49167E2ECD3A}"/>
          </ac:spMkLst>
        </pc:spChg>
        <pc:spChg chg="add del mod">
          <ac:chgData name="Jorgensen, Rick" userId="22b7bd11-eb0f-413f-9bcb-9ce21ec7b0a8" providerId="ADAL" clId="{63C519A2-C2B2-47AC-828F-E429CD2FEDB2}" dt="2023-07-27T17:33:49.807" v="9296" actId="478"/>
          <ac:spMkLst>
            <pc:docMk/>
            <pc:sldMk cId="2264319159" sldId="408"/>
            <ac:spMk id="16" creationId="{AA43EFEB-2BC0-1289-83CF-640785EE1C2A}"/>
          </ac:spMkLst>
        </pc:spChg>
        <pc:spChg chg="add mod">
          <ac:chgData name="Jorgensen, Rick" userId="22b7bd11-eb0f-413f-9bcb-9ce21ec7b0a8" providerId="ADAL" clId="{63C519A2-C2B2-47AC-828F-E429CD2FEDB2}" dt="2023-07-27T17:35:13.551" v="9321" actId="1076"/>
          <ac:spMkLst>
            <pc:docMk/>
            <pc:sldMk cId="2264319159" sldId="408"/>
            <ac:spMk id="17" creationId="{02ECCAB9-A8AC-24FB-7845-8BF54152DD86}"/>
          </ac:spMkLst>
        </pc:spChg>
        <pc:spChg chg="add mod">
          <ac:chgData name="Jorgensen, Rick" userId="22b7bd11-eb0f-413f-9bcb-9ce21ec7b0a8" providerId="ADAL" clId="{63C519A2-C2B2-47AC-828F-E429CD2FEDB2}" dt="2023-07-27T17:35:15.905" v="9323" actId="1076"/>
          <ac:spMkLst>
            <pc:docMk/>
            <pc:sldMk cId="2264319159" sldId="408"/>
            <ac:spMk id="18" creationId="{3FA7D0C5-ABB7-8048-BD96-32E18AC34425}"/>
          </ac:spMkLst>
        </pc:spChg>
        <pc:spChg chg="add mod">
          <ac:chgData name="Jorgensen, Rick" userId="22b7bd11-eb0f-413f-9bcb-9ce21ec7b0a8" providerId="ADAL" clId="{63C519A2-C2B2-47AC-828F-E429CD2FEDB2}" dt="2023-07-27T17:35:20.461" v="9325" actId="1076"/>
          <ac:spMkLst>
            <pc:docMk/>
            <pc:sldMk cId="2264319159" sldId="408"/>
            <ac:spMk id="19" creationId="{D5401852-59DF-2725-2EDF-E6796BFD9EE4}"/>
          </ac:spMkLst>
        </pc:spChg>
        <pc:spChg chg="add mod">
          <ac:chgData name="Jorgensen, Rick" userId="22b7bd11-eb0f-413f-9bcb-9ce21ec7b0a8" providerId="ADAL" clId="{63C519A2-C2B2-47AC-828F-E429CD2FEDB2}" dt="2023-07-27T17:35:23.426" v="9327" actId="1076"/>
          <ac:spMkLst>
            <pc:docMk/>
            <pc:sldMk cId="2264319159" sldId="408"/>
            <ac:spMk id="20" creationId="{A02BF9A5-5622-4BF3-B873-FDF2956CB763}"/>
          </ac:spMkLst>
        </pc:spChg>
        <pc:spChg chg="add del mod">
          <ac:chgData name="Jorgensen, Rick" userId="22b7bd11-eb0f-413f-9bcb-9ce21ec7b0a8" providerId="ADAL" clId="{63C519A2-C2B2-47AC-828F-E429CD2FEDB2}" dt="2023-07-27T17:33:49.807" v="9296" actId="478"/>
          <ac:spMkLst>
            <pc:docMk/>
            <pc:sldMk cId="2264319159" sldId="408"/>
            <ac:spMk id="21" creationId="{3B9A3174-6392-90C0-056B-0FDC88892F48}"/>
          </ac:spMkLst>
        </pc:spChg>
        <pc:spChg chg="add mod">
          <ac:chgData name="Jorgensen, Rick" userId="22b7bd11-eb0f-413f-9bcb-9ce21ec7b0a8" providerId="ADAL" clId="{63C519A2-C2B2-47AC-828F-E429CD2FEDB2}" dt="2023-07-27T17:35:25.923" v="9329" actId="1076"/>
          <ac:spMkLst>
            <pc:docMk/>
            <pc:sldMk cId="2264319159" sldId="408"/>
            <ac:spMk id="22" creationId="{29EEF589-D58B-7963-62BD-2F4300CCF26B}"/>
          </ac:spMkLst>
        </pc:spChg>
        <pc:spChg chg="add del mod ord">
          <ac:chgData name="Jorgensen, Rick" userId="22b7bd11-eb0f-413f-9bcb-9ce21ec7b0a8" providerId="ADAL" clId="{63C519A2-C2B2-47AC-828F-E429CD2FEDB2}" dt="2023-07-27T17:33:49.807" v="9296" actId="478"/>
          <ac:spMkLst>
            <pc:docMk/>
            <pc:sldMk cId="2264319159" sldId="408"/>
            <ac:spMk id="23" creationId="{19550F3A-D9E1-F153-89B0-8CD9494F9302}"/>
          </ac:spMkLst>
        </pc:spChg>
        <pc:spChg chg="add del mod ord">
          <ac:chgData name="Jorgensen, Rick" userId="22b7bd11-eb0f-413f-9bcb-9ce21ec7b0a8" providerId="ADAL" clId="{63C519A2-C2B2-47AC-828F-E429CD2FEDB2}" dt="2023-07-27T17:33:48.548" v="9295" actId="478"/>
          <ac:spMkLst>
            <pc:docMk/>
            <pc:sldMk cId="2264319159" sldId="408"/>
            <ac:spMk id="24" creationId="{EAA976DB-8DA4-9B26-CCC3-94FCE9F99ADA}"/>
          </ac:spMkLst>
        </pc:spChg>
        <pc:spChg chg="mod">
          <ac:chgData name="Jorgensen, Rick" userId="22b7bd11-eb0f-413f-9bcb-9ce21ec7b0a8" providerId="ADAL" clId="{63C519A2-C2B2-47AC-828F-E429CD2FEDB2}" dt="2023-08-01T15:56:34.243" v="12247" actId="20577"/>
          <ac:spMkLst>
            <pc:docMk/>
            <pc:sldMk cId="2264319159" sldId="408"/>
            <ac:spMk id="25" creationId="{43DF711F-4684-B34D-9236-D3A26D348F11}"/>
          </ac:spMkLst>
        </pc:spChg>
        <pc:spChg chg="add del mod">
          <ac:chgData name="Jorgensen, Rick" userId="22b7bd11-eb0f-413f-9bcb-9ce21ec7b0a8" providerId="ADAL" clId="{63C519A2-C2B2-47AC-828F-E429CD2FEDB2}" dt="2023-07-27T17:33:48.548" v="9295" actId="478"/>
          <ac:spMkLst>
            <pc:docMk/>
            <pc:sldMk cId="2264319159" sldId="408"/>
            <ac:spMk id="26" creationId="{82DFD962-4B35-42D7-9E88-929DAF8AF198}"/>
          </ac:spMkLst>
        </pc:spChg>
        <pc:spChg chg="add del mod">
          <ac:chgData name="Jorgensen, Rick" userId="22b7bd11-eb0f-413f-9bcb-9ce21ec7b0a8" providerId="ADAL" clId="{63C519A2-C2B2-47AC-828F-E429CD2FEDB2}" dt="2023-07-27T17:33:48.548" v="9295" actId="478"/>
          <ac:spMkLst>
            <pc:docMk/>
            <pc:sldMk cId="2264319159" sldId="408"/>
            <ac:spMk id="27" creationId="{8FD21EAD-EBFF-3FB4-4AB8-4F730C820176}"/>
          </ac:spMkLst>
        </pc:spChg>
        <pc:spChg chg="add del mod">
          <ac:chgData name="Jorgensen, Rick" userId="22b7bd11-eb0f-413f-9bcb-9ce21ec7b0a8" providerId="ADAL" clId="{63C519A2-C2B2-47AC-828F-E429CD2FEDB2}" dt="2023-07-27T17:33:48.548" v="9295" actId="478"/>
          <ac:spMkLst>
            <pc:docMk/>
            <pc:sldMk cId="2264319159" sldId="408"/>
            <ac:spMk id="28" creationId="{7904D664-C175-8E08-BFC8-D8801AABA637}"/>
          </ac:spMkLst>
        </pc:spChg>
        <pc:spChg chg="add del mod">
          <ac:chgData name="Jorgensen, Rick" userId="22b7bd11-eb0f-413f-9bcb-9ce21ec7b0a8" providerId="ADAL" clId="{63C519A2-C2B2-47AC-828F-E429CD2FEDB2}" dt="2023-07-27T17:33:48.548" v="9295" actId="478"/>
          <ac:spMkLst>
            <pc:docMk/>
            <pc:sldMk cId="2264319159" sldId="408"/>
            <ac:spMk id="29" creationId="{1562BBC8-9915-3DE9-09BF-DE5F5615ABBB}"/>
          </ac:spMkLst>
        </pc:spChg>
        <pc:spChg chg="mod ord">
          <ac:chgData name="Jorgensen, Rick" userId="22b7bd11-eb0f-413f-9bcb-9ce21ec7b0a8" providerId="ADAL" clId="{63C519A2-C2B2-47AC-828F-E429CD2FEDB2}" dt="2023-07-27T17:34:33.120" v="9309" actId="1076"/>
          <ac:spMkLst>
            <pc:docMk/>
            <pc:sldMk cId="2264319159" sldId="408"/>
            <ac:spMk id="30" creationId="{3D48DC1C-90A7-8867-CD77-A30256D274E3}"/>
          </ac:spMkLst>
        </pc:spChg>
        <pc:spChg chg="mod ord">
          <ac:chgData name="Jorgensen, Rick" userId="22b7bd11-eb0f-413f-9bcb-9ce21ec7b0a8" providerId="ADAL" clId="{63C519A2-C2B2-47AC-828F-E429CD2FEDB2}" dt="2023-08-01T15:52:24.505" v="12148" actId="1076"/>
          <ac:spMkLst>
            <pc:docMk/>
            <pc:sldMk cId="2264319159" sldId="408"/>
            <ac:spMk id="31" creationId="{1780F414-B5FA-B5ED-4ECE-42C5CA3D7C74}"/>
          </ac:spMkLst>
        </pc:spChg>
        <pc:spChg chg="add del mod">
          <ac:chgData name="Jorgensen, Rick" userId="22b7bd11-eb0f-413f-9bcb-9ce21ec7b0a8" providerId="ADAL" clId="{63C519A2-C2B2-47AC-828F-E429CD2FEDB2}" dt="2023-07-27T17:33:48.548" v="9295" actId="478"/>
          <ac:spMkLst>
            <pc:docMk/>
            <pc:sldMk cId="2264319159" sldId="408"/>
            <ac:spMk id="32" creationId="{C90D9045-95AA-99FE-29BB-971165462D87}"/>
          </ac:spMkLst>
        </pc:spChg>
        <pc:spChg chg="mod">
          <ac:chgData name="Jorgensen, Rick" userId="22b7bd11-eb0f-413f-9bcb-9ce21ec7b0a8" providerId="ADAL" clId="{63C519A2-C2B2-47AC-828F-E429CD2FEDB2}" dt="2023-08-01T15:52:18.393" v="12147" actId="20577"/>
          <ac:spMkLst>
            <pc:docMk/>
            <pc:sldMk cId="2264319159" sldId="408"/>
            <ac:spMk id="33" creationId="{C0BEA176-77D8-CDD1-9079-4E9E8965D112}"/>
          </ac:spMkLst>
        </pc:spChg>
        <pc:spChg chg="add mod">
          <ac:chgData name="Jorgensen, Rick" userId="22b7bd11-eb0f-413f-9bcb-9ce21ec7b0a8" providerId="ADAL" clId="{63C519A2-C2B2-47AC-828F-E429CD2FEDB2}" dt="2023-07-27T17:35:28.496" v="9331" actId="1076"/>
          <ac:spMkLst>
            <pc:docMk/>
            <pc:sldMk cId="2264319159" sldId="408"/>
            <ac:spMk id="34" creationId="{0D4D6E56-2E19-5E64-D2CC-96CF321057CB}"/>
          </ac:spMkLst>
        </pc:spChg>
        <pc:spChg chg="add mod">
          <ac:chgData name="Jorgensen, Rick" userId="22b7bd11-eb0f-413f-9bcb-9ce21ec7b0a8" providerId="ADAL" clId="{63C519A2-C2B2-47AC-828F-E429CD2FEDB2}" dt="2023-07-27T17:35:30.836" v="9333" actId="1076"/>
          <ac:spMkLst>
            <pc:docMk/>
            <pc:sldMk cId="2264319159" sldId="408"/>
            <ac:spMk id="35" creationId="{95339A7D-727D-DBD1-4212-1C3838AE2D04}"/>
          </ac:spMkLst>
        </pc:spChg>
        <pc:spChg chg="add mod">
          <ac:chgData name="Jorgensen, Rick" userId="22b7bd11-eb0f-413f-9bcb-9ce21ec7b0a8" providerId="ADAL" clId="{63C519A2-C2B2-47AC-828F-E429CD2FEDB2}" dt="2023-07-27T17:35:33.223" v="9335" actId="1076"/>
          <ac:spMkLst>
            <pc:docMk/>
            <pc:sldMk cId="2264319159" sldId="408"/>
            <ac:spMk id="36" creationId="{7958BDEF-7F54-86B7-417D-6E2F5FF1EBE4}"/>
          </ac:spMkLst>
        </pc:spChg>
        <pc:spChg chg="add mod">
          <ac:chgData name="Jorgensen, Rick" userId="22b7bd11-eb0f-413f-9bcb-9ce21ec7b0a8" providerId="ADAL" clId="{63C519A2-C2B2-47AC-828F-E429CD2FEDB2}" dt="2023-07-27T17:35:36.477" v="9337" actId="1076"/>
          <ac:spMkLst>
            <pc:docMk/>
            <pc:sldMk cId="2264319159" sldId="408"/>
            <ac:spMk id="37" creationId="{73579EB4-AE44-3CD5-82E0-87B7EC08E83A}"/>
          </ac:spMkLst>
        </pc:spChg>
        <pc:grpChg chg="add mod ord">
          <ac:chgData name="Jorgensen, Rick" userId="22b7bd11-eb0f-413f-9bcb-9ce21ec7b0a8" providerId="ADAL" clId="{63C519A2-C2B2-47AC-828F-E429CD2FEDB2}" dt="2023-07-27T17:41:30.551" v="9354" actId="1076"/>
          <ac:grpSpMkLst>
            <pc:docMk/>
            <pc:sldMk cId="2264319159" sldId="408"/>
            <ac:grpSpMk id="6" creationId="{9536570B-187C-20CB-F1E2-3451D8577D5B}"/>
          </ac:grpSpMkLst>
        </pc:grpChg>
        <pc:grpChg chg="add mod ord">
          <ac:chgData name="Jorgensen, Rick" userId="22b7bd11-eb0f-413f-9bcb-9ce21ec7b0a8" providerId="ADAL" clId="{63C519A2-C2B2-47AC-828F-E429CD2FEDB2}" dt="2023-07-27T17:34:36.239" v="9310" actId="1076"/>
          <ac:grpSpMkLst>
            <pc:docMk/>
            <pc:sldMk cId="2264319159" sldId="408"/>
            <ac:grpSpMk id="11" creationId="{F15114B5-9AE8-15A9-F83F-9112797F4535}"/>
          </ac:grpSpMkLst>
        </pc:grpChg>
        <pc:grpChg chg="del">
          <ac:chgData name="Jorgensen, Rick" userId="22b7bd11-eb0f-413f-9bcb-9ce21ec7b0a8" providerId="ADAL" clId="{63C519A2-C2B2-47AC-828F-E429CD2FEDB2}" dt="2023-07-24T14:28:31.802" v="7287" actId="478"/>
          <ac:grpSpMkLst>
            <pc:docMk/>
            <pc:sldMk cId="2264319159" sldId="408"/>
            <ac:grpSpMk id="20" creationId="{0B2F194D-FED7-2B84-ED02-A1688A3FDA40}"/>
          </ac:grpSpMkLst>
        </pc:grpChg>
        <pc:graphicFrameChg chg="add del mod">
          <ac:chgData name="Jorgensen, Rick" userId="22b7bd11-eb0f-413f-9bcb-9ce21ec7b0a8" providerId="ADAL" clId="{63C519A2-C2B2-47AC-828F-E429CD2FEDB2}" dt="2023-07-27T17:34:46.705" v="9311" actId="478"/>
          <ac:graphicFrameMkLst>
            <pc:docMk/>
            <pc:sldMk cId="2264319159" sldId="408"/>
            <ac:graphicFrameMk id="3" creationId="{7BB3A9BD-A127-4B41-B92F-A1864F1BB2EF}"/>
          </ac:graphicFrameMkLst>
        </pc:graphicFrameChg>
        <pc:graphicFrameChg chg="add mod">
          <ac:chgData name="Jorgensen, Rick" userId="22b7bd11-eb0f-413f-9bcb-9ce21ec7b0a8" providerId="ADAL" clId="{63C519A2-C2B2-47AC-828F-E429CD2FEDB2}" dt="2023-08-01T15:54:01.721" v="12186"/>
          <ac:graphicFrameMkLst>
            <pc:docMk/>
            <pc:sldMk cId="2264319159" sldId="408"/>
            <ac:graphicFrameMk id="5" creationId="{AE1F7F2C-2903-49BF-8D46-B74042A4DF30}"/>
          </ac:graphicFrameMkLst>
        </pc:graphicFrameChg>
        <pc:graphicFrameChg chg="add del mod ord">
          <ac:chgData name="Jorgensen, Rick" userId="22b7bd11-eb0f-413f-9bcb-9ce21ec7b0a8" providerId="ADAL" clId="{63C519A2-C2B2-47AC-828F-E429CD2FEDB2}" dt="2023-07-27T17:33:20.002" v="9290" actId="478"/>
          <ac:graphicFrameMkLst>
            <pc:docMk/>
            <pc:sldMk cId="2264319159" sldId="408"/>
            <ac:graphicFrameMk id="7" creationId="{AE1F7F2C-2903-49BF-8D46-B74042A4DF30}"/>
          </ac:graphicFrameMkLst>
        </pc:graphicFrameChg>
        <pc:graphicFrameChg chg="add del mod">
          <ac:chgData name="Jorgensen, Rick" userId="22b7bd11-eb0f-413f-9bcb-9ce21ec7b0a8" providerId="ADAL" clId="{63C519A2-C2B2-47AC-828F-E429CD2FEDB2}" dt="2023-07-24T14:52:22.669" v="7341"/>
          <ac:graphicFrameMkLst>
            <pc:docMk/>
            <pc:sldMk cId="2264319159" sldId="408"/>
            <ac:graphicFrameMk id="8" creationId="{2DC83630-B2FA-90D6-8ECE-2698DDFAC9FE}"/>
          </ac:graphicFrameMkLst>
        </pc:graphicFrameChg>
        <pc:graphicFrameChg chg="del mod">
          <ac:chgData name="Jorgensen, Rick" userId="22b7bd11-eb0f-413f-9bcb-9ce21ec7b0a8" providerId="ADAL" clId="{63C519A2-C2B2-47AC-828F-E429CD2FEDB2}" dt="2023-07-24T14:28:39.313" v="7290" actId="478"/>
          <ac:graphicFrameMkLst>
            <pc:docMk/>
            <pc:sldMk cId="2264319159" sldId="408"/>
            <ac:graphicFrameMk id="22" creationId="{871B0361-088F-4166-B51E-18DC5A5E21C1}"/>
          </ac:graphicFrameMkLst>
        </pc:graphicFrameChg>
        <pc:graphicFrameChg chg="add del mod">
          <ac:chgData name="Jorgensen, Rick" userId="22b7bd11-eb0f-413f-9bcb-9ce21ec7b0a8" providerId="ADAL" clId="{63C519A2-C2B2-47AC-828F-E429CD2FEDB2}" dt="2023-07-27T17:40:53.639" v="9348" actId="478"/>
          <ac:graphicFrameMkLst>
            <pc:docMk/>
            <pc:sldMk cId="2264319159" sldId="408"/>
            <ac:graphicFrameMk id="38" creationId="{AE1F7F2C-2903-49BF-8D46-B74042A4DF30}"/>
          </ac:graphicFrameMkLst>
        </pc:graphicFrameChg>
        <pc:graphicFrameChg chg="add mod ord">
          <ac:chgData name="Jorgensen, Rick" userId="22b7bd11-eb0f-413f-9bcb-9ce21ec7b0a8" providerId="ADAL" clId="{63C519A2-C2B2-47AC-828F-E429CD2FEDB2}" dt="2023-08-01T15:50:20.640" v="12120" actId="692"/>
          <ac:graphicFrameMkLst>
            <pc:docMk/>
            <pc:sldMk cId="2264319159" sldId="408"/>
            <ac:graphicFrameMk id="39" creationId="{7BB3A9BD-A127-4B41-B92F-A1864F1BB2EF}"/>
          </ac:graphicFrameMkLst>
        </pc:graphicFrameChg>
      </pc:sldChg>
      <pc:sldChg chg="modSp add mod ord">
        <pc:chgData name="Jorgensen, Rick" userId="22b7bd11-eb0f-413f-9bcb-9ce21ec7b0a8" providerId="ADAL" clId="{63C519A2-C2B2-47AC-828F-E429CD2FEDB2}" dt="2023-08-01T15:57:04.405" v="12260" actId="20577"/>
        <pc:sldMkLst>
          <pc:docMk/>
          <pc:sldMk cId="2818941781" sldId="409"/>
        </pc:sldMkLst>
        <pc:spChg chg="mod">
          <ac:chgData name="Jorgensen, Rick" userId="22b7bd11-eb0f-413f-9bcb-9ce21ec7b0a8" providerId="ADAL" clId="{63C519A2-C2B2-47AC-828F-E429CD2FEDB2}" dt="2023-08-01T15:56:35.910" v="12249" actId="20577"/>
          <ac:spMkLst>
            <pc:docMk/>
            <pc:sldMk cId="2818941781" sldId="409"/>
            <ac:spMk id="2" creationId="{00000000-0000-0000-0000-000000000000}"/>
          </ac:spMkLst>
        </pc:spChg>
        <pc:spChg chg="mod">
          <ac:chgData name="Jorgensen, Rick" userId="22b7bd11-eb0f-413f-9bcb-9ce21ec7b0a8" providerId="ADAL" clId="{63C519A2-C2B2-47AC-828F-E429CD2FEDB2}" dt="2023-08-01T15:57:04.405" v="12260" actId="20577"/>
          <ac:spMkLst>
            <pc:docMk/>
            <pc:sldMk cId="2818941781" sldId="409"/>
            <ac:spMk id="3" creationId="{00000000-0000-0000-0000-000000000000}"/>
          </ac:spMkLst>
        </pc:spChg>
      </pc:sldChg>
      <pc:sldChg chg="modSp add del mod">
        <pc:chgData name="Jorgensen, Rick" userId="22b7bd11-eb0f-413f-9bcb-9ce21ec7b0a8" providerId="ADAL" clId="{63C519A2-C2B2-47AC-828F-E429CD2FEDB2}" dt="2023-07-31T18:39:21.570" v="10207" actId="47"/>
        <pc:sldMkLst>
          <pc:docMk/>
          <pc:sldMk cId="2749969029" sldId="410"/>
        </pc:sldMkLst>
        <pc:spChg chg="mod">
          <ac:chgData name="Jorgensen, Rick" userId="22b7bd11-eb0f-413f-9bcb-9ce21ec7b0a8" providerId="ADAL" clId="{63C519A2-C2B2-47AC-828F-E429CD2FEDB2}" dt="2023-07-24T18:27:12.995" v="8247" actId="20577"/>
          <ac:spMkLst>
            <pc:docMk/>
            <pc:sldMk cId="2749969029" sldId="410"/>
            <ac:spMk id="25" creationId="{43DF711F-4684-B34D-9236-D3A26D348F11}"/>
          </ac:spMkLst>
        </pc:spChg>
      </pc:sldChg>
      <pc:sldChg chg="addSp delSp modSp add mod">
        <pc:chgData name="Jorgensen, Rick" userId="22b7bd11-eb0f-413f-9bcb-9ce21ec7b0a8" providerId="ADAL" clId="{63C519A2-C2B2-47AC-828F-E429CD2FEDB2}" dt="2023-08-01T15:18:31.016" v="11233" actId="1076"/>
        <pc:sldMkLst>
          <pc:docMk/>
          <pc:sldMk cId="969353579" sldId="411"/>
        </pc:sldMkLst>
        <pc:spChg chg="add mod">
          <ac:chgData name="Jorgensen, Rick" userId="22b7bd11-eb0f-413f-9bcb-9ce21ec7b0a8" providerId="ADAL" clId="{63C519A2-C2B2-47AC-828F-E429CD2FEDB2}" dt="2023-08-01T15:18:31.016" v="11233" actId="1076"/>
          <ac:spMkLst>
            <pc:docMk/>
            <pc:sldMk cId="969353579" sldId="411"/>
            <ac:spMk id="3" creationId="{1A462FE6-0F7A-01F0-9AF2-F3F16D36ABAB}"/>
          </ac:spMkLst>
        </pc:spChg>
        <pc:spChg chg="del">
          <ac:chgData name="Jorgensen, Rick" userId="22b7bd11-eb0f-413f-9bcb-9ce21ec7b0a8" providerId="ADAL" clId="{63C519A2-C2B2-47AC-828F-E429CD2FEDB2}" dt="2023-07-24T17:30:55.340" v="7608" actId="478"/>
          <ac:spMkLst>
            <pc:docMk/>
            <pc:sldMk cId="969353579" sldId="411"/>
            <ac:spMk id="5" creationId="{D781EC2B-E649-9293-3A1C-83975708065C}"/>
          </ac:spMkLst>
        </pc:spChg>
        <pc:spChg chg="del">
          <ac:chgData name="Jorgensen, Rick" userId="22b7bd11-eb0f-413f-9bcb-9ce21ec7b0a8" providerId="ADAL" clId="{63C519A2-C2B2-47AC-828F-E429CD2FEDB2}" dt="2023-07-24T17:31:04.983" v="7613" actId="478"/>
          <ac:spMkLst>
            <pc:docMk/>
            <pc:sldMk cId="969353579" sldId="411"/>
            <ac:spMk id="6" creationId="{40B6CEB3-3A82-4E60-F188-FC045C4CBC79}"/>
          </ac:spMkLst>
        </pc:spChg>
        <pc:spChg chg="del">
          <ac:chgData name="Jorgensen, Rick" userId="22b7bd11-eb0f-413f-9bcb-9ce21ec7b0a8" providerId="ADAL" clId="{63C519A2-C2B2-47AC-828F-E429CD2FEDB2}" dt="2023-07-24T17:31:07.486" v="7614" actId="478"/>
          <ac:spMkLst>
            <pc:docMk/>
            <pc:sldMk cId="969353579" sldId="411"/>
            <ac:spMk id="7" creationId="{951535AA-70E5-4B16-E222-46AD8972F9CE}"/>
          </ac:spMkLst>
        </pc:spChg>
        <pc:spChg chg="del mod">
          <ac:chgData name="Jorgensen, Rick" userId="22b7bd11-eb0f-413f-9bcb-9ce21ec7b0a8" providerId="ADAL" clId="{63C519A2-C2B2-47AC-828F-E429CD2FEDB2}" dt="2023-07-24T17:33:32.072" v="7626" actId="478"/>
          <ac:spMkLst>
            <pc:docMk/>
            <pc:sldMk cId="969353579" sldId="411"/>
            <ac:spMk id="8" creationId="{A85A1349-C6A4-F81E-2D7B-75FD5E4C4736}"/>
          </ac:spMkLst>
        </pc:spChg>
        <pc:spChg chg="mod ord">
          <ac:chgData name="Jorgensen, Rick" userId="22b7bd11-eb0f-413f-9bcb-9ce21ec7b0a8" providerId="ADAL" clId="{63C519A2-C2B2-47AC-828F-E429CD2FEDB2}" dt="2023-07-24T17:34:41.855" v="7660" actId="20577"/>
          <ac:spMkLst>
            <pc:docMk/>
            <pc:sldMk cId="969353579" sldId="411"/>
            <ac:spMk id="10" creationId="{7522894A-B4AC-36B0-5629-F20EC9F4B9FC}"/>
          </ac:spMkLst>
        </pc:spChg>
        <pc:spChg chg="mod">
          <ac:chgData name="Jorgensen, Rick" userId="22b7bd11-eb0f-413f-9bcb-9ce21ec7b0a8" providerId="ADAL" clId="{63C519A2-C2B2-47AC-828F-E429CD2FEDB2}" dt="2023-08-01T15:17:28.570" v="11226" actId="1076"/>
          <ac:spMkLst>
            <pc:docMk/>
            <pc:sldMk cId="969353579" sldId="411"/>
            <ac:spMk id="11" creationId="{EF4D9831-160A-4CD3-10DC-6541144E8A9A}"/>
          </ac:spMkLst>
        </pc:spChg>
        <pc:spChg chg="mod">
          <ac:chgData name="Jorgensen, Rick" userId="22b7bd11-eb0f-413f-9bcb-9ce21ec7b0a8" providerId="ADAL" clId="{63C519A2-C2B2-47AC-828F-E429CD2FEDB2}" dt="2023-07-24T17:34:40.363" v="7659" actId="1076"/>
          <ac:spMkLst>
            <pc:docMk/>
            <pc:sldMk cId="969353579" sldId="411"/>
            <ac:spMk id="12" creationId="{CF6FBB5F-FA38-2245-30C4-D451AF10E3FB}"/>
          </ac:spMkLst>
        </pc:spChg>
        <pc:spChg chg="mod">
          <ac:chgData name="Jorgensen, Rick" userId="22b7bd11-eb0f-413f-9bcb-9ce21ec7b0a8" providerId="ADAL" clId="{63C519A2-C2B2-47AC-828F-E429CD2FEDB2}" dt="2023-07-24T17:34:00.898" v="7631" actId="14100"/>
          <ac:spMkLst>
            <pc:docMk/>
            <pc:sldMk cId="969353579" sldId="411"/>
            <ac:spMk id="13" creationId="{911BA559-AAEB-1D23-6B7F-319764FA4494}"/>
          </ac:spMkLst>
        </pc:spChg>
        <pc:spChg chg="del mod">
          <ac:chgData name="Jorgensen, Rick" userId="22b7bd11-eb0f-413f-9bcb-9ce21ec7b0a8" providerId="ADAL" clId="{63C519A2-C2B2-47AC-828F-E429CD2FEDB2}" dt="2023-08-01T15:16:44.839" v="11214" actId="478"/>
          <ac:spMkLst>
            <pc:docMk/>
            <pc:sldMk cId="969353579" sldId="411"/>
            <ac:spMk id="14" creationId="{AA92C4F3-BF02-3BBC-8A8E-B130F6238713}"/>
          </ac:spMkLst>
        </pc:spChg>
        <pc:spChg chg="mod">
          <ac:chgData name="Jorgensen, Rick" userId="22b7bd11-eb0f-413f-9bcb-9ce21ec7b0a8" providerId="ADAL" clId="{63C519A2-C2B2-47AC-828F-E429CD2FEDB2}" dt="2023-07-24T17:31:10.846" v="7616" actId="20577"/>
          <ac:spMkLst>
            <pc:docMk/>
            <pc:sldMk cId="969353579" sldId="411"/>
            <ac:spMk id="15" creationId="{1BA55689-1E02-D64A-AEF5-1140E4E5B817}"/>
          </ac:spMkLst>
        </pc:spChg>
        <pc:spChg chg="del">
          <ac:chgData name="Jorgensen, Rick" userId="22b7bd11-eb0f-413f-9bcb-9ce21ec7b0a8" providerId="ADAL" clId="{63C519A2-C2B2-47AC-828F-E429CD2FEDB2}" dt="2023-07-24T17:30:57.427" v="7609" actId="478"/>
          <ac:spMkLst>
            <pc:docMk/>
            <pc:sldMk cId="969353579" sldId="411"/>
            <ac:spMk id="16" creationId="{BE744FE4-2EF0-B94D-B621-3533220D4D03}"/>
          </ac:spMkLst>
        </pc:spChg>
        <pc:spChg chg="mod">
          <ac:chgData name="Jorgensen, Rick" userId="22b7bd11-eb0f-413f-9bcb-9ce21ec7b0a8" providerId="ADAL" clId="{63C519A2-C2B2-47AC-828F-E429CD2FEDB2}" dt="2023-08-01T15:17:45.145" v="11228" actId="20577"/>
          <ac:spMkLst>
            <pc:docMk/>
            <pc:sldMk cId="969353579" sldId="411"/>
            <ac:spMk id="25" creationId="{43DF711F-4684-B34D-9236-D3A26D348F11}"/>
          </ac:spMkLst>
        </pc:spChg>
        <pc:spChg chg="del mod">
          <ac:chgData name="Jorgensen, Rick" userId="22b7bd11-eb0f-413f-9bcb-9ce21ec7b0a8" providerId="ADAL" clId="{63C519A2-C2B2-47AC-828F-E429CD2FEDB2}" dt="2023-07-24T17:31:02.188" v="7612" actId="478"/>
          <ac:spMkLst>
            <pc:docMk/>
            <pc:sldMk cId="969353579" sldId="411"/>
            <ac:spMk id="38" creationId="{70029A47-2B66-0DA1-2049-5A43CA27F7A6}"/>
          </ac:spMkLst>
        </pc:spChg>
        <pc:spChg chg="del">
          <ac:chgData name="Jorgensen, Rick" userId="22b7bd11-eb0f-413f-9bcb-9ce21ec7b0a8" providerId="ADAL" clId="{63C519A2-C2B2-47AC-828F-E429CD2FEDB2}" dt="2023-07-25T16:49:53.169" v="8378" actId="478"/>
          <ac:spMkLst>
            <pc:docMk/>
            <pc:sldMk cId="969353579" sldId="411"/>
            <ac:spMk id="40" creationId="{DDDF0E5A-3974-79DF-0FE1-B6DF8F6D1D64}"/>
          </ac:spMkLst>
        </pc:spChg>
        <pc:spChg chg="mod">
          <ac:chgData name="Jorgensen, Rick" userId="22b7bd11-eb0f-413f-9bcb-9ce21ec7b0a8" providerId="ADAL" clId="{63C519A2-C2B2-47AC-828F-E429CD2FEDB2}" dt="2023-08-01T15:18:26.042" v="11232" actId="1076"/>
          <ac:spMkLst>
            <pc:docMk/>
            <pc:sldMk cId="969353579" sldId="411"/>
            <ac:spMk id="41" creationId="{66DA6F02-7D4C-D65E-6836-19D0B5646E8F}"/>
          </ac:spMkLst>
        </pc:spChg>
        <pc:spChg chg="del">
          <ac:chgData name="Jorgensen, Rick" userId="22b7bd11-eb0f-413f-9bcb-9ce21ec7b0a8" providerId="ADAL" clId="{63C519A2-C2B2-47AC-828F-E429CD2FEDB2}" dt="2023-07-24T17:31:02.188" v="7612" actId="478"/>
          <ac:spMkLst>
            <pc:docMk/>
            <pc:sldMk cId="969353579" sldId="411"/>
            <ac:spMk id="42" creationId="{2D84763A-F38F-0D7E-646F-FC534BCD1E4B}"/>
          </ac:spMkLst>
        </pc:spChg>
        <pc:spChg chg="del">
          <ac:chgData name="Jorgensen, Rick" userId="22b7bd11-eb0f-413f-9bcb-9ce21ec7b0a8" providerId="ADAL" clId="{63C519A2-C2B2-47AC-828F-E429CD2FEDB2}" dt="2023-07-24T17:31:02.188" v="7612" actId="478"/>
          <ac:spMkLst>
            <pc:docMk/>
            <pc:sldMk cId="969353579" sldId="411"/>
            <ac:spMk id="43" creationId="{4E395039-7876-8176-160C-B3C5E23BB480}"/>
          </ac:spMkLst>
        </pc:spChg>
        <pc:spChg chg="del">
          <ac:chgData name="Jorgensen, Rick" userId="22b7bd11-eb0f-413f-9bcb-9ce21ec7b0a8" providerId="ADAL" clId="{63C519A2-C2B2-47AC-828F-E429CD2FEDB2}" dt="2023-07-24T17:31:02.188" v="7612" actId="478"/>
          <ac:spMkLst>
            <pc:docMk/>
            <pc:sldMk cId="969353579" sldId="411"/>
            <ac:spMk id="44" creationId="{1099F439-2C72-613A-9FFB-A4EEC230954D}"/>
          </ac:spMkLst>
        </pc:spChg>
        <pc:grpChg chg="mod">
          <ac:chgData name="Jorgensen, Rick" userId="22b7bd11-eb0f-413f-9bcb-9ce21ec7b0a8" providerId="ADAL" clId="{63C519A2-C2B2-47AC-828F-E429CD2FEDB2}" dt="2023-07-25T16:49:47.136" v="8376" actId="1076"/>
          <ac:grpSpMkLst>
            <pc:docMk/>
            <pc:sldMk cId="969353579" sldId="411"/>
            <ac:grpSpMk id="21" creationId="{CC56C904-0BDB-5A14-493D-83F762479834}"/>
          </ac:grpSpMkLst>
        </pc:grpChg>
        <pc:grpChg chg="del">
          <ac:chgData name="Jorgensen, Rick" userId="22b7bd11-eb0f-413f-9bcb-9ce21ec7b0a8" providerId="ADAL" clId="{63C519A2-C2B2-47AC-828F-E429CD2FEDB2}" dt="2023-07-24T17:31:02.188" v="7612" actId="478"/>
          <ac:grpSpMkLst>
            <pc:docMk/>
            <pc:sldMk cId="969353579" sldId="411"/>
            <ac:grpSpMk id="33" creationId="{B7B8DA1C-6608-F3AC-6499-78EA4121866B}"/>
          </ac:grpSpMkLst>
        </pc:grpChg>
        <pc:graphicFrameChg chg="add mod ord">
          <ac:chgData name="Jorgensen, Rick" userId="22b7bd11-eb0f-413f-9bcb-9ce21ec7b0a8" providerId="ADAL" clId="{63C519A2-C2B2-47AC-828F-E429CD2FEDB2}" dt="2023-08-01T15:17:08.860" v="11219" actId="692"/>
          <ac:graphicFrameMkLst>
            <pc:docMk/>
            <pc:sldMk cId="969353579" sldId="411"/>
            <ac:graphicFrameMk id="2" creationId="{13D7C20C-3EBD-4E3D-9B74-1FF6413849C7}"/>
          </ac:graphicFrameMkLst>
        </pc:graphicFrameChg>
        <pc:graphicFrameChg chg="del">
          <ac:chgData name="Jorgensen, Rick" userId="22b7bd11-eb0f-413f-9bcb-9ce21ec7b0a8" providerId="ADAL" clId="{63C519A2-C2B2-47AC-828F-E429CD2FEDB2}" dt="2023-07-24T17:30:46.624" v="7604" actId="478"/>
          <ac:graphicFrameMkLst>
            <pc:docMk/>
            <pc:sldMk cId="969353579" sldId="411"/>
            <ac:graphicFrameMk id="9" creationId="{3570F2B5-DAE4-4ED3-8040-377E7BDD6F78}"/>
          </ac:graphicFrameMkLst>
        </pc:graphicFrameChg>
        <pc:graphicFrameChg chg="del">
          <ac:chgData name="Jorgensen, Rick" userId="22b7bd11-eb0f-413f-9bcb-9ce21ec7b0a8" providerId="ADAL" clId="{63C519A2-C2B2-47AC-828F-E429CD2FEDB2}" dt="2023-07-24T17:30:48.361" v="7605" actId="478"/>
          <ac:graphicFrameMkLst>
            <pc:docMk/>
            <pc:sldMk cId="969353579" sldId="411"/>
            <ac:graphicFrameMk id="39" creationId="{DE951F37-77FB-4F5A-B764-8CE1F8B42F66}"/>
          </ac:graphicFrameMkLst>
        </pc:graphicFrameChg>
      </pc:sldChg>
      <pc:sldChg chg="addSp delSp modSp add mod">
        <pc:chgData name="Jorgensen, Rick" userId="22b7bd11-eb0f-413f-9bcb-9ce21ec7b0a8" providerId="ADAL" clId="{63C519A2-C2B2-47AC-828F-E429CD2FEDB2}" dt="2023-08-01T15:21:08.483" v="11346" actId="113"/>
        <pc:sldMkLst>
          <pc:docMk/>
          <pc:sldMk cId="2783075774" sldId="412"/>
        </pc:sldMkLst>
        <pc:spChg chg="add mod">
          <ac:chgData name="Jorgensen, Rick" userId="22b7bd11-eb0f-413f-9bcb-9ce21ec7b0a8" providerId="ADAL" clId="{63C519A2-C2B2-47AC-828F-E429CD2FEDB2}" dt="2023-07-27T17:15:59.784" v="9136" actId="113"/>
          <ac:spMkLst>
            <pc:docMk/>
            <pc:sldMk cId="2783075774" sldId="412"/>
            <ac:spMk id="2" creationId="{B48A3ED1-53E0-F941-6AA9-DAE13A3FA945}"/>
          </ac:spMkLst>
        </pc:spChg>
        <pc:spChg chg="mod">
          <ac:chgData name="Jorgensen, Rick" userId="22b7bd11-eb0f-413f-9bcb-9ce21ec7b0a8" providerId="ADAL" clId="{63C519A2-C2B2-47AC-828F-E429CD2FEDB2}" dt="2023-07-24T18:03:47.737" v="7773" actId="1076"/>
          <ac:spMkLst>
            <pc:docMk/>
            <pc:sldMk cId="2783075774" sldId="412"/>
            <ac:spMk id="3" creationId="{1A462FE6-0F7A-01F0-9AF2-F3F16D36ABAB}"/>
          </ac:spMkLst>
        </pc:spChg>
        <pc:spChg chg="add mod">
          <ac:chgData name="Jorgensen, Rick" userId="22b7bd11-eb0f-413f-9bcb-9ce21ec7b0a8" providerId="ADAL" clId="{63C519A2-C2B2-47AC-828F-E429CD2FEDB2}" dt="2023-07-24T17:57:20.786" v="7724"/>
          <ac:spMkLst>
            <pc:docMk/>
            <pc:sldMk cId="2783075774" sldId="412"/>
            <ac:spMk id="5" creationId="{BB28D932-BBBA-3DA2-597D-5FCC93A19672}"/>
          </ac:spMkLst>
        </pc:spChg>
        <pc:spChg chg="add mod">
          <ac:chgData name="Jorgensen, Rick" userId="22b7bd11-eb0f-413f-9bcb-9ce21ec7b0a8" providerId="ADAL" clId="{63C519A2-C2B2-47AC-828F-E429CD2FEDB2}" dt="2023-07-27T17:15:58.256" v="9135" actId="113"/>
          <ac:spMkLst>
            <pc:docMk/>
            <pc:sldMk cId="2783075774" sldId="412"/>
            <ac:spMk id="6" creationId="{97725DA6-3936-B5AA-8772-05CDAB3D6953}"/>
          </ac:spMkLst>
        </pc:spChg>
        <pc:spChg chg="add mod">
          <ac:chgData name="Jorgensen, Rick" userId="22b7bd11-eb0f-413f-9bcb-9ce21ec7b0a8" providerId="ADAL" clId="{63C519A2-C2B2-47AC-828F-E429CD2FEDB2}" dt="2023-07-24T18:02:49.067" v="7756" actId="1076"/>
          <ac:spMkLst>
            <pc:docMk/>
            <pc:sldMk cId="2783075774" sldId="412"/>
            <ac:spMk id="8" creationId="{C137511A-E5B2-A3E5-3904-E608F5FC6331}"/>
          </ac:spMkLst>
        </pc:spChg>
        <pc:spChg chg="add mod">
          <ac:chgData name="Jorgensen, Rick" userId="22b7bd11-eb0f-413f-9bcb-9ce21ec7b0a8" providerId="ADAL" clId="{63C519A2-C2B2-47AC-828F-E429CD2FEDB2}" dt="2023-07-24T18:02:58.600" v="7759" actId="1076"/>
          <ac:spMkLst>
            <pc:docMk/>
            <pc:sldMk cId="2783075774" sldId="412"/>
            <ac:spMk id="9" creationId="{2F0EA6C4-CA91-DAD4-8FC2-C8519E9CAC83}"/>
          </ac:spMkLst>
        </pc:spChg>
        <pc:spChg chg="mod">
          <ac:chgData name="Jorgensen, Rick" userId="22b7bd11-eb0f-413f-9bcb-9ce21ec7b0a8" providerId="ADAL" clId="{63C519A2-C2B2-47AC-828F-E429CD2FEDB2}" dt="2023-07-24T17:39:29.609" v="7709" actId="1076"/>
          <ac:spMkLst>
            <pc:docMk/>
            <pc:sldMk cId="2783075774" sldId="412"/>
            <ac:spMk id="10" creationId="{7522894A-B4AC-36B0-5629-F20EC9F4B9FC}"/>
          </ac:spMkLst>
        </pc:spChg>
        <pc:spChg chg="mod ord">
          <ac:chgData name="Jorgensen, Rick" userId="22b7bd11-eb0f-413f-9bcb-9ce21ec7b0a8" providerId="ADAL" clId="{63C519A2-C2B2-47AC-828F-E429CD2FEDB2}" dt="2023-07-24T17:58:07.585" v="7744" actId="12788"/>
          <ac:spMkLst>
            <pc:docMk/>
            <pc:sldMk cId="2783075774" sldId="412"/>
            <ac:spMk id="11" creationId="{EF4D9831-160A-4CD3-10DC-6541144E8A9A}"/>
          </ac:spMkLst>
        </pc:spChg>
        <pc:spChg chg="mod ord">
          <ac:chgData name="Jorgensen, Rick" userId="22b7bd11-eb0f-413f-9bcb-9ce21ec7b0a8" providerId="ADAL" clId="{63C519A2-C2B2-47AC-828F-E429CD2FEDB2}" dt="2023-07-24T17:58:07.585" v="7744" actId="12788"/>
          <ac:spMkLst>
            <pc:docMk/>
            <pc:sldMk cId="2783075774" sldId="412"/>
            <ac:spMk id="12" creationId="{CF6FBB5F-FA38-2245-30C4-D451AF10E3FB}"/>
          </ac:spMkLst>
        </pc:spChg>
        <pc:spChg chg="add mod">
          <ac:chgData name="Jorgensen, Rick" userId="22b7bd11-eb0f-413f-9bcb-9ce21ec7b0a8" providerId="ADAL" clId="{63C519A2-C2B2-47AC-828F-E429CD2FEDB2}" dt="2023-07-27T17:18:24.406" v="9160" actId="1076"/>
          <ac:spMkLst>
            <pc:docMk/>
            <pc:sldMk cId="2783075774" sldId="412"/>
            <ac:spMk id="13" creationId="{17A0C391-6265-722A-0433-5D317B131458}"/>
          </ac:spMkLst>
        </pc:spChg>
        <pc:spChg chg="del mod">
          <ac:chgData name="Jorgensen, Rick" userId="22b7bd11-eb0f-413f-9bcb-9ce21ec7b0a8" providerId="ADAL" clId="{63C519A2-C2B2-47AC-828F-E429CD2FEDB2}" dt="2023-07-24T17:39:22.657" v="7706" actId="478"/>
          <ac:spMkLst>
            <pc:docMk/>
            <pc:sldMk cId="2783075774" sldId="412"/>
            <ac:spMk id="13" creationId="{911BA559-AAEB-1D23-6B7F-319764FA4494}"/>
          </ac:spMkLst>
        </pc:spChg>
        <pc:spChg chg="del mod">
          <ac:chgData name="Jorgensen, Rick" userId="22b7bd11-eb0f-413f-9bcb-9ce21ec7b0a8" providerId="ADAL" clId="{63C519A2-C2B2-47AC-828F-E429CD2FEDB2}" dt="2023-08-01T15:18:52.734" v="11243" actId="478"/>
          <ac:spMkLst>
            <pc:docMk/>
            <pc:sldMk cId="2783075774" sldId="412"/>
            <ac:spMk id="14" creationId="{AA92C4F3-BF02-3BBC-8A8E-B130F6238713}"/>
          </ac:spMkLst>
        </pc:spChg>
        <pc:spChg chg="mod">
          <ac:chgData name="Jorgensen, Rick" userId="22b7bd11-eb0f-413f-9bcb-9ce21ec7b0a8" providerId="ADAL" clId="{63C519A2-C2B2-47AC-828F-E429CD2FEDB2}" dt="2023-07-24T17:39:47.052" v="7713" actId="20577"/>
          <ac:spMkLst>
            <pc:docMk/>
            <pc:sldMk cId="2783075774" sldId="412"/>
            <ac:spMk id="15" creationId="{1BA55689-1E02-D64A-AEF5-1140E4E5B817}"/>
          </ac:spMkLst>
        </pc:spChg>
        <pc:spChg chg="add mod">
          <ac:chgData name="Jorgensen, Rick" userId="22b7bd11-eb0f-413f-9bcb-9ce21ec7b0a8" providerId="ADAL" clId="{63C519A2-C2B2-47AC-828F-E429CD2FEDB2}" dt="2023-07-24T18:05:30.008" v="7804" actId="12788"/>
          <ac:spMkLst>
            <pc:docMk/>
            <pc:sldMk cId="2783075774" sldId="412"/>
            <ac:spMk id="16" creationId="{F6896C2B-CBB5-05DA-365A-A6C391468130}"/>
          </ac:spMkLst>
        </pc:spChg>
        <pc:spChg chg="add mod">
          <ac:chgData name="Jorgensen, Rick" userId="22b7bd11-eb0f-413f-9bcb-9ce21ec7b0a8" providerId="ADAL" clId="{63C519A2-C2B2-47AC-828F-E429CD2FEDB2}" dt="2023-07-24T18:05:36.911" v="7805" actId="1076"/>
          <ac:spMkLst>
            <pc:docMk/>
            <pc:sldMk cId="2783075774" sldId="412"/>
            <ac:spMk id="22" creationId="{643FF9F1-47ED-7EF0-5443-853893D04C68}"/>
          </ac:spMkLst>
        </pc:spChg>
        <pc:spChg chg="add mod">
          <ac:chgData name="Jorgensen, Rick" userId="22b7bd11-eb0f-413f-9bcb-9ce21ec7b0a8" providerId="ADAL" clId="{63C519A2-C2B2-47AC-828F-E429CD2FEDB2}" dt="2023-07-24T18:05:30.008" v="7804" actId="12788"/>
          <ac:spMkLst>
            <pc:docMk/>
            <pc:sldMk cId="2783075774" sldId="412"/>
            <ac:spMk id="23" creationId="{CD5A92D5-6B39-B5FE-0486-71A7C8609BC2}"/>
          </ac:spMkLst>
        </pc:spChg>
        <pc:spChg chg="add mod">
          <ac:chgData name="Jorgensen, Rick" userId="22b7bd11-eb0f-413f-9bcb-9ce21ec7b0a8" providerId="ADAL" clId="{63C519A2-C2B2-47AC-828F-E429CD2FEDB2}" dt="2023-07-27T17:15:46.822" v="9126" actId="692"/>
          <ac:spMkLst>
            <pc:docMk/>
            <pc:sldMk cId="2783075774" sldId="412"/>
            <ac:spMk id="24" creationId="{02A7DFAB-A4E9-9DC8-E3BB-C80A5F5FB494}"/>
          </ac:spMkLst>
        </pc:spChg>
        <pc:spChg chg="mod">
          <ac:chgData name="Jorgensen, Rick" userId="22b7bd11-eb0f-413f-9bcb-9ce21ec7b0a8" providerId="ADAL" clId="{63C519A2-C2B2-47AC-828F-E429CD2FEDB2}" dt="2023-08-01T15:18:41.523" v="11241" actId="20577"/>
          <ac:spMkLst>
            <pc:docMk/>
            <pc:sldMk cId="2783075774" sldId="412"/>
            <ac:spMk id="25" creationId="{43DF711F-4684-B34D-9236-D3A26D348F11}"/>
          </ac:spMkLst>
        </pc:spChg>
        <pc:spChg chg="mod">
          <ac:chgData name="Jorgensen, Rick" userId="22b7bd11-eb0f-413f-9bcb-9ce21ec7b0a8" providerId="ADAL" clId="{63C519A2-C2B2-47AC-828F-E429CD2FEDB2}" dt="2023-07-24T18:04:14.492" v="7778"/>
          <ac:spMkLst>
            <pc:docMk/>
            <pc:sldMk cId="2783075774" sldId="412"/>
            <ac:spMk id="27" creationId="{19F38BB8-889B-6D72-B8D4-2AFCDACFE9B2}"/>
          </ac:spMkLst>
        </pc:spChg>
        <pc:spChg chg="mod">
          <ac:chgData name="Jorgensen, Rick" userId="22b7bd11-eb0f-413f-9bcb-9ce21ec7b0a8" providerId="ADAL" clId="{63C519A2-C2B2-47AC-828F-E429CD2FEDB2}" dt="2023-07-24T18:04:14.492" v="7778"/>
          <ac:spMkLst>
            <pc:docMk/>
            <pc:sldMk cId="2783075774" sldId="412"/>
            <ac:spMk id="28" creationId="{6992DB56-B35A-02D4-8BA1-8CBED0330B5D}"/>
          </ac:spMkLst>
        </pc:spChg>
        <pc:spChg chg="mod">
          <ac:chgData name="Jorgensen, Rick" userId="22b7bd11-eb0f-413f-9bcb-9ce21ec7b0a8" providerId="ADAL" clId="{63C519A2-C2B2-47AC-828F-E429CD2FEDB2}" dt="2023-07-24T18:04:14.492" v="7778"/>
          <ac:spMkLst>
            <pc:docMk/>
            <pc:sldMk cId="2783075774" sldId="412"/>
            <ac:spMk id="29" creationId="{A8DEA823-6F04-3DDD-9D94-67297791C90B}"/>
          </ac:spMkLst>
        </pc:spChg>
        <pc:spChg chg="mod">
          <ac:chgData name="Jorgensen, Rick" userId="22b7bd11-eb0f-413f-9bcb-9ce21ec7b0a8" providerId="ADAL" clId="{63C519A2-C2B2-47AC-828F-E429CD2FEDB2}" dt="2023-07-24T18:04:14.492" v="7778"/>
          <ac:spMkLst>
            <pc:docMk/>
            <pc:sldMk cId="2783075774" sldId="412"/>
            <ac:spMk id="30" creationId="{EBD7F961-30EA-686C-AAD1-AC668A22501E}"/>
          </ac:spMkLst>
        </pc:spChg>
        <pc:spChg chg="add mod">
          <ac:chgData name="Jorgensen, Rick" userId="22b7bd11-eb0f-413f-9bcb-9ce21ec7b0a8" providerId="ADAL" clId="{63C519A2-C2B2-47AC-828F-E429CD2FEDB2}" dt="2023-07-27T17:18:28.492" v="9162" actId="1076"/>
          <ac:spMkLst>
            <pc:docMk/>
            <pc:sldMk cId="2783075774" sldId="412"/>
            <ac:spMk id="31" creationId="{84AC0E23-8A21-4C94-5E51-05A97A7607A0}"/>
          </ac:spMkLst>
        </pc:spChg>
        <pc:spChg chg="add mod">
          <ac:chgData name="Jorgensen, Rick" userId="22b7bd11-eb0f-413f-9bcb-9ce21ec7b0a8" providerId="ADAL" clId="{63C519A2-C2B2-47AC-828F-E429CD2FEDB2}" dt="2023-07-27T17:18:52.315" v="9164" actId="1076"/>
          <ac:spMkLst>
            <pc:docMk/>
            <pc:sldMk cId="2783075774" sldId="412"/>
            <ac:spMk id="32" creationId="{671FB36C-C53D-1383-B1A7-C6B28182FB4E}"/>
          </ac:spMkLst>
        </pc:spChg>
        <pc:spChg chg="add mod">
          <ac:chgData name="Jorgensen, Rick" userId="22b7bd11-eb0f-413f-9bcb-9ce21ec7b0a8" providerId="ADAL" clId="{63C519A2-C2B2-47AC-828F-E429CD2FEDB2}" dt="2023-08-01T15:21:08.483" v="11346" actId="113"/>
          <ac:spMkLst>
            <pc:docMk/>
            <pc:sldMk cId="2783075774" sldId="412"/>
            <ac:spMk id="33" creationId="{AE9B9143-6439-A491-DC8A-6D1ED72DE22D}"/>
          </ac:spMkLst>
        </pc:spChg>
        <pc:spChg chg="mod">
          <ac:chgData name="Jorgensen, Rick" userId="22b7bd11-eb0f-413f-9bcb-9ce21ec7b0a8" providerId="ADAL" clId="{63C519A2-C2B2-47AC-828F-E429CD2FEDB2}" dt="2023-07-24T17:56:58.725" v="7720" actId="1076"/>
          <ac:spMkLst>
            <pc:docMk/>
            <pc:sldMk cId="2783075774" sldId="412"/>
            <ac:spMk id="41" creationId="{66DA6F02-7D4C-D65E-6836-19D0B5646E8F}"/>
          </ac:spMkLst>
        </pc:spChg>
        <pc:grpChg chg="add mod">
          <ac:chgData name="Jorgensen, Rick" userId="22b7bd11-eb0f-413f-9bcb-9ce21ec7b0a8" providerId="ADAL" clId="{63C519A2-C2B2-47AC-828F-E429CD2FEDB2}" dt="2023-07-24T17:58:04.265" v="7743" actId="164"/>
          <ac:grpSpMkLst>
            <pc:docMk/>
            <pc:sldMk cId="2783075774" sldId="412"/>
            <ac:grpSpMk id="6" creationId="{DCFC1777-DB20-6318-1301-248FFE4DFA2C}"/>
          </ac:grpSpMkLst>
        </pc:grpChg>
        <pc:grpChg chg="mod">
          <ac:chgData name="Jorgensen, Rick" userId="22b7bd11-eb0f-413f-9bcb-9ce21ec7b0a8" providerId="ADAL" clId="{63C519A2-C2B2-47AC-828F-E429CD2FEDB2}" dt="2023-07-25T16:49:29.383" v="8375" actId="1076"/>
          <ac:grpSpMkLst>
            <pc:docMk/>
            <pc:sldMk cId="2783075774" sldId="412"/>
            <ac:grpSpMk id="21" creationId="{CC56C904-0BDB-5A14-493D-83F762479834}"/>
          </ac:grpSpMkLst>
        </pc:grpChg>
        <pc:grpChg chg="add mod">
          <ac:chgData name="Jorgensen, Rick" userId="22b7bd11-eb0f-413f-9bcb-9ce21ec7b0a8" providerId="ADAL" clId="{63C519A2-C2B2-47AC-828F-E429CD2FEDB2}" dt="2023-07-24T18:04:28.475" v="7780" actId="1076"/>
          <ac:grpSpMkLst>
            <pc:docMk/>
            <pc:sldMk cId="2783075774" sldId="412"/>
            <ac:grpSpMk id="26" creationId="{54BD471A-6DE7-603B-C7E1-93A0D7EACCCD}"/>
          </ac:grpSpMkLst>
        </pc:grpChg>
        <pc:graphicFrameChg chg="del">
          <ac:chgData name="Jorgensen, Rick" userId="22b7bd11-eb0f-413f-9bcb-9ce21ec7b0a8" providerId="ADAL" clId="{63C519A2-C2B2-47AC-828F-E429CD2FEDB2}" dt="2023-07-24T17:39:15.821" v="7702" actId="478"/>
          <ac:graphicFrameMkLst>
            <pc:docMk/>
            <pc:sldMk cId="2783075774" sldId="412"/>
            <ac:graphicFrameMk id="2" creationId="{13D7C20C-3EBD-4E3D-9B74-1FF6413849C7}"/>
          </ac:graphicFrameMkLst>
        </pc:graphicFrameChg>
        <pc:graphicFrameChg chg="add mod ord">
          <ac:chgData name="Jorgensen, Rick" userId="22b7bd11-eb0f-413f-9bcb-9ce21ec7b0a8" providerId="ADAL" clId="{63C519A2-C2B2-47AC-828F-E429CD2FEDB2}" dt="2023-08-01T15:18:56.940" v="11244" actId="692"/>
          <ac:graphicFrameMkLst>
            <pc:docMk/>
            <pc:sldMk cId="2783075774" sldId="412"/>
            <ac:graphicFrameMk id="4" creationId="{BC0289C9-88C8-4E03-837C-113225E7B331}"/>
          </ac:graphicFrameMkLst>
        </pc:graphicFrameChg>
        <pc:graphicFrameChg chg="add mod ord">
          <ac:chgData name="Jorgensen, Rick" userId="22b7bd11-eb0f-413f-9bcb-9ce21ec7b0a8" providerId="ADAL" clId="{63C519A2-C2B2-47AC-828F-E429CD2FEDB2}" dt="2023-08-01T15:18:58.992" v="11245" actId="692"/>
          <ac:graphicFrameMkLst>
            <pc:docMk/>
            <pc:sldMk cId="2783075774" sldId="412"/>
            <ac:graphicFrameMk id="7" creationId="{D2CC10A6-67CF-4C23-B38D-3611ECA572F3}"/>
          </ac:graphicFrameMkLst>
        </pc:graphicFrameChg>
      </pc:sldChg>
      <pc:sldChg chg="modSp add mod ord">
        <pc:chgData name="Jorgensen, Rick" userId="22b7bd11-eb0f-413f-9bcb-9ce21ec7b0a8" providerId="ADAL" clId="{63C519A2-C2B2-47AC-828F-E429CD2FEDB2}" dt="2023-08-01T14:47:15.640" v="10517" actId="20577"/>
        <pc:sldMkLst>
          <pc:docMk/>
          <pc:sldMk cId="2657217629" sldId="413"/>
        </pc:sldMkLst>
        <pc:spChg chg="mod">
          <ac:chgData name="Jorgensen, Rick" userId="22b7bd11-eb0f-413f-9bcb-9ce21ec7b0a8" providerId="ADAL" clId="{63C519A2-C2B2-47AC-828F-E429CD2FEDB2}" dt="2023-08-01T14:45:50.295" v="10467" actId="207"/>
          <ac:spMkLst>
            <pc:docMk/>
            <pc:sldMk cId="2657217629" sldId="413"/>
            <ac:spMk id="2" creationId="{00000000-0000-0000-0000-000000000000}"/>
          </ac:spMkLst>
        </pc:spChg>
        <pc:spChg chg="mod">
          <ac:chgData name="Jorgensen, Rick" userId="22b7bd11-eb0f-413f-9bcb-9ce21ec7b0a8" providerId="ADAL" clId="{63C519A2-C2B2-47AC-828F-E429CD2FEDB2}" dt="2023-08-01T14:47:15.640" v="10517" actId="20577"/>
          <ac:spMkLst>
            <pc:docMk/>
            <pc:sldMk cId="2657217629" sldId="413"/>
            <ac:spMk id="3" creationId="{00000000-0000-0000-0000-000000000000}"/>
          </ac:spMkLst>
        </pc:spChg>
      </pc:sldChg>
      <pc:sldChg chg="modSp add mod">
        <pc:chgData name="Jorgensen, Rick" userId="22b7bd11-eb0f-413f-9bcb-9ce21ec7b0a8" providerId="ADAL" clId="{63C519A2-C2B2-47AC-828F-E429CD2FEDB2}" dt="2023-08-01T14:57:26.062" v="10764" actId="207"/>
        <pc:sldMkLst>
          <pc:docMk/>
          <pc:sldMk cId="1709919940" sldId="414"/>
        </pc:sldMkLst>
        <pc:spChg chg="mod">
          <ac:chgData name="Jorgensen, Rick" userId="22b7bd11-eb0f-413f-9bcb-9ce21ec7b0a8" providerId="ADAL" clId="{63C519A2-C2B2-47AC-828F-E429CD2FEDB2}" dt="2023-08-01T14:57:26.062" v="10764" actId="207"/>
          <ac:spMkLst>
            <pc:docMk/>
            <pc:sldMk cId="1709919940" sldId="414"/>
            <ac:spMk id="2" creationId="{00000000-0000-0000-0000-000000000000}"/>
          </ac:spMkLst>
        </pc:spChg>
        <pc:spChg chg="mod">
          <ac:chgData name="Jorgensen, Rick" userId="22b7bd11-eb0f-413f-9bcb-9ce21ec7b0a8" providerId="ADAL" clId="{63C519A2-C2B2-47AC-828F-E429CD2FEDB2}" dt="2023-08-01T14:57:16.727" v="10763" actId="20577"/>
          <ac:spMkLst>
            <pc:docMk/>
            <pc:sldMk cId="1709919940" sldId="414"/>
            <ac:spMk id="3" creationId="{00000000-0000-0000-0000-000000000000}"/>
          </ac:spMkLst>
        </pc:spChg>
      </pc:sldChg>
      <pc:sldChg chg="modSp add mod modNotesTx">
        <pc:chgData name="Jorgensen, Rick" userId="22b7bd11-eb0f-413f-9bcb-9ce21ec7b0a8" providerId="ADAL" clId="{63C519A2-C2B2-47AC-828F-E429CD2FEDB2}" dt="2023-08-01T15:14:07.596" v="11190" actId="20577"/>
        <pc:sldMkLst>
          <pc:docMk/>
          <pc:sldMk cId="4212414396" sldId="415"/>
        </pc:sldMkLst>
        <pc:spChg chg="mod">
          <ac:chgData name="Jorgensen, Rick" userId="22b7bd11-eb0f-413f-9bcb-9ce21ec7b0a8" providerId="ADAL" clId="{63C519A2-C2B2-47AC-828F-E429CD2FEDB2}" dt="2023-08-01T15:07:52.034" v="11091" actId="207"/>
          <ac:spMkLst>
            <pc:docMk/>
            <pc:sldMk cId="4212414396" sldId="415"/>
            <ac:spMk id="2" creationId="{00000000-0000-0000-0000-000000000000}"/>
          </ac:spMkLst>
        </pc:spChg>
        <pc:spChg chg="mod">
          <ac:chgData name="Jorgensen, Rick" userId="22b7bd11-eb0f-413f-9bcb-9ce21ec7b0a8" providerId="ADAL" clId="{63C519A2-C2B2-47AC-828F-E429CD2FEDB2}" dt="2023-08-01T15:14:07.596" v="11190" actId="20577"/>
          <ac:spMkLst>
            <pc:docMk/>
            <pc:sldMk cId="4212414396" sldId="415"/>
            <ac:spMk id="3" creationId="{00000000-0000-0000-0000-000000000000}"/>
          </ac:spMkLst>
        </pc:spChg>
      </pc:sldChg>
      <pc:sldChg chg="modSp add mod">
        <pc:chgData name="Jorgensen, Rick" userId="22b7bd11-eb0f-413f-9bcb-9ce21ec7b0a8" providerId="ADAL" clId="{63C519A2-C2B2-47AC-828F-E429CD2FEDB2}" dt="2023-08-01T15:25:12.692" v="11623" actId="20577"/>
        <pc:sldMkLst>
          <pc:docMk/>
          <pc:sldMk cId="2623063376" sldId="416"/>
        </pc:sldMkLst>
        <pc:spChg chg="mod">
          <ac:chgData name="Jorgensen, Rick" userId="22b7bd11-eb0f-413f-9bcb-9ce21ec7b0a8" providerId="ADAL" clId="{63C519A2-C2B2-47AC-828F-E429CD2FEDB2}" dt="2023-08-01T15:25:12.692" v="11623" actId="20577"/>
          <ac:spMkLst>
            <pc:docMk/>
            <pc:sldMk cId="2623063376" sldId="416"/>
            <ac:spMk id="2" creationId="{00000000-0000-0000-0000-000000000000}"/>
          </ac:spMkLst>
        </pc:spChg>
        <pc:spChg chg="mod">
          <ac:chgData name="Jorgensen, Rick" userId="22b7bd11-eb0f-413f-9bcb-9ce21ec7b0a8" providerId="ADAL" clId="{63C519A2-C2B2-47AC-828F-E429CD2FEDB2}" dt="2023-08-01T15:25:09.096" v="11620" actId="20577"/>
          <ac:spMkLst>
            <pc:docMk/>
            <pc:sldMk cId="2623063376" sldId="416"/>
            <ac:spMk id="3" creationId="{00000000-0000-0000-0000-000000000000}"/>
          </ac:spMkLst>
        </pc:spChg>
      </pc:sldChg>
      <pc:sldChg chg="addSp delSp modSp add mod ord">
        <pc:chgData name="Jorgensen, Rick" userId="22b7bd11-eb0f-413f-9bcb-9ce21ec7b0a8" providerId="ADAL" clId="{63C519A2-C2B2-47AC-828F-E429CD2FEDB2}" dt="2023-08-01T15:57:40.357" v="12302" actId="20577"/>
        <pc:sldMkLst>
          <pc:docMk/>
          <pc:sldMk cId="4097523969" sldId="417"/>
        </pc:sldMkLst>
        <pc:spChg chg="add mod">
          <ac:chgData name="Jorgensen, Rick" userId="22b7bd11-eb0f-413f-9bcb-9ce21ec7b0a8" providerId="ADAL" clId="{63C519A2-C2B2-47AC-828F-E429CD2FEDB2}" dt="2023-07-25T16:56:32.995" v="8681" actId="20577"/>
          <ac:spMkLst>
            <pc:docMk/>
            <pc:sldMk cId="4097523969" sldId="417"/>
            <ac:spMk id="2" creationId="{8B5AADCD-8D30-1DE0-29A6-A19B735BC60A}"/>
          </ac:spMkLst>
        </pc:spChg>
        <pc:spChg chg="del">
          <ac:chgData name="Jorgensen, Rick" userId="22b7bd11-eb0f-413f-9bcb-9ce21ec7b0a8" providerId="ADAL" clId="{63C519A2-C2B2-47AC-828F-E429CD2FEDB2}" dt="2023-07-24T19:20:19.408" v="8256" actId="478"/>
          <ac:spMkLst>
            <pc:docMk/>
            <pc:sldMk cId="4097523969" sldId="417"/>
            <ac:spMk id="2" creationId="{8EFEAB41-433B-43A8-ACF1-88DEF577F222}"/>
          </ac:spMkLst>
        </pc:spChg>
        <pc:spChg chg="add mod">
          <ac:chgData name="Jorgensen, Rick" userId="22b7bd11-eb0f-413f-9bcb-9ce21ec7b0a8" providerId="ADAL" clId="{63C519A2-C2B2-47AC-828F-E429CD2FEDB2}" dt="2023-08-01T15:57:40.357" v="12302" actId="20577"/>
          <ac:spMkLst>
            <pc:docMk/>
            <pc:sldMk cId="4097523969" sldId="417"/>
            <ac:spMk id="3" creationId="{A4430EDA-9C79-4E9B-CECC-2455BE331958}"/>
          </ac:spMkLst>
        </pc:spChg>
        <pc:spChg chg="mod">
          <ac:chgData name="Jorgensen, Rick" userId="22b7bd11-eb0f-413f-9bcb-9ce21ec7b0a8" providerId="ADAL" clId="{63C519A2-C2B2-47AC-828F-E429CD2FEDB2}" dt="2023-07-24T19:23:02.661" v="8275" actId="164"/>
          <ac:spMkLst>
            <pc:docMk/>
            <pc:sldMk cId="4097523969" sldId="417"/>
            <ac:spMk id="4" creationId="{BA8AFA7A-54C4-A2FE-02DA-3CD76CF0C5E3}"/>
          </ac:spMkLst>
        </pc:spChg>
        <pc:spChg chg="del">
          <ac:chgData name="Jorgensen, Rick" userId="22b7bd11-eb0f-413f-9bcb-9ce21ec7b0a8" providerId="ADAL" clId="{63C519A2-C2B2-47AC-828F-E429CD2FEDB2}" dt="2023-07-24T19:20:13.541" v="8253" actId="478"/>
          <ac:spMkLst>
            <pc:docMk/>
            <pc:sldMk cId="4097523969" sldId="417"/>
            <ac:spMk id="9" creationId="{16C98FF7-C9E9-8046-A859-D9A599468A34}"/>
          </ac:spMkLst>
        </pc:spChg>
        <pc:spChg chg="del">
          <ac:chgData name="Jorgensen, Rick" userId="22b7bd11-eb0f-413f-9bcb-9ce21ec7b0a8" providerId="ADAL" clId="{63C519A2-C2B2-47AC-828F-E429CD2FEDB2}" dt="2023-07-24T19:20:23.421" v="8258" actId="478"/>
          <ac:spMkLst>
            <pc:docMk/>
            <pc:sldMk cId="4097523969" sldId="417"/>
            <ac:spMk id="10" creationId="{9F84E2A2-11BF-6249-A2DF-0BE34D738A76}"/>
          </ac:spMkLst>
        </pc:spChg>
        <pc:spChg chg="mod">
          <ac:chgData name="Jorgensen, Rick" userId="22b7bd11-eb0f-413f-9bcb-9ce21ec7b0a8" providerId="ADAL" clId="{63C519A2-C2B2-47AC-828F-E429CD2FEDB2}" dt="2023-07-24T19:20:57.097" v="8268" actId="1076"/>
          <ac:spMkLst>
            <pc:docMk/>
            <pc:sldMk cId="4097523969" sldId="417"/>
            <ac:spMk id="13" creationId="{17223BBD-BD68-A3C5-875F-E0DF77012F65}"/>
          </ac:spMkLst>
        </pc:spChg>
        <pc:spChg chg="del">
          <ac:chgData name="Jorgensen, Rick" userId="22b7bd11-eb0f-413f-9bcb-9ce21ec7b0a8" providerId="ADAL" clId="{63C519A2-C2B2-47AC-828F-E429CD2FEDB2}" dt="2023-07-24T19:22:57.456" v="8274" actId="478"/>
          <ac:spMkLst>
            <pc:docMk/>
            <pc:sldMk cId="4097523969" sldId="417"/>
            <ac:spMk id="14" creationId="{156CE65C-A549-44C4-F8D6-ED4B92254675}"/>
          </ac:spMkLst>
        </pc:spChg>
        <pc:spChg chg="mod">
          <ac:chgData name="Jorgensen, Rick" userId="22b7bd11-eb0f-413f-9bcb-9ce21ec7b0a8" providerId="ADAL" clId="{63C519A2-C2B2-47AC-828F-E429CD2FEDB2}" dt="2023-07-27T14:17:21.816" v="8752" actId="1076"/>
          <ac:spMkLst>
            <pc:docMk/>
            <pc:sldMk cId="4097523969" sldId="417"/>
            <ac:spMk id="15" creationId="{173B057F-B5A5-65B5-CC6F-49167E2ECD3A}"/>
          </ac:spMkLst>
        </pc:spChg>
        <pc:spChg chg="mod">
          <ac:chgData name="Jorgensen, Rick" userId="22b7bd11-eb0f-413f-9bcb-9ce21ec7b0a8" providerId="ADAL" clId="{63C519A2-C2B2-47AC-828F-E429CD2FEDB2}" dt="2023-07-27T14:17:26.526" v="8753" actId="1076"/>
          <ac:spMkLst>
            <pc:docMk/>
            <pc:sldMk cId="4097523969" sldId="417"/>
            <ac:spMk id="16" creationId="{AA43EFEB-2BC0-1289-83CF-640785EE1C2A}"/>
          </ac:spMkLst>
        </pc:spChg>
        <pc:spChg chg="mod">
          <ac:chgData name="Jorgensen, Rick" userId="22b7bd11-eb0f-413f-9bcb-9ce21ec7b0a8" providerId="ADAL" clId="{63C519A2-C2B2-47AC-828F-E429CD2FEDB2}" dt="2023-07-27T14:17:30.949" v="8754" actId="1076"/>
          <ac:spMkLst>
            <pc:docMk/>
            <pc:sldMk cId="4097523969" sldId="417"/>
            <ac:spMk id="21" creationId="{3B9A3174-6392-90C0-056B-0FDC88892F48}"/>
          </ac:spMkLst>
        </pc:spChg>
        <pc:spChg chg="del">
          <ac:chgData name="Jorgensen, Rick" userId="22b7bd11-eb0f-413f-9bcb-9ce21ec7b0a8" providerId="ADAL" clId="{63C519A2-C2B2-47AC-828F-E429CD2FEDB2}" dt="2023-07-24T19:22:57.456" v="8274" actId="478"/>
          <ac:spMkLst>
            <pc:docMk/>
            <pc:sldMk cId="4097523969" sldId="417"/>
            <ac:spMk id="23" creationId="{19550F3A-D9E1-F153-89B0-8CD9494F9302}"/>
          </ac:spMkLst>
        </pc:spChg>
        <pc:spChg chg="del">
          <ac:chgData name="Jorgensen, Rick" userId="22b7bd11-eb0f-413f-9bcb-9ce21ec7b0a8" providerId="ADAL" clId="{63C519A2-C2B2-47AC-828F-E429CD2FEDB2}" dt="2023-07-24T19:22:57.456" v="8274" actId="478"/>
          <ac:spMkLst>
            <pc:docMk/>
            <pc:sldMk cId="4097523969" sldId="417"/>
            <ac:spMk id="24" creationId="{EAA976DB-8DA4-9B26-CCC3-94FCE9F99ADA}"/>
          </ac:spMkLst>
        </pc:spChg>
        <pc:spChg chg="mod">
          <ac:chgData name="Jorgensen, Rick" userId="22b7bd11-eb0f-413f-9bcb-9ce21ec7b0a8" providerId="ADAL" clId="{63C519A2-C2B2-47AC-828F-E429CD2FEDB2}" dt="2023-08-01T15:56:39.135" v="12251" actId="20577"/>
          <ac:spMkLst>
            <pc:docMk/>
            <pc:sldMk cId="4097523969" sldId="417"/>
            <ac:spMk id="25" creationId="{43DF711F-4684-B34D-9236-D3A26D348F11}"/>
          </ac:spMkLst>
        </pc:spChg>
        <pc:spChg chg="del">
          <ac:chgData name="Jorgensen, Rick" userId="22b7bd11-eb0f-413f-9bcb-9ce21ec7b0a8" providerId="ADAL" clId="{63C519A2-C2B2-47AC-828F-E429CD2FEDB2}" dt="2023-07-24T19:22:57.456" v="8274" actId="478"/>
          <ac:spMkLst>
            <pc:docMk/>
            <pc:sldMk cId="4097523969" sldId="417"/>
            <ac:spMk id="26" creationId="{82DFD962-4B35-42D7-9E88-929DAF8AF198}"/>
          </ac:spMkLst>
        </pc:spChg>
        <pc:spChg chg="del">
          <ac:chgData name="Jorgensen, Rick" userId="22b7bd11-eb0f-413f-9bcb-9ce21ec7b0a8" providerId="ADAL" clId="{63C519A2-C2B2-47AC-828F-E429CD2FEDB2}" dt="2023-07-24T19:22:57.456" v="8274" actId="478"/>
          <ac:spMkLst>
            <pc:docMk/>
            <pc:sldMk cId="4097523969" sldId="417"/>
            <ac:spMk id="27" creationId="{8FD21EAD-EBFF-3FB4-4AB8-4F730C820176}"/>
          </ac:spMkLst>
        </pc:spChg>
        <pc:spChg chg="del">
          <ac:chgData name="Jorgensen, Rick" userId="22b7bd11-eb0f-413f-9bcb-9ce21ec7b0a8" providerId="ADAL" clId="{63C519A2-C2B2-47AC-828F-E429CD2FEDB2}" dt="2023-07-24T19:22:57.456" v="8274" actId="478"/>
          <ac:spMkLst>
            <pc:docMk/>
            <pc:sldMk cId="4097523969" sldId="417"/>
            <ac:spMk id="28" creationId="{7904D664-C175-8E08-BFC8-D8801AABA637}"/>
          </ac:spMkLst>
        </pc:spChg>
        <pc:spChg chg="del">
          <ac:chgData name="Jorgensen, Rick" userId="22b7bd11-eb0f-413f-9bcb-9ce21ec7b0a8" providerId="ADAL" clId="{63C519A2-C2B2-47AC-828F-E429CD2FEDB2}" dt="2023-07-24T19:22:57.456" v="8274" actId="478"/>
          <ac:spMkLst>
            <pc:docMk/>
            <pc:sldMk cId="4097523969" sldId="417"/>
            <ac:spMk id="29" creationId="{1562BBC8-9915-3DE9-09BF-DE5F5615ABBB}"/>
          </ac:spMkLst>
        </pc:spChg>
        <pc:spChg chg="mod ord">
          <ac:chgData name="Jorgensen, Rick" userId="22b7bd11-eb0f-413f-9bcb-9ce21ec7b0a8" providerId="ADAL" clId="{63C519A2-C2B2-47AC-828F-E429CD2FEDB2}" dt="2023-07-24T19:23:02.661" v="8275" actId="164"/>
          <ac:spMkLst>
            <pc:docMk/>
            <pc:sldMk cId="4097523969" sldId="417"/>
            <ac:spMk id="30" creationId="{3D48DC1C-90A7-8867-CD77-A30256D274E3}"/>
          </ac:spMkLst>
        </pc:spChg>
        <pc:spChg chg="del">
          <ac:chgData name="Jorgensen, Rick" userId="22b7bd11-eb0f-413f-9bcb-9ce21ec7b0a8" providerId="ADAL" clId="{63C519A2-C2B2-47AC-828F-E429CD2FEDB2}" dt="2023-07-24T19:22:57.456" v="8274" actId="478"/>
          <ac:spMkLst>
            <pc:docMk/>
            <pc:sldMk cId="4097523969" sldId="417"/>
            <ac:spMk id="32" creationId="{C90D9045-95AA-99FE-29BB-971165462D87}"/>
          </ac:spMkLst>
        </pc:spChg>
        <pc:grpChg chg="del">
          <ac:chgData name="Jorgensen, Rick" userId="22b7bd11-eb0f-413f-9bcb-9ce21ec7b0a8" providerId="ADAL" clId="{63C519A2-C2B2-47AC-828F-E429CD2FEDB2}" dt="2023-07-24T19:20:17.441" v="8255" actId="478"/>
          <ac:grpSpMkLst>
            <pc:docMk/>
            <pc:sldMk cId="4097523969" sldId="417"/>
            <ac:grpSpMk id="6" creationId="{9536570B-187C-20CB-F1E2-3451D8577D5B}"/>
          </ac:grpSpMkLst>
        </pc:grpChg>
        <pc:grpChg chg="add mod ord">
          <ac:chgData name="Jorgensen, Rick" userId="22b7bd11-eb0f-413f-9bcb-9ce21ec7b0a8" providerId="ADAL" clId="{63C519A2-C2B2-47AC-828F-E429CD2FEDB2}" dt="2023-07-27T14:17:09.255" v="8750" actId="167"/>
          <ac:grpSpMkLst>
            <pc:docMk/>
            <pc:sldMk cId="4097523969" sldId="417"/>
            <ac:grpSpMk id="8" creationId="{554CA56B-E938-2C2D-8BAE-4ED945DABE13}"/>
          </ac:grpSpMkLst>
        </pc:grpChg>
        <pc:grpChg chg="mod ord">
          <ac:chgData name="Jorgensen, Rick" userId="22b7bd11-eb0f-413f-9bcb-9ce21ec7b0a8" providerId="ADAL" clId="{63C519A2-C2B2-47AC-828F-E429CD2FEDB2}" dt="2023-07-24T19:23:02.661" v="8275" actId="164"/>
          <ac:grpSpMkLst>
            <pc:docMk/>
            <pc:sldMk cId="4097523969" sldId="417"/>
            <ac:grpSpMk id="11" creationId="{F15114B5-9AE8-15A9-F83F-9112797F4535}"/>
          </ac:grpSpMkLst>
        </pc:grpChg>
        <pc:graphicFrameChg chg="del">
          <ac:chgData name="Jorgensen, Rick" userId="22b7bd11-eb0f-413f-9bcb-9ce21ec7b0a8" providerId="ADAL" clId="{63C519A2-C2B2-47AC-828F-E429CD2FEDB2}" dt="2023-07-24T19:20:15.759" v="8254" actId="478"/>
          <ac:graphicFrameMkLst>
            <pc:docMk/>
            <pc:sldMk cId="4097523969" sldId="417"/>
            <ac:graphicFrameMk id="3" creationId="{7BB3A9BD-A127-4B41-B92F-A1864F1BB2EF}"/>
          </ac:graphicFrameMkLst>
        </pc:graphicFrameChg>
        <pc:graphicFrameChg chg="add mod ord">
          <ac:chgData name="Jorgensen, Rick" userId="22b7bd11-eb0f-413f-9bcb-9ce21ec7b0a8" providerId="ADAL" clId="{63C519A2-C2B2-47AC-828F-E429CD2FEDB2}" dt="2023-07-27T18:03:04.552" v="9383" actId="692"/>
          <ac:graphicFrameMkLst>
            <pc:docMk/>
            <pc:sldMk cId="4097523969" sldId="417"/>
            <ac:graphicFrameMk id="5" creationId="{D4CCACB4-4E67-4B42-B1F7-EB2D9C2F572E}"/>
          </ac:graphicFrameMkLst>
        </pc:graphicFrameChg>
        <pc:graphicFrameChg chg="del">
          <ac:chgData name="Jorgensen, Rick" userId="22b7bd11-eb0f-413f-9bcb-9ce21ec7b0a8" providerId="ADAL" clId="{63C519A2-C2B2-47AC-828F-E429CD2FEDB2}" dt="2023-07-24T19:20:21.678" v="8257" actId="478"/>
          <ac:graphicFrameMkLst>
            <pc:docMk/>
            <pc:sldMk cId="4097523969" sldId="417"/>
            <ac:graphicFrameMk id="7" creationId="{AE1F7F2C-2903-49BF-8D46-B74042A4DF30}"/>
          </ac:graphicFrameMkLst>
        </pc:graphicFrameChg>
      </pc:sldChg>
      <pc:sldChg chg="modSp add mod">
        <pc:chgData name="Jorgensen, Rick" userId="22b7bd11-eb0f-413f-9bcb-9ce21ec7b0a8" providerId="ADAL" clId="{63C519A2-C2B2-47AC-828F-E429CD2FEDB2}" dt="2023-08-01T15:59:15.246" v="12457" actId="20577"/>
        <pc:sldMkLst>
          <pc:docMk/>
          <pc:sldMk cId="4043107919" sldId="418"/>
        </pc:sldMkLst>
        <pc:spChg chg="mod">
          <ac:chgData name="Jorgensen, Rick" userId="22b7bd11-eb0f-413f-9bcb-9ce21ec7b0a8" providerId="ADAL" clId="{63C519A2-C2B2-47AC-828F-E429CD2FEDB2}" dt="2023-08-01T15:56:44.040" v="12253" actId="20577"/>
          <ac:spMkLst>
            <pc:docMk/>
            <pc:sldMk cId="4043107919" sldId="418"/>
            <ac:spMk id="2" creationId="{00000000-0000-0000-0000-000000000000}"/>
          </ac:spMkLst>
        </pc:spChg>
        <pc:spChg chg="mod">
          <ac:chgData name="Jorgensen, Rick" userId="22b7bd11-eb0f-413f-9bcb-9ce21ec7b0a8" providerId="ADAL" clId="{63C519A2-C2B2-47AC-828F-E429CD2FEDB2}" dt="2023-08-01T15:59:15.246" v="12457" actId="20577"/>
          <ac:spMkLst>
            <pc:docMk/>
            <pc:sldMk cId="4043107919" sldId="418"/>
            <ac:spMk id="3" creationId="{00000000-0000-0000-0000-000000000000}"/>
          </ac:spMkLst>
        </pc:spChg>
      </pc:sldChg>
      <pc:sldChg chg="addSp delSp modSp add mod">
        <pc:chgData name="Jorgensen, Rick" userId="22b7bd11-eb0f-413f-9bcb-9ce21ec7b0a8" providerId="ADAL" clId="{63C519A2-C2B2-47AC-828F-E429CD2FEDB2}" dt="2023-08-01T15:59:22.783" v="12459" actId="20577"/>
        <pc:sldMkLst>
          <pc:docMk/>
          <pc:sldMk cId="1551454966" sldId="419"/>
        </pc:sldMkLst>
        <pc:spChg chg="del">
          <ac:chgData name="Jorgensen, Rick" userId="22b7bd11-eb0f-413f-9bcb-9ce21ec7b0a8" providerId="ADAL" clId="{63C519A2-C2B2-47AC-828F-E429CD2FEDB2}" dt="2023-07-31T17:39:22.911" v="9388" actId="478"/>
          <ac:spMkLst>
            <pc:docMk/>
            <pc:sldMk cId="1551454966" sldId="419"/>
            <ac:spMk id="2" creationId="{8B5AADCD-8D30-1DE0-29A6-A19B735BC60A}"/>
          </ac:spMkLst>
        </pc:spChg>
        <pc:spChg chg="add mod">
          <ac:chgData name="Jorgensen, Rick" userId="22b7bd11-eb0f-413f-9bcb-9ce21ec7b0a8" providerId="ADAL" clId="{63C519A2-C2B2-47AC-828F-E429CD2FEDB2}" dt="2023-08-01T15:05:50.655" v="10967" actId="20577"/>
          <ac:spMkLst>
            <pc:docMk/>
            <pc:sldMk cId="1551454966" sldId="419"/>
            <ac:spMk id="2" creationId="{E4AB3438-02A3-FCA3-6BEE-117F2F89AB1D}"/>
          </ac:spMkLst>
        </pc:spChg>
        <pc:spChg chg="add mod">
          <ac:chgData name="Jorgensen, Rick" userId="22b7bd11-eb0f-413f-9bcb-9ce21ec7b0a8" providerId="ADAL" clId="{63C519A2-C2B2-47AC-828F-E429CD2FEDB2}" dt="2023-07-31T17:49:23.587" v="9536" actId="1076"/>
          <ac:spMkLst>
            <pc:docMk/>
            <pc:sldMk cId="1551454966" sldId="419"/>
            <ac:spMk id="17" creationId="{055AFFF1-7D90-FBB9-1959-2C2BBDB4E1ED}"/>
          </ac:spMkLst>
        </pc:spChg>
        <pc:spChg chg="mod topLvl">
          <ac:chgData name="Jorgensen, Rick" userId="22b7bd11-eb0f-413f-9bcb-9ce21ec7b0a8" providerId="ADAL" clId="{63C519A2-C2B2-47AC-828F-E429CD2FEDB2}" dt="2023-08-01T15:04:54.516" v="10886" actId="1076"/>
          <ac:spMkLst>
            <pc:docMk/>
            <pc:sldMk cId="1551454966" sldId="419"/>
            <ac:spMk id="19" creationId="{672A4FC3-3D56-829F-2976-0E0C208F8297}"/>
          </ac:spMkLst>
        </pc:spChg>
        <pc:spChg chg="mod topLvl">
          <ac:chgData name="Jorgensen, Rick" userId="22b7bd11-eb0f-413f-9bcb-9ce21ec7b0a8" providerId="ADAL" clId="{63C519A2-C2B2-47AC-828F-E429CD2FEDB2}" dt="2023-07-31T18:24:16.727" v="9817" actId="554"/>
          <ac:spMkLst>
            <pc:docMk/>
            <pc:sldMk cId="1551454966" sldId="419"/>
            <ac:spMk id="20" creationId="{2528A491-AA50-60E3-6310-24435633F104}"/>
          </ac:spMkLst>
        </pc:spChg>
        <pc:spChg chg="mod topLvl">
          <ac:chgData name="Jorgensen, Rick" userId="22b7bd11-eb0f-413f-9bcb-9ce21ec7b0a8" providerId="ADAL" clId="{63C519A2-C2B2-47AC-828F-E429CD2FEDB2}" dt="2023-07-31T18:24:12.751" v="9811" actId="1076"/>
          <ac:spMkLst>
            <pc:docMk/>
            <pc:sldMk cId="1551454966" sldId="419"/>
            <ac:spMk id="23" creationId="{3C341047-FD9F-DF12-634D-79C97FE1D07B}"/>
          </ac:spMkLst>
        </pc:spChg>
        <pc:spChg chg="mod">
          <ac:chgData name="Jorgensen, Rick" userId="22b7bd11-eb0f-413f-9bcb-9ce21ec7b0a8" providerId="ADAL" clId="{63C519A2-C2B2-47AC-828F-E429CD2FEDB2}" dt="2023-08-01T15:59:22.783" v="12459" actId="20577"/>
          <ac:spMkLst>
            <pc:docMk/>
            <pc:sldMk cId="1551454966" sldId="419"/>
            <ac:spMk id="25" creationId="{43DF711F-4684-B34D-9236-D3A26D348F11}"/>
          </ac:spMkLst>
        </pc:spChg>
        <pc:spChg chg="mod">
          <ac:chgData name="Jorgensen, Rick" userId="22b7bd11-eb0f-413f-9bcb-9ce21ec7b0a8" providerId="ADAL" clId="{63C519A2-C2B2-47AC-828F-E429CD2FEDB2}" dt="2023-07-31T17:48:10.964" v="9505" actId="1076"/>
          <ac:spMkLst>
            <pc:docMk/>
            <pc:sldMk cId="1551454966" sldId="419"/>
            <ac:spMk id="26" creationId="{919ADD27-8304-7486-4707-0E934543F599}"/>
          </ac:spMkLst>
        </pc:spChg>
        <pc:spChg chg="mod">
          <ac:chgData name="Jorgensen, Rick" userId="22b7bd11-eb0f-413f-9bcb-9ce21ec7b0a8" providerId="ADAL" clId="{63C519A2-C2B2-47AC-828F-E429CD2FEDB2}" dt="2023-07-31T17:48:15.014" v="9506" actId="1076"/>
          <ac:spMkLst>
            <pc:docMk/>
            <pc:sldMk cId="1551454966" sldId="419"/>
            <ac:spMk id="27" creationId="{6F92A4CE-9341-E588-5B6F-D9D02E215FCB}"/>
          </ac:spMkLst>
        </pc:spChg>
        <pc:spChg chg="mod">
          <ac:chgData name="Jorgensen, Rick" userId="22b7bd11-eb0f-413f-9bcb-9ce21ec7b0a8" providerId="ADAL" clId="{63C519A2-C2B2-47AC-828F-E429CD2FEDB2}" dt="2023-07-31T17:46:57.387" v="9498" actId="20577"/>
          <ac:spMkLst>
            <pc:docMk/>
            <pc:sldMk cId="1551454966" sldId="419"/>
            <ac:spMk id="29" creationId="{9F0252AC-1FAC-ABFC-38BB-17CC392365A2}"/>
          </ac:spMkLst>
        </pc:spChg>
        <pc:spChg chg="mod">
          <ac:chgData name="Jorgensen, Rick" userId="22b7bd11-eb0f-413f-9bcb-9ce21ec7b0a8" providerId="ADAL" clId="{63C519A2-C2B2-47AC-828F-E429CD2FEDB2}" dt="2023-07-31T17:48:53.082" v="9515" actId="113"/>
          <ac:spMkLst>
            <pc:docMk/>
            <pc:sldMk cId="1551454966" sldId="419"/>
            <ac:spMk id="37" creationId="{87D72CE6-938B-01C3-05F2-32775D1499DC}"/>
          </ac:spMkLst>
        </pc:spChg>
        <pc:spChg chg="mod">
          <ac:chgData name="Jorgensen, Rick" userId="22b7bd11-eb0f-413f-9bcb-9ce21ec7b0a8" providerId="ADAL" clId="{63C519A2-C2B2-47AC-828F-E429CD2FEDB2}" dt="2023-07-31T17:48:53.082" v="9515" actId="113"/>
          <ac:spMkLst>
            <pc:docMk/>
            <pc:sldMk cId="1551454966" sldId="419"/>
            <ac:spMk id="38" creationId="{D1A81F6D-19BA-8027-2D97-1E85FFEEE055}"/>
          </ac:spMkLst>
        </pc:spChg>
        <pc:spChg chg="mod">
          <ac:chgData name="Jorgensen, Rick" userId="22b7bd11-eb0f-413f-9bcb-9ce21ec7b0a8" providerId="ADAL" clId="{63C519A2-C2B2-47AC-828F-E429CD2FEDB2}" dt="2023-07-31T17:48:53.082" v="9515" actId="113"/>
          <ac:spMkLst>
            <pc:docMk/>
            <pc:sldMk cId="1551454966" sldId="419"/>
            <ac:spMk id="40" creationId="{861F0312-B802-DABC-F884-777F338859F5}"/>
          </ac:spMkLst>
        </pc:spChg>
        <pc:spChg chg="mod topLvl">
          <ac:chgData name="Jorgensen, Rick" userId="22b7bd11-eb0f-413f-9bcb-9ce21ec7b0a8" providerId="ADAL" clId="{63C519A2-C2B2-47AC-828F-E429CD2FEDB2}" dt="2023-07-31T18:24:16.727" v="9817" actId="554"/>
          <ac:spMkLst>
            <pc:docMk/>
            <pc:sldMk cId="1551454966" sldId="419"/>
            <ac:spMk id="42" creationId="{791B78AD-8DB3-6DB6-F6A9-DDD906D220C5}"/>
          </ac:spMkLst>
        </pc:spChg>
        <pc:spChg chg="mod topLvl">
          <ac:chgData name="Jorgensen, Rick" userId="22b7bd11-eb0f-413f-9bcb-9ce21ec7b0a8" providerId="ADAL" clId="{63C519A2-C2B2-47AC-828F-E429CD2FEDB2}" dt="2023-07-31T18:24:16.727" v="9817" actId="554"/>
          <ac:spMkLst>
            <pc:docMk/>
            <pc:sldMk cId="1551454966" sldId="419"/>
            <ac:spMk id="43" creationId="{9248024D-CADF-9502-669A-BD87314121FB}"/>
          </ac:spMkLst>
        </pc:spChg>
        <pc:spChg chg="mod topLvl">
          <ac:chgData name="Jorgensen, Rick" userId="22b7bd11-eb0f-413f-9bcb-9ce21ec7b0a8" providerId="ADAL" clId="{63C519A2-C2B2-47AC-828F-E429CD2FEDB2}" dt="2023-07-31T18:21:36.532" v="9758" actId="165"/>
          <ac:spMkLst>
            <pc:docMk/>
            <pc:sldMk cId="1551454966" sldId="419"/>
            <ac:spMk id="45" creationId="{93016FDB-1635-B52B-E5CC-109D3D3A5EC7}"/>
          </ac:spMkLst>
        </pc:spChg>
        <pc:spChg chg="add mod">
          <ac:chgData name="Jorgensen, Rick" userId="22b7bd11-eb0f-413f-9bcb-9ce21ec7b0a8" providerId="ADAL" clId="{63C519A2-C2B2-47AC-828F-E429CD2FEDB2}" dt="2023-07-31T18:17:53.904" v="9615" actId="1076"/>
          <ac:spMkLst>
            <pc:docMk/>
            <pc:sldMk cId="1551454966" sldId="419"/>
            <ac:spMk id="53" creationId="{6396E680-00D0-8F82-1816-555E623E2E69}"/>
          </ac:spMkLst>
        </pc:spChg>
        <pc:spChg chg="add mod">
          <ac:chgData name="Jorgensen, Rick" userId="22b7bd11-eb0f-413f-9bcb-9ce21ec7b0a8" providerId="ADAL" clId="{63C519A2-C2B2-47AC-828F-E429CD2FEDB2}" dt="2023-07-31T18:18:00.178" v="9616" actId="1076"/>
          <ac:spMkLst>
            <pc:docMk/>
            <pc:sldMk cId="1551454966" sldId="419"/>
            <ac:spMk id="54" creationId="{AF1A4DE1-431E-F8D2-F34E-B86711B93E41}"/>
          </ac:spMkLst>
        </pc:spChg>
        <pc:spChg chg="add mod">
          <ac:chgData name="Jorgensen, Rick" userId="22b7bd11-eb0f-413f-9bcb-9ce21ec7b0a8" providerId="ADAL" clId="{63C519A2-C2B2-47AC-828F-E429CD2FEDB2}" dt="2023-07-31T18:17:33.207" v="9613" actId="1076"/>
          <ac:spMkLst>
            <pc:docMk/>
            <pc:sldMk cId="1551454966" sldId="419"/>
            <ac:spMk id="55" creationId="{62636936-5942-8106-460E-CC1AC237CC3A}"/>
          </ac:spMkLst>
        </pc:spChg>
        <pc:grpChg chg="del">
          <ac:chgData name="Jorgensen, Rick" userId="22b7bd11-eb0f-413f-9bcb-9ce21ec7b0a8" providerId="ADAL" clId="{63C519A2-C2B2-47AC-828F-E429CD2FEDB2}" dt="2023-07-31T17:39:21.253" v="9387" actId="478"/>
          <ac:grpSpMkLst>
            <pc:docMk/>
            <pc:sldMk cId="1551454966" sldId="419"/>
            <ac:grpSpMk id="8" creationId="{554CA56B-E938-2C2D-8BAE-4ED945DABE13}"/>
          </ac:grpSpMkLst>
        </pc:grpChg>
        <pc:grpChg chg="add del mod">
          <ac:chgData name="Jorgensen, Rick" userId="22b7bd11-eb0f-413f-9bcb-9ce21ec7b0a8" providerId="ADAL" clId="{63C519A2-C2B2-47AC-828F-E429CD2FEDB2}" dt="2023-07-31T18:21:40.959" v="9759" actId="165"/>
          <ac:grpSpMkLst>
            <pc:docMk/>
            <pc:sldMk cId="1551454966" sldId="419"/>
            <ac:grpSpMk id="18" creationId="{9BC186D3-89A2-96FA-272F-E5111E0C0F58}"/>
          </ac:grpSpMkLst>
        </pc:grpChg>
        <pc:grpChg chg="add del mod">
          <ac:chgData name="Jorgensen, Rick" userId="22b7bd11-eb0f-413f-9bcb-9ce21ec7b0a8" providerId="ADAL" clId="{63C519A2-C2B2-47AC-828F-E429CD2FEDB2}" dt="2023-07-31T17:49:15.652" v="9535" actId="478"/>
          <ac:grpSpMkLst>
            <pc:docMk/>
            <pc:sldMk cId="1551454966" sldId="419"/>
            <ac:grpSpMk id="24" creationId="{95DD4602-B8F0-DB14-BE37-19D75F64512D}"/>
          </ac:grpSpMkLst>
        </pc:grpChg>
        <pc:grpChg chg="add del mod">
          <ac:chgData name="Jorgensen, Rick" userId="22b7bd11-eb0f-413f-9bcb-9ce21ec7b0a8" providerId="ADAL" clId="{63C519A2-C2B2-47AC-828F-E429CD2FEDB2}" dt="2023-07-31T17:48:54.689" v="9516" actId="478"/>
          <ac:grpSpMkLst>
            <pc:docMk/>
            <pc:sldMk cId="1551454966" sldId="419"/>
            <ac:grpSpMk id="36" creationId="{5863F96C-E156-F2AA-360C-0E174F902658}"/>
          </ac:grpSpMkLst>
        </pc:grpChg>
        <pc:grpChg chg="add del mod">
          <ac:chgData name="Jorgensen, Rick" userId="22b7bd11-eb0f-413f-9bcb-9ce21ec7b0a8" providerId="ADAL" clId="{63C519A2-C2B2-47AC-828F-E429CD2FEDB2}" dt="2023-07-31T18:21:36.532" v="9758" actId="165"/>
          <ac:grpSpMkLst>
            <pc:docMk/>
            <pc:sldMk cId="1551454966" sldId="419"/>
            <ac:grpSpMk id="41" creationId="{F0F35F16-1664-11E0-1794-ABFBE7FA181B}"/>
          </ac:grpSpMkLst>
        </pc:grpChg>
        <pc:graphicFrameChg chg="add del mod">
          <ac:chgData name="Jorgensen, Rick" userId="22b7bd11-eb0f-413f-9bcb-9ce21ec7b0a8" providerId="ADAL" clId="{63C519A2-C2B2-47AC-828F-E429CD2FEDB2}" dt="2023-07-31T17:39:36.513" v="9390" actId="478"/>
          <ac:graphicFrameMkLst>
            <pc:docMk/>
            <pc:sldMk cId="1551454966" sldId="419"/>
            <ac:graphicFrameMk id="3" creationId="{4936B1E3-6CC8-4944-870F-DC784E261689}"/>
          </ac:graphicFrameMkLst>
        </pc:graphicFrameChg>
        <pc:graphicFrameChg chg="add del mod">
          <ac:chgData name="Jorgensen, Rick" userId="22b7bd11-eb0f-413f-9bcb-9ce21ec7b0a8" providerId="ADAL" clId="{63C519A2-C2B2-47AC-828F-E429CD2FEDB2}" dt="2023-07-31T17:39:42.650" v="9392" actId="478"/>
          <ac:graphicFrameMkLst>
            <pc:docMk/>
            <pc:sldMk cId="1551454966" sldId="419"/>
            <ac:graphicFrameMk id="6" creationId="{4936B1E3-6CC8-4944-870F-DC784E261689}"/>
          </ac:graphicFrameMkLst>
        </pc:graphicFrameChg>
        <pc:graphicFrameChg chg="add del mod">
          <ac:chgData name="Jorgensen, Rick" userId="22b7bd11-eb0f-413f-9bcb-9ce21ec7b0a8" providerId="ADAL" clId="{63C519A2-C2B2-47AC-828F-E429CD2FEDB2}" dt="2023-07-31T17:41:02.594" v="9397" actId="478"/>
          <ac:graphicFrameMkLst>
            <pc:docMk/>
            <pc:sldMk cId="1551454966" sldId="419"/>
            <ac:graphicFrameMk id="9" creationId="{4936B1E3-6CC8-4944-870F-DC784E261689}"/>
          </ac:graphicFrameMkLst>
        </pc:graphicFrameChg>
        <pc:graphicFrameChg chg="add del mod">
          <ac:chgData name="Jorgensen, Rick" userId="22b7bd11-eb0f-413f-9bcb-9ce21ec7b0a8" providerId="ADAL" clId="{63C519A2-C2B2-47AC-828F-E429CD2FEDB2}" dt="2023-07-31T17:43:17.101" v="9402" actId="478"/>
          <ac:graphicFrameMkLst>
            <pc:docMk/>
            <pc:sldMk cId="1551454966" sldId="419"/>
            <ac:graphicFrameMk id="10" creationId="{4936B1E3-6CC8-4944-870F-DC784E261689}"/>
          </ac:graphicFrameMkLst>
        </pc:graphicFrameChg>
        <pc:graphicFrameChg chg="add mod">
          <ac:chgData name="Jorgensen, Rick" userId="22b7bd11-eb0f-413f-9bcb-9ce21ec7b0a8" providerId="ADAL" clId="{63C519A2-C2B2-47AC-828F-E429CD2FEDB2}" dt="2023-08-01T15:05:28.520" v="10919" actId="692"/>
          <ac:graphicFrameMkLst>
            <pc:docMk/>
            <pc:sldMk cId="1551454966" sldId="419"/>
            <ac:graphicFrameMk id="14" creationId="{4936B1E3-6CC8-4944-870F-DC784E261689}"/>
          </ac:graphicFrameMkLst>
        </pc:graphicFrameChg>
        <pc:picChg chg="add del mod">
          <ac:chgData name="Jorgensen, Rick" userId="22b7bd11-eb0f-413f-9bcb-9ce21ec7b0a8" providerId="ADAL" clId="{63C519A2-C2B2-47AC-828F-E429CD2FEDB2}" dt="2023-07-31T17:40:05.438" v="9395" actId="478"/>
          <ac:picMkLst>
            <pc:docMk/>
            <pc:sldMk cId="1551454966" sldId="419"/>
            <ac:picMk id="7" creationId="{0F3E5807-50BC-BBEF-569A-9137AF5DC553}"/>
          </ac:picMkLst>
        </pc:picChg>
        <pc:cxnChg chg="mod topLvl">
          <ac:chgData name="Jorgensen, Rick" userId="22b7bd11-eb0f-413f-9bcb-9ce21ec7b0a8" providerId="ADAL" clId="{63C519A2-C2B2-47AC-828F-E429CD2FEDB2}" dt="2023-07-31T18:24:12.228" v="9809" actId="1076"/>
          <ac:cxnSpMkLst>
            <pc:docMk/>
            <pc:sldMk cId="1551454966" sldId="419"/>
            <ac:cxnSpMk id="22" creationId="{9D89CD87-22E7-3F67-0AD6-B11D79286539}"/>
          </ac:cxnSpMkLst>
        </pc:cxnChg>
        <pc:cxnChg chg="mod">
          <ac:chgData name="Jorgensen, Rick" userId="22b7bd11-eb0f-413f-9bcb-9ce21ec7b0a8" providerId="ADAL" clId="{63C519A2-C2B2-47AC-828F-E429CD2FEDB2}" dt="2023-07-31T17:47:43.037" v="9503" actId="14100"/>
          <ac:cxnSpMkLst>
            <pc:docMk/>
            <pc:sldMk cId="1551454966" sldId="419"/>
            <ac:cxnSpMk id="28" creationId="{9D3AE35E-D7C6-21DE-01A4-EBAEEDEF4B9A}"/>
          </ac:cxnSpMkLst>
        </pc:cxnChg>
        <pc:cxnChg chg="mod">
          <ac:chgData name="Jorgensen, Rick" userId="22b7bd11-eb0f-413f-9bcb-9ce21ec7b0a8" providerId="ADAL" clId="{63C519A2-C2B2-47AC-828F-E429CD2FEDB2}" dt="2023-07-31T17:48:52.847" v="9514"/>
          <ac:cxnSpMkLst>
            <pc:docMk/>
            <pc:sldMk cId="1551454966" sldId="419"/>
            <ac:cxnSpMk id="39" creationId="{35E49D7C-724B-DB24-5E1F-CBE8880AD31E}"/>
          </ac:cxnSpMkLst>
        </pc:cxnChg>
        <pc:cxnChg chg="mod topLvl">
          <ac:chgData name="Jorgensen, Rick" userId="22b7bd11-eb0f-413f-9bcb-9ce21ec7b0a8" providerId="ADAL" clId="{63C519A2-C2B2-47AC-828F-E429CD2FEDB2}" dt="2023-07-31T18:21:36.532" v="9758" actId="165"/>
          <ac:cxnSpMkLst>
            <pc:docMk/>
            <pc:sldMk cId="1551454966" sldId="419"/>
            <ac:cxnSpMk id="44" creationId="{C0B642FE-BBB8-764F-C259-C15A86DC5DE1}"/>
          </ac:cxnSpMkLst>
        </pc:cxnChg>
        <pc:cxnChg chg="add mod">
          <ac:chgData name="Jorgensen, Rick" userId="22b7bd11-eb0f-413f-9bcb-9ce21ec7b0a8" providerId="ADAL" clId="{63C519A2-C2B2-47AC-828F-E429CD2FEDB2}" dt="2023-07-31T18:17:38.259" v="9614" actId="1076"/>
          <ac:cxnSpMkLst>
            <pc:docMk/>
            <pc:sldMk cId="1551454966" sldId="419"/>
            <ac:cxnSpMk id="47" creationId="{41CF870C-618E-C86D-36B2-57490FC42E41}"/>
          </ac:cxnSpMkLst>
        </pc:cxnChg>
        <pc:cxnChg chg="add mod">
          <ac:chgData name="Jorgensen, Rick" userId="22b7bd11-eb0f-413f-9bcb-9ce21ec7b0a8" providerId="ADAL" clId="{63C519A2-C2B2-47AC-828F-E429CD2FEDB2}" dt="2023-07-31T18:16:52.772" v="9603" actId="1076"/>
          <ac:cxnSpMkLst>
            <pc:docMk/>
            <pc:sldMk cId="1551454966" sldId="419"/>
            <ac:cxnSpMk id="49" creationId="{2EC63D4A-D56C-05F2-F952-D9466476B9B9}"/>
          </ac:cxnSpMkLst>
        </pc:cxnChg>
        <pc:cxnChg chg="add mod">
          <ac:chgData name="Jorgensen, Rick" userId="22b7bd11-eb0f-413f-9bcb-9ce21ec7b0a8" providerId="ADAL" clId="{63C519A2-C2B2-47AC-828F-E429CD2FEDB2}" dt="2023-07-31T18:16:48.948" v="9602" actId="1076"/>
          <ac:cxnSpMkLst>
            <pc:docMk/>
            <pc:sldMk cId="1551454966" sldId="419"/>
            <ac:cxnSpMk id="51" creationId="{F32A2DA8-3CEB-1B7B-3F28-CFCCEE994F48}"/>
          </ac:cxnSpMkLst>
        </pc:cxnChg>
      </pc:sldChg>
      <pc:sldChg chg="modSp add mod">
        <pc:chgData name="Jorgensen, Rick" userId="22b7bd11-eb0f-413f-9bcb-9ce21ec7b0a8" providerId="ADAL" clId="{63C519A2-C2B2-47AC-828F-E429CD2FEDB2}" dt="2023-08-01T16:01:08.854" v="12534"/>
        <pc:sldMkLst>
          <pc:docMk/>
          <pc:sldMk cId="946471094" sldId="420"/>
        </pc:sldMkLst>
        <pc:spChg chg="mod">
          <ac:chgData name="Jorgensen, Rick" userId="22b7bd11-eb0f-413f-9bcb-9ce21ec7b0a8" providerId="ADAL" clId="{63C519A2-C2B2-47AC-828F-E429CD2FEDB2}" dt="2023-08-01T15:59:44.512" v="12476" actId="20577"/>
          <ac:spMkLst>
            <pc:docMk/>
            <pc:sldMk cId="946471094" sldId="420"/>
            <ac:spMk id="2" creationId="{00000000-0000-0000-0000-000000000000}"/>
          </ac:spMkLst>
        </pc:spChg>
        <pc:spChg chg="mod">
          <ac:chgData name="Jorgensen, Rick" userId="22b7bd11-eb0f-413f-9bcb-9ce21ec7b0a8" providerId="ADAL" clId="{63C519A2-C2B2-47AC-828F-E429CD2FEDB2}" dt="2023-08-01T16:01:08.854" v="12534"/>
          <ac:spMkLst>
            <pc:docMk/>
            <pc:sldMk cId="946471094" sldId="420"/>
            <ac:spMk id="3" creationId="{00000000-0000-0000-0000-000000000000}"/>
          </ac:spMkLst>
        </pc:spChg>
      </pc:sldChg>
      <pc:sldChg chg="add del">
        <pc:chgData name="Jorgensen, Rick" userId="22b7bd11-eb0f-413f-9bcb-9ce21ec7b0a8" providerId="ADAL" clId="{63C519A2-C2B2-47AC-828F-E429CD2FEDB2}" dt="2023-07-31T17:50:20.241" v="9538" actId="47"/>
        <pc:sldMkLst>
          <pc:docMk/>
          <pc:sldMk cId="2087508095" sldId="420"/>
        </pc:sldMkLst>
      </pc:sldChg>
      <pc:sldChg chg="add del">
        <pc:chgData name="Jorgensen, Rick" userId="22b7bd11-eb0f-413f-9bcb-9ce21ec7b0a8" providerId="ADAL" clId="{63C519A2-C2B2-47AC-828F-E429CD2FEDB2}" dt="2023-08-01T15:28:28.309" v="11631" actId="47"/>
        <pc:sldMkLst>
          <pc:docMk/>
          <pc:sldMk cId="1133585668" sldId="421"/>
        </pc:sldMkLst>
      </pc:sldChg>
      <pc:sldChg chg="modSp add mod">
        <pc:chgData name="Jorgensen, Rick" userId="22b7bd11-eb0f-413f-9bcb-9ce21ec7b0a8" providerId="ADAL" clId="{63C519A2-C2B2-47AC-828F-E429CD2FEDB2}" dt="2023-08-01T15:39:06.174" v="11990" actId="207"/>
        <pc:sldMkLst>
          <pc:docMk/>
          <pc:sldMk cId="1169520667" sldId="422"/>
        </pc:sldMkLst>
        <pc:spChg chg="mod">
          <ac:chgData name="Jorgensen, Rick" userId="22b7bd11-eb0f-413f-9bcb-9ce21ec7b0a8" providerId="ADAL" clId="{63C519A2-C2B2-47AC-828F-E429CD2FEDB2}" dt="2023-08-01T15:39:06.174" v="11990" actId="207"/>
          <ac:spMkLst>
            <pc:docMk/>
            <pc:sldMk cId="1169520667" sldId="422"/>
            <ac:spMk id="2" creationId="{00000000-0000-0000-0000-000000000000}"/>
          </ac:spMkLst>
        </pc:spChg>
        <pc:spChg chg="mod">
          <ac:chgData name="Jorgensen, Rick" userId="22b7bd11-eb0f-413f-9bcb-9ce21ec7b0a8" providerId="ADAL" clId="{63C519A2-C2B2-47AC-828F-E429CD2FEDB2}" dt="2023-08-01T15:38:59.550" v="11989" actId="20577"/>
          <ac:spMkLst>
            <pc:docMk/>
            <pc:sldMk cId="1169520667" sldId="422"/>
            <ac:spMk id="3" creationId="{00000000-0000-0000-0000-000000000000}"/>
          </ac:spMkLst>
        </pc:spChg>
      </pc:sldChg>
      <pc:sldChg chg="delSp modSp add del mod ord">
        <pc:chgData name="Jorgensen, Rick" userId="22b7bd11-eb0f-413f-9bcb-9ce21ec7b0a8" providerId="ADAL" clId="{63C519A2-C2B2-47AC-828F-E429CD2FEDB2}" dt="2023-08-01T15:30:35.759" v="11675" actId="47"/>
        <pc:sldMkLst>
          <pc:docMk/>
          <pc:sldMk cId="2811338133" sldId="423"/>
        </pc:sldMkLst>
        <pc:spChg chg="mod">
          <ac:chgData name="Jorgensen, Rick" userId="22b7bd11-eb0f-413f-9bcb-9ce21ec7b0a8" providerId="ADAL" clId="{63C519A2-C2B2-47AC-828F-E429CD2FEDB2}" dt="2023-08-01T15:27:56.869" v="11630" actId="1076"/>
          <ac:spMkLst>
            <pc:docMk/>
            <pc:sldMk cId="2811338133" sldId="423"/>
            <ac:spMk id="9" creationId="{16C98FF7-C9E9-8046-A859-D9A599468A34}"/>
          </ac:spMkLst>
        </pc:spChg>
        <pc:spChg chg="mod">
          <ac:chgData name="Jorgensen, Rick" userId="22b7bd11-eb0f-413f-9bcb-9ce21ec7b0a8" providerId="ADAL" clId="{63C519A2-C2B2-47AC-828F-E429CD2FEDB2}" dt="2023-08-01T15:27:56.869" v="11630" actId="1076"/>
          <ac:spMkLst>
            <pc:docMk/>
            <pc:sldMk cId="2811338133" sldId="423"/>
            <ac:spMk id="10" creationId="{9F84E2A2-11BF-6249-A2DF-0BE34D738A76}"/>
          </ac:spMkLst>
        </pc:spChg>
        <pc:spChg chg="mod">
          <ac:chgData name="Jorgensen, Rick" userId="22b7bd11-eb0f-413f-9bcb-9ce21ec7b0a8" providerId="ADAL" clId="{63C519A2-C2B2-47AC-828F-E429CD2FEDB2}" dt="2023-08-01T15:27:56.869" v="11630" actId="1076"/>
          <ac:spMkLst>
            <pc:docMk/>
            <pc:sldMk cId="2811338133" sldId="423"/>
            <ac:spMk id="15" creationId="{D0BC4A18-9D32-73E9-AADD-E9497BF9BADD}"/>
          </ac:spMkLst>
        </pc:spChg>
        <pc:spChg chg="mod">
          <ac:chgData name="Jorgensen, Rick" userId="22b7bd11-eb0f-413f-9bcb-9ce21ec7b0a8" providerId="ADAL" clId="{63C519A2-C2B2-47AC-828F-E429CD2FEDB2}" dt="2023-08-01T15:27:56.869" v="11630" actId="1076"/>
          <ac:spMkLst>
            <pc:docMk/>
            <pc:sldMk cId="2811338133" sldId="423"/>
            <ac:spMk id="17" creationId="{9DF35772-8786-2BDE-86C5-5759E33DDDEE}"/>
          </ac:spMkLst>
        </pc:spChg>
        <pc:spChg chg="mod">
          <ac:chgData name="Jorgensen, Rick" userId="22b7bd11-eb0f-413f-9bcb-9ce21ec7b0a8" providerId="ADAL" clId="{63C519A2-C2B2-47AC-828F-E429CD2FEDB2}" dt="2023-08-01T15:27:56.869" v="11630" actId="1076"/>
          <ac:spMkLst>
            <pc:docMk/>
            <pc:sldMk cId="2811338133" sldId="423"/>
            <ac:spMk id="32" creationId="{4CF0541F-3412-06E7-0866-3D9F5502D1A2}"/>
          </ac:spMkLst>
        </pc:spChg>
        <pc:spChg chg="mod">
          <ac:chgData name="Jorgensen, Rick" userId="22b7bd11-eb0f-413f-9bcb-9ce21ec7b0a8" providerId="ADAL" clId="{63C519A2-C2B2-47AC-828F-E429CD2FEDB2}" dt="2023-08-01T15:27:56.869" v="11630" actId="1076"/>
          <ac:spMkLst>
            <pc:docMk/>
            <pc:sldMk cId="2811338133" sldId="423"/>
            <ac:spMk id="35" creationId="{764319EC-7103-84E4-7E64-529EAD99F69B}"/>
          </ac:spMkLst>
        </pc:spChg>
        <pc:spChg chg="mod">
          <ac:chgData name="Jorgensen, Rick" userId="22b7bd11-eb0f-413f-9bcb-9ce21ec7b0a8" providerId="ADAL" clId="{63C519A2-C2B2-47AC-828F-E429CD2FEDB2}" dt="2023-08-01T15:27:56.869" v="11630" actId="1076"/>
          <ac:spMkLst>
            <pc:docMk/>
            <pc:sldMk cId="2811338133" sldId="423"/>
            <ac:spMk id="36" creationId="{9698F0FB-4FA1-BFFF-3496-88B5DEAA214D}"/>
          </ac:spMkLst>
        </pc:spChg>
        <pc:spChg chg="mod">
          <ac:chgData name="Jorgensen, Rick" userId="22b7bd11-eb0f-413f-9bcb-9ce21ec7b0a8" providerId="ADAL" clId="{63C519A2-C2B2-47AC-828F-E429CD2FEDB2}" dt="2023-08-01T15:27:56.869" v="11630" actId="1076"/>
          <ac:spMkLst>
            <pc:docMk/>
            <pc:sldMk cId="2811338133" sldId="423"/>
            <ac:spMk id="105" creationId="{D441D6E1-A983-A53B-9ADF-4F9118D62180}"/>
          </ac:spMkLst>
        </pc:spChg>
        <pc:spChg chg="mod">
          <ac:chgData name="Jorgensen, Rick" userId="22b7bd11-eb0f-413f-9bcb-9ce21ec7b0a8" providerId="ADAL" clId="{63C519A2-C2B2-47AC-828F-E429CD2FEDB2}" dt="2023-08-01T15:27:56.869" v="11630" actId="1076"/>
          <ac:spMkLst>
            <pc:docMk/>
            <pc:sldMk cId="2811338133" sldId="423"/>
            <ac:spMk id="108" creationId="{AB0B669A-4242-8BF1-2D3A-99138A13C0C4}"/>
          </ac:spMkLst>
        </pc:spChg>
        <pc:picChg chg="mod">
          <ac:chgData name="Jorgensen, Rick" userId="22b7bd11-eb0f-413f-9bcb-9ce21ec7b0a8" providerId="ADAL" clId="{63C519A2-C2B2-47AC-828F-E429CD2FEDB2}" dt="2023-08-01T15:30:02.077" v="11660" actId="1582"/>
          <ac:picMkLst>
            <pc:docMk/>
            <pc:sldMk cId="2811338133" sldId="423"/>
            <ac:picMk id="3" creationId="{12E58C05-3AF1-F43A-3711-E982A1F9928F}"/>
          </ac:picMkLst>
        </pc:picChg>
        <pc:picChg chg="del mod">
          <ac:chgData name="Jorgensen, Rick" userId="22b7bd11-eb0f-413f-9bcb-9ce21ec7b0a8" providerId="ADAL" clId="{63C519A2-C2B2-47AC-828F-E429CD2FEDB2}" dt="2023-08-01T15:30:21.550" v="11668" actId="478"/>
          <ac:picMkLst>
            <pc:docMk/>
            <pc:sldMk cId="2811338133" sldId="423"/>
            <ac:picMk id="5" creationId="{BCC49389-5791-6572-92B9-EBEE2D717F91}"/>
          </ac:picMkLst>
        </pc:picChg>
        <pc:picChg chg="del mod">
          <ac:chgData name="Jorgensen, Rick" userId="22b7bd11-eb0f-413f-9bcb-9ce21ec7b0a8" providerId="ADAL" clId="{63C519A2-C2B2-47AC-828F-E429CD2FEDB2}" dt="2023-08-01T15:30:20.913" v="11667" actId="478"/>
          <ac:picMkLst>
            <pc:docMk/>
            <pc:sldMk cId="2811338133" sldId="423"/>
            <ac:picMk id="7" creationId="{31D08072-D8D0-FB0F-E636-270CEA7CC335}"/>
          </ac:picMkLst>
        </pc:picChg>
        <pc:picChg chg="del mod">
          <ac:chgData name="Jorgensen, Rick" userId="22b7bd11-eb0f-413f-9bcb-9ce21ec7b0a8" providerId="ADAL" clId="{63C519A2-C2B2-47AC-828F-E429CD2FEDB2}" dt="2023-08-01T15:30:16.452" v="11663" actId="478"/>
          <ac:picMkLst>
            <pc:docMk/>
            <pc:sldMk cId="2811338133" sldId="423"/>
            <ac:picMk id="12" creationId="{9AFA4186-28D1-1BE7-AD29-872BCBC6F61B}"/>
          </ac:picMkLst>
        </pc:picChg>
        <pc:picChg chg="del mod">
          <ac:chgData name="Jorgensen, Rick" userId="22b7bd11-eb0f-413f-9bcb-9ce21ec7b0a8" providerId="ADAL" clId="{63C519A2-C2B2-47AC-828F-E429CD2FEDB2}" dt="2023-08-01T15:30:19.609" v="11665" actId="478"/>
          <ac:picMkLst>
            <pc:docMk/>
            <pc:sldMk cId="2811338133" sldId="423"/>
            <ac:picMk id="14" creationId="{032269AD-5D1F-FFFA-EE0C-AC42FF03C7B6}"/>
          </ac:picMkLst>
        </pc:picChg>
        <pc:picChg chg="del mod">
          <ac:chgData name="Jorgensen, Rick" userId="22b7bd11-eb0f-413f-9bcb-9ce21ec7b0a8" providerId="ADAL" clId="{63C519A2-C2B2-47AC-828F-E429CD2FEDB2}" dt="2023-08-01T15:30:20.274" v="11666" actId="478"/>
          <ac:picMkLst>
            <pc:docMk/>
            <pc:sldMk cId="2811338133" sldId="423"/>
            <ac:picMk id="18" creationId="{D41F7070-D792-5867-A7E0-31F323357543}"/>
          </ac:picMkLst>
        </pc:picChg>
        <pc:picChg chg="del mod">
          <ac:chgData name="Jorgensen, Rick" userId="22b7bd11-eb0f-413f-9bcb-9ce21ec7b0a8" providerId="ADAL" clId="{63C519A2-C2B2-47AC-828F-E429CD2FEDB2}" dt="2023-08-01T15:30:18.901" v="11664" actId="478"/>
          <ac:picMkLst>
            <pc:docMk/>
            <pc:sldMk cId="2811338133" sldId="423"/>
            <ac:picMk id="23" creationId="{36418CC3-0C68-71AA-D843-C6A9EC37A89A}"/>
          </ac:picMkLst>
        </pc:picChg>
        <pc:picChg chg="mod">
          <ac:chgData name="Jorgensen, Rick" userId="22b7bd11-eb0f-413f-9bcb-9ce21ec7b0a8" providerId="ADAL" clId="{63C519A2-C2B2-47AC-828F-E429CD2FEDB2}" dt="2023-08-01T15:30:06.493" v="11661" actId="1582"/>
          <ac:picMkLst>
            <pc:docMk/>
            <pc:sldMk cId="2811338133" sldId="423"/>
            <ac:picMk id="26" creationId="{DA719DD5-FB78-ED87-7FE6-722E71E82EA2}"/>
          </ac:picMkLst>
        </pc:picChg>
        <pc:picChg chg="mod">
          <ac:chgData name="Jorgensen, Rick" userId="22b7bd11-eb0f-413f-9bcb-9ce21ec7b0a8" providerId="ADAL" clId="{63C519A2-C2B2-47AC-828F-E429CD2FEDB2}" dt="2023-08-01T15:30:10.498" v="11662" actId="1582"/>
          <ac:picMkLst>
            <pc:docMk/>
            <pc:sldMk cId="2811338133" sldId="423"/>
            <ac:picMk id="28" creationId="{563D0730-CA0B-95DA-FC1B-E0C1CAC055CB}"/>
          </ac:picMkLst>
        </pc:picChg>
      </pc:sldChg>
      <pc:sldChg chg="addSp delSp modSp add mod">
        <pc:chgData name="Jorgensen, Rick" userId="22b7bd11-eb0f-413f-9bcb-9ce21ec7b0a8" providerId="ADAL" clId="{63C519A2-C2B2-47AC-828F-E429CD2FEDB2}" dt="2023-08-01T15:39:29.676" v="11994" actId="207"/>
        <pc:sldMkLst>
          <pc:docMk/>
          <pc:sldMk cId="1781225942" sldId="424"/>
        </pc:sldMkLst>
        <pc:spChg chg="add mod">
          <ac:chgData name="Jorgensen, Rick" userId="22b7bd11-eb0f-413f-9bcb-9ce21ec7b0a8" providerId="ADAL" clId="{63C519A2-C2B2-47AC-828F-E429CD2FEDB2}" dt="2023-08-01T15:32:19.645" v="11716" actId="1076"/>
          <ac:spMkLst>
            <pc:docMk/>
            <pc:sldMk cId="1781225942" sldId="424"/>
            <ac:spMk id="5" creationId="{5F14C65F-9DFA-A4D9-9EFC-D21BDA533DC5}"/>
          </ac:spMkLst>
        </pc:spChg>
        <pc:spChg chg="add mod">
          <ac:chgData name="Jorgensen, Rick" userId="22b7bd11-eb0f-413f-9bcb-9ce21ec7b0a8" providerId="ADAL" clId="{63C519A2-C2B2-47AC-828F-E429CD2FEDB2}" dt="2023-08-01T15:32:14.486" v="11714" actId="1076"/>
          <ac:spMkLst>
            <pc:docMk/>
            <pc:sldMk cId="1781225942" sldId="424"/>
            <ac:spMk id="6" creationId="{516E0B6D-E064-42AD-7036-2957C5EB74C8}"/>
          </ac:spMkLst>
        </pc:spChg>
        <pc:spChg chg="mod">
          <ac:chgData name="Jorgensen, Rick" userId="22b7bd11-eb0f-413f-9bcb-9ce21ec7b0a8" providerId="ADAL" clId="{63C519A2-C2B2-47AC-828F-E429CD2FEDB2}" dt="2023-08-01T15:32:07.877" v="11712" actId="1076"/>
          <ac:spMkLst>
            <pc:docMk/>
            <pc:sldMk cId="1781225942" sldId="424"/>
            <ac:spMk id="9" creationId="{16C98FF7-C9E9-8046-A859-D9A599468A34}"/>
          </ac:spMkLst>
        </pc:spChg>
        <pc:spChg chg="mod">
          <ac:chgData name="Jorgensen, Rick" userId="22b7bd11-eb0f-413f-9bcb-9ce21ec7b0a8" providerId="ADAL" clId="{63C519A2-C2B2-47AC-828F-E429CD2FEDB2}" dt="2023-08-01T15:39:26.759" v="11993" actId="1076"/>
          <ac:spMkLst>
            <pc:docMk/>
            <pc:sldMk cId="1781225942" sldId="424"/>
            <ac:spMk id="10" creationId="{9F84E2A2-11BF-6249-A2DF-0BE34D738A76}"/>
          </ac:spMkLst>
        </pc:spChg>
        <pc:spChg chg="del">
          <ac:chgData name="Jorgensen, Rick" userId="22b7bd11-eb0f-413f-9bcb-9ce21ec7b0a8" providerId="ADAL" clId="{63C519A2-C2B2-47AC-828F-E429CD2FEDB2}" dt="2023-08-01T15:31:41.313" v="11708" actId="478"/>
          <ac:spMkLst>
            <pc:docMk/>
            <pc:sldMk cId="1781225942" sldId="424"/>
            <ac:spMk id="15" creationId="{D0BC4A18-9D32-73E9-AADD-E9497BF9BADD}"/>
          </ac:spMkLst>
        </pc:spChg>
        <pc:spChg chg="del mod">
          <ac:chgData name="Jorgensen, Rick" userId="22b7bd11-eb0f-413f-9bcb-9ce21ec7b0a8" providerId="ADAL" clId="{63C519A2-C2B2-47AC-828F-E429CD2FEDB2}" dt="2023-08-01T15:31:37.657" v="11705" actId="478"/>
          <ac:spMkLst>
            <pc:docMk/>
            <pc:sldMk cId="1781225942" sldId="424"/>
            <ac:spMk id="17" creationId="{9DF35772-8786-2BDE-86C5-5759E33DDDEE}"/>
          </ac:spMkLst>
        </pc:spChg>
        <pc:spChg chg="mod">
          <ac:chgData name="Jorgensen, Rick" userId="22b7bd11-eb0f-413f-9bcb-9ce21ec7b0a8" providerId="ADAL" clId="{63C519A2-C2B2-47AC-828F-E429CD2FEDB2}" dt="2023-08-01T15:39:29.676" v="11994" actId="207"/>
          <ac:spMkLst>
            <pc:docMk/>
            <pc:sldMk cId="1781225942" sldId="424"/>
            <ac:spMk id="25" creationId="{43DF711F-4684-B34D-9236-D3A26D348F11}"/>
          </ac:spMkLst>
        </pc:spChg>
        <pc:spChg chg="del mod">
          <ac:chgData name="Jorgensen, Rick" userId="22b7bd11-eb0f-413f-9bcb-9ce21ec7b0a8" providerId="ADAL" clId="{63C519A2-C2B2-47AC-828F-E429CD2FEDB2}" dt="2023-08-01T15:31:38.785" v="11706" actId="478"/>
          <ac:spMkLst>
            <pc:docMk/>
            <pc:sldMk cId="1781225942" sldId="424"/>
            <ac:spMk id="32" creationId="{4CF0541F-3412-06E7-0866-3D9F5502D1A2}"/>
          </ac:spMkLst>
        </pc:spChg>
        <pc:spChg chg="del mod">
          <ac:chgData name="Jorgensen, Rick" userId="22b7bd11-eb0f-413f-9bcb-9ce21ec7b0a8" providerId="ADAL" clId="{63C519A2-C2B2-47AC-828F-E429CD2FEDB2}" dt="2023-08-01T15:31:39.998" v="11707" actId="478"/>
          <ac:spMkLst>
            <pc:docMk/>
            <pc:sldMk cId="1781225942" sldId="424"/>
            <ac:spMk id="35" creationId="{764319EC-7103-84E4-7E64-529EAD99F69B}"/>
          </ac:spMkLst>
        </pc:spChg>
        <pc:spChg chg="del">
          <ac:chgData name="Jorgensen, Rick" userId="22b7bd11-eb0f-413f-9bcb-9ce21ec7b0a8" providerId="ADAL" clId="{63C519A2-C2B2-47AC-828F-E429CD2FEDB2}" dt="2023-08-01T15:29:16.056" v="11655" actId="478"/>
          <ac:spMkLst>
            <pc:docMk/>
            <pc:sldMk cId="1781225942" sldId="424"/>
            <ac:spMk id="36" creationId="{9698F0FB-4FA1-BFFF-3496-88B5DEAA214D}"/>
          </ac:spMkLst>
        </pc:spChg>
        <pc:spChg chg="del">
          <ac:chgData name="Jorgensen, Rick" userId="22b7bd11-eb0f-413f-9bcb-9ce21ec7b0a8" providerId="ADAL" clId="{63C519A2-C2B2-47AC-828F-E429CD2FEDB2}" dt="2023-08-01T15:29:16.056" v="11655" actId="478"/>
          <ac:spMkLst>
            <pc:docMk/>
            <pc:sldMk cId="1781225942" sldId="424"/>
            <ac:spMk id="105" creationId="{D441D6E1-A983-A53B-9ADF-4F9118D62180}"/>
          </ac:spMkLst>
        </pc:spChg>
        <pc:spChg chg="del">
          <ac:chgData name="Jorgensen, Rick" userId="22b7bd11-eb0f-413f-9bcb-9ce21ec7b0a8" providerId="ADAL" clId="{63C519A2-C2B2-47AC-828F-E429CD2FEDB2}" dt="2023-08-01T15:29:16.056" v="11655" actId="478"/>
          <ac:spMkLst>
            <pc:docMk/>
            <pc:sldMk cId="1781225942" sldId="424"/>
            <ac:spMk id="108" creationId="{AB0B669A-4242-8BF1-2D3A-99138A13C0C4}"/>
          </ac:spMkLst>
        </pc:spChg>
        <pc:picChg chg="add mod">
          <ac:chgData name="Jorgensen, Rick" userId="22b7bd11-eb0f-413f-9bcb-9ce21ec7b0a8" providerId="ADAL" clId="{63C519A2-C2B2-47AC-828F-E429CD2FEDB2}" dt="2023-08-01T15:32:07.877" v="11712" actId="1076"/>
          <ac:picMkLst>
            <pc:docMk/>
            <pc:sldMk cId="1781225942" sldId="424"/>
            <ac:picMk id="2" creationId="{0FE050AE-B11D-8896-DEC1-30985EB0CA79}"/>
          </ac:picMkLst>
        </pc:picChg>
        <pc:picChg chg="add mod">
          <ac:chgData name="Jorgensen, Rick" userId="22b7bd11-eb0f-413f-9bcb-9ce21ec7b0a8" providerId="ADAL" clId="{63C519A2-C2B2-47AC-828F-E429CD2FEDB2}" dt="2023-08-01T15:32:07.877" v="11712" actId="1076"/>
          <ac:picMkLst>
            <pc:docMk/>
            <pc:sldMk cId="1781225942" sldId="424"/>
            <ac:picMk id="3" creationId="{9C51E4C6-2D00-DBC0-4433-BE48D6899817}"/>
          </ac:picMkLst>
        </pc:picChg>
        <pc:picChg chg="add mod">
          <ac:chgData name="Jorgensen, Rick" userId="22b7bd11-eb0f-413f-9bcb-9ce21ec7b0a8" providerId="ADAL" clId="{63C519A2-C2B2-47AC-828F-E429CD2FEDB2}" dt="2023-08-01T15:39:16.291" v="11992" actId="1076"/>
          <ac:picMkLst>
            <pc:docMk/>
            <pc:sldMk cId="1781225942" sldId="424"/>
            <ac:picMk id="4" creationId="{20950D87-1661-52AD-ED57-D1C1AD73D31F}"/>
          </ac:picMkLst>
        </pc:picChg>
        <pc:picChg chg="del">
          <ac:chgData name="Jorgensen, Rick" userId="22b7bd11-eb0f-413f-9bcb-9ce21ec7b0a8" providerId="ADAL" clId="{63C519A2-C2B2-47AC-828F-E429CD2FEDB2}" dt="2023-08-01T15:29:10.365" v="11651" actId="478"/>
          <ac:picMkLst>
            <pc:docMk/>
            <pc:sldMk cId="1781225942" sldId="424"/>
            <ac:picMk id="88" creationId="{67262DE4-1CAF-B8F0-3DF8-656909E6E9C3}"/>
          </ac:picMkLst>
        </pc:picChg>
        <pc:picChg chg="mod">
          <ac:chgData name="Jorgensen, Rick" userId="22b7bd11-eb0f-413f-9bcb-9ce21ec7b0a8" providerId="ADAL" clId="{63C519A2-C2B2-47AC-828F-E429CD2FEDB2}" dt="2023-08-01T15:32:07.877" v="11712" actId="1076"/>
          <ac:picMkLst>
            <pc:docMk/>
            <pc:sldMk cId="1781225942" sldId="424"/>
            <ac:picMk id="90" creationId="{4C5BBF87-2E7A-B6B7-553B-26F213832CAE}"/>
          </ac:picMkLst>
        </pc:picChg>
        <pc:picChg chg="del">
          <ac:chgData name="Jorgensen, Rick" userId="22b7bd11-eb0f-413f-9bcb-9ce21ec7b0a8" providerId="ADAL" clId="{63C519A2-C2B2-47AC-828F-E429CD2FEDB2}" dt="2023-08-01T15:29:10.828" v="11652" actId="478"/>
          <ac:picMkLst>
            <pc:docMk/>
            <pc:sldMk cId="1781225942" sldId="424"/>
            <ac:picMk id="92" creationId="{0ECF3F55-E9CA-2D1D-A76F-BF0EA6422FA7}"/>
          </ac:picMkLst>
        </pc:picChg>
        <pc:picChg chg="del">
          <ac:chgData name="Jorgensen, Rick" userId="22b7bd11-eb0f-413f-9bcb-9ce21ec7b0a8" providerId="ADAL" clId="{63C519A2-C2B2-47AC-828F-E429CD2FEDB2}" dt="2023-08-01T15:29:07.955" v="11648" actId="478"/>
          <ac:picMkLst>
            <pc:docMk/>
            <pc:sldMk cId="1781225942" sldId="424"/>
            <ac:picMk id="96" creationId="{0DF7A5C5-4221-18F9-BF8C-5F78BCF059AF}"/>
          </ac:picMkLst>
        </pc:picChg>
        <pc:picChg chg="del">
          <ac:chgData name="Jorgensen, Rick" userId="22b7bd11-eb0f-413f-9bcb-9ce21ec7b0a8" providerId="ADAL" clId="{63C519A2-C2B2-47AC-828F-E429CD2FEDB2}" dt="2023-08-01T15:29:07.195" v="11647" actId="478"/>
          <ac:picMkLst>
            <pc:docMk/>
            <pc:sldMk cId="1781225942" sldId="424"/>
            <ac:picMk id="98" creationId="{BDF343AA-E9D4-AFFE-27C9-B79C39FDCB85}"/>
          </ac:picMkLst>
        </pc:picChg>
        <pc:picChg chg="del">
          <ac:chgData name="Jorgensen, Rick" userId="22b7bd11-eb0f-413f-9bcb-9ce21ec7b0a8" providerId="ADAL" clId="{63C519A2-C2B2-47AC-828F-E429CD2FEDB2}" dt="2023-08-01T15:29:08.447" v="11649" actId="478"/>
          <ac:picMkLst>
            <pc:docMk/>
            <pc:sldMk cId="1781225942" sldId="424"/>
            <ac:picMk id="100" creationId="{662601E4-F6B4-44B7-63C4-5BFF23596B2A}"/>
          </ac:picMkLst>
        </pc:picChg>
        <pc:picChg chg="mod">
          <ac:chgData name="Jorgensen, Rick" userId="22b7bd11-eb0f-413f-9bcb-9ce21ec7b0a8" providerId="ADAL" clId="{63C519A2-C2B2-47AC-828F-E429CD2FEDB2}" dt="2023-08-01T15:32:07.877" v="11712" actId="1076"/>
          <ac:picMkLst>
            <pc:docMk/>
            <pc:sldMk cId="1781225942" sldId="424"/>
            <ac:picMk id="102" creationId="{B23D2D46-5729-78AB-69A0-765DE47B96D4}"/>
          </ac:picMkLst>
        </pc:picChg>
        <pc:picChg chg="mod">
          <ac:chgData name="Jorgensen, Rick" userId="22b7bd11-eb0f-413f-9bcb-9ce21ec7b0a8" providerId="ADAL" clId="{63C519A2-C2B2-47AC-828F-E429CD2FEDB2}" dt="2023-08-01T15:39:13.972" v="11991" actId="1076"/>
          <ac:picMkLst>
            <pc:docMk/>
            <pc:sldMk cId="1781225942" sldId="424"/>
            <ac:picMk id="104" creationId="{59E53313-CD33-C522-0C5A-C40772E2886E}"/>
          </ac:picMkLst>
        </pc:picChg>
        <pc:picChg chg="del">
          <ac:chgData name="Jorgensen, Rick" userId="22b7bd11-eb0f-413f-9bcb-9ce21ec7b0a8" providerId="ADAL" clId="{63C519A2-C2B2-47AC-828F-E429CD2FEDB2}" dt="2023-08-01T15:29:09.203" v="11650" actId="478"/>
          <ac:picMkLst>
            <pc:docMk/>
            <pc:sldMk cId="1781225942" sldId="424"/>
            <ac:picMk id="107" creationId="{02C06F37-38B6-78A9-5CC2-5FCEC31D8BCD}"/>
          </ac:picMkLst>
        </pc:picChg>
      </pc:sldChg>
      <pc:sldChg chg="add ord">
        <pc:chgData name="Jorgensen, Rick" userId="22b7bd11-eb0f-413f-9bcb-9ce21ec7b0a8" providerId="ADAL" clId="{63C519A2-C2B2-47AC-828F-E429CD2FEDB2}" dt="2023-08-01T15:32:39.036" v="11723"/>
        <pc:sldMkLst>
          <pc:docMk/>
          <pc:sldMk cId="2024394527" sldId="425"/>
        </pc:sldMkLst>
      </pc:sldChg>
      <pc:sldChg chg="add ord">
        <pc:chgData name="Jorgensen, Rick" userId="22b7bd11-eb0f-413f-9bcb-9ce21ec7b0a8" providerId="ADAL" clId="{63C519A2-C2B2-47AC-828F-E429CD2FEDB2}" dt="2023-08-01T15:32:39.036" v="11723"/>
        <pc:sldMkLst>
          <pc:docMk/>
          <pc:sldMk cId="2703005835" sldId="426"/>
        </pc:sldMkLst>
      </pc:sldChg>
      <pc:sldChg chg="add ord">
        <pc:chgData name="Jorgensen, Rick" userId="22b7bd11-eb0f-413f-9bcb-9ce21ec7b0a8" providerId="ADAL" clId="{63C519A2-C2B2-47AC-828F-E429CD2FEDB2}" dt="2023-08-01T15:41:43.295" v="12002"/>
        <pc:sldMkLst>
          <pc:docMk/>
          <pc:sldMk cId="3028790565" sldId="427"/>
        </pc:sldMkLst>
      </pc:sldChg>
      <pc:sldChg chg="modSp add mod">
        <pc:chgData name="Jorgensen, Rick" userId="22b7bd11-eb0f-413f-9bcb-9ce21ec7b0a8" providerId="ADAL" clId="{63C519A2-C2B2-47AC-828F-E429CD2FEDB2}" dt="2023-08-01T15:56:23.236" v="12241" actId="20577"/>
        <pc:sldMkLst>
          <pc:docMk/>
          <pc:sldMk cId="2795450968" sldId="428"/>
        </pc:sldMkLst>
        <pc:spChg chg="mod">
          <ac:chgData name="Jorgensen, Rick" userId="22b7bd11-eb0f-413f-9bcb-9ce21ec7b0a8" providerId="ADAL" clId="{63C519A2-C2B2-47AC-828F-E429CD2FEDB2}" dt="2023-08-01T15:56:23.236" v="12241" actId="20577"/>
          <ac:spMkLst>
            <pc:docMk/>
            <pc:sldMk cId="2795450968" sldId="428"/>
            <ac:spMk id="2" creationId="{00000000-0000-0000-0000-000000000000}"/>
          </ac:spMkLst>
        </pc:spChg>
      </pc:sldChg>
    </pc:docChg>
  </pc:docChgLst>
  <pc:docChgLst>
    <pc:chgData name="Jorgensen, Rick" userId="22b7bd11-eb0f-413f-9bcb-9ce21ec7b0a8" providerId="ADAL" clId="{24926DDF-822A-4EF4-AAA6-9954AC421AC4}"/>
    <pc:docChg chg="delSld">
      <pc:chgData name="Jorgensen, Rick" userId="22b7bd11-eb0f-413f-9bcb-9ce21ec7b0a8" providerId="ADAL" clId="{24926DDF-822A-4EF4-AAA6-9954AC421AC4}" dt="2023-08-10T16:22:34.975" v="18" actId="47"/>
      <pc:docMkLst>
        <pc:docMk/>
      </pc:docMkLst>
      <pc:sldChg chg="del">
        <pc:chgData name="Jorgensen, Rick" userId="22b7bd11-eb0f-413f-9bcb-9ce21ec7b0a8" providerId="ADAL" clId="{24926DDF-822A-4EF4-AAA6-9954AC421AC4}" dt="2023-08-10T16:22:32.243" v="7" actId="47"/>
        <pc:sldMkLst>
          <pc:docMk/>
          <pc:sldMk cId="1787906480" sldId="329"/>
        </pc:sldMkLst>
      </pc:sldChg>
      <pc:sldChg chg="del">
        <pc:chgData name="Jorgensen, Rick" userId="22b7bd11-eb0f-413f-9bcb-9ce21ec7b0a8" providerId="ADAL" clId="{24926DDF-822A-4EF4-AAA6-9954AC421AC4}" dt="2023-08-10T16:22:32.418" v="8" actId="47"/>
        <pc:sldMkLst>
          <pc:docMk/>
          <pc:sldMk cId="913073503" sldId="330"/>
        </pc:sldMkLst>
      </pc:sldChg>
      <pc:sldChg chg="del">
        <pc:chgData name="Jorgensen, Rick" userId="22b7bd11-eb0f-413f-9bcb-9ce21ec7b0a8" providerId="ADAL" clId="{24926DDF-822A-4EF4-AAA6-9954AC421AC4}" dt="2023-08-10T16:22:32.994" v="11" actId="47"/>
        <pc:sldMkLst>
          <pc:docMk/>
          <pc:sldMk cId="400082519" sldId="332"/>
        </pc:sldMkLst>
      </pc:sldChg>
      <pc:sldChg chg="del">
        <pc:chgData name="Jorgensen, Rick" userId="22b7bd11-eb0f-413f-9bcb-9ce21ec7b0a8" providerId="ADAL" clId="{24926DDF-822A-4EF4-AAA6-9954AC421AC4}" dt="2023-08-10T16:22:33.213" v="12" actId="47"/>
        <pc:sldMkLst>
          <pc:docMk/>
          <pc:sldMk cId="1044495293" sldId="333"/>
        </pc:sldMkLst>
      </pc:sldChg>
      <pc:sldChg chg="del">
        <pc:chgData name="Jorgensen, Rick" userId="22b7bd11-eb0f-413f-9bcb-9ce21ec7b0a8" providerId="ADAL" clId="{24926DDF-822A-4EF4-AAA6-9954AC421AC4}" dt="2023-08-10T16:22:33.449" v="13" actId="47"/>
        <pc:sldMkLst>
          <pc:docMk/>
          <pc:sldMk cId="2379362570" sldId="336"/>
        </pc:sldMkLst>
      </pc:sldChg>
      <pc:sldChg chg="del">
        <pc:chgData name="Jorgensen, Rick" userId="22b7bd11-eb0f-413f-9bcb-9ce21ec7b0a8" providerId="ADAL" clId="{24926DDF-822A-4EF4-AAA6-9954AC421AC4}" dt="2023-08-10T16:22:33.638" v="14" actId="47"/>
        <pc:sldMkLst>
          <pc:docMk/>
          <pc:sldMk cId="4068842680" sldId="337"/>
        </pc:sldMkLst>
      </pc:sldChg>
      <pc:sldChg chg="del">
        <pc:chgData name="Jorgensen, Rick" userId="22b7bd11-eb0f-413f-9bcb-9ce21ec7b0a8" providerId="ADAL" clId="{24926DDF-822A-4EF4-AAA6-9954AC421AC4}" dt="2023-08-10T16:22:31.170" v="1" actId="47"/>
        <pc:sldMkLst>
          <pc:docMk/>
          <pc:sldMk cId="4233420906" sldId="371"/>
        </pc:sldMkLst>
      </pc:sldChg>
      <pc:sldChg chg="del">
        <pc:chgData name="Jorgensen, Rick" userId="22b7bd11-eb0f-413f-9bcb-9ce21ec7b0a8" providerId="ADAL" clId="{24926DDF-822A-4EF4-AAA6-9954AC421AC4}" dt="2023-08-10T16:22:31.555" v="3" actId="47"/>
        <pc:sldMkLst>
          <pc:docMk/>
          <pc:sldMk cId="4070891446" sldId="377"/>
        </pc:sldMkLst>
      </pc:sldChg>
      <pc:sldChg chg="del">
        <pc:chgData name="Jorgensen, Rick" userId="22b7bd11-eb0f-413f-9bcb-9ce21ec7b0a8" providerId="ADAL" clId="{24926DDF-822A-4EF4-AAA6-9954AC421AC4}" dt="2023-08-10T16:22:31.710" v="4" actId="47"/>
        <pc:sldMkLst>
          <pc:docMk/>
          <pc:sldMk cId="3740473727" sldId="378"/>
        </pc:sldMkLst>
      </pc:sldChg>
      <pc:sldChg chg="del">
        <pc:chgData name="Jorgensen, Rick" userId="22b7bd11-eb0f-413f-9bcb-9ce21ec7b0a8" providerId="ADAL" clId="{24926DDF-822A-4EF4-AAA6-9954AC421AC4}" dt="2023-08-10T16:22:33.835" v="15" actId="47"/>
        <pc:sldMkLst>
          <pc:docMk/>
          <pc:sldMk cId="4180539983" sldId="381"/>
        </pc:sldMkLst>
      </pc:sldChg>
      <pc:sldChg chg="del">
        <pc:chgData name="Jorgensen, Rick" userId="22b7bd11-eb0f-413f-9bcb-9ce21ec7b0a8" providerId="ADAL" clId="{24926DDF-822A-4EF4-AAA6-9954AC421AC4}" dt="2023-08-10T16:22:30.633" v="0" actId="47"/>
        <pc:sldMkLst>
          <pc:docMk/>
          <pc:sldMk cId="1669493757" sldId="401"/>
        </pc:sldMkLst>
      </pc:sldChg>
      <pc:sldChg chg="del">
        <pc:chgData name="Jorgensen, Rick" userId="22b7bd11-eb0f-413f-9bcb-9ce21ec7b0a8" providerId="ADAL" clId="{24926DDF-822A-4EF4-AAA6-9954AC421AC4}" dt="2023-08-10T16:22:31.883" v="5" actId="47"/>
        <pc:sldMkLst>
          <pc:docMk/>
          <pc:sldMk cId="329471573" sldId="402"/>
        </pc:sldMkLst>
      </pc:sldChg>
      <pc:sldChg chg="del">
        <pc:chgData name="Jorgensen, Rick" userId="22b7bd11-eb0f-413f-9bcb-9ce21ec7b0a8" providerId="ADAL" clId="{24926DDF-822A-4EF4-AAA6-9954AC421AC4}" dt="2023-08-10T16:22:32.617" v="9" actId="47"/>
        <pc:sldMkLst>
          <pc:docMk/>
          <pc:sldMk cId="1498640041" sldId="403"/>
        </pc:sldMkLst>
      </pc:sldChg>
      <pc:sldChg chg="del">
        <pc:chgData name="Jorgensen, Rick" userId="22b7bd11-eb0f-413f-9bcb-9ce21ec7b0a8" providerId="ADAL" clId="{24926DDF-822A-4EF4-AAA6-9954AC421AC4}" dt="2023-08-10T16:22:34.018" v="16" actId="47"/>
        <pc:sldMkLst>
          <pc:docMk/>
          <pc:sldMk cId="969353579" sldId="411"/>
        </pc:sldMkLst>
      </pc:sldChg>
      <pc:sldChg chg="del">
        <pc:chgData name="Jorgensen, Rick" userId="22b7bd11-eb0f-413f-9bcb-9ce21ec7b0a8" providerId="ADAL" clId="{24926DDF-822A-4EF4-AAA6-9954AC421AC4}" dt="2023-08-10T16:22:34.219" v="17" actId="47"/>
        <pc:sldMkLst>
          <pc:docMk/>
          <pc:sldMk cId="2783075774" sldId="412"/>
        </pc:sldMkLst>
      </pc:sldChg>
      <pc:sldChg chg="del">
        <pc:chgData name="Jorgensen, Rick" userId="22b7bd11-eb0f-413f-9bcb-9ce21ec7b0a8" providerId="ADAL" clId="{24926DDF-822A-4EF4-AAA6-9954AC421AC4}" dt="2023-08-10T16:22:31.384" v="2" actId="47"/>
        <pc:sldMkLst>
          <pc:docMk/>
          <pc:sldMk cId="2657217629" sldId="413"/>
        </pc:sldMkLst>
      </pc:sldChg>
      <pc:sldChg chg="del">
        <pc:chgData name="Jorgensen, Rick" userId="22b7bd11-eb0f-413f-9bcb-9ce21ec7b0a8" providerId="ADAL" clId="{24926DDF-822A-4EF4-AAA6-9954AC421AC4}" dt="2023-08-10T16:22:32.081" v="6" actId="47"/>
        <pc:sldMkLst>
          <pc:docMk/>
          <pc:sldMk cId="1709919940" sldId="414"/>
        </pc:sldMkLst>
      </pc:sldChg>
      <pc:sldChg chg="del">
        <pc:chgData name="Jorgensen, Rick" userId="22b7bd11-eb0f-413f-9bcb-9ce21ec7b0a8" providerId="ADAL" clId="{24926DDF-822A-4EF4-AAA6-9954AC421AC4}" dt="2023-08-10T16:22:32.791" v="10" actId="47"/>
        <pc:sldMkLst>
          <pc:docMk/>
          <pc:sldMk cId="4212414396" sldId="415"/>
        </pc:sldMkLst>
      </pc:sldChg>
      <pc:sldChg chg="del">
        <pc:chgData name="Jorgensen, Rick" userId="22b7bd11-eb0f-413f-9bcb-9ce21ec7b0a8" providerId="ADAL" clId="{24926DDF-822A-4EF4-AAA6-9954AC421AC4}" dt="2023-08-10T16:22:34.975" v="18" actId="47"/>
        <pc:sldMkLst>
          <pc:docMk/>
          <pc:sldMk cId="2623063376" sldId="416"/>
        </pc:sldMkLst>
      </pc:sldChg>
    </pc:docChg>
  </pc:docChgLst>
  <pc:docChgLst>
    <pc:chgData name="Jorgensen, Rick" userId="22b7bd11-eb0f-413f-9bcb-9ce21ec7b0a8" providerId="ADAL" clId="{0566973D-188F-4C4C-9526-C2D46DEF99FC}"/>
    <pc:docChg chg="undo custSel addSld delSld modSld sldOrd">
      <pc:chgData name="Jorgensen, Rick" userId="22b7bd11-eb0f-413f-9bcb-9ce21ec7b0a8" providerId="ADAL" clId="{0566973D-188F-4C4C-9526-C2D46DEF99FC}" dt="2023-08-03T20:37:30.184" v="1795" actId="20577"/>
      <pc:docMkLst>
        <pc:docMk/>
      </pc:docMkLst>
      <pc:sldChg chg="del">
        <pc:chgData name="Jorgensen, Rick" userId="22b7bd11-eb0f-413f-9bcb-9ce21ec7b0a8" providerId="ADAL" clId="{0566973D-188F-4C4C-9526-C2D46DEF99FC}" dt="2023-08-01T17:41:59.946" v="23" actId="47"/>
        <pc:sldMkLst>
          <pc:docMk/>
          <pc:sldMk cId="3228758306" sldId="313"/>
        </pc:sldMkLst>
      </pc:sldChg>
      <pc:sldChg chg="del">
        <pc:chgData name="Jorgensen, Rick" userId="22b7bd11-eb0f-413f-9bcb-9ce21ec7b0a8" providerId="ADAL" clId="{0566973D-188F-4C4C-9526-C2D46DEF99FC}" dt="2023-08-01T17:41:59.151" v="19" actId="47"/>
        <pc:sldMkLst>
          <pc:docMk/>
          <pc:sldMk cId="2030081462" sldId="321"/>
        </pc:sldMkLst>
      </pc:sldChg>
      <pc:sldChg chg="addSp delSp modSp mod">
        <pc:chgData name="Jorgensen, Rick" userId="22b7bd11-eb0f-413f-9bcb-9ce21ec7b0a8" providerId="ADAL" clId="{0566973D-188F-4C4C-9526-C2D46DEF99FC}" dt="2023-08-03T19:12:24.561" v="1032" actId="20577"/>
        <pc:sldMkLst>
          <pc:docMk/>
          <pc:sldMk cId="1787906480" sldId="329"/>
        </pc:sldMkLst>
        <pc:spChg chg="mod">
          <ac:chgData name="Jorgensen, Rick" userId="22b7bd11-eb0f-413f-9bcb-9ce21ec7b0a8" providerId="ADAL" clId="{0566973D-188F-4C4C-9526-C2D46DEF99FC}" dt="2023-08-01T20:03:07.704" v="273" actId="207"/>
          <ac:spMkLst>
            <pc:docMk/>
            <pc:sldMk cId="1787906480" sldId="329"/>
            <ac:spMk id="2" creationId="{C9880D3B-B374-2310-4B7A-8663C682C20E}"/>
          </ac:spMkLst>
        </pc:spChg>
        <pc:spChg chg="add mod">
          <ac:chgData name="Jorgensen, Rick" userId="22b7bd11-eb0f-413f-9bcb-9ce21ec7b0a8" providerId="ADAL" clId="{0566973D-188F-4C4C-9526-C2D46DEF99FC}" dt="2023-08-01T19:55:48.677" v="187" actId="1076"/>
          <ac:spMkLst>
            <pc:docMk/>
            <pc:sldMk cId="1787906480" sldId="329"/>
            <ac:spMk id="7" creationId="{3093F3B9-A1CB-B38A-E7F9-198C7E5BCC08}"/>
          </ac:spMkLst>
        </pc:spChg>
        <pc:spChg chg="del mod">
          <ac:chgData name="Jorgensen, Rick" userId="22b7bd11-eb0f-413f-9bcb-9ce21ec7b0a8" providerId="ADAL" clId="{0566973D-188F-4C4C-9526-C2D46DEF99FC}" dt="2023-08-01T17:52:52.251" v="85" actId="478"/>
          <ac:spMkLst>
            <pc:docMk/>
            <pc:sldMk cId="1787906480" sldId="329"/>
            <ac:spMk id="11" creationId="{99578930-C130-A573-FBA3-1825193E1906}"/>
          </ac:spMkLst>
        </pc:spChg>
        <pc:spChg chg="mod">
          <ac:chgData name="Jorgensen, Rick" userId="22b7bd11-eb0f-413f-9bcb-9ce21ec7b0a8" providerId="ADAL" clId="{0566973D-188F-4C4C-9526-C2D46DEF99FC}" dt="2023-08-01T19:55:39.218" v="184" actId="1076"/>
          <ac:spMkLst>
            <pc:docMk/>
            <pc:sldMk cId="1787906480" sldId="329"/>
            <ac:spMk id="12" creationId="{50C074E6-7201-EA4D-A079-DB7A9FBB333F}"/>
          </ac:spMkLst>
        </pc:spChg>
        <pc:spChg chg="mod">
          <ac:chgData name="Jorgensen, Rick" userId="22b7bd11-eb0f-413f-9bcb-9ce21ec7b0a8" providerId="ADAL" clId="{0566973D-188F-4C4C-9526-C2D46DEF99FC}" dt="2023-08-01T20:03:04.120" v="272" actId="207"/>
          <ac:spMkLst>
            <pc:docMk/>
            <pc:sldMk cId="1787906480" sldId="329"/>
            <ac:spMk id="25" creationId="{43DF711F-4684-B34D-9236-D3A26D348F11}"/>
          </ac:spMkLst>
        </pc:spChg>
        <pc:graphicFrameChg chg="del">
          <ac:chgData name="Jorgensen, Rick" userId="22b7bd11-eb0f-413f-9bcb-9ce21ec7b0a8" providerId="ADAL" clId="{0566973D-188F-4C4C-9526-C2D46DEF99FC}" dt="2023-08-01T17:51:36.343" v="75" actId="478"/>
          <ac:graphicFrameMkLst>
            <pc:docMk/>
            <pc:sldMk cId="1787906480" sldId="329"/>
            <ac:graphicFrameMk id="3" creationId="{00000000-0008-0000-0500-000038000000}"/>
          </ac:graphicFrameMkLst>
        </pc:graphicFrameChg>
        <pc:graphicFrameChg chg="add del mod ord">
          <ac:chgData name="Jorgensen, Rick" userId="22b7bd11-eb0f-413f-9bcb-9ce21ec7b0a8" providerId="ADAL" clId="{0566973D-188F-4C4C-9526-C2D46DEF99FC}" dt="2023-08-01T17:52:46.207" v="81" actId="478"/>
          <ac:graphicFrameMkLst>
            <pc:docMk/>
            <pc:sldMk cId="1787906480" sldId="329"/>
            <ac:graphicFrameMk id="4" creationId="{00000000-0008-0000-0500-000038000000}"/>
          </ac:graphicFrameMkLst>
        </pc:graphicFrameChg>
        <pc:graphicFrameChg chg="add mod">
          <ac:chgData name="Jorgensen, Rick" userId="22b7bd11-eb0f-413f-9bcb-9ce21ec7b0a8" providerId="ADAL" clId="{0566973D-188F-4C4C-9526-C2D46DEF99FC}" dt="2023-08-01T19:55:39.218" v="184" actId="1076"/>
          <ac:graphicFrameMkLst>
            <pc:docMk/>
            <pc:sldMk cId="1787906480" sldId="329"/>
            <ac:graphicFrameMk id="6" creationId="{00000000-0008-0000-0500-000038000000}"/>
          </ac:graphicFrameMkLst>
        </pc:graphicFrameChg>
        <pc:graphicFrameChg chg="add mod">
          <ac:chgData name="Jorgensen, Rick" userId="22b7bd11-eb0f-413f-9bcb-9ce21ec7b0a8" providerId="ADAL" clId="{0566973D-188F-4C4C-9526-C2D46DEF99FC}" dt="2023-08-03T19:12:24.561" v="1032" actId="20577"/>
          <ac:graphicFrameMkLst>
            <pc:docMk/>
            <pc:sldMk cId="1787906480" sldId="329"/>
            <ac:graphicFrameMk id="8" creationId="{018CE3B7-4A47-CAF3-031C-B868CC0161C8}"/>
          </ac:graphicFrameMkLst>
        </pc:graphicFrameChg>
        <pc:picChg chg="del">
          <ac:chgData name="Jorgensen, Rick" userId="22b7bd11-eb0f-413f-9bcb-9ce21ec7b0a8" providerId="ADAL" clId="{0566973D-188F-4C4C-9526-C2D46DEF99FC}" dt="2023-08-01T17:52:51.196" v="84" actId="478"/>
          <ac:picMkLst>
            <pc:docMk/>
            <pc:sldMk cId="1787906480" sldId="329"/>
            <ac:picMk id="5" creationId="{96847F31-992F-3F48-8927-1664FB5CDAFE}"/>
          </ac:picMkLst>
        </pc:picChg>
      </pc:sldChg>
      <pc:sldChg chg="modSp mod">
        <pc:chgData name="Jorgensen, Rick" userId="22b7bd11-eb0f-413f-9bcb-9ce21ec7b0a8" providerId="ADAL" clId="{0566973D-188F-4C4C-9526-C2D46DEF99FC}" dt="2023-08-01T20:03:17.603" v="276" actId="207"/>
        <pc:sldMkLst>
          <pc:docMk/>
          <pc:sldMk cId="913073503" sldId="330"/>
        </pc:sldMkLst>
        <pc:spChg chg="mod">
          <ac:chgData name="Jorgensen, Rick" userId="22b7bd11-eb0f-413f-9bcb-9ce21ec7b0a8" providerId="ADAL" clId="{0566973D-188F-4C4C-9526-C2D46DEF99FC}" dt="2023-08-01T20:03:17.603" v="276" actId="207"/>
          <ac:spMkLst>
            <pc:docMk/>
            <pc:sldMk cId="913073503" sldId="330"/>
            <ac:spMk id="2" creationId="{00000000-0000-0000-0000-000000000000}"/>
          </ac:spMkLst>
        </pc:spChg>
        <pc:spChg chg="mod">
          <ac:chgData name="Jorgensen, Rick" userId="22b7bd11-eb0f-413f-9bcb-9ce21ec7b0a8" providerId="ADAL" clId="{0566973D-188F-4C4C-9526-C2D46DEF99FC}" dt="2023-08-01T19:50:50.369" v="171" actId="20577"/>
          <ac:spMkLst>
            <pc:docMk/>
            <pc:sldMk cId="913073503" sldId="330"/>
            <ac:spMk id="3" creationId="{00000000-0000-0000-0000-000000000000}"/>
          </ac:spMkLst>
        </pc:spChg>
      </pc:sldChg>
      <pc:sldChg chg="addSp delSp modSp mod">
        <pc:chgData name="Jorgensen, Rick" userId="22b7bd11-eb0f-413f-9bcb-9ce21ec7b0a8" providerId="ADAL" clId="{0566973D-188F-4C4C-9526-C2D46DEF99FC}" dt="2023-08-03T19:17:54.330" v="1060" actId="478"/>
        <pc:sldMkLst>
          <pc:docMk/>
          <pc:sldMk cId="400082519" sldId="332"/>
        </pc:sldMkLst>
        <pc:spChg chg="del mod">
          <ac:chgData name="Jorgensen, Rick" userId="22b7bd11-eb0f-413f-9bcb-9ce21ec7b0a8" providerId="ADAL" clId="{0566973D-188F-4C4C-9526-C2D46DEF99FC}" dt="2023-08-03T19:17:54.330" v="1060" actId="478"/>
          <ac:spMkLst>
            <pc:docMk/>
            <pc:sldMk cId="400082519" sldId="332"/>
            <ac:spMk id="4" creationId="{E113C254-E4A3-31B0-2CEC-29CF4C5E22F3}"/>
          </ac:spMkLst>
        </pc:spChg>
        <pc:spChg chg="mod">
          <ac:chgData name="Jorgensen, Rick" userId="22b7bd11-eb0f-413f-9bcb-9ce21ec7b0a8" providerId="ADAL" clId="{0566973D-188F-4C4C-9526-C2D46DEF99FC}" dt="2023-08-01T20:03:22.071" v="277" actId="207"/>
          <ac:spMkLst>
            <pc:docMk/>
            <pc:sldMk cId="400082519" sldId="332"/>
            <ac:spMk id="9" creationId="{7D999125-4BFA-114C-85A1-52968C4B85C6}"/>
          </ac:spMkLst>
        </pc:spChg>
        <pc:graphicFrameChg chg="del">
          <ac:chgData name="Jorgensen, Rick" userId="22b7bd11-eb0f-413f-9bcb-9ce21ec7b0a8" providerId="ADAL" clId="{0566973D-188F-4C4C-9526-C2D46DEF99FC}" dt="2023-08-01T19:52:51.256" v="172" actId="478"/>
          <ac:graphicFrameMkLst>
            <pc:docMk/>
            <pc:sldMk cId="400082519" sldId="332"/>
            <ac:graphicFrameMk id="2" creationId="{7DA9CAFC-E22D-4235-9BCD-9629C3388F48}"/>
          </ac:graphicFrameMkLst>
        </pc:graphicFrameChg>
        <pc:graphicFrameChg chg="del">
          <ac:chgData name="Jorgensen, Rick" userId="22b7bd11-eb0f-413f-9bcb-9ce21ec7b0a8" providerId="ADAL" clId="{0566973D-188F-4C4C-9526-C2D46DEF99FC}" dt="2023-08-01T19:53:10.552" v="177" actId="478"/>
          <ac:graphicFrameMkLst>
            <pc:docMk/>
            <pc:sldMk cId="400082519" sldId="332"/>
            <ac:graphicFrameMk id="3" creationId="{96047870-A663-6440-BE4E-10F8515D4591}"/>
          </ac:graphicFrameMkLst>
        </pc:graphicFrameChg>
        <pc:graphicFrameChg chg="add mod">
          <ac:chgData name="Jorgensen, Rick" userId="22b7bd11-eb0f-413f-9bcb-9ce21ec7b0a8" providerId="ADAL" clId="{0566973D-188F-4C4C-9526-C2D46DEF99FC}" dt="2023-08-01T19:55:04.611" v="181" actId="20577"/>
          <ac:graphicFrameMkLst>
            <pc:docMk/>
            <pc:sldMk cId="400082519" sldId="332"/>
            <ac:graphicFrameMk id="5" creationId="{7DA9CAFC-E22D-4235-9BCD-9629C3388F48}"/>
          </ac:graphicFrameMkLst>
        </pc:graphicFrameChg>
        <pc:graphicFrameChg chg="add mod">
          <ac:chgData name="Jorgensen, Rick" userId="22b7bd11-eb0f-413f-9bcb-9ce21ec7b0a8" providerId="ADAL" clId="{0566973D-188F-4C4C-9526-C2D46DEF99FC}" dt="2023-08-01T19:54:54.409" v="179" actId="1076"/>
          <ac:graphicFrameMkLst>
            <pc:docMk/>
            <pc:sldMk cId="400082519" sldId="332"/>
            <ac:graphicFrameMk id="6" creationId="{AB76A4F8-7877-B64B-B2BB-AB6E66062E61}"/>
          </ac:graphicFrameMkLst>
        </pc:graphicFrameChg>
      </pc:sldChg>
      <pc:sldChg chg="modSp mod">
        <pc:chgData name="Jorgensen, Rick" userId="22b7bd11-eb0f-413f-9bcb-9ce21ec7b0a8" providerId="ADAL" clId="{0566973D-188F-4C4C-9526-C2D46DEF99FC}" dt="2023-08-01T20:03:46.492" v="281" actId="207"/>
        <pc:sldMkLst>
          <pc:docMk/>
          <pc:sldMk cId="1044495293" sldId="333"/>
        </pc:sldMkLst>
        <pc:spChg chg="mod">
          <ac:chgData name="Jorgensen, Rick" userId="22b7bd11-eb0f-413f-9bcb-9ce21ec7b0a8" providerId="ADAL" clId="{0566973D-188F-4C4C-9526-C2D46DEF99FC}" dt="2023-08-01T20:03:46.492" v="281" actId="207"/>
          <ac:spMkLst>
            <pc:docMk/>
            <pc:sldMk cId="1044495293" sldId="333"/>
            <ac:spMk id="2" creationId="{00000000-0000-0000-0000-000000000000}"/>
          </ac:spMkLst>
        </pc:spChg>
        <pc:spChg chg="mod">
          <ac:chgData name="Jorgensen, Rick" userId="22b7bd11-eb0f-413f-9bcb-9ce21ec7b0a8" providerId="ADAL" clId="{0566973D-188F-4C4C-9526-C2D46DEF99FC}" dt="2023-08-01T20:02:03.210" v="218" actId="20577"/>
          <ac:spMkLst>
            <pc:docMk/>
            <pc:sldMk cId="1044495293" sldId="333"/>
            <ac:spMk id="3" creationId="{00000000-0000-0000-0000-000000000000}"/>
          </ac:spMkLst>
        </pc:spChg>
      </pc:sldChg>
      <pc:sldChg chg="addSp delSp modSp mod">
        <pc:chgData name="Jorgensen, Rick" userId="22b7bd11-eb0f-413f-9bcb-9ce21ec7b0a8" providerId="ADAL" clId="{0566973D-188F-4C4C-9526-C2D46DEF99FC}" dt="2023-08-03T19:18:09.292" v="1061" actId="478"/>
        <pc:sldMkLst>
          <pc:docMk/>
          <pc:sldMk cId="2379362570" sldId="336"/>
        </pc:sldMkLst>
        <pc:spChg chg="del mod">
          <ac:chgData name="Jorgensen, Rick" userId="22b7bd11-eb0f-413f-9bcb-9ce21ec7b0a8" providerId="ADAL" clId="{0566973D-188F-4C4C-9526-C2D46DEF99FC}" dt="2023-08-03T19:18:09.292" v="1061" actId="478"/>
          <ac:spMkLst>
            <pc:docMk/>
            <pc:sldMk cId="2379362570" sldId="336"/>
            <ac:spMk id="2" creationId="{08A7B40D-026C-5D3D-02BE-8B4DDBDBF1D5}"/>
          </ac:spMkLst>
        </pc:spChg>
        <pc:spChg chg="del">
          <ac:chgData name="Jorgensen, Rick" userId="22b7bd11-eb0f-413f-9bcb-9ce21ec7b0a8" providerId="ADAL" clId="{0566973D-188F-4C4C-9526-C2D46DEF99FC}" dt="2023-08-01T20:08:07.081" v="283" actId="478"/>
          <ac:spMkLst>
            <pc:docMk/>
            <pc:sldMk cId="2379362570" sldId="336"/>
            <ac:spMk id="12" creationId="{70A0D6B9-85C8-C040-A699-C3CE1479D561}"/>
          </ac:spMkLst>
        </pc:spChg>
        <pc:spChg chg="mod">
          <ac:chgData name="Jorgensen, Rick" userId="22b7bd11-eb0f-413f-9bcb-9ce21ec7b0a8" providerId="ADAL" clId="{0566973D-188F-4C4C-9526-C2D46DEF99FC}" dt="2023-08-01T20:09:51.792" v="291" actId="207"/>
          <ac:spMkLst>
            <pc:docMk/>
            <pc:sldMk cId="2379362570" sldId="336"/>
            <ac:spMk id="25" creationId="{43DF711F-4684-B34D-9236-D3A26D348F11}"/>
          </ac:spMkLst>
        </pc:spChg>
        <pc:graphicFrameChg chg="add mod">
          <ac:chgData name="Jorgensen, Rick" userId="22b7bd11-eb0f-413f-9bcb-9ce21ec7b0a8" providerId="ADAL" clId="{0566973D-188F-4C4C-9526-C2D46DEF99FC}" dt="2023-08-01T20:08:11.939" v="285" actId="1076"/>
          <ac:graphicFrameMkLst>
            <pc:docMk/>
            <pc:sldMk cId="2379362570" sldId="336"/>
            <ac:graphicFrameMk id="3" creationId="{FD838422-8D1E-DB4E-BD54-3F097ACD7685}"/>
          </ac:graphicFrameMkLst>
        </pc:graphicFrameChg>
        <pc:graphicFrameChg chg="del">
          <ac:chgData name="Jorgensen, Rick" userId="22b7bd11-eb0f-413f-9bcb-9ce21ec7b0a8" providerId="ADAL" clId="{0566973D-188F-4C4C-9526-C2D46DEF99FC}" dt="2023-08-01T20:08:04.486" v="282" actId="478"/>
          <ac:graphicFrameMkLst>
            <pc:docMk/>
            <pc:sldMk cId="2379362570" sldId="336"/>
            <ac:graphicFrameMk id="4" creationId="{FD838422-8D1E-DB4E-BD54-3F097ACD7685}"/>
          </ac:graphicFrameMkLst>
        </pc:graphicFrameChg>
        <pc:graphicFrameChg chg="del">
          <ac:chgData name="Jorgensen, Rick" userId="22b7bd11-eb0f-413f-9bcb-9ce21ec7b0a8" providerId="ADAL" clId="{0566973D-188F-4C4C-9526-C2D46DEF99FC}" dt="2023-08-01T20:09:15.470" v="286" actId="478"/>
          <ac:graphicFrameMkLst>
            <pc:docMk/>
            <pc:sldMk cId="2379362570" sldId="336"/>
            <ac:graphicFrameMk id="5" creationId="{7736B398-AA26-FA4F-816A-B5494460DD23}"/>
          </ac:graphicFrameMkLst>
        </pc:graphicFrameChg>
        <pc:graphicFrameChg chg="add mod">
          <ac:chgData name="Jorgensen, Rick" userId="22b7bd11-eb0f-413f-9bcb-9ce21ec7b0a8" providerId="ADAL" clId="{0566973D-188F-4C4C-9526-C2D46DEF99FC}" dt="2023-08-01T20:09:24.622" v="290" actId="1076"/>
          <ac:graphicFrameMkLst>
            <pc:docMk/>
            <pc:sldMk cId="2379362570" sldId="336"/>
            <ac:graphicFrameMk id="6" creationId="{7736B398-AA26-FA4F-816A-B5494460DD23}"/>
          </ac:graphicFrameMkLst>
        </pc:graphicFrameChg>
      </pc:sldChg>
      <pc:sldChg chg="modSp mod">
        <pc:chgData name="Jorgensen, Rick" userId="22b7bd11-eb0f-413f-9bcb-9ce21ec7b0a8" providerId="ADAL" clId="{0566973D-188F-4C4C-9526-C2D46DEF99FC}" dt="2023-08-01T20:10:19.078" v="298" actId="207"/>
        <pc:sldMkLst>
          <pc:docMk/>
          <pc:sldMk cId="4068842680" sldId="337"/>
        </pc:sldMkLst>
        <pc:spChg chg="mod">
          <ac:chgData name="Jorgensen, Rick" userId="22b7bd11-eb0f-413f-9bcb-9ce21ec7b0a8" providerId="ADAL" clId="{0566973D-188F-4C4C-9526-C2D46DEF99FC}" dt="2023-08-01T20:10:19.078" v="298" actId="207"/>
          <ac:spMkLst>
            <pc:docMk/>
            <pc:sldMk cId="4068842680" sldId="337"/>
            <ac:spMk id="2" creationId="{00000000-0000-0000-0000-000000000000}"/>
          </ac:spMkLst>
        </pc:spChg>
        <pc:spChg chg="mod">
          <ac:chgData name="Jorgensen, Rick" userId="22b7bd11-eb0f-413f-9bcb-9ce21ec7b0a8" providerId="ADAL" clId="{0566973D-188F-4C4C-9526-C2D46DEF99FC}" dt="2023-08-01T20:10:03.893" v="297" actId="20577"/>
          <ac:spMkLst>
            <pc:docMk/>
            <pc:sldMk cId="4068842680" sldId="337"/>
            <ac:spMk id="3" creationId="{00000000-0000-0000-0000-000000000000}"/>
          </ac:spMkLst>
        </pc:spChg>
      </pc:sldChg>
      <pc:sldChg chg="del">
        <pc:chgData name="Jorgensen, Rick" userId="22b7bd11-eb0f-413f-9bcb-9ce21ec7b0a8" providerId="ADAL" clId="{0566973D-188F-4C4C-9526-C2D46DEF99FC}" dt="2023-08-01T17:41:59.347" v="20" actId="47"/>
        <pc:sldMkLst>
          <pc:docMk/>
          <pc:sldMk cId="1798676617" sldId="343"/>
        </pc:sldMkLst>
      </pc:sldChg>
      <pc:sldChg chg="del">
        <pc:chgData name="Jorgensen, Rick" userId="22b7bd11-eb0f-413f-9bcb-9ce21ec7b0a8" providerId="ADAL" clId="{0566973D-188F-4C4C-9526-C2D46DEF99FC}" dt="2023-08-01T17:41:59.546" v="21" actId="47"/>
        <pc:sldMkLst>
          <pc:docMk/>
          <pc:sldMk cId="3719922809" sldId="344"/>
        </pc:sldMkLst>
      </pc:sldChg>
      <pc:sldChg chg="del">
        <pc:chgData name="Jorgensen, Rick" userId="22b7bd11-eb0f-413f-9bcb-9ce21ec7b0a8" providerId="ADAL" clId="{0566973D-188F-4C4C-9526-C2D46DEF99FC}" dt="2023-08-01T17:41:54.801" v="17" actId="47"/>
        <pc:sldMkLst>
          <pc:docMk/>
          <pc:sldMk cId="3247327489" sldId="350"/>
        </pc:sldMkLst>
      </pc:sldChg>
      <pc:sldChg chg="del">
        <pc:chgData name="Jorgensen, Rick" userId="22b7bd11-eb0f-413f-9bcb-9ce21ec7b0a8" providerId="ADAL" clId="{0566973D-188F-4C4C-9526-C2D46DEF99FC}" dt="2023-08-01T17:41:58.976" v="18" actId="47"/>
        <pc:sldMkLst>
          <pc:docMk/>
          <pc:sldMk cId="908059905" sldId="352"/>
        </pc:sldMkLst>
      </pc:sldChg>
      <pc:sldChg chg="del">
        <pc:chgData name="Jorgensen, Rick" userId="22b7bd11-eb0f-413f-9bcb-9ce21ec7b0a8" providerId="ADAL" clId="{0566973D-188F-4C4C-9526-C2D46DEF99FC}" dt="2023-08-01T17:41:54.243" v="16" actId="47"/>
        <pc:sldMkLst>
          <pc:docMk/>
          <pc:sldMk cId="1098282450" sldId="357"/>
        </pc:sldMkLst>
      </pc:sldChg>
      <pc:sldChg chg="del">
        <pc:chgData name="Jorgensen, Rick" userId="22b7bd11-eb0f-413f-9bcb-9ce21ec7b0a8" providerId="ADAL" clId="{0566973D-188F-4C4C-9526-C2D46DEF99FC}" dt="2023-08-01T17:41:59.736" v="22" actId="47"/>
        <pc:sldMkLst>
          <pc:docMk/>
          <pc:sldMk cId="2562333133" sldId="364"/>
        </pc:sldMkLst>
      </pc:sldChg>
      <pc:sldChg chg="addSp delSp modSp del mod">
        <pc:chgData name="Jorgensen, Rick" userId="22b7bd11-eb0f-413f-9bcb-9ce21ec7b0a8" providerId="ADAL" clId="{0566973D-188F-4C4C-9526-C2D46DEF99FC}" dt="2023-08-03T19:16:19.458" v="1051" actId="47"/>
        <pc:sldMkLst>
          <pc:docMk/>
          <pc:sldMk cId="409862460" sldId="370"/>
        </pc:sldMkLst>
        <pc:spChg chg="add mod">
          <ac:chgData name="Jorgensen, Rick" userId="22b7bd11-eb0f-413f-9bcb-9ce21ec7b0a8" providerId="ADAL" clId="{0566973D-188F-4C4C-9526-C2D46DEF99FC}" dt="2023-08-03T19:14:42.404" v="1050" actId="20577"/>
          <ac:spMkLst>
            <pc:docMk/>
            <pc:sldMk cId="409862460" sldId="370"/>
            <ac:spMk id="4" creationId="{C4436853-1564-49FA-C818-8CD3628421D3}"/>
          </ac:spMkLst>
        </pc:spChg>
        <pc:spChg chg="add mod">
          <ac:chgData name="Jorgensen, Rick" userId="22b7bd11-eb0f-413f-9bcb-9ce21ec7b0a8" providerId="ADAL" clId="{0566973D-188F-4C4C-9526-C2D46DEF99FC}" dt="2023-08-01T19:56:06.948" v="193" actId="1076"/>
          <ac:spMkLst>
            <pc:docMk/>
            <pc:sldMk cId="409862460" sldId="370"/>
            <ac:spMk id="7" creationId="{09359763-BB22-76DF-37AE-2E5B24423970}"/>
          </ac:spMkLst>
        </pc:spChg>
        <pc:spChg chg="del">
          <ac:chgData name="Jorgensen, Rick" userId="22b7bd11-eb0f-413f-9bcb-9ce21ec7b0a8" providerId="ADAL" clId="{0566973D-188F-4C4C-9526-C2D46DEF99FC}" dt="2023-08-01T19:55:54.455" v="190" actId="478"/>
          <ac:spMkLst>
            <pc:docMk/>
            <pc:sldMk cId="409862460" sldId="370"/>
            <ac:spMk id="12" creationId="{A36E8925-C57C-6740-8FAB-525CBEEBAE0E}"/>
          </ac:spMkLst>
        </pc:spChg>
        <pc:spChg chg="mod">
          <ac:chgData name="Jorgensen, Rick" userId="22b7bd11-eb0f-413f-9bcb-9ce21ec7b0a8" providerId="ADAL" clId="{0566973D-188F-4C4C-9526-C2D46DEF99FC}" dt="2023-08-01T19:55:58.275" v="191" actId="1076"/>
          <ac:spMkLst>
            <pc:docMk/>
            <pc:sldMk cId="409862460" sldId="370"/>
            <ac:spMk id="13" creationId="{412B2D64-BC52-8E44-AE33-5C6BBC551AE1}"/>
          </ac:spMkLst>
        </pc:spChg>
        <pc:spChg chg="mod">
          <ac:chgData name="Jorgensen, Rick" userId="22b7bd11-eb0f-413f-9bcb-9ce21ec7b0a8" providerId="ADAL" clId="{0566973D-188F-4C4C-9526-C2D46DEF99FC}" dt="2023-08-01T20:03:14.279" v="275" actId="207"/>
          <ac:spMkLst>
            <pc:docMk/>
            <pc:sldMk cId="409862460" sldId="370"/>
            <ac:spMk id="25" creationId="{43DF711F-4684-B34D-9236-D3A26D348F11}"/>
          </ac:spMkLst>
        </pc:spChg>
        <pc:graphicFrameChg chg="add del mod">
          <ac:chgData name="Jorgensen, Rick" userId="22b7bd11-eb0f-413f-9bcb-9ce21ec7b0a8" providerId="ADAL" clId="{0566973D-188F-4C4C-9526-C2D46DEF99FC}" dt="2023-08-01T19:55:52.976" v="189" actId="478"/>
          <ac:graphicFrameMkLst>
            <pc:docMk/>
            <pc:sldMk cId="409862460" sldId="370"/>
            <ac:graphicFrameMk id="2" creationId="{20A35F74-6155-854D-8801-F53C28AF0151}"/>
          </ac:graphicFrameMkLst>
        </pc:graphicFrameChg>
        <pc:graphicFrameChg chg="add mod">
          <ac:chgData name="Jorgensen, Rick" userId="22b7bd11-eb0f-413f-9bcb-9ce21ec7b0a8" providerId="ADAL" clId="{0566973D-188F-4C4C-9526-C2D46DEF99FC}" dt="2023-08-01T19:55:58.275" v="191" actId="1076"/>
          <ac:graphicFrameMkLst>
            <pc:docMk/>
            <pc:sldMk cId="409862460" sldId="370"/>
            <ac:graphicFrameMk id="3" creationId="{A27E7A54-A97F-B041-A3E9-B13A645A6280}"/>
          </ac:graphicFrameMkLst>
        </pc:graphicFrameChg>
        <pc:graphicFrameChg chg="del">
          <ac:chgData name="Jorgensen, Rick" userId="22b7bd11-eb0f-413f-9bcb-9ce21ec7b0a8" providerId="ADAL" clId="{0566973D-188F-4C4C-9526-C2D46DEF99FC}" dt="2023-08-01T17:54:14.765" v="149" actId="478"/>
          <ac:graphicFrameMkLst>
            <pc:docMk/>
            <pc:sldMk cId="409862460" sldId="370"/>
            <ac:graphicFrameMk id="5" creationId="{2EC3F3E2-A4EF-4B48-86D0-23E339D1EC91}"/>
          </ac:graphicFrameMkLst>
        </pc:graphicFrameChg>
        <pc:graphicFrameChg chg="del mod">
          <ac:chgData name="Jorgensen, Rick" userId="22b7bd11-eb0f-413f-9bcb-9ce21ec7b0a8" providerId="ADAL" clId="{0566973D-188F-4C4C-9526-C2D46DEF99FC}" dt="2023-08-01T19:47:23.607" v="156" actId="478"/>
          <ac:graphicFrameMkLst>
            <pc:docMk/>
            <pc:sldMk cId="409862460" sldId="370"/>
            <ac:graphicFrameMk id="6" creationId="{A27E7A54-A97F-B041-A3E9-B13A645A6280}"/>
          </ac:graphicFrameMkLst>
        </pc:graphicFrameChg>
        <pc:graphicFrameChg chg="add mod">
          <ac:chgData name="Jorgensen, Rick" userId="22b7bd11-eb0f-413f-9bcb-9ce21ec7b0a8" providerId="ADAL" clId="{0566973D-188F-4C4C-9526-C2D46DEF99FC}" dt="2023-08-01T19:56:06.948" v="193" actId="1076"/>
          <ac:graphicFrameMkLst>
            <pc:docMk/>
            <pc:sldMk cId="409862460" sldId="370"/>
            <ac:graphicFrameMk id="8" creationId="{F61C57E5-68A6-EF4C-CB26-F37AA39A29FA}"/>
          </ac:graphicFrameMkLst>
        </pc:graphicFrameChg>
      </pc:sldChg>
      <pc:sldChg chg="addSp delSp modSp mod">
        <pc:chgData name="Jorgensen, Rick" userId="22b7bd11-eb0f-413f-9bcb-9ce21ec7b0a8" providerId="ADAL" clId="{0566973D-188F-4C4C-9526-C2D46DEF99FC}" dt="2023-08-01T20:02:57.419" v="271" actId="207"/>
        <pc:sldMkLst>
          <pc:docMk/>
          <pc:sldMk cId="4233420906" sldId="371"/>
        </pc:sldMkLst>
        <pc:spChg chg="mod">
          <ac:chgData name="Jorgensen, Rick" userId="22b7bd11-eb0f-413f-9bcb-9ce21ec7b0a8" providerId="ADAL" clId="{0566973D-188F-4C4C-9526-C2D46DEF99FC}" dt="2023-08-01T17:45:49.705" v="33" actId="1076"/>
          <ac:spMkLst>
            <pc:docMk/>
            <pc:sldMk cId="4233420906" sldId="371"/>
            <ac:spMk id="2" creationId="{D6C5BD8B-1213-63CE-A5EC-A6AD4B8F433D}"/>
          </ac:spMkLst>
        </pc:spChg>
        <pc:spChg chg="mod">
          <ac:chgData name="Jorgensen, Rick" userId="22b7bd11-eb0f-413f-9bcb-9ce21ec7b0a8" providerId="ADAL" clId="{0566973D-188F-4C4C-9526-C2D46DEF99FC}" dt="2023-08-01T20:02:54.959" v="270" actId="207"/>
          <ac:spMkLst>
            <pc:docMk/>
            <pc:sldMk cId="4233420906" sldId="371"/>
            <ac:spMk id="4" creationId="{C1464C00-88D7-F8FC-7A22-D15A26949AB4}"/>
          </ac:spMkLst>
        </pc:spChg>
        <pc:spChg chg="mod">
          <ac:chgData name="Jorgensen, Rick" userId="22b7bd11-eb0f-413f-9bcb-9ce21ec7b0a8" providerId="ADAL" clId="{0566973D-188F-4C4C-9526-C2D46DEF99FC}" dt="2023-08-01T20:02:57.419" v="271" actId="207"/>
          <ac:spMkLst>
            <pc:docMk/>
            <pc:sldMk cId="4233420906" sldId="371"/>
            <ac:spMk id="5" creationId="{3A53ACCA-D541-44AB-07A4-B6FE2AD4FD4D}"/>
          </ac:spMkLst>
        </pc:spChg>
        <pc:graphicFrameChg chg="del">
          <ac:chgData name="Jorgensen, Rick" userId="22b7bd11-eb0f-413f-9bcb-9ce21ec7b0a8" providerId="ADAL" clId="{0566973D-188F-4C4C-9526-C2D46DEF99FC}" dt="2023-08-01T17:45:35.994" v="27" actId="478"/>
          <ac:graphicFrameMkLst>
            <pc:docMk/>
            <pc:sldMk cId="4233420906" sldId="371"/>
            <ac:graphicFrameMk id="3" creationId="{1109EF19-42B5-1D41-9810-BAD609E3061D}"/>
          </ac:graphicFrameMkLst>
        </pc:graphicFrameChg>
        <pc:graphicFrameChg chg="add mod">
          <ac:chgData name="Jorgensen, Rick" userId="22b7bd11-eb0f-413f-9bcb-9ce21ec7b0a8" providerId="ADAL" clId="{0566973D-188F-4C4C-9526-C2D46DEF99FC}" dt="2023-08-01T17:45:44.137" v="31"/>
          <ac:graphicFrameMkLst>
            <pc:docMk/>
            <pc:sldMk cId="4233420906" sldId="371"/>
            <ac:graphicFrameMk id="6" creationId="{1109EF19-42B5-1D41-9810-BAD609E3061D}"/>
          </ac:graphicFrameMkLst>
        </pc:graphicFrameChg>
      </pc:sldChg>
      <pc:sldChg chg="addSp delSp modSp del mod">
        <pc:chgData name="Jorgensen, Rick" userId="22b7bd11-eb0f-413f-9bcb-9ce21ec7b0a8" providerId="ADAL" clId="{0566973D-188F-4C4C-9526-C2D46DEF99FC}" dt="2023-08-01T19:56:08.603" v="194" actId="47"/>
        <pc:sldMkLst>
          <pc:docMk/>
          <pc:sldMk cId="776687571" sldId="374"/>
        </pc:sldMkLst>
        <pc:spChg chg="add mod">
          <ac:chgData name="Jorgensen, Rick" userId="22b7bd11-eb0f-413f-9bcb-9ce21ec7b0a8" providerId="ADAL" clId="{0566973D-188F-4C4C-9526-C2D46DEF99FC}" dt="2023-08-01T19:50:31.603" v="166"/>
          <ac:spMkLst>
            <pc:docMk/>
            <pc:sldMk cId="776687571" sldId="374"/>
            <ac:spMk id="6" creationId="{684A98CA-07DD-8505-B150-E161B013A6E7}"/>
          </ac:spMkLst>
        </pc:spChg>
        <pc:graphicFrameChg chg="del">
          <ac:chgData name="Jorgensen, Rick" userId="22b7bd11-eb0f-413f-9bcb-9ce21ec7b0a8" providerId="ADAL" clId="{0566973D-188F-4C4C-9526-C2D46DEF99FC}" dt="2023-08-01T19:49:01.219" v="161" actId="478"/>
          <ac:graphicFrameMkLst>
            <pc:docMk/>
            <pc:sldMk cId="776687571" sldId="374"/>
            <ac:graphicFrameMk id="2" creationId="{3ECE29A9-59FA-8DD2-48F2-2CABF395C46F}"/>
          </ac:graphicFrameMkLst>
        </pc:graphicFrameChg>
        <pc:graphicFrameChg chg="add mod">
          <ac:chgData name="Jorgensen, Rick" userId="22b7bd11-eb0f-413f-9bcb-9ce21ec7b0a8" providerId="ADAL" clId="{0566973D-188F-4C4C-9526-C2D46DEF99FC}" dt="2023-08-01T19:50:09.888" v="163" actId="1076"/>
          <ac:graphicFrameMkLst>
            <pc:docMk/>
            <pc:sldMk cId="776687571" sldId="374"/>
            <ac:graphicFrameMk id="5" creationId="{22A28235-9576-9D40-AAAE-FCCA9ACDEF11}"/>
          </ac:graphicFrameMkLst>
        </pc:graphicFrameChg>
      </pc:sldChg>
      <pc:sldChg chg="addSp delSp modSp del mod">
        <pc:chgData name="Jorgensen, Rick" userId="22b7bd11-eb0f-413f-9bcb-9ce21ec7b0a8" providerId="ADAL" clId="{0566973D-188F-4C4C-9526-C2D46DEF99FC}" dt="2023-08-03T19:17:50.725" v="1059" actId="47"/>
        <pc:sldMkLst>
          <pc:docMk/>
          <pc:sldMk cId="1502923220" sldId="375"/>
        </pc:sldMkLst>
        <pc:spChg chg="add mod">
          <ac:chgData name="Jorgensen, Rick" userId="22b7bd11-eb0f-413f-9bcb-9ce21ec7b0a8" providerId="ADAL" clId="{0566973D-188F-4C4C-9526-C2D46DEF99FC}" dt="2023-08-01T20:03:31.993" v="280" actId="207"/>
          <ac:spMkLst>
            <pc:docMk/>
            <pc:sldMk cId="1502923220" sldId="375"/>
            <ac:spMk id="4" creationId="{6FC69CA4-E782-5F95-99CA-29E5603530B7}"/>
          </ac:spMkLst>
        </pc:spChg>
        <pc:spChg chg="mod">
          <ac:chgData name="Jorgensen, Rick" userId="22b7bd11-eb0f-413f-9bcb-9ce21ec7b0a8" providerId="ADAL" clId="{0566973D-188F-4C4C-9526-C2D46DEF99FC}" dt="2023-08-01T20:03:29.233" v="279" actId="207"/>
          <ac:spMkLst>
            <pc:docMk/>
            <pc:sldMk cId="1502923220" sldId="375"/>
            <ac:spMk id="9" creationId="{7D999125-4BFA-114C-85A1-52968C4B85C6}"/>
          </ac:spMkLst>
        </pc:spChg>
        <pc:graphicFrameChg chg="add mod">
          <ac:chgData name="Jorgensen, Rick" userId="22b7bd11-eb0f-413f-9bcb-9ce21ec7b0a8" providerId="ADAL" clId="{0566973D-188F-4C4C-9526-C2D46DEF99FC}" dt="2023-08-01T19:59:47.974" v="205" actId="1076"/>
          <ac:graphicFrameMkLst>
            <pc:docMk/>
            <pc:sldMk cId="1502923220" sldId="375"/>
            <ac:graphicFrameMk id="2" creationId="{96047870-A663-6440-BE4E-10F8515D4591}"/>
          </ac:graphicFrameMkLst>
        </pc:graphicFrameChg>
        <pc:graphicFrameChg chg="add mod">
          <ac:chgData name="Jorgensen, Rick" userId="22b7bd11-eb0f-413f-9bcb-9ce21ec7b0a8" providerId="ADAL" clId="{0566973D-188F-4C4C-9526-C2D46DEF99FC}" dt="2023-08-01T20:00:46.628" v="208" actId="1076"/>
          <ac:graphicFrameMkLst>
            <pc:docMk/>
            <pc:sldMk cId="1502923220" sldId="375"/>
            <ac:graphicFrameMk id="3" creationId="{BC7FA32F-65B7-5442-BA35-54D20CA5D8AC}"/>
          </ac:graphicFrameMkLst>
        </pc:graphicFrameChg>
        <pc:graphicFrameChg chg="del">
          <ac:chgData name="Jorgensen, Rick" userId="22b7bd11-eb0f-413f-9bcb-9ce21ec7b0a8" providerId="ADAL" clId="{0566973D-188F-4C4C-9526-C2D46DEF99FC}" dt="2023-08-01T19:58:43.900" v="203" actId="478"/>
          <ac:graphicFrameMkLst>
            <pc:docMk/>
            <pc:sldMk cId="1502923220" sldId="375"/>
            <ac:graphicFrameMk id="5" creationId="{96047870-A663-6440-BE4E-10F8515D4591}"/>
          </ac:graphicFrameMkLst>
        </pc:graphicFrameChg>
        <pc:graphicFrameChg chg="del">
          <ac:chgData name="Jorgensen, Rick" userId="22b7bd11-eb0f-413f-9bcb-9ce21ec7b0a8" providerId="ADAL" clId="{0566973D-188F-4C4C-9526-C2D46DEF99FC}" dt="2023-08-01T19:59:50.069" v="206" actId="478"/>
          <ac:graphicFrameMkLst>
            <pc:docMk/>
            <pc:sldMk cId="1502923220" sldId="375"/>
            <ac:graphicFrameMk id="6" creationId="{D7ED6DED-B81D-0542-9B85-22EBCF9BB5B6}"/>
          </ac:graphicFrameMkLst>
        </pc:graphicFrameChg>
      </pc:sldChg>
      <pc:sldChg chg="modSp mod">
        <pc:chgData name="Jorgensen, Rick" userId="22b7bd11-eb0f-413f-9bcb-9ce21ec7b0a8" providerId="ADAL" clId="{0566973D-188F-4C4C-9526-C2D46DEF99FC}" dt="2023-08-01T17:46:21.972" v="72" actId="1076"/>
        <pc:sldMkLst>
          <pc:docMk/>
          <pc:sldMk cId="4070891446" sldId="377"/>
        </pc:sldMkLst>
        <pc:spChg chg="mod">
          <ac:chgData name="Jorgensen, Rick" userId="22b7bd11-eb0f-413f-9bcb-9ce21ec7b0a8" providerId="ADAL" clId="{0566973D-188F-4C4C-9526-C2D46DEF99FC}" dt="2023-08-01T17:46:21.972" v="72" actId="1076"/>
          <ac:spMkLst>
            <pc:docMk/>
            <pc:sldMk cId="4070891446" sldId="377"/>
            <ac:spMk id="10" creationId="{DE9A23F4-1D6F-7D27-4B02-FD7334D78603}"/>
          </ac:spMkLst>
        </pc:spChg>
      </pc:sldChg>
      <pc:sldChg chg="modSp mod">
        <pc:chgData name="Jorgensen, Rick" userId="22b7bd11-eb0f-413f-9bcb-9ce21ec7b0a8" providerId="ADAL" clId="{0566973D-188F-4C4C-9526-C2D46DEF99FC}" dt="2023-08-02T00:40:31.081" v="1019" actId="20577"/>
        <pc:sldMkLst>
          <pc:docMk/>
          <pc:sldMk cId="3740473727" sldId="378"/>
        </pc:sldMkLst>
        <pc:spChg chg="mod">
          <ac:chgData name="Jorgensen, Rick" userId="22b7bd11-eb0f-413f-9bcb-9ce21ec7b0a8" providerId="ADAL" clId="{0566973D-188F-4C4C-9526-C2D46DEF99FC}" dt="2023-08-02T00:40:31.081" v="1019" actId="20577"/>
          <ac:spMkLst>
            <pc:docMk/>
            <pc:sldMk cId="3740473727" sldId="378"/>
            <ac:spMk id="3" creationId="{00000000-0000-0000-0000-000000000000}"/>
          </ac:spMkLst>
        </pc:spChg>
      </pc:sldChg>
      <pc:sldChg chg="del">
        <pc:chgData name="Jorgensen, Rick" userId="22b7bd11-eb0f-413f-9bcb-9ce21ec7b0a8" providerId="ADAL" clId="{0566973D-188F-4C4C-9526-C2D46DEF99FC}" dt="2023-08-01T17:42:00.428" v="24" actId="47"/>
        <pc:sldMkLst>
          <pc:docMk/>
          <pc:sldMk cId="3976310766" sldId="379"/>
        </pc:sldMkLst>
      </pc:sldChg>
      <pc:sldChg chg="addSp delSp modSp mod">
        <pc:chgData name="Jorgensen, Rick" userId="22b7bd11-eb0f-413f-9bcb-9ce21ec7b0a8" providerId="ADAL" clId="{0566973D-188F-4C4C-9526-C2D46DEF99FC}" dt="2023-08-03T18:44:23.261" v="1027" actId="1076"/>
        <pc:sldMkLst>
          <pc:docMk/>
          <pc:sldMk cId="4180539983" sldId="381"/>
        </pc:sldMkLst>
        <pc:spChg chg="add del mod">
          <ac:chgData name="Jorgensen, Rick" userId="22b7bd11-eb0f-413f-9bcb-9ce21ec7b0a8" providerId="ADAL" clId="{0566973D-188F-4C4C-9526-C2D46DEF99FC}" dt="2023-08-01T20:54:04.650" v="552" actId="478"/>
          <ac:spMkLst>
            <pc:docMk/>
            <pc:sldMk cId="4180539983" sldId="381"/>
            <ac:spMk id="4" creationId="{980FA329-511A-700C-18C2-A601A8C5EAD2}"/>
          </ac:spMkLst>
        </pc:spChg>
        <pc:spChg chg="mod">
          <ac:chgData name="Jorgensen, Rick" userId="22b7bd11-eb0f-413f-9bcb-9ce21ec7b0a8" providerId="ADAL" clId="{0566973D-188F-4C4C-9526-C2D46DEF99FC}" dt="2023-08-01T20:52:29.530" v="545" actId="1076"/>
          <ac:spMkLst>
            <pc:docMk/>
            <pc:sldMk cId="4180539983" sldId="381"/>
            <ac:spMk id="5" creationId="{D781EC2B-E649-9293-3A1C-83975708065C}"/>
          </ac:spMkLst>
        </pc:spChg>
        <pc:spChg chg="mod">
          <ac:chgData name="Jorgensen, Rick" userId="22b7bd11-eb0f-413f-9bcb-9ce21ec7b0a8" providerId="ADAL" clId="{0566973D-188F-4C4C-9526-C2D46DEF99FC}" dt="2023-08-01T20:53:57.127" v="550" actId="207"/>
          <ac:spMkLst>
            <pc:docMk/>
            <pc:sldMk cId="4180539983" sldId="381"/>
            <ac:spMk id="25" creationId="{43DF711F-4684-B34D-9236-D3A26D348F11}"/>
          </ac:spMkLst>
        </pc:spChg>
        <pc:spChg chg="mod">
          <ac:chgData name="Jorgensen, Rick" userId="22b7bd11-eb0f-413f-9bcb-9ce21ec7b0a8" providerId="ADAL" clId="{0566973D-188F-4C4C-9526-C2D46DEF99FC}" dt="2023-08-01T20:51:48.005" v="544" actId="14100"/>
          <ac:spMkLst>
            <pc:docMk/>
            <pc:sldMk cId="4180539983" sldId="381"/>
            <ac:spMk id="40" creationId="{DDDF0E5A-3974-79DF-0FE1-B6DF8F6D1D64}"/>
          </ac:spMkLst>
        </pc:spChg>
        <pc:spChg chg="mod">
          <ac:chgData name="Jorgensen, Rick" userId="22b7bd11-eb0f-413f-9bcb-9ce21ec7b0a8" providerId="ADAL" clId="{0566973D-188F-4C4C-9526-C2D46DEF99FC}" dt="2023-08-03T18:44:23.261" v="1027" actId="1076"/>
          <ac:spMkLst>
            <pc:docMk/>
            <pc:sldMk cId="4180539983" sldId="381"/>
            <ac:spMk id="44" creationId="{1099F439-2C72-613A-9FFB-A4EEC230954D}"/>
          </ac:spMkLst>
        </pc:spChg>
        <pc:graphicFrameChg chg="mod">
          <ac:chgData name="Jorgensen, Rick" userId="22b7bd11-eb0f-413f-9bcb-9ce21ec7b0a8" providerId="ADAL" clId="{0566973D-188F-4C4C-9526-C2D46DEF99FC}" dt="2023-08-01T21:13:49.846" v="636" actId="692"/>
          <ac:graphicFrameMkLst>
            <pc:docMk/>
            <pc:sldMk cId="4180539983" sldId="381"/>
            <ac:graphicFrameMk id="9" creationId="{3570F2B5-DAE4-4ED3-8040-377E7BDD6F78}"/>
          </ac:graphicFrameMkLst>
        </pc:graphicFrameChg>
        <pc:graphicFrameChg chg="mod">
          <ac:chgData name="Jorgensen, Rick" userId="22b7bd11-eb0f-413f-9bcb-9ce21ec7b0a8" providerId="ADAL" clId="{0566973D-188F-4C4C-9526-C2D46DEF99FC}" dt="2023-08-03T18:44:20.458" v="1026"/>
          <ac:graphicFrameMkLst>
            <pc:docMk/>
            <pc:sldMk cId="4180539983" sldId="381"/>
            <ac:graphicFrameMk id="39" creationId="{DE951F37-77FB-4F5A-B764-8CE1F8B42F66}"/>
          </ac:graphicFrameMkLst>
        </pc:graphicFrameChg>
      </pc:sldChg>
      <pc:sldChg chg="del">
        <pc:chgData name="Jorgensen, Rick" userId="22b7bd11-eb0f-413f-9bcb-9ce21ec7b0a8" providerId="ADAL" clId="{0566973D-188F-4C4C-9526-C2D46DEF99FC}" dt="2023-08-01T17:41:53.636" v="14" actId="47"/>
        <pc:sldMkLst>
          <pc:docMk/>
          <pc:sldMk cId="603868055" sldId="382"/>
        </pc:sldMkLst>
      </pc:sldChg>
      <pc:sldChg chg="del">
        <pc:chgData name="Jorgensen, Rick" userId="22b7bd11-eb0f-413f-9bcb-9ce21ec7b0a8" providerId="ADAL" clId="{0566973D-188F-4C4C-9526-C2D46DEF99FC}" dt="2023-08-01T17:41:53.266" v="13" actId="47"/>
        <pc:sldMkLst>
          <pc:docMk/>
          <pc:sldMk cId="1539833663" sldId="383"/>
        </pc:sldMkLst>
      </pc:sldChg>
      <pc:sldChg chg="del">
        <pc:chgData name="Jorgensen, Rick" userId="22b7bd11-eb0f-413f-9bcb-9ce21ec7b0a8" providerId="ADAL" clId="{0566973D-188F-4C4C-9526-C2D46DEF99FC}" dt="2023-08-01T17:41:51.956" v="8" actId="47"/>
        <pc:sldMkLst>
          <pc:docMk/>
          <pc:sldMk cId="3869918126" sldId="385"/>
        </pc:sldMkLst>
      </pc:sldChg>
      <pc:sldChg chg="addSp delSp modSp mod ord">
        <pc:chgData name="Jorgensen, Rick" userId="22b7bd11-eb0f-413f-9bcb-9ce21ec7b0a8" providerId="ADAL" clId="{0566973D-188F-4C4C-9526-C2D46DEF99FC}" dt="2023-08-03T20:31:00.750" v="1778" actId="20577"/>
        <pc:sldMkLst>
          <pc:docMk/>
          <pc:sldMk cId="1930347573" sldId="386"/>
        </pc:sldMkLst>
        <pc:spChg chg="del mod">
          <ac:chgData name="Jorgensen, Rick" userId="22b7bd11-eb0f-413f-9bcb-9ce21ec7b0a8" providerId="ADAL" clId="{0566973D-188F-4C4C-9526-C2D46DEF99FC}" dt="2023-08-03T19:31:52.959" v="1116" actId="478"/>
          <ac:spMkLst>
            <pc:docMk/>
            <pc:sldMk cId="1930347573" sldId="386"/>
            <ac:spMk id="2" creationId="{7FE5B6EF-7FEE-E6F6-B1FB-04BEC9D64FBA}"/>
          </ac:spMkLst>
        </pc:spChg>
        <pc:spChg chg="del mod">
          <ac:chgData name="Jorgensen, Rick" userId="22b7bd11-eb0f-413f-9bcb-9ce21ec7b0a8" providerId="ADAL" clId="{0566973D-188F-4C4C-9526-C2D46DEF99FC}" dt="2023-08-03T19:31:56.161" v="1119" actId="478"/>
          <ac:spMkLst>
            <pc:docMk/>
            <pc:sldMk cId="1930347573" sldId="386"/>
            <ac:spMk id="3" creationId="{4738819F-EC27-2C00-D45B-69BFDB7E3FC4}"/>
          </ac:spMkLst>
        </pc:spChg>
        <pc:spChg chg="del">
          <ac:chgData name="Jorgensen, Rick" userId="22b7bd11-eb0f-413f-9bcb-9ce21ec7b0a8" providerId="ADAL" clId="{0566973D-188F-4C4C-9526-C2D46DEF99FC}" dt="2023-08-03T19:31:55.150" v="1118" actId="478"/>
          <ac:spMkLst>
            <pc:docMk/>
            <pc:sldMk cId="1930347573" sldId="386"/>
            <ac:spMk id="5" creationId="{8D31E811-9219-17E9-A74B-55B29D9B3BC7}"/>
          </ac:spMkLst>
        </pc:spChg>
        <pc:spChg chg="del mod">
          <ac:chgData name="Jorgensen, Rick" userId="22b7bd11-eb0f-413f-9bcb-9ce21ec7b0a8" providerId="ADAL" clId="{0566973D-188F-4C4C-9526-C2D46DEF99FC}" dt="2023-08-03T19:35:59.721" v="1210" actId="478"/>
          <ac:spMkLst>
            <pc:docMk/>
            <pc:sldMk cId="1930347573" sldId="386"/>
            <ac:spMk id="17" creationId="{D181E944-4B90-E74E-9153-2053FAE9DD47}"/>
          </ac:spMkLst>
        </pc:spChg>
        <pc:spChg chg="mod">
          <ac:chgData name="Jorgensen, Rick" userId="22b7bd11-eb0f-413f-9bcb-9ce21ec7b0a8" providerId="ADAL" clId="{0566973D-188F-4C4C-9526-C2D46DEF99FC}" dt="2023-08-03T19:33:05.850" v="1132" actId="14100"/>
          <ac:spMkLst>
            <pc:docMk/>
            <pc:sldMk cId="1930347573" sldId="386"/>
            <ac:spMk id="21" creationId="{F20C939D-279D-1987-3323-543F2FDD569F}"/>
          </ac:spMkLst>
        </pc:spChg>
        <pc:spChg chg="del">
          <ac:chgData name="Jorgensen, Rick" userId="22b7bd11-eb0f-413f-9bcb-9ce21ec7b0a8" providerId="ADAL" clId="{0566973D-188F-4C4C-9526-C2D46DEF99FC}" dt="2023-08-03T19:31:59.106" v="1121" actId="478"/>
          <ac:spMkLst>
            <pc:docMk/>
            <pc:sldMk cId="1930347573" sldId="386"/>
            <ac:spMk id="22" creationId="{09C0A976-1706-0DD0-3A28-3F125DD8EF1D}"/>
          </ac:spMkLst>
        </pc:spChg>
        <pc:spChg chg="mod">
          <ac:chgData name="Jorgensen, Rick" userId="22b7bd11-eb0f-413f-9bcb-9ce21ec7b0a8" providerId="ADAL" clId="{0566973D-188F-4C4C-9526-C2D46DEF99FC}" dt="2023-08-03T19:39:10.141" v="1621" actId="1076"/>
          <ac:spMkLst>
            <pc:docMk/>
            <pc:sldMk cId="1930347573" sldId="386"/>
            <ac:spMk id="23" creationId="{753D7537-F164-CFEE-DDB8-D7FC97922DF8}"/>
          </ac:spMkLst>
        </pc:spChg>
        <pc:spChg chg="add del mod">
          <ac:chgData name="Jorgensen, Rick" userId="22b7bd11-eb0f-413f-9bcb-9ce21ec7b0a8" providerId="ADAL" clId="{0566973D-188F-4C4C-9526-C2D46DEF99FC}" dt="2023-08-03T19:31:21.800" v="1114" actId="478"/>
          <ac:spMkLst>
            <pc:docMk/>
            <pc:sldMk cId="1930347573" sldId="386"/>
            <ac:spMk id="24" creationId="{E93DF8A8-D853-D574-F1FA-CA3E28D011D4}"/>
          </ac:spMkLst>
        </pc:spChg>
        <pc:spChg chg="add mod">
          <ac:chgData name="Jorgensen, Rick" userId="22b7bd11-eb0f-413f-9bcb-9ce21ec7b0a8" providerId="ADAL" clId="{0566973D-188F-4C4C-9526-C2D46DEF99FC}" dt="2023-08-03T19:36:31.997" v="1219" actId="1076"/>
          <ac:spMkLst>
            <pc:docMk/>
            <pc:sldMk cId="1930347573" sldId="386"/>
            <ac:spMk id="25" creationId="{0CD6FEC8-C307-5DA6-9811-72BA8DA41024}"/>
          </ac:spMkLst>
        </pc:spChg>
        <pc:spChg chg="mod">
          <ac:chgData name="Jorgensen, Rick" userId="22b7bd11-eb0f-413f-9bcb-9ce21ec7b0a8" providerId="ADAL" clId="{0566973D-188F-4C4C-9526-C2D46DEF99FC}" dt="2023-08-03T20:31:00.750" v="1778" actId="20577"/>
          <ac:spMkLst>
            <pc:docMk/>
            <pc:sldMk cId="1930347573" sldId="386"/>
            <ac:spMk id="29" creationId="{2E51C695-DD93-3E46-975E-4AD32D674DE1}"/>
          </ac:spMkLst>
        </pc:spChg>
        <pc:grpChg chg="mod">
          <ac:chgData name="Jorgensen, Rick" userId="22b7bd11-eb0f-413f-9bcb-9ce21ec7b0a8" providerId="ADAL" clId="{0566973D-188F-4C4C-9526-C2D46DEF99FC}" dt="2023-08-03T19:36:08.781" v="1211" actId="1076"/>
          <ac:grpSpMkLst>
            <pc:docMk/>
            <pc:sldMk cId="1930347573" sldId="386"/>
            <ac:grpSpMk id="8" creationId="{3F0A3545-1777-341E-3333-34A87D41DE63}"/>
          </ac:grpSpMkLst>
        </pc:grpChg>
        <pc:grpChg chg="del">
          <ac:chgData name="Jorgensen, Rick" userId="22b7bd11-eb0f-413f-9bcb-9ce21ec7b0a8" providerId="ADAL" clId="{0566973D-188F-4C4C-9526-C2D46DEF99FC}" dt="2023-08-03T19:31:57.371" v="1120" actId="478"/>
          <ac:grpSpMkLst>
            <pc:docMk/>
            <pc:sldMk cId="1930347573" sldId="386"/>
            <ac:grpSpMk id="12" creationId="{1B50585F-6C48-890F-D6BD-D343C918731A}"/>
          </ac:grpSpMkLst>
        </pc:grpChg>
        <pc:graphicFrameChg chg="mod">
          <ac:chgData name="Jorgensen, Rick" userId="22b7bd11-eb0f-413f-9bcb-9ce21ec7b0a8" providerId="ADAL" clId="{0566973D-188F-4C4C-9526-C2D46DEF99FC}" dt="2023-08-03T19:34:58.187" v="1141" actId="1076"/>
          <ac:graphicFrameMkLst>
            <pc:docMk/>
            <pc:sldMk cId="1930347573" sldId="386"/>
            <ac:graphicFrameMk id="6" creationId="{9A9B4E5A-BE93-E01F-F26A-ABE8CB9500C3}"/>
          </ac:graphicFrameMkLst>
        </pc:graphicFrameChg>
        <pc:graphicFrameChg chg="del">
          <ac:chgData name="Jorgensen, Rick" userId="22b7bd11-eb0f-413f-9bcb-9ce21ec7b0a8" providerId="ADAL" clId="{0566973D-188F-4C4C-9526-C2D46DEF99FC}" dt="2023-08-03T19:31:51.484" v="1115" actId="478"/>
          <ac:graphicFrameMkLst>
            <pc:docMk/>
            <pc:sldMk cId="1930347573" sldId="386"/>
            <ac:graphicFrameMk id="10" creationId="{6A4EC095-5490-40BE-88AC-88E4EC7B03DE}"/>
          </ac:graphicFrameMkLst>
        </pc:graphicFrameChg>
        <pc:cxnChg chg="del">
          <ac:chgData name="Jorgensen, Rick" userId="22b7bd11-eb0f-413f-9bcb-9ce21ec7b0a8" providerId="ADAL" clId="{0566973D-188F-4C4C-9526-C2D46DEF99FC}" dt="2023-08-03T19:31:53.854" v="1117" actId="478"/>
          <ac:cxnSpMkLst>
            <pc:docMk/>
            <pc:sldMk cId="1930347573" sldId="386"/>
            <ac:cxnSpMk id="4" creationId="{EC3D0536-8958-1C98-41DB-C0427AE32BBC}"/>
          </ac:cxnSpMkLst>
        </pc:cxnChg>
        <pc:cxnChg chg="add mod">
          <ac:chgData name="Jorgensen, Rick" userId="22b7bd11-eb0f-413f-9bcb-9ce21ec7b0a8" providerId="ADAL" clId="{0566973D-188F-4C4C-9526-C2D46DEF99FC}" dt="2023-08-03T19:35:52.696" v="1208" actId="692"/>
          <ac:cxnSpMkLst>
            <pc:docMk/>
            <pc:sldMk cId="1930347573" sldId="386"/>
            <ac:cxnSpMk id="27" creationId="{EE9D047B-5AF6-9476-4B3C-67448253C46F}"/>
          </ac:cxnSpMkLst>
        </pc:cxnChg>
      </pc:sldChg>
      <pc:sldChg chg="del">
        <pc:chgData name="Jorgensen, Rick" userId="22b7bd11-eb0f-413f-9bcb-9ce21ec7b0a8" providerId="ADAL" clId="{0566973D-188F-4C4C-9526-C2D46DEF99FC}" dt="2023-08-01T17:41:44.223" v="0" actId="47"/>
        <pc:sldMkLst>
          <pc:docMk/>
          <pc:sldMk cId="361227352" sldId="387"/>
        </pc:sldMkLst>
      </pc:sldChg>
      <pc:sldChg chg="del">
        <pc:chgData name="Jorgensen, Rick" userId="22b7bd11-eb0f-413f-9bcb-9ce21ec7b0a8" providerId="ADAL" clId="{0566973D-188F-4C4C-9526-C2D46DEF99FC}" dt="2023-08-01T17:41:51.746" v="7" actId="47"/>
        <pc:sldMkLst>
          <pc:docMk/>
          <pc:sldMk cId="3056925330" sldId="389"/>
        </pc:sldMkLst>
      </pc:sldChg>
      <pc:sldChg chg="del">
        <pc:chgData name="Jorgensen, Rick" userId="22b7bd11-eb0f-413f-9bcb-9ce21ec7b0a8" providerId="ADAL" clId="{0566973D-188F-4C4C-9526-C2D46DEF99FC}" dt="2023-08-01T17:41:50.395" v="5" actId="47"/>
        <pc:sldMkLst>
          <pc:docMk/>
          <pc:sldMk cId="3756482471" sldId="390"/>
        </pc:sldMkLst>
      </pc:sldChg>
      <pc:sldChg chg="del">
        <pc:chgData name="Jorgensen, Rick" userId="22b7bd11-eb0f-413f-9bcb-9ce21ec7b0a8" providerId="ADAL" clId="{0566973D-188F-4C4C-9526-C2D46DEF99FC}" dt="2023-08-01T21:14:49.915" v="643" actId="47"/>
        <pc:sldMkLst>
          <pc:docMk/>
          <pc:sldMk cId="2295641252" sldId="391"/>
        </pc:sldMkLst>
      </pc:sldChg>
      <pc:sldChg chg="del">
        <pc:chgData name="Jorgensen, Rick" userId="22b7bd11-eb0f-413f-9bcb-9ce21ec7b0a8" providerId="ADAL" clId="{0566973D-188F-4C4C-9526-C2D46DEF99FC}" dt="2023-08-01T17:41:46.444" v="4" actId="47"/>
        <pc:sldMkLst>
          <pc:docMk/>
          <pc:sldMk cId="230635334" sldId="392"/>
        </pc:sldMkLst>
      </pc:sldChg>
      <pc:sldChg chg="del">
        <pc:chgData name="Jorgensen, Rick" userId="22b7bd11-eb0f-413f-9bcb-9ce21ec7b0a8" providerId="ADAL" clId="{0566973D-188F-4C4C-9526-C2D46DEF99FC}" dt="2023-08-01T17:41:45.649" v="3" actId="47"/>
        <pc:sldMkLst>
          <pc:docMk/>
          <pc:sldMk cId="836877954" sldId="393"/>
        </pc:sldMkLst>
      </pc:sldChg>
      <pc:sldChg chg="del">
        <pc:chgData name="Jorgensen, Rick" userId="22b7bd11-eb0f-413f-9bcb-9ce21ec7b0a8" providerId="ADAL" clId="{0566973D-188F-4C4C-9526-C2D46DEF99FC}" dt="2023-08-01T17:41:53.040" v="12" actId="47"/>
        <pc:sldMkLst>
          <pc:docMk/>
          <pc:sldMk cId="3513125160" sldId="394"/>
        </pc:sldMkLst>
      </pc:sldChg>
      <pc:sldChg chg="del">
        <pc:chgData name="Jorgensen, Rick" userId="22b7bd11-eb0f-413f-9bcb-9ce21ec7b0a8" providerId="ADAL" clId="{0566973D-188F-4C4C-9526-C2D46DEF99FC}" dt="2023-08-01T17:41:52.117" v="9" actId="47"/>
        <pc:sldMkLst>
          <pc:docMk/>
          <pc:sldMk cId="4258801853" sldId="398"/>
        </pc:sldMkLst>
      </pc:sldChg>
      <pc:sldChg chg="del">
        <pc:chgData name="Jorgensen, Rick" userId="22b7bd11-eb0f-413f-9bcb-9ce21ec7b0a8" providerId="ADAL" clId="{0566973D-188F-4C4C-9526-C2D46DEF99FC}" dt="2023-08-01T17:42:01.163" v="26" actId="47"/>
        <pc:sldMkLst>
          <pc:docMk/>
          <pc:sldMk cId="2240995552" sldId="399"/>
        </pc:sldMkLst>
      </pc:sldChg>
      <pc:sldChg chg="del">
        <pc:chgData name="Jorgensen, Rick" userId="22b7bd11-eb0f-413f-9bcb-9ce21ec7b0a8" providerId="ADAL" clId="{0566973D-188F-4C4C-9526-C2D46DEF99FC}" dt="2023-08-01T17:42:00.722" v="25" actId="47"/>
        <pc:sldMkLst>
          <pc:docMk/>
          <pc:sldMk cId="2134229182" sldId="400"/>
        </pc:sldMkLst>
      </pc:sldChg>
      <pc:sldChg chg="addSp delSp modSp mod">
        <pc:chgData name="Jorgensen, Rick" userId="22b7bd11-eb0f-413f-9bcb-9ce21ec7b0a8" providerId="ADAL" clId="{0566973D-188F-4C4C-9526-C2D46DEF99FC}" dt="2023-08-01T20:02:51.426" v="269" actId="207"/>
        <pc:sldMkLst>
          <pc:docMk/>
          <pc:sldMk cId="1669493757" sldId="401"/>
        </pc:sldMkLst>
        <pc:spChg chg="mod">
          <ac:chgData name="Jorgensen, Rick" userId="22b7bd11-eb0f-413f-9bcb-9ce21ec7b0a8" providerId="ADAL" clId="{0566973D-188F-4C4C-9526-C2D46DEF99FC}" dt="2023-08-01T20:02:51.426" v="269" actId="207"/>
          <ac:spMkLst>
            <pc:docMk/>
            <pc:sldMk cId="1669493757" sldId="401"/>
            <ac:spMk id="2" creationId="{A67035C2-4715-E15F-55F2-0611B5831114}"/>
          </ac:spMkLst>
        </pc:spChg>
        <pc:spChg chg="mod">
          <ac:chgData name="Jorgensen, Rick" userId="22b7bd11-eb0f-413f-9bcb-9ce21ec7b0a8" providerId="ADAL" clId="{0566973D-188F-4C4C-9526-C2D46DEF99FC}" dt="2023-08-01T20:02:48.775" v="268" actId="207"/>
          <ac:spMkLst>
            <pc:docMk/>
            <pc:sldMk cId="1669493757" sldId="401"/>
            <ac:spMk id="9" creationId="{090E3AC6-72C7-E48F-824F-47B306FEB8B6}"/>
          </ac:spMkLst>
        </pc:spChg>
        <pc:spChg chg="add del mod">
          <ac:chgData name="Jorgensen, Rick" userId="22b7bd11-eb0f-413f-9bcb-9ce21ec7b0a8" providerId="ADAL" clId="{0566973D-188F-4C4C-9526-C2D46DEF99FC}" dt="2023-08-01T20:01:44.498" v="212" actId="478"/>
          <ac:spMkLst>
            <pc:docMk/>
            <pc:sldMk cId="1669493757" sldId="401"/>
            <ac:spMk id="14" creationId="{7D399B0F-D55A-74C6-A148-F10BD7D51DE7}"/>
          </ac:spMkLst>
        </pc:spChg>
      </pc:sldChg>
      <pc:sldChg chg="addSp delSp modSp mod">
        <pc:chgData name="Jorgensen, Rick" userId="22b7bd11-eb0f-413f-9bcb-9ce21ec7b0a8" providerId="ADAL" clId="{0566973D-188F-4C4C-9526-C2D46DEF99FC}" dt="2023-08-03T19:16:58.329" v="1058" actId="478"/>
        <pc:sldMkLst>
          <pc:docMk/>
          <pc:sldMk cId="1498640041" sldId="403"/>
        </pc:sldMkLst>
        <pc:spChg chg="del mod">
          <ac:chgData name="Jorgensen, Rick" userId="22b7bd11-eb0f-413f-9bcb-9ce21ec7b0a8" providerId="ADAL" clId="{0566973D-188F-4C4C-9526-C2D46DEF99FC}" dt="2023-08-03T19:16:58.329" v="1058" actId="478"/>
          <ac:spMkLst>
            <pc:docMk/>
            <pc:sldMk cId="1498640041" sldId="403"/>
            <ac:spMk id="2" creationId="{17D1D561-2F59-5C4F-5DEB-D61C87E9EF15}"/>
          </ac:spMkLst>
        </pc:spChg>
        <pc:spChg chg="add mod">
          <ac:chgData name="Jorgensen, Rick" userId="22b7bd11-eb0f-413f-9bcb-9ce21ec7b0a8" providerId="ADAL" clId="{0566973D-188F-4C4C-9526-C2D46DEF99FC}" dt="2023-08-01T20:17:15.289" v="338" actId="208"/>
          <ac:spMkLst>
            <pc:docMk/>
            <pc:sldMk cId="1498640041" sldId="403"/>
            <ac:spMk id="4" creationId="{DD7B8007-5E3D-45CD-58B4-240762C12025}"/>
          </ac:spMkLst>
        </pc:spChg>
        <pc:spChg chg="add mod">
          <ac:chgData name="Jorgensen, Rick" userId="22b7bd11-eb0f-413f-9bcb-9ce21ec7b0a8" providerId="ADAL" clId="{0566973D-188F-4C4C-9526-C2D46DEF99FC}" dt="2023-08-01T20:19:10.830" v="396" actId="554"/>
          <ac:spMkLst>
            <pc:docMk/>
            <pc:sldMk cId="1498640041" sldId="403"/>
            <ac:spMk id="5" creationId="{2032185C-7C9D-832F-F8DB-6927DD1B2B43}"/>
          </ac:spMkLst>
        </pc:spChg>
        <pc:spChg chg="add mod">
          <ac:chgData name="Jorgensen, Rick" userId="22b7bd11-eb0f-413f-9bcb-9ce21ec7b0a8" providerId="ADAL" clId="{0566973D-188F-4C4C-9526-C2D46DEF99FC}" dt="2023-08-01T20:19:10.830" v="396" actId="554"/>
          <ac:spMkLst>
            <pc:docMk/>
            <pc:sldMk cId="1498640041" sldId="403"/>
            <ac:spMk id="6" creationId="{B609E1E1-4461-7C8A-8760-6789D4D2BCF2}"/>
          </ac:spMkLst>
        </pc:spChg>
        <pc:spChg chg="add mod">
          <ac:chgData name="Jorgensen, Rick" userId="22b7bd11-eb0f-413f-9bcb-9ce21ec7b0a8" providerId="ADAL" clId="{0566973D-188F-4C4C-9526-C2D46DEF99FC}" dt="2023-08-01T20:19:10.830" v="396" actId="554"/>
          <ac:spMkLst>
            <pc:docMk/>
            <pc:sldMk cId="1498640041" sldId="403"/>
            <ac:spMk id="7" creationId="{77173498-9B50-9BCB-CA1D-F801DDFB5FEC}"/>
          </ac:spMkLst>
        </pc:spChg>
        <pc:spChg chg="add mod">
          <ac:chgData name="Jorgensen, Rick" userId="22b7bd11-eb0f-413f-9bcb-9ce21ec7b0a8" providerId="ADAL" clId="{0566973D-188F-4C4C-9526-C2D46DEF99FC}" dt="2023-08-01T20:19:18.689" v="397" actId="1076"/>
          <ac:spMkLst>
            <pc:docMk/>
            <pc:sldMk cId="1498640041" sldId="403"/>
            <ac:spMk id="8" creationId="{7132C0C5-552C-98A4-1228-CB6A8E934BE5}"/>
          </ac:spMkLst>
        </pc:spChg>
        <pc:spChg chg="mod">
          <ac:chgData name="Jorgensen, Rick" userId="22b7bd11-eb0f-413f-9bcb-9ce21ec7b0a8" providerId="ADAL" clId="{0566973D-188F-4C4C-9526-C2D46DEF99FC}" dt="2023-08-01T20:15:10.051" v="312" actId="1076"/>
          <ac:spMkLst>
            <pc:docMk/>
            <pc:sldMk cId="1498640041" sldId="403"/>
            <ac:spMk id="14" creationId="{23478ECB-C0DB-7751-2BDB-0AC0625EFB69}"/>
          </ac:spMkLst>
        </pc:spChg>
        <pc:spChg chg="mod">
          <ac:chgData name="Jorgensen, Rick" userId="22b7bd11-eb0f-413f-9bcb-9ce21ec7b0a8" providerId="ADAL" clId="{0566973D-188F-4C4C-9526-C2D46DEF99FC}" dt="2023-08-01T20:19:37.262" v="398" actId="207"/>
          <ac:spMkLst>
            <pc:docMk/>
            <pc:sldMk cId="1498640041" sldId="403"/>
            <ac:spMk id="29" creationId="{2E51C695-DD93-3E46-975E-4AD32D674DE1}"/>
          </ac:spMkLst>
        </pc:spChg>
        <pc:spChg chg="add mod">
          <ac:chgData name="Jorgensen, Rick" userId="22b7bd11-eb0f-413f-9bcb-9ce21ec7b0a8" providerId="ADAL" clId="{0566973D-188F-4C4C-9526-C2D46DEF99FC}" dt="2023-08-01T20:31:35.514" v="444" actId="1076"/>
          <ac:spMkLst>
            <pc:docMk/>
            <pc:sldMk cId="1498640041" sldId="403"/>
            <ac:spMk id="46" creationId="{82E3565C-239E-D06F-6DDB-841F260B73A1}"/>
          </ac:spMkLst>
        </pc:spChg>
        <pc:spChg chg="add mod">
          <ac:chgData name="Jorgensen, Rick" userId="22b7bd11-eb0f-413f-9bcb-9ce21ec7b0a8" providerId="ADAL" clId="{0566973D-188F-4C4C-9526-C2D46DEF99FC}" dt="2023-08-01T20:31:24.515" v="441" actId="1076"/>
          <ac:spMkLst>
            <pc:docMk/>
            <pc:sldMk cId="1498640041" sldId="403"/>
            <ac:spMk id="47" creationId="{0C5D52BF-4C59-7E7B-7CB7-C20A4D051FC7}"/>
          </ac:spMkLst>
        </pc:spChg>
        <pc:spChg chg="add mod">
          <ac:chgData name="Jorgensen, Rick" userId="22b7bd11-eb0f-413f-9bcb-9ce21ec7b0a8" providerId="ADAL" clId="{0566973D-188F-4C4C-9526-C2D46DEF99FC}" dt="2023-08-01T20:31:29.504" v="443" actId="1076"/>
          <ac:spMkLst>
            <pc:docMk/>
            <pc:sldMk cId="1498640041" sldId="403"/>
            <ac:spMk id="48" creationId="{9543C4EC-EFE9-43B9-0ABE-11F25C9384A8}"/>
          </ac:spMkLst>
        </pc:spChg>
        <pc:grpChg chg="del mod">
          <ac:chgData name="Jorgensen, Rick" userId="22b7bd11-eb0f-413f-9bcb-9ce21ec7b0a8" providerId="ADAL" clId="{0566973D-188F-4C4C-9526-C2D46DEF99FC}" dt="2023-08-01T20:14:25.796" v="302" actId="478"/>
          <ac:grpSpMkLst>
            <pc:docMk/>
            <pc:sldMk cId="1498640041" sldId="403"/>
            <ac:grpSpMk id="11" creationId="{660C241B-610F-C6C9-28DA-2F5C32967A67}"/>
          </ac:grpSpMkLst>
        </pc:grpChg>
        <pc:grpChg chg="del">
          <ac:chgData name="Jorgensen, Rick" userId="22b7bd11-eb0f-413f-9bcb-9ce21ec7b0a8" providerId="ADAL" clId="{0566973D-188F-4C4C-9526-C2D46DEF99FC}" dt="2023-08-01T20:15:12.021" v="313" actId="478"/>
          <ac:grpSpMkLst>
            <pc:docMk/>
            <pc:sldMk cId="1498640041" sldId="403"/>
            <ac:grpSpMk id="12" creationId="{1B50585F-6C48-890F-D6BD-D343C918731A}"/>
          </ac:grpSpMkLst>
        </pc:grpChg>
        <pc:grpChg chg="del">
          <ac:chgData name="Jorgensen, Rick" userId="22b7bd11-eb0f-413f-9bcb-9ce21ec7b0a8" providerId="ADAL" clId="{0566973D-188F-4C4C-9526-C2D46DEF99FC}" dt="2023-08-01T20:14:27.211" v="303" actId="478"/>
          <ac:grpSpMkLst>
            <pc:docMk/>
            <pc:sldMk cId="1498640041" sldId="403"/>
            <ac:grpSpMk id="22" creationId="{DCF3D9BB-BA75-1C7F-5845-272BB6CB383B}"/>
          </ac:grpSpMkLst>
        </pc:grpChg>
        <pc:grpChg chg="del">
          <ac:chgData name="Jorgensen, Rick" userId="22b7bd11-eb0f-413f-9bcb-9ce21ec7b0a8" providerId="ADAL" clId="{0566973D-188F-4C4C-9526-C2D46DEF99FC}" dt="2023-08-01T20:14:28.493" v="304" actId="478"/>
          <ac:grpSpMkLst>
            <pc:docMk/>
            <pc:sldMk cId="1498640041" sldId="403"/>
            <ac:grpSpMk id="27" creationId="{60D2182B-1BF9-1058-1C88-A01FC67B8A11}"/>
          </ac:grpSpMkLst>
        </pc:grpChg>
        <pc:grpChg chg="del">
          <ac:chgData name="Jorgensen, Rick" userId="22b7bd11-eb0f-413f-9bcb-9ce21ec7b0a8" providerId="ADAL" clId="{0566973D-188F-4C4C-9526-C2D46DEF99FC}" dt="2023-08-01T20:14:29.634" v="305" actId="478"/>
          <ac:grpSpMkLst>
            <pc:docMk/>
            <pc:sldMk cId="1498640041" sldId="403"/>
            <ac:grpSpMk id="33" creationId="{72C80383-82F6-1E78-C7F7-39D1AFDB78D3}"/>
          </ac:grpSpMkLst>
        </pc:grpChg>
        <pc:graphicFrameChg chg="add mod">
          <ac:chgData name="Jorgensen, Rick" userId="22b7bd11-eb0f-413f-9bcb-9ce21ec7b0a8" providerId="ADAL" clId="{0566973D-188F-4C4C-9526-C2D46DEF99FC}" dt="2023-08-01T20:34:12.810" v="474"/>
          <ac:graphicFrameMkLst>
            <pc:docMk/>
            <pc:sldMk cId="1498640041" sldId="403"/>
            <ac:graphicFrameMk id="3" creationId="{AB6268C2-3B80-4C29-8854-0BF14EBD3279}"/>
          </ac:graphicFrameMkLst>
        </pc:graphicFrameChg>
        <pc:graphicFrameChg chg="del">
          <ac:chgData name="Jorgensen, Rick" userId="22b7bd11-eb0f-413f-9bcb-9ce21ec7b0a8" providerId="ADAL" clId="{0566973D-188F-4C4C-9526-C2D46DEF99FC}" dt="2023-08-01T20:13:51.014" v="299" actId="478"/>
          <ac:graphicFrameMkLst>
            <pc:docMk/>
            <pc:sldMk cId="1498640041" sldId="403"/>
            <ac:graphicFrameMk id="10" creationId="{AB6268C2-3B80-4C29-8854-0BF14EBD3279}"/>
          </ac:graphicFrameMkLst>
        </pc:graphicFrameChg>
        <pc:picChg chg="add del mod">
          <ac:chgData name="Jorgensen, Rick" userId="22b7bd11-eb0f-413f-9bcb-9ce21ec7b0a8" providerId="ADAL" clId="{0566973D-188F-4C4C-9526-C2D46DEF99FC}" dt="2023-08-03T19:16:51.636" v="1055" actId="478"/>
          <ac:picMkLst>
            <pc:docMk/>
            <pc:sldMk cId="1498640041" sldId="403"/>
            <ac:picMk id="16" creationId="{7F9774C8-DA8E-A61E-9525-DA4B994DF508}"/>
          </ac:picMkLst>
        </pc:picChg>
        <pc:picChg chg="add del mod">
          <ac:chgData name="Jorgensen, Rick" userId="22b7bd11-eb0f-413f-9bcb-9ce21ec7b0a8" providerId="ADAL" clId="{0566973D-188F-4C4C-9526-C2D46DEF99FC}" dt="2023-08-03T19:16:53.417" v="1056" actId="478"/>
          <ac:picMkLst>
            <pc:docMk/>
            <pc:sldMk cId="1498640041" sldId="403"/>
            <ac:picMk id="38" creationId="{C5C97AA2-32B4-890E-4761-116E18749FAB}"/>
          </ac:picMkLst>
        </pc:picChg>
        <pc:cxnChg chg="add mod">
          <ac:chgData name="Jorgensen, Rick" userId="22b7bd11-eb0f-413f-9bcb-9ce21ec7b0a8" providerId="ADAL" clId="{0566973D-188F-4C4C-9526-C2D46DEF99FC}" dt="2023-08-01T20:28:42.950" v="425" actId="692"/>
          <ac:cxnSpMkLst>
            <pc:docMk/>
            <pc:sldMk cId="1498640041" sldId="403"/>
            <ac:cxnSpMk id="40" creationId="{7BCAB6DA-DA2F-FF19-F27A-AE82D73298C0}"/>
          </ac:cxnSpMkLst>
        </pc:cxnChg>
        <pc:cxnChg chg="add mod">
          <ac:chgData name="Jorgensen, Rick" userId="22b7bd11-eb0f-413f-9bcb-9ce21ec7b0a8" providerId="ADAL" clId="{0566973D-188F-4C4C-9526-C2D46DEF99FC}" dt="2023-08-01T20:28:47.858" v="427" actId="692"/>
          <ac:cxnSpMkLst>
            <pc:docMk/>
            <pc:sldMk cId="1498640041" sldId="403"/>
            <ac:cxnSpMk id="42" creationId="{9A12EB78-BA74-1107-C1AA-A8F4C5988103}"/>
          </ac:cxnSpMkLst>
        </pc:cxnChg>
        <pc:cxnChg chg="add mod">
          <ac:chgData name="Jorgensen, Rick" userId="22b7bd11-eb0f-413f-9bcb-9ce21ec7b0a8" providerId="ADAL" clId="{0566973D-188F-4C4C-9526-C2D46DEF99FC}" dt="2023-08-01T20:28:50.520" v="429" actId="692"/>
          <ac:cxnSpMkLst>
            <pc:docMk/>
            <pc:sldMk cId="1498640041" sldId="403"/>
            <ac:cxnSpMk id="44" creationId="{DF74D20B-BE0F-A27D-989F-F29CF42E5FB8}"/>
          </ac:cxnSpMkLst>
        </pc:cxnChg>
      </pc:sldChg>
      <pc:sldChg chg="del">
        <pc:chgData name="Jorgensen, Rick" userId="22b7bd11-eb0f-413f-9bcb-9ce21ec7b0a8" providerId="ADAL" clId="{0566973D-188F-4C4C-9526-C2D46DEF99FC}" dt="2023-08-01T17:41:45.387" v="2" actId="47"/>
        <pc:sldMkLst>
          <pc:docMk/>
          <pc:sldMk cId="3421980213" sldId="404"/>
        </pc:sldMkLst>
      </pc:sldChg>
      <pc:sldChg chg="del">
        <pc:chgData name="Jorgensen, Rick" userId="22b7bd11-eb0f-413f-9bcb-9ce21ec7b0a8" providerId="ADAL" clId="{0566973D-188F-4C4C-9526-C2D46DEF99FC}" dt="2023-08-01T17:41:45.040" v="1" actId="47"/>
        <pc:sldMkLst>
          <pc:docMk/>
          <pc:sldMk cId="2185191487" sldId="405"/>
        </pc:sldMkLst>
      </pc:sldChg>
      <pc:sldChg chg="del">
        <pc:chgData name="Jorgensen, Rick" userId="22b7bd11-eb0f-413f-9bcb-9ce21ec7b0a8" providerId="ADAL" clId="{0566973D-188F-4C4C-9526-C2D46DEF99FC}" dt="2023-08-01T17:41:53.885" v="15" actId="47"/>
        <pc:sldMkLst>
          <pc:docMk/>
          <pc:sldMk cId="3023127125" sldId="406"/>
        </pc:sldMkLst>
      </pc:sldChg>
      <pc:sldChg chg="delSp modSp mod ord">
        <pc:chgData name="Jorgensen, Rick" userId="22b7bd11-eb0f-413f-9bcb-9ce21ec7b0a8" providerId="ADAL" clId="{0566973D-188F-4C4C-9526-C2D46DEF99FC}" dt="2023-08-03T20:37:21.861" v="1789" actId="20577"/>
        <pc:sldMkLst>
          <pc:docMk/>
          <pc:sldMk cId="2264319159" sldId="408"/>
        </pc:sldMkLst>
        <pc:spChg chg="del mod">
          <ac:chgData name="Jorgensen, Rick" userId="22b7bd11-eb0f-413f-9bcb-9ce21ec7b0a8" providerId="ADAL" clId="{0566973D-188F-4C4C-9526-C2D46DEF99FC}" dt="2023-08-03T19:40:45.218" v="1659" actId="478"/>
          <ac:spMkLst>
            <pc:docMk/>
            <pc:sldMk cId="2264319159" sldId="408"/>
            <ac:spMk id="2" creationId="{C7BC4AC9-55F0-A34C-0E36-E0E54A5C4936}"/>
          </ac:spMkLst>
        </pc:spChg>
        <pc:spChg chg="del">
          <ac:chgData name="Jorgensen, Rick" userId="22b7bd11-eb0f-413f-9bcb-9ce21ec7b0a8" providerId="ADAL" clId="{0566973D-188F-4C4C-9526-C2D46DEF99FC}" dt="2023-08-03T19:40:20.891" v="1650" actId="478"/>
          <ac:spMkLst>
            <pc:docMk/>
            <pc:sldMk cId="2264319159" sldId="408"/>
            <ac:spMk id="3" creationId="{2CBEE1F9-D739-120F-A3B4-7E6DE2B8A648}"/>
          </ac:spMkLst>
        </pc:spChg>
        <pc:spChg chg="del mod">
          <ac:chgData name="Jorgensen, Rick" userId="22b7bd11-eb0f-413f-9bcb-9ce21ec7b0a8" providerId="ADAL" clId="{0566973D-188F-4C4C-9526-C2D46DEF99FC}" dt="2023-08-03T19:40:38.262" v="1657" actId="478"/>
          <ac:spMkLst>
            <pc:docMk/>
            <pc:sldMk cId="2264319159" sldId="408"/>
            <ac:spMk id="4" creationId="{BA8AFA7A-54C4-A2FE-02DA-3CD76CF0C5E3}"/>
          </ac:spMkLst>
        </pc:spChg>
        <pc:spChg chg="del">
          <ac:chgData name="Jorgensen, Rick" userId="22b7bd11-eb0f-413f-9bcb-9ce21ec7b0a8" providerId="ADAL" clId="{0566973D-188F-4C4C-9526-C2D46DEF99FC}" dt="2023-08-01T21:21:11.485" v="672" actId="478"/>
          <ac:spMkLst>
            <pc:docMk/>
            <pc:sldMk cId="2264319159" sldId="408"/>
            <ac:spMk id="7" creationId="{26939D55-B6EB-1805-9ACB-748C824D15DD}"/>
          </ac:spMkLst>
        </pc:spChg>
        <pc:spChg chg="mod">
          <ac:chgData name="Jorgensen, Rick" userId="22b7bd11-eb0f-413f-9bcb-9ce21ec7b0a8" providerId="ADAL" clId="{0566973D-188F-4C4C-9526-C2D46DEF99FC}" dt="2023-08-03T19:40:42.256" v="1658" actId="1076"/>
          <ac:spMkLst>
            <pc:docMk/>
            <pc:sldMk cId="2264319159" sldId="408"/>
            <ac:spMk id="8" creationId="{627942DB-E913-E84F-DA5F-E3A249FA3908}"/>
          </ac:spMkLst>
        </pc:spChg>
        <pc:spChg chg="del">
          <ac:chgData name="Jorgensen, Rick" userId="22b7bd11-eb0f-413f-9bcb-9ce21ec7b0a8" providerId="ADAL" clId="{0566973D-188F-4C4C-9526-C2D46DEF99FC}" dt="2023-08-03T19:40:24.865" v="1653" actId="478"/>
          <ac:spMkLst>
            <pc:docMk/>
            <pc:sldMk cId="2264319159" sldId="408"/>
            <ac:spMk id="9" creationId="{16C98FF7-C9E9-8046-A859-D9A599468A34}"/>
          </ac:spMkLst>
        </pc:spChg>
        <pc:spChg chg="del">
          <ac:chgData name="Jorgensen, Rick" userId="22b7bd11-eb0f-413f-9bcb-9ce21ec7b0a8" providerId="ADAL" clId="{0566973D-188F-4C4C-9526-C2D46DEF99FC}" dt="2023-08-03T19:40:26.073" v="1654" actId="478"/>
          <ac:spMkLst>
            <pc:docMk/>
            <pc:sldMk cId="2264319159" sldId="408"/>
            <ac:spMk id="10" creationId="{9F84E2A2-11BF-6249-A2DF-0BE34D738A76}"/>
          </ac:spMkLst>
        </pc:spChg>
        <pc:spChg chg="mod">
          <ac:chgData name="Jorgensen, Rick" userId="22b7bd11-eb0f-413f-9bcb-9ce21ec7b0a8" providerId="ADAL" clId="{0566973D-188F-4C4C-9526-C2D46DEF99FC}" dt="2023-08-02T00:39:07.748" v="1016" actId="20577"/>
          <ac:spMkLst>
            <pc:docMk/>
            <pc:sldMk cId="2264319159" sldId="408"/>
            <ac:spMk id="13" creationId="{17223BBD-BD68-A3C5-875F-E0DF77012F65}"/>
          </ac:spMkLst>
        </pc:spChg>
        <pc:spChg chg="mod">
          <ac:chgData name="Jorgensen, Rick" userId="22b7bd11-eb0f-413f-9bcb-9ce21ec7b0a8" providerId="ADAL" clId="{0566973D-188F-4C4C-9526-C2D46DEF99FC}" dt="2023-08-03T19:40:42.256" v="1658" actId="1076"/>
          <ac:spMkLst>
            <pc:docMk/>
            <pc:sldMk cId="2264319159" sldId="408"/>
            <ac:spMk id="14" creationId="{156CE65C-A549-44C4-F8D6-ED4B92254675}"/>
          </ac:spMkLst>
        </pc:spChg>
        <pc:spChg chg="mod">
          <ac:chgData name="Jorgensen, Rick" userId="22b7bd11-eb0f-413f-9bcb-9ce21ec7b0a8" providerId="ADAL" clId="{0566973D-188F-4C4C-9526-C2D46DEF99FC}" dt="2023-08-03T19:40:42.256" v="1658" actId="1076"/>
          <ac:spMkLst>
            <pc:docMk/>
            <pc:sldMk cId="2264319159" sldId="408"/>
            <ac:spMk id="17" creationId="{02ECCAB9-A8AC-24FB-7845-8BF54152DD86}"/>
          </ac:spMkLst>
        </pc:spChg>
        <pc:spChg chg="mod">
          <ac:chgData name="Jorgensen, Rick" userId="22b7bd11-eb0f-413f-9bcb-9ce21ec7b0a8" providerId="ADAL" clId="{0566973D-188F-4C4C-9526-C2D46DEF99FC}" dt="2023-08-03T19:40:42.256" v="1658" actId="1076"/>
          <ac:spMkLst>
            <pc:docMk/>
            <pc:sldMk cId="2264319159" sldId="408"/>
            <ac:spMk id="18" creationId="{3FA7D0C5-ABB7-8048-BD96-32E18AC34425}"/>
          </ac:spMkLst>
        </pc:spChg>
        <pc:spChg chg="mod">
          <ac:chgData name="Jorgensen, Rick" userId="22b7bd11-eb0f-413f-9bcb-9ce21ec7b0a8" providerId="ADAL" clId="{0566973D-188F-4C4C-9526-C2D46DEF99FC}" dt="2023-08-03T19:40:42.256" v="1658" actId="1076"/>
          <ac:spMkLst>
            <pc:docMk/>
            <pc:sldMk cId="2264319159" sldId="408"/>
            <ac:spMk id="19" creationId="{D5401852-59DF-2725-2EDF-E6796BFD9EE4}"/>
          </ac:spMkLst>
        </pc:spChg>
        <pc:spChg chg="mod">
          <ac:chgData name="Jorgensen, Rick" userId="22b7bd11-eb0f-413f-9bcb-9ce21ec7b0a8" providerId="ADAL" clId="{0566973D-188F-4C4C-9526-C2D46DEF99FC}" dt="2023-08-03T19:40:42.256" v="1658" actId="1076"/>
          <ac:spMkLst>
            <pc:docMk/>
            <pc:sldMk cId="2264319159" sldId="408"/>
            <ac:spMk id="20" creationId="{A02BF9A5-5622-4BF3-B873-FDF2956CB763}"/>
          </ac:spMkLst>
        </pc:spChg>
        <pc:spChg chg="mod">
          <ac:chgData name="Jorgensen, Rick" userId="22b7bd11-eb0f-413f-9bcb-9ce21ec7b0a8" providerId="ADAL" clId="{0566973D-188F-4C4C-9526-C2D46DEF99FC}" dt="2023-08-03T19:40:42.256" v="1658" actId="1076"/>
          <ac:spMkLst>
            <pc:docMk/>
            <pc:sldMk cId="2264319159" sldId="408"/>
            <ac:spMk id="22" creationId="{29EEF589-D58B-7963-62BD-2F4300CCF26B}"/>
          </ac:spMkLst>
        </pc:spChg>
        <pc:spChg chg="mod">
          <ac:chgData name="Jorgensen, Rick" userId="22b7bd11-eb0f-413f-9bcb-9ce21ec7b0a8" providerId="ADAL" clId="{0566973D-188F-4C4C-9526-C2D46DEF99FC}" dt="2023-08-03T20:37:21.861" v="1789" actId="20577"/>
          <ac:spMkLst>
            <pc:docMk/>
            <pc:sldMk cId="2264319159" sldId="408"/>
            <ac:spMk id="25" creationId="{43DF711F-4684-B34D-9236-D3A26D348F11}"/>
          </ac:spMkLst>
        </pc:spChg>
        <pc:spChg chg="mod">
          <ac:chgData name="Jorgensen, Rick" userId="22b7bd11-eb0f-413f-9bcb-9ce21ec7b0a8" providerId="ADAL" clId="{0566973D-188F-4C4C-9526-C2D46DEF99FC}" dt="2023-08-03T19:40:42.256" v="1658" actId="1076"/>
          <ac:spMkLst>
            <pc:docMk/>
            <pc:sldMk cId="2264319159" sldId="408"/>
            <ac:spMk id="30" creationId="{3D48DC1C-90A7-8867-CD77-A30256D274E3}"/>
          </ac:spMkLst>
        </pc:spChg>
        <pc:spChg chg="del mod topLvl">
          <ac:chgData name="Jorgensen, Rick" userId="22b7bd11-eb0f-413f-9bcb-9ce21ec7b0a8" providerId="ADAL" clId="{0566973D-188F-4C4C-9526-C2D46DEF99FC}" dt="2023-08-03T19:40:22.156" v="1651" actId="478"/>
          <ac:spMkLst>
            <pc:docMk/>
            <pc:sldMk cId="2264319159" sldId="408"/>
            <ac:spMk id="31" creationId="{1780F414-B5FA-B5ED-4ECE-42C5CA3D7C74}"/>
          </ac:spMkLst>
        </pc:spChg>
        <pc:spChg chg="del topLvl">
          <ac:chgData name="Jorgensen, Rick" userId="22b7bd11-eb0f-413f-9bcb-9ce21ec7b0a8" providerId="ADAL" clId="{0566973D-188F-4C4C-9526-C2D46DEF99FC}" dt="2023-08-03T19:40:23.198" v="1652" actId="478"/>
          <ac:spMkLst>
            <pc:docMk/>
            <pc:sldMk cId="2264319159" sldId="408"/>
            <ac:spMk id="33" creationId="{C0BEA176-77D8-CDD1-9079-4E9E8965D112}"/>
          </ac:spMkLst>
        </pc:spChg>
        <pc:spChg chg="mod">
          <ac:chgData name="Jorgensen, Rick" userId="22b7bd11-eb0f-413f-9bcb-9ce21ec7b0a8" providerId="ADAL" clId="{0566973D-188F-4C4C-9526-C2D46DEF99FC}" dt="2023-08-03T19:40:42.256" v="1658" actId="1076"/>
          <ac:spMkLst>
            <pc:docMk/>
            <pc:sldMk cId="2264319159" sldId="408"/>
            <ac:spMk id="34" creationId="{0D4D6E56-2E19-5E64-D2CC-96CF321057CB}"/>
          </ac:spMkLst>
        </pc:spChg>
        <pc:spChg chg="mod">
          <ac:chgData name="Jorgensen, Rick" userId="22b7bd11-eb0f-413f-9bcb-9ce21ec7b0a8" providerId="ADAL" clId="{0566973D-188F-4C4C-9526-C2D46DEF99FC}" dt="2023-08-03T19:40:42.256" v="1658" actId="1076"/>
          <ac:spMkLst>
            <pc:docMk/>
            <pc:sldMk cId="2264319159" sldId="408"/>
            <ac:spMk id="35" creationId="{95339A7D-727D-DBD1-4212-1C3838AE2D04}"/>
          </ac:spMkLst>
        </pc:spChg>
        <pc:spChg chg="mod">
          <ac:chgData name="Jorgensen, Rick" userId="22b7bd11-eb0f-413f-9bcb-9ce21ec7b0a8" providerId="ADAL" clId="{0566973D-188F-4C4C-9526-C2D46DEF99FC}" dt="2023-08-03T19:40:42.256" v="1658" actId="1076"/>
          <ac:spMkLst>
            <pc:docMk/>
            <pc:sldMk cId="2264319159" sldId="408"/>
            <ac:spMk id="36" creationId="{7958BDEF-7F54-86B7-417D-6E2F5FF1EBE4}"/>
          </ac:spMkLst>
        </pc:spChg>
        <pc:spChg chg="mod ord">
          <ac:chgData name="Jorgensen, Rick" userId="22b7bd11-eb0f-413f-9bcb-9ce21ec7b0a8" providerId="ADAL" clId="{0566973D-188F-4C4C-9526-C2D46DEF99FC}" dt="2023-08-03T19:40:42.256" v="1658" actId="1076"/>
          <ac:spMkLst>
            <pc:docMk/>
            <pc:sldMk cId="2264319159" sldId="408"/>
            <ac:spMk id="37" creationId="{73579EB4-AE44-3CD5-82E0-87B7EC08E83A}"/>
          </ac:spMkLst>
        </pc:spChg>
        <pc:grpChg chg="del">
          <ac:chgData name="Jorgensen, Rick" userId="22b7bd11-eb0f-413f-9bcb-9ce21ec7b0a8" providerId="ADAL" clId="{0566973D-188F-4C4C-9526-C2D46DEF99FC}" dt="2023-08-03T19:40:22.156" v="1651" actId="478"/>
          <ac:grpSpMkLst>
            <pc:docMk/>
            <pc:sldMk cId="2264319159" sldId="408"/>
            <ac:grpSpMk id="6" creationId="{9536570B-187C-20CB-F1E2-3451D8577D5B}"/>
          </ac:grpSpMkLst>
        </pc:grpChg>
        <pc:grpChg chg="mod">
          <ac:chgData name="Jorgensen, Rick" userId="22b7bd11-eb0f-413f-9bcb-9ce21ec7b0a8" providerId="ADAL" clId="{0566973D-188F-4C4C-9526-C2D46DEF99FC}" dt="2023-08-03T19:40:42.256" v="1658" actId="1076"/>
          <ac:grpSpMkLst>
            <pc:docMk/>
            <pc:sldMk cId="2264319159" sldId="408"/>
            <ac:grpSpMk id="11" creationId="{F15114B5-9AE8-15A9-F83F-9112797F4535}"/>
          </ac:grpSpMkLst>
        </pc:grpChg>
        <pc:graphicFrameChg chg="mod">
          <ac:chgData name="Jorgensen, Rick" userId="22b7bd11-eb0f-413f-9bcb-9ce21ec7b0a8" providerId="ADAL" clId="{0566973D-188F-4C4C-9526-C2D46DEF99FC}" dt="2023-08-03T19:40:42.256" v="1658" actId="1076"/>
          <ac:graphicFrameMkLst>
            <pc:docMk/>
            <pc:sldMk cId="2264319159" sldId="408"/>
            <ac:graphicFrameMk id="5" creationId="{AE1F7F2C-2903-49BF-8D46-B74042A4DF30}"/>
          </ac:graphicFrameMkLst>
        </pc:graphicFrameChg>
        <pc:graphicFrameChg chg="del mod">
          <ac:chgData name="Jorgensen, Rick" userId="22b7bd11-eb0f-413f-9bcb-9ce21ec7b0a8" providerId="ADAL" clId="{0566973D-188F-4C4C-9526-C2D46DEF99FC}" dt="2023-08-03T19:40:19.641" v="1649" actId="478"/>
          <ac:graphicFrameMkLst>
            <pc:docMk/>
            <pc:sldMk cId="2264319159" sldId="408"/>
            <ac:graphicFrameMk id="39" creationId="{7BB3A9BD-A127-4B41-B92F-A1864F1BB2EF}"/>
          </ac:graphicFrameMkLst>
        </pc:graphicFrameChg>
      </pc:sldChg>
      <pc:sldChg chg="modSp mod ord modNotesTx">
        <pc:chgData name="Jorgensen, Rick" userId="22b7bd11-eb0f-413f-9bcb-9ce21ec7b0a8" providerId="ADAL" clId="{0566973D-188F-4C4C-9526-C2D46DEF99FC}" dt="2023-08-03T20:37:23.940" v="1791" actId="20577"/>
        <pc:sldMkLst>
          <pc:docMk/>
          <pc:sldMk cId="2818941781" sldId="409"/>
        </pc:sldMkLst>
        <pc:spChg chg="mod">
          <ac:chgData name="Jorgensen, Rick" userId="22b7bd11-eb0f-413f-9bcb-9ce21ec7b0a8" providerId="ADAL" clId="{0566973D-188F-4C4C-9526-C2D46DEF99FC}" dt="2023-08-03T20:37:23.940" v="1791" actId="20577"/>
          <ac:spMkLst>
            <pc:docMk/>
            <pc:sldMk cId="2818941781" sldId="409"/>
            <ac:spMk id="2" creationId="{00000000-0000-0000-0000-000000000000}"/>
          </ac:spMkLst>
        </pc:spChg>
        <pc:spChg chg="mod">
          <ac:chgData name="Jorgensen, Rick" userId="22b7bd11-eb0f-413f-9bcb-9ce21ec7b0a8" providerId="ADAL" clId="{0566973D-188F-4C4C-9526-C2D46DEF99FC}" dt="2023-08-03T19:41:05.290" v="1667" actId="20577"/>
          <ac:spMkLst>
            <pc:docMk/>
            <pc:sldMk cId="2818941781" sldId="409"/>
            <ac:spMk id="3" creationId="{00000000-0000-0000-0000-000000000000}"/>
          </ac:spMkLst>
        </pc:spChg>
      </pc:sldChg>
      <pc:sldChg chg="addSp delSp modSp mod">
        <pc:chgData name="Jorgensen, Rick" userId="22b7bd11-eb0f-413f-9bcb-9ce21ec7b0a8" providerId="ADAL" clId="{0566973D-188F-4C4C-9526-C2D46DEF99FC}" dt="2023-08-03T18:44:11.700" v="1025" actId="1076"/>
        <pc:sldMkLst>
          <pc:docMk/>
          <pc:sldMk cId="969353579" sldId="411"/>
        </pc:sldMkLst>
        <pc:spChg chg="mod">
          <ac:chgData name="Jorgensen, Rick" userId="22b7bd11-eb0f-413f-9bcb-9ce21ec7b0a8" providerId="ADAL" clId="{0566973D-188F-4C4C-9526-C2D46DEF99FC}" dt="2023-08-03T18:44:05.850" v="1024" actId="1076"/>
          <ac:spMkLst>
            <pc:docMk/>
            <pc:sldMk cId="969353579" sldId="411"/>
            <ac:spMk id="3" creationId="{1A462FE6-0F7A-01F0-9AF2-F3F16D36ABAB}"/>
          </ac:spMkLst>
        </pc:spChg>
        <pc:spChg chg="add del mod">
          <ac:chgData name="Jorgensen, Rick" userId="22b7bd11-eb0f-413f-9bcb-9ce21ec7b0a8" providerId="ADAL" clId="{0566973D-188F-4C4C-9526-C2D46DEF99FC}" dt="2023-08-01T20:54:07.299" v="553" actId="478"/>
          <ac:spMkLst>
            <pc:docMk/>
            <pc:sldMk cId="969353579" sldId="411"/>
            <ac:spMk id="4" creationId="{BD6617CD-2148-D3A6-A86C-1AECB90BF571}"/>
          </ac:spMkLst>
        </pc:spChg>
        <pc:spChg chg="mod">
          <ac:chgData name="Jorgensen, Rick" userId="22b7bd11-eb0f-413f-9bcb-9ce21ec7b0a8" providerId="ADAL" clId="{0566973D-188F-4C4C-9526-C2D46DEF99FC}" dt="2023-08-01T21:19:04.743" v="659" actId="1076"/>
          <ac:spMkLst>
            <pc:docMk/>
            <pc:sldMk cId="969353579" sldId="411"/>
            <ac:spMk id="10" creationId="{7522894A-B4AC-36B0-5629-F20EC9F4B9FC}"/>
          </ac:spMkLst>
        </pc:spChg>
        <pc:spChg chg="mod">
          <ac:chgData name="Jorgensen, Rick" userId="22b7bd11-eb0f-413f-9bcb-9ce21ec7b0a8" providerId="ADAL" clId="{0566973D-188F-4C4C-9526-C2D46DEF99FC}" dt="2023-08-01T21:19:09.075" v="660" actId="1076"/>
          <ac:spMkLst>
            <pc:docMk/>
            <pc:sldMk cId="969353579" sldId="411"/>
            <ac:spMk id="11" creationId="{EF4D9831-160A-4CD3-10DC-6541144E8A9A}"/>
          </ac:spMkLst>
        </pc:spChg>
        <pc:spChg chg="mod">
          <ac:chgData name="Jorgensen, Rick" userId="22b7bd11-eb0f-413f-9bcb-9ce21ec7b0a8" providerId="ADAL" clId="{0566973D-188F-4C4C-9526-C2D46DEF99FC}" dt="2023-08-01T21:19:04.743" v="659" actId="1076"/>
          <ac:spMkLst>
            <pc:docMk/>
            <pc:sldMk cId="969353579" sldId="411"/>
            <ac:spMk id="12" creationId="{CF6FBB5F-FA38-2245-30C4-D451AF10E3FB}"/>
          </ac:spMkLst>
        </pc:spChg>
        <pc:spChg chg="mod">
          <ac:chgData name="Jorgensen, Rick" userId="22b7bd11-eb0f-413f-9bcb-9ce21ec7b0a8" providerId="ADAL" clId="{0566973D-188F-4C4C-9526-C2D46DEF99FC}" dt="2023-08-01T21:18:41.721" v="655" actId="14100"/>
          <ac:spMkLst>
            <pc:docMk/>
            <pc:sldMk cId="969353579" sldId="411"/>
            <ac:spMk id="13" creationId="{911BA559-AAEB-1D23-6B7F-319764FA4494}"/>
          </ac:spMkLst>
        </pc:spChg>
        <pc:spChg chg="mod">
          <ac:chgData name="Jorgensen, Rick" userId="22b7bd11-eb0f-413f-9bcb-9ce21ec7b0a8" providerId="ADAL" clId="{0566973D-188F-4C4C-9526-C2D46DEF99FC}" dt="2023-08-01T20:54:00.960" v="551" actId="207"/>
          <ac:spMkLst>
            <pc:docMk/>
            <pc:sldMk cId="969353579" sldId="411"/>
            <ac:spMk id="25" creationId="{43DF711F-4684-B34D-9236-D3A26D348F11}"/>
          </ac:spMkLst>
        </pc:spChg>
        <pc:spChg chg="mod">
          <ac:chgData name="Jorgensen, Rick" userId="22b7bd11-eb0f-413f-9bcb-9ce21ec7b0a8" providerId="ADAL" clId="{0566973D-188F-4C4C-9526-C2D46DEF99FC}" dt="2023-08-03T18:44:11.700" v="1025" actId="1076"/>
          <ac:spMkLst>
            <pc:docMk/>
            <pc:sldMk cId="969353579" sldId="411"/>
            <ac:spMk id="41" creationId="{66DA6F02-7D4C-D65E-6836-19D0B5646E8F}"/>
          </ac:spMkLst>
        </pc:spChg>
        <pc:grpChg chg="mod">
          <ac:chgData name="Jorgensen, Rick" userId="22b7bd11-eb0f-413f-9bcb-9ce21ec7b0a8" providerId="ADAL" clId="{0566973D-188F-4C4C-9526-C2D46DEF99FC}" dt="2023-08-01T21:19:27.909" v="661" actId="1076"/>
          <ac:grpSpMkLst>
            <pc:docMk/>
            <pc:sldMk cId="969353579" sldId="411"/>
            <ac:grpSpMk id="21" creationId="{CC56C904-0BDB-5A14-493D-83F762479834}"/>
          </ac:grpSpMkLst>
        </pc:grpChg>
        <pc:graphicFrameChg chg="del mod">
          <ac:chgData name="Jorgensen, Rick" userId="22b7bd11-eb0f-413f-9bcb-9ce21ec7b0a8" providerId="ADAL" clId="{0566973D-188F-4C4C-9526-C2D46DEF99FC}" dt="2023-08-01T21:18:27.030" v="650" actId="478"/>
          <ac:graphicFrameMkLst>
            <pc:docMk/>
            <pc:sldMk cId="969353579" sldId="411"/>
            <ac:graphicFrameMk id="2" creationId="{13D7C20C-3EBD-4E3D-9B74-1FF6413849C7}"/>
          </ac:graphicFrameMkLst>
        </pc:graphicFrameChg>
        <pc:graphicFrameChg chg="add mod ord">
          <ac:chgData name="Jorgensen, Rick" userId="22b7bd11-eb0f-413f-9bcb-9ce21ec7b0a8" providerId="ADAL" clId="{0566973D-188F-4C4C-9526-C2D46DEF99FC}" dt="2023-08-03T18:43:43.094" v="1022" actId="692"/>
          <ac:graphicFrameMkLst>
            <pc:docMk/>
            <pc:sldMk cId="969353579" sldId="411"/>
            <ac:graphicFrameMk id="5" creationId="{13D7C20C-3EBD-4E3D-9B74-1FF6413849C7}"/>
          </ac:graphicFrameMkLst>
        </pc:graphicFrameChg>
      </pc:sldChg>
      <pc:sldChg chg="addSp delSp modSp mod">
        <pc:chgData name="Jorgensen, Rick" userId="22b7bd11-eb0f-413f-9bcb-9ce21ec7b0a8" providerId="ADAL" clId="{0566973D-188F-4C4C-9526-C2D46DEF99FC}" dt="2023-08-03T20:24:26.898" v="1768" actId="478"/>
        <pc:sldMkLst>
          <pc:docMk/>
          <pc:sldMk cId="2783075774" sldId="412"/>
        </pc:sldMkLst>
        <pc:spChg chg="mod">
          <ac:chgData name="Jorgensen, Rick" userId="22b7bd11-eb0f-413f-9bcb-9ce21ec7b0a8" providerId="ADAL" clId="{0566973D-188F-4C4C-9526-C2D46DEF99FC}" dt="2023-08-01T21:09:51.838" v="578" actId="1076"/>
          <ac:spMkLst>
            <pc:docMk/>
            <pc:sldMk cId="2783075774" sldId="412"/>
            <ac:spMk id="2" creationId="{B48A3ED1-53E0-F941-6AA9-DAE13A3FA945}"/>
          </ac:spMkLst>
        </pc:spChg>
        <pc:spChg chg="mod">
          <ac:chgData name="Jorgensen, Rick" userId="22b7bd11-eb0f-413f-9bcb-9ce21ec7b0a8" providerId="ADAL" clId="{0566973D-188F-4C4C-9526-C2D46DEF99FC}" dt="2023-08-03T20:23:47.593" v="1764" actId="1076"/>
          <ac:spMkLst>
            <pc:docMk/>
            <pc:sldMk cId="2783075774" sldId="412"/>
            <ac:spMk id="3" creationId="{1A462FE6-0F7A-01F0-9AF2-F3F16D36ABAB}"/>
          </ac:spMkLst>
        </pc:spChg>
        <pc:spChg chg="mod">
          <ac:chgData name="Jorgensen, Rick" userId="22b7bd11-eb0f-413f-9bcb-9ce21ec7b0a8" providerId="ADAL" clId="{0566973D-188F-4C4C-9526-C2D46DEF99FC}" dt="2023-08-01T21:08:53.808" v="570" actId="1076"/>
          <ac:spMkLst>
            <pc:docMk/>
            <pc:sldMk cId="2783075774" sldId="412"/>
            <ac:spMk id="5" creationId="{BB28D932-BBBA-3DA2-597D-5FCC93A19672}"/>
          </ac:spMkLst>
        </pc:spChg>
        <pc:spChg chg="mod">
          <ac:chgData name="Jorgensen, Rick" userId="22b7bd11-eb0f-413f-9bcb-9ce21ec7b0a8" providerId="ADAL" clId="{0566973D-188F-4C4C-9526-C2D46DEF99FC}" dt="2023-08-01T21:10:10.835" v="584" actId="1076"/>
          <ac:spMkLst>
            <pc:docMk/>
            <pc:sldMk cId="2783075774" sldId="412"/>
            <ac:spMk id="6" creationId="{97725DA6-3936-B5AA-8772-05CDAB3D6953}"/>
          </ac:spMkLst>
        </pc:spChg>
        <pc:spChg chg="add del mod">
          <ac:chgData name="Jorgensen, Rick" userId="22b7bd11-eb0f-413f-9bcb-9ce21ec7b0a8" providerId="ADAL" clId="{0566973D-188F-4C4C-9526-C2D46DEF99FC}" dt="2023-08-03T20:24:18.489" v="1767" actId="478"/>
          <ac:spMkLst>
            <pc:docMk/>
            <pc:sldMk cId="2783075774" sldId="412"/>
            <ac:spMk id="7" creationId="{C0134FDB-A444-49D1-DA85-5AB219044E0D}"/>
          </ac:spMkLst>
        </pc:spChg>
        <pc:spChg chg="mod">
          <ac:chgData name="Jorgensen, Rick" userId="22b7bd11-eb0f-413f-9bcb-9ce21ec7b0a8" providerId="ADAL" clId="{0566973D-188F-4C4C-9526-C2D46DEF99FC}" dt="2023-08-01T21:10:39.549" v="589" actId="1076"/>
          <ac:spMkLst>
            <pc:docMk/>
            <pc:sldMk cId="2783075774" sldId="412"/>
            <ac:spMk id="8" creationId="{C137511A-E5B2-A3E5-3904-E608F5FC6331}"/>
          </ac:spMkLst>
        </pc:spChg>
        <pc:spChg chg="mod">
          <ac:chgData name="Jorgensen, Rick" userId="22b7bd11-eb0f-413f-9bcb-9ce21ec7b0a8" providerId="ADAL" clId="{0566973D-188F-4C4C-9526-C2D46DEF99FC}" dt="2023-08-01T21:08:53.808" v="570" actId="1076"/>
          <ac:spMkLst>
            <pc:docMk/>
            <pc:sldMk cId="2783075774" sldId="412"/>
            <ac:spMk id="9" creationId="{2F0EA6C4-CA91-DAD4-8FC2-C8519E9CAC83}"/>
          </ac:spMkLst>
        </pc:spChg>
        <pc:spChg chg="mod">
          <ac:chgData name="Jorgensen, Rick" userId="22b7bd11-eb0f-413f-9bcb-9ce21ec7b0a8" providerId="ADAL" clId="{0566973D-188F-4C4C-9526-C2D46DEF99FC}" dt="2023-08-01T21:08:53.808" v="570" actId="1076"/>
          <ac:spMkLst>
            <pc:docMk/>
            <pc:sldMk cId="2783075774" sldId="412"/>
            <ac:spMk id="10" creationId="{7522894A-B4AC-36B0-5629-F20EC9F4B9FC}"/>
          </ac:spMkLst>
        </pc:spChg>
        <pc:spChg chg="del mod">
          <ac:chgData name="Jorgensen, Rick" userId="22b7bd11-eb0f-413f-9bcb-9ce21ec7b0a8" providerId="ADAL" clId="{0566973D-188F-4C4C-9526-C2D46DEF99FC}" dt="2023-08-01T21:11:48.712" v="617" actId="478"/>
          <ac:spMkLst>
            <pc:docMk/>
            <pc:sldMk cId="2783075774" sldId="412"/>
            <ac:spMk id="11" creationId="{EF4D9831-160A-4CD3-10DC-6541144E8A9A}"/>
          </ac:spMkLst>
        </pc:spChg>
        <pc:spChg chg="mod ord">
          <ac:chgData name="Jorgensen, Rick" userId="22b7bd11-eb0f-413f-9bcb-9ce21ec7b0a8" providerId="ADAL" clId="{0566973D-188F-4C4C-9526-C2D46DEF99FC}" dt="2023-08-01T21:11:37.387" v="612" actId="20577"/>
          <ac:spMkLst>
            <pc:docMk/>
            <pc:sldMk cId="2783075774" sldId="412"/>
            <ac:spMk id="12" creationId="{CF6FBB5F-FA38-2245-30C4-D451AF10E3FB}"/>
          </ac:spMkLst>
        </pc:spChg>
        <pc:spChg chg="mod">
          <ac:chgData name="Jorgensen, Rick" userId="22b7bd11-eb0f-413f-9bcb-9ce21ec7b0a8" providerId="ADAL" clId="{0566973D-188F-4C4C-9526-C2D46DEF99FC}" dt="2023-08-01T21:09:56.050" v="579" actId="1076"/>
          <ac:spMkLst>
            <pc:docMk/>
            <pc:sldMk cId="2783075774" sldId="412"/>
            <ac:spMk id="13" creationId="{17A0C391-6265-722A-0433-5D317B131458}"/>
          </ac:spMkLst>
        </pc:spChg>
        <pc:spChg chg="mod ord">
          <ac:chgData name="Jorgensen, Rick" userId="22b7bd11-eb0f-413f-9bcb-9ce21ec7b0a8" providerId="ADAL" clId="{0566973D-188F-4C4C-9526-C2D46DEF99FC}" dt="2023-08-01T21:10:32.953" v="588" actId="1076"/>
          <ac:spMkLst>
            <pc:docMk/>
            <pc:sldMk cId="2783075774" sldId="412"/>
            <ac:spMk id="15" creationId="{1BA55689-1E02-D64A-AEF5-1140E4E5B817}"/>
          </ac:spMkLst>
        </pc:spChg>
        <pc:spChg chg="mod">
          <ac:chgData name="Jorgensen, Rick" userId="22b7bd11-eb0f-413f-9bcb-9ce21ec7b0a8" providerId="ADAL" clId="{0566973D-188F-4C4C-9526-C2D46DEF99FC}" dt="2023-08-01T21:11:22.509" v="604" actId="553"/>
          <ac:spMkLst>
            <pc:docMk/>
            <pc:sldMk cId="2783075774" sldId="412"/>
            <ac:spMk id="16" creationId="{F6896C2B-CBB5-05DA-365A-A6C391468130}"/>
          </ac:spMkLst>
        </pc:spChg>
        <pc:spChg chg="mod">
          <ac:chgData name="Jorgensen, Rick" userId="22b7bd11-eb0f-413f-9bcb-9ce21ec7b0a8" providerId="ADAL" clId="{0566973D-188F-4C4C-9526-C2D46DEF99FC}" dt="2023-08-01T21:11:22.509" v="604" actId="553"/>
          <ac:spMkLst>
            <pc:docMk/>
            <pc:sldMk cId="2783075774" sldId="412"/>
            <ac:spMk id="22" creationId="{643FF9F1-47ED-7EF0-5443-853893D04C68}"/>
          </ac:spMkLst>
        </pc:spChg>
        <pc:spChg chg="mod">
          <ac:chgData name="Jorgensen, Rick" userId="22b7bd11-eb0f-413f-9bcb-9ce21ec7b0a8" providerId="ADAL" clId="{0566973D-188F-4C4C-9526-C2D46DEF99FC}" dt="2023-08-01T21:11:22.509" v="604" actId="553"/>
          <ac:spMkLst>
            <pc:docMk/>
            <pc:sldMk cId="2783075774" sldId="412"/>
            <ac:spMk id="23" creationId="{CD5A92D5-6B39-B5FE-0486-71A7C8609BC2}"/>
          </ac:spMkLst>
        </pc:spChg>
        <pc:spChg chg="del mod">
          <ac:chgData name="Jorgensen, Rick" userId="22b7bd11-eb0f-413f-9bcb-9ce21ec7b0a8" providerId="ADAL" clId="{0566973D-188F-4C4C-9526-C2D46DEF99FC}" dt="2023-08-01T21:09:48.067" v="577" actId="478"/>
          <ac:spMkLst>
            <pc:docMk/>
            <pc:sldMk cId="2783075774" sldId="412"/>
            <ac:spMk id="24" creationId="{02A7DFAB-A4E9-9DC8-E3BB-C80A5F5FB494}"/>
          </ac:spMkLst>
        </pc:spChg>
        <pc:spChg chg="mod">
          <ac:chgData name="Jorgensen, Rick" userId="22b7bd11-eb0f-413f-9bcb-9ce21ec7b0a8" providerId="ADAL" clId="{0566973D-188F-4C4C-9526-C2D46DEF99FC}" dt="2023-08-01T21:13:30.927" v="633" actId="207"/>
          <ac:spMkLst>
            <pc:docMk/>
            <pc:sldMk cId="2783075774" sldId="412"/>
            <ac:spMk id="25" creationId="{43DF711F-4684-B34D-9236-D3A26D348F11}"/>
          </ac:spMkLst>
        </pc:spChg>
        <pc:spChg chg="mod">
          <ac:chgData name="Jorgensen, Rick" userId="22b7bd11-eb0f-413f-9bcb-9ce21ec7b0a8" providerId="ADAL" clId="{0566973D-188F-4C4C-9526-C2D46DEF99FC}" dt="2023-08-01T21:10:05.960" v="583" actId="1076"/>
          <ac:spMkLst>
            <pc:docMk/>
            <pc:sldMk cId="2783075774" sldId="412"/>
            <ac:spMk id="31" creationId="{84AC0E23-8A21-4C94-5E51-05A97A7607A0}"/>
          </ac:spMkLst>
        </pc:spChg>
        <pc:spChg chg="mod">
          <ac:chgData name="Jorgensen, Rick" userId="22b7bd11-eb0f-413f-9bcb-9ce21ec7b0a8" providerId="ADAL" clId="{0566973D-188F-4C4C-9526-C2D46DEF99FC}" dt="2023-08-01T21:09:43.184" v="575" actId="1076"/>
          <ac:spMkLst>
            <pc:docMk/>
            <pc:sldMk cId="2783075774" sldId="412"/>
            <ac:spMk id="32" creationId="{671FB36C-C53D-1383-B1A7-C6B28182FB4E}"/>
          </ac:spMkLst>
        </pc:spChg>
        <pc:spChg chg="del mod">
          <ac:chgData name="Jorgensen, Rick" userId="22b7bd11-eb0f-413f-9bcb-9ce21ec7b0a8" providerId="ADAL" clId="{0566973D-188F-4C4C-9526-C2D46DEF99FC}" dt="2023-08-03T20:24:26.898" v="1768" actId="478"/>
          <ac:spMkLst>
            <pc:docMk/>
            <pc:sldMk cId="2783075774" sldId="412"/>
            <ac:spMk id="33" creationId="{AE9B9143-6439-A491-DC8A-6D1ED72DE22D}"/>
          </ac:spMkLst>
        </pc:spChg>
        <pc:spChg chg="add mod">
          <ac:chgData name="Jorgensen, Rick" userId="22b7bd11-eb0f-413f-9bcb-9ce21ec7b0a8" providerId="ADAL" clId="{0566973D-188F-4C4C-9526-C2D46DEF99FC}" dt="2023-08-01T21:10:54.885" v="594" actId="1076"/>
          <ac:spMkLst>
            <pc:docMk/>
            <pc:sldMk cId="2783075774" sldId="412"/>
            <ac:spMk id="35" creationId="{5BA76D43-7A3C-3578-A466-85AE4C925389}"/>
          </ac:spMkLst>
        </pc:spChg>
        <pc:spChg chg="add mod">
          <ac:chgData name="Jorgensen, Rick" userId="22b7bd11-eb0f-413f-9bcb-9ce21ec7b0a8" providerId="ADAL" clId="{0566973D-188F-4C4C-9526-C2D46DEF99FC}" dt="2023-08-01T21:11:45.139" v="616" actId="20577"/>
          <ac:spMkLst>
            <pc:docMk/>
            <pc:sldMk cId="2783075774" sldId="412"/>
            <ac:spMk id="36" creationId="{5158A9ED-00DD-D319-050C-1D4F1D9B9882}"/>
          </ac:spMkLst>
        </pc:spChg>
        <pc:spChg chg="mod">
          <ac:chgData name="Jorgensen, Rick" userId="22b7bd11-eb0f-413f-9bcb-9ce21ec7b0a8" providerId="ADAL" clId="{0566973D-188F-4C4C-9526-C2D46DEF99FC}" dt="2023-08-01T21:08:53.808" v="570" actId="1076"/>
          <ac:spMkLst>
            <pc:docMk/>
            <pc:sldMk cId="2783075774" sldId="412"/>
            <ac:spMk id="40" creationId="{DDDF0E5A-3974-79DF-0FE1-B6DF8F6D1D64}"/>
          </ac:spMkLst>
        </pc:spChg>
        <pc:spChg chg="mod">
          <ac:chgData name="Jorgensen, Rick" userId="22b7bd11-eb0f-413f-9bcb-9ce21ec7b0a8" providerId="ADAL" clId="{0566973D-188F-4C4C-9526-C2D46DEF99FC}" dt="2023-08-03T18:43:57.133" v="1023" actId="1076"/>
          <ac:spMkLst>
            <pc:docMk/>
            <pc:sldMk cId="2783075774" sldId="412"/>
            <ac:spMk id="41" creationId="{66DA6F02-7D4C-D65E-6836-19D0B5646E8F}"/>
          </ac:spMkLst>
        </pc:spChg>
        <pc:grpChg chg="mod">
          <ac:chgData name="Jorgensen, Rick" userId="22b7bd11-eb0f-413f-9bcb-9ce21ec7b0a8" providerId="ADAL" clId="{0566973D-188F-4C4C-9526-C2D46DEF99FC}" dt="2023-08-01T21:13:21.964" v="632" actId="1076"/>
          <ac:grpSpMkLst>
            <pc:docMk/>
            <pc:sldMk cId="2783075774" sldId="412"/>
            <ac:grpSpMk id="21" creationId="{CC56C904-0BDB-5A14-493D-83F762479834}"/>
          </ac:grpSpMkLst>
        </pc:grpChg>
        <pc:grpChg chg="mod">
          <ac:chgData name="Jorgensen, Rick" userId="22b7bd11-eb0f-413f-9bcb-9ce21ec7b0a8" providerId="ADAL" clId="{0566973D-188F-4C4C-9526-C2D46DEF99FC}" dt="2023-08-01T21:10:03.899" v="582" actId="1076"/>
          <ac:grpSpMkLst>
            <pc:docMk/>
            <pc:sldMk cId="2783075774" sldId="412"/>
            <ac:grpSpMk id="26" creationId="{54BD471A-6DE7-603B-C7E1-93A0D7EACCCD}"/>
          </ac:grpSpMkLst>
        </pc:grpChg>
        <pc:graphicFrameChg chg="del">
          <ac:chgData name="Jorgensen, Rick" userId="22b7bd11-eb0f-413f-9bcb-9ce21ec7b0a8" providerId="ADAL" clId="{0566973D-188F-4C4C-9526-C2D46DEF99FC}" dt="2023-08-01T21:08:17.445" v="561" actId="478"/>
          <ac:graphicFrameMkLst>
            <pc:docMk/>
            <pc:sldMk cId="2783075774" sldId="412"/>
            <ac:graphicFrameMk id="4" creationId="{BC0289C9-88C8-4E03-837C-113225E7B331}"/>
          </ac:graphicFrameMkLst>
        </pc:graphicFrameChg>
        <pc:graphicFrameChg chg="add mod ord">
          <ac:chgData name="Jorgensen, Rick" userId="22b7bd11-eb0f-413f-9bcb-9ce21ec7b0a8" providerId="ADAL" clId="{0566973D-188F-4C4C-9526-C2D46DEF99FC}" dt="2023-08-03T20:23:44.698" v="1763" actId="1076"/>
          <ac:graphicFrameMkLst>
            <pc:docMk/>
            <pc:sldMk cId="2783075774" sldId="412"/>
            <ac:graphicFrameMk id="4" creationId="{D2CC10A6-67CF-4C23-B38D-3611ECA572F3}"/>
          </ac:graphicFrameMkLst>
        </pc:graphicFrameChg>
        <pc:graphicFrameChg chg="del mod">
          <ac:chgData name="Jorgensen, Rick" userId="22b7bd11-eb0f-413f-9bcb-9ce21ec7b0a8" providerId="ADAL" clId="{0566973D-188F-4C4C-9526-C2D46DEF99FC}" dt="2023-08-01T21:09:19.026" v="571" actId="478"/>
          <ac:graphicFrameMkLst>
            <pc:docMk/>
            <pc:sldMk cId="2783075774" sldId="412"/>
            <ac:graphicFrameMk id="7" creationId="{D2CC10A6-67CF-4C23-B38D-3611ECA572F3}"/>
          </ac:graphicFrameMkLst>
        </pc:graphicFrameChg>
        <pc:graphicFrameChg chg="add del mod ord">
          <ac:chgData name="Jorgensen, Rick" userId="22b7bd11-eb0f-413f-9bcb-9ce21ec7b0a8" providerId="ADAL" clId="{0566973D-188F-4C4C-9526-C2D46DEF99FC}" dt="2023-08-03T20:23:30.505" v="1759" actId="478"/>
          <ac:graphicFrameMkLst>
            <pc:docMk/>
            <pc:sldMk cId="2783075774" sldId="412"/>
            <ac:graphicFrameMk id="14" creationId="{D2CC10A6-67CF-4C23-B38D-3611ECA572F3}"/>
          </ac:graphicFrameMkLst>
        </pc:graphicFrameChg>
        <pc:graphicFrameChg chg="add mod ord">
          <ac:chgData name="Jorgensen, Rick" userId="22b7bd11-eb0f-413f-9bcb-9ce21ec7b0a8" providerId="ADAL" clId="{0566973D-188F-4C4C-9526-C2D46DEF99FC}" dt="2023-08-01T21:10:49.811" v="592" actId="14100"/>
          <ac:graphicFrameMkLst>
            <pc:docMk/>
            <pc:sldMk cId="2783075774" sldId="412"/>
            <ac:graphicFrameMk id="34" creationId="{BC0289C9-88C8-4E03-837C-113225E7B331}"/>
          </ac:graphicFrameMkLst>
        </pc:graphicFrameChg>
      </pc:sldChg>
      <pc:sldChg chg="modSp mod">
        <pc:chgData name="Jorgensen, Rick" userId="22b7bd11-eb0f-413f-9bcb-9ce21ec7b0a8" providerId="ADAL" clId="{0566973D-188F-4C4C-9526-C2D46DEF99FC}" dt="2023-08-02T00:40:22.243" v="1018" actId="20577"/>
        <pc:sldMkLst>
          <pc:docMk/>
          <pc:sldMk cId="1709919940" sldId="414"/>
        </pc:sldMkLst>
        <pc:spChg chg="mod">
          <ac:chgData name="Jorgensen, Rick" userId="22b7bd11-eb0f-413f-9bcb-9ce21ec7b0a8" providerId="ADAL" clId="{0566973D-188F-4C4C-9526-C2D46DEF99FC}" dt="2023-08-02T00:40:22.243" v="1018" actId="20577"/>
          <ac:spMkLst>
            <pc:docMk/>
            <pc:sldMk cId="1709919940" sldId="414"/>
            <ac:spMk id="3" creationId="{00000000-0000-0000-0000-000000000000}"/>
          </ac:spMkLst>
        </pc:spChg>
      </pc:sldChg>
      <pc:sldChg chg="modSp mod">
        <pc:chgData name="Jorgensen, Rick" userId="22b7bd11-eb0f-413f-9bcb-9ce21ec7b0a8" providerId="ADAL" clId="{0566973D-188F-4C4C-9526-C2D46DEF99FC}" dt="2023-08-02T00:41:03.586" v="1020" actId="20577"/>
        <pc:sldMkLst>
          <pc:docMk/>
          <pc:sldMk cId="4212414396" sldId="415"/>
        </pc:sldMkLst>
        <pc:spChg chg="mod">
          <ac:chgData name="Jorgensen, Rick" userId="22b7bd11-eb0f-413f-9bcb-9ce21ec7b0a8" providerId="ADAL" clId="{0566973D-188F-4C4C-9526-C2D46DEF99FC}" dt="2023-08-01T20:32:08.975" v="451" actId="207"/>
          <ac:spMkLst>
            <pc:docMk/>
            <pc:sldMk cId="4212414396" sldId="415"/>
            <ac:spMk id="2" creationId="{00000000-0000-0000-0000-000000000000}"/>
          </ac:spMkLst>
        </pc:spChg>
        <pc:spChg chg="mod">
          <ac:chgData name="Jorgensen, Rick" userId="22b7bd11-eb0f-413f-9bcb-9ce21ec7b0a8" providerId="ADAL" clId="{0566973D-188F-4C4C-9526-C2D46DEF99FC}" dt="2023-08-02T00:41:03.586" v="1020" actId="20577"/>
          <ac:spMkLst>
            <pc:docMk/>
            <pc:sldMk cId="4212414396" sldId="415"/>
            <ac:spMk id="3" creationId="{00000000-0000-0000-0000-000000000000}"/>
          </ac:spMkLst>
        </pc:spChg>
      </pc:sldChg>
      <pc:sldChg chg="modSp del mod">
        <pc:chgData name="Jorgensen, Rick" userId="22b7bd11-eb0f-413f-9bcb-9ce21ec7b0a8" providerId="ADAL" clId="{0566973D-188F-4C4C-9526-C2D46DEF99FC}" dt="2023-08-03T18:45:34.152" v="1028" actId="47"/>
        <pc:sldMkLst>
          <pc:docMk/>
          <pc:sldMk cId="4097523969" sldId="417"/>
        </pc:sldMkLst>
        <pc:spChg chg="mod">
          <ac:chgData name="Jorgensen, Rick" userId="22b7bd11-eb0f-413f-9bcb-9ce21ec7b0a8" providerId="ADAL" clId="{0566973D-188F-4C4C-9526-C2D46DEF99FC}" dt="2023-08-02T00:14:02.027" v="898" actId="20577"/>
          <ac:spMkLst>
            <pc:docMk/>
            <pc:sldMk cId="4097523969" sldId="417"/>
            <ac:spMk id="2" creationId="{8B5AADCD-8D30-1DE0-29A6-A19B735BC60A}"/>
          </ac:spMkLst>
        </pc:spChg>
        <pc:graphicFrameChg chg="mod">
          <ac:chgData name="Jorgensen, Rick" userId="22b7bd11-eb0f-413f-9bcb-9ce21ec7b0a8" providerId="ADAL" clId="{0566973D-188F-4C4C-9526-C2D46DEF99FC}" dt="2023-08-02T00:28:32.015" v="915" actId="692"/>
          <ac:graphicFrameMkLst>
            <pc:docMk/>
            <pc:sldMk cId="4097523969" sldId="417"/>
            <ac:graphicFrameMk id="5" creationId="{D4CCACB4-4E67-4B42-B1F7-EB2D9C2F572E}"/>
          </ac:graphicFrameMkLst>
        </pc:graphicFrameChg>
      </pc:sldChg>
      <pc:sldChg chg="modSp mod">
        <pc:chgData name="Jorgensen, Rick" userId="22b7bd11-eb0f-413f-9bcb-9ce21ec7b0a8" providerId="ADAL" clId="{0566973D-188F-4C4C-9526-C2D46DEF99FC}" dt="2023-08-03T19:41:40.690" v="1700" actId="207"/>
        <pc:sldMkLst>
          <pc:docMk/>
          <pc:sldMk cId="4043107919" sldId="418"/>
        </pc:sldMkLst>
        <pc:spChg chg="mod">
          <ac:chgData name="Jorgensen, Rick" userId="22b7bd11-eb0f-413f-9bcb-9ce21ec7b0a8" providerId="ADAL" clId="{0566973D-188F-4C4C-9526-C2D46DEF99FC}" dt="2023-08-03T19:41:40.690" v="1700" actId="207"/>
          <ac:spMkLst>
            <pc:docMk/>
            <pc:sldMk cId="4043107919" sldId="418"/>
            <ac:spMk id="2" creationId="{00000000-0000-0000-0000-000000000000}"/>
          </ac:spMkLst>
        </pc:spChg>
        <pc:spChg chg="mod">
          <ac:chgData name="Jorgensen, Rick" userId="22b7bd11-eb0f-413f-9bcb-9ce21ec7b0a8" providerId="ADAL" clId="{0566973D-188F-4C4C-9526-C2D46DEF99FC}" dt="2023-08-02T00:39:49.371" v="1017" actId="20577"/>
          <ac:spMkLst>
            <pc:docMk/>
            <pc:sldMk cId="4043107919" sldId="418"/>
            <ac:spMk id="3" creationId="{00000000-0000-0000-0000-000000000000}"/>
          </ac:spMkLst>
        </pc:spChg>
      </pc:sldChg>
      <pc:sldChg chg="addSp delSp modSp mod">
        <pc:chgData name="Jorgensen, Rick" userId="22b7bd11-eb0f-413f-9bcb-9ce21ec7b0a8" providerId="ADAL" clId="{0566973D-188F-4C4C-9526-C2D46DEF99FC}" dt="2023-08-03T19:41:43.966" v="1701" actId="478"/>
        <pc:sldMkLst>
          <pc:docMk/>
          <pc:sldMk cId="1551454966" sldId="419"/>
        </pc:sldMkLst>
        <pc:spChg chg="del mod">
          <ac:chgData name="Jorgensen, Rick" userId="22b7bd11-eb0f-413f-9bcb-9ce21ec7b0a8" providerId="ADAL" clId="{0566973D-188F-4C4C-9526-C2D46DEF99FC}" dt="2023-08-03T19:41:43.966" v="1701" actId="478"/>
          <ac:spMkLst>
            <pc:docMk/>
            <pc:sldMk cId="1551454966" sldId="419"/>
            <ac:spMk id="2" creationId="{E4AB3438-02A3-FCA3-6BEE-117F2F89AB1D}"/>
          </ac:spMkLst>
        </pc:spChg>
        <pc:spChg chg="add mod">
          <ac:chgData name="Jorgensen, Rick" userId="22b7bd11-eb0f-413f-9bcb-9ce21ec7b0a8" providerId="ADAL" clId="{0566973D-188F-4C4C-9526-C2D46DEF99FC}" dt="2023-08-01T20:35:17.840" v="505" actId="554"/>
          <ac:spMkLst>
            <pc:docMk/>
            <pc:sldMk cId="1551454966" sldId="419"/>
            <ac:spMk id="3" creationId="{A9911829-125C-2AF7-3570-AF5B472CF4F9}"/>
          </ac:spMkLst>
        </pc:spChg>
        <pc:spChg chg="add mod">
          <ac:chgData name="Jorgensen, Rick" userId="22b7bd11-eb0f-413f-9bcb-9ce21ec7b0a8" providerId="ADAL" clId="{0566973D-188F-4C4C-9526-C2D46DEF99FC}" dt="2023-08-01T20:35:27.853" v="507" actId="1076"/>
          <ac:spMkLst>
            <pc:docMk/>
            <pc:sldMk cId="1551454966" sldId="419"/>
            <ac:spMk id="4" creationId="{CA8E73CD-369F-0B3A-47A4-727DC48EE995}"/>
          </ac:spMkLst>
        </pc:spChg>
        <pc:spChg chg="add mod">
          <ac:chgData name="Jorgensen, Rick" userId="22b7bd11-eb0f-413f-9bcb-9ce21ec7b0a8" providerId="ADAL" clId="{0566973D-188F-4C4C-9526-C2D46DEF99FC}" dt="2023-08-01T20:35:24.396" v="506" actId="1076"/>
          <ac:spMkLst>
            <pc:docMk/>
            <pc:sldMk cId="1551454966" sldId="419"/>
            <ac:spMk id="5" creationId="{937AEC2F-1FFC-9213-F3B3-CB64E79EF898}"/>
          </ac:spMkLst>
        </pc:spChg>
        <pc:spChg chg="mod">
          <ac:chgData name="Jorgensen, Rick" userId="22b7bd11-eb0f-413f-9bcb-9ce21ec7b0a8" providerId="ADAL" clId="{0566973D-188F-4C4C-9526-C2D46DEF99FC}" dt="2023-08-01T20:35:17.840" v="505" actId="554"/>
          <ac:spMkLst>
            <pc:docMk/>
            <pc:sldMk cId="1551454966" sldId="419"/>
            <ac:spMk id="19" creationId="{672A4FC3-3D56-829F-2976-0E0C208F8297}"/>
          </ac:spMkLst>
        </pc:spChg>
        <pc:spChg chg="del">
          <ac:chgData name="Jorgensen, Rick" userId="22b7bd11-eb0f-413f-9bcb-9ce21ec7b0a8" providerId="ADAL" clId="{0566973D-188F-4C4C-9526-C2D46DEF99FC}" dt="2023-08-01T20:33:38.130" v="459" actId="478"/>
          <ac:spMkLst>
            <pc:docMk/>
            <pc:sldMk cId="1551454966" sldId="419"/>
            <ac:spMk id="20" creationId="{2528A491-AA50-60E3-6310-24435633F104}"/>
          </ac:spMkLst>
        </pc:spChg>
        <pc:spChg chg="del">
          <ac:chgData name="Jorgensen, Rick" userId="22b7bd11-eb0f-413f-9bcb-9ce21ec7b0a8" providerId="ADAL" clId="{0566973D-188F-4C4C-9526-C2D46DEF99FC}" dt="2023-08-01T20:33:47.653" v="466" actId="478"/>
          <ac:spMkLst>
            <pc:docMk/>
            <pc:sldMk cId="1551454966" sldId="419"/>
            <ac:spMk id="23" creationId="{3C341047-FD9F-DF12-634D-79C97FE1D07B}"/>
          </ac:spMkLst>
        </pc:spChg>
        <pc:spChg chg="mod">
          <ac:chgData name="Jorgensen, Rick" userId="22b7bd11-eb0f-413f-9bcb-9ce21ec7b0a8" providerId="ADAL" clId="{0566973D-188F-4C4C-9526-C2D46DEF99FC}" dt="2023-08-01T20:49:50.994" v="538" actId="207"/>
          <ac:spMkLst>
            <pc:docMk/>
            <pc:sldMk cId="1551454966" sldId="419"/>
            <ac:spMk id="25" creationId="{43DF711F-4684-B34D-9236-D3A26D348F11}"/>
          </ac:spMkLst>
        </pc:spChg>
        <pc:spChg chg="del">
          <ac:chgData name="Jorgensen, Rick" userId="22b7bd11-eb0f-413f-9bcb-9ce21ec7b0a8" providerId="ADAL" clId="{0566973D-188F-4C4C-9526-C2D46DEF99FC}" dt="2023-08-01T20:33:39.406" v="460" actId="478"/>
          <ac:spMkLst>
            <pc:docMk/>
            <pc:sldMk cId="1551454966" sldId="419"/>
            <ac:spMk id="42" creationId="{791B78AD-8DB3-6DB6-F6A9-DDD906D220C5}"/>
          </ac:spMkLst>
        </pc:spChg>
        <pc:spChg chg="del">
          <ac:chgData name="Jorgensen, Rick" userId="22b7bd11-eb0f-413f-9bcb-9ce21ec7b0a8" providerId="ADAL" clId="{0566973D-188F-4C4C-9526-C2D46DEF99FC}" dt="2023-08-01T20:33:40.622" v="461" actId="478"/>
          <ac:spMkLst>
            <pc:docMk/>
            <pc:sldMk cId="1551454966" sldId="419"/>
            <ac:spMk id="43" creationId="{9248024D-CADF-9502-669A-BD87314121FB}"/>
          </ac:spMkLst>
        </pc:spChg>
        <pc:spChg chg="del">
          <ac:chgData name="Jorgensen, Rick" userId="22b7bd11-eb0f-413f-9bcb-9ce21ec7b0a8" providerId="ADAL" clId="{0566973D-188F-4C4C-9526-C2D46DEF99FC}" dt="2023-08-01T20:33:45.593" v="464" actId="478"/>
          <ac:spMkLst>
            <pc:docMk/>
            <pc:sldMk cId="1551454966" sldId="419"/>
            <ac:spMk id="45" creationId="{93016FDB-1635-B52B-E5CC-109D3D3A5EC7}"/>
          </ac:spMkLst>
        </pc:spChg>
        <pc:spChg chg="mod">
          <ac:chgData name="Jorgensen, Rick" userId="22b7bd11-eb0f-413f-9bcb-9ce21ec7b0a8" providerId="ADAL" clId="{0566973D-188F-4C4C-9526-C2D46DEF99FC}" dt="2023-08-01T20:41:49.465" v="536" actId="1076"/>
          <ac:spMkLst>
            <pc:docMk/>
            <pc:sldMk cId="1551454966" sldId="419"/>
            <ac:spMk id="53" creationId="{6396E680-00D0-8F82-1816-555E623E2E69}"/>
          </ac:spMkLst>
        </pc:spChg>
        <pc:spChg chg="mod">
          <ac:chgData name="Jorgensen, Rick" userId="22b7bd11-eb0f-413f-9bcb-9ce21ec7b0a8" providerId="ADAL" clId="{0566973D-188F-4C4C-9526-C2D46DEF99FC}" dt="2023-08-01T20:41:49.465" v="536" actId="1076"/>
          <ac:spMkLst>
            <pc:docMk/>
            <pc:sldMk cId="1551454966" sldId="419"/>
            <ac:spMk id="54" creationId="{AF1A4DE1-431E-F8D2-F34E-B86711B93E41}"/>
          </ac:spMkLst>
        </pc:spChg>
        <pc:spChg chg="mod">
          <ac:chgData name="Jorgensen, Rick" userId="22b7bd11-eb0f-413f-9bcb-9ce21ec7b0a8" providerId="ADAL" clId="{0566973D-188F-4C4C-9526-C2D46DEF99FC}" dt="2023-08-01T20:41:49.465" v="536" actId="1076"/>
          <ac:spMkLst>
            <pc:docMk/>
            <pc:sldMk cId="1551454966" sldId="419"/>
            <ac:spMk id="55" creationId="{62636936-5942-8106-460E-CC1AC237CC3A}"/>
          </ac:spMkLst>
        </pc:spChg>
        <pc:graphicFrameChg chg="add mod ord">
          <ac:chgData name="Jorgensen, Rick" userId="22b7bd11-eb0f-413f-9bcb-9ce21ec7b0a8" providerId="ADAL" clId="{0566973D-188F-4C4C-9526-C2D46DEF99FC}" dt="2023-08-01T21:22:38.622" v="689"/>
          <ac:graphicFrameMkLst>
            <pc:docMk/>
            <pc:sldMk cId="1551454966" sldId="419"/>
            <ac:graphicFrameMk id="9" creationId="{4936B1E3-6CC8-4944-870F-DC784E261689}"/>
          </ac:graphicFrameMkLst>
        </pc:graphicFrameChg>
        <pc:graphicFrameChg chg="add del mod">
          <ac:chgData name="Jorgensen, Rick" userId="22b7bd11-eb0f-413f-9bcb-9ce21ec7b0a8" providerId="ADAL" clId="{0566973D-188F-4C4C-9526-C2D46DEF99FC}" dt="2023-08-01T20:40:59.658" v="528" actId="478"/>
          <ac:graphicFrameMkLst>
            <pc:docMk/>
            <pc:sldMk cId="1551454966" sldId="419"/>
            <ac:graphicFrameMk id="14" creationId="{4936B1E3-6CC8-4944-870F-DC784E261689}"/>
          </ac:graphicFrameMkLst>
        </pc:graphicFrameChg>
        <pc:cxnChg chg="del">
          <ac:chgData name="Jorgensen, Rick" userId="22b7bd11-eb0f-413f-9bcb-9ce21ec7b0a8" providerId="ADAL" clId="{0566973D-188F-4C4C-9526-C2D46DEF99FC}" dt="2023-08-01T20:33:48.406" v="467" actId="478"/>
          <ac:cxnSpMkLst>
            <pc:docMk/>
            <pc:sldMk cId="1551454966" sldId="419"/>
            <ac:cxnSpMk id="22" creationId="{9D89CD87-22E7-3F67-0AD6-B11D79286539}"/>
          </ac:cxnSpMkLst>
        </pc:cxnChg>
        <pc:cxnChg chg="del">
          <ac:chgData name="Jorgensen, Rick" userId="22b7bd11-eb0f-413f-9bcb-9ce21ec7b0a8" providerId="ADAL" clId="{0566973D-188F-4C4C-9526-C2D46DEF99FC}" dt="2023-08-01T20:33:46.357" v="465" actId="478"/>
          <ac:cxnSpMkLst>
            <pc:docMk/>
            <pc:sldMk cId="1551454966" sldId="419"/>
            <ac:cxnSpMk id="44" creationId="{C0B642FE-BBB8-764F-C259-C15A86DC5DE1}"/>
          </ac:cxnSpMkLst>
        </pc:cxnChg>
        <pc:cxnChg chg="mod">
          <ac:chgData name="Jorgensen, Rick" userId="22b7bd11-eb0f-413f-9bcb-9ce21ec7b0a8" providerId="ADAL" clId="{0566973D-188F-4C4C-9526-C2D46DEF99FC}" dt="2023-08-01T20:41:49.465" v="536" actId="1076"/>
          <ac:cxnSpMkLst>
            <pc:docMk/>
            <pc:sldMk cId="1551454966" sldId="419"/>
            <ac:cxnSpMk id="47" creationId="{41CF870C-618E-C86D-36B2-57490FC42E41}"/>
          </ac:cxnSpMkLst>
        </pc:cxnChg>
        <pc:cxnChg chg="mod">
          <ac:chgData name="Jorgensen, Rick" userId="22b7bd11-eb0f-413f-9bcb-9ce21ec7b0a8" providerId="ADAL" clId="{0566973D-188F-4C4C-9526-C2D46DEF99FC}" dt="2023-08-01T20:41:49.465" v="536" actId="1076"/>
          <ac:cxnSpMkLst>
            <pc:docMk/>
            <pc:sldMk cId="1551454966" sldId="419"/>
            <ac:cxnSpMk id="49" creationId="{2EC63D4A-D56C-05F2-F952-D9466476B9B9}"/>
          </ac:cxnSpMkLst>
        </pc:cxnChg>
        <pc:cxnChg chg="mod">
          <ac:chgData name="Jorgensen, Rick" userId="22b7bd11-eb0f-413f-9bcb-9ce21ec7b0a8" providerId="ADAL" clId="{0566973D-188F-4C4C-9526-C2D46DEF99FC}" dt="2023-08-01T20:41:49.465" v="536" actId="1076"/>
          <ac:cxnSpMkLst>
            <pc:docMk/>
            <pc:sldMk cId="1551454966" sldId="419"/>
            <ac:cxnSpMk id="51" creationId="{F32A2DA8-3CEB-1B7B-3F28-CFCCEE994F48}"/>
          </ac:cxnSpMkLst>
        </pc:cxnChg>
      </pc:sldChg>
      <pc:sldChg chg="modSp mod">
        <pc:chgData name="Jorgensen, Rick" userId="22b7bd11-eb0f-413f-9bcb-9ce21ec7b0a8" providerId="ADAL" clId="{0566973D-188F-4C4C-9526-C2D46DEF99FC}" dt="2023-08-01T20:42:12.622" v="537"/>
        <pc:sldMkLst>
          <pc:docMk/>
          <pc:sldMk cId="946471094" sldId="420"/>
        </pc:sldMkLst>
        <pc:spChg chg="mod">
          <ac:chgData name="Jorgensen, Rick" userId="22b7bd11-eb0f-413f-9bcb-9ce21ec7b0a8" providerId="ADAL" clId="{0566973D-188F-4C4C-9526-C2D46DEF99FC}" dt="2023-08-01T20:42:12.622" v="537"/>
          <ac:spMkLst>
            <pc:docMk/>
            <pc:sldMk cId="946471094" sldId="420"/>
            <ac:spMk id="3" creationId="{00000000-0000-0000-0000-000000000000}"/>
          </ac:spMkLst>
        </pc:spChg>
      </pc:sldChg>
      <pc:sldChg chg="modSp mod">
        <pc:chgData name="Jorgensen, Rick" userId="22b7bd11-eb0f-413f-9bcb-9ce21ec7b0a8" providerId="ADAL" clId="{0566973D-188F-4C4C-9526-C2D46DEF99FC}" dt="2023-08-03T20:37:30.184" v="1795" actId="20577"/>
        <pc:sldMkLst>
          <pc:docMk/>
          <pc:sldMk cId="1169520667" sldId="422"/>
        </pc:sldMkLst>
        <pc:spChg chg="mod">
          <ac:chgData name="Jorgensen, Rick" userId="22b7bd11-eb0f-413f-9bcb-9ce21ec7b0a8" providerId="ADAL" clId="{0566973D-188F-4C4C-9526-C2D46DEF99FC}" dt="2023-08-03T20:37:30.184" v="1795" actId="20577"/>
          <ac:spMkLst>
            <pc:docMk/>
            <pc:sldMk cId="1169520667" sldId="422"/>
            <ac:spMk id="2" creationId="{00000000-0000-0000-0000-000000000000}"/>
          </ac:spMkLst>
        </pc:spChg>
      </pc:sldChg>
      <pc:sldChg chg="addSp delSp modSp mod">
        <pc:chgData name="Jorgensen, Rick" userId="22b7bd11-eb0f-413f-9bcb-9ce21ec7b0a8" providerId="ADAL" clId="{0566973D-188F-4C4C-9526-C2D46DEF99FC}" dt="2023-08-03T20:37:28.089" v="1793" actId="20577"/>
        <pc:sldMkLst>
          <pc:docMk/>
          <pc:sldMk cId="1781225942" sldId="424"/>
        </pc:sldMkLst>
        <pc:spChg chg="add del mod">
          <ac:chgData name="Jorgensen, Rick" userId="22b7bd11-eb0f-413f-9bcb-9ce21ec7b0a8" providerId="ADAL" clId="{0566973D-188F-4C4C-9526-C2D46DEF99FC}" dt="2023-08-03T20:31:06.756" v="1783" actId="478"/>
          <ac:spMkLst>
            <pc:docMk/>
            <pc:sldMk cId="1781225942" sldId="424"/>
            <ac:spMk id="7" creationId="{982A5796-55E8-4760-4C04-D970007647C2}"/>
          </ac:spMkLst>
        </pc:spChg>
        <pc:spChg chg="mod">
          <ac:chgData name="Jorgensen, Rick" userId="22b7bd11-eb0f-413f-9bcb-9ce21ec7b0a8" providerId="ADAL" clId="{0566973D-188F-4C4C-9526-C2D46DEF99FC}" dt="2023-08-03T20:37:28.089" v="1793" actId="20577"/>
          <ac:spMkLst>
            <pc:docMk/>
            <pc:sldMk cId="1781225942" sldId="424"/>
            <ac:spMk id="25" creationId="{43DF711F-4684-B34D-9236-D3A26D348F11}"/>
          </ac:spMkLst>
        </pc:spChg>
        <pc:picChg chg="mod">
          <ac:chgData name="Jorgensen, Rick" userId="22b7bd11-eb0f-413f-9bcb-9ce21ec7b0a8" providerId="ADAL" clId="{0566973D-188F-4C4C-9526-C2D46DEF99FC}" dt="2023-08-01T21:14:22.249" v="640" actId="408"/>
          <ac:picMkLst>
            <pc:docMk/>
            <pc:sldMk cId="1781225942" sldId="424"/>
            <ac:picMk id="102" creationId="{B23D2D46-5729-78AB-69A0-765DE47B96D4}"/>
          </ac:picMkLst>
        </pc:picChg>
      </pc:sldChg>
      <pc:sldChg chg="del">
        <pc:chgData name="Jorgensen, Rick" userId="22b7bd11-eb0f-413f-9bcb-9ce21ec7b0a8" providerId="ADAL" clId="{0566973D-188F-4C4C-9526-C2D46DEF99FC}" dt="2023-08-01T17:41:53.028" v="11" actId="47"/>
        <pc:sldMkLst>
          <pc:docMk/>
          <pc:sldMk cId="2024394527" sldId="425"/>
        </pc:sldMkLst>
      </pc:sldChg>
      <pc:sldChg chg="del">
        <pc:chgData name="Jorgensen, Rick" userId="22b7bd11-eb0f-413f-9bcb-9ce21ec7b0a8" providerId="ADAL" clId="{0566973D-188F-4C4C-9526-C2D46DEF99FC}" dt="2023-08-01T17:41:52.318" v="10" actId="47"/>
        <pc:sldMkLst>
          <pc:docMk/>
          <pc:sldMk cId="2703005835" sldId="426"/>
        </pc:sldMkLst>
      </pc:sldChg>
      <pc:sldChg chg="del">
        <pc:chgData name="Jorgensen, Rick" userId="22b7bd11-eb0f-413f-9bcb-9ce21ec7b0a8" providerId="ADAL" clId="{0566973D-188F-4C4C-9526-C2D46DEF99FC}" dt="2023-08-01T17:41:51.590" v="6" actId="47"/>
        <pc:sldMkLst>
          <pc:docMk/>
          <pc:sldMk cId="3028790565" sldId="427"/>
        </pc:sldMkLst>
      </pc:sldChg>
      <pc:sldChg chg="modSp mod ord">
        <pc:chgData name="Jorgensen, Rick" userId="22b7bd11-eb0f-413f-9bcb-9ce21ec7b0a8" providerId="ADAL" clId="{0566973D-188F-4C4C-9526-C2D46DEF99FC}" dt="2023-08-03T20:30:59.096" v="1776" actId="20577"/>
        <pc:sldMkLst>
          <pc:docMk/>
          <pc:sldMk cId="2795450968" sldId="428"/>
        </pc:sldMkLst>
        <pc:spChg chg="mod">
          <ac:chgData name="Jorgensen, Rick" userId="22b7bd11-eb0f-413f-9bcb-9ce21ec7b0a8" providerId="ADAL" clId="{0566973D-188F-4C4C-9526-C2D46DEF99FC}" dt="2023-08-03T20:30:59.096" v="1776" actId="20577"/>
          <ac:spMkLst>
            <pc:docMk/>
            <pc:sldMk cId="2795450968" sldId="428"/>
            <ac:spMk id="2" creationId="{00000000-0000-0000-0000-000000000000}"/>
          </ac:spMkLst>
        </pc:spChg>
        <pc:spChg chg="mod">
          <ac:chgData name="Jorgensen, Rick" userId="22b7bd11-eb0f-413f-9bcb-9ce21ec7b0a8" providerId="ADAL" clId="{0566973D-188F-4C4C-9526-C2D46DEF99FC}" dt="2023-08-03T19:39:45.214" v="1647" actId="207"/>
          <ac:spMkLst>
            <pc:docMk/>
            <pc:sldMk cId="2795450968" sldId="428"/>
            <ac:spMk id="3" creationId="{00000000-0000-0000-0000-000000000000}"/>
          </ac:spMkLst>
        </pc:spChg>
      </pc:sldChg>
      <pc:sldChg chg="add del">
        <pc:chgData name="Jorgensen, Rick" userId="22b7bd11-eb0f-413f-9bcb-9ce21ec7b0a8" providerId="ADAL" clId="{0566973D-188F-4C4C-9526-C2D46DEF99FC}" dt="2023-08-01T19:55:29.954" v="183"/>
        <pc:sldMkLst>
          <pc:docMk/>
          <pc:sldMk cId="1014888751" sldId="429"/>
        </pc:sldMkLst>
      </pc:sldChg>
      <pc:sldChg chg="addSp delSp modSp add mod">
        <pc:chgData name="Jorgensen, Rick" userId="22b7bd11-eb0f-413f-9bcb-9ce21ec7b0a8" providerId="ADAL" clId="{0566973D-188F-4C4C-9526-C2D46DEF99FC}" dt="2023-08-03T19:41:37.873" v="1699" actId="207"/>
        <pc:sldMkLst>
          <pc:docMk/>
          <pc:sldMk cId="2552959805" sldId="429"/>
        </pc:sldMkLst>
        <pc:spChg chg="del">
          <ac:chgData name="Jorgensen, Rick" userId="22b7bd11-eb0f-413f-9bcb-9ce21ec7b0a8" providerId="ADAL" clId="{0566973D-188F-4C4C-9526-C2D46DEF99FC}" dt="2023-08-02T00:36:23.934" v="944" actId="478"/>
          <ac:spMkLst>
            <pc:docMk/>
            <pc:sldMk cId="2552959805" sldId="429"/>
            <ac:spMk id="2" creationId="{8B5AADCD-8D30-1DE0-29A6-A19B735BC60A}"/>
          </ac:spMkLst>
        </pc:spChg>
        <pc:spChg chg="del mod">
          <ac:chgData name="Jorgensen, Rick" userId="22b7bd11-eb0f-413f-9bcb-9ce21ec7b0a8" providerId="ADAL" clId="{0566973D-188F-4C4C-9526-C2D46DEF99FC}" dt="2023-08-03T19:40:08.419" v="1648" actId="478"/>
          <ac:spMkLst>
            <pc:docMk/>
            <pc:sldMk cId="2552959805" sldId="429"/>
            <ac:spMk id="3" creationId="{A4430EDA-9C79-4E9B-CECC-2455BE331958}"/>
          </ac:spMkLst>
        </pc:spChg>
        <pc:spChg chg="add mod ord">
          <ac:chgData name="Jorgensen, Rick" userId="22b7bd11-eb0f-413f-9bcb-9ce21ec7b0a8" providerId="ADAL" clId="{0566973D-188F-4C4C-9526-C2D46DEF99FC}" dt="2023-08-03T19:22:39.699" v="1112" actId="1076"/>
          <ac:spMkLst>
            <pc:docMk/>
            <pc:sldMk cId="2552959805" sldId="429"/>
            <ac:spMk id="7" creationId="{07E4C538-E00E-3525-DA62-3F5FD0968DED}"/>
          </ac:spMkLst>
        </pc:spChg>
        <pc:spChg chg="add mod ord">
          <ac:chgData name="Jorgensen, Rick" userId="22b7bd11-eb0f-413f-9bcb-9ce21ec7b0a8" providerId="ADAL" clId="{0566973D-188F-4C4C-9526-C2D46DEF99FC}" dt="2023-08-03T19:22:42.026" v="1113" actId="1076"/>
          <ac:spMkLst>
            <pc:docMk/>
            <pc:sldMk cId="2552959805" sldId="429"/>
            <ac:spMk id="9" creationId="{7389AAA5-3E58-6445-D200-A1EBDB88A436}"/>
          </ac:spMkLst>
        </pc:spChg>
        <pc:spChg chg="add mod">
          <ac:chgData name="Jorgensen, Rick" userId="22b7bd11-eb0f-413f-9bcb-9ce21ec7b0a8" providerId="ADAL" clId="{0566973D-188F-4C4C-9526-C2D46DEF99FC}" dt="2023-08-02T00:32:52.485" v="926" actId="207"/>
          <ac:spMkLst>
            <pc:docMk/>
            <pc:sldMk cId="2552959805" sldId="429"/>
            <ac:spMk id="10" creationId="{3E37CC4E-B5FE-402F-FED6-F3C1B221D7B7}"/>
          </ac:spMkLst>
        </pc:spChg>
        <pc:spChg chg="add del mod">
          <ac:chgData name="Jorgensen, Rick" userId="22b7bd11-eb0f-413f-9bcb-9ce21ec7b0a8" providerId="ADAL" clId="{0566973D-188F-4C4C-9526-C2D46DEF99FC}" dt="2023-08-03T19:22:36.661" v="1111" actId="478"/>
          <ac:spMkLst>
            <pc:docMk/>
            <pc:sldMk cId="2552959805" sldId="429"/>
            <ac:spMk id="14" creationId="{120439AC-3863-E8F2-0454-81844131A54E}"/>
          </ac:spMkLst>
        </pc:spChg>
        <pc:spChg chg="add mod">
          <ac:chgData name="Jorgensen, Rick" userId="22b7bd11-eb0f-413f-9bcb-9ce21ec7b0a8" providerId="ADAL" clId="{0566973D-188F-4C4C-9526-C2D46DEF99FC}" dt="2023-08-03T19:21:22.921" v="1106" actId="1076"/>
          <ac:spMkLst>
            <pc:docMk/>
            <pc:sldMk cId="2552959805" sldId="429"/>
            <ac:spMk id="17" creationId="{C0217B56-E66C-515D-7E75-EAA96F430CE8}"/>
          </ac:spMkLst>
        </pc:spChg>
        <pc:spChg chg="add mod">
          <ac:chgData name="Jorgensen, Rick" userId="22b7bd11-eb0f-413f-9bcb-9ce21ec7b0a8" providerId="ADAL" clId="{0566973D-188F-4C4C-9526-C2D46DEF99FC}" dt="2023-08-03T19:21:20.553" v="1105" actId="1076"/>
          <ac:spMkLst>
            <pc:docMk/>
            <pc:sldMk cId="2552959805" sldId="429"/>
            <ac:spMk id="18" creationId="{450E6268-86E5-4738-1B8D-11CCE562E840}"/>
          </ac:spMkLst>
        </pc:spChg>
        <pc:spChg chg="add mod">
          <ac:chgData name="Jorgensen, Rick" userId="22b7bd11-eb0f-413f-9bcb-9ce21ec7b0a8" providerId="ADAL" clId="{0566973D-188F-4C4C-9526-C2D46DEF99FC}" dt="2023-08-03T19:21:29.471" v="1109" actId="1076"/>
          <ac:spMkLst>
            <pc:docMk/>
            <pc:sldMk cId="2552959805" sldId="429"/>
            <ac:spMk id="19" creationId="{997093FD-A6D6-C2E0-0084-8DB95C7B1B3B}"/>
          </ac:spMkLst>
        </pc:spChg>
        <pc:spChg chg="mod">
          <ac:chgData name="Jorgensen, Rick" userId="22b7bd11-eb0f-413f-9bcb-9ce21ec7b0a8" providerId="ADAL" clId="{0566973D-188F-4C4C-9526-C2D46DEF99FC}" dt="2023-08-03T19:41:37.873" v="1699" actId="207"/>
          <ac:spMkLst>
            <pc:docMk/>
            <pc:sldMk cId="2552959805" sldId="429"/>
            <ac:spMk id="25" creationId="{43DF711F-4684-B34D-9236-D3A26D348F11}"/>
          </ac:spMkLst>
        </pc:spChg>
        <pc:grpChg chg="del">
          <ac:chgData name="Jorgensen, Rick" userId="22b7bd11-eb0f-413f-9bcb-9ce21ec7b0a8" providerId="ADAL" clId="{0566973D-188F-4C4C-9526-C2D46DEF99FC}" dt="2023-08-02T00:31:59.049" v="917" actId="478"/>
          <ac:grpSpMkLst>
            <pc:docMk/>
            <pc:sldMk cId="2552959805" sldId="429"/>
            <ac:grpSpMk id="8" creationId="{554CA56B-E938-2C2D-8BAE-4ED945DABE13}"/>
          </ac:grpSpMkLst>
        </pc:grpChg>
        <pc:graphicFrameChg chg="add mod">
          <ac:chgData name="Jorgensen, Rick" userId="22b7bd11-eb0f-413f-9bcb-9ce21ec7b0a8" providerId="ADAL" clId="{0566973D-188F-4C4C-9526-C2D46DEF99FC}" dt="2023-08-03T19:22:28.619" v="1110"/>
          <ac:graphicFrameMkLst>
            <pc:docMk/>
            <pc:sldMk cId="2552959805" sldId="429"/>
            <ac:graphicFrameMk id="6" creationId="{D4CCACB4-4E67-4B42-B1F7-EB2D9C2F572E}"/>
          </ac:graphicFrameMkLst>
        </pc:graphicFrameChg>
      </pc:sldChg>
    </pc:docChg>
  </pc:docChgLst>
  <pc:docChgLst>
    <pc:chgData name="Jorgensen, Rick" userId="22b7bd11-eb0f-413f-9bcb-9ce21ec7b0a8" providerId="ADAL" clId="{6351A6E1-0F41-4575-8F28-E16DED587AF3}"/>
    <pc:docChg chg="custSel modSld">
      <pc:chgData name="Jorgensen, Rick" userId="22b7bd11-eb0f-413f-9bcb-9ce21ec7b0a8" providerId="ADAL" clId="{6351A6E1-0F41-4575-8F28-E16DED587AF3}" dt="2023-07-18T19:05:08.423" v="693" actId="1076"/>
      <pc:docMkLst>
        <pc:docMk/>
      </pc:docMkLst>
      <pc:sldChg chg="addSp modSp mod">
        <pc:chgData name="Jorgensen, Rick" userId="22b7bd11-eb0f-413f-9bcb-9ce21ec7b0a8" providerId="ADAL" clId="{6351A6E1-0F41-4575-8F28-E16DED587AF3}" dt="2023-07-18T18:56:43.659" v="259" actId="20577"/>
        <pc:sldMkLst>
          <pc:docMk/>
          <pc:sldMk cId="4180539983" sldId="381"/>
        </pc:sldMkLst>
        <pc:spChg chg="add mod">
          <ac:chgData name="Jorgensen, Rick" userId="22b7bd11-eb0f-413f-9bcb-9ce21ec7b0a8" providerId="ADAL" clId="{6351A6E1-0F41-4575-8F28-E16DED587AF3}" dt="2023-07-18T18:56:43.659" v="259" actId="20577"/>
          <ac:spMkLst>
            <pc:docMk/>
            <pc:sldMk cId="4180539983" sldId="381"/>
            <ac:spMk id="8" creationId="{A85A1349-C6A4-F81E-2D7B-75FD5E4C4736}"/>
          </ac:spMkLst>
        </pc:spChg>
      </pc:sldChg>
      <pc:sldChg chg="addSp modSp mod">
        <pc:chgData name="Jorgensen, Rick" userId="22b7bd11-eb0f-413f-9bcb-9ce21ec7b0a8" providerId="ADAL" clId="{6351A6E1-0F41-4575-8F28-E16DED587AF3}" dt="2023-07-18T19:04:28.503" v="641" actId="20577"/>
        <pc:sldMkLst>
          <pc:docMk/>
          <pc:sldMk cId="3421980213" sldId="404"/>
        </pc:sldMkLst>
        <pc:spChg chg="add mod">
          <ac:chgData name="Jorgensen, Rick" userId="22b7bd11-eb0f-413f-9bcb-9ce21ec7b0a8" providerId="ADAL" clId="{6351A6E1-0F41-4575-8F28-E16DED587AF3}" dt="2023-07-18T19:04:28.503" v="641" actId="20577"/>
          <ac:spMkLst>
            <pc:docMk/>
            <pc:sldMk cId="3421980213" sldId="404"/>
            <ac:spMk id="2" creationId="{8EFEAB41-433B-43A8-ACF1-88DEF577F222}"/>
          </ac:spMkLst>
        </pc:spChg>
      </pc:sldChg>
      <pc:sldChg chg="addSp modSp mod">
        <pc:chgData name="Jorgensen, Rick" userId="22b7bd11-eb0f-413f-9bcb-9ce21ec7b0a8" providerId="ADAL" clId="{6351A6E1-0F41-4575-8F28-E16DED587AF3}" dt="2023-07-18T19:05:08.423" v="693" actId="1076"/>
        <pc:sldMkLst>
          <pc:docMk/>
          <pc:sldMk cId="2185191487" sldId="405"/>
        </pc:sldMkLst>
        <pc:spChg chg="add mod">
          <ac:chgData name="Jorgensen, Rick" userId="22b7bd11-eb0f-413f-9bcb-9ce21ec7b0a8" providerId="ADAL" clId="{6351A6E1-0F41-4575-8F28-E16DED587AF3}" dt="2023-07-18T19:05:08.423" v="693" actId="1076"/>
          <ac:spMkLst>
            <pc:docMk/>
            <pc:sldMk cId="2185191487" sldId="405"/>
            <ac:spMk id="3" creationId="{EA657AC3-89FD-FE9B-0F2E-15ED8E6EB877}"/>
          </ac:spMkLst>
        </pc:spChg>
      </pc:sldChg>
      <pc:sldChg chg="addSp modSp mod">
        <pc:chgData name="Jorgensen, Rick" userId="22b7bd11-eb0f-413f-9bcb-9ce21ec7b0a8" providerId="ADAL" clId="{6351A6E1-0F41-4575-8F28-E16DED587AF3}" dt="2023-07-18T19:02:22.358" v="517" actId="20577"/>
        <pc:sldMkLst>
          <pc:docMk/>
          <pc:sldMk cId="2194956609" sldId="407"/>
        </pc:sldMkLst>
        <pc:spChg chg="add mod">
          <ac:chgData name="Jorgensen, Rick" userId="22b7bd11-eb0f-413f-9bcb-9ce21ec7b0a8" providerId="ADAL" clId="{6351A6E1-0F41-4575-8F28-E16DED587AF3}" dt="2023-07-18T19:02:22.358" v="517" actId="20577"/>
          <ac:spMkLst>
            <pc:docMk/>
            <pc:sldMk cId="2194956609" sldId="407"/>
            <ac:spMk id="5" creationId="{9FC6211B-39C1-955A-0B6C-E098D48468C7}"/>
          </ac:spMkLst>
        </pc:spChg>
        <pc:spChg chg="mod">
          <ac:chgData name="Jorgensen, Rick" userId="22b7bd11-eb0f-413f-9bcb-9ce21ec7b0a8" providerId="ADAL" clId="{6351A6E1-0F41-4575-8F28-E16DED587AF3}" dt="2023-07-18T19:02:08.095" v="484" actId="14100"/>
          <ac:spMkLst>
            <pc:docMk/>
            <pc:sldMk cId="2194956609" sldId="407"/>
            <ac:spMk id="8" creationId="{E093DCF8-E319-E622-6BE1-7CBE00E0614C}"/>
          </ac:spMkLst>
        </pc:spChg>
      </pc:sldChg>
    </pc:docChg>
  </pc:docChgLst>
  <pc:docChgLst>
    <pc:chgData name="Jorgensen, Rick" userId="22b7bd11-eb0f-413f-9bcb-9ce21ec7b0a8" providerId="ADAL" clId="{6663B843-0924-411C-BB24-8E2E2A24B695}"/>
    <pc:docChg chg="custSel modSld sldOrd">
      <pc:chgData name="Jorgensen, Rick" userId="22b7bd11-eb0f-413f-9bcb-9ce21ec7b0a8" providerId="ADAL" clId="{6663B843-0924-411C-BB24-8E2E2A24B695}" dt="2023-08-09T19:48:18.254" v="99" actId="20577"/>
      <pc:docMkLst>
        <pc:docMk/>
      </pc:docMkLst>
      <pc:sldChg chg="delSp mod">
        <pc:chgData name="Jorgensen, Rick" userId="22b7bd11-eb0f-413f-9bcb-9ce21ec7b0a8" providerId="ADAL" clId="{6663B843-0924-411C-BB24-8E2E2A24B695}" dt="2023-08-09T19:36:41.035" v="18" actId="478"/>
        <pc:sldMkLst>
          <pc:docMk/>
          <pc:sldMk cId="1787906480" sldId="329"/>
        </pc:sldMkLst>
        <pc:spChg chg="del">
          <ac:chgData name="Jorgensen, Rick" userId="22b7bd11-eb0f-413f-9bcb-9ce21ec7b0a8" providerId="ADAL" clId="{6663B843-0924-411C-BB24-8E2E2A24B695}" dt="2023-08-09T19:36:41.035" v="18" actId="478"/>
          <ac:spMkLst>
            <pc:docMk/>
            <pc:sldMk cId="1787906480" sldId="329"/>
            <ac:spMk id="2" creationId="{C9880D3B-B374-2310-4B7A-8663C682C20E}"/>
          </ac:spMkLst>
        </pc:spChg>
      </pc:sldChg>
      <pc:sldChg chg="delSp mod">
        <pc:chgData name="Jorgensen, Rick" userId="22b7bd11-eb0f-413f-9bcb-9ce21ec7b0a8" providerId="ADAL" clId="{6663B843-0924-411C-BB24-8E2E2A24B695}" dt="2023-08-09T19:31:20.002" v="5" actId="478"/>
        <pc:sldMkLst>
          <pc:docMk/>
          <pc:sldMk cId="4233420906" sldId="371"/>
        </pc:sldMkLst>
        <pc:spChg chg="del">
          <ac:chgData name="Jorgensen, Rick" userId="22b7bd11-eb0f-413f-9bcb-9ce21ec7b0a8" providerId="ADAL" clId="{6663B843-0924-411C-BB24-8E2E2A24B695}" dt="2023-08-09T19:31:20.002" v="5" actId="478"/>
          <ac:spMkLst>
            <pc:docMk/>
            <pc:sldMk cId="4233420906" sldId="371"/>
            <ac:spMk id="5" creationId="{3A53ACCA-D541-44AB-07A4-B6FE2AD4FD4D}"/>
          </ac:spMkLst>
        </pc:spChg>
      </pc:sldChg>
      <pc:sldChg chg="modSp mod">
        <pc:chgData name="Jorgensen, Rick" userId="22b7bd11-eb0f-413f-9bcb-9ce21ec7b0a8" providerId="ADAL" clId="{6663B843-0924-411C-BB24-8E2E2A24B695}" dt="2023-08-09T19:35:19.389" v="15" actId="20577"/>
        <pc:sldMkLst>
          <pc:docMk/>
          <pc:sldMk cId="1930347573" sldId="386"/>
        </pc:sldMkLst>
        <pc:spChg chg="mod">
          <ac:chgData name="Jorgensen, Rick" userId="22b7bd11-eb0f-413f-9bcb-9ce21ec7b0a8" providerId="ADAL" clId="{6663B843-0924-411C-BB24-8E2E2A24B695}" dt="2023-08-09T19:35:19.389" v="15" actId="20577"/>
          <ac:spMkLst>
            <pc:docMk/>
            <pc:sldMk cId="1930347573" sldId="386"/>
            <ac:spMk id="29" creationId="{2E51C695-DD93-3E46-975E-4AD32D674DE1}"/>
          </ac:spMkLst>
        </pc:spChg>
      </pc:sldChg>
      <pc:sldChg chg="delSp modSp mod">
        <pc:chgData name="Jorgensen, Rick" userId="22b7bd11-eb0f-413f-9bcb-9ce21ec7b0a8" providerId="ADAL" clId="{6663B843-0924-411C-BB24-8E2E2A24B695}" dt="2023-08-09T19:30:58.639" v="4" actId="20577"/>
        <pc:sldMkLst>
          <pc:docMk/>
          <pc:sldMk cId="1669493757" sldId="401"/>
        </pc:sldMkLst>
        <pc:spChg chg="del">
          <ac:chgData name="Jorgensen, Rick" userId="22b7bd11-eb0f-413f-9bcb-9ce21ec7b0a8" providerId="ADAL" clId="{6663B843-0924-411C-BB24-8E2E2A24B695}" dt="2023-08-09T19:30:43.431" v="0" actId="478"/>
          <ac:spMkLst>
            <pc:docMk/>
            <pc:sldMk cId="1669493757" sldId="401"/>
            <ac:spMk id="2" creationId="{A67035C2-4715-E15F-55F2-0611B5831114}"/>
          </ac:spMkLst>
        </pc:spChg>
        <pc:spChg chg="mod">
          <ac:chgData name="Jorgensen, Rick" userId="22b7bd11-eb0f-413f-9bcb-9ce21ec7b0a8" providerId="ADAL" clId="{6663B843-0924-411C-BB24-8E2E2A24B695}" dt="2023-08-09T19:30:58.639" v="4" actId="20577"/>
          <ac:spMkLst>
            <pc:docMk/>
            <pc:sldMk cId="1669493757" sldId="401"/>
            <ac:spMk id="9" creationId="{090E3AC6-72C7-E48F-824F-47B306FEB8B6}"/>
          </ac:spMkLst>
        </pc:spChg>
      </pc:sldChg>
      <pc:sldChg chg="modSp mod">
        <pc:chgData name="Jorgensen, Rick" userId="22b7bd11-eb0f-413f-9bcb-9ce21ec7b0a8" providerId="ADAL" clId="{6663B843-0924-411C-BB24-8E2E2A24B695}" dt="2023-08-09T19:45:33.488" v="90" actId="20577"/>
        <pc:sldMkLst>
          <pc:docMk/>
          <pc:sldMk cId="2264319159" sldId="408"/>
        </pc:sldMkLst>
        <pc:spChg chg="mod">
          <ac:chgData name="Jorgensen, Rick" userId="22b7bd11-eb0f-413f-9bcb-9ce21ec7b0a8" providerId="ADAL" clId="{6663B843-0924-411C-BB24-8E2E2A24B695}" dt="2023-08-09T19:45:33.488" v="90" actId="20577"/>
          <ac:spMkLst>
            <pc:docMk/>
            <pc:sldMk cId="2264319159" sldId="408"/>
            <ac:spMk id="25" creationId="{43DF711F-4684-B34D-9236-D3A26D348F11}"/>
          </ac:spMkLst>
        </pc:spChg>
      </pc:sldChg>
      <pc:sldChg chg="modSp mod">
        <pc:chgData name="Jorgensen, Rick" userId="22b7bd11-eb0f-413f-9bcb-9ce21ec7b0a8" providerId="ADAL" clId="{6663B843-0924-411C-BB24-8E2E2A24B695}" dt="2023-08-09T19:45:23.472" v="88" actId="20577"/>
        <pc:sldMkLst>
          <pc:docMk/>
          <pc:sldMk cId="2818941781" sldId="409"/>
        </pc:sldMkLst>
        <pc:spChg chg="mod">
          <ac:chgData name="Jorgensen, Rick" userId="22b7bd11-eb0f-413f-9bcb-9ce21ec7b0a8" providerId="ADAL" clId="{6663B843-0924-411C-BB24-8E2E2A24B695}" dt="2023-08-09T19:45:23.472" v="88" actId="20577"/>
          <ac:spMkLst>
            <pc:docMk/>
            <pc:sldMk cId="2818941781" sldId="409"/>
            <ac:spMk id="2" creationId="{00000000-0000-0000-0000-000000000000}"/>
          </ac:spMkLst>
        </pc:spChg>
      </pc:sldChg>
      <pc:sldChg chg="modSp mod ord">
        <pc:chgData name="Jorgensen, Rick" userId="22b7bd11-eb0f-413f-9bcb-9ce21ec7b0a8" providerId="ADAL" clId="{6663B843-0924-411C-BB24-8E2E2A24B695}" dt="2023-08-09T19:45:14.811" v="86" actId="20577"/>
        <pc:sldMkLst>
          <pc:docMk/>
          <pc:sldMk cId="4043107919" sldId="418"/>
        </pc:sldMkLst>
        <pc:spChg chg="mod">
          <ac:chgData name="Jorgensen, Rick" userId="22b7bd11-eb0f-413f-9bcb-9ce21ec7b0a8" providerId="ADAL" clId="{6663B843-0924-411C-BB24-8E2E2A24B695}" dt="2023-08-09T19:35:16.839" v="13" actId="20577"/>
          <ac:spMkLst>
            <pc:docMk/>
            <pc:sldMk cId="4043107919" sldId="418"/>
            <ac:spMk id="2" creationId="{00000000-0000-0000-0000-000000000000}"/>
          </ac:spMkLst>
        </pc:spChg>
        <pc:spChg chg="mod">
          <ac:chgData name="Jorgensen, Rick" userId="22b7bd11-eb0f-413f-9bcb-9ce21ec7b0a8" providerId="ADAL" clId="{6663B843-0924-411C-BB24-8E2E2A24B695}" dt="2023-08-09T19:45:14.811" v="86" actId="20577"/>
          <ac:spMkLst>
            <pc:docMk/>
            <pc:sldMk cId="4043107919" sldId="418"/>
            <ac:spMk id="3" creationId="{00000000-0000-0000-0000-000000000000}"/>
          </ac:spMkLst>
        </pc:spChg>
      </pc:sldChg>
      <pc:sldChg chg="modSp mod">
        <pc:chgData name="Jorgensen, Rick" userId="22b7bd11-eb0f-413f-9bcb-9ce21ec7b0a8" providerId="ADAL" clId="{6663B843-0924-411C-BB24-8E2E2A24B695}" dt="2023-08-09T19:48:18.254" v="99" actId="20577"/>
        <pc:sldMkLst>
          <pc:docMk/>
          <pc:sldMk cId="1169520667" sldId="422"/>
        </pc:sldMkLst>
        <pc:spChg chg="mod">
          <ac:chgData name="Jorgensen, Rick" userId="22b7bd11-eb0f-413f-9bcb-9ce21ec7b0a8" providerId="ADAL" clId="{6663B843-0924-411C-BB24-8E2E2A24B695}" dt="2023-08-09T19:48:15.814" v="97" actId="20577"/>
          <ac:spMkLst>
            <pc:docMk/>
            <pc:sldMk cId="1169520667" sldId="422"/>
            <ac:spMk id="2" creationId="{00000000-0000-0000-0000-000000000000}"/>
          </ac:spMkLst>
        </pc:spChg>
        <pc:spChg chg="mod">
          <ac:chgData name="Jorgensen, Rick" userId="22b7bd11-eb0f-413f-9bcb-9ce21ec7b0a8" providerId="ADAL" clId="{6663B843-0924-411C-BB24-8E2E2A24B695}" dt="2023-08-09T19:48:18.254" v="99" actId="20577"/>
          <ac:spMkLst>
            <pc:docMk/>
            <pc:sldMk cId="1169520667" sldId="422"/>
            <ac:spMk id="3" creationId="{00000000-0000-0000-0000-000000000000}"/>
          </ac:spMkLst>
        </pc:spChg>
      </pc:sldChg>
      <pc:sldChg chg="modSp mod">
        <pc:chgData name="Jorgensen, Rick" userId="22b7bd11-eb0f-413f-9bcb-9ce21ec7b0a8" providerId="ADAL" clId="{6663B843-0924-411C-BB24-8E2E2A24B695}" dt="2023-08-09T19:48:12.851" v="95" actId="20577"/>
        <pc:sldMkLst>
          <pc:docMk/>
          <pc:sldMk cId="1781225942" sldId="424"/>
        </pc:sldMkLst>
        <pc:spChg chg="mod">
          <ac:chgData name="Jorgensen, Rick" userId="22b7bd11-eb0f-413f-9bcb-9ce21ec7b0a8" providerId="ADAL" clId="{6663B843-0924-411C-BB24-8E2E2A24B695}" dt="2023-08-09T19:48:12.851" v="95" actId="20577"/>
          <ac:spMkLst>
            <pc:docMk/>
            <pc:sldMk cId="1781225942" sldId="424"/>
            <ac:spMk id="25" creationId="{43DF711F-4684-B34D-9236-D3A26D348F11}"/>
          </ac:spMkLst>
        </pc:spChg>
      </pc:sldChg>
      <pc:sldChg chg="modSp mod">
        <pc:chgData name="Jorgensen, Rick" userId="22b7bd11-eb0f-413f-9bcb-9ce21ec7b0a8" providerId="ADAL" clId="{6663B843-0924-411C-BB24-8E2E2A24B695}" dt="2023-08-09T19:45:10.241" v="84" actId="20577"/>
        <pc:sldMkLst>
          <pc:docMk/>
          <pc:sldMk cId="2795450968" sldId="428"/>
        </pc:sldMkLst>
        <pc:spChg chg="mod">
          <ac:chgData name="Jorgensen, Rick" userId="22b7bd11-eb0f-413f-9bcb-9ce21ec7b0a8" providerId="ADAL" clId="{6663B843-0924-411C-BB24-8E2E2A24B695}" dt="2023-08-09T19:45:10.241" v="84" actId="20577"/>
          <ac:spMkLst>
            <pc:docMk/>
            <pc:sldMk cId="2795450968" sldId="428"/>
            <ac:spMk id="2" creationId="{00000000-0000-0000-0000-000000000000}"/>
          </ac:spMkLst>
        </pc:spChg>
        <pc:spChg chg="mod">
          <ac:chgData name="Jorgensen, Rick" userId="22b7bd11-eb0f-413f-9bcb-9ce21ec7b0a8" providerId="ADAL" clId="{6663B843-0924-411C-BB24-8E2E2A24B695}" dt="2023-08-09T19:44:50.760" v="80" actId="20577"/>
          <ac:spMkLst>
            <pc:docMk/>
            <pc:sldMk cId="2795450968" sldId="428"/>
            <ac:spMk id="3" creationId="{00000000-0000-0000-0000-000000000000}"/>
          </ac:spMkLst>
        </pc:spChg>
      </pc:sldChg>
      <pc:sldChg chg="modSp mod ord">
        <pc:chgData name="Jorgensen, Rick" userId="22b7bd11-eb0f-413f-9bcb-9ce21ec7b0a8" providerId="ADAL" clId="{6663B843-0924-411C-BB24-8E2E2A24B695}" dt="2023-08-09T19:35:10.923" v="9"/>
        <pc:sldMkLst>
          <pc:docMk/>
          <pc:sldMk cId="2552959805" sldId="429"/>
        </pc:sldMkLst>
        <pc:spChg chg="mod">
          <ac:chgData name="Jorgensen, Rick" userId="22b7bd11-eb0f-413f-9bcb-9ce21ec7b0a8" providerId="ADAL" clId="{6663B843-0924-411C-BB24-8E2E2A24B695}" dt="2023-08-09T19:35:08.042" v="7" actId="20577"/>
          <ac:spMkLst>
            <pc:docMk/>
            <pc:sldMk cId="2552959805" sldId="429"/>
            <ac:spMk id="25" creationId="{43DF711F-4684-B34D-9236-D3A26D348F11}"/>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embeddings/oleObject1.bin"/><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embeddings/oleObject2.bin"/><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253696412948382"/>
          <c:y val="3.9656652360515021E-2"/>
          <c:w val="0.81112992125984251"/>
          <c:h val="0.85284611268251653"/>
        </c:manualLayout>
      </c:layout>
      <c:lineChart>
        <c:grouping val="standard"/>
        <c:varyColors val="0"/>
        <c:ser>
          <c:idx val="24"/>
          <c:order val="0"/>
          <c:tx>
            <c:strRef>
              <c:f>'[UPCA1 RT data sIgE MMCP tIgE.xlsx]Frank testing on AABB and AABBD'!$R$98</c:f>
              <c:strCache>
                <c:ptCount val="1"/>
                <c:pt idx="0">
                  <c:v>UPCA Pre Pooled </c:v>
                </c:pt>
              </c:strCache>
            </c:strRef>
          </c:tx>
          <c:spPr>
            <a:ln w="28575" cap="rnd">
              <a:solidFill>
                <a:schemeClr val="tx1"/>
              </a:solidFill>
              <a:prstDash val="sysDot"/>
              <a:round/>
            </a:ln>
            <a:effectLst/>
          </c:spPr>
          <c:marker>
            <c:symbol val="circle"/>
            <c:size val="7"/>
            <c:spPr>
              <a:noFill/>
              <a:ln w="19050">
                <a:solidFill>
                  <a:schemeClr val="tx1"/>
                </a:solidFill>
              </a:ln>
              <a:effectLst/>
            </c:spPr>
          </c:marker>
          <c:errBars>
            <c:errDir val="y"/>
            <c:errBarType val="both"/>
            <c:errValType val="cust"/>
            <c:noEndCap val="0"/>
            <c:plus>
              <c:numRef>
                <c:f>'[1]Frank testing on AABB and AABBD'!$S$101:$X$101</c:f>
                <c:numCache>
                  <c:formatCode>General</c:formatCode>
                  <c:ptCount val="6"/>
                  <c:pt idx="0">
                    <c:v>1.5379572490807429E-2</c:v>
                  </c:pt>
                  <c:pt idx="1">
                    <c:v>2.5809397513308987E-2</c:v>
                  </c:pt>
                  <c:pt idx="2">
                    <c:v>1.2904698756654509E-2</c:v>
                  </c:pt>
                  <c:pt idx="3">
                    <c:v>1.0253048327204927E-2</c:v>
                  </c:pt>
                  <c:pt idx="4">
                    <c:v>1.5556349186104074E-2</c:v>
                  </c:pt>
                  <c:pt idx="5">
                    <c:v>1.308147545195114E-2</c:v>
                  </c:pt>
                </c:numCache>
              </c:numRef>
            </c:plus>
            <c:minus>
              <c:numRef>
                <c:f>'[1]Frank testing on AABB and AABBD'!$S$101:$X$101</c:f>
                <c:numCache>
                  <c:formatCode>General</c:formatCode>
                  <c:ptCount val="6"/>
                  <c:pt idx="0">
                    <c:v>1.5379572490807429E-2</c:v>
                  </c:pt>
                  <c:pt idx="1">
                    <c:v>2.5809397513308987E-2</c:v>
                  </c:pt>
                  <c:pt idx="2">
                    <c:v>1.2904698756654509E-2</c:v>
                  </c:pt>
                  <c:pt idx="3">
                    <c:v>1.0253048327204927E-2</c:v>
                  </c:pt>
                  <c:pt idx="4">
                    <c:v>1.5556349186104074E-2</c:v>
                  </c:pt>
                  <c:pt idx="5">
                    <c:v>1.308147545195114E-2</c:v>
                  </c:pt>
                </c:numCache>
              </c:numRef>
            </c:minus>
            <c:spPr>
              <a:noFill/>
              <a:ln w="12700" cap="flat" cmpd="sng" algn="ctr">
                <a:solidFill>
                  <a:schemeClr val="tx1">
                    <a:lumMod val="65000"/>
                    <a:lumOff val="35000"/>
                  </a:schemeClr>
                </a:solidFill>
                <a:round/>
              </a:ln>
              <a:effectLst/>
            </c:spPr>
          </c:errBars>
          <c:cat>
            <c:strRef>
              <c:f>'[1]IgG1 titer curves'!$R$25:$AA$25</c:f>
              <c:strCache>
                <c:ptCount val="10"/>
                <c:pt idx="0">
                  <c:v>1/40</c:v>
                </c:pt>
                <c:pt idx="1">
                  <c:v>1/80</c:v>
                </c:pt>
                <c:pt idx="2">
                  <c:v>1/160</c:v>
                </c:pt>
                <c:pt idx="3">
                  <c:v>1/320</c:v>
                </c:pt>
                <c:pt idx="4">
                  <c:v>1/640</c:v>
                </c:pt>
                <c:pt idx="5">
                  <c:v>1/1280</c:v>
                </c:pt>
                <c:pt idx="6">
                  <c:v>1/2560</c:v>
                </c:pt>
                <c:pt idx="7">
                  <c:v>1/5120</c:v>
                </c:pt>
                <c:pt idx="8">
                  <c:v>1/10240</c:v>
                </c:pt>
                <c:pt idx="9">
                  <c:v>1/20480</c:v>
                </c:pt>
              </c:strCache>
            </c:strRef>
          </c:cat>
          <c:val>
            <c:numRef>
              <c:f>'[1]Frank testing on AABB and AABBD'!$S$99:$X$99</c:f>
              <c:numCache>
                <c:formatCode>General</c:formatCode>
                <c:ptCount val="6"/>
                <c:pt idx="0">
                  <c:v>0.17750000000000002</c:v>
                </c:pt>
                <c:pt idx="1">
                  <c:v>0.183</c:v>
                </c:pt>
                <c:pt idx="2">
                  <c:v>0.1545</c:v>
                </c:pt>
                <c:pt idx="3">
                  <c:v>0.159</c:v>
                </c:pt>
                <c:pt idx="4">
                  <c:v>0.184</c:v>
                </c:pt>
                <c:pt idx="5">
                  <c:v>0.16199999999999998</c:v>
                </c:pt>
              </c:numCache>
            </c:numRef>
          </c:val>
          <c:smooth val="0"/>
          <c:extLst>
            <c:ext xmlns:c16="http://schemas.microsoft.com/office/drawing/2014/chart" uri="{C3380CC4-5D6E-409C-BE32-E72D297353CC}">
              <c16:uniqueId val="{00000000-86D7-4A08-9C92-E59018DF717B}"/>
            </c:ext>
          </c:extLst>
        </c:ser>
        <c:ser>
          <c:idx val="25"/>
          <c:order val="1"/>
          <c:tx>
            <c:strRef>
              <c:f>'[UPCA1 RT data sIgE MMCP tIgE.xlsx]Frank testing on AABB and AABBD'!$R$102</c:f>
              <c:strCache>
                <c:ptCount val="1"/>
                <c:pt idx="0">
                  <c:v>UPCA 6R Pooled </c:v>
                </c:pt>
              </c:strCache>
            </c:strRef>
          </c:tx>
          <c:spPr>
            <a:ln w="25400" cap="rnd">
              <a:solidFill>
                <a:schemeClr val="tx1"/>
              </a:solidFill>
              <a:round/>
            </a:ln>
            <a:effectLst/>
          </c:spPr>
          <c:marker>
            <c:symbol val="circle"/>
            <c:size val="7"/>
            <c:spPr>
              <a:solidFill>
                <a:schemeClr val="tx1"/>
              </a:solidFill>
              <a:ln w="9525">
                <a:solidFill>
                  <a:schemeClr val="tx1"/>
                </a:solidFill>
              </a:ln>
              <a:effectLst/>
            </c:spPr>
          </c:marker>
          <c:errBars>
            <c:errDir val="y"/>
            <c:errBarType val="both"/>
            <c:errValType val="cust"/>
            <c:noEndCap val="0"/>
            <c:plus>
              <c:numRef>
                <c:f>'sIgE + control'!$AJ$49:$AO$49</c:f>
                <c:numCache>
                  <c:formatCode>General</c:formatCode>
                  <c:ptCount val="6"/>
                  <c:pt idx="0">
                    <c:v>6.7500000000000115E-2</c:v>
                  </c:pt>
                  <c:pt idx="1">
                    <c:v>3.5000000000000586E-3</c:v>
                  </c:pt>
                  <c:pt idx="2">
                    <c:v>1.3000000000000012E-2</c:v>
                  </c:pt>
                  <c:pt idx="3">
                    <c:v>6.2E-2</c:v>
                  </c:pt>
                  <c:pt idx="4">
                    <c:v>5.8500000000000371E-2</c:v>
                  </c:pt>
                  <c:pt idx="5">
                    <c:v>3.4999999999999749E-3</c:v>
                  </c:pt>
                </c:numCache>
              </c:numRef>
            </c:plus>
            <c:minus>
              <c:numRef>
                <c:f>'sIgE + control'!$AJ$49:$AO$49</c:f>
                <c:numCache>
                  <c:formatCode>General</c:formatCode>
                  <c:ptCount val="6"/>
                  <c:pt idx="0">
                    <c:v>6.7500000000000115E-2</c:v>
                  </c:pt>
                  <c:pt idx="1">
                    <c:v>3.5000000000000586E-3</c:v>
                  </c:pt>
                  <c:pt idx="2">
                    <c:v>1.3000000000000012E-2</c:v>
                  </c:pt>
                  <c:pt idx="3">
                    <c:v>6.2E-2</c:v>
                  </c:pt>
                  <c:pt idx="4">
                    <c:v>5.8500000000000371E-2</c:v>
                  </c:pt>
                  <c:pt idx="5">
                    <c:v>3.4999999999999749E-3</c:v>
                  </c:pt>
                </c:numCache>
              </c:numRef>
            </c:minus>
            <c:spPr>
              <a:noFill/>
              <a:ln w="19050" cap="flat" cmpd="sng" algn="ctr">
                <a:solidFill>
                  <a:schemeClr val="tx1"/>
                </a:solidFill>
                <a:round/>
              </a:ln>
              <a:effectLst/>
            </c:spPr>
          </c:errBars>
          <c:cat>
            <c:strRef>
              <c:f>'[1]IgG1 titer curves'!$R$25:$AA$25</c:f>
              <c:strCache>
                <c:ptCount val="10"/>
                <c:pt idx="0">
                  <c:v>1/40</c:v>
                </c:pt>
                <c:pt idx="1">
                  <c:v>1/80</c:v>
                </c:pt>
                <c:pt idx="2">
                  <c:v>1/160</c:v>
                </c:pt>
                <c:pt idx="3">
                  <c:v>1/320</c:v>
                </c:pt>
                <c:pt idx="4">
                  <c:v>1/640</c:v>
                </c:pt>
                <c:pt idx="5">
                  <c:v>1/1280</c:v>
                </c:pt>
                <c:pt idx="6">
                  <c:v>1/2560</c:v>
                </c:pt>
                <c:pt idx="7">
                  <c:v>1/5120</c:v>
                </c:pt>
                <c:pt idx="8">
                  <c:v>1/10240</c:v>
                </c:pt>
                <c:pt idx="9">
                  <c:v>1/20480</c:v>
                </c:pt>
              </c:strCache>
            </c:strRef>
          </c:cat>
          <c:val>
            <c:numRef>
              <c:f>'sIgE + control'!$AJ$45:$AO$45</c:f>
              <c:numCache>
                <c:formatCode>General</c:formatCode>
                <c:ptCount val="6"/>
                <c:pt idx="0">
                  <c:v>2.4675000000000002</c:v>
                </c:pt>
                <c:pt idx="1">
                  <c:v>1.6225000000000001</c:v>
                </c:pt>
                <c:pt idx="2">
                  <c:v>1.105</c:v>
                </c:pt>
                <c:pt idx="3">
                  <c:v>0.74199999999999999</c:v>
                </c:pt>
                <c:pt idx="4">
                  <c:v>0.48049999999999993</c:v>
                </c:pt>
                <c:pt idx="5">
                  <c:v>0.28649999999999998</c:v>
                </c:pt>
              </c:numCache>
            </c:numRef>
          </c:val>
          <c:smooth val="0"/>
          <c:extLst>
            <c:ext xmlns:c16="http://schemas.microsoft.com/office/drawing/2014/chart" uri="{C3380CC4-5D6E-409C-BE32-E72D297353CC}">
              <c16:uniqueId val="{00000001-86D7-4A08-9C92-E59018DF717B}"/>
            </c:ext>
          </c:extLst>
        </c:ser>
        <c:dLbls>
          <c:showLegendKey val="0"/>
          <c:showVal val="0"/>
          <c:showCatName val="0"/>
          <c:showSerName val="0"/>
          <c:showPercent val="0"/>
          <c:showBubbleSize val="0"/>
        </c:dLbls>
        <c:marker val="1"/>
        <c:smooth val="0"/>
        <c:axId val="322032816"/>
        <c:axId val="322034464"/>
      </c:lineChart>
      <c:catAx>
        <c:axId val="322032816"/>
        <c:scaling>
          <c:orientation val="minMax"/>
        </c:scaling>
        <c:delete val="0"/>
        <c:axPos val="b"/>
        <c:numFmt formatCode="General" sourceLinked="1"/>
        <c:majorTickMark val="out"/>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crossAx val="322034464"/>
        <c:crosses val="autoZero"/>
        <c:auto val="1"/>
        <c:lblAlgn val="ctr"/>
        <c:lblOffset val="100"/>
        <c:noMultiLvlLbl val="0"/>
      </c:catAx>
      <c:valAx>
        <c:axId val="322034464"/>
        <c:scaling>
          <c:orientation val="minMax"/>
          <c:max val="3"/>
        </c:scaling>
        <c:delete val="0"/>
        <c:axPos val="l"/>
        <c:title>
          <c:tx>
            <c:rich>
              <a:bodyPr rot="-54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r>
                  <a:rPr lang="en-US" sz="1600" b="1" i="0" u="none" strike="noStrike" kern="1200" baseline="0" dirty="0">
                    <a:solidFill>
                      <a:sysClr val="windowText" lastClr="000000"/>
                    </a:solidFill>
                    <a:latin typeface="Times New Roman" panose="02020603050405020304" pitchFamily="18" charset="0"/>
                  </a:rPr>
                  <a:t>Specific IgE Antibody (OD 405- 690 nm)</a:t>
                </a:r>
              </a:p>
            </c:rich>
          </c:tx>
          <c:layout>
            <c:manualLayout>
              <c:xMode val="edge"/>
              <c:yMode val="edge"/>
              <c:x val="5.5555555555555558E-3"/>
              <c:y val="0.10157490507861275"/>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title>
        <c:numFmt formatCode="0.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crossAx val="322032816"/>
        <c:crosses val="autoZero"/>
        <c:crossBetween val="between"/>
        <c:majorUnit val="0.5"/>
      </c:valAx>
      <c:spPr>
        <a:noFill/>
        <a:ln>
          <a:noFill/>
        </a:ln>
        <a:effectLst/>
      </c:spPr>
    </c:plotArea>
    <c:legend>
      <c:legendPos val="r"/>
      <c:layout>
        <c:manualLayout>
          <c:xMode val="edge"/>
          <c:yMode val="edge"/>
          <c:x val="0.6333333333333333"/>
          <c:y val="4.7681389611706246E-2"/>
          <c:w val="0.31643110236220473"/>
          <c:h val="0.31910954819967891"/>
        </c:manualLayout>
      </c:layou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legend>
    <c:plotVisOnly val="1"/>
    <c:dispBlanksAs val="gap"/>
    <c:showDLblsOverMax val="0"/>
  </c:chart>
  <c:spPr>
    <a:noFill/>
    <a:ln>
      <a:noFill/>
    </a:ln>
    <a:effectLst/>
  </c:spPr>
  <c:txPr>
    <a:bodyPr/>
    <a:lstStyle/>
    <a:p>
      <a:pPr>
        <a:defRPr sz="1600" b="1" i="0" baseline="0">
          <a:solidFill>
            <a:sysClr val="windowText" lastClr="000000"/>
          </a:solidFill>
          <a:latin typeface="Times New Roman" panose="02020603050405020304" pitchFamily="18"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029265091863518"/>
          <c:y val="9.1570806844979771E-2"/>
          <c:w val="0.76581102362204723"/>
          <c:h val="0.82355063747895108"/>
        </c:manualLayout>
      </c:layout>
      <c:lineChart>
        <c:grouping val="standard"/>
        <c:varyColors val="0"/>
        <c:ser>
          <c:idx val="0"/>
          <c:order val="0"/>
          <c:tx>
            <c:v>IP PBS (n=10)</c:v>
          </c:tx>
          <c:spPr>
            <a:ln w="25400" cap="rnd">
              <a:solidFill>
                <a:schemeClr val="tx1"/>
              </a:solidFill>
              <a:round/>
            </a:ln>
            <a:effectLst/>
          </c:spPr>
          <c:marker>
            <c:symbol val="triangle"/>
            <c:size val="9"/>
            <c:spPr>
              <a:noFill/>
              <a:ln w="15875">
                <a:solidFill>
                  <a:schemeClr val="tx1"/>
                </a:solidFill>
              </a:ln>
              <a:effectLst/>
            </c:spPr>
          </c:marker>
          <c:errBars>
            <c:errDir val="y"/>
            <c:errBarType val="both"/>
            <c:errValType val="cust"/>
            <c:noEndCap val="0"/>
            <c:plus>
              <c:numRef>
                <c:f>'[UCAT1F Rectal Temps for reviewer comments.xlsx]RT data'!$N$113:$S$113</c:f>
                <c:numCache>
                  <c:formatCode>General</c:formatCode>
                  <c:ptCount val="6"/>
                  <c:pt idx="0">
                    <c:v>0.22161026851459562</c:v>
                  </c:pt>
                  <c:pt idx="1">
                    <c:v>0.2409241466612356</c:v>
                  </c:pt>
                  <c:pt idx="2">
                    <c:v>0.26459612829954837</c:v>
                  </c:pt>
                  <c:pt idx="3">
                    <c:v>0.25925105807134347</c:v>
                  </c:pt>
                  <c:pt idx="4">
                    <c:v>0.40531195119041036</c:v>
                  </c:pt>
                  <c:pt idx="5">
                    <c:v>0.32292069889955621</c:v>
                  </c:pt>
                </c:numCache>
              </c:numRef>
            </c:plus>
            <c:minus>
              <c:numRef>
                <c:f>'[UCAT1F Rectal Temps for reviewer comments.xlsx]RT data'!$N$113:$S$113</c:f>
                <c:numCache>
                  <c:formatCode>General</c:formatCode>
                  <c:ptCount val="6"/>
                  <c:pt idx="0">
                    <c:v>0.22161026851459562</c:v>
                  </c:pt>
                  <c:pt idx="1">
                    <c:v>0.2409241466612356</c:v>
                  </c:pt>
                  <c:pt idx="2">
                    <c:v>0.26459612829954837</c:v>
                  </c:pt>
                  <c:pt idx="3">
                    <c:v>0.25925105807134347</c:v>
                  </c:pt>
                  <c:pt idx="4">
                    <c:v>0.40531195119041036</c:v>
                  </c:pt>
                  <c:pt idx="5">
                    <c:v>0.32292069889955621</c:v>
                  </c:pt>
                </c:numCache>
              </c:numRef>
            </c:minus>
            <c:spPr>
              <a:noFill/>
              <a:ln w="19050" cap="flat" cmpd="sng" algn="ctr">
                <a:solidFill>
                  <a:schemeClr val="tx1"/>
                </a:solidFill>
                <a:round/>
              </a:ln>
              <a:effectLst/>
            </c:spPr>
          </c:errBars>
          <c:cat>
            <c:numRef>
              <c:f>'[UCAT1F Rectal Temps for reviewer comments.xlsx]RT data'!$G$112:$L$112</c:f>
              <c:numCache>
                <c:formatCode>General</c:formatCode>
                <c:ptCount val="6"/>
                <c:pt idx="0">
                  <c:v>5</c:v>
                </c:pt>
                <c:pt idx="1">
                  <c:v>10</c:v>
                </c:pt>
                <c:pt idx="2">
                  <c:v>15</c:v>
                </c:pt>
                <c:pt idx="3">
                  <c:v>20</c:v>
                </c:pt>
                <c:pt idx="4">
                  <c:v>25</c:v>
                </c:pt>
                <c:pt idx="5">
                  <c:v>30</c:v>
                </c:pt>
              </c:numCache>
            </c:numRef>
          </c:cat>
          <c:val>
            <c:numRef>
              <c:f>'[UCAT1F Rectal Temps for reviewer comments.xlsx]RT data'!$G$113:$L$113</c:f>
              <c:numCache>
                <c:formatCode>0.0</c:formatCode>
                <c:ptCount val="6"/>
                <c:pt idx="0">
                  <c:v>-0.30999999999999517</c:v>
                </c:pt>
                <c:pt idx="1">
                  <c:v>-0.26999999999999602</c:v>
                </c:pt>
                <c:pt idx="2">
                  <c:v>-0.22999999999999687</c:v>
                </c:pt>
                <c:pt idx="3">
                  <c:v>-0.29999999999999005</c:v>
                </c:pt>
                <c:pt idx="4">
                  <c:v>0.17999999999999972</c:v>
                </c:pt>
                <c:pt idx="5">
                  <c:v>6.0000000000002274E-2</c:v>
                </c:pt>
              </c:numCache>
            </c:numRef>
          </c:val>
          <c:smooth val="0"/>
          <c:extLst>
            <c:ext xmlns:c16="http://schemas.microsoft.com/office/drawing/2014/chart" uri="{C3380CC4-5D6E-409C-BE32-E72D297353CC}">
              <c16:uniqueId val="{00000000-3A1F-428A-B7C7-2DE2EB69DA83}"/>
            </c:ext>
          </c:extLst>
        </c:ser>
        <c:ser>
          <c:idx val="2"/>
          <c:order val="1"/>
          <c:spPr>
            <a:ln w="19050" cap="rnd">
              <a:solidFill>
                <a:schemeClr val="tx1"/>
              </a:solidFill>
              <a:round/>
            </a:ln>
            <a:effectLst/>
          </c:spPr>
          <c:marker>
            <c:symbol val="square"/>
            <c:size val="9"/>
            <c:spPr>
              <a:solidFill>
                <a:schemeClr val="tx1"/>
              </a:solidFill>
              <a:ln w="15875">
                <a:solidFill>
                  <a:schemeClr val="tx1"/>
                </a:solidFill>
              </a:ln>
              <a:effectLst/>
            </c:spPr>
          </c:marker>
          <c:errBars>
            <c:errDir val="y"/>
            <c:errBarType val="both"/>
            <c:errValType val="cust"/>
            <c:noEndCap val="0"/>
            <c:plus>
              <c:numRef>
                <c:f>'[UCAT1F Rectal Temps for reviewer comments.xlsx]RT data'!$N$114:$S$114</c:f>
                <c:numCache>
                  <c:formatCode>General</c:formatCode>
                  <c:ptCount val="6"/>
                  <c:pt idx="0">
                    <c:v>0.12083045973594604</c:v>
                  </c:pt>
                  <c:pt idx="1">
                    <c:v>0.13038404810405319</c:v>
                  </c:pt>
                  <c:pt idx="2">
                    <c:v>0.12000000000000055</c:v>
                  </c:pt>
                  <c:pt idx="3">
                    <c:v>5.8309518948453792E-2</c:v>
                  </c:pt>
                  <c:pt idx="4">
                    <c:v>8.0000000000000168E-2</c:v>
                  </c:pt>
                  <c:pt idx="5">
                    <c:v>5.8309518948453889E-2</c:v>
                  </c:pt>
                </c:numCache>
              </c:numRef>
            </c:plus>
            <c:minus>
              <c:numRef>
                <c:f>'[UCAT1F Rectal Temps for reviewer comments.xlsx]RT data'!$N$114:$S$114</c:f>
                <c:numCache>
                  <c:formatCode>General</c:formatCode>
                  <c:ptCount val="6"/>
                  <c:pt idx="0">
                    <c:v>0.12083045973594604</c:v>
                  </c:pt>
                  <c:pt idx="1">
                    <c:v>0.13038404810405319</c:v>
                  </c:pt>
                  <c:pt idx="2">
                    <c:v>0.12000000000000055</c:v>
                  </c:pt>
                  <c:pt idx="3">
                    <c:v>5.8309518948453792E-2</c:v>
                  </c:pt>
                  <c:pt idx="4">
                    <c:v>8.0000000000000168E-2</c:v>
                  </c:pt>
                  <c:pt idx="5">
                    <c:v>5.8309518948453889E-2</c:v>
                  </c:pt>
                </c:numCache>
              </c:numRef>
            </c:minus>
            <c:spPr>
              <a:noFill/>
              <a:ln w="19050" cap="flat" cmpd="sng" algn="ctr">
                <a:solidFill>
                  <a:schemeClr val="tx1"/>
                </a:solidFill>
                <a:round/>
              </a:ln>
              <a:effectLst/>
            </c:spPr>
          </c:errBars>
          <c:cat>
            <c:numRef>
              <c:f>'[UCAT1F Rectal Temps for reviewer comments.xlsx]RT data'!$G$112:$L$112</c:f>
              <c:numCache>
                <c:formatCode>General</c:formatCode>
                <c:ptCount val="6"/>
                <c:pt idx="0">
                  <c:v>5</c:v>
                </c:pt>
                <c:pt idx="1">
                  <c:v>10</c:v>
                </c:pt>
                <c:pt idx="2">
                  <c:v>15</c:v>
                </c:pt>
                <c:pt idx="3">
                  <c:v>20</c:v>
                </c:pt>
                <c:pt idx="4">
                  <c:v>25</c:v>
                </c:pt>
                <c:pt idx="5">
                  <c:v>30</c:v>
                </c:pt>
              </c:numCache>
            </c:numRef>
          </c:cat>
          <c:val>
            <c:numRef>
              <c:f>'[UCAT1F Rectal Temps for reviewer comments.xlsx]RT data'!$G$115:$L$115</c:f>
              <c:numCache>
                <c:formatCode>0.0</c:formatCode>
                <c:ptCount val="6"/>
                <c:pt idx="0">
                  <c:v>-1.0799999999999983</c:v>
                </c:pt>
                <c:pt idx="1">
                  <c:v>-1.3999999999999986</c:v>
                </c:pt>
                <c:pt idx="2">
                  <c:v>-1.4799999999999969</c:v>
                </c:pt>
                <c:pt idx="3">
                  <c:v>-1.4000000000000057</c:v>
                </c:pt>
                <c:pt idx="4">
                  <c:v>-0.94000000000000483</c:v>
                </c:pt>
                <c:pt idx="5">
                  <c:v>-0.78000000000000824</c:v>
                </c:pt>
              </c:numCache>
            </c:numRef>
          </c:val>
          <c:smooth val="0"/>
          <c:extLst>
            <c:ext xmlns:c16="http://schemas.microsoft.com/office/drawing/2014/chart" uri="{C3380CC4-5D6E-409C-BE32-E72D297353CC}">
              <c16:uniqueId val="{00000001-3A1F-428A-B7C7-2DE2EB69DA83}"/>
            </c:ext>
          </c:extLst>
        </c:ser>
        <c:dLbls>
          <c:showLegendKey val="0"/>
          <c:showVal val="0"/>
          <c:showCatName val="0"/>
          <c:showSerName val="0"/>
          <c:showPercent val="0"/>
          <c:showBubbleSize val="0"/>
        </c:dLbls>
        <c:marker val="1"/>
        <c:smooth val="0"/>
        <c:axId val="1094032751"/>
        <c:axId val="1055342271"/>
      </c:lineChart>
      <c:catAx>
        <c:axId val="1094032751"/>
        <c:scaling>
          <c:orientation val="minMax"/>
        </c:scaling>
        <c:delete val="0"/>
        <c:axPos val="b"/>
        <c:numFmt formatCode="General" sourceLinked="1"/>
        <c:majorTickMark val="out"/>
        <c:minorTickMark val="none"/>
        <c:tickLblPos val="high"/>
        <c:spPr>
          <a:noFill/>
          <a:ln w="2540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055342271"/>
        <c:crosses val="autoZero"/>
        <c:auto val="1"/>
        <c:lblAlgn val="ctr"/>
        <c:lblOffset val="100"/>
        <c:noMultiLvlLbl val="0"/>
      </c:catAx>
      <c:valAx>
        <c:axId val="1055342271"/>
        <c:scaling>
          <c:orientation val="minMax"/>
          <c:max val="1"/>
          <c:min val="-2"/>
        </c:scaling>
        <c:delete val="0"/>
        <c:axPos val="l"/>
        <c:title>
          <c:tx>
            <c:rich>
              <a:bodyPr rot="-5400000" spcFirstLastPara="1" vertOverflow="ellipsis" vert="horz" wrap="square" anchor="ctr" anchorCtr="1"/>
              <a:lstStyle/>
              <a:p>
                <a:pPr algn="ctr" rtl="0">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600" b="1" i="0" baseline="0">
                    <a:effectLst/>
                  </a:rPr>
                  <a:t>Change in Rectal Temperature (∆°C)</a:t>
                </a:r>
                <a:endParaRPr lang="en-US" sz="1600">
                  <a:effectLst/>
                </a:endParaRPr>
              </a:p>
            </c:rich>
          </c:tx>
          <c:layout>
            <c:manualLayout>
              <c:xMode val="edge"/>
              <c:yMode val="edge"/>
              <c:x val="7.1506999125109357E-3"/>
              <c:y val="0.1244750656167979"/>
            </c:manualLayout>
          </c:layout>
          <c:overlay val="0"/>
          <c:spPr>
            <a:noFill/>
            <a:ln>
              <a:noFill/>
            </a:ln>
            <a:effectLst/>
          </c:spPr>
          <c:txPr>
            <a:bodyPr rot="-5400000" spcFirstLastPara="1" vertOverflow="ellipsis" vert="horz" wrap="square" anchor="ctr" anchorCtr="1"/>
            <a:lstStyle/>
            <a:p>
              <a:pPr algn="ctr" rtl="0">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0" sourceLinked="1"/>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094032751"/>
        <c:crosses val="autoZero"/>
        <c:crossBetween val="between"/>
        <c:majorUnit val="1"/>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b="1" i="0">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364807524059492"/>
          <c:y val="3.9656652360515021E-2"/>
          <c:w val="0.80001881014873144"/>
          <c:h val="0.7382523965620178"/>
        </c:manualLayout>
      </c:layout>
      <c:lineChart>
        <c:grouping val="standard"/>
        <c:varyColors val="0"/>
        <c:ser>
          <c:idx val="24"/>
          <c:order val="0"/>
          <c:tx>
            <c:strRef>
              <c:f>'IgG1 titer curves'!$Y$58:$Y$61</c:f>
              <c:strCache>
                <c:ptCount val="1"/>
                <c:pt idx="0">
                  <c:v>ASDG Pre (n=20)</c:v>
                </c:pt>
              </c:strCache>
            </c:strRef>
          </c:tx>
          <c:spPr>
            <a:ln w="25400" cap="rnd">
              <a:solidFill>
                <a:schemeClr val="tx1"/>
              </a:solidFill>
              <a:prstDash val="sysDot"/>
              <a:round/>
            </a:ln>
            <a:effectLst/>
          </c:spPr>
          <c:marker>
            <c:symbol val="circle"/>
            <c:size val="5"/>
            <c:spPr>
              <a:noFill/>
              <a:ln w="19050">
                <a:solidFill>
                  <a:schemeClr val="tx1"/>
                </a:solidFill>
              </a:ln>
              <a:effectLst/>
            </c:spPr>
          </c:marker>
          <c:errBars>
            <c:errDir val="y"/>
            <c:errBarType val="both"/>
            <c:errValType val="cust"/>
            <c:noEndCap val="0"/>
            <c:plus>
              <c:numRef>
                <c:f>'IgG1 titer curves'!$AA$61:$AJ$61</c:f>
                <c:numCache>
                  <c:formatCode>General</c:formatCode>
                  <c:ptCount val="10"/>
                  <c:pt idx="0">
                    <c:v>1.5860721925561915E-3</c:v>
                  </c:pt>
                  <c:pt idx="1">
                    <c:v>3.2274861218395016E-4</c:v>
                  </c:pt>
                  <c:pt idx="2">
                    <c:v>6.5748890991914569E-4</c:v>
                  </c:pt>
                  <c:pt idx="3">
                    <c:v>1.3693063937629164E-3</c:v>
                  </c:pt>
                  <c:pt idx="4">
                    <c:v>1.0103629710818442E-3</c:v>
                  </c:pt>
                  <c:pt idx="5">
                    <c:v>1.3149778198382918E-3</c:v>
                  </c:pt>
                  <c:pt idx="6">
                    <c:v>1.7365554986812268E-3</c:v>
                  </c:pt>
                  <c:pt idx="7">
                    <c:v>3.1457643480294821E-4</c:v>
                  </c:pt>
                  <c:pt idx="8">
                    <c:v>1.0282468899377557E-3</c:v>
                  </c:pt>
                  <c:pt idx="9">
                    <c:v>4.2695628191498364E-4</c:v>
                  </c:pt>
                </c:numCache>
              </c:numRef>
            </c:plus>
            <c:minus>
              <c:numRef>
                <c:f>'IgG1 titer curves'!$AA$61:$AJ$61</c:f>
                <c:numCache>
                  <c:formatCode>General</c:formatCode>
                  <c:ptCount val="10"/>
                  <c:pt idx="0">
                    <c:v>1.5860721925561915E-3</c:v>
                  </c:pt>
                  <c:pt idx="1">
                    <c:v>3.2274861218395016E-4</c:v>
                  </c:pt>
                  <c:pt idx="2">
                    <c:v>6.5748890991914569E-4</c:v>
                  </c:pt>
                  <c:pt idx="3">
                    <c:v>1.3693063937629164E-3</c:v>
                  </c:pt>
                  <c:pt idx="4">
                    <c:v>1.0103629710818442E-3</c:v>
                  </c:pt>
                  <c:pt idx="5">
                    <c:v>1.3149778198382918E-3</c:v>
                  </c:pt>
                  <c:pt idx="6">
                    <c:v>1.7365554986812268E-3</c:v>
                  </c:pt>
                  <c:pt idx="7">
                    <c:v>3.1457643480294821E-4</c:v>
                  </c:pt>
                  <c:pt idx="8">
                    <c:v>1.0282468899377557E-3</c:v>
                  </c:pt>
                  <c:pt idx="9">
                    <c:v>4.2695628191498364E-4</c:v>
                  </c:pt>
                </c:numCache>
              </c:numRef>
            </c:minus>
            <c:spPr>
              <a:noFill/>
              <a:ln w="12700" cap="flat" cmpd="sng" algn="ctr">
                <a:solidFill>
                  <a:schemeClr val="tx1">
                    <a:lumMod val="65000"/>
                    <a:lumOff val="35000"/>
                  </a:schemeClr>
                </a:solidFill>
                <a:round/>
              </a:ln>
              <a:effectLst/>
            </c:spPr>
          </c:errBars>
          <c:cat>
            <c:strRef>
              <c:f>'IgG1 titer curves'!$R$25:$AA$25</c:f>
              <c:strCache>
                <c:ptCount val="10"/>
                <c:pt idx="0">
                  <c:v>1/2k</c:v>
                </c:pt>
                <c:pt idx="1">
                  <c:v>1/4k</c:v>
                </c:pt>
                <c:pt idx="2">
                  <c:v>1/8k</c:v>
                </c:pt>
                <c:pt idx="3">
                  <c:v>1/16k</c:v>
                </c:pt>
                <c:pt idx="4">
                  <c:v>1/32k</c:v>
                </c:pt>
                <c:pt idx="5">
                  <c:v>1/64k</c:v>
                </c:pt>
                <c:pt idx="6">
                  <c:v>1/128k</c:v>
                </c:pt>
                <c:pt idx="7">
                  <c:v>1/256k</c:v>
                </c:pt>
                <c:pt idx="8">
                  <c:v>1/512k</c:v>
                </c:pt>
                <c:pt idx="9">
                  <c:v>1/1024k</c:v>
                </c:pt>
              </c:strCache>
            </c:strRef>
          </c:cat>
          <c:val>
            <c:numRef>
              <c:f>'IgG1 titer curves'!$AA$59:$AJ$59</c:f>
              <c:numCache>
                <c:formatCode>0.000</c:formatCode>
                <c:ptCount val="10"/>
                <c:pt idx="0">
                  <c:v>6.0749999999999998E-2</c:v>
                </c:pt>
                <c:pt idx="1">
                  <c:v>5.9499999999999997E-2</c:v>
                </c:pt>
                <c:pt idx="2">
                  <c:v>6.1249999999999999E-2</c:v>
                </c:pt>
                <c:pt idx="3">
                  <c:v>6.7000000000000004E-2</c:v>
                </c:pt>
                <c:pt idx="4">
                  <c:v>6.8500000000000005E-2</c:v>
                </c:pt>
                <c:pt idx="5">
                  <c:v>7.350000000000001E-2</c:v>
                </c:pt>
                <c:pt idx="6">
                  <c:v>6.4750000000000002E-2</c:v>
                </c:pt>
                <c:pt idx="7">
                  <c:v>6.5250000000000002E-2</c:v>
                </c:pt>
                <c:pt idx="8">
                  <c:v>6.7250000000000004E-2</c:v>
                </c:pt>
                <c:pt idx="9">
                  <c:v>6.7750000000000005E-2</c:v>
                </c:pt>
              </c:numCache>
            </c:numRef>
          </c:val>
          <c:smooth val="0"/>
          <c:extLst>
            <c:ext xmlns:c16="http://schemas.microsoft.com/office/drawing/2014/chart" uri="{C3380CC4-5D6E-409C-BE32-E72D297353CC}">
              <c16:uniqueId val="{00000000-5F28-4A89-90CB-47C6C701588D}"/>
            </c:ext>
          </c:extLst>
        </c:ser>
        <c:ser>
          <c:idx val="25"/>
          <c:order val="1"/>
          <c:tx>
            <c:strRef>
              <c:f>'IgG1 titer curves'!$Y$62:$Y$65</c:f>
              <c:strCache>
                <c:ptCount val="1"/>
                <c:pt idx="0">
                  <c:v>ASDG 6R (n=20)</c:v>
                </c:pt>
              </c:strCache>
            </c:strRef>
          </c:tx>
          <c:spPr>
            <a:ln w="25400" cap="rnd">
              <a:solidFill>
                <a:schemeClr val="tx1"/>
              </a:solidFill>
              <a:round/>
            </a:ln>
            <a:effectLst/>
          </c:spPr>
          <c:marker>
            <c:symbol val="circle"/>
            <c:size val="7"/>
            <c:spPr>
              <a:solidFill>
                <a:schemeClr val="tx1"/>
              </a:solidFill>
              <a:ln w="9525">
                <a:solidFill>
                  <a:schemeClr val="tx1"/>
                </a:solidFill>
              </a:ln>
              <a:effectLst/>
            </c:spPr>
          </c:marker>
          <c:errBars>
            <c:errDir val="y"/>
            <c:errBarType val="both"/>
            <c:errValType val="cust"/>
            <c:noEndCap val="0"/>
            <c:plus>
              <c:numRef>
                <c:f>'IgG1 titer curves'!$AA$65:$AJ$65</c:f>
                <c:numCache>
                  <c:formatCode>General</c:formatCode>
                  <c:ptCount val="10"/>
                  <c:pt idx="0">
                    <c:v>2.5179666896128675E-2</c:v>
                  </c:pt>
                  <c:pt idx="1">
                    <c:v>2.1464602644043179E-2</c:v>
                  </c:pt>
                  <c:pt idx="2">
                    <c:v>1.6545864286884517E-2</c:v>
                  </c:pt>
                  <c:pt idx="3">
                    <c:v>4.646212615310092E-2</c:v>
                  </c:pt>
                  <c:pt idx="4">
                    <c:v>8.1257948329174101E-2</c:v>
                  </c:pt>
                  <c:pt idx="5">
                    <c:v>9.1692647833218802E-2</c:v>
                  </c:pt>
                  <c:pt idx="6">
                    <c:v>7.9511791578356431E-2</c:v>
                  </c:pt>
                  <c:pt idx="7">
                    <c:v>6.1416101309021622E-2</c:v>
                  </c:pt>
                  <c:pt idx="8">
                    <c:v>3.5584699427328711E-2</c:v>
                  </c:pt>
                  <c:pt idx="9">
                    <c:v>1.9061851081851117E-2</c:v>
                  </c:pt>
                </c:numCache>
              </c:numRef>
            </c:plus>
            <c:minus>
              <c:numRef>
                <c:f>'IgG1 titer curves'!$AA$65:$AJ$65</c:f>
                <c:numCache>
                  <c:formatCode>General</c:formatCode>
                  <c:ptCount val="10"/>
                  <c:pt idx="0">
                    <c:v>2.5179666896128675E-2</c:v>
                  </c:pt>
                  <c:pt idx="1">
                    <c:v>2.1464602644043179E-2</c:v>
                  </c:pt>
                  <c:pt idx="2">
                    <c:v>1.6545864286884517E-2</c:v>
                  </c:pt>
                  <c:pt idx="3">
                    <c:v>4.646212615310092E-2</c:v>
                  </c:pt>
                  <c:pt idx="4">
                    <c:v>8.1257948329174101E-2</c:v>
                  </c:pt>
                  <c:pt idx="5">
                    <c:v>9.1692647833218802E-2</c:v>
                  </c:pt>
                  <c:pt idx="6">
                    <c:v>7.9511791578356431E-2</c:v>
                  </c:pt>
                  <c:pt idx="7">
                    <c:v>6.1416101309021622E-2</c:v>
                  </c:pt>
                  <c:pt idx="8">
                    <c:v>3.5584699427328711E-2</c:v>
                  </c:pt>
                  <c:pt idx="9">
                    <c:v>1.9061851081851117E-2</c:v>
                  </c:pt>
                </c:numCache>
              </c:numRef>
            </c:minus>
            <c:spPr>
              <a:noFill/>
              <a:ln w="19050" cap="flat" cmpd="sng" algn="ctr">
                <a:solidFill>
                  <a:schemeClr val="tx1"/>
                </a:solidFill>
                <a:round/>
              </a:ln>
              <a:effectLst/>
            </c:spPr>
          </c:errBars>
          <c:cat>
            <c:strRef>
              <c:f>'IgG1 titer curves'!$R$25:$AA$25</c:f>
              <c:strCache>
                <c:ptCount val="10"/>
                <c:pt idx="0">
                  <c:v>1/2k</c:v>
                </c:pt>
                <c:pt idx="1">
                  <c:v>1/4k</c:v>
                </c:pt>
                <c:pt idx="2">
                  <c:v>1/8k</c:v>
                </c:pt>
                <c:pt idx="3">
                  <c:v>1/16k</c:v>
                </c:pt>
                <c:pt idx="4">
                  <c:v>1/32k</c:v>
                </c:pt>
                <c:pt idx="5">
                  <c:v>1/64k</c:v>
                </c:pt>
                <c:pt idx="6">
                  <c:v>1/128k</c:v>
                </c:pt>
                <c:pt idx="7">
                  <c:v>1/256k</c:v>
                </c:pt>
                <c:pt idx="8">
                  <c:v>1/512k</c:v>
                </c:pt>
                <c:pt idx="9">
                  <c:v>1/1024k</c:v>
                </c:pt>
              </c:strCache>
            </c:strRef>
          </c:cat>
          <c:val>
            <c:numRef>
              <c:f>'IgG1 titer curves'!$AA$63:$AJ$63</c:f>
              <c:numCache>
                <c:formatCode>0.000</c:formatCode>
                <c:ptCount val="10"/>
                <c:pt idx="0">
                  <c:v>3.6777499999999996</c:v>
                </c:pt>
                <c:pt idx="1">
                  <c:v>3.5344999999999995</c:v>
                </c:pt>
                <c:pt idx="2">
                  <c:v>3.4077500000000001</c:v>
                </c:pt>
                <c:pt idx="3">
                  <c:v>3.1284999999999998</c:v>
                </c:pt>
                <c:pt idx="4">
                  <c:v>2.6164999999999998</c:v>
                </c:pt>
                <c:pt idx="5">
                  <c:v>1.9949999999999999</c:v>
                </c:pt>
                <c:pt idx="6">
                  <c:v>1.35</c:v>
                </c:pt>
                <c:pt idx="7">
                  <c:v>0.85949999999999993</c:v>
                </c:pt>
                <c:pt idx="8">
                  <c:v>0.50050000000000006</c:v>
                </c:pt>
                <c:pt idx="9">
                  <c:v>0.30449999999999999</c:v>
                </c:pt>
              </c:numCache>
            </c:numRef>
          </c:val>
          <c:smooth val="0"/>
          <c:extLst>
            <c:ext xmlns:c16="http://schemas.microsoft.com/office/drawing/2014/chart" uri="{C3380CC4-5D6E-409C-BE32-E72D297353CC}">
              <c16:uniqueId val="{00000001-5F28-4A89-90CB-47C6C701588D}"/>
            </c:ext>
          </c:extLst>
        </c:ser>
        <c:dLbls>
          <c:showLegendKey val="0"/>
          <c:showVal val="0"/>
          <c:showCatName val="0"/>
          <c:showSerName val="0"/>
          <c:showPercent val="0"/>
          <c:showBubbleSize val="0"/>
        </c:dLbls>
        <c:marker val="1"/>
        <c:smooth val="0"/>
        <c:axId val="322032816"/>
        <c:axId val="322034464"/>
      </c:lineChart>
      <c:catAx>
        <c:axId val="322032816"/>
        <c:scaling>
          <c:orientation val="minMax"/>
        </c:scaling>
        <c:delete val="0"/>
        <c:axPos val="b"/>
        <c:title>
          <c:tx>
            <c:rich>
              <a:bodyPr rot="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r>
                  <a:rPr lang="en-US" dirty="0"/>
                  <a:t>Plasma Dilution</a:t>
                </a:r>
              </a:p>
            </c:rich>
          </c:tx>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title>
        <c:numFmt formatCode="General" sourceLinked="1"/>
        <c:majorTickMark val="out"/>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crossAx val="322034464"/>
        <c:crosses val="autoZero"/>
        <c:auto val="1"/>
        <c:lblAlgn val="ctr"/>
        <c:lblOffset val="100"/>
        <c:noMultiLvlLbl val="0"/>
      </c:catAx>
      <c:valAx>
        <c:axId val="322034464"/>
        <c:scaling>
          <c:orientation val="minMax"/>
          <c:max val="4"/>
        </c:scaling>
        <c:delete val="0"/>
        <c:axPos val="l"/>
        <c:title>
          <c:tx>
            <c:rich>
              <a:bodyPr rot="-54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r>
                  <a:rPr lang="en-US"/>
                  <a:t>ASDG Specific IgG1 Antibody </a:t>
                </a:r>
              </a:p>
              <a:p>
                <a:pPr>
                  <a:defRPr/>
                </a:pPr>
                <a:r>
                  <a:rPr lang="en-US"/>
                  <a:t>(OD 405- 690 nm)</a:t>
                </a:r>
              </a:p>
            </c:rich>
          </c:tx>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title>
        <c:numFmt formatCode="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crossAx val="322032816"/>
        <c:crosses val="autoZero"/>
        <c:crossBetween val="between"/>
        <c:majorUnit val="1"/>
      </c:valAx>
      <c:spPr>
        <a:noFill/>
        <a:ln>
          <a:noFill/>
        </a:ln>
        <a:effectLst/>
      </c:spPr>
    </c:plotArea>
    <c:legend>
      <c:legendPos val="r"/>
      <c:layout>
        <c:manualLayout>
          <c:xMode val="edge"/>
          <c:yMode val="edge"/>
          <c:x val="0.6333333333333333"/>
          <c:y val="4.7681389611706246E-2"/>
          <c:w val="0.34166666666666667"/>
          <c:h val="0.23510932378087929"/>
        </c:manualLayout>
      </c:layou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legend>
    <c:plotVisOnly val="1"/>
    <c:dispBlanksAs val="gap"/>
    <c:showDLblsOverMax val="0"/>
  </c:chart>
  <c:spPr>
    <a:noFill/>
    <a:ln>
      <a:noFill/>
    </a:ln>
    <a:effectLst/>
  </c:spPr>
  <c:txPr>
    <a:bodyPr/>
    <a:lstStyle/>
    <a:p>
      <a:pPr>
        <a:defRPr sz="1600" b="1" i="0" baseline="0">
          <a:solidFill>
            <a:sysClr val="windowText" lastClr="000000"/>
          </a:solidFill>
          <a:latin typeface="Times New Roman" panose="02020603050405020304" pitchFamily="18"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5"/>
          <c:order val="5"/>
          <c:tx>
            <c:v>Average</c:v>
          </c:tx>
          <c:spPr>
            <a:solidFill>
              <a:schemeClr val="bg1">
                <a:lumMod val="75000"/>
              </a:schemeClr>
            </a:solidFill>
            <a:ln w="19050">
              <a:solidFill>
                <a:schemeClr val="dk1"/>
              </a:solidFill>
            </a:ln>
            <a:effectLst/>
          </c:spPr>
          <c:invertIfNegative val="0"/>
          <c:dPt>
            <c:idx val="0"/>
            <c:invertIfNegative val="0"/>
            <c:bubble3D val="0"/>
            <c:spPr>
              <a:noFill/>
              <a:ln w="19050">
                <a:solidFill>
                  <a:schemeClr val="dk1"/>
                </a:solidFill>
              </a:ln>
              <a:effectLst/>
            </c:spPr>
            <c:extLst>
              <c:ext xmlns:c16="http://schemas.microsoft.com/office/drawing/2014/chart" uri="{C3380CC4-5D6E-409C-BE32-E72D297353CC}">
                <c16:uniqueId val="{00000001-3F20-4CA0-A627-E6E9F57A854D}"/>
              </c:ext>
            </c:extLst>
          </c:dPt>
          <c:dPt>
            <c:idx val="1"/>
            <c:invertIfNegative val="0"/>
            <c:bubble3D val="0"/>
            <c:spPr>
              <a:pattFill prst="ltVert">
                <a:fgClr>
                  <a:schemeClr val="tx1"/>
                </a:fgClr>
                <a:bgClr>
                  <a:schemeClr val="bg1"/>
                </a:bgClr>
              </a:pattFill>
              <a:ln w="19050">
                <a:solidFill>
                  <a:schemeClr val="dk1"/>
                </a:solidFill>
              </a:ln>
              <a:effectLst/>
            </c:spPr>
            <c:extLst>
              <c:ext xmlns:c16="http://schemas.microsoft.com/office/drawing/2014/chart" uri="{C3380CC4-5D6E-409C-BE32-E72D297353CC}">
                <c16:uniqueId val="{00000003-3F20-4CA0-A627-E6E9F57A854D}"/>
              </c:ext>
            </c:extLst>
          </c:dPt>
          <c:dPt>
            <c:idx val="2"/>
            <c:invertIfNegative val="0"/>
            <c:bubble3D val="0"/>
            <c:spPr>
              <a:pattFill prst="ltHorz">
                <a:fgClr>
                  <a:schemeClr val="bg1">
                    <a:lumMod val="75000"/>
                  </a:schemeClr>
                </a:fgClr>
                <a:bgClr>
                  <a:schemeClr val="bg1"/>
                </a:bgClr>
              </a:pattFill>
              <a:ln w="19050">
                <a:solidFill>
                  <a:schemeClr val="dk1"/>
                </a:solidFill>
              </a:ln>
              <a:effectLst/>
            </c:spPr>
            <c:extLst>
              <c:ext xmlns:c16="http://schemas.microsoft.com/office/drawing/2014/chart" uri="{C3380CC4-5D6E-409C-BE32-E72D297353CC}">
                <c16:uniqueId val="{00000011-3F20-4CA0-A627-E6E9F57A854D}"/>
              </c:ext>
            </c:extLst>
          </c:dPt>
          <c:dPt>
            <c:idx val="4"/>
            <c:invertIfNegative val="0"/>
            <c:bubble3D val="0"/>
            <c:spPr>
              <a:solidFill>
                <a:schemeClr val="bg1">
                  <a:lumMod val="75000"/>
                </a:schemeClr>
              </a:solidFill>
              <a:ln w="19050">
                <a:solidFill>
                  <a:schemeClr val="dk1"/>
                </a:solidFill>
              </a:ln>
              <a:effectLst/>
            </c:spPr>
            <c:extLst>
              <c:ext xmlns:c16="http://schemas.microsoft.com/office/drawing/2014/chart" uri="{C3380CC4-5D6E-409C-BE32-E72D297353CC}">
                <c16:uniqueId val="{00000005-3F20-4CA0-A627-E6E9F57A854D}"/>
              </c:ext>
            </c:extLst>
          </c:dPt>
          <c:dPt>
            <c:idx val="5"/>
            <c:invertIfNegative val="0"/>
            <c:bubble3D val="0"/>
            <c:spPr>
              <a:solidFill>
                <a:schemeClr val="bg1">
                  <a:lumMod val="75000"/>
                </a:schemeClr>
              </a:solidFill>
              <a:ln w="19050">
                <a:solidFill>
                  <a:schemeClr val="dk1"/>
                </a:solidFill>
              </a:ln>
              <a:effectLst/>
            </c:spPr>
            <c:extLst>
              <c:ext xmlns:c16="http://schemas.microsoft.com/office/drawing/2014/chart" uri="{C3380CC4-5D6E-409C-BE32-E72D297353CC}">
                <c16:uniqueId val="{00000007-3F20-4CA0-A627-E6E9F57A854D}"/>
              </c:ext>
            </c:extLst>
          </c:dPt>
          <c:errBars>
            <c:errBarType val="both"/>
            <c:errValType val="cust"/>
            <c:noEndCap val="0"/>
            <c:plus>
              <c:numRef>
                <c:f>'[Histamine CA Jorgensen et al 2023 Frontiers.xlsx]Histamine Analysis'!$C$73,'[Histamine CA Jorgensen et al 2023 Frontiers.xlsx]Histamine Analysis'!$E$73,'[Histamine CA Jorgensen et al 2023 Frontiers.xlsx]Histamine Analysis'!$G$73,'[Histamine CA Jorgensen et al 2023 Frontiers.xlsx]Histamine Analysis'!$I$73</c:f>
                <c:numCache>
                  <c:formatCode>General</c:formatCode>
                  <c:ptCount val="4"/>
                  <c:pt idx="0">
                    <c:v>5.3061319117083157</c:v>
                  </c:pt>
                  <c:pt idx="1">
                    <c:v>5.582249957326952</c:v>
                  </c:pt>
                  <c:pt idx="2">
                    <c:v>12.028099928212839</c:v>
                  </c:pt>
                  <c:pt idx="3">
                    <c:v>39.099550708002972</c:v>
                  </c:pt>
                </c:numCache>
                <c:extLst/>
              </c:numRef>
            </c:plus>
            <c:minus>
              <c:numRef>
                <c:f>'[Histamine CA Jorgensen et al 2023 Frontiers.xlsx]Histamine Analysis'!$C$73,'[Histamine CA Jorgensen et al 2023 Frontiers.xlsx]Histamine Analysis'!$E$73,'[Histamine CA Jorgensen et al 2023 Frontiers.xlsx]Histamine Analysis'!$G$73,'[Histamine CA Jorgensen et al 2023 Frontiers.xlsx]Histamine Analysis'!$I$73</c:f>
                <c:numCache>
                  <c:formatCode>General</c:formatCode>
                  <c:ptCount val="4"/>
                  <c:pt idx="0">
                    <c:v>5.3061319117083157</c:v>
                  </c:pt>
                  <c:pt idx="1">
                    <c:v>5.582249957326952</c:v>
                  </c:pt>
                  <c:pt idx="2">
                    <c:v>12.028099928212839</c:v>
                  </c:pt>
                  <c:pt idx="3">
                    <c:v>39.099550708002972</c:v>
                  </c:pt>
                </c:numCache>
                <c:extLst/>
              </c:numRef>
            </c:minus>
            <c:spPr>
              <a:noFill/>
              <a:ln w="19050" cap="flat" cmpd="sng" algn="ctr">
                <a:solidFill>
                  <a:schemeClr val="tx1"/>
                </a:solidFill>
                <a:round/>
              </a:ln>
              <a:effectLst/>
            </c:spPr>
          </c:errBars>
          <c:cat>
            <c:multiLvlStrRef>
              <c:f>'[UNR1 RT data sIgE MMCP tIgE.xlsx]sIgE + control'!$AN$109:$AR$109</c:f>
              <c:extLst/>
            </c:multiLvlStrRef>
          </c:cat>
          <c:val>
            <c:numRef>
              <c:f>'[Histamine CA Jorgensen et al 2023 Frontiers.xlsx]Histamine Analysis'!$M$68:$M$69,'[Histamine CA Jorgensen et al 2023 Frontiers.xlsx]Histamine Analysis'!$P$68:$P$69</c:f>
              <c:numCache>
                <c:formatCode>0.00</c:formatCode>
                <c:ptCount val="4"/>
                <c:pt idx="0">
                  <c:v>137.48264248879417</c:v>
                </c:pt>
                <c:pt idx="1">
                  <c:v>90.198227615436991</c:v>
                </c:pt>
                <c:pt idx="2">
                  <c:v>112.53865566891227</c:v>
                </c:pt>
                <c:pt idx="3">
                  <c:v>1193.6489487920869</c:v>
                </c:pt>
              </c:numCache>
              <c:extLst/>
            </c:numRef>
          </c:val>
          <c:extLst>
            <c:ext xmlns:c16="http://schemas.microsoft.com/office/drawing/2014/chart" uri="{C3380CC4-5D6E-409C-BE32-E72D297353CC}">
              <c16:uniqueId val="{00000008-3F20-4CA0-A627-E6E9F57A854D}"/>
            </c:ext>
          </c:extLst>
        </c:ser>
        <c:dLbls>
          <c:showLegendKey val="0"/>
          <c:showVal val="0"/>
          <c:showCatName val="0"/>
          <c:showSerName val="0"/>
          <c:showPercent val="0"/>
          <c:showBubbleSize val="0"/>
        </c:dLbls>
        <c:gapWidth val="86"/>
        <c:axId val="322032816"/>
        <c:axId val="322034464"/>
      </c:barChart>
      <c:lineChart>
        <c:grouping val="standard"/>
        <c:varyColors val="0"/>
        <c:dLbls>
          <c:showLegendKey val="0"/>
          <c:showVal val="0"/>
          <c:showCatName val="0"/>
          <c:showSerName val="0"/>
          <c:showPercent val="0"/>
          <c:showBubbleSize val="0"/>
        </c:dLbls>
        <c:marker val="1"/>
        <c:smooth val="0"/>
        <c:axId val="322032816"/>
        <c:axId val="322034464"/>
        <c:extLst>
          <c:ext xmlns:c15="http://schemas.microsoft.com/office/drawing/2012/chart" uri="{02D57815-91ED-43cb-92C2-25804820EDAC}">
            <c15:filteredLineSeries>
              <c15:ser>
                <c:idx val="0"/>
                <c:order val="0"/>
                <c:tx>
                  <c:v>C11</c:v>
                </c:tx>
                <c:spPr>
                  <a:ln w="25400" cap="rnd">
                    <a:noFill/>
                    <a:round/>
                  </a:ln>
                  <a:effectLst/>
                </c:spPr>
                <c:marker>
                  <c:symbol val="circle"/>
                  <c:size val="7"/>
                  <c:spPr>
                    <a:solidFill>
                      <a:schemeClr val="tx1"/>
                    </a:solidFill>
                    <a:ln w="15875">
                      <a:solidFill>
                        <a:schemeClr val="tx1"/>
                      </a:solidFill>
                    </a:ln>
                    <a:effectLst/>
                  </c:spPr>
                </c:marker>
                <c:cat>
                  <c:multiLvlStrRef>
                    <c:extLst>
                      <c:ex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c:ext uri="{02D57815-91ED-43cb-92C2-25804820EDAC}">
                        <c15:formulaRef>
                          <c15:sqref>'[UNR1 RT data sIgE MMCP tIgE.xlsx]sIgE + control'!$AN$110:$AR$110</c15:sqref>
                        </c15:formulaRef>
                      </c:ext>
                    </c:extLst>
                  </c:numRef>
                </c:val>
                <c:smooth val="0"/>
                <c:extLst>
                  <c:ext xmlns:c16="http://schemas.microsoft.com/office/drawing/2014/chart" uri="{C3380CC4-5D6E-409C-BE32-E72D297353CC}">
                    <c16:uniqueId val="{00000009-3F20-4CA0-A627-E6E9F57A854D}"/>
                  </c:ext>
                </c:extLst>
              </c15:ser>
            </c15:filteredLineSeries>
            <c15:filteredLineSeries>
              <c15:ser>
                <c:idx val="1"/>
                <c:order val="1"/>
                <c:tx>
                  <c:v>C12</c:v>
                </c:tx>
                <c:spPr>
                  <a:ln w="25400" cap="rnd">
                    <a:noFill/>
                    <a:round/>
                  </a:ln>
                  <a:effectLst/>
                </c:spPr>
                <c:marker>
                  <c:symbol val="circle"/>
                  <c:size val="7"/>
                  <c:spPr>
                    <a:solidFill>
                      <a:schemeClr val="tx1"/>
                    </a:solidFill>
                    <a:ln w="1587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1:$AR$111</c15:sqref>
                        </c15:formulaRef>
                      </c:ext>
                    </c:extLst>
                  </c:numRef>
                </c:val>
                <c:smooth val="0"/>
                <c:extLst xmlns:c15="http://schemas.microsoft.com/office/drawing/2012/chart">
                  <c:ext xmlns:c16="http://schemas.microsoft.com/office/drawing/2014/chart" uri="{C3380CC4-5D6E-409C-BE32-E72D297353CC}">
                    <c16:uniqueId val="{0000000A-3F20-4CA0-A627-E6E9F57A854D}"/>
                  </c:ext>
                </c:extLst>
              </c15:ser>
            </c15:filteredLineSeries>
            <c15:filteredLineSeries>
              <c15:ser>
                <c:idx val="2"/>
                <c:order val="2"/>
                <c:tx>
                  <c:v>C13</c:v>
                </c:tx>
                <c:spPr>
                  <a:ln w="25400" cap="rnd">
                    <a:noFill/>
                    <a:round/>
                  </a:ln>
                  <a:effectLst/>
                </c:spPr>
                <c:marker>
                  <c:symbol val="circle"/>
                  <c:size val="7"/>
                  <c:spPr>
                    <a:solidFill>
                      <a:schemeClr val="tx1"/>
                    </a:solidFill>
                    <a:ln w="1587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2:$AR$112</c15:sqref>
                        </c15:formulaRef>
                      </c:ext>
                    </c:extLst>
                  </c:numRef>
                </c:val>
                <c:smooth val="0"/>
                <c:extLst xmlns:c15="http://schemas.microsoft.com/office/drawing/2012/chart">
                  <c:ext xmlns:c16="http://schemas.microsoft.com/office/drawing/2014/chart" uri="{C3380CC4-5D6E-409C-BE32-E72D297353CC}">
                    <c16:uniqueId val="{0000000B-3F20-4CA0-A627-E6E9F57A854D}"/>
                  </c:ext>
                </c:extLst>
              </c15:ser>
            </c15:filteredLineSeries>
            <c15:filteredLineSeries>
              <c15:ser>
                <c:idx val="3"/>
                <c:order val="3"/>
                <c:tx>
                  <c:v>C14</c:v>
                </c:tx>
                <c:spPr>
                  <a:ln w="25400" cap="rnd">
                    <a:noFill/>
                    <a:round/>
                  </a:ln>
                  <a:effectLst/>
                </c:spPr>
                <c:marker>
                  <c:symbol val="circle"/>
                  <c:size val="7"/>
                  <c:spPr>
                    <a:solidFill>
                      <a:schemeClr val="tx1"/>
                    </a:solidFill>
                    <a:ln w="1587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3:$AR$113</c15:sqref>
                        </c15:formulaRef>
                      </c:ext>
                    </c:extLst>
                  </c:numRef>
                </c:val>
                <c:smooth val="0"/>
                <c:extLst xmlns:c15="http://schemas.microsoft.com/office/drawing/2012/chart">
                  <c:ext xmlns:c16="http://schemas.microsoft.com/office/drawing/2014/chart" uri="{C3380CC4-5D6E-409C-BE32-E72D297353CC}">
                    <c16:uniqueId val="{0000000C-3F20-4CA0-A627-E6E9F57A854D}"/>
                  </c:ext>
                </c:extLst>
              </c15:ser>
            </c15:filteredLineSeries>
            <c15:filteredLineSeries>
              <c15:ser>
                <c:idx val="4"/>
                <c:order val="4"/>
                <c:tx>
                  <c:v>C15</c:v>
                </c:tx>
                <c:spPr>
                  <a:ln w="25400" cap="rnd">
                    <a:noFill/>
                    <a:round/>
                  </a:ln>
                  <a:effectLst/>
                </c:spPr>
                <c:marker>
                  <c:symbol val="circle"/>
                  <c:size val="7"/>
                  <c:spPr>
                    <a:solidFill>
                      <a:schemeClr val="tx1"/>
                    </a:solidFill>
                    <a:ln w="1587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4:$AR$114</c15:sqref>
                        </c15:formulaRef>
                      </c:ext>
                    </c:extLst>
                  </c:numRef>
                </c:val>
                <c:smooth val="0"/>
                <c:extLst xmlns:c15="http://schemas.microsoft.com/office/drawing/2012/chart">
                  <c:ext xmlns:c16="http://schemas.microsoft.com/office/drawing/2014/chart" uri="{C3380CC4-5D6E-409C-BE32-E72D297353CC}">
                    <c16:uniqueId val="{0000000D-3F20-4CA0-A627-E6E9F57A854D}"/>
                  </c:ext>
                </c:extLst>
              </c15:ser>
            </c15:filteredLineSeries>
            <c15:filteredLineSeries>
              <c15:ser>
                <c:idx val="6"/>
                <c:order val="6"/>
                <c:tx>
                  <c:v>C21</c:v>
                </c:tx>
                <c:spPr>
                  <a:ln w="25400" cap="rnd">
                    <a:noFill/>
                    <a:round/>
                  </a:ln>
                  <a:effectLst/>
                </c:spPr>
                <c:marker>
                  <c:symbol val="circle"/>
                  <c:size val="7"/>
                  <c:spPr>
                    <a:solidFill>
                      <a:schemeClr val="tx1"/>
                    </a:solidFill>
                    <a:ln w="1587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5:$AR$115</c15:sqref>
                        </c15:formulaRef>
                      </c:ext>
                    </c:extLst>
                  </c:numRef>
                </c:val>
                <c:smooth val="0"/>
                <c:extLst xmlns:c15="http://schemas.microsoft.com/office/drawing/2012/chart">
                  <c:ext xmlns:c16="http://schemas.microsoft.com/office/drawing/2014/chart" uri="{C3380CC4-5D6E-409C-BE32-E72D297353CC}">
                    <c16:uniqueId val="{0000000E-3F20-4CA0-A627-E6E9F57A854D}"/>
                  </c:ext>
                </c:extLst>
              </c15:ser>
            </c15:filteredLineSeries>
            <c15:filteredLineSeries>
              <c15:ser>
                <c:idx val="7"/>
                <c:order val="7"/>
                <c:tx>
                  <c:v>C22</c:v>
                </c:tx>
                <c:spPr>
                  <a:ln w="25400" cap="rnd">
                    <a:noFill/>
                    <a:round/>
                  </a:ln>
                  <a:effectLst/>
                </c:spPr>
                <c:marker>
                  <c:symbol val="circle"/>
                  <c:size val="7"/>
                  <c:spPr>
                    <a:solidFill>
                      <a:schemeClr val="tx1"/>
                    </a:solidFill>
                    <a:ln w="1587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6:$AR$116</c15:sqref>
                        </c15:formulaRef>
                      </c:ext>
                    </c:extLst>
                  </c:numRef>
                </c:val>
                <c:smooth val="0"/>
                <c:extLst xmlns:c15="http://schemas.microsoft.com/office/drawing/2012/chart">
                  <c:ext xmlns:c16="http://schemas.microsoft.com/office/drawing/2014/chart" uri="{C3380CC4-5D6E-409C-BE32-E72D297353CC}">
                    <c16:uniqueId val="{0000000F-3F20-4CA0-A627-E6E9F57A854D}"/>
                  </c:ext>
                </c:extLst>
              </c15:ser>
            </c15:filteredLineSeries>
            <c15:filteredLineSeries>
              <c15:ser>
                <c:idx val="8"/>
                <c:order val="8"/>
                <c:tx>
                  <c:v>C23</c:v>
                </c:tx>
                <c:spPr>
                  <a:ln w="25400" cap="rnd">
                    <a:noFill/>
                    <a:round/>
                  </a:ln>
                  <a:effectLst/>
                </c:spPr>
                <c:marker>
                  <c:symbol val="circle"/>
                  <c:size val="7"/>
                  <c:spPr>
                    <a:solidFill>
                      <a:schemeClr val="tx1"/>
                    </a:solidFill>
                    <a:ln w="9525">
                      <a:solidFill>
                        <a:schemeClr val="tx1"/>
                      </a:solidFill>
                    </a:ln>
                    <a:effectLst/>
                  </c:spPr>
                </c:marker>
                <c:cat>
                  <c:multiLvlStrRef>
                    <c:extLst xmlns:c15="http://schemas.microsoft.com/office/drawing/2012/chart">
                      <c:ext xmlns:c15="http://schemas.microsoft.com/office/drawing/2012/chart" uri="{02D57815-91ED-43cb-92C2-25804820EDAC}">
                        <c15:formulaRef>
                          <c15:sqref>'[Histamine CA Jorgensen et al 2023 Frontiers.xlsx]Histamine Analysis'!$L$68:$L$69,'[Histamine CA Jorgensen et al 2023 Frontiers.xlsx]Histamine Analysis'!$O$67:$O$69</c15:sqref>
                        </c15:formulaRef>
                      </c:ext>
                    </c:extLst>
                    <c:multiLvlStrCache>
                      <c:ptCount val="2"/>
                      <c:lvl>
                        <c:pt idx="0">
                          <c:v>V/P IP</c:v>
                        </c:pt>
                        <c:pt idx="1">
                          <c:v>P/P IP</c:v>
                        </c:pt>
                      </c:lvl>
                      <c:lvl>
                        <c:pt idx="0">
                          <c:v>V/V IP</c:v>
                        </c:pt>
                        <c:pt idx="1">
                          <c:v>P/V IP</c:v>
                        </c:pt>
                      </c:lvl>
                    </c:multiLvlStrCache>
                  </c:multiLvlStrRef>
                </c:cat>
                <c:val>
                  <c:numRef>
                    <c:extLst xmlns:c15="http://schemas.microsoft.com/office/drawing/2012/chart">
                      <c:ext xmlns:c15="http://schemas.microsoft.com/office/drawing/2012/chart" uri="{02D57815-91ED-43cb-92C2-25804820EDAC}">
                        <c15:formulaRef>
                          <c15:sqref>'[UNR1 RT data sIgE MMCP tIgE.xlsx]sIgE + control'!$AN$118:$AR$118</c15:sqref>
                        </c15:formulaRef>
                      </c:ext>
                    </c:extLst>
                  </c:numRef>
                </c:val>
                <c:smooth val="0"/>
                <c:extLst xmlns:c15="http://schemas.microsoft.com/office/drawing/2012/chart">
                  <c:ext xmlns:c16="http://schemas.microsoft.com/office/drawing/2014/chart" uri="{C3380CC4-5D6E-409C-BE32-E72D297353CC}">
                    <c16:uniqueId val="{00000010-3F20-4CA0-A627-E6E9F57A854D}"/>
                  </c:ext>
                </c:extLst>
              </c15:ser>
            </c15:filteredLineSeries>
          </c:ext>
        </c:extLst>
      </c:lineChart>
      <c:catAx>
        <c:axId val="322032816"/>
        <c:scaling>
          <c:orientation val="minMax"/>
        </c:scaling>
        <c:delete val="0"/>
        <c:axPos val="b"/>
        <c:title>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title>
        <c:numFmt formatCode="General" sourceLinked="1"/>
        <c:majorTickMark val="out"/>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crossAx val="322034464"/>
        <c:crosses val="autoZero"/>
        <c:auto val="1"/>
        <c:lblAlgn val="ctr"/>
        <c:lblOffset val="100"/>
        <c:noMultiLvlLbl val="0"/>
      </c:catAx>
      <c:valAx>
        <c:axId val="322034464"/>
        <c:scaling>
          <c:orientation val="minMax"/>
          <c:max val="1400"/>
        </c:scaling>
        <c:delete val="0"/>
        <c:axPos val="l"/>
        <c:title>
          <c:tx>
            <c:rich>
              <a:bodyPr rot="-54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r>
                  <a:rPr lang="en-US" baseline="0"/>
                  <a:t>Histamine (ng/mL)</a:t>
                </a:r>
              </a:p>
            </c:rich>
          </c:tx>
          <c:layout>
            <c:manualLayout>
              <c:xMode val="edge"/>
              <c:yMode val="edge"/>
              <c:x val="2.7777777777777779E-3"/>
              <c:y val="0.27243525809273839"/>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title>
        <c:numFmt formatCode="0.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Times New Roman" panose="02020603050405020304" pitchFamily="18" charset="0"/>
                <a:ea typeface="+mn-ea"/>
                <a:cs typeface="+mn-cs"/>
              </a:defRPr>
            </a:pPr>
            <a:endParaRPr lang="en-US"/>
          </a:p>
        </c:txPr>
        <c:crossAx val="322032816"/>
        <c:crosses val="autoZero"/>
        <c:crossBetween val="between"/>
        <c:majorUnit val="200"/>
      </c:valAx>
      <c:spPr>
        <a:noFill/>
        <a:ln>
          <a:noFill/>
        </a:ln>
        <a:effectLst/>
      </c:spPr>
    </c:plotArea>
    <c:plotVisOnly val="1"/>
    <c:dispBlanksAs val="gap"/>
    <c:showDLblsOverMax val="0"/>
  </c:chart>
  <c:spPr>
    <a:noFill/>
    <a:ln>
      <a:noFill/>
    </a:ln>
    <a:effectLst/>
  </c:spPr>
  <c:txPr>
    <a:bodyPr/>
    <a:lstStyle/>
    <a:p>
      <a:pPr>
        <a:defRPr sz="1600" b="1" i="0" baseline="0">
          <a:solidFill>
            <a:sysClr val="windowText" lastClr="000000"/>
          </a:solidFill>
          <a:latin typeface="Times New Roman" panose="02020603050405020304" pitchFamily="18"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5"/>
          <c:order val="5"/>
          <c:tx>
            <c:strRef>
              <c:f>'sIgE + control'!$X$98:$AB$98</c:f>
              <c:strCache>
                <c:ptCount val="5"/>
                <c:pt idx="0">
                  <c:v>Pre </c:v>
                </c:pt>
                <c:pt idx="1">
                  <c:v>2R </c:v>
                </c:pt>
                <c:pt idx="2">
                  <c:v>4R</c:v>
                </c:pt>
                <c:pt idx="3">
                  <c:v>6R</c:v>
                </c:pt>
                <c:pt idx="4">
                  <c:v>8R</c:v>
                </c:pt>
              </c:strCache>
            </c:strRef>
          </c:tx>
          <c:spPr>
            <a:solidFill>
              <a:schemeClr val="accent6"/>
            </a:solidFill>
            <a:ln w="19050">
              <a:solidFill>
                <a:schemeClr val="tx1"/>
              </a:solidFill>
            </a:ln>
            <a:effectLst/>
          </c:spPr>
          <c:invertIfNegative val="0"/>
          <c:dPt>
            <c:idx val="0"/>
            <c:invertIfNegative val="0"/>
            <c:bubble3D val="0"/>
            <c:spPr>
              <a:noFill/>
              <a:ln w="19050">
                <a:solidFill>
                  <a:schemeClr val="tx1"/>
                </a:solidFill>
              </a:ln>
              <a:effectLst/>
            </c:spPr>
            <c:extLst>
              <c:ext xmlns:c16="http://schemas.microsoft.com/office/drawing/2014/chart" uri="{C3380CC4-5D6E-409C-BE32-E72D297353CC}">
                <c16:uniqueId val="{00000001-685A-4FF6-A15F-94B85F5B56BD}"/>
              </c:ext>
            </c:extLst>
          </c:dPt>
          <c:dPt>
            <c:idx val="1"/>
            <c:invertIfNegative val="0"/>
            <c:bubble3D val="0"/>
            <c:spPr>
              <a:pattFill prst="ltDnDiag">
                <a:fgClr>
                  <a:schemeClr val="tx1"/>
                </a:fgClr>
                <a:bgClr>
                  <a:schemeClr val="bg1"/>
                </a:bgClr>
              </a:pattFill>
              <a:ln w="19050">
                <a:solidFill>
                  <a:schemeClr val="tx1"/>
                </a:solidFill>
              </a:ln>
              <a:effectLst/>
            </c:spPr>
            <c:extLst>
              <c:ext xmlns:c16="http://schemas.microsoft.com/office/drawing/2014/chart" uri="{C3380CC4-5D6E-409C-BE32-E72D297353CC}">
                <c16:uniqueId val="{00000003-685A-4FF6-A15F-94B85F5B56BD}"/>
              </c:ext>
            </c:extLst>
          </c:dPt>
          <c:dPt>
            <c:idx val="2"/>
            <c:invertIfNegative val="0"/>
            <c:bubble3D val="0"/>
            <c:spPr>
              <a:pattFill prst="narHorz">
                <a:fgClr>
                  <a:schemeClr val="tx1"/>
                </a:fgClr>
                <a:bgClr>
                  <a:schemeClr val="bg1"/>
                </a:bgClr>
              </a:pattFill>
              <a:ln w="19050">
                <a:solidFill>
                  <a:schemeClr val="tx1"/>
                </a:solidFill>
              </a:ln>
              <a:effectLst/>
            </c:spPr>
            <c:extLst>
              <c:ext xmlns:c16="http://schemas.microsoft.com/office/drawing/2014/chart" uri="{C3380CC4-5D6E-409C-BE32-E72D297353CC}">
                <c16:uniqueId val="{00000005-685A-4FF6-A15F-94B85F5B56BD}"/>
              </c:ext>
            </c:extLst>
          </c:dPt>
          <c:dPt>
            <c:idx val="3"/>
            <c:invertIfNegative val="0"/>
            <c:bubble3D val="0"/>
            <c:spPr>
              <a:pattFill prst="dashDnDiag">
                <a:fgClr>
                  <a:schemeClr val="tx1"/>
                </a:fgClr>
                <a:bgClr>
                  <a:schemeClr val="bg1"/>
                </a:bgClr>
              </a:pattFill>
              <a:ln w="19050">
                <a:solidFill>
                  <a:schemeClr val="tx1"/>
                </a:solidFill>
              </a:ln>
              <a:effectLst/>
            </c:spPr>
            <c:extLst>
              <c:ext xmlns:c16="http://schemas.microsoft.com/office/drawing/2014/chart" uri="{C3380CC4-5D6E-409C-BE32-E72D297353CC}">
                <c16:uniqueId val="{00000007-685A-4FF6-A15F-94B85F5B56BD}"/>
              </c:ext>
            </c:extLst>
          </c:dPt>
          <c:dPt>
            <c:idx val="4"/>
            <c:invertIfNegative val="0"/>
            <c:bubble3D val="0"/>
            <c:spPr>
              <a:solidFill>
                <a:schemeClr val="bg1">
                  <a:lumMod val="75000"/>
                </a:schemeClr>
              </a:solidFill>
              <a:ln w="19050">
                <a:solidFill>
                  <a:schemeClr val="tx1"/>
                </a:solidFill>
              </a:ln>
              <a:effectLst/>
            </c:spPr>
            <c:extLst>
              <c:ext xmlns:c16="http://schemas.microsoft.com/office/drawing/2014/chart" uri="{C3380CC4-5D6E-409C-BE32-E72D297353CC}">
                <c16:uniqueId val="{00000009-685A-4FF6-A15F-94B85F5B56BD}"/>
              </c:ext>
            </c:extLst>
          </c:dPt>
          <c:errBars>
            <c:errBarType val="both"/>
            <c:errValType val="cust"/>
            <c:noEndCap val="0"/>
            <c:plus>
              <c:numRef>
                <c:f>'sIgE + control'!$P$126:$T$126</c:f>
                <c:numCache>
                  <c:formatCode>General</c:formatCode>
                  <c:ptCount val="5"/>
                  <c:pt idx="0">
                    <c:v>2.5199344127267388E-3</c:v>
                  </c:pt>
                  <c:pt idx="1">
                    <c:v>3.6178665444337949E-3</c:v>
                  </c:pt>
                  <c:pt idx="2">
                    <c:v>4.4092705367970208E-3</c:v>
                  </c:pt>
                  <c:pt idx="3">
                    <c:v>4.5434705897584495E-3</c:v>
                  </c:pt>
                  <c:pt idx="4">
                    <c:v>2.1213203435596424E-3</c:v>
                  </c:pt>
                </c:numCache>
              </c:numRef>
            </c:plus>
            <c:minus>
              <c:numRef>
                <c:f>'sIgE + control'!$P$126:$T$126</c:f>
                <c:numCache>
                  <c:formatCode>General</c:formatCode>
                  <c:ptCount val="5"/>
                  <c:pt idx="0">
                    <c:v>2.5199344127267388E-3</c:v>
                  </c:pt>
                  <c:pt idx="1">
                    <c:v>3.6178665444337949E-3</c:v>
                  </c:pt>
                  <c:pt idx="2">
                    <c:v>4.4092705367970208E-3</c:v>
                  </c:pt>
                  <c:pt idx="3">
                    <c:v>4.5434705897584495E-3</c:v>
                  </c:pt>
                  <c:pt idx="4">
                    <c:v>2.1213203435596424E-3</c:v>
                  </c:pt>
                </c:numCache>
              </c:numRef>
            </c:minus>
            <c:spPr>
              <a:noFill/>
              <a:ln w="19050" cap="flat" cmpd="sng" algn="ctr">
                <a:solidFill>
                  <a:schemeClr val="tx1"/>
                </a:solidFill>
                <a:round/>
              </a:ln>
              <a:effectLst/>
            </c:spPr>
          </c:errBars>
          <c:cat>
            <c:strRef>
              <c:f>'sIgE + control'!$X$98:$AB$98</c:f>
              <c:strCache>
                <c:ptCount val="5"/>
                <c:pt idx="0">
                  <c:v>Pre </c:v>
                </c:pt>
                <c:pt idx="1">
                  <c:v>2R </c:v>
                </c:pt>
                <c:pt idx="2">
                  <c:v>4R</c:v>
                </c:pt>
                <c:pt idx="3">
                  <c:v>6R</c:v>
                </c:pt>
                <c:pt idx="4">
                  <c:v>8R</c:v>
                </c:pt>
              </c:strCache>
            </c:strRef>
          </c:cat>
          <c:val>
            <c:numRef>
              <c:f>'sIgE + control'!$P$124:$T$124</c:f>
              <c:numCache>
                <c:formatCode>General</c:formatCode>
                <c:ptCount val="5"/>
                <c:pt idx="0">
                  <c:v>0.12592500000000001</c:v>
                </c:pt>
                <c:pt idx="1">
                  <c:v>0.12467500000000001</c:v>
                </c:pt>
                <c:pt idx="2">
                  <c:v>0.12875</c:v>
                </c:pt>
                <c:pt idx="3">
                  <c:v>0.14042500000000002</c:v>
                </c:pt>
                <c:pt idx="4">
                  <c:v>0.158</c:v>
                </c:pt>
              </c:numCache>
            </c:numRef>
          </c:val>
          <c:extLst>
            <c:ext xmlns:c16="http://schemas.microsoft.com/office/drawing/2014/chart" uri="{C3380CC4-5D6E-409C-BE32-E72D297353CC}">
              <c16:uniqueId val="{0000000A-685A-4FF6-A15F-94B85F5B56BD}"/>
            </c:ext>
          </c:extLst>
        </c:ser>
        <c:dLbls>
          <c:showLegendKey val="0"/>
          <c:showVal val="0"/>
          <c:showCatName val="0"/>
          <c:showSerName val="0"/>
          <c:showPercent val="0"/>
          <c:showBubbleSize val="0"/>
        </c:dLbls>
        <c:gapWidth val="89"/>
        <c:axId val="322032816"/>
        <c:axId val="322034464"/>
      </c:barChart>
      <c:lineChart>
        <c:grouping val="standard"/>
        <c:varyColors val="0"/>
        <c:dLbls>
          <c:showLegendKey val="0"/>
          <c:showVal val="0"/>
          <c:showCatName val="0"/>
          <c:showSerName val="0"/>
          <c:showPercent val="0"/>
          <c:showBubbleSize val="0"/>
        </c:dLbls>
        <c:marker val="1"/>
        <c:smooth val="0"/>
        <c:axId val="322032816"/>
        <c:axId val="322034464"/>
        <c:extLst>
          <c:ext xmlns:c15="http://schemas.microsoft.com/office/drawing/2012/chart" uri="{02D57815-91ED-43cb-92C2-25804820EDAC}">
            <c15:filteredLineSeries>
              <c15:ser>
                <c:idx val="0"/>
                <c:order val="0"/>
                <c:tx>
                  <c:v>C11</c:v>
                </c:tx>
                <c:spPr>
                  <a:ln w="28575" cap="rnd">
                    <a:noFill/>
                    <a:round/>
                  </a:ln>
                  <a:effectLst/>
                </c:spPr>
                <c:marker>
                  <c:symbol val="none"/>
                </c:marker>
                <c:cat>
                  <c:numRef>
                    <c:extLst>
                      <c:ext uri="{02D57815-91ED-43cb-92C2-25804820EDAC}">
                        <c15:formulaRef>
                          <c15:sqref>'sIgE + control'!$AR$67:$AU$67</c15:sqref>
                        </c15:formulaRef>
                      </c:ext>
                    </c:extLst>
                    <c:numCache>
                      <c:formatCode>General</c:formatCode>
                      <c:ptCount val="4"/>
                    </c:numCache>
                  </c:numRef>
                </c:cat>
                <c:val>
                  <c:numRef>
                    <c:extLst>
                      <c:ext uri="{02D57815-91ED-43cb-92C2-25804820EDAC}">
                        <c15:formulaRef>
                          <c15:sqref>'sIgE + control'!$X$99:$AA$99</c15:sqref>
                        </c15:formulaRef>
                      </c:ext>
                    </c:extLst>
                    <c:numCache>
                      <c:formatCode>General</c:formatCode>
                      <c:ptCount val="4"/>
                    </c:numCache>
                  </c:numRef>
                </c:val>
                <c:smooth val="0"/>
                <c:extLst>
                  <c:ext xmlns:c16="http://schemas.microsoft.com/office/drawing/2014/chart" uri="{C3380CC4-5D6E-409C-BE32-E72D297353CC}">
                    <c16:uniqueId val="{0000000B-685A-4FF6-A15F-94B85F5B56BD}"/>
                  </c:ext>
                </c:extLst>
              </c15:ser>
            </c15:filteredLineSeries>
            <c15:filteredLineSeries>
              <c15:ser>
                <c:idx val="1"/>
                <c:order val="1"/>
                <c:tx>
                  <c:v>C12</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0:$AA$100</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C-685A-4FF6-A15F-94B85F5B56BD}"/>
                  </c:ext>
                </c:extLst>
              </c15:ser>
            </c15:filteredLineSeries>
            <c15:filteredLineSeries>
              <c15:ser>
                <c:idx val="2"/>
                <c:order val="2"/>
                <c:tx>
                  <c:v>C13</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1:$AA$101</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D-685A-4FF6-A15F-94B85F5B56BD}"/>
                  </c:ext>
                </c:extLst>
              </c15:ser>
            </c15:filteredLineSeries>
            <c15:filteredLineSeries>
              <c15:ser>
                <c:idx val="3"/>
                <c:order val="3"/>
                <c:tx>
                  <c:v>C14</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2:$AA$102</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E-685A-4FF6-A15F-94B85F5B56BD}"/>
                  </c:ext>
                </c:extLst>
              </c15:ser>
            </c15:filteredLineSeries>
            <c15:filteredLineSeries>
              <c15:ser>
                <c:idx val="4"/>
                <c:order val="4"/>
                <c:tx>
                  <c:v>C15</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3:$AA$103</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F-685A-4FF6-A15F-94B85F5B56BD}"/>
                  </c:ext>
                </c:extLst>
              </c15:ser>
            </c15:filteredLineSeries>
            <c15:filteredLineSeries>
              <c15:ser>
                <c:idx val="7"/>
                <c:order val="6"/>
                <c:tx>
                  <c:v>C22</c:v>
                </c:tx>
                <c:spPr>
                  <a:ln w="25400"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5:$AA$105</c15:sqref>
                        </c15:formulaRef>
                      </c:ext>
                    </c:extLst>
                    <c:numCache>
                      <c:formatCode>0.00</c:formatCode>
                      <c:ptCount val="4"/>
                      <c:pt idx="0">
                        <c:v>0.12625</c:v>
                      </c:pt>
                      <c:pt idx="1">
                        <c:v>2.0100000000000002</c:v>
                      </c:pt>
                      <c:pt idx="2">
                        <c:v>3.2155000000000005</c:v>
                      </c:pt>
                      <c:pt idx="3">
                        <c:v>3.8410000000000002</c:v>
                      </c:pt>
                    </c:numCache>
                  </c:numRef>
                </c:val>
                <c:smooth val="0"/>
                <c:extLst xmlns:c15="http://schemas.microsoft.com/office/drawing/2012/chart">
                  <c:ext xmlns:c16="http://schemas.microsoft.com/office/drawing/2014/chart" uri="{C3380CC4-5D6E-409C-BE32-E72D297353CC}">
                    <c16:uniqueId val="{00000010-685A-4FF6-A15F-94B85F5B56BD}"/>
                  </c:ext>
                </c:extLst>
              </c15:ser>
            </c15:filteredLineSeries>
            <c15:filteredLineSeries>
              <c15:ser>
                <c:idx val="8"/>
                <c:order val="7"/>
                <c:tx>
                  <c:v>C23</c:v>
                </c:tx>
                <c:spPr>
                  <a:ln w="25400"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6:$AA$106</c15:sqref>
                        </c15:formulaRef>
                      </c:ext>
                    </c:extLst>
                    <c:numCache>
                      <c:formatCode>0.00</c:formatCode>
                      <c:ptCount val="4"/>
                      <c:pt idx="0">
                        <c:v>0.1565</c:v>
                      </c:pt>
                      <c:pt idx="1">
                        <c:v>0.22600000000000003</c:v>
                      </c:pt>
                      <c:pt idx="2">
                        <c:v>1.1447499999999999</c:v>
                      </c:pt>
                      <c:pt idx="3">
                        <c:v>1.7202500000000001</c:v>
                      </c:pt>
                    </c:numCache>
                  </c:numRef>
                </c:val>
                <c:smooth val="0"/>
                <c:extLst xmlns:c15="http://schemas.microsoft.com/office/drawing/2012/chart">
                  <c:ext xmlns:c16="http://schemas.microsoft.com/office/drawing/2014/chart" uri="{C3380CC4-5D6E-409C-BE32-E72D297353CC}">
                    <c16:uniqueId val="{00000011-685A-4FF6-A15F-94B85F5B56BD}"/>
                  </c:ext>
                </c:extLst>
              </c15:ser>
            </c15:filteredLineSeries>
            <c15:filteredLineSeries>
              <c15:ser>
                <c:idx val="9"/>
                <c:order val="8"/>
                <c:tx>
                  <c:v>C24</c:v>
                </c:tx>
                <c:spPr>
                  <a:ln w="25400"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7:$AA$107</c15:sqref>
                        </c15:formulaRef>
                      </c:ext>
                    </c:extLst>
                    <c:numCache>
                      <c:formatCode>0.00</c:formatCode>
                      <c:ptCount val="4"/>
                      <c:pt idx="0">
                        <c:v>0.154</c:v>
                      </c:pt>
                      <c:pt idx="1">
                        <c:v>2.8059999999999996</c:v>
                      </c:pt>
                      <c:pt idx="2">
                        <c:v>1.9295</c:v>
                      </c:pt>
                      <c:pt idx="3">
                        <c:v>2.3639999999999999</c:v>
                      </c:pt>
                    </c:numCache>
                  </c:numRef>
                </c:val>
                <c:smooth val="0"/>
                <c:extLst xmlns:c15="http://schemas.microsoft.com/office/drawing/2012/chart">
                  <c:ext xmlns:c16="http://schemas.microsoft.com/office/drawing/2014/chart" uri="{C3380CC4-5D6E-409C-BE32-E72D297353CC}">
                    <c16:uniqueId val="{00000012-685A-4FF6-A15F-94B85F5B56BD}"/>
                  </c:ext>
                </c:extLst>
              </c15:ser>
            </c15:filteredLineSeries>
          </c:ext>
        </c:extLst>
      </c:lineChart>
      <c:catAx>
        <c:axId val="322032816"/>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322034464"/>
        <c:crosses val="autoZero"/>
        <c:auto val="1"/>
        <c:lblAlgn val="ctr"/>
        <c:lblOffset val="100"/>
        <c:noMultiLvlLbl val="0"/>
      </c:catAx>
      <c:valAx>
        <c:axId val="322034464"/>
        <c:scaling>
          <c:orientation val="minMax"/>
          <c:max val="4"/>
          <c:min val="0"/>
        </c:scaling>
        <c:delete val="0"/>
        <c:axPos val="l"/>
        <c:title>
          <c:tx>
            <c:rich>
              <a:bodyPr rot="-54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600" b="1" i="0" u="none" strike="noStrike" kern="1200" baseline="0" dirty="0">
                    <a:solidFill>
                      <a:sysClr val="windowText" lastClr="000000"/>
                    </a:solidFill>
                    <a:latin typeface="Times New Roman" panose="02020603050405020304" pitchFamily="18" charset="0"/>
                  </a:rPr>
                  <a:t>Specific IgE Antibody (OD 405- 690 nm)</a:t>
                </a:r>
              </a:p>
            </c:rich>
          </c:tx>
          <c:layout>
            <c:manualLayout>
              <c:xMode val="edge"/>
              <c:yMode val="edge"/>
              <c:x val="7.7838347129685712E-3"/>
              <c:y val="8.0490813648293968E-2"/>
            </c:manualLayout>
          </c:layout>
          <c:overlay val="0"/>
          <c:spPr>
            <a:noFill/>
            <a:ln>
              <a:noFill/>
            </a:ln>
            <a:effectLst/>
          </c:spPr>
          <c:txPr>
            <a:bodyPr rot="-54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322032816"/>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5"/>
          <c:order val="5"/>
          <c:tx>
            <c:strRef>
              <c:f>'sIgE + control'!$X$98:$AB$98</c:f>
              <c:strCache>
                <c:ptCount val="5"/>
                <c:pt idx="0">
                  <c:v>Pre </c:v>
                </c:pt>
                <c:pt idx="1">
                  <c:v>2R </c:v>
                </c:pt>
                <c:pt idx="2">
                  <c:v>4R</c:v>
                </c:pt>
                <c:pt idx="3">
                  <c:v>6R</c:v>
                </c:pt>
                <c:pt idx="4">
                  <c:v>8R</c:v>
                </c:pt>
              </c:strCache>
            </c:strRef>
          </c:tx>
          <c:spPr>
            <a:solidFill>
              <a:schemeClr val="bg1">
                <a:lumMod val="75000"/>
              </a:schemeClr>
            </a:solidFill>
            <a:ln w="19050">
              <a:solidFill>
                <a:schemeClr val="tx1"/>
              </a:solidFill>
            </a:ln>
            <a:effectLst/>
          </c:spPr>
          <c:invertIfNegative val="0"/>
          <c:dPt>
            <c:idx val="0"/>
            <c:invertIfNegative val="0"/>
            <c:bubble3D val="0"/>
            <c:spPr>
              <a:noFill/>
              <a:ln w="19050">
                <a:solidFill>
                  <a:schemeClr val="tx1"/>
                </a:solidFill>
              </a:ln>
              <a:effectLst/>
            </c:spPr>
            <c:extLst>
              <c:ext xmlns:c16="http://schemas.microsoft.com/office/drawing/2014/chart" uri="{C3380CC4-5D6E-409C-BE32-E72D297353CC}">
                <c16:uniqueId val="{00000001-8512-40C7-BA01-2FAFFE1B312D}"/>
              </c:ext>
            </c:extLst>
          </c:dPt>
          <c:dPt>
            <c:idx val="1"/>
            <c:invertIfNegative val="0"/>
            <c:bubble3D val="0"/>
            <c:spPr>
              <a:pattFill prst="wdDnDiag">
                <a:fgClr>
                  <a:schemeClr val="tx1"/>
                </a:fgClr>
                <a:bgClr>
                  <a:schemeClr val="bg1"/>
                </a:bgClr>
              </a:pattFill>
              <a:ln w="19050">
                <a:solidFill>
                  <a:schemeClr val="tx1"/>
                </a:solidFill>
              </a:ln>
              <a:effectLst/>
            </c:spPr>
            <c:extLst>
              <c:ext xmlns:c16="http://schemas.microsoft.com/office/drawing/2014/chart" uri="{C3380CC4-5D6E-409C-BE32-E72D297353CC}">
                <c16:uniqueId val="{00000003-8512-40C7-BA01-2FAFFE1B312D}"/>
              </c:ext>
            </c:extLst>
          </c:dPt>
          <c:dPt>
            <c:idx val="2"/>
            <c:invertIfNegative val="0"/>
            <c:bubble3D val="0"/>
            <c:spPr>
              <a:pattFill prst="dkHorz">
                <a:fgClr>
                  <a:schemeClr val="tx1"/>
                </a:fgClr>
                <a:bgClr>
                  <a:schemeClr val="bg1"/>
                </a:bgClr>
              </a:pattFill>
              <a:ln w="19050">
                <a:solidFill>
                  <a:schemeClr val="tx1"/>
                </a:solidFill>
              </a:ln>
              <a:effectLst/>
            </c:spPr>
            <c:extLst>
              <c:ext xmlns:c16="http://schemas.microsoft.com/office/drawing/2014/chart" uri="{C3380CC4-5D6E-409C-BE32-E72D297353CC}">
                <c16:uniqueId val="{00000005-8512-40C7-BA01-2FAFFE1B312D}"/>
              </c:ext>
            </c:extLst>
          </c:dPt>
          <c:dPt>
            <c:idx val="3"/>
            <c:invertIfNegative val="0"/>
            <c:bubble3D val="0"/>
            <c:spPr>
              <a:pattFill prst="dashDnDiag">
                <a:fgClr>
                  <a:schemeClr val="tx1"/>
                </a:fgClr>
                <a:bgClr>
                  <a:schemeClr val="bg1"/>
                </a:bgClr>
              </a:pattFill>
              <a:ln w="19050">
                <a:solidFill>
                  <a:schemeClr val="tx1"/>
                </a:solidFill>
              </a:ln>
              <a:effectLst/>
            </c:spPr>
            <c:extLst>
              <c:ext xmlns:c16="http://schemas.microsoft.com/office/drawing/2014/chart" uri="{C3380CC4-5D6E-409C-BE32-E72D297353CC}">
                <c16:uniqueId val="{00000007-8512-40C7-BA01-2FAFFE1B312D}"/>
              </c:ext>
            </c:extLst>
          </c:dPt>
          <c:errBars>
            <c:errBarType val="both"/>
            <c:errValType val="cust"/>
            <c:noEndCap val="0"/>
            <c:plus>
              <c:numRef>
                <c:f>'sIgE + control'!$X$126:$AB$126</c:f>
                <c:numCache>
                  <c:formatCode>General</c:formatCode>
                  <c:ptCount val="5"/>
                  <c:pt idx="0">
                    <c:v>5.6939112216472113E-3</c:v>
                  </c:pt>
                  <c:pt idx="1">
                    <c:v>0.35336885827701342</c:v>
                  </c:pt>
                  <c:pt idx="2">
                    <c:v>0.35272482015021284</c:v>
                  </c:pt>
                  <c:pt idx="3">
                    <c:v>0.42202720217422013</c:v>
                  </c:pt>
                  <c:pt idx="4">
                    <c:v>0.43950085324149246</c:v>
                  </c:pt>
                </c:numCache>
              </c:numRef>
            </c:plus>
            <c:minus>
              <c:numRef>
                <c:f>'sIgE + control'!$X$126:$AB$126</c:f>
                <c:numCache>
                  <c:formatCode>General</c:formatCode>
                  <c:ptCount val="5"/>
                  <c:pt idx="0">
                    <c:v>5.6939112216472113E-3</c:v>
                  </c:pt>
                  <c:pt idx="1">
                    <c:v>0.35336885827701342</c:v>
                  </c:pt>
                  <c:pt idx="2">
                    <c:v>0.35272482015021284</c:v>
                  </c:pt>
                  <c:pt idx="3">
                    <c:v>0.42202720217422013</c:v>
                  </c:pt>
                  <c:pt idx="4">
                    <c:v>0.43950085324149246</c:v>
                  </c:pt>
                </c:numCache>
              </c:numRef>
            </c:minus>
            <c:spPr>
              <a:noFill/>
              <a:ln w="19050" cap="flat" cmpd="sng" algn="ctr">
                <a:solidFill>
                  <a:schemeClr val="tx1"/>
                </a:solidFill>
                <a:round/>
              </a:ln>
              <a:effectLst/>
            </c:spPr>
          </c:errBars>
          <c:cat>
            <c:strRef>
              <c:f>'sIgE + control'!$X$98:$AB$98</c:f>
              <c:strCache>
                <c:ptCount val="5"/>
                <c:pt idx="0">
                  <c:v>Pre </c:v>
                </c:pt>
                <c:pt idx="1">
                  <c:v>2R </c:v>
                </c:pt>
                <c:pt idx="2">
                  <c:v>4R</c:v>
                </c:pt>
                <c:pt idx="3">
                  <c:v>6R</c:v>
                </c:pt>
                <c:pt idx="4">
                  <c:v>8R</c:v>
                </c:pt>
              </c:strCache>
            </c:strRef>
          </c:cat>
          <c:val>
            <c:numRef>
              <c:f>'sIgE + control'!$X$124:$AB$124</c:f>
              <c:numCache>
                <c:formatCode>0.00</c:formatCode>
                <c:ptCount val="5"/>
                <c:pt idx="0">
                  <c:v>0.25637499999999996</c:v>
                </c:pt>
                <c:pt idx="1">
                  <c:v>0.84442499999999987</c:v>
                </c:pt>
                <c:pt idx="2">
                  <c:v>1.0882499999999999</c:v>
                </c:pt>
                <c:pt idx="3">
                  <c:v>1.270975</c:v>
                </c:pt>
                <c:pt idx="4" formatCode="General">
                  <c:v>2.2999999999999998</c:v>
                </c:pt>
              </c:numCache>
            </c:numRef>
          </c:val>
          <c:extLst>
            <c:ext xmlns:c16="http://schemas.microsoft.com/office/drawing/2014/chart" uri="{C3380CC4-5D6E-409C-BE32-E72D297353CC}">
              <c16:uniqueId val="{00000008-8512-40C7-BA01-2FAFFE1B312D}"/>
            </c:ext>
          </c:extLst>
        </c:ser>
        <c:dLbls>
          <c:showLegendKey val="0"/>
          <c:showVal val="0"/>
          <c:showCatName val="0"/>
          <c:showSerName val="0"/>
          <c:showPercent val="0"/>
          <c:showBubbleSize val="0"/>
        </c:dLbls>
        <c:gapWidth val="89"/>
        <c:axId val="322032816"/>
        <c:axId val="322034464"/>
      </c:barChart>
      <c:lineChart>
        <c:grouping val="standard"/>
        <c:varyColors val="0"/>
        <c:dLbls>
          <c:showLegendKey val="0"/>
          <c:showVal val="0"/>
          <c:showCatName val="0"/>
          <c:showSerName val="0"/>
          <c:showPercent val="0"/>
          <c:showBubbleSize val="0"/>
        </c:dLbls>
        <c:marker val="1"/>
        <c:smooth val="0"/>
        <c:axId val="322032816"/>
        <c:axId val="322034464"/>
        <c:extLst>
          <c:ext xmlns:c15="http://schemas.microsoft.com/office/drawing/2012/chart" uri="{02D57815-91ED-43cb-92C2-25804820EDAC}">
            <c15:filteredLineSeries>
              <c15:ser>
                <c:idx val="0"/>
                <c:order val="0"/>
                <c:tx>
                  <c:v>C11</c:v>
                </c:tx>
                <c:spPr>
                  <a:ln w="28575" cap="rnd">
                    <a:noFill/>
                    <a:round/>
                  </a:ln>
                  <a:effectLst/>
                </c:spPr>
                <c:marker>
                  <c:symbol val="none"/>
                </c:marker>
                <c:cat>
                  <c:numRef>
                    <c:extLst>
                      <c:ext uri="{02D57815-91ED-43cb-92C2-25804820EDAC}">
                        <c15:formulaRef>
                          <c15:sqref>'sIgE + control'!$AR$67:$AU$67</c15:sqref>
                        </c15:formulaRef>
                      </c:ext>
                    </c:extLst>
                    <c:numCache>
                      <c:formatCode>General</c:formatCode>
                      <c:ptCount val="4"/>
                    </c:numCache>
                  </c:numRef>
                </c:cat>
                <c:val>
                  <c:numRef>
                    <c:extLst>
                      <c:ext uri="{02D57815-91ED-43cb-92C2-25804820EDAC}">
                        <c15:formulaRef>
                          <c15:sqref>'sIgE + control'!$X$99:$AA$99</c15:sqref>
                        </c15:formulaRef>
                      </c:ext>
                    </c:extLst>
                    <c:numCache>
                      <c:formatCode>General</c:formatCode>
                      <c:ptCount val="4"/>
                    </c:numCache>
                  </c:numRef>
                </c:val>
                <c:smooth val="0"/>
                <c:extLst>
                  <c:ext xmlns:c16="http://schemas.microsoft.com/office/drawing/2014/chart" uri="{C3380CC4-5D6E-409C-BE32-E72D297353CC}">
                    <c16:uniqueId val="{00000009-8512-40C7-BA01-2FAFFE1B312D}"/>
                  </c:ext>
                </c:extLst>
              </c15:ser>
            </c15:filteredLineSeries>
            <c15:filteredLineSeries>
              <c15:ser>
                <c:idx val="1"/>
                <c:order val="1"/>
                <c:tx>
                  <c:v>C12</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0:$AA$100</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A-8512-40C7-BA01-2FAFFE1B312D}"/>
                  </c:ext>
                </c:extLst>
              </c15:ser>
            </c15:filteredLineSeries>
            <c15:filteredLineSeries>
              <c15:ser>
                <c:idx val="2"/>
                <c:order val="2"/>
                <c:tx>
                  <c:v>C13</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1:$AA$101</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B-8512-40C7-BA01-2FAFFE1B312D}"/>
                  </c:ext>
                </c:extLst>
              </c15:ser>
            </c15:filteredLineSeries>
            <c15:filteredLineSeries>
              <c15:ser>
                <c:idx val="3"/>
                <c:order val="3"/>
                <c:tx>
                  <c:v>C14</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2:$AA$102</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C-8512-40C7-BA01-2FAFFE1B312D}"/>
                  </c:ext>
                </c:extLst>
              </c15:ser>
            </c15:filteredLineSeries>
            <c15:filteredLineSeries>
              <c15:ser>
                <c:idx val="4"/>
                <c:order val="4"/>
                <c:tx>
                  <c:v>C15</c:v>
                </c:tx>
                <c:spPr>
                  <a:ln w="28575"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3:$AA$103</c15:sqref>
                        </c15:formulaRef>
                      </c:ext>
                    </c:extLst>
                    <c:numCache>
                      <c:formatCode>General</c:formatCode>
                      <c:ptCount val="4"/>
                    </c:numCache>
                  </c:numRef>
                </c:val>
                <c:smooth val="0"/>
                <c:extLst xmlns:c15="http://schemas.microsoft.com/office/drawing/2012/chart">
                  <c:ext xmlns:c16="http://schemas.microsoft.com/office/drawing/2014/chart" uri="{C3380CC4-5D6E-409C-BE32-E72D297353CC}">
                    <c16:uniqueId val="{0000000D-8512-40C7-BA01-2FAFFE1B312D}"/>
                  </c:ext>
                </c:extLst>
              </c15:ser>
            </c15:filteredLineSeries>
            <c15:filteredLineSeries>
              <c15:ser>
                <c:idx val="7"/>
                <c:order val="6"/>
                <c:tx>
                  <c:v>C22</c:v>
                </c:tx>
                <c:spPr>
                  <a:ln w="25400"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5:$AA$105</c15:sqref>
                        </c15:formulaRef>
                      </c:ext>
                    </c:extLst>
                    <c:numCache>
                      <c:formatCode>0.00</c:formatCode>
                      <c:ptCount val="4"/>
                      <c:pt idx="0">
                        <c:v>0.12625</c:v>
                      </c:pt>
                      <c:pt idx="1">
                        <c:v>2.0100000000000002</c:v>
                      </c:pt>
                      <c:pt idx="2">
                        <c:v>3.2155000000000005</c:v>
                      </c:pt>
                      <c:pt idx="3">
                        <c:v>3.8410000000000002</c:v>
                      </c:pt>
                    </c:numCache>
                  </c:numRef>
                </c:val>
                <c:smooth val="0"/>
                <c:extLst xmlns:c15="http://schemas.microsoft.com/office/drawing/2012/chart">
                  <c:ext xmlns:c16="http://schemas.microsoft.com/office/drawing/2014/chart" uri="{C3380CC4-5D6E-409C-BE32-E72D297353CC}">
                    <c16:uniqueId val="{0000000E-8512-40C7-BA01-2FAFFE1B312D}"/>
                  </c:ext>
                </c:extLst>
              </c15:ser>
            </c15:filteredLineSeries>
            <c15:filteredLineSeries>
              <c15:ser>
                <c:idx val="8"/>
                <c:order val="7"/>
                <c:tx>
                  <c:v>C23</c:v>
                </c:tx>
                <c:spPr>
                  <a:ln w="25400"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6:$AA$106</c15:sqref>
                        </c15:formulaRef>
                      </c:ext>
                    </c:extLst>
                    <c:numCache>
                      <c:formatCode>0.00</c:formatCode>
                      <c:ptCount val="4"/>
                      <c:pt idx="0">
                        <c:v>0.1565</c:v>
                      </c:pt>
                      <c:pt idx="1">
                        <c:v>0.22600000000000003</c:v>
                      </c:pt>
                      <c:pt idx="2">
                        <c:v>1.1447499999999999</c:v>
                      </c:pt>
                      <c:pt idx="3">
                        <c:v>1.7202500000000001</c:v>
                      </c:pt>
                    </c:numCache>
                  </c:numRef>
                </c:val>
                <c:smooth val="0"/>
                <c:extLst xmlns:c15="http://schemas.microsoft.com/office/drawing/2012/chart">
                  <c:ext xmlns:c16="http://schemas.microsoft.com/office/drawing/2014/chart" uri="{C3380CC4-5D6E-409C-BE32-E72D297353CC}">
                    <c16:uniqueId val="{0000000F-8512-40C7-BA01-2FAFFE1B312D}"/>
                  </c:ext>
                </c:extLst>
              </c15:ser>
            </c15:filteredLineSeries>
            <c15:filteredLineSeries>
              <c15:ser>
                <c:idx val="9"/>
                <c:order val="8"/>
                <c:tx>
                  <c:v>C24</c:v>
                </c:tx>
                <c:spPr>
                  <a:ln w="25400" cap="rnd">
                    <a:noFill/>
                    <a:round/>
                  </a:ln>
                  <a:effectLst/>
                </c:spPr>
                <c:marker>
                  <c:symbol val="none"/>
                </c:marker>
                <c:cat>
                  <c:numRef>
                    <c:extLst xmlns:c15="http://schemas.microsoft.com/office/drawing/2012/chart">
                      <c:ext xmlns:c15="http://schemas.microsoft.com/office/drawing/2012/chart" uri="{02D57815-91ED-43cb-92C2-25804820EDAC}">
                        <c15:formulaRef>
                          <c15:sqref>'sIgE + control'!$AR$67:$AU$67</c15:sqref>
                        </c15:formulaRef>
                      </c:ext>
                    </c:extLst>
                    <c:numCache>
                      <c:formatCode>General</c:formatCode>
                      <c:ptCount val="4"/>
                    </c:numCache>
                  </c:numRef>
                </c:cat>
                <c:val>
                  <c:numRef>
                    <c:extLst xmlns:c15="http://schemas.microsoft.com/office/drawing/2012/chart">
                      <c:ext xmlns:c15="http://schemas.microsoft.com/office/drawing/2012/chart" uri="{02D57815-91ED-43cb-92C2-25804820EDAC}">
                        <c15:formulaRef>
                          <c15:sqref>'sIgE + control'!$X$107:$AA$107</c15:sqref>
                        </c15:formulaRef>
                      </c:ext>
                    </c:extLst>
                    <c:numCache>
                      <c:formatCode>0.00</c:formatCode>
                      <c:ptCount val="4"/>
                      <c:pt idx="0">
                        <c:v>0.154</c:v>
                      </c:pt>
                      <c:pt idx="1">
                        <c:v>2.8059999999999996</c:v>
                      </c:pt>
                      <c:pt idx="2">
                        <c:v>1.9295</c:v>
                      </c:pt>
                      <c:pt idx="3">
                        <c:v>2.3639999999999999</c:v>
                      </c:pt>
                    </c:numCache>
                  </c:numRef>
                </c:val>
                <c:smooth val="0"/>
                <c:extLst xmlns:c15="http://schemas.microsoft.com/office/drawing/2012/chart">
                  <c:ext xmlns:c16="http://schemas.microsoft.com/office/drawing/2014/chart" uri="{C3380CC4-5D6E-409C-BE32-E72D297353CC}">
                    <c16:uniqueId val="{00000010-8512-40C7-BA01-2FAFFE1B312D}"/>
                  </c:ext>
                </c:extLst>
              </c15:ser>
            </c15:filteredLineSeries>
          </c:ext>
        </c:extLst>
      </c:lineChart>
      <c:catAx>
        <c:axId val="322032816"/>
        <c:scaling>
          <c:orientation val="minMax"/>
        </c:scaling>
        <c:delete val="0"/>
        <c:axPos val="b"/>
        <c:numFmt formatCode="General" sourceLinked="1"/>
        <c:majorTickMark val="none"/>
        <c:minorTickMark val="none"/>
        <c:tickLblPos val="nextTo"/>
        <c:spPr>
          <a:noFill/>
          <a:ln w="2540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322034464"/>
        <c:crosses val="autoZero"/>
        <c:auto val="1"/>
        <c:lblAlgn val="ctr"/>
        <c:lblOffset val="100"/>
        <c:noMultiLvlLbl val="0"/>
      </c:catAx>
      <c:valAx>
        <c:axId val="322034464"/>
        <c:scaling>
          <c:orientation val="minMax"/>
          <c:max val="4"/>
        </c:scaling>
        <c:delete val="0"/>
        <c:axPos val="l"/>
        <c:title>
          <c:tx>
            <c:rich>
              <a:bodyPr rot="-54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sz="1600" b="1" i="0" u="none" strike="noStrike" kern="1200" baseline="0" dirty="0">
                    <a:solidFill>
                      <a:sysClr val="windowText" lastClr="000000"/>
                    </a:solidFill>
                    <a:latin typeface="Times New Roman" panose="02020603050405020304" pitchFamily="18" charset="0"/>
                  </a:rPr>
                  <a:t>Specific IgE Antibody (OD 405- 690 nm)</a:t>
                </a:r>
              </a:p>
            </c:rich>
          </c:tx>
          <c:layout>
            <c:manualLayout>
              <c:xMode val="edge"/>
              <c:yMode val="edge"/>
              <c:x val="1.1752136752136752E-2"/>
              <c:y val="6.6601924759405073E-2"/>
            </c:manualLayout>
          </c:layout>
          <c:overlay val="0"/>
          <c:spPr>
            <a:noFill/>
            <a:ln>
              <a:noFill/>
            </a:ln>
            <a:effectLst/>
          </c:spPr>
          <c:txPr>
            <a:bodyPr rot="-5400000" spcFirstLastPara="1" vertOverflow="ellipsis" vert="horz" wrap="square" anchor="ctr" anchorCtr="1"/>
            <a:lstStyle/>
            <a:p>
              <a:pPr>
                <a:defRPr sz="16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title>
        <c:numFmt formatCode="0.0" sourceLinked="0"/>
        <c:majorTickMark val="out"/>
        <c:minorTickMark val="none"/>
        <c:tickLblPos val="nextTo"/>
        <c:spPr>
          <a:noFill/>
          <a:ln w="25400">
            <a:solidFill>
              <a:schemeClr val="tx1"/>
            </a:solidFill>
          </a:ln>
          <a:effectLst/>
        </c:spPr>
        <c:txPr>
          <a:bodyPr rot="-60000000" spcFirstLastPara="1" vertOverflow="ellipsis" vert="horz" wrap="square" anchor="ctr" anchorCtr="1"/>
          <a:lstStyle/>
          <a:p>
            <a:pPr>
              <a:defRPr sz="16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322032816"/>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446F560-B38A-3F41-987D-A7BE2B373496}" type="datetimeFigureOut">
              <a:rPr lang="en-US" smtClean="0"/>
              <a:t>9/9/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4A8AC74-9211-454C-90B7-F23AF4F5B9CA}" type="slidenum">
              <a:rPr lang="en-US" smtClean="0"/>
              <a:t>‹#›</a:t>
            </a:fld>
            <a:endParaRPr lang="en-US"/>
          </a:p>
        </p:txBody>
      </p:sp>
    </p:spTree>
    <p:extLst>
      <p:ext uri="{BB962C8B-B14F-4D97-AF65-F5344CB8AC3E}">
        <p14:creationId xmlns:p14="http://schemas.microsoft.com/office/powerpoint/2010/main" val="12850656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4A8AC74-9211-454C-90B7-F23AF4F5B9CA}" type="slidenum">
              <a:rPr lang="en-US" smtClean="0"/>
              <a:t>6</a:t>
            </a:fld>
            <a:endParaRPr lang="en-US"/>
          </a:p>
        </p:txBody>
      </p:sp>
    </p:spTree>
    <p:extLst>
      <p:ext uri="{BB962C8B-B14F-4D97-AF65-F5344CB8AC3E}">
        <p14:creationId xmlns:p14="http://schemas.microsoft.com/office/powerpoint/2010/main" val="25503308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altLang="zh-CN" sz="1200" dirty="0">
                <a:solidFill>
                  <a:schemeClr val="accent6"/>
                </a:solidFill>
                <a:latin typeface="Times New Roman" charset="0"/>
                <a:ea typeface="Times New Roman" charset="0"/>
                <a:cs typeface="Times New Roman" charset="0"/>
              </a:rPr>
              <a:t>.</a:t>
            </a:r>
          </a:p>
          <a:p>
            <a:endParaRPr lang="en-US" dirty="0"/>
          </a:p>
        </p:txBody>
      </p:sp>
      <p:sp>
        <p:nvSpPr>
          <p:cNvPr id="4" name="Slide Number Placeholder 3"/>
          <p:cNvSpPr>
            <a:spLocks noGrp="1"/>
          </p:cNvSpPr>
          <p:nvPr>
            <p:ph type="sldNum" sz="quarter" idx="5"/>
          </p:nvPr>
        </p:nvSpPr>
        <p:spPr/>
        <p:txBody>
          <a:bodyPr/>
          <a:lstStyle/>
          <a:p>
            <a:fld id="{B4A8AC74-9211-454C-90B7-F23AF4F5B9CA}" type="slidenum">
              <a:rPr lang="en-US" smtClean="0"/>
              <a:t>8</a:t>
            </a:fld>
            <a:endParaRPr lang="en-US"/>
          </a:p>
        </p:txBody>
      </p:sp>
    </p:spTree>
    <p:extLst>
      <p:ext uri="{BB962C8B-B14F-4D97-AF65-F5344CB8AC3E}">
        <p14:creationId xmlns:p14="http://schemas.microsoft.com/office/powerpoint/2010/main" val="16372031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BFF68779-641A-B94F-B7F4-65E67FCFB16D}" type="datetimeFigureOut">
              <a:rPr lang="en-US" smtClean="0"/>
              <a:t>9/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5720504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F68779-641A-B94F-B7F4-65E67FCFB16D}" type="datetimeFigureOut">
              <a:rPr lang="en-US" smtClean="0"/>
              <a:t>9/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4292907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F68779-641A-B94F-B7F4-65E67FCFB16D}" type="datetimeFigureOut">
              <a:rPr lang="en-US" smtClean="0"/>
              <a:t>9/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3376943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F68779-641A-B94F-B7F4-65E67FCFB16D}" type="datetimeFigureOut">
              <a:rPr lang="en-US" smtClean="0"/>
              <a:t>9/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9599654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FF68779-641A-B94F-B7F4-65E67FCFB16D}" type="datetimeFigureOut">
              <a:rPr lang="en-US" smtClean="0"/>
              <a:t>9/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945605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BFF68779-641A-B94F-B7F4-65E67FCFB16D}" type="datetimeFigureOut">
              <a:rPr lang="en-US" smtClean="0"/>
              <a:t>9/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419373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FF68779-641A-B94F-B7F4-65E67FCFB16D}" type="datetimeFigureOut">
              <a:rPr lang="en-US" smtClean="0"/>
              <a:t>9/9/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8341932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FF68779-641A-B94F-B7F4-65E67FCFB16D}" type="datetimeFigureOut">
              <a:rPr lang="en-US" smtClean="0"/>
              <a:t>9/9/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587042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F68779-641A-B94F-B7F4-65E67FCFB16D}" type="datetimeFigureOut">
              <a:rPr lang="en-US" smtClean="0"/>
              <a:t>9/9/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680603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FF68779-641A-B94F-B7F4-65E67FCFB16D}" type="datetimeFigureOut">
              <a:rPr lang="en-US" smtClean="0"/>
              <a:t>9/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6493234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FF68779-641A-B94F-B7F4-65E67FCFB16D}" type="datetimeFigureOut">
              <a:rPr lang="en-US" smtClean="0"/>
              <a:t>9/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1F69574-6812-9540-9EAB-A67E36DF70E2}" type="slidenum">
              <a:rPr lang="en-US" smtClean="0"/>
              <a:t>‹#›</a:t>
            </a:fld>
            <a:endParaRPr lang="en-US"/>
          </a:p>
        </p:txBody>
      </p:sp>
    </p:spTree>
    <p:extLst>
      <p:ext uri="{BB962C8B-B14F-4D97-AF65-F5344CB8AC3E}">
        <p14:creationId xmlns:p14="http://schemas.microsoft.com/office/powerpoint/2010/main" val="18148473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FF68779-641A-B94F-B7F4-65E67FCFB16D}" type="datetimeFigureOut">
              <a:rPr lang="en-US" smtClean="0"/>
              <a:t>9/9/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1F69574-6812-9540-9EAB-A67E36DF70E2}" type="slidenum">
              <a:rPr lang="en-US" smtClean="0"/>
              <a:t>‹#›</a:t>
            </a:fld>
            <a:endParaRPr lang="en-US"/>
          </a:p>
        </p:txBody>
      </p:sp>
    </p:spTree>
    <p:extLst>
      <p:ext uri="{BB962C8B-B14F-4D97-AF65-F5344CB8AC3E}">
        <p14:creationId xmlns:p14="http://schemas.microsoft.com/office/powerpoint/2010/main" val="15543263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2.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a:extLst>
              <a:ext uri="{FF2B5EF4-FFF2-40B4-BE49-F238E27FC236}">
                <a16:creationId xmlns:a16="http://schemas.microsoft.com/office/drawing/2014/main" id="{631A0593-D48F-4A59-9FB2-8E82BC5FCC8B}"/>
              </a:ext>
            </a:extLst>
          </p:cNvPr>
          <p:cNvGraphicFramePr>
            <a:graphicFrameLocks/>
          </p:cNvGraphicFramePr>
          <p:nvPr>
            <p:extLst>
              <p:ext uri="{D42A27DB-BD31-4B8C-83A1-F6EECF244321}">
                <p14:modId xmlns:p14="http://schemas.microsoft.com/office/powerpoint/2010/main" val="3051432549"/>
              </p:ext>
            </p:extLst>
          </p:nvPr>
        </p:nvGraphicFramePr>
        <p:xfrm>
          <a:off x="3810000" y="1343458"/>
          <a:ext cx="4572000" cy="4905375"/>
        </p:xfrm>
        <a:graphic>
          <a:graphicData uri="http://schemas.openxmlformats.org/drawingml/2006/chart">
            <c:chart xmlns:c="http://schemas.openxmlformats.org/drawingml/2006/chart" xmlns:r="http://schemas.openxmlformats.org/officeDocument/2006/relationships" r:id="rId2"/>
          </a:graphicData>
        </a:graphic>
      </p:graphicFrame>
      <p:sp>
        <p:nvSpPr>
          <p:cNvPr id="25" name="Title 1">
            <a:extLst>
              <a:ext uri="{FF2B5EF4-FFF2-40B4-BE49-F238E27FC236}">
                <a16:creationId xmlns:a16="http://schemas.microsoft.com/office/drawing/2014/main" id="{43DF711F-4684-B34D-9236-D3A26D348F11}"/>
              </a:ext>
            </a:extLst>
          </p:cNvPr>
          <p:cNvSpPr txBox="1">
            <a:spLocks/>
          </p:cNvSpPr>
          <p:nvPr/>
        </p:nvSpPr>
        <p:spPr>
          <a:xfrm>
            <a:off x="0" y="95033"/>
            <a:ext cx="7960649" cy="609601"/>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altLang="zh-CN" sz="2700" b="1" dirty="0">
                <a:latin typeface="Times New Roman" charset="0"/>
                <a:ea typeface="Times New Roman" charset="0"/>
                <a:cs typeface="Times New Roman" charset="0"/>
              </a:rPr>
              <a:t>Jorgensen</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et</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al.,</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2023)</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Supplemental Figure 1</a:t>
            </a:r>
            <a:endParaRPr lang="en-US" sz="2700" b="1" dirty="0">
              <a:latin typeface="Times New Roman" charset="0"/>
              <a:ea typeface="Times New Roman" charset="0"/>
              <a:cs typeface="Times New Roman" charset="0"/>
            </a:endParaRPr>
          </a:p>
        </p:txBody>
      </p:sp>
      <p:sp>
        <p:nvSpPr>
          <p:cNvPr id="17" name="TextBox 16">
            <a:extLst>
              <a:ext uri="{FF2B5EF4-FFF2-40B4-BE49-F238E27FC236}">
                <a16:creationId xmlns:a16="http://schemas.microsoft.com/office/drawing/2014/main" id="{C0217B56-E66C-515D-7E75-EAA96F430CE8}"/>
              </a:ext>
            </a:extLst>
          </p:cNvPr>
          <p:cNvSpPr txBox="1"/>
          <p:nvPr/>
        </p:nvSpPr>
        <p:spPr>
          <a:xfrm>
            <a:off x="4821087" y="1923165"/>
            <a:ext cx="42949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997093FD-A6D6-C2E0-0084-8DB95C7B1B3B}"/>
              </a:ext>
            </a:extLst>
          </p:cNvPr>
          <p:cNvSpPr txBox="1"/>
          <p:nvPr/>
        </p:nvSpPr>
        <p:spPr>
          <a:xfrm>
            <a:off x="5444515" y="3183864"/>
            <a:ext cx="42949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
        <p:nvSpPr>
          <p:cNvPr id="10" name="Rectangle 9">
            <a:extLst>
              <a:ext uri="{FF2B5EF4-FFF2-40B4-BE49-F238E27FC236}">
                <a16:creationId xmlns:a16="http://schemas.microsoft.com/office/drawing/2014/main" id="{3E37CC4E-B5FE-402F-FED6-F3C1B221D7B7}"/>
              </a:ext>
            </a:extLst>
          </p:cNvPr>
          <p:cNvSpPr/>
          <p:nvPr/>
        </p:nvSpPr>
        <p:spPr>
          <a:xfrm>
            <a:off x="7120647" y="1498060"/>
            <a:ext cx="1001949" cy="166636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07E4C538-E00E-3525-DA62-3F5FD0968DED}"/>
              </a:ext>
            </a:extLst>
          </p:cNvPr>
          <p:cNvSpPr txBox="1"/>
          <p:nvPr/>
        </p:nvSpPr>
        <p:spPr>
          <a:xfrm>
            <a:off x="7082307" y="2313779"/>
            <a:ext cx="1278912"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Post-eight exposure</a:t>
            </a:r>
          </a:p>
        </p:txBody>
      </p:sp>
      <p:sp>
        <p:nvSpPr>
          <p:cNvPr id="9" name="TextBox 8">
            <a:extLst>
              <a:ext uri="{FF2B5EF4-FFF2-40B4-BE49-F238E27FC236}">
                <a16:creationId xmlns:a16="http://schemas.microsoft.com/office/drawing/2014/main" id="{7389AAA5-3E58-6445-D200-A1EBDB88A436}"/>
              </a:ext>
            </a:extLst>
          </p:cNvPr>
          <p:cNvSpPr txBox="1"/>
          <p:nvPr/>
        </p:nvSpPr>
        <p:spPr>
          <a:xfrm>
            <a:off x="7060394" y="1646003"/>
            <a:ext cx="1399417" cy="338554"/>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Pre-exposure</a:t>
            </a:r>
          </a:p>
        </p:txBody>
      </p:sp>
      <p:sp>
        <p:nvSpPr>
          <p:cNvPr id="4" name="TextBox 3">
            <a:extLst>
              <a:ext uri="{FF2B5EF4-FFF2-40B4-BE49-F238E27FC236}">
                <a16:creationId xmlns:a16="http://schemas.microsoft.com/office/drawing/2014/main" id="{8723B67C-EAAD-8AC1-4144-6DB5487D4127}"/>
              </a:ext>
            </a:extLst>
          </p:cNvPr>
          <p:cNvSpPr txBox="1"/>
          <p:nvPr/>
        </p:nvSpPr>
        <p:spPr>
          <a:xfrm>
            <a:off x="6054115" y="3926423"/>
            <a:ext cx="42949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6045110D-145D-AB29-3651-4C82DCEF642C}"/>
              </a:ext>
            </a:extLst>
          </p:cNvPr>
          <p:cNvSpPr txBox="1"/>
          <p:nvPr/>
        </p:nvSpPr>
        <p:spPr>
          <a:xfrm>
            <a:off x="6652816" y="4403075"/>
            <a:ext cx="42949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42D1D179-0786-9FCD-DBCF-F419D3D87573}"/>
              </a:ext>
            </a:extLst>
          </p:cNvPr>
          <p:cNvSpPr txBox="1"/>
          <p:nvPr/>
        </p:nvSpPr>
        <p:spPr>
          <a:xfrm>
            <a:off x="7292272" y="4765785"/>
            <a:ext cx="42949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529598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b="1" dirty="0">
                <a:latin typeface="Times New Roman" charset="0"/>
                <a:ea typeface="Times New Roman" charset="0"/>
                <a:cs typeface="Times New Roman" charset="0"/>
              </a:rPr>
              <a:t>Jorgensen</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et</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al.,</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2023)</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Supplemental Figure</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5.</a:t>
            </a:r>
            <a:endParaRPr lang="en-US" b="1" dirty="0">
              <a:latin typeface="Times New Roman" charset="0"/>
              <a:ea typeface="Times New Roman" charset="0"/>
              <a:cs typeface="Times New Roman" charset="0"/>
            </a:endParaRP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sz="2000" b="1" dirty="0">
                <a:latin typeface="Times New Roman"/>
                <a:cs typeface="Times New Roman"/>
              </a:rPr>
              <a:t>Supplemental Figure 5. Systemic anaphylaxis induced by alcohol soluble durum gluten (ASDG) is associated with histamine response. </a:t>
            </a:r>
            <a:r>
              <a:rPr lang="en-US" sz="2000" dirty="0">
                <a:latin typeface="Times New Roman"/>
                <a:cs typeface="Times New Roman"/>
              </a:rPr>
              <a:t>Mice were treated as described in Materials and Methods. Plasma histamine </a:t>
            </a:r>
            <a:r>
              <a:rPr lang="en-US" altLang="zh-CN" sz="2000" dirty="0">
                <a:latin typeface="Times New Roman"/>
                <a:ea typeface="Times New Roman" charset="0"/>
                <a:cs typeface="Times New Roman"/>
              </a:rPr>
              <a:t>levels (ng/mL) were measured using an ELISA-based method as described in the text. </a:t>
            </a:r>
            <a:r>
              <a:rPr lang="en-US" altLang="zh-CN" sz="2000" dirty="0">
                <a:latin typeface="Times New Roman" charset="0"/>
                <a:ea typeface="Times New Roman" charset="0"/>
                <a:cs typeface="Times New Roman" charset="0"/>
              </a:rPr>
              <a:t>Vehicle/Vehicle = skin exposure with vehicle followed by vehicle challenge; Vehicle/ASDG =  skin exposure with vehicle followed by ASDG challenge; ASDG/Vehicle = skin exposure with ASDG followed by vehicle challenge; ASDG/ASDG = skin exposure with ASDG followed by ASDG challenge.</a:t>
            </a:r>
            <a:r>
              <a:rPr lang="en-US" altLang="zh-CN" sz="2000" dirty="0">
                <a:latin typeface="Times New Roman"/>
                <a:ea typeface="Times New Roman" charset="0"/>
                <a:cs typeface="Times New Roman"/>
              </a:rPr>
              <a:t> *** p &lt; 0.005, one-way ANOVA and Tukey’s post hoc tests. </a:t>
            </a:r>
          </a:p>
        </p:txBody>
      </p:sp>
    </p:spTree>
    <p:extLst>
      <p:ext uri="{BB962C8B-B14F-4D97-AF65-F5344CB8AC3E}">
        <p14:creationId xmlns:p14="http://schemas.microsoft.com/office/powerpoint/2010/main" val="9464710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itle 1">
            <a:extLst>
              <a:ext uri="{FF2B5EF4-FFF2-40B4-BE49-F238E27FC236}">
                <a16:creationId xmlns:a16="http://schemas.microsoft.com/office/drawing/2014/main" id="{43DF711F-4684-B34D-9236-D3A26D348F11}"/>
              </a:ext>
            </a:extLst>
          </p:cNvPr>
          <p:cNvSpPr txBox="1">
            <a:spLocks/>
          </p:cNvSpPr>
          <p:nvPr/>
        </p:nvSpPr>
        <p:spPr>
          <a:xfrm>
            <a:off x="0" y="95033"/>
            <a:ext cx="7960649" cy="609601"/>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altLang="zh-CN" sz="2700" b="1" dirty="0">
                <a:latin typeface="Times New Roman" charset="0"/>
                <a:ea typeface="Times New Roman" charset="0"/>
                <a:cs typeface="Times New Roman" charset="0"/>
              </a:rPr>
              <a:t>Jorgensen</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et</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al.,</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2023)</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Supplemental Figure 6</a:t>
            </a:r>
            <a:endParaRPr lang="en-US" sz="2700" b="1" dirty="0">
              <a:latin typeface="Times New Roman" charset="0"/>
              <a:ea typeface="Times New Roman" charset="0"/>
              <a:cs typeface="Times New Roman" charset="0"/>
            </a:endParaRPr>
          </a:p>
        </p:txBody>
      </p:sp>
      <p:sp>
        <p:nvSpPr>
          <p:cNvPr id="2" name="TextBox 1">
            <a:extLst>
              <a:ext uri="{FF2B5EF4-FFF2-40B4-BE49-F238E27FC236}">
                <a16:creationId xmlns:a16="http://schemas.microsoft.com/office/drawing/2014/main" id="{638B8333-ABA7-9388-D941-A92EF4F4AB71}"/>
              </a:ext>
            </a:extLst>
          </p:cNvPr>
          <p:cNvSpPr txBox="1"/>
          <p:nvPr/>
        </p:nvSpPr>
        <p:spPr>
          <a:xfrm>
            <a:off x="73573" y="858383"/>
            <a:ext cx="341637"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A</a:t>
            </a:r>
            <a:endParaRPr lang="en-US"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172AD0FF-44A0-7EE4-5143-1275FE26035B}"/>
              </a:ext>
            </a:extLst>
          </p:cNvPr>
          <p:cNvSpPr txBox="1"/>
          <p:nvPr/>
        </p:nvSpPr>
        <p:spPr>
          <a:xfrm>
            <a:off x="5880538" y="862376"/>
            <a:ext cx="341637"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B</a:t>
            </a:r>
            <a:endParaRPr lang="en-US" dirty="0">
              <a:latin typeface="Times New Roman" panose="02020603050405020304" pitchFamily="18" charset="0"/>
              <a:cs typeface="Times New Roman" panose="02020603050405020304" pitchFamily="18" charset="0"/>
            </a:endParaRPr>
          </a:p>
        </p:txBody>
      </p:sp>
      <p:graphicFrame>
        <p:nvGraphicFramePr>
          <p:cNvPr id="8" name="Chart 7">
            <a:extLst>
              <a:ext uri="{FF2B5EF4-FFF2-40B4-BE49-F238E27FC236}">
                <a16:creationId xmlns:a16="http://schemas.microsoft.com/office/drawing/2014/main" id="{9FC82532-2841-4B26-9F8F-5E2647E5AEDC}"/>
              </a:ext>
            </a:extLst>
          </p:cNvPr>
          <p:cNvGraphicFramePr>
            <a:graphicFrameLocks/>
          </p:cNvGraphicFramePr>
          <p:nvPr>
            <p:extLst>
              <p:ext uri="{D42A27DB-BD31-4B8C-83A1-F6EECF244321}">
                <p14:modId xmlns:p14="http://schemas.microsoft.com/office/powerpoint/2010/main" val="802537863"/>
              </p:ext>
            </p:extLst>
          </p:nvPr>
        </p:nvGraphicFramePr>
        <p:xfrm>
          <a:off x="341637" y="1593054"/>
          <a:ext cx="5943600" cy="4572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1" name="Chart 30">
            <a:extLst>
              <a:ext uri="{FF2B5EF4-FFF2-40B4-BE49-F238E27FC236}">
                <a16:creationId xmlns:a16="http://schemas.microsoft.com/office/drawing/2014/main" id="{356CDF2D-2D4E-4705-B3F5-40BBBB402459}"/>
              </a:ext>
            </a:extLst>
          </p:cNvPr>
          <p:cNvGraphicFramePr>
            <a:graphicFrameLocks/>
          </p:cNvGraphicFramePr>
          <p:nvPr>
            <p:extLst>
              <p:ext uri="{D42A27DB-BD31-4B8C-83A1-F6EECF244321}">
                <p14:modId xmlns:p14="http://schemas.microsoft.com/office/powerpoint/2010/main" val="1384962587"/>
              </p:ext>
            </p:extLst>
          </p:nvPr>
        </p:nvGraphicFramePr>
        <p:xfrm>
          <a:off x="6248400" y="1593054"/>
          <a:ext cx="5943600" cy="4572000"/>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40316699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b="1" dirty="0">
                <a:latin typeface="Times New Roman" charset="0"/>
                <a:ea typeface="Times New Roman" charset="0"/>
                <a:cs typeface="Times New Roman" charset="0"/>
              </a:rPr>
              <a:t>Jorgensen</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et</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al.,</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2023)</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Supplemental Figure</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6.</a:t>
            </a:r>
            <a:endParaRPr lang="en-US" b="1" dirty="0">
              <a:latin typeface="Times New Roman" charset="0"/>
              <a:ea typeface="Times New Roman" charset="0"/>
              <a:cs typeface="Times New Roman" charset="0"/>
            </a:endParaRP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sz="2000" b="1" dirty="0">
                <a:latin typeface="Times New Roman"/>
                <a:cs typeface="Times New Roman"/>
              </a:rPr>
              <a:t>Supplemental Figure 6. Progressive increase in specific IgE antibody response upon chronic transdermal exposure to alcohol-soluble durum gluten (ASDG) in this model. </a:t>
            </a:r>
            <a:r>
              <a:rPr lang="en-US" sz="2000" dirty="0">
                <a:latin typeface="Times New Roman" panose="02020603050405020304" pitchFamily="18" charset="0"/>
                <a:cs typeface="Times New Roman" panose="02020603050405020304" pitchFamily="18" charset="0"/>
              </a:rPr>
              <a:t>Mice were exposed to vehicle (Figure A) or ASDG (Figure B) as described in Materials and Methods. </a:t>
            </a:r>
            <a:r>
              <a:rPr lang="en-US" altLang="zh-CN" sz="2000" dirty="0">
                <a:latin typeface="Times New Roman" charset="0"/>
                <a:ea typeface="Times New Roman" charset="0"/>
                <a:cs typeface="Times New Roman" charset="0"/>
              </a:rPr>
              <a:t>Blood was collected before exposure (Pre) and after second (2R), fourth (4R), sixth (6R), and eighth (8R) exposures. Plasma was used at 1 in 40 dilution to measure ASDG-specific IgE antibody levels using an ELISA method described previously. </a:t>
            </a:r>
            <a:r>
              <a:rPr lang="en-US" altLang="zh-CN" sz="2000" i="1" dirty="0">
                <a:latin typeface="Times New Roman" charset="0"/>
                <a:ea typeface="Times New Roman" charset="0"/>
                <a:cs typeface="Times New Roman" charset="0"/>
              </a:rPr>
              <a:t>n</a:t>
            </a:r>
            <a:r>
              <a:rPr lang="en-US" altLang="zh-CN" sz="2000" dirty="0">
                <a:latin typeface="Times New Roman" charset="0"/>
                <a:ea typeface="Times New Roman" charset="0"/>
                <a:cs typeface="Times New Roman" charset="0"/>
              </a:rPr>
              <a:t> = 10 mice/group. </a:t>
            </a:r>
            <a:endParaRPr lang="en-US" altLang="zh-CN" sz="2000" dirty="0">
              <a:latin typeface="Times New Roman"/>
              <a:ea typeface="Times New Roman" charset="0"/>
              <a:cs typeface="Times New Roman"/>
            </a:endParaRPr>
          </a:p>
        </p:txBody>
      </p:sp>
    </p:spTree>
    <p:extLst>
      <p:ext uri="{BB962C8B-B14F-4D97-AF65-F5344CB8AC3E}">
        <p14:creationId xmlns:p14="http://schemas.microsoft.com/office/powerpoint/2010/main" val="10750451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zh-CN" sz="3600" b="1" dirty="0">
                <a:latin typeface="Times New Roman" charset="0"/>
                <a:ea typeface="Times New Roman" charset="0"/>
                <a:cs typeface="Times New Roman" charset="0"/>
              </a:rPr>
              <a:t>Jorgensen et al.,</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2023)</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Supplemental Figure</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1.</a:t>
            </a:r>
            <a:endParaRPr lang="en-US" sz="3600" b="1" dirty="0">
              <a:latin typeface="Times New Roman" charset="0"/>
              <a:ea typeface="Times New Roman" charset="0"/>
              <a:cs typeface="Times New Roman" charset="0"/>
            </a:endParaRPr>
          </a:p>
        </p:txBody>
      </p:sp>
      <p:sp>
        <p:nvSpPr>
          <p:cNvPr id="3" name="Content Placeholder 2"/>
          <p:cNvSpPr>
            <a:spLocks noGrp="1"/>
          </p:cNvSpPr>
          <p:nvPr>
            <p:ph idx="1"/>
          </p:nvPr>
        </p:nvSpPr>
        <p:spPr>
          <a:xfrm>
            <a:off x="838200" y="1825625"/>
            <a:ext cx="10515600" cy="2415635"/>
          </a:xfrm>
        </p:spPr>
        <p:txBody>
          <a:bodyPr>
            <a:normAutofit/>
          </a:bodyPr>
          <a:lstStyle/>
          <a:p>
            <a:pPr marL="0" indent="0">
              <a:buNone/>
            </a:pPr>
            <a:r>
              <a:rPr lang="en-US" sz="2000" b="1" dirty="0">
                <a:latin typeface="Times New Roman" panose="02020603050405020304" pitchFamily="18" charset="0"/>
                <a:cs typeface="Times New Roman" panose="02020603050405020304" pitchFamily="18" charset="0"/>
              </a:rPr>
              <a:t>Supplemental Figure 1. Titration of ASDG-specific IgE Antibody levels in this model. </a:t>
            </a:r>
            <a:r>
              <a:rPr lang="en-US" sz="2000" dirty="0">
                <a:latin typeface="Times New Roman" panose="02020603050405020304" pitchFamily="18" charset="0"/>
                <a:cs typeface="Times New Roman" panose="02020603050405020304" pitchFamily="18" charset="0"/>
              </a:rPr>
              <a:t>Mice were exposed to ASDG described in Materials and Methods. </a:t>
            </a:r>
            <a:r>
              <a:rPr lang="en-US" altLang="zh-CN" sz="2000" dirty="0">
                <a:latin typeface="Times New Roman" charset="0"/>
                <a:ea typeface="Times New Roman" charset="0"/>
                <a:cs typeface="Times New Roman" charset="0"/>
              </a:rPr>
              <a:t>Blood was collected before 1</a:t>
            </a:r>
            <a:r>
              <a:rPr lang="en-US" altLang="zh-CN" sz="2000" baseline="30000" dirty="0">
                <a:latin typeface="Times New Roman" charset="0"/>
                <a:ea typeface="Times New Roman" charset="0"/>
                <a:cs typeface="Times New Roman" charset="0"/>
              </a:rPr>
              <a:t>st</a:t>
            </a:r>
            <a:r>
              <a:rPr lang="en-US" altLang="zh-CN" sz="2000" dirty="0">
                <a:latin typeface="Times New Roman" charset="0"/>
                <a:ea typeface="Times New Roman" charset="0"/>
                <a:cs typeface="Times New Roman" charset="0"/>
              </a:rPr>
              <a:t> exposure (Pre) and after 8</a:t>
            </a:r>
            <a:r>
              <a:rPr lang="en-US" altLang="zh-CN" sz="2000" baseline="30000" dirty="0">
                <a:latin typeface="Times New Roman" charset="0"/>
                <a:ea typeface="Times New Roman" charset="0"/>
                <a:cs typeface="Times New Roman" charset="0"/>
              </a:rPr>
              <a:t>th </a:t>
            </a:r>
            <a:r>
              <a:rPr lang="en-US" altLang="zh-CN" sz="2000" dirty="0">
                <a:latin typeface="Times New Roman" charset="0"/>
                <a:ea typeface="Times New Roman" charset="0"/>
                <a:cs typeface="Times New Roman" charset="0"/>
              </a:rPr>
              <a:t>exposure. Plasma was used in various dilutions as shown to measure ASDG-specific IgE antibody levels using an ELISA method described previously. </a:t>
            </a:r>
            <a:r>
              <a:rPr lang="en-US" sz="2000" dirty="0">
                <a:latin typeface="Times New Roman" panose="02020603050405020304" pitchFamily="18" charset="0"/>
                <a:cs typeface="Times New Roman" panose="02020603050405020304" pitchFamily="18" charset="0"/>
              </a:rPr>
              <a:t>Student’s two-tailed t-test: </a:t>
            </a:r>
            <a:r>
              <a:rPr lang="zh-CN" altLang="en-US" sz="2000" dirty="0">
                <a:latin typeface="Times New Roman" panose="02020603050405020304" pitchFamily="18" charset="0"/>
                <a:ea typeface="Times New Roman" charset="0"/>
                <a:cs typeface="Times New Roman" panose="02020603050405020304" pitchFamily="18" charset="0"/>
              </a:rPr>
              <a:t>*</a:t>
            </a:r>
            <a:r>
              <a:rPr lang="en-US" altLang="zh-CN" sz="2000" i="1" dirty="0">
                <a:latin typeface="Times New Roman" panose="02020603050405020304" pitchFamily="18" charset="0"/>
                <a:ea typeface="Times New Roman" charset="0"/>
                <a:cs typeface="Times New Roman" panose="02020603050405020304" pitchFamily="18" charset="0"/>
              </a:rPr>
              <a:t>p</a:t>
            </a:r>
            <a:r>
              <a:rPr lang="en-US" altLang="zh-CN" sz="2000" dirty="0">
                <a:latin typeface="Times New Roman" panose="02020603050405020304" pitchFamily="18" charset="0"/>
                <a:ea typeface="Times New Roman" charset="0"/>
                <a:cs typeface="Times New Roman" panose="02020603050405020304" pitchFamily="18" charset="0"/>
              </a:rPr>
              <a:t> &lt; 0.05.</a:t>
            </a:r>
            <a:r>
              <a:rPr lang="en-US" sz="2000" dirty="0">
                <a:latin typeface="Times New Roman" panose="02020603050405020304" pitchFamily="18" charset="0"/>
                <a:cs typeface="Times New Roman" panose="02020603050405020304" pitchFamily="18" charset="0"/>
              </a:rPr>
              <a:t> </a:t>
            </a:r>
            <a:endParaRPr lang="en-US" altLang="zh-CN" sz="2000" dirty="0">
              <a:latin typeface="Times New Roman" panose="02020603050405020304" pitchFamily="18" charset="0"/>
              <a:ea typeface="Times New Roman" charset="0"/>
              <a:cs typeface="Times New Roman" panose="02020603050405020304" pitchFamily="18" charset="0"/>
            </a:endParaRPr>
          </a:p>
          <a:p>
            <a:pPr marL="0" indent="0">
              <a:buNone/>
            </a:pPr>
            <a:endParaRPr lang="en-US" altLang="zh-CN" sz="2000" dirty="0">
              <a:solidFill>
                <a:schemeClr val="bg1">
                  <a:lumMod val="50000"/>
                </a:schemeClr>
              </a:solidFill>
              <a:latin typeface="Times New Roman" charset="0"/>
              <a:ea typeface="Times New Roman" charset="0"/>
              <a:cs typeface="Times New Roman" charset="0"/>
            </a:endParaRPr>
          </a:p>
          <a:p>
            <a:pPr marL="0" indent="0">
              <a:buNone/>
            </a:pPr>
            <a:endParaRPr lang="en-US" altLang="zh-CN" sz="20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40431079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itle 1">
            <a:extLst>
              <a:ext uri="{FF2B5EF4-FFF2-40B4-BE49-F238E27FC236}">
                <a16:creationId xmlns:a16="http://schemas.microsoft.com/office/drawing/2014/main" id="{2E51C695-DD93-3E46-975E-4AD32D674DE1}"/>
              </a:ext>
            </a:extLst>
          </p:cNvPr>
          <p:cNvSpPr txBox="1">
            <a:spLocks/>
          </p:cNvSpPr>
          <p:nvPr/>
        </p:nvSpPr>
        <p:spPr>
          <a:xfrm>
            <a:off x="531248" y="185690"/>
            <a:ext cx="1051560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l"/>
            <a:r>
              <a:rPr lang="en-US" altLang="zh-CN" sz="2800" b="1" dirty="0">
                <a:latin typeface="Times New Roman" charset="0"/>
                <a:ea typeface="Times New Roman" charset="0"/>
                <a:cs typeface="Times New Roman" charset="0"/>
              </a:rPr>
              <a:t>Jorgensen</a:t>
            </a:r>
            <a:r>
              <a:rPr lang="zh-CN" altLang="en-US" sz="2800" b="1" dirty="0">
                <a:latin typeface="Times New Roman" charset="0"/>
                <a:ea typeface="Times New Roman" charset="0"/>
                <a:cs typeface="Times New Roman" charset="0"/>
              </a:rPr>
              <a:t> </a:t>
            </a:r>
            <a:r>
              <a:rPr lang="en-US" altLang="zh-CN" sz="2800" b="1" dirty="0">
                <a:latin typeface="Times New Roman" charset="0"/>
                <a:ea typeface="Times New Roman" charset="0"/>
                <a:cs typeface="Times New Roman" charset="0"/>
              </a:rPr>
              <a:t>et</a:t>
            </a:r>
            <a:r>
              <a:rPr lang="zh-CN" altLang="en-US" sz="2800" b="1" dirty="0">
                <a:latin typeface="Times New Roman" charset="0"/>
                <a:ea typeface="Times New Roman" charset="0"/>
                <a:cs typeface="Times New Roman" charset="0"/>
              </a:rPr>
              <a:t> </a:t>
            </a:r>
            <a:r>
              <a:rPr lang="en-US" altLang="zh-CN" sz="2800" b="1" dirty="0">
                <a:latin typeface="Times New Roman" charset="0"/>
                <a:ea typeface="Times New Roman" charset="0"/>
                <a:cs typeface="Times New Roman" charset="0"/>
              </a:rPr>
              <a:t>al.,</a:t>
            </a:r>
            <a:r>
              <a:rPr lang="zh-CN" altLang="en-US" sz="2800" b="1" dirty="0">
                <a:latin typeface="Times New Roman" charset="0"/>
                <a:ea typeface="Times New Roman" charset="0"/>
                <a:cs typeface="Times New Roman" charset="0"/>
              </a:rPr>
              <a:t> </a:t>
            </a:r>
            <a:r>
              <a:rPr lang="en-US" altLang="zh-CN" sz="2800" b="1" dirty="0">
                <a:latin typeface="Times New Roman" charset="0"/>
                <a:ea typeface="Times New Roman" charset="0"/>
                <a:cs typeface="Times New Roman" charset="0"/>
              </a:rPr>
              <a:t>(2023)</a:t>
            </a:r>
            <a:r>
              <a:rPr lang="zh-CN" altLang="en-US" sz="2800" b="1" dirty="0">
                <a:latin typeface="Times New Roman" charset="0"/>
                <a:ea typeface="Times New Roman" charset="0"/>
                <a:cs typeface="Times New Roman" charset="0"/>
              </a:rPr>
              <a:t> </a:t>
            </a:r>
            <a:r>
              <a:rPr lang="en-US" altLang="zh-CN" sz="2800" b="1" dirty="0">
                <a:latin typeface="Times New Roman" charset="0"/>
                <a:ea typeface="Times New Roman" charset="0"/>
                <a:cs typeface="Times New Roman" charset="0"/>
              </a:rPr>
              <a:t>Supplemental Figure 2. </a:t>
            </a:r>
            <a:endParaRPr lang="en-US" sz="2800" b="1" dirty="0">
              <a:latin typeface="Times New Roman" charset="0"/>
              <a:ea typeface="Times New Roman" charset="0"/>
              <a:cs typeface="Times New Roman" charset="0"/>
            </a:endParaRPr>
          </a:p>
        </p:txBody>
      </p:sp>
      <p:sp>
        <p:nvSpPr>
          <p:cNvPr id="7" name="Rectangle 6">
            <a:extLst>
              <a:ext uri="{FF2B5EF4-FFF2-40B4-BE49-F238E27FC236}">
                <a16:creationId xmlns:a16="http://schemas.microsoft.com/office/drawing/2014/main" id="{3C3BE146-B654-24C5-1312-6B07E139E8DA}"/>
              </a:ext>
            </a:extLst>
          </p:cNvPr>
          <p:cNvSpPr/>
          <p:nvPr/>
        </p:nvSpPr>
        <p:spPr>
          <a:xfrm>
            <a:off x="7988893" y="5744290"/>
            <a:ext cx="3314920" cy="33855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6" name="Chart 5">
            <a:extLst>
              <a:ext uri="{FF2B5EF4-FFF2-40B4-BE49-F238E27FC236}">
                <a16:creationId xmlns:a16="http://schemas.microsoft.com/office/drawing/2014/main" id="{9A9B4E5A-BE93-E01F-F26A-ABE8CB9500C3}"/>
              </a:ext>
            </a:extLst>
          </p:cNvPr>
          <p:cNvGraphicFramePr>
            <a:graphicFrameLocks/>
          </p:cNvGraphicFramePr>
          <p:nvPr>
            <p:extLst>
              <p:ext uri="{D42A27DB-BD31-4B8C-83A1-F6EECF244321}">
                <p14:modId xmlns:p14="http://schemas.microsoft.com/office/powerpoint/2010/main" val="1114435510"/>
              </p:ext>
            </p:extLst>
          </p:nvPr>
        </p:nvGraphicFramePr>
        <p:xfrm>
          <a:off x="3421669" y="1902520"/>
          <a:ext cx="4535424" cy="4572000"/>
        </p:xfrm>
        <a:graphic>
          <a:graphicData uri="http://schemas.openxmlformats.org/drawingml/2006/chart">
            <c:chart xmlns:c="http://schemas.openxmlformats.org/drawingml/2006/chart" xmlns:r="http://schemas.openxmlformats.org/officeDocument/2006/relationships" r:id="rId2"/>
          </a:graphicData>
        </a:graphic>
      </p:graphicFrame>
      <p:grpSp>
        <p:nvGrpSpPr>
          <p:cNvPr id="8" name="Group 7">
            <a:extLst>
              <a:ext uri="{FF2B5EF4-FFF2-40B4-BE49-F238E27FC236}">
                <a16:creationId xmlns:a16="http://schemas.microsoft.com/office/drawing/2014/main" id="{3F0A3545-1777-341E-3333-34A87D41DE63}"/>
              </a:ext>
            </a:extLst>
          </p:cNvPr>
          <p:cNvGrpSpPr/>
          <p:nvPr/>
        </p:nvGrpSpPr>
        <p:grpSpPr>
          <a:xfrm>
            <a:off x="4327048" y="5744290"/>
            <a:ext cx="2724666" cy="830998"/>
            <a:chOff x="1682270" y="5308326"/>
            <a:chExt cx="2724666" cy="830998"/>
          </a:xfrm>
        </p:grpSpPr>
        <p:grpSp>
          <p:nvGrpSpPr>
            <p:cNvPr id="9" name="Group 8">
              <a:extLst>
                <a:ext uri="{FF2B5EF4-FFF2-40B4-BE49-F238E27FC236}">
                  <a16:creationId xmlns:a16="http://schemas.microsoft.com/office/drawing/2014/main" id="{350527BC-A0A4-F134-33DF-884DBE1FBEE8}"/>
                </a:ext>
              </a:extLst>
            </p:cNvPr>
            <p:cNvGrpSpPr/>
            <p:nvPr/>
          </p:nvGrpSpPr>
          <p:grpSpPr>
            <a:xfrm>
              <a:off x="1682270" y="5308326"/>
              <a:ext cx="2724666" cy="830998"/>
              <a:chOff x="1483990" y="5118536"/>
              <a:chExt cx="2591727" cy="830998"/>
            </a:xfrm>
          </p:grpSpPr>
          <p:grpSp>
            <p:nvGrpSpPr>
              <p:cNvPr id="16" name="Group 15">
                <a:extLst>
                  <a:ext uri="{FF2B5EF4-FFF2-40B4-BE49-F238E27FC236}">
                    <a16:creationId xmlns:a16="http://schemas.microsoft.com/office/drawing/2014/main" id="{AEC33ED1-A1AD-9C0B-2876-10C2CA5A142A}"/>
                  </a:ext>
                </a:extLst>
              </p:cNvPr>
              <p:cNvGrpSpPr/>
              <p:nvPr/>
            </p:nvGrpSpPr>
            <p:grpSpPr>
              <a:xfrm>
                <a:off x="1483990" y="5118536"/>
                <a:ext cx="2591727" cy="830998"/>
                <a:chOff x="543910" y="6403177"/>
                <a:chExt cx="2887997" cy="830998"/>
              </a:xfrm>
            </p:grpSpPr>
            <p:sp>
              <p:nvSpPr>
                <p:cNvPr id="19" name="TextBox 18">
                  <a:extLst>
                    <a:ext uri="{FF2B5EF4-FFF2-40B4-BE49-F238E27FC236}">
                      <a16:creationId xmlns:a16="http://schemas.microsoft.com/office/drawing/2014/main" id="{D07375C6-5A39-CC28-1C88-3E25F9949578}"/>
                    </a:ext>
                  </a:extLst>
                </p:cNvPr>
                <p:cNvSpPr txBox="1"/>
                <p:nvPr/>
              </p:nvSpPr>
              <p:spPr>
                <a:xfrm>
                  <a:off x="912934" y="6403178"/>
                  <a:ext cx="2518973" cy="830997"/>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SDG/ASDG (</a:t>
                  </a:r>
                  <a:r>
                    <a:rPr lang="en-US" sz="1600" b="1" i="1" dirty="0">
                      <a:latin typeface="Times New Roman" panose="02020603050405020304" pitchFamily="18" charset="0"/>
                      <a:cs typeface="Times New Roman" panose="02020603050405020304" pitchFamily="18" charset="0"/>
                    </a:rPr>
                    <a:t>n</a:t>
                  </a:r>
                  <a:r>
                    <a:rPr lang="en-US" sz="1600" b="1" dirty="0">
                      <a:latin typeface="Times New Roman" panose="02020603050405020304" pitchFamily="18" charset="0"/>
                      <a:cs typeface="Times New Roman" panose="02020603050405020304" pitchFamily="18" charset="0"/>
                    </a:rPr>
                    <a:t> = 5)</a:t>
                  </a:r>
                </a:p>
                <a:p>
                  <a:endParaRPr lang="en-US" sz="1600" b="1" dirty="0">
                    <a:latin typeface="Times New Roman" panose="02020603050405020304" pitchFamily="18" charset="0"/>
                    <a:cs typeface="Times New Roman" panose="02020603050405020304" pitchFamily="18" charset="0"/>
                  </a:endParaRPr>
                </a:p>
                <a:p>
                  <a:endParaRPr lang="en-US" sz="1600" b="1" dirty="0">
                    <a:latin typeface="Times New Roman" panose="02020603050405020304" pitchFamily="18" charset="0"/>
                    <a:cs typeface="Times New Roman" panose="02020603050405020304" pitchFamily="18" charset="0"/>
                  </a:endParaRPr>
                </a:p>
              </p:txBody>
            </p:sp>
            <p:pic>
              <p:nvPicPr>
                <p:cNvPr id="20" name="Picture 19">
                  <a:extLst>
                    <a:ext uri="{FF2B5EF4-FFF2-40B4-BE49-F238E27FC236}">
                      <a16:creationId xmlns:a16="http://schemas.microsoft.com/office/drawing/2014/main" id="{CD808FCB-AB7A-142A-4F64-76A3AE1AE2B7}"/>
                    </a:ext>
                  </a:extLst>
                </p:cNvPr>
                <p:cNvPicPr>
                  <a:picLocks noChangeAspect="1"/>
                </p:cNvPicPr>
                <p:nvPr/>
              </p:nvPicPr>
              <p:blipFill rotWithShape="1">
                <a:blip r:embed="rId3"/>
                <a:srcRect l="2656" t="44338" r="15740"/>
                <a:stretch/>
              </p:blipFill>
              <p:spPr>
                <a:xfrm>
                  <a:off x="675664" y="6428036"/>
                  <a:ext cx="236405" cy="258754"/>
                </a:xfrm>
                <a:prstGeom prst="rect">
                  <a:avLst/>
                </a:prstGeom>
              </p:spPr>
            </p:pic>
            <p:sp>
              <p:nvSpPr>
                <p:cNvPr id="21" name="Rectangle 20">
                  <a:extLst>
                    <a:ext uri="{FF2B5EF4-FFF2-40B4-BE49-F238E27FC236}">
                      <a16:creationId xmlns:a16="http://schemas.microsoft.com/office/drawing/2014/main" id="{F20C939D-279D-1987-3323-543F2FDD569F}"/>
                    </a:ext>
                  </a:extLst>
                </p:cNvPr>
                <p:cNvSpPr/>
                <p:nvPr/>
              </p:nvSpPr>
              <p:spPr>
                <a:xfrm>
                  <a:off x="543910" y="6403177"/>
                  <a:ext cx="2620495" cy="622167"/>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8" name="Rectangle 17">
                <a:extLst>
                  <a:ext uri="{FF2B5EF4-FFF2-40B4-BE49-F238E27FC236}">
                    <a16:creationId xmlns:a16="http://schemas.microsoft.com/office/drawing/2014/main" id="{2856FA08-4592-183F-E4B3-854AD0019A87}"/>
                  </a:ext>
                </a:extLst>
              </p:cNvPr>
              <p:cNvSpPr/>
              <p:nvPr/>
            </p:nvSpPr>
            <p:spPr>
              <a:xfrm>
                <a:off x="1597583" y="5143395"/>
                <a:ext cx="65314"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1" name="TextBox 10">
              <a:extLst>
                <a:ext uri="{FF2B5EF4-FFF2-40B4-BE49-F238E27FC236}">
                  <a16:creationId xmlns:a16="http://schemas.microsoft.com/office/drawing/2014/main" id="{918192D5-6F5C-0935-FB63-6AF2FADAC45F}"/>
                </a:ext>
              </a:extLst>
            </p:cNvPr>
            <p:cNvSpPr txBox="1"/>
            <p:nvPr/>
          </p:nvSpPr>
          <p:spPr>
            <a:xfrm>
              <a:off x="2018186" y="5591939"/>
              <a:ext cx="2388750"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Vehicle/Vehicle (</a:t>
              </a:r>
              <a:r>
                <a:rPr lang="en-US" sz="1600" b="1" i="1" dirty="0">
                  <a:latin typeface="Times New Roman" panose="02020603050405020304" pitchFamily="18" charset="0"/>
                  <a:cs typeface="Times New Roman" panose="02020603050405020304" pitchFamily="18" charset="0"/>
                </a:rPr>
                <a:t>n </a:t>
              </a:r>
              <a:r>
                <a:rPr lang="en-US" sz="1600" b="1" dirty="0">
                  <a:latin typeface="Times New Roman" panose="02020603050405020304" pitchFamily="18" charset="0"/>
                  <a:cs typeface="Times New Roman" panose="02020603050405020304" pitchFamily="18" charset="0"/>
                </a:rPr>
                <a:t>= 10)</a:t>
              </a:r>
            </a:p>
          </p:txBody>
        </p:sp>
        <p:pic>
          <p:nvPicPr>
            <p:cNvPr id="15" name="Picture 14">
              <a:extLst>
                <a:ext uri="{FF2B5EF4-FFF2-40B4-BE49-F238E27FC236}">
                  <a16:creationId xmlns:a16="http://schemas.microsoft.com/office/drawing/2014/main" id="{1E2B2408-8CB3-1E38-E63A-2E6319212BE7}"/>
                </a:ext>
              </a:extLst>
            </p:cNvPr>
            <p:cNvPicPr>
              <a:picLocks/>
            </p:cNvPicPr>
            <p:nvPr/>
          </p:nvPicPr>
          <p:blipFill rotWithShape="1">
            <a:blip r:embed="rId4"/>
            <a:srcRect l="10188" t="6231" r="7731" b="59413"/>
            <a:stretch/>
          </p:blipFill>
          <p:spPr>
            <a:xfrm>
              <a:off x="1801690" y="5689968"/>
              <a:ext cx="251265" cy="150405"/>
            </a:xfrm>
            <a:prstGeom prst="rect">
              <a:avLst/>
            </a:prstGeom>
          </p:spPr>
        </p:pic>
      </p:grpSp>
      <p:sp>
        <p:nvSpPr>
          <p:cNvPr id="23" name="TextBox 22">
            <a:extLst>
              <a:ext uri="{FF2B5EF4-FFF2-40B4-BE49-F238E27FC236}">
                <a16:creationId xmlns:a16="http://schemas.microsoft.com/office/drawing/2014/main" id="{753D7537-F164-CFEE-DDB8-D7FC97922DF8}"/>
              </a:ext>
            </a:extLst>
          </p:cNvPr>
          <p:cNvSpPr txBox="1"/>
          <p:nvPr/>
        </p:nvSpPr>
        <p:spPr>
          <a:xfrm>
            <a:off x="5677080" y="5040826"/>
            <a:ext cx="223935"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0CD6FEC8-C307-5DA6-9811-72BA8DA41024}"/>
              </a:ext>
            </a:extLst>
          </p:cNvPr>
          <p:cNvSpPr txBox="1"/>
          <p:nvPr/>
        </p:nvSpPr>
        <p:spPr>
          <a:xfrm>
            <a:off x="4379472" y="1588198"/>
            <a:ext cx="3324103"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Post Oral Challenge Time (minutes)</a:t>
            </a:r>
          </a:p>
        </p:txBody>
      </p:sp>
      <p:cxnSp>
        <p:nvCxnSpPr>
          <p:cNvPr id="27" name="Straight Connector 26">
            <a:extLst>
              <a:ext uri="{FF2B5EF4-FFF2-40B4-BE49-F238E27FC236}">
                <a16:creationId xmlns:a16="http://schemas.microsoft.com/office/drawing/2014/main" id="{EE9D047B-5AF6-9476-4B3C-67448253C46F}"/>
              </a:ext>
            </a:extLst>
          </p:cNvPr>
          <p:cNvCxnSpPr/>
          <p:nvPr/>
        </p:nvCxnSpPr>
        <p:spPr>
          <a:xfrm>
            <a:off x="4427515" y="1916374"/>
            <a:ext cx="3228019"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303475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CN" b="1" dirty="0">
                <a:latin typeface="Times New Roman" charset="0"/>
                <a:ea typeface="Times New Roman" charset="0"/>
                <a:cs typeface="Times New Roman" charset="0"/>
              </a:rPr>
              <a:t>Jorgensen</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et</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al.,</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2023)</a:t>
            </a:r>
            <a:r>
              <a:rPr lang="zh-CN" altLang="en-US" b="1" dirty="0">
                <a:latin typeface="Times New Roman" charset="0"/>
                <a:ea typeface="Times New Roman" charset="0"/>
                <a:cs typeface="Times New Roman" charset="0"/>
              </a:rPr>
              <a:t> </a:t>
            </a:r>
            <a:r>
              <a:rPr lang="en-US" altLang="zh-CN" b="1" dirty="0">
                <a:latin typeface="Times New Roman" charset="0"/>
                <a:ea typeface="Times New Roman" charset="0"/>
                <a:cs typeface="Times New Roman" charset="0"/>
              </a:rPr>
              <a:t>Supplemental Figure 2</a:t>
            </a:r>
            <a:endParaRPr lang="en-US" b="1" dirty="0">
              <a:latin typeface="Times New Roman" charset="0"/>
              <a:ea typeface="Times New Roman" charset="0"/>
              <a:cs typeface="Times New Roman" charset="0"/>
            </a:endParaRP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sz="2000" b="1" dirty="0">
                <a:latin typeface="Times New Roman"/>
                <a:cs typeface="Times New Roman"/>
              </a:rPr>
              <a:t>Supplemental Figure 2. Transdermal sensitization with alcohol-soluble durum gluten (ASDG) results in clinical sensitization for oral ASDG-induced systemic anaphylaxis. </a:t>
            </a:r>
            <a:r>
              <a:rPr lang="en-US" sz="2000" dirty="0">
                <a:latin typeface="Times New Roman"/>
                <a:cs typeface="Times New Roman"/>
              </a:rPr>
              <a:t>Groups of mice were exposed to ASDG or vehicle as describe in the text. After nine exposures, mice were orally challenged with ASDG or vehicle. Systemic hypothermic shock responses were quantified by rectal thermometry. </a:t>
            </a:r>
            <a:r>
              <a:rPr lang="en-US" sz="2000" dirty="0">
                <a:latin typeface="Times New Roman" panose="02020603050405020304" pitchFamily="18" charset="0"/>
                <a:cs typeface="Times New Roman" panose="02020603050405020304" pitchFamily="18" charset="0"/>
              </a:rPr>
              <a:t>Student’s two-tailed t-test: </a:t>
            </a:r>
            <a:r>
              <a:rPr lang="zh-CN" altLang="en-US" sz="2000" dirty="0">
                <a:latin typeface="Times New Roman"/>
                <a:ea typeface="Times New Roman" charset="0"/>
                <a:cs typeface="Times New Roman"/>
              </a:rPr>
              <a:t>*</a:t>
            </a:r>
            <a:r>
              <a:rPr lang="en-US" altLang="zh-CN" sz="2000" i="1" dirty="0">
                <a:latin typeface="Times New Roman"/>
                <a:ea typeface="Times New Roman" charset="0"/>
                <a:cs typeface="Times New Roman"/>
              </a:rPr>
              <a:t>p</a:t>
            </a:r>
            <a:r>
              <a:rPr lang="en-US" altLang="zh-CN" sz="2000" dirty="0">
                <a:latin typeface="Times New Roman"/>
                <a:ea typeface="Times New Roman" charset="0"/>
                <a:cs typeface="Times New Roman"/>
              </a:rPr>
              <a:t> &lt; 0.001. </a:t>
            </a:r>
            <a:endParaRPr lang="en-US" altLang="zh-CN" sz="2000" dirty="0">
              <a:solidFill>
                <a:srgbClr val="FF0000"/>
              </a:solidFill>
              <a:latin typeface="Times New Roman"/>
              <a:ea typeface="Times New Roman" charset="0"/>
              <a:cs typeface="Times New Roman"/>
            </a:endParaRPr>
          </a:p>
          <a:p>
            <a:pPr marL="0" indent="0">
              <a:buNone/>
            </a:pPr>
            <a:endParaRPr lang="en-US" altLang="zh-CN" sz="2000" dirty="0">
              <a:latin typeface="Times New Roman"/>
              <a:ea typeface="Times New Roman" charset="0"/>
              <a:cs typeface="Times New Roman"/>
            </a:endParaRPr>
          </a:p>
        </p:txBody>
      </p:sp>
    </p:spTree>
    <p:extLst>
      <p:ext uri="{BB962C8B-B14F-4D97-AF65-F5344CB8AC3E}">
        <p14:creationId xmlns:p14="http://schemas.microsoft.com/office/powerpoint/2010/main" val="27954509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extBox 36">
            <a:extLst>
              <a:ext uri="{FF2B5EF4-FFF2-40B4-BE49-F238E27FC236}">
                <a16:creationId xmlns:a16="http://schemas.microsoft.com/office/drawing/2014/main" id="{73579EB4-AE44-3CD5-82E0-87B7EC08E83A}"/>
              </a:ext>
            </a:extLst>
          </p:cNvPr>
          <p:cNvSpPr txBox="1"/>
          <p:nvPr/>
        </p:nvSpPr>
        <p:spPr>
          <a:xfrm>
            <a:off x="7854417" y="4786361"/>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25" name="Title 1">
            <a:extLst>
              <a:ext uri="{FF2B5EF4-FFF2-40B4-BE49-F238E27FC236}">
                <a16:creationId xmlns:a16="http://schemas.microsoft.com/office/drawing/2014/main" id="{43DF711F-4684-B34D-9236-D3A26D348F11}"/>
              </a:ext>
            </a:extLst>
          </p:cNvPr>
          <p:cNvSpPr txBox="1">
            <a:spLocks/>
          </p:cNvSpPr>
          <p:nvPr/>
        </p:nvSpPr>
        <p:spPr>
          <a:xfrm>
            <a:off x="0" y="95033"/>
            <a:ext cx="7960649" cy="609601"/>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altLang="zh-CN" sz="2700" b="1" dirty="0">
                <a:latin typeface="Times New Roman" charset="0"/>
                <a:ea typeface="Times New Roman" charset="0"/>
                <a:cs typeface="Times New Roman" charset="0"/>
              </a:rPr>
              <a:t>Jorgensen</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et</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al.,</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2023)</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Supplemental Figure 3</a:t>
            </a:r>
            <a:endParaRPr lang="en-US" sz="2700" b="1" dirty="0">
              <a:latin typeface="Times New Roman" charset="0"/>
              <a:ea typeface="Times New Roman" charset="0"/>
              <a:cs typeface="Times New Roman" charset="0"/>
            </a:endParaRPr>
          </a:p>
        </p:txBody>
      </p:sp>
      <p:sp>
        <p:nvSpPr>
          <p:cNvPr id="14" name="Rectangle 13">
            <a:extLst>
              <a:ext uri="{FF2B5EF4-FFF2-40B4-BE49-F238E27FC236}">
                <a16:creationId xmlns:a16="http://schemas.microsoft.com/office/drawing/2014/main" id="{156CE65C-A549-44C4-F8D6-ED4B92254675}"/>
              </a:ext>
            </a:extLst>
          </p:cNvPr>
          <p:cNvSpPr/>
          <p:nvPr/>
        </p:nvSpPr>
        <p:spPr>
          <a:xfrm>
            <a:off x="7044481" y="1948225"/>
            <a:ext cx="1022619" cy="1484621"/>
          </a:xfrm>
          <a:prstGeom prst="rect">
            <a:avLst/>
          </a:prstGeom>
          <a:solidFill>
            <a:schemeClr val="bg1"/>
          </a:solidFill>
          <a:ln>
            <a:solidFill>
              <a:schemeClr val="bg1"/>
            </a:solidFill>
          </a:ln>
        </p:spPr>
        <p:style>
          <a:lnRef idx="1">
            <a:schemeClr val="accent2"/>
          </a:lnRef>
          <a:fillRef idx="3">
            <a:schemeClr val="accent2"/>
          </a:fillRef>
          <a:effectRef idx="2">
            <a:schemeClr val="accent2"/>
          </a:effectRef>
          <a:fontRef idx="minor">
            <a:schemeClr val="lt1"/>
          </a:fontRef>
        </p:style>
        <p:txBody>
          <a:bodyPr rtlCol="0" anchor="ctr"/>
          <a:lstStyle/>
          <a:p>
            <a:pPr algn="ctr"/>
            <a:endParaRPr lang="en-US"/>
          </a:p>
        </p:txBody>
      </p:sp>
      <p:graphicFrame>
        <p:nvGraphicFramePr>
          <p:cNvPr id="5" name="Chart 4">
            <a:extLst>
              <a:ext uri="{FF2B5EF4-FFF2-40B4-BE49-F238E27FC236}">
                <a16:creationId xmlns:a16="http://schemas.microsoft.com/office/drawing/2014/main" id="{AE1F7F2C-2903-49BF-8D46-B74042A4DF30}"/>
              </a:ext>
            </a:extLst>
          </p:cNvPr>
          <p:cNvGraphicFramePr>
            <a:graphicFrameLocks/>
          </p:cNvGraphicFramePr>
          <p:nvPr>
            <p:extLst>
              <p:ext uri="{D42A27DB-BD31-4B8C-83A1-F6EECF244321}">
                <p14:modId xmlns:p14="http://schemas.microsoft.com/office/powerpoint/2010/main" val="668041552"/>
              </p:ext>
            </p:extLst>
          </p:nvPr>
        </p:nvGraphicFramePr>
        <p:xfrm>
          <a:off x="3647500" y="1713847"/>
          <a:ext cx="4572000" cy="4572000"/>
        </p:xfrm>
        <a:graphic>
          <a:graphicData uri="http://schemas.openxmlformats.org/drawingml/2006/chart">
            <c:chart xmlns:c="http://schemas.openxmlformats.org/drawingml/2006/chart" xmlns:r="http://schemas.openxmlformats.org/officeDocument/2006/relationships" r:id="rId2"/>
          </a:graphicData>
        </a:graphic>
      </p:graphicFrame>
      <p:sp>
        <p:nvSpPr>
          <p:cNvPr id="30" name="Rectangle 29">
            <a:extLst>
              <a:ext uri="{FF2B5EF4-FFF2-40B4-BE49-F238E27FC236}">
                <a16:creationId xmlns:a16="http://schemas.microsoft.com/office/drawing/2014/main" id="{3D48DC1C-90A7-8867-CD77-A30256D274E3}"/>
              </a:ext>
            </a:extLst>
          </p:cNvPr>
          <p:cNvSpPr/>
          <p:nvPr/>
        </p:nvSpPr>
        <p:spPr>
          <a:xfrm>
            <a:off x="7044481" y="1799396"/>
            <a:ext cx="1551709" cy="1184563"/>
          </a:xfrm>
          <a:prstGeom prst="rect">
            <a:avLst/>
          </a:prstGeom>
          <a:solidFill>
            <a:schemeClr val="bg1"/>
          </a:solidFill>
          <a:ln>
            <a:solidFill>
              <a:schemeClr val="bg1"/>
            </a:solid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dirty="0"/>
          </a:p>
        </p:txBody>
      </p:sp>
      <p:grpSp>
        <p:nvGrpSpPr>
          <p:cNvPr id="11" name="Group 10">
            <a:extLst>
              <a:ext uri="{FF2B5EF4-FFF2-40B4-BE49-F238E27FC236}">
                <a16:creationId xmlns:a16="http://schemas.microsoft.com/office/drawing/2014/main" id="{F15114B5-9AE8-15A9-F83F-9112797F4535}"/>
              </a:ext>
            </a:extLst>
          </p:cNvPr>
          <p:cNvGrpSpPr/>
          <p:nvPr/>
        </p:nvGrpSpPr>
        <p:grpSpPr>
          <a:xfrm>
            <a:off x="7044480" y="1637778"/>
            <a:ext cx="1399417" cy="1251264"/>
            <a:chOff x="9584511" y="1339138"/>
            <a:chExt cx="1399417" cy="1251264"/>
          </a:xfrm>
        </p:grpSpPr>
        <p:sp>
          <p:nvSpPr>
            <p:cNvPr id="12" name="TextBox 11">
              <a:extLst>
                <a:ext uri="{FF2B5EF4-FFF2-40B4-BE49-F238E27FC236}">
                  <a16:creationId xmlns:a16="http://schemas.microsoft.com/office/drawing/2014/main" id="{FB9219B3-968D-FB2B-0B8E-B0F2C2B08910}"/>
                </a:ext>
              </a:extLst>
            </p:cNvPr>
            <p:cNvSpPr txBox="1"/>
            <p:nvPr/>
          </p:nvSpPr>
          <p:spPr>
            <a:xfrm>
              <a:off x="9644763" y="2005627"/>
              <a:ext cx="1278912"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Post 6</a:t>
              </a:r>
              <a:r>
                <a:rPr lang="en-US" sz="1600" b="1" baseline="30000" dirty="0">
                  <a:latin typeface="Times New Roman" panose="02020603050405020304" pitchFamily="18" charset="0"/>
                  <a:cs typeface="Times New Roman" panose="02020603050405020304" pitchFamily="18" charset="0"/>
                </a:rPr>
                <a:t>th</a:t>
              </a:r>
              <a:r>
                <a:rPr lang="en-US" sz="1600" b="1" dirty="0">
                  <a:latin typeface="Times New Roman" panose="02020603050405020304" pitchFamily="18" charset="0"/>
                  <a:cs typeface="Times New Roman" panose="02020603050405020304" pitchFamily="18" charset="0"/>
                </a:rPr>
                <a:t> Exposure</a:t>
              </a:r>
            </a:p>
          </p:txBody>
        </p:sp>
        <p:sp>
          <p:nvSpPr>
            <p:cNvPr id="13" name="TextBox 12">
              <a:extLst>
                <a:ext uri="{FF2B5EF4-FFF2-40B4-BE49-F238E27FC236}">
                  <a16:creationId xmlns:a16="http://schemas.microsoft.com/office/drawing/2014/main" id="{17223BBD-BD68-A3C5-875F-E0DF77012F65}"/>
                </a:ext>
              </a:extLst>
            </p:cNvPr>
            <p:cNvSpPr txBox="1"/>
            <p:nvPr/>
          </p:nvSpPr>
          <p:spPr>
            <a:xfrm>
              <a:off x="9584511" y="1339138"/>
              <a:ext cx="1399417" cy="584775"/>
            </a:xfrm>
            <a:prstGeom prst="rect">
              <a:avLst/>
            </a:prstGeom>
            <a:noFill/>
          </p:spPr>
          <p:txBody>
            <a:bodyPr wrap="square" rtlCol="0">
              <a:spAutoFit/>
            </a:bodyPr>
            <a:lstStyle/>
            <a:p>
              <a:pPr algn="ctr"/>
              <a:endParaRPr lang="en-US" sz="1600" b="1" dirty="0">
                <a:latin typeface="Times New Roman" panose="02020603050405020304" pitchFamily="18" charset="0"/>
                <a:cs typeface="Times New Roman" panose="02020603050405020304" pitchFamily="18" charset="0"/>
              </a:endParaRPr>
            </a:p>
            <a:p>
              <a:pPr algn="ctr"/>
              <a:r>
                <a:rPr lang="en-US" sz="1600" b="1" dirty="0">
                  <a:latin typeface="Times New Roman" panose="02020603050405020304" pitchFamily="18" charset="0"/>
                  <a:cs typeface="Times New Roman" panose="02020603050405020304" pitchFamily="18" charset="0"/>
                </a:rPr>
                <a:t>Pre-Exposure</a:t>
              </a:r>
            </a:p>
          </p:txBody>
        </p:sp>
      </p:grpSp>
      <p:sp>
        <p:nvSpPr>
          <p:cNvPr id="8" name="TextBox 7">
            <a:extLst>
              <a:ext uri="{FF2B5EF4-FFF2-40B4-BE49-F238E27FC236}">
                <a16:creationId xmlns:a16="http://schemas.microsoft.com/office/drawing/2014/main" id="{627942DB-E913-E84F-DA5F-E3A249FA3908}"/>
              </a:ext>
            </a:extLst>
          </p:cNvPr>
          <p:cNvSpPr txBox="1"/>
          <p:nvPr/>
        </p:nvSpPr>
        <p:spPr>
          <a:xfrm>
            <a:off x="4567115" y="1889416"/>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17" name="TextBox 16">
            <a:extLst>
              <a:ext uri="{FF2B5EF4-FFF2-40B4-BE49-F238E27FC236}">
                <a16:creationId xmlns:a16="http://schemas.microsoft.com/office/drawing/2014/main" id="{02ECCAB9-A8AC-24FB-7845-8BF54152DD86}"/>
              </a:ext>
            </a:extLst>
          </p:cNvPr>
          <p:cNvSpPr txBox="1"/>
          <p:nvPr/>
        </p:nvSpPr>
        <p:spPr>
          <a:xfrm>
            <a:off x="4976339" y="2046990"/>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18" name="TextBox 17">
            <a:extLst>
              <a:ext uri="{FF2B5EF4-FFF2-40B4-BE49-F238E27FC236}">
                <a16:creationId xmlns:a16="http://schemas.microsoft.com/office/drawing/2014/main" id="{3FA7D0C5-ABB7-8048-BD96-32E18AC34425}"/>
              </a:ext>
            </a:extLst>
          </p:cNvPr>
          <p:cNvSpPr txBox="1"/>
          <p:nvPr/>
        </p:nvSpPr>
        <p:spPr>
          <a:xfrm>
            <a:off x="5366052" y="2199290"/>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19" name="TextBox 18">
            <a:extLst>
              <a:ext uri="{FF2B5EF4-FFF2-40B4-BE49-F238E27FC236}">
                <a16:creationId xmlns:a16="http://schemas.microsoft.com/office/drawing/2014/main" id="{D5401852-59DF-2725-2EDF-E6796BFD9EE4}"/>
              </a:ext>
            </a:extLst>
          </p:cNvPr>
          <p:cNvSpPr txBox="1"/>
          <p:nvPr/>
        </p:nvSpPr>
        <p:spPr>
          <a:xfrm>
            <a:off x="5661428" y="2385544"/>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20" name="TextBox 19">
            <a:extLst>
              <a:ext uri="{FF2B5EF4-FFF2-40B4-BE49-F238E27FC236}">
                <a16:creationId xmlns:a16="http://schemas.microsoft.com/office/drawing/2014/main" id="{A02BF9A5-5622-4BF3-B873-FDF2956CB763}"/>
              </a:ext>
            </a:extLst>
          </p:cNvPr>
          <p:cNvSpPr txBox="1"/>
          <p:nvPr/>
        </p:nvSpPr>
        <p:spPr>
          <a:xfrm>
            <a:off x="6031079" y="2814682"/>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22" name="TextBox 21">
            <a:extLst>
              <a:ext uri="{FF2B5EF4-FFF2-40B4-BE49-F238E27FC236}">
                <a16:creationId xmlns:a16="http://schemas.microsoft.com/office/drawing/2014/main" id="{29EEF589-D58B-7963-62BD-2F4300CCF26B}"/>
              </a:ext>
            </a:extLst>
          </p:cNvPr>
          <p:cNvSpPr txBox="1"/>
          <p:nvPr/>
        </p:nvSpPr>
        <p:spPr>
          <a:xfrm>
            <a:off x="6396625" y="3305636"/>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34" name="TextBox 33">
            <a:extLst>
              <a:ext uri="{FF2B5EF4-FFF2-40B4-BE49-F238E27FC236}">
                <a16:creationId xmlns:a16="http://schemas.microsoft.com/office/drawing/2014/main" id="{0D4D6E56-2E19-5E64-D2CC-96CF321057CB}"/>
              </a:ext>
            </a:extLst>
          </p:cNvPr>
          <p:cNvSpPr txBox="1"/>
          <p:nvPr/>
        </p:nvSpPr>
        <p:spPr>
          <a:xfrm>
            <a:off x="6766276" y="3849013"/>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35" name="TextBox 34">
            <a:extLst>
              <a:ext uri="{FF2B5EF4-FFF2-40B4-BE49-F238E27FC236}">
                <a16:creationId xmlns:a16="http://schemas.microsoft.com/office/drawing/2014/main" id="{95339A7D-727D-DBD1-4212-1C3838AE2D04}"/>
              </a:ext>
            </a:extLst>
          </p:cNvPr>
          <p:cNvSpPr txBox="1"/>
          <p:nvPr/>
        </p:nvSpPr>
        <p:spPr>
          <a:xfrm>
            <a:off x="7115115" y="4265180"/>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
        <p:nvSpPr>
          <p:cNvPr id="36" name="TextBox 35">
            <a:extLst>
              <a:ext uri="{FF2B5EF4-FFF2-40B4-BE49-F238E27FC236}">
                <a16:creationId xmlns:a16="http://schemas.microsoft.com/office/drawing/2014/main" id="{7958BDEF-7F54-86B7-417D-6E2F5FF1EBE4}"/>
              </a:ext>
            </a:extLst>
          </p:cNvPr>
          <p:cNvSpPr txBox="1"/>
          <p:nvPr/>
        </p:nvSpPr>
        <p:spPr>
          <a:xfrm>
            <a:off x="7484766" y="4603734"/>
            <a:ext cx="369651"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22643191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zh-CN" sz="3600" b="1" dirty="0">
                <a:latin typeface="Times New Roman" charset="0"/>
                <a:ea typeface="Times New Roman" charset="0"/>
                <a:cs typeface="Times New Roman" charset="0"/>
              </a:rPr>
              <a:t>Jorgensen et al.,</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2023)</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Supplemental Figure</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3.</a:t>
            </a:r>
            <a:endParaRPr lang="en-US" sz="3600" b="1" dirty="0">
              <a:latin typeface="Times New Roman" charset="0"/>
              <a:ea typeface="Times New Roman" charset="0"/>
              <a:cs typeface="Times New Roman" charset="0"/>
            </a:endParaRPr>
          </a:p>
        </p:txBody>
      </p:sp>
      <p:sp>
        <p:nvSpPr>
          <p:cNvPr id="3" name="Content Placeholder 2"/>
          <p:cNvSpPr>
            <a:spLocks noGrp="1"/>
          </p:cNvSpPr>
          <p:nvPr>
            <p:ph idx="1"/>
          </p:nvPr>
        </p:nvSpPr>
        <p:spPr>
          <a:xfrm>
            <a:off x="838200" y="1825625"/>
            <a:ext cx="10515600" cy="2415635"/>
          </a:xfrm>
        </p:spPr>
        <p:txBody>
          <a:bodyPr>
            <a:normAutofit/>
          </a:bodyPr>
          <a:lstStyle/>
          <a:p>
            <a:pPr marL="0" indent="0">
              <a:buNone/>
            </a:pPr>
            <a:r>
              <a:rPr lang="en-US" sz="2000" b="1" dirty="0">
                <a:latin typeface="Times New Roman" panose="02020603050405020304" pitchFamily="18" charset="0"/>
                <a:cs typeface="Times New Roman" panose="02020603050405020304" pitchFamily="18" charset="0"/>
              </a:rPr>
              <a:t>Supplemental Figure 3. Chronic skin exposure to alcohol-soluble durum gluten (ASDG) elicited IgG1 antibody responses in Balb/c mice. </a:t>
            </a:r>
            <a:r>
              <a:rPr lang="en-US" sz="2000" dirty="0">
                <a:latin typeface="Times New Roman" panose="02020603050405020304" pitchFamily="18" charset="0"/>
                <a:cs typeface="Times New Roman" panose="02020603050405020304" pitchFamily="18" charset="0"/>
              </a:rPr>
              <a:t>Mice were exposed to ASDG or to </a:t>
            </a:r>
            <a:r>
              <a:rPr lang="en-US" altLang="zh-CN" sz="2000" dirty="0">
                <a:latin typeface="Times New Roman" panose="02020603050405020304" pitchFamily="18" charset="0"/>
                <a:cs typeface="Times New Roman" panose="02020603050405020304" pitchFamily="18" charset="0"/>
              </a:rPr>
              <a:t>vehicle </a:t>
            </a:r>
            <a:r>
              <a:rPr lang="en-US" sz="2000" dirty="0">
                <a:latin typeface="Times New Roman" panose="02020603050405020304" pitchFamily="18" charset="0"/>
                <a:cs typeface="Times New Roman" panose="02020603050405020304" pitchFamily="18" charset="0"/>
              </a:rPr>
              <a:t>as described in Materials and Methods. </a:t>
            </a:r>
            <a:r>
              <a:rPr lang="en-US" altLang="zh-CN" sz="2000" dirty="0">
                <a:latin typeface="Times New Roman" charset="0"/>
                <a:ea typeface="Times New Roman" charset="0"/>
                <a:cs typeface="Times New Roman" charset="0"/>
              </a:rPr>
              <a:t>Blood was collected before 1</a:t>
            </a:r>
            <a:r>
              <a:rPr lang="en-US" altLang="zh-CN" sz="2000" baseline="30000" dirty="0">
                <a:latin typeface="Times New Roman" charset="0"/>
                <a:ea typeface="Times New Roman" charset="0"/>
                <a:cs typeface="Times New Roman" charset="0"/>
              </a:rPr>
              <a:t>st</a:t>
            </a:r>
            <a:r>
              <a:rPr lang="en-US" altLang="zh-CN" sz="2000" dirty="0">
                <a:latin typeface="Times New Roman" charset="0"/>
                <a:ea typeface="Times New Roman" charset="0"/>
                <a:cs typeface="Times New Roman" charset="0"/>
              </a:rPr>
              <a:t> exposure (Pre) and after 6</a:t>
            </a:r>
            <a:r>
              <a:rPr lang="en-US" altLang="zh-CN" sz="2000" baseline="30000" dirty="0">
                <a:latin typeface="Times New Roman" charset="0"/>
                <a:ea typeface="Times New Roman" charset="0"/>
                <a:cs typeface="Times New Roman" charset="0"/>
              </a:rPr>
              <a:t>th </a:t>
            </a:r>
            <a:r>
              <a:rPr lang="en-US" altLang="zh-CN" sz="2000" dirty="0">
                <a:latin typeface="Times New Roman" charset="0"/>
                <a:ea typeface="Times New Roman" charset="0"/>
                <a:cs typeface="Times New Roman" charset="0"/>
              </a:rPr>
              <a:t>exposure. Plasma was used in measurement of IgG1 antibody levels (OD 405-690 nm) using an ELISA method described previously. </a:t>
            </a:r>
            <a:r>
              <a:rPr lang="en-US" altLang="zh-CN" sz="2000" b="1" dirty="0">
                <a:latin typeface="Times New Roman" charset="0"/>
                <a:ea typeface="Times New Roman" charset="0"/>
                <a:cs typeface="Times New Roman" charset="0"/>
              </a:rPr>
              <a:t>(A) </a:t>
            </a:r>
            <a:r>
              <a:rPr lang="en-US" altLang="zh-CN" sz="2000" dirty="0">
                <a:latin typeface="Times New Roman" charset="0"/>
                <a:ea typeface="Times New Roman" charset="0"/>
                <a:cs typeface="Times New Roman" charset="0"/>
              </a:rPr>
              <a:t>IgG1</a:t>
            </a:r>
            <a:r>
              <a:rPr lang="en-US" altLang="zh-CN" sz="2000" b="1" dirty="0">
                <a:latin typeface="Times New Roman" charset="0"/>
                <a:ea typeface="Times New Roman" charset="0"/>
                <a:cs typeface="Times New Roman" charset="0"/>
              </a:rPr>
              <a:t> </a:t>
            </a:r>
            <a:r>
              <a:rPr lang="en-US" altLang="zh-CN" sz="2000" dirty="0">
                <a:latin typeface="Times New Roman" charset="0"/>
                <a:ea typeface="Times New Roman" charset="0"/>
                <a:cs typeface="Times New Roman" charset="0"/>
              </a:rPr>
              <a:t>antibody levels in ASDG-exposed mice</a:t>
            </a:r>
            <a:r>
              <a:rPr lang="en-US" altLang="zh-CN" sz="2000" dirty="0">
                <a:latin typeface="Times New Roman" panose="02020603050405020304" pitchFamily="18" charset="0"/>
                <a:ea typeface="Times New Roman" charset="0"/>
                <a:cs typeface="Times New Roman" panose="02020603050405020304" pitchFamily="18" charset="0"/>
              </a:rPr>
              <a:t>.</a:t>
            </a:r>
            <a:r>
              <a:rPr lang="en-US" altLang="zh-CN" sz="2000" b="1" dirty="0">
                <a:latin typeface="Times New Roman" charset="0"/>
                <a:ea typeface="Times New Roman" charset="0"/>
                <a:cs typeface="Times New Roman" charset="0"/>
              </a:rPr>
              <a:t> </a:t>
            </a:r>
            <a:r>
              <a:rPr lang="en-US" sz="2000" dirty="0">
                <a:latin typeface="Times New Roman" panose="02020603050405020304" pitchFamily="18" charset="0"/>
                <a:cs typeface="Times New Roman" panose="02020603050405020304" pitchFamily="18" charset="0"/>
              </a:rPr>
              <a:t>Student’s two-tailed t-test: </a:t>
            </a:r>
            <a:r>
              <a:rPr lang="zh-CN" altLang="en-US" sz="2000" dirty="0">
                <a:latin typeface="Times New Roman" panose="02020603050405020304" pitchFamily="18" charset="0"/>
                <a:ea typeface="Times New Roman" charset="0"/>
                <a:cs typeface="Times New Roman" panose="02020603050405020304" pitchFamily="18" charset="0"/>
              </a:rPr>
              <a:t>*</a:t>
            </a:r>
            <a:r>
              <a:rPr lang="en-US" altLang="zh-CN" sz="2000" i="1" dirty="0">
                <a:latin typeface="Times New Roman" panose="02020603050405020304" pitchFamily="18" charset="0"/>
                <a:ea typeface="Times New Roman" charset="0"/>
                <a:cs typeface="Times New Roman" panose="02020603050405020304" pitchFamily="18" charset="0"/>
              </a:rPr>
              <a:t>p</a:t>
            </a:r>
            <a:r>
              <a:rPr lang="en-US" altLang="zh-CN" sz="2000" dirty="0">
                <a:latin typeface="Times New Roman" panose="02020603050405020304" pitchFamily="18" charset="0"/>
                <a:ea typeface="Times New Roman" charset="0"/>
                <a:cs typeface="Times New Roman" panose="02020603050405020304" pitchFamily="18" charset="0"/>
              </a:rPr>
              <a:t> &lt; 0.001.</a:t>
            </a:r>
            <a:r>
              <a:rPr lang="en-US" sz="2000" dirty="0">
                <a:latin typeface="Times New Roman" panose="02020603050405020304" pitchFamily="18" charset="0"/>
                <a:cs typeface="Times New Roman" panose="02020603050405020304" pitchFamily="18" charset="0"/>
              </a:rPr>
              <a:t> </a:t>
            </a:r>
            <a:endParaRPr lang="en-US" altLang="zh-CN" sz="2000" dirty="0">
              <a:latin typeface="Times New Roman" panose="02020603050405020304" pitchFamily="18" charset="0"/>
              <a:ea typeface="Times New Roman" charset="0"/>
              <a:cs typeface="Times New Roman" panose="02020603050405020304" pitchFamily="18" charset="0"/>
            </a:endParaRPr>
          </a:p>
          <a:p>
            <a:pPr marL="0" indent="0">
              <a:buNone/>
            </a:pPr>
            <a:endParaRPr lang="en-US" altLang="zh-CN" sz="2000" dirty="0">
              <a:solidFill>
                <a:schemeClr val="bg1">
                  <a:lumMod val="50000"/>
                </a:schemeClr>
              </a:solidFill>
              <a:latin typeface="Times New Roman" charset="0"/>
              <a:ea typeface="Times New Roman" charset="0"/>
              <a:cs typeface="Times New Roman" charset="0"/>
            </a:endParaRPr>
          </a:p>
          <a:p>
            <a:pPr marL="0" indent="0">
              <a:buNone/>
            </a:pPr>
            <a:endParaRPr lang="en-US" altLang="zh-CN" sz="20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28189417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3B1AFDC-4BCF-D63A-D653-5F0D48E10DCF}"/>
              </a:ext>
            </a:extLst>
          </p:cNvPr>
          <p:cNvPicPr>
            <a:picLocks noChangeAspect="1"/>
          </p:cNvPicPr>
          <p:nvPr/>
        </p:nvPicPr>
        <p:blipFill>
          <a:blip r:embed="rId2"/>
          <a:stretch>
            <a:fillRect/>
          </a:stretch>
        </p:blipFill>
        <p:spPr>
          <a:xfrm>
            <a:off x="2209800" y="706997"/>
            <a:ext cx="7772400" cy="5444006"/>
          </a:xfrm>
          <a:prstGeom prst="rect">
            <a:avLst/>
          </a:prstGeom>
        </p:spPr>
      </p:pic>
      <p:sp>
        <p:nvSpPr>
          <p:cNvPr id="6" name="TextBox 5">
            <a:extLst>
              <a:ext uri="{FF2B5EF4-FFF2-40B4-BE49-F238E27FC236}">
                <a16:creationId xmlns:a16="http://schemas.microsoft.com/office/drawing/2014/main" id="{E6B2EFB4-F0CD-9064-4939-1CD9244F75DB}"/>
              </a:ext>
            </a:extLst>
          </p:cNvPr>
          <p:cNvSpPr txBox="1"/>
          <p:nvPr/>
        </p:nvSpPr>
        <p:spPr>
          <a:xfrm>
            <a:off x="1555531" y="337665"/>
            <a:ext cx="6096000" cy="369332"/>
          </a:xfrm>
          <a:prstGeom prst="rect">
            <a:avLst/>
          </a:prstGeom>
          <a:noFill/>
        </p:spPr>
        <p:txBody>
          <a:bodyPr wrap="square">
            <a:spAutoFit/>
          </a:bodyPr>
          <a:lstStyle/>
          <a:p>
            <a:pPr algn="l"/>
            <a:r>
              <a:rPr lang="en-US" altLang="zh-CN" sz="1800" b="1" dirty="0">
                <a:latin typeface="Times New Roman" charset="0"/>
                <a:ea typeface="Times New Roman" charset="0"/>
                <a:cs typeface="Times New Roman" charset="0"/>
              </a:rPr>
              <a:t>Jorgensen</a:t>
            </a:r>
            <a:r>
              <a:rPr lang="zh-CN" altLang="en-US" sz="1800" b="1" dirty="0">
                <a:latin typeface="Times New Roman" charset="0"/>
                <a:ea typeface="Times New Roman" charset="0"/>
                <a:cs typeface="Times New Roman" charset="0"/>
              </a:rPr>
              <a:t> </a:t>
            </a:r>
            <a:r>
              <a:rPr lang="en-US" altLang="zh-CN" sz="1800" b="1" dirty="0">
                <a:latin typeface="Times New Roman" charset="0"/>
                <a:ea typeface="Times New Roman" charset="0"/>
                <a:cs typeface="Times New Roman" charset="0"/>
              </a:rPr>
              <a:t>et</a:t>
            </a:r>
            <a:r>
              <a:rPr lang="zh-CN" altLang="en-US" sz="1800" b="1" dirty="0">
                <a:latin typeface="Times New Roman" charset="0"/>
                <a:ea typeface="Times New Roman" charset="0"/>
                <a:cs typeface="Times New Roman" charset="0"/>
              </a:rPr>
              <a:t> </a:t>
            </a:r>
            <a:r>
              <a:rPr lang="en-US" altLang="zh-CN" sz="1800" b="1" dirty="0">
                <a:latin typeface="Times New Roman" charset="0"/>
                <a:ea typeface="Times New Roman" charset="0"/>
                <a:cs typeface="Times New Roman" charset="0"/>
              </a:rPr>
              <a:t>al.,</a:t>
            </a:r>
            <a:r>
              <a:rPr lang="zh-CN" altLang="en-US" sz="1800" b="1" dirty="0">
                <a:latin typeface="Times New Roman" charset="0"/>
                <a:ea typeface="Times New Roman" charset="0"/>
                <a:cs typeface="Times New Roman" charset="0"/>
              </a:rPr>
              <a:t> </a:t>
            </a:r>
            <a:r>
              <a:rPr lang="en-US" altLang="zh-CN" sz="1800" b="1" dirty="0">
                <a:latin typeface="Times New Roman" charset="0"/>
                <a:ea typeface="Times New Roman" charset="0"/>
                <a:cs typeface="Times New Roman" charset="0"/>
              </a:rPr>
              <a:t>(2023)</a:t>
            </a:r>
            <a:r>
              <a:rPr lang="zh-CN" altLang="en-US" sz="1800" b="1" dirty="0">
                <a:latin typeface="Times New Roman" charset="0"/>
                <a:ea typeface="Times New Roman" charset="0"/>
                <a:cs typeface="Times New Roman" charset="0"/>
              </a:rPr>
              <a:t> </a:t>
            </a:r>
            <a:r>
              <a:rPr lang="en-US" altLang="zh-CN" sz="1800" b="1" dirty="0">
                <a:latin typeface="Times New Roman" charset="0"/>
                <a:ea typeface="Times New Roman" charset="0"/>
                <a:cs typeface="Times New Roman" charset="0"/>
              </a:rPr>
              <a:t>Supplemental Figure 4</a:t>
            </a:r>
            <a:endParaRPr lang="en-US" sz="1800" b="1" dirty="0">
              <a:latin typeface="Times New Roman" charset="0"/>
              <a:ea typeface="Times New Roman" charset="0"/>
              <a:cs typeface="Times New Roman" charset="0"/>
            </a:endParaRPr>
          </a:p>
        </p:txBody>
      </p:sp>
    </p:spTree>
    <p:extLst>
      <p:ext uri="{BB962C8B-B14F-4D97-AF65-F5344CB8AC3E}">
        <p14:creationId xmlns:p14="http://schemas.microsoft.com/office/powerpoint/2010/main" val="4343210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altLang="zh-CN" sz="3600" b="1" dirty="0">
                <a:latin typeface="Times New Roman" charset="0"/>
                <a:ea typeface="Times New Roman" charset="0"/>
                <a:cs typeface="Times New Roman" charset="0"/>
              </a:rPr>
              <a:t>Jorgensen et al., (2023)</a:t>
            </a:r>
            <a:r>
              <a:rPr lang="zh-CN" altLang="en-US" sz="3600" b="1" dirty="0">
                <a:latin typeface="Times New Roman" charset="0"/>
                <a:ea typeface="Times New Roman" charset="0"/>
                <a:cs typeface="Times New Roman" charset="0"/>
              </a:rPr>
              <a:t> </a:t>
            </a:r>
            <a:r>
              <a:rPr lang="en-US" altLang="zh-CN" sz="3600" b="1" dirty="0">
                <a:latin typeface="Times New Roman" charset="0"/>
                <a:ea typeface="Times New Roman" charset="0"/>
                <a:cs typeface="Times New Roman" charset="0"/>
              </a:rPr>
              <a:t>Supplemental Figure 4</a:t>
            </a:r>
            <a:endParaRPr lang="en-US" sz="3600" b="1" dirty="0">
              <a:latin typeface="Times New Roman" charset="0"/>
              <a:ea typeface="Times New Roman" charset="0"/>
              <a:cs typeface="Times New Roman" charset="0"/>
            </a:endParaRPr>
          </a:p>
        </p:txBody>
      </p:sp>
      <p:sp>
        <p:nvSpPr>
          <p:cNvPr id="3" name="Content Placeholder 2"/>
          <p:cNvSpPr>
            <a:spLocks noGrp="1"/>
          </p:cNvSpPr>
          <p:nvPr>
            <p:ph idx="1"/>
          </p:nvPr>
        </p:nvSpPr>
        <p:spPr>
          <a:xfrm>
            <a:off x="838200" y="1554163"/>
            <a:ext cx="10515600" cy="4351338"/>
          </a:xfrm>
        </p:spPr>
        <p:txBody>
          <a:bodyPr>
            <a:noAutofit/>
          </a:bodyPr>
          <a:lstStyle/>
          <a:p>
            <a:pPr marL="0" indent="0">
              <a:buNone/>
            </a:pPr>
            <a:r>
              <a:rPr lang="en-US" sz="2000" b="1" dirty="0">
                <a:latin typeface="Times New Roman" panose="02020603050405020304" pitchFamily="18" charset="0"/>
                <a:cs typeface="Times New Roman" panose="02020603050405020304" pitchFamily="18" charset="0"/>
              </a:rPr>
              <a:t>Supplemental Figure 4. Transdermal application with vehicle or alcohol-soluble durum gliadin (ASDG) does not cause damage to the skin. (</a:t>
            </a:r>
            <a:r>
              <a:rPr lang="en-US" sz="2000" b="1" dirty="0">
                <a:latin typeface="Times New Roman" charset="0"/>
                <a:cs typeface="Times New Roman" charset="0"/>
              </a:rPr>
              <a:t>A</a:t>
            </a:r>
            <a:r>
              <a:rPr lang="en-US" altLang="zh-CN" sz="2000" b="1" dirty="0">
                <a:latin typeface="Times New Roman" charset="0"/>
                <a:ea typeface="Times New Roman" charset="0"/>
                <a:cs typeface="Times New Roman" charset="0"/>
              </a:rPr>
              <a:t>) </a:t>
            </a:r>
            <a:r>
              <a:rPr lang="en-US" altLang="zh-CN" sz="2000" dirty="0">
                <a:latin typeface="Times New Roman" charset="0"/>
                <a:ea typeface="Times New Roman" charset="0"/>
                <a:cs typeface="Times New Roman" charset="0"/>
              </a:rPr>
              <a:t>H &amp; E staining of skin sections from ASDG-exposed mice are shown from 3 individual mice. </a:t>
            </a:r>
            <a:r>
              <a:rPr lang="en-US" sz="2000" b="1" dirty="0">
                <a:latin typeface="Times New Roman" panose="02020603050405020304" pitchFamily="18" charset="0"/>
                <a:cs typeface="Times New Roman" panose="02020603050405020304" pitchFamily="18" charset="0"/>
              </a:rPr>
              <a:t>(</a:t>
            </a:r>
            <a:r>
              <a:rPr lang="en-US" sz="2000" b="1" dirty="0">
                <a:latin typeface="Times New Roman" charset="0"/>
                <a:cs typeface="Times New Roman" charset="0"/>
              </a:rPr>
              <a:t>B</a:t>
            </a:r>
            <a:r>
              <a:rPr lang="en-US" altLang="zh-CN" sz="2000" b="1" dirty="0">
                <a:latin typeface="Times New Roman" charset="0"/>
                <a:ea typeface="Times New Roman" charset="0"/>
                <a:cs typeface="Times New Roman" charset="0"/>
              </a:rPr>
              <a:t>) </a:t>
            </a:r>
            <a:r>
              <a:rPr lang="en-US" altLang="zh-CN" sz="2000" dirty="0">
                <a:latin typeface="Times New Roman" charset="0"/>
                <a:ea typeface="Times New Roman" charset="0"/>
                <a:cs typeface="Times New Roman" charset="0"/>
              </a:rPr>
              <a:t>H &amp; E staining of skin sections from vehicle-exposed mice are shown from 3 individual mice. </a:t>
            </a:r>
            <a:endParaRPr lang="en-US" altLang="zh-CN" sz="2000" dirty="0">
              <a:solidFill>
                <a:schemeClr val="accent6"/>
              </a:solidFill>
              <a:latin typeface="Times New Roman" charset="0"/>
              <a:ea typeface="Times New Roman" charset="0"/>
              <a:cs typeface="Times New Roman" charset="0"/>
            </a:endParaRPr>
          </a:p>
        </p:txBody>
      </p:sp>
    </p:spTree>
    <p:extLst>
      <p:ext uri="{BB962C8B-B14F-4D97-AF65-F5344CB8AC3E}">
        <p14:creationId xmlns:p14="http://schemas.microsoft.com/office/powerpoint/2010/main" val="116952066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hart 8">
            <a:extLst>
              <a:ext uri="{FF2B5EF4-FFF2-40B4-BE49-F238E27FC236}">
                <a16:creationId xmlns:a16="http://schemas.microsoft.com/office/drawing/2014/main" id="{4936B1E3-6CC8-4944-870F-DC784E261689}"/>
              </a:ext>
            </a:extLst>
          </p:cNvPr>
          <p:cNvGraphicFramePr>
            <a:graphicFrameLocks/>
          </p:cNvGraphicFramePr>
          <p:nvPr>
            <p:extLst>
              <p:ext uri="{D42A27DB-BD31-4B8C-83A1-F6EECF244321}">
                <p14:modId xmlns:p14="http://schemas.microsoft.com/office/powerpoint/2010/main" val="730894514"/>
              </p:ext>
            </p:extLst>
          </p:nvPr>
        </p:nvGraphicFramePr>
        <p:xfrm>
          <a:off x="2667000" y="1685699"/>
          <a:ext cx="6858000" cy="4572000"/>
        </p:xfrm>
        <a:graphic>
          <a:graphicData uri="http://schemas.openxmlformats.org/drawingml/2006/chart">
            <c:chart xmlns:c="http://schemas.openxmlformats.org/drawingml/2006/chart" xmlns:r="http://schemas.openxmlformats.org/officeDocument/2006/relationships" r:id="rId2"/>
          </a:graphicData>
        </a:graphic>
      </p:graphicFrame>
      <p:sp>
        <p:nvSpPr>
          <p:cNvPr id="25" name="Title 1">
            <a:extLst>
              <a:ext uri="{FF2B5EF4-FFF2-40B4-BE49-F238E27FC236}">
                <a16:creationId xmlns:a16="http://schemas.microsoft.com/office/drawing/2014/main" id="{43DF711F-4684-B34D-9236-D3A26D348F11}"/>
              </a:ext>
            </a:extLst>
          </p:cNvPr>
          <p:cNvSpPr txBox="1">
            <a:spLocks/>
          </p:cNvSpPr>
          <p:nvPr/>
        </p:nvSpPr>
        <p:spPr>
          <a:xfrm>
            <a:off x="0" y="95033"/>
            <a:ext cx="7960649" cy="609601"/>
          </a:xfrm>
          <a:prstGeom prst="rect">
            <a:avLst/>
          </a:prstGeom>
        </p:spPr>
        <p:txBody>
          <a:bodyPr vert="horz" lIns="91440" tIns="45720" rIns="91440" bIns="45720" rtlCol="0" anchor="b">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algn="l"/>
            <a:r>
              <a:rPr lang="en-US" altLang="zh-CN" sz="2700" b="1" dirty="0">
                <a:latin typeface="Times New Roman" charset="0"/>
                <a:ea typeface="Times New Roman" charset="0"/>
                <a:cs typeface="Times New Roman" charset="0"/>
              </a:rPr>
              <a:t>Jorgensen</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et</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al.,</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2023)</a:t>
            </a:r>
            <a:r>
              <a:rPr lang="zh-CN" altLang="en-US" sz="2700" b="1" dirty="0">
                <a:latin typeface="Times New Roman" charset="0"/>
                <a:ea typeface="Times New Roman" charset="0"/>
                <a:cs typeface="Times New Roman" charset="0"/>
              </a:rPr>
              <a:t> </a:t>
            </a:r>
            <a:r>
              <a:rPr lang="en-US" altLang="zh-CN" sz="2700" b="1" dirty="0">
                <a:latin typeface="Times New Roman" charset="0"/>
                <a:ea typeface="Times New Roman" charset="0"/>
                <a:cs typeface="Times New Roman" charset="0"/>
              </a:rPr>
              <a:t>Supplemental Figure 5</a:t>
            </a:r>
            <a:endParaRPr lang="en-US" sz="2700" b="1" dirty="0">
              <a:latin typeface="Times New Roman" charset="0"/>
              <a:ea typeface="Times New Roman" charset="0"/>
              <a:cs typeface="Times New Roman" charset="0"/>
            </a:endParaRPr>
          </a:p>
        </p:txBody>
      </p:sp>
      <p:sp>
        <p:nvSpPr>
          <p:cNvPr id="17" name="Rectangle 16">
            <a:extLst>
              <a:ext uri="{FF2B5EF4-FFF2-40B4-BE49-F238E27FC236}">
                <a16:creationId xmlns:a16="http://schemas.microsoft.com/office/drawing/2014/main" id="{055AFFF1-7D90-FBB9-1959-2C2BBDB4E1ED}"/>
              </a:ext>
            </a:extLst>
          </p:cNvPr>
          <p:cNvSpPr/>
          <p:nvPr/>
        </p:nvSpPr>
        <p:spPr>
          <a:xfrm>
            <a:off x="5652926" y="5725410"/>
            <a:ext cx="1607127" cy="437591"/>
          </a:xfrm>
          <a:prstGeom prst="rect">
            <a:avLst/>
          </a:prstGeom>
          <a:solidFill>
            <a:schemeClr val="bg1"/>
          </a:solidFill>
          <a:ln>
            <a:solidFill>
              <a:schemeClr val="bg1"/>
            </a:solid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672A4FC3-3D56-829F-2976-0E0C208F8297}"/>
              </a:ext>
            </a:extLst>
          </p:cNvPr>
          <p:cNvSpPr txBox="1"/>
          <p:nvPr/>
        </p:nvSpPr>
        <p:spPr>
          <a:xfrm>
            <a:off x="3774599" y="5528191"/>
            <a:ext cx="1511587"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 </a:t>
            </a:r>
          </a:p>
          <a:p>
            <a:pPr algn="ctr"/>
            <a:r>
              <a:rPr lang="en-US" sz="1600" b="1" dirty="0">
                <a:latin typeface="Times New Roman" panose="02020603050405020304" pitchFamily="18" charset="0"/>
                <a:cs typeface="Times New Roman" panose="02020603050405020304" pitchFamily="18" charset="0"/>
              </a:rPr>
              <a:t>Vehicle/Vehicle</a:t>
            </a:r>
          </a:p>
        </p:txBody>
      </p:sp>
      <p:cxnSp>
        <p:nvCxnSpPr>
          <p:cNvPr id="47" name="Straight Connector 46">
            <a:extLst>
              <a:ext uri="{FF2B5EF4-FFF2-40B4-BE49-F238E27FC236}">
                <a16:creationId xmlns:a16="http://schemas.microsoft.com/office/drawing/2014/main" id="{41CF870C-618E-C86D-36B2-57490FC42E41}"/>
              </a:ext>
            </a:extLst>
          </p:cNvPr>
          <p:cNvCxnSpPr>
            <a:cxnSpLocks/>
          </p:cNvCxnSpPr>
          <p:nvPr/>
        </p:nvCxnSpPr>
        <p:spPr>
          <a:xfrm>
            <a:off x="4515963" y="1751568"/>
            <a:ext cx="4234627"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a16="http://schemas.microsoft.com/office/drawing/2014/main" id="{2EC63D4A-D56C-05F2-F952-D9466476B9B9}"/>
              </a:ext>
            </a:extLst>
          </p:cNvPr>
          <p:cNvCxnSpPr>
            <a:cxnSpLocks/>
          </p:cNvCxnSpPr>
          <p:nvPr/>
        </p:nvCxnSpPr>
        <p:spPr>
          <a:xfrm>
            <a:off x="5877835" y="1967935"/>
            <a:ext cx="2872755"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a16="http://schemas.microsoft.com/office/drawing/2014/main" id="{F32A2DA8-3CEB-1B7B-3F28-CFCCEE994F48}"/>
              </a:ext>
            </a:extLst>
          </p:cNvPr>
          <p:cNvCxnSpPr>
            <a:cxnSpLocks/>
          </p:cNvCxnSpPr>
          <p:nvPr/>
        </p:nvCxnSpPr>
        <p:spPr>
          <a:xfrm>
            <a:off x="7252654" y="2167646"/>
            <a:ext cx="149793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6396E680-00D0-8F82-1816-555E623E2E69}"/>
              </a:ext>
            </a:extLst>
          </p:cNvPr>
          <p:cNvSpPr txBox="1"/>
          <p:nvPr/>
        </p:nvSpPr>
        <p:spPr>
          <a:xfrm>
            <a:off x="6288704" y="1485112"/>
            <a:ext cx="1025508" cy="369332"/>
          </a:xfrm>
          <a:prstGeom prst="rect">
            <a:avLst/>
          </a:prstGeom>
          <a:noFill/>
        </p:spPr>
        <p:txBody>
          <a:bodyPr wrap="square" rtlCol="0">
            <a:spAutoFit/>
          </a:bodyPr>
          <a:lstStyle/>
          <a:p>
            <a:r>
              <a:rPr lang="en-US" dirty="0"/>
              <a:t>***</a:t>
            </a:r>
          </a:p>
        </p:txBody>
      </p:sp>
      <p:sp>
        <p:nvSpPr>
          <p:cNvPr id="54" name="TextBox 53">
            <a:extLst>
              <a:ext uri="{FF2B5EF4-FFF2-40B4-BE49-F238E27FC236}">
                <a16:creationId xmlns:a16="http://schemas.microsoft.com/office/drawing/2014/main" id="{AF1A4DE1-431E-F8D2-F34E-B86711B93E41}"/>
              </a:ext>
            </a:extLst>
          </p:cNvPr>
          <p:cNvSpPr txBox="1"/>
          <p:nvPr/>
        </p:nvSpPr>
        <p:spPr>
          <a:xfrm>
            <a:off x="7095848" y="1736161"/>
            <a:ext cx="1025508" cy="369332"/>
          </a:xfrm>
          <a:prstGeom prst="rect">
            <a:avLst/>
          </a:prstGeom>
          <a:noFill/>
        </p:spPr>
        <p:txBody>
          <a:bodyPr wrap="square" rtlCol="0">
            <a:spAutoFit/>
          </a:bodyPr>
          <a:lstStyle/>
          <a:p>
            <a:r>
              <a:rPr lang="en-US" dirty="0"/>
              <a:t>***</a:t>
            </a:r>
          </a:p>
        </p:txBody>
      </p:sp>
      <p:sp>
        <p:nvSpPr>
          <p:cNvPr id="55" name="TextBox 54">
            <a:extLst>
              <a:ext uri="{FF2B5EF4-FFF2-40B4-BE49-F238E27FC236}">
                <a16:creationId xmlns:a16="http://schemas.microsoft.com/office/drawing/2014/main" id="{62636936-5942-8106-460E-CC1AC237CC3A}"/>
              </a:ext>
            </a:extLst>
          </p:cNvPr>
          <p:cNvSpPr txBox="1"/>
          <p:nvPr/>
        </p:nvSpPr>
        <p:spPr>
          <a:xfrm>
            <a:off x="7766890" y="1932740"/>
            <a:ext cx="1025508" cy="369332"/>
          </a:xfrm>
          <a:prstGeom prst="rect">
            <a:avLst/>
          </a:prstGeom>
          <a:noFill/>
        </p:spPr>
        <p:txBody>
          <a:bodyPr wrap="square" rtlCol="0">
            <a:spAutoFit/>
          </a:bodyPr>
          <a:lstStyle/>
          <a:p>
            <a:r>
              <a:rPr lang="en-US" dirty="0"/>
              <a:t>***</a:t>
            </a:r>
          </a:p>
        </p:txBody>
      </p:sp>
      <p:sp>
        <p:nvSpPr>
          <p:cNvPr id="3" name="TextBox 2">
            <a:extLst>
              <a:ext uri="{FF2B5EF4-FFF2-40B4-BE49-F238E27FC236}">
                <a16:creationId xmlns:a16="http://schemas.microsoft.com/office/drawing/2014/main" id="{A9911829-125C-2AF7-3570-AF5B472CF4F9}"/>
              </a:ext>
            </a:extLst>
          </p:cNvPr>
          <p:cNvSpPr txBox="1"/>
          <p:nvPr/>
        </p:nvSpPr>
        <p:spPr>
          <a:xfrm>
            <a:off x="5175578" y="5528191"/>
            <a:ext cx="1511587"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 </a:t>
            </a:r>
          </a:p>
          <a:p>
            <a:pPr algn="ctr"/>
            <a:r>
              <a:rPr lang="en-US" sz="1600" b="1" dirty="0">
                <a:latin typeface="Times New Roman" panose="02020603050405020304" pitchFamily="18" charset="0"/>
                <a:cs typeface="Times New Roman" panose="02020603050405020304" pitchFamily="18" charset="0"/>
              </a:rPr>
              <a:t>Vehicle/ASDG</a:t>
            </a:r>
          </a:p>
        </p:txBody>
      </p:sp>
      <p:sp>
        <p:nvSpPr>
          <p:cNvPr id="4" name="TextBox 3">
            <a:extLst>
              <a:ext uri="{FF2B5EF4-FFF2-40B4-BE49-F238E27FC236}">
                <a16:creationId xmlns:a16="http://schemas.microsoft.com/office/drawing/2014/main" id="{CA8E73CD-369F-0B3A-47A4-727DC48EE995}"/>
              </a:ext>
            </a:extLst>
          </p:cNvPr>
          <p:cNvSpPr txBox="1"/>
          <p:nvPr/>
        </p:nvSpPr>
        <p:spPr>
          <a:xfrm>
            <a:off x="6591147" y="5528191"/>
            <a:ext cx="1511587"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 </a:t>
            </a:r>
          </a:p>
          <a:p>
            <a:pPr algn="ctr"/>
            <a:r>
              <a:rPr lang="en-US" sz="1600" b="1" dirty="0">
                <a:latin typeface="Times New Roman" panose="02020603050405020304" pitchFamily="18" charset="0"/>
                <a:cs typeface="Times New Roman" panose="02020603050405020304" pitchFamily="18" charset="0"/>
              </a:rPr>
              <a:t>ASDG/Vehicle</a:t>
            </a:r>
          </a:p>
        </p:txBody>
      </p:sp>
      <p:sp>
        <p:nvSpPr>
          <p:cNvPr id="5" name="TextBox 4">
            <a:extLst>
              <a:ext uri="{FF2B5EF4-FFF2-40B4-BE49-F238E27FC236}">
                <a16:creationId xmlns:a16="http://schemas.microsoft.com/office/drawing/2014/main" id="{937AEC2F-1FFC-9213-F3B3-CB64E79EF898}"/>
              </a:ext>
            </a:extLst>
          </p:cNvPr>
          <p:cNvSpPr txBox="1"/>
          <p:nvPr/>
        </p:nvSpPr>
        <p:spPr>
          <a:xfrm>
            <a:off x="7937108" y="5528191"/>
            <a:ext cx="1511587" cy="584775"/>
          </a:xfrm>
          <a:prstGeom prst="rect">
            <a:avLst/>
          </a:prstGeom>
          <a:noFill/>
        </p:spPr>
        <p:txBody>
          <a:bodyPr wrap="square" rtlCol="0">
            <a:spAutoFit/>
          </a:bodyPr>
          <a:lstStyle/>
          <a:p>
            <a:pPr algn="ctr"/>
            <a:r>
              <a:rPr lang="en-US" sz="1600" b="1" dirty="0">
                <a:latin typeface="Times New Roman" panose="02020603050405020304" pitchFamily="18" charset="0"/>
                <a:cs typeface="Times New Roman" panose="02020603050405020304" pitchFamily="18" charset="0"/>
              </a:rPr>
              <a:t> </a:t>
            </a:r>
          </a:p>
          <a:p>
            <a:pPr algn="ctr"/>
            <a:r>
              <a:rPr lang="en-US" sz="1600" b="1" dirty="0">
                <a:latin typeface="Times New Roman" panose="02020603050405020304" pitchFamily="18" charset="0"/>
                <a:cs typeface="Times New Roman" panose="02020603050405020304" pitchFamily="18" charset="0"/>
              </a:rPr>
              <a:t>ASDG/ASDG</a:t>
            </a:r>
          </a:p>
        </p:txBody>
      </p:sp>
    </p:spTree>
    <p:extLst>
      <p:ext uri="{BB962C8B-B14F-4D97-AF65-F5344CB8AC3E}">
        <p14:creationId xmlns:p14="http://schemas.microsoft.com/office/powerpoint/2010/main" val="15514549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399</TotalTime>
  <Words>767</Words>
  <Application>Microsoft Macintosh PowerPoint</Application>
  <PresentationFormat>Widescreen</PresentationFormat>
  <Paragraphs>67</Paragraphs>
  <Slides>1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Times New Roman</vt:lpstr>
      <vt:lpstr>Office Theme</vt:lpstr>
      <vt:lpstr>PowerPoint Presentation</vt:lpstr>
      <vt:lpstr>Jorgensen et al., (2023) Supplemental Figure 1.</vt:lpstr>
      <vt:lpstr>PowerPoint Presentation</vt:lpstr>
      <vt:lpstr>Jorgensen et al., (2023) Supplemental Figure 2</vt:lpstr>
      <vt:lpstr>PowerPoint Presentation</vt:lpstr>
      <vt:lpstr>Jorgensen et al., (2023) Supplemental Figure 3.</vt:lpstr>
      <vt:lpstr>PowerPoint Presentation</vt:lpstr>
      <vt:lpstr>Jorgensen et al., (2023) Supplemental Figure 4</vt:lpstr>
      <vt:lpstr>PowerPoint Presentation</vt:lpstr>
      <vt:lpstr>Jorgensen et al., (2023) Supplemental Figure 5.</vt:lpstr>
      <vt:lpstr>PowerPoint Presentation</vt:lpstr>
      <vt:lpstr>Jorgensen et al., (2023) Supplemental Figure 6.</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o, Haoran</dc:creator>
  <cp:lastModifiedBy>Gangur, Venugopal</cp:lastModifiedBy>
  <cp:revision>483</cp:revision>
  <dcterms:created xsi:type="dcterms:W3CDTF">2018-03-15T20:04:11Z</dcterms:created>
  <dcterms:modified xsi:type="dcterms:W3CDTF">2023-09-09T20:41:11Z</dcterms:modified>
</cp:coreProperties>
</file>